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ppt/charts/chart47.xml" ContentType="application/vnd.openxmlformats-officedocument.drawingml.chart+xml"/>
  <Override PartName="/ppt/charts/chart4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 autoAdjust="0"/>
    <p:restoredTop sz="94671" autoAdjust="0"/>
  </p:normalViewPr>
  <p:slideViewPr>
    <p:cSldViewPr>
      <p:cViewPr varScale="1">
        <p:scale>
          <a:sx n="52" d="100"/>
          <a:sy n="52" d="100"/>
        </p:scale>
        <p:origin x="-1404" y="-9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0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1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3.xlsx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4.xlsx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5.xlsx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6.xlsx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7.xlsx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8.xlsx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9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0.xlsx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1.xlsx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2.xlsx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3.xlsx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4.xlsx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5.xlsx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6.xlsx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7.xlsx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8.xlsx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9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0.xlsx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1.xlsx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2.xlsx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3.xlsx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4.xlsx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5.xlsx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6.xlsx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7.xlsx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8.xlsx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9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0.xlsx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1.xlsx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2.xlsx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3.xlsx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4.xlsx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5.xlsx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6.xlsx"/></Relationships>
</file>

<file path=ppt/charts/_rels/chart4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7.xlsx"/></Relationships>
</file>

<file path=ppt/charts/_rels/chart4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8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042545620514736"/>
          <c:y val="5.1400554097404488E-2"/>
          <c:w val="0.71033763127957028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'Sheet1 (2)'!$C$1</c:f>
              <c:strCache>
                <c:ptCount val="1"/>
                <c:pt idx="0">
                  <c:v>Acet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Sheet1 (2)'!$B$2:$B$97</c:f>
              <c:strCache>
                <c:ptCount val="96"/>
                <c:pt idx="0">
                  <c:v>B12</c:v>
                </c:pt>
                <c:pt idx="1">
                  <c:v>D4</c:v>
                </c:pt>
                <c:pt idx="2">
                  <c:v>D1</c:v>
                </c:pt>
                <c:pt idx="3">
                  <c:v>A2</c:v>
                </c:pt>
                <c:pt idx="4">
                  <c:v>E12</c:v>
                </c:pt>
                <c:pt idx="5">
                  <c:v>H1</c:v>
                </c:pt>
                <c:pt idx="6">
                  <c:v>D12</c:v>
                </c:pt>
                <c:pt idx="7">
                  <c:v>E3</c:v>
                </c:pt>
                <c:pt idx="8">
                  <c:v>C2</c:v>
                </c:pt>
                <c:pt idx="9">
                  <c:v>A12</c:v>
                </c:pt>
                <c:pt idx="10">
                  <c:v>A4</c:v>
                </c:pt>
                <c:pt idx="11">
                  <c:v>F1</c:v>
                </c:pt>
                <c:pt idx="12">
                  <c:v>H10</c:v>
                </c:pt>
                <c:pt idx="13">
                  <c:v>H3</c:v>
                </c:pt>
                <c:pt idx="14">
                  <c:v>F11</c:v>
                </c:pt>
                <c:pt idx="15">
                  <c:v>D11</c:v>
                </c:pt>
                <c:pt idx="16">
                  <c:v>E8</c:v>
                </c:pt>
                <c:pt idx="17">
                  <c:v>C6</c:v>
                </c:pt>
                <c:pt idx="18">
                  <c:v>C3</c:v>
                </c:pt>
                <c:pt idx="19">
                  <c:v>H7</c:v>
                </c:pt>
                <c:pt idx="20">
                  <c:v>E6</c:v>
                </c:pt>
                <c:pt idx="21">
                  <c:v>E10</c:v>
                </c:pt>
                <c:pt idx="22">
                  <c:v>E7</c:v>
                </c:pt>
                <c:pt idx="23">
                  <c:v>F2</c:v>
                </c:pt>
                <c:pt idx="24">
                  <c:v>C8</c:v>
                </c:pt>
                <c:pt idx="25">
                  <c:v>B10</c:v>
                </c:pt>
                <c:pt idx="26">
                  <c:v>D10</c:v>
                </c:pt>
                <c:pt idx="27">
                  <c:v>D8</c:v>
                </c:pt>
                <c:pt idx="28">
                  <c:v>B2</c:v>
                </c:pt>
                <c:pt idx="29">
                  <c:v>E4</c:v>
                </c:pt>
                <c:pt idx="30">
                  <c:v>H4</c:v>
                </c:pt>
                <c:pt idx="31">
                  <c:v>D2</c:v>
                </c:pt>
                <c:pt idx="32">
                  <c:v>H11</c:v>
                </c:pt>
                <c:pt idx="33">
                  <c:v>G9</c:v>
                </c:pt>
                <c:pt idx="34">
                  <c:v>E9</c:v>
                </c:pt>
                <c:pt idx="35">
                  <c:v>A1</c:v>
                </c:pt>
                <c:pt idx="36">
                  <c:v>D3</c:v>
                </c:pt>
                <c:pt idx="37">
                  <c:v>F9</c:v>
                </c:pt>
                <c:pt idx="38">
                  <c:v>E11</c:v>
                </c:pt>
                <c:pt idx="39">
                  <c:v>B6</c:v>
                </c:pt>
                <c:pt idx="40">
                  <c:v>A11</c:v>
                </c:pt>
                <c:pt idx="41">
                  <c:v>A10</c:v>
                </c:pt>
                <c:pt idx="42">
                  <c:v>G2</c:v>
                </c:pt>
                <c:pt idx="43">
                  <c:v>H9</c:v>
                </c:pt>
                <c:pt idx="44">
                  <c:v>H6</c:v>
                </c:pt>
                <c:pt idx="45">
                  <c:v>A9</c:v>
                </c:pt>
                <c:pt idx="46">
                  <c:v>D6</c:v>
                </c:pt>
                <c:pt idx="47">
                  <c:v>C11</c:v>
                </c:pt>
                <c:pt idx="48">
                  <c:v>C9</c:v>
                </c:pt>
                <c:pt idx="49">
                  <c:v>D5</c:v>
                </c:pt>
                <c:pt idx="50">
                  <c:v>H8</c:v>
                </c:pt>
                <c:pt idx="51">
                  <c:v>H2</c:v>
                </c:pt>
                <c:pt idx="52">
                  <c:v>E5</c:v>
                </c:pt>
                <c:pt idx="53">
                  <c:v>A8</c:v>
                </c:pt>
                <c:pt idx="54">
                  <c:v>F7</c:v>
                </c:pt>
                <c:pt idx="55">
                  <c:v>H12</c:v>
                </c:pt>
                <c:pt idx="56">
                  <c:v>C10</c:v>
                </c:pt>
                <c:pt idx="57">
                  <c:v>C7</c:v>
                </c:pt>
                <c:pt idx="58">
                  <c:v>A6</c:v>
                </c:pt>
                <c:pt idx="59">
                  <c:v>G10</c:v>
                </c:pt>
                <c:pt idx="60">
                  <c:v>D9</c:v>
                </c:pt>
                <c:pt idx="61">
                  <c:v>F5</c:v>
                </c:pt>
                <c:pt idx="62">
                  <c:v>F8</c:v>
                </c:pt>
                <c:pt idx="63">
                  <c:v>G7</c:v>
                </c:pt>
                <c:pt idx="64">
                  <c:v>F12</c:v>
                </c:pt>
                <c:pt idx="65">
                  <c:v>E1</c:v>
                </c:pt>
                <c:pt idx="66">
                  <c:v>A5</c:v>
                </c:pt>
                <c:pt idx="67">
                  <c:v>B4</c:v>
                </c:pt>
                <c:pt idx="68">
                  <c:v>B8</c:v>
                </c:pt>
                <c:pt idx="69">
                  <c:v>A3</c:v>
                </c:pt>
                <c:pt idx="70">
                  <c:v>C5</c:v>
                </c:pt>
                <c:pt idx="71">
                  <c:v>B1</c:v>
                </c:pt>
                <c:pt idx="72">
                  <c:v>G1</c:v>
                </c:pt>
                <c:pt idx="73">
                  <c:v>B5</c:v>
                </c:pt>
                <c:pt idx="74">
                  <c:v>H5</c:v>
                </c:pt>
                <c:pt idx="75">
                  <c:v>F6</c:v>
                </c:pt>
                <c:pt idx="76">
                  <c:v>B7</c:v>
                </c:pt>
                <c:pt idx="77">
                  <c:v>G4</c:v>
                </c:pt>
                <c:pt idx="78">
                  <c:v>C4</c:v>
                </c:pt>
                <c:pt idx="79">
                  <c:v>F4</c:v>
                </c:pt>
                <c:pt idx="80">
                  <c:v>A7</c:v>
                </c:pt>
                <c:pt idx="81">
                  <c:v>F10</c:v>
                </c:pt>
                <c:pt idx="82">
                  <c:v>G8</c:v>
                </c:pt>
                <c:pt idx="83">
                  <c:v>G11</c:v>
                </c:pt>
                <c:pt idx="84">
                  <c:v>B11</c:v>
                </c:pt>
                <c:pt idx="85">
                  <c:v>G6</c:v>
                </c:pt>
                <c:pt idx="86">
                  <c:v>B9</c:v>
                </c:pt>
                <c:pt idx="87">
                  <c:v>E2</c:v>
                </c:pt>
                <c:pt idx="88">
                  <c:v>G5</c:v>
                </c:pt>
                <c:pt idx="89">
                  <c:v>B3</c:v>
                </c:pt>
                <c:pt idx="90">
                  <c:v>C1</c:v>
                </c:pt>
                <c:pt idx="91">
                  <c:v>D7</c:v>
                </c:pt>
                <c:pt idx="92">
                  <c:v>F3</c:v>
                </c:pt>
                <c:pt idx="93">
                  <c:v>G3</c:v>
                </c:pt>
                <c:pt idx="94">
                  <c:v>C12</c:v>
                </c:pt>
                <c:pt idx="95">
                  <c:v>G12</c:v>
                </c:pt>
              </c:strCache>
            </c:strRef>
          </c:xVal>
          <c:yVal>
            <c:numRef>
              <c:f>'Sheet1 (2)'!$C$2:$C$97</c:f>
              <c:numCache>
                <c:formatCode>General</c:formatCode>
                <c:ptCount val="96"/>
                <c:pt idx="0">
                  <c:v>65.753424657534225</c:v>
                </c:pt>
                <c:pt idx="1">
                  <c:v>72.41379310344827</c:v>
                </c:pt>
                <c:pt idx="2">
                  <c:v>72.950819672131146</c:v>
                </c:pt>
                <c:pt idx="3">
                  <c:v>78.021978021977972</c:v>
                </c:pt>
                <c:pt idx="4">
                  <c:v>78.181818181818173</c:v>
                </c:pt>
                <c:pt idx="5">
                  <c:v>80</c:v>
                </c:pt>
                <c:pt idx="6">
                  <c:v>80.303030303030326</c:v>
                </c:pt>
                <c:pt idx="7">
                  <c:v>80.597014925373173</c:v>
                </c:pt>
                <c:pt idx="8">
                  <c:v>81.632653061224488</c:v>
                </c:pt>
                <c:pt idx="9">
                  <c:v>83.597883597883538</c:v>
                </c:pt>
                <c:pt idx="10">
                  <c:v>84.210526315789394</c:v>
                </c:pt>
                <c:pt idx="11">
                  <c:v>84.466019417475721</c:v>
                </c:pt>
                <c:pt idx="12">
                  <c:v>84.563758389261722</c:v>
                </c:pt>
                <c:pt idx="13">
                  <c:v>84.848484848484844</c:v>
                </c:pt>
                <c:pt idx="14">
                  <c:v>84.905660377358458</c:v>
                </c:pt>
                <c:pt idx="15">
                  <c:v>85.714285714285737</c:v>
                </c:pt>
                <c:pt idx="16">
                  <c:v>85.937500000000014</c:v>
                </c:pt>
                <c:pt idx="17">
                  <c:v>86.619718309859152</c:v>
                </c:pt>
                <c:pt idx="18">
                  <c:v>86.764705882352914</c:v>
                </c:pt>
                <c:pt idx="19">
                  <c:v>86.92307692307692</c:v>
                </c:pt>
                <c:pt idx="20">
                  <c:v>87.142857142857139</c:v>
                </c:pt>
                <c:pt idx="21">
                  <c:v>87.179487179487154</c:v>
                </c:pt>
                <c:pt idx="22">
                  <c:v>87.200000000000017</c:v>
                </c:pt>
                <c:pt idx="23">
                  <c:v>87.500000000000014</c:v>
                </c:pt>
                <c:pt idx="24">
                  <c:v>87.903225806451616</c:v>
                </c:pt>
                <c:pt idx="25">
                  <c:v>88.034188034188006</c:v>
                </c:pt>
                <c:pt idx="26">
                  <c:v>88.679245283018872</c:v>
                </c:pt>
                <c:pt idx="27">
                  <c:v>88.8888888888889</c:v>
                </c:pt>
                <c:pt idx="28">
                  <c:v>90.425531914893625</c:v>
                </c:pt>
                <c:pt idx="29">
                  <c:v>91.428571428571431</c:v>
                </c:pt>
                <c:pt idx="30">
                  <c:v>91.54929577464786</c:v>
                </c:pt>
                <c:pt idx="31">
                  <c:v>91.780821917808225</c:v>
                </c:pt>
                <c:pt idx="32">
                  <c:v>91.8032786885246</c:v>
                </c:pt>
                <c:pt idx="33">
                  <c:v>91.935483870967744</c:v>
                </c:pt>
                <c:pt idx="34">
                  <c:v>91.964285714285708</c:v>
                </c:pt>
                <c:pt idx="35">
                  <c:v>92.151162790697668</c:v>
                </c:pt>
                <c:pt idx="36">
                  <c:v>92.187500000000014</c:v>
                </c:pt>
                <c:pt idx="37">
                  <c:v>92.38095238095238</c:v>
                </c:pt>
                <c:pt idx="38">
                  <c:v>92.473118279569917</c:v>
                </c:pt>
                <c:pt idx="39">
                  <c:v>92.805755395683448</c:v>
                </c:pt>
                <c:pt idx="40">
                  <c:v>92.874692874692883</c:v>
                </c:pt>
                <c:pt idx="41">
                  <c:v>92.897727272727252</c:v>
                </c:pt>
                <c:pt idx="42">
                  <c:v>92.941176470588218</c:v>
                </c:pt>
                <c:pt idx="43">
                  <c:v>93.162393162393158</c:v>
                </c:pt>
                <c:pt idx="44">
                  <c:v>93.373493975903628</c:v>
                </c:pt>
                <c:pt idx="45">
                  <c:v>93.781094527363194</c:v>
                </c:pt>
                <c:pt idx="46">
                  <c:v>93.798449612403104</c:v>
                </c:pt>
                <c:pt idx="47">
                  <c:v>94.174757281553426</c:v>
                </c:pt>
                <c:pt idx="48">
                  <c:v>94.39252336448601</c:v>
                </c:pt>
                <c:pt idx="49">
                  <c:v>94.666666666666686</c:v>
                </c:pt>
                <c:pt idx="50">
                  <c:v>95.424836601307177</c:v>
                </c:pt>
                <c:pt idx="51">
                  <c:v>95.65217391304347</c:v>
                </c:pt>
                <c:pt idx="52">
                  <c:v>95.652173913043498</c:v>
                </c:pt>
                <c:pt idx="53">
                  <c:v>95.942720763723131</c:v>
                </c:pt>
                <c:pt idx="54">
                  <c:v>96.153846153846104</c:v>
                </c:pt>
                <c:pt idx="55">
                  <c:v>96.428571428571402</c:v>
                </c:pt>
                <c:pt idx="56">
                  <c:v>97.169811320754718</c:v>
                </c:pt>
                <c:pt idx="57">
                  <c:v>97.297297297297334</c:v>
                </c:pt>
                <c:pt idx="58">
                  <c:v>97.330097087378675</c:v>
                </c:pt>
                <c:pt idx="59">
                  <c:v>97.52066115702479</c:v>
                </c:pt>
                <c:pt idx="60">
                  <c:v>98.113207547169822</c:v>
                </c:pt>
                <c:pt idx="61">
                  <c:v>98.52941176470587</c:v>
                </c:pt>
                <c:pt idx="62">
                  <c:v>99.137931034482776</c:v>
                </c:pt>
                <c:pt idx="63">
                  <c:v>99.218749999999986</c:v>
                </c:pt>
                <c:pt idx="64">
                  <c:v>99.999999999999943</c:v>
                </c:pt>
                <c:pt idx="65">
                  <c:v>99.999999999999957</c:v>
                </c:pt>
                <c:pt idx="66">
                  <c:v>100</c:v>
                </c:pt>
                <c:pt idx="67">
                  <c:v>100.00000000000007</c:v>
                </c:pt>
                <c:pt idx="68">
                  <c:v>100.88495575221239</c:v>
                </c:pt>
                <c:pt idx="69">
                  <c:v>101.40186915887854</c:v>
                </c:pt>
                <c:pt idx="70">
                  <c:v>101.44927536231883</c:v>
                </c:pt>
                <c:pt idx="71">
                  <c:v>101.8018018018018</c:v>
                </c:pt>
                <c:pt idx="72">
                  <c:v>101.96078431372551</c:v>
                </c:pt>
                <c:pt idx="73">
                  <c:v>102.53164556962024</c:v>
                </c:pt>
                <c:pt idx="74">
                  <c:v>102.77777777777777</c:v>
                </c:pt>
                <c:pt idx="75">
                  <c:v>102.96296296296299</c:v>
                </c:pt>
                <c:pt idx="76">
                  <c:v>103.47826086956519</c:v>
                </c:pt>
                <c:pt idx="77">
                  <c:v>104.41176470588236</c:v>
                </c:pt>
                <c:pt idx="78">
                  <c:v>104.61538461538463</c:v>
                </c:pt>
                <c:pt idx="79">
                  <c:v>104.6875</c:v>
                </c:pt>
                <c:pt idx="80">
                  <c:v>105.71428571428569</c:v>
                </c:pt>
                <c:pt idx="81">
                  <c:v>105.71428571428572</c:v>
                </c:pt>
                <c:pt idx="82">
                  <c:v>106.24999999999997</c:v>
                </c:pt>
                <c:pt idx="83">
                  <c:v>106.6037735849057</c:v>
                </c:pt>
                <c:pt idx="84">
                  <c:v>106.79611650485434</c:v>
                </c:pt>
                <c:pt idx="85">
                  <c:v>106.87022900763358</c:v>
                </c:pt>
                <c:pt idx="86">
                  <c:v>108.57142857142857</c:v>
                </c:pt>
                <c:pt idx="87">
                  <c:v>108.95522388059702</c:v>
                </c:pt>
                <c:pt idx="88">
                  <c:v>109.99999999999999</c:v>
                </c:pt>
                <c:pt idx="89">
                  <c:v>114.28571428571428</c:v>
                </c:pt>
                <c:pt idx="90">
                  <c:v>121.77419354838712</c:v>
                </c:pt>
                <c:pt idx="91">
                  <c:v>123.07692307692307</c:v>
                </c:pt>
                <c:pt idx="92">
                  <c:v>124.24242424242429</c:v>
                </c:pt>
                <c:pt idx="93">
                  <c:v>129.6296296296297</c:v>
                </c:pt>
                <c:pt idx="94">
                  <c:v>164.86486486486476</c:v>
                </c:pt>
                <c:pt idx="95">
                  <c:v>179.1666666666666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431808"/>
        <c:axId val="69432960"/>
      </c:scatterChart>
      <c:valAx>
        <c:axId val="6943180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69432960"/>
        <c:crosses val="autoZero"/>
        <c:crossBetween val="midCat"/>
      </c:valAx>
      <c:valAx>
        <c:axId val="69432960"/>
        <c:scaling>
          <c:orientation val="minMax"/>
          <c:max val="180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943180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6846104091893279"/>
          <c:y val="0.61401319626713335"/>
          <c:w val="0.3926500915928256"/>
          <c:h val="0.202528798483522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784442353627376"/>
          <c:y val="5.1400554097404488E-2"/>
          <c:w val="0.67217227599711138"/>
          <c:h val="0.81873067949839606"/>
        </c:manualLayout>
      </c:layout>
      <c:scatterChart>
        <c:scatterStyle val="lineMarker"/>
        <c:varyColors val="0"/>
        <c:ser>
          <c:idx val="1"/>
          <c:order val="0"/>
          <c:tx>
            <c:strRef>
              <c:f>'formic acid'!$D$1</c:f>
              <c:strCache>
                <c:ptCount val="1"/>
                <c:pt idx="0">
                  <c:v>Form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formic acid'!$B$2:$B$97</c:f>
              <c:strCache>
                <c:ptCount val="96"/>
                <c:pt idx="0">
                  <c:v>B8</c:v>
                </c:pt>
                <c:pt idx="1">
                  <c:v>B1</c:v>
                </c:pt>
                <c:pt idx="2">
                  <c:v>H6</c:v>
                </c:pt>
                <c:pt idx="3">
                  <c:v>H7</c:v>
                </c:pt>
                <c:pt idx="4">
                  <c:v>D10</c:v>
                </c:pt>
                <c:pt idx="5">
                  <c:v>E2</c:v>
                </c:pt>
                <c:pt idx="6">
                  <c:v>H10</c:v>
                </c:pt>
                <c:pt idx="7">
                  <c:v>D3</c:v>
                </c:pt>
                <c:pt idx="8">
                  <c:v>H2</c:v>
                </c:pt>
                <c:pt idx="9">
                  <c:v>C3</c:v>
                </c:pt>
                <c:pt idx="10">
                  <c:v>D1</c:v>
                </c:pt>
                <c:pt idx="11">
                  <c:v>D2</c:v>
                </c:pt>
                <c:pt idx="12">
                  <c:v>F2</c:v>
                </c:pt>
                <c:pt idx="13">
                  <c:v>D9</c:v>
                </c:pt>
                <c:pt idx="14">
                  <c:v>D7</c:v>
                </c:pt>
                <c:pt idx="15">
                  <c:v>E4</c:v>
                </c:pt>
                <c:pt idx="16">
                  <c:v>E9</c:v>
                </c:pt>
                <c:pt idx="17">
                  <c:v>E5</c:v>
                </c:pt>
                <c:pt idx="18">
                  <c:v>H3</c:v>
                </c:pt>
                <c:pt idx="19">
                  <c:v>A2</c:v>
                </c:pt>
                <c:pt idx="20">
                  <c:v>A7</c:v>
                </c:pt>
                <c:pt idx="21">
                  <c:v>A4</c:v>
                </c:pt>
                <c:pt idx="22">
                  <c:v>F1</c:v>
                </c:pt>
                <c:pt idx="23">
                  <c:v>H5</c:v>
                </c:pt>
                <c:pt idx="24">
                  <c:v>D11</c:v>
                </c:pt>
                <c:pt idx="25">
                  <c:v>H1</c:v>
                </c:pt>
                <c:pt idx="26">
                  <c:v>D12</c:v>
                </c:pt>
                <c:pt idx="27">
                  <c:v>E7</c:v>
                </c:pt>
                <c:pt idx="28">
                  <c:v>B4</c:v>
                </c:pt>
                <c:pt idx="29">
                  <c:v>C10</c:v>
                </c:pt>
                <c:pt idx="30">
                  <c:v>G7</c:v>
                </c:pt>
                <c:pt idx="31">
                  <c:v>H12</c:v>
                </c:pt>
                <c:pt idx="32">
                  <c:v>E10</c:v>
                </c:pt>
                <c:pt idx="33">
                  <c:v>G9</c:v>
                </c:pt>
                <c:pt idx="34">
                  <c:v>C1</c:v>
                </c:pt>
                <c:pt idx="35">
                  <c:v>H9</c:v>
                </c:pt>
                <c:pt idx="36">
                  <c:v>H4</c:v>
                </c:pt>
                <c:pt idx="37">
                  <c:v>F11</c:v>
                </c:pt>
                <c:pt idx="38">
                  <c:v>B12</c:v>
                </c:pt>
                <c:pt idx="39">
                  <c:v>G4</c:v>
                </c:pt>
                <c:pt idx="40">
                  <c:v>A6</c:v>
                </c:pt>
                <c:pt idx="41">
                  <c:v>G6</c:v>
                </c:pt>
                <c:pt idx="42">
                  <c:v>A11</c:v>
                </c:pt>
                <c:pt idx="43">
                  <c:v>C4</c:v>
                </c:pt>
                <c:pt idx="44">
                  <c:v>F4</c:v>
                </c:pt>
                <c:pt idx="45">
                  <c:v>F10</c:v>
                </c:pt>
                <c:pt idx="46">
                  <c:v>C2</c:v>
                </c:pt>
                <c:pt idx="47">
                  <c:v>H11</c:v>
                </c:pt>
                <c:pt idx="48">
                  <c:v>E11</c:v>
                </c:pt>
                <c:pt idx="49">
                  <c:v>A9</c:v>
                </c:pt>
                <c:pt idx="50">
                  <c:v>A8</c:v>
                </c:pt>
                <c:pt idx="51">
                  <c:v>A5</c:v>
                </c:pt>
                <c:pt idx="52">
                  <c:v>C11</c:v>
                </c:pt>
                <c:pt idx="53">
                  <c:v>D6</c:v>
                </c:pt>
                <c:pt idx="54">
                  <c:v>F9</c:v>
                </c:pt>
                <c:pt idx="55">
                  <c:v>B7</c:v>
                </c:pt>
                <c:pt idx="56">
                  <c:v>C5</c:v>
                </c:pt>
                <c:pt idx="57">
                  <c:v>B5</c:v>
                </c:pt>
                <c:pt idx="58">
                  <c:v>G8</c:v>
                </c:pt>
                <c:pt idx="59">
                  <c:v>G5</c:v>
                </c:pt>
                <c:pt idx="60">
                  <c:v>H8</c:v>
                </c:pt>
                <c:pt idx="61">
                  <c:v>A12</c:v>
                </c:pt>
                <c:pt idx="62">
                  <c:v>F7</c:v>
                </c:pt>
                <c:pt idx="63">
                  <c:v>G11</c:v>
                </c:pt>
                <c:pt idx="64">
                  <c:v>G2</c:v>
                </c:pt>
                <c:pt idx="65">
                  <c:v>G3</c:v>
                </c:pt>
                <c:pt idx="66">
                  <c:v>F5</c:v>
                </c:pt>
                <c:pt idx="67">
                  <c:v>E8</c:v>
                </c:pt>
                <c:pt idx="68">
                  <c:v>F3</c:v>
                </c:pt>
                <c:pt idx="69">
                  <c:v>C12</c:v>
                </c:pt>
                <c:pt idx="70">
                  <c:v>A1</c:v>
                </c:pt>
                <c:pt idx="71">
                  <c:v>E1</c:v>
                </c:pt>
                <c:pt idx="72">
                  <c:v>B2</c:v>
                </c:pt>
                <c:pt idx="73">
                  <c:v>A3</c:v>
                </c:pt>
                <c:pt idx="74">
                  <c:v>A10</c:v>
                </c:pt>
                <c:pt idx="75">
                  <c:v>E3</c:v>
                </c:pt>
                <c:pt idx="76">
                  <c:v>E12</c:v>
                </c:pt>
                <c:pt idx="77">
                  <c:v>G10</c:v>
                </c:pt>
                <c:pt idx="78">
                  <c:v>B9</c:v>
                </c:pt>
                <c:pt idx="79">
                  <c:v>D4</c:v>
                </c:pt>
                <c:pt idx="80">
                  <c:v>F6</c:v>
                </c:pt>
                <c:pt idx="81">
                  <c:v>G12</c:v>
                </c:pt>
                <c:pt idx="82">
                  <c:v>D5</c:v>
                </c:pt>
                <c:pt idx="83">
                  <c:v>C6</c:v>
                </c:pt>
                <c:pt idx="84">
                  <c:v>B10</c:v>
                </c:pt>
                <c:pt idx="85">
                  <c:v>B11</c:v>
                </c:pt>
                <c:pt idx="86">
                  <c:v>G1</c:v>
                </c:pt>
                <c:pt idx="87">
                  <c:v>B3</c:v>
                </c:pt>
                <c:pt idx="88">
                  <c:v>D8</c:v>
                </c:pt>
                <c:pt idx="89">
                  <c:v>F8</c:v>
                </c:pt>
                <c:pt idx="90">
                  <c:v>C7</c:v>
                </c:pt>
                <c:pt idx="91">
                  <c:v>B6</c:v>
                </c:pt>
                <c:pt idx="92">
                  <c:v>C9</c:v>
                </c:pt>
                <c:pt idx="93">
                  <c:v>E6</c:v>
                </c:pt>
                <c:pt idx="94">
                  <c:v>C8</c:v>
                </c:pt>
                <c:pt idx="95">
                  <c:v>F12</c:v>
                </c:pt>
              </c:strCache>
            </c:strRef>
          </c:xVal>
          <c:yVal>
            <c:numRef>
              <c:f>'formic acid'!$D$2:$D$97</c:f>
              <c:numCache>
                <c:formatCode>General</c:formatCode>
                <c:ptCount val="96"/>
                <c:pt idx="0">
                  <c:v>58.878504672897193</c:v>
                </c:pt>
                <c:pt idx="1">
                  <c:v>70.707070707070713</c:v>
                </c:pt>
                <c:pt idx="2">
                  <c:v>77.692307692307679</c:v>
                </c:pt>
                <c:pt idx="3">
                  <c:v>79.487179487179503</c:v>
                </c:pt>
                <c:pt idx="4">
                  <c:v>79.999999999999986</c:v>
                </c:pt>
                <c:pt idx="5">
                  <c:v>79.999999999999986</c:v>
                </c:pt>
                <c:pt idx="6">
                  <c:v>81.967213114754117</c:v>
                </c:pt>
                <c:pt idx="7">
                  <c:v>82.500000000000014</c:v>
                </c:pt>
                <c:pt idx="8">
                  <c:v>83.636363636363626</c:v>
                </c:pt>
                <c:pt idx="9">
                  <c:v>83.695652173913032</c:v>
                </c:pt>
                <c:pt idx="10">
                  <c:v>83.898305084745772</c:v>
                </c:pt>
                <c:pt idx="11">
                  <c:v>84.403669724770623</c:v>
                </c:pt>
                <c:pt idx="12">
                  <c:v>84.905660377358458</c:v>
                </c:pt>
                <c:pt idx="13">
                  <c:v>85.585585585585605</c:v>
                </c:pt>
                <c:pt idx="14">
                  <c:v>86.274509803921575</c:v>
                </c:pt>
                <c:pt idx="15">
                  <c:v>86.274509803921575</c:v>
                </c:pt>
                <c:pt idx="16">
                  <c:v>86.734693877551038</c:v>
                </c:pt>
                <c:pt idx="17">
                  <c:v>87.068965517241395</c:v>
                </c:pt>
                <c:pt idx="18">
                  <c:v>88</c:v>
                </c:pt>
                <c:pt idx="19">
                  <c:v>88.081395348837205</c:v>
                </c:pt>
                <c:pt idx="20">
                  <c:v>88.101265822784796</c:v>
                </c:pt>
                <c:pt idx="21">
                  <c:v>88.101265822784825</c:v>
                </c:pt>
                <c:pt idx="22">
                  <c:v>88.181818181818159</c:v>
                </c:pt>
                <c:pt idx="23">
                  <c:v>88.39285714285711</c:v>
                </c:pt>
                <c:pt idx="24">
                  <c:v>88.764044943820238</c:v>
                </c:pt>
                <c:pt idx="25">
                  <c:v>88.800000000000026</c:v>
                </c:pt>
                <c:pt idx="26">
                  <c:v>89.090909090909093</c:v>
                </c:pt>
                <c:pt idx="27">
                  <c:v>89.523809523809547</c:v>
                </c:pt>
                <c:pt idx="28">
                  <c:v>89.65517241379311</c:v>
                </c:pt>
                <c:pt idx="29">
                  <c:v>90.082644628099146</c:v>
                </c:pt>
                <c:pt idx="30">
                  <c:v>90.909090909090935</c:v>
                </c:pt>
                <c:pt idx="31">
                  <c:v>90.972222222222229</c:v>
                </c:pt>
                <c:pt idx="32">
                  <c:v>91.428571428571445</c:v>
                </c:pt>
                <c:pt idx="33">
                  <c:v>92.079207920792086</c:v>
                </c:pt>
                <c:pt idx="34">
                  <c:v>92.307692307692307</c:v>
                </c:pt>
                <c:pt idx="35">
                  <c:v>92.391304347826051</c:v>
                </c:pt>
                <c:pt idx="36">
                  <c:v>92.473118279569917</c:v>
                </c:pt>
                <c:pt idx="37">
                  <c:v>92.631578947368411</c:v>
                </c:pt>
                <c:pt idx="38">
                  <c:v>92.7083333333333</c:v>
                </c:pt>
                <c:pt idx="39">
                  <c:v>92.857142857142875</c:v>
                </c:pt>
                <c:pt idx="40">
                  <c:v>92.920353982300895</c:v>
                </c:pt>
                <c:pt idx="41">
                  <c:v>93.000000000000014</c:v>
                </c:pt>
                <c:pt idx="42">
                  <c:v>93.000000000000028</c:v>
                </c:pt>
                <c:pt idx="43">
                  <c:v>93.043478260869577</c:v>
                </c:pt>
                <c:pt idx="44">
                  <c:v>93.269230769230759</c:v>
                </c:pt>
                <c:pt idx="45">
                  <c:v>93.45794392523365</c:v>
                </c:pt>
                <c:pt idx="46">
                  <c:v>93.577981651376135</c:v>
                </c:pt>
                <c:pt idx="47">
                  <c:v>93.617021276595722</c:v>
                </c:pt>
                <c:pt idx="48">
                  <c:v>93.750000000000028</c:v>
                </c:pt>
                <c:pt idx="49">
                  <c:v>93.870967741935516</c:v>
                </c:pt>
                <c:pt idx="50">
                  <c:v>94.285714285714278</c:v>
                </c:pt>
                <c:pt idx="51">
                  <c:v>94.508670520231249</c:v>
                </c:pt>
                <c:pt idx="52">
                  <c:v>94.565217391304358</c:v>
                </c:pt>
                <c:pt idx="53">
                  <c:v>95.098039215686299</c:v>
                </c:pt>
                <c:pt idx="54">
                  <c:v>95.283018867924511</c:v>
                </c:pt>
                <c:pt idx="55">
                  <c:v>95.454545454545425</c:v>
                </c:pt>
                <c:pt idx="56">
                  <c:v>95.78947368421052</c:v>
                </c:pt>
                <c:pt idx="57">
                  <c:v>95.833333333333329</c:v>
                </c:pt>
                <c:pt idx="58">
                  <c:v>95.833333333333329</c:v>
                </c:pt>
                <c:pt idx="59">
                  <c:v>95.967741935483872</c:v>
                </c:pt>
                <c:pt idx="60">
                  <c:v>96.000000000000014</c:v>
                </c:pt>
                <c:pt idx="61">
                  <c:v>96.072507552870093</c:v>
                </c:pt>
                <c:pt idx="62">
                  <c:v>96.226415094339629</c:v>
                </c:pt>
                <c:pt idx="63">
                  <c:v>96.250000000000028</c:v>
                </c:pt>
                <c:pt idx="64">
                  <c:v>96.396396396396383</c:v>
                </c:pt>
                <c:pt idx="65">
                  <c:v>96.551724137931032</c:v>
                </c:pt>
                <c:pt idx="66">
                  <c:v>96.747967479674813</c:v>
                </c:pt>
                <c:pt idx="67">
                  <c:v>96.938775510204081</c:v>
                </c:pt>
                <c:pt idx="68">
                  <c:v>96.946564885496173</c:v>
                </c:pt>
                <c:pt idx="69">
                  <c:v>96.946564885496187</c:v>
                </c:pt>
                <c:pt idx="70">
                  <c:v>97.032640949554903</c:v>
                </c:pt>
                <c:pt idx="71">
                  <c:v>97.058823529411811</c:v>
                </c:pt>
                <c:pt idx="72">
                  <c:v>97.169811320754718</c:v>
                </c:pt>
                <c:pt idx="73">
                  <c:v>98.019801980198025</c:v>
                </c:pt>
                <c:pt idx="74">
                  <c:v>98.108108108108098</c:v>
                </c:pt>
                <c:pt idx="75">
                  <c:v>98.130841121495294</c:v>
                </c:pt>
                <c:pt idx="76">
                  <c:v>99.065420560747654</c:v>
                </c:pt>
                <c:pt idx="77">
                  <c:v>99.107142857142875</c:v>
                </c:pt>
                <c:pt idx="78">
                  <c:v>99.999999999999972</c:v>
                </c:pt>
                <c:pt idx="79">
                  <c:v>100</c:v>
                </c:pt>
                <c:pt idx="80">
                  <c:v>100</c:v>
                </c:pt>
                <c:pt idx="81">
                  <c:v>100.99999999999996</c:v>
                </c:pt>
                <c:pt idx="82">
                  <c:v>101.88679245283019</c:v>
                </c:pt>
                <c:pt idx="83">
                  <c:v>101.9047619047619</c:v>
                </c:pt>
                <c:pt idx="84">
                  <c:v>103.2</c:v>
                </c:pt>
                <c:pt idx="85">
                  <c:v>103.96039603960399</c:v>
                </c:pt>
                <c:pt idx="86">
                  <c:v>104.50450450450452</c:v>
                </c:pt>
                <c:pt idx="87">
                  <c:v>104.58715596330276</c:v>
                </c:pt>
                <c:pt idx="88">
                  <c:v>105.49450549450552</c:v>
                </c:pt>
                <c:pt idx="89">
                  <c:v>105.94059405940595</c:v>
                </c:pt>
                <c:pt idx="90">
                  <c:v>106.30630630630627</c:v>
                </c:pt>
                <c:pt idx="91">
                  <c:v>106.95652173913047</c:v>
                </c:pt>
                <c:pt idx="92">
                  <c:v>107.60869565217392</c:v>
                </c:pt>
                <c:pt idx="93">
                  <c:v>107.61904761904762</c:v>
                </c:pt>
                <c:pt idx="94">
                  <c:v>108.16326530612245</c:v>
                </c:pt>
                <c:pt idx="95">
                  <c:v>118.269230769230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083328"/>
        <c:axId val="34083904"/>
      </c:scatterChart>
      <c:valAx>
        <c:axId val="3408332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4083904"/>
        <c:crosses val="autoZero"/>
        <c:crossBetween val="midCat"/>
      </c:valAx>
      <c:valAx>
        <c:axId val="34083904"/>
        <c:scaling>
          <c:orientation val="minMax"/>
          <c:max val="12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408332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3602865674857678"/>
          <c:y val="0.60323762577631967"/>
          <c:w val="0.3169598802747407"/>
          <c:h val="9.2104324671310717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03405725047343"/>
          <c:y val="5.1400554097404488E-2"/>
          <c:w val="0.70107981476341241"/>
          <c:h val="0.81873067949839606"/>
        </c:manualLayout>
      </c:layout>
      <c:scatterChart>
        <c:scatterStyle val="lineMarker"/>
        <c:varyColors val="0"/>
        <c:ser>
          <c:idx val="2"/>
          <c:order val="0"/>
          <c:tx>
            <c:strRef>
              <c:f>furfural!$E$1</c:f>
              <c:strCache>
                <c:ptCount val="1"/>
                <c:pt idx="0">
                  <c:v>Furfura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furfural!$B$2:$B$97</c:f>
              <c:strCache>
                <c:ptCount val="96"/>
                <c:pt idx="0">
                  <c:v>D1</c:v>
                </c:pt>
                <c:pt idx="1">
                  <c:v>D9</c:v>
                </c:pt>
                <c:pt idx="2">
                  <c:v>E1</c:v>
                </c:pt>
                <c:pt idx="3">
                  <c:v>C11</c:v>
                </c:pt>
                <c:pt idx="4">
                  <c:v>D6</c:v>
                </c:pt>
                <c:pt idx="5">
                  <c:v>B9</c:v>
                </c:pt>
                <c:pt idx="6">
                  <c:v>E11</c:v>
                </c:pt>
                <c:pt idx="7">
                  <c:v>B1</c:v>
                </c:pt>
                <c:pt idx="8">
                  <c:v>D2</c:v>
                </c:pt>
                <c:pt idx="9">
                  <c:v>E9</c:v>
                </c:pt>
                <c:pt idx="10">
                  <c:v>D11</c:v>
                </c:pt>
                <c:pt idx="11">
                  <c:v>G6</c:v>
                </c:pt>
                <c:pt idx="12">
                  <c:v>F9</c:v>
                </c:pt>
                <c:pt idx="13">
                  <c:v>F11</c:v>
                </c:pt>
                <c:pt idx="14">
                  <c:v>A9</c:v>
                </c:pt>
                <c:pt idx="15">
                  <c:v>C1</c:v>
                </c:pt>
                <c:pt idx="16">
                  <c:v>A5</c:v>
                </c:pt>
                <c:pt idx="17">
                  <c:v>F2</c:v>
                </c:pt>
                <c:pt idx="18">
                  <c:v>C9</c:v>
                </c:pt>
                <c:pt idx="19">
                  <c:v>F1</c:v>
                </c:pt>
                <c:pt idx="20">
                  <c:v>F10</c:v>
                </c:pt>
                <c:pt idx="21">
                  <c:v>D10</c:v>
                </c:pt>
                <c:pt idx="22">
                  <c:v>E5</c:v>
                </c:pt>
                <c:pt idx="23">
                  <c:v>A7</c:v>
                </c:pt>
                <c:pt idx="24">
                  <c:v>D8</c:v>
                </c:pt>
                <c:pt idx="25">
                  <c:v>C8</c:v>
                </c:pt>
                <c:pt idx="26">
                  <c:v>H6</c:v>
                </c:pt>
                <c:pt idx="27">
                  <c:v>E6</c:v>
                </c:pt>
                <c:pt idx="28">
                  <c:v>E8</c:v>
                </c:pt>
                <c:pt idx="29">
                  <c:v>D12</c:v>
                </c:pt>
                <c:pt idx="30">
                  <c:v>G2</c:v>
                </c:pt>
                <c:pt idx="31">
                  <c:v>A1</c:v>
                </c:pt>
                <c:pt idx="32">
                  <c:v>B6</c:v>
                </c:pt>
                <c:pt idx="33">
                  <c:v>C12</c:v>
                </c:pt>
                <c:pt idx="34">
                  <c:v>B7</c:v>
                </c:pt>
                <c:pt idx="35">
                  <c:v>A8</c:v>
                </c:pt>
                <c:pt idx="36">
                  <c:v>D3</c:v>
                </c:pt>
                <c:pt idx="37">
                  <c:v>H3</c:v>
                </c:pt>
                <c:pt idx="38">
                  <c:v>G7</c:v>
                </c:pt>
                <c:pt idx="39">
                  <c:v>E2</c:v>
                </c:pt>
                <c:pt idx="40">
                  <c:v>A4</c:v>
                </c:pt>
                <c:pt idx="41">
                  <c:v>B2</c:v>
                </c:pt>
                <c:pt idx="42">
                  <c:v>F6</c:v>
                </c:pt>
                <c:pt idx="43">
                  <c:v>G1</c:v>
                </c:pt>
                <c:pt idx="44">
                  <c:v>G11</c:v>
                </c:pt>
                <c:pt idx="45">
                  <c:v>F5</c:v>
                </c:pt>
                <c:pt idx="46">
                  <c:v>B4</c:v>
                </c:pt>
                <c:pt idx="47">
                  <c:v>G9</c:v>
                </c:pt>
                <c:pt idx="48">
                  <c:v>C10</c:v>
                </c:pt>
                <c:pt idx="49">
                  <c:v>H1</c:v>
                </c:pt>
                <c:pt idx="50">
                  <c:v>H9</c:v>
                </c:pt>
                <c:pt idx="51">
                  <c:v>G4</c:v>
                </c:pt>
                <c:pt idx="52">
                  <c:v>F8</c:v>
                </c:pt>
                <c:pt idx="53">
                  <c:v>C3</c:v>
                </c:pt>
                <c:pt idx="54">
                  <c:v>F4</c:v>
                </c:pt>
                <c:pt idx="55">
                  <c:v>B10</c:v>
                </c:pt>
                <c:pt idx="56">
                  <c:v>A11</c:v>
                </c:pt>
                <c:pt idx="57">
                  <c:v>H11</c:v>
                </c:pt>
                <c:pt idx="58">
                  <c:v>C2</c:v>
                </c:pt>
                <c:pt idx="59">
                  <c:v>E4</c:v>
                </c:pt>
                <c:pt idx="60">
                  <c:v>G8</c:v>
                </c:pt>
                <c:pt idx="61">
                  <c:v>B3</c:v>
                </c:pt>
                <c:pt idx="62">
                  <c:v>D7</c:v>
                </c:pt>
                <c:pt idx="63">
                  <c:v>F3</c:v>
                </c:pt>
                <c:pt idx="64">
                  <c:v>C7</c:v>
                </c:pt>
                <c:pt idx="65">
                  <c:v>F7</c:v>
                </c:pt>
                <c:pt idx="66">
                  <c:v>A12</c:v>
                </c:pt>
                <c:pt idx="67">
                  <c:v>B12</c:v>
                </c:pt>
                <c:pt idx="68">
                  <c:v>H2</c:v>
                </c:pt>
                <c:pt idx="69">
                  <c:v>C6</c:v>
                </c:pt>
                <c:pt idx="70">
                  <c:v>H7</c:v>
                </c:pt>
                <c:pt idx="71">
                  <c:v>A2</c:v>
                </c:pt>
                <c:pt idx="72">
                  <c:v>G5</c:v>
                </c:pt>
                <c:pt idx="73">
                  <c:v>A6</c:v>
                </c:pt>
                <c:pt idx="74">
                  <c:v>C5</c:v>
                </c:pt>
                <c:pt idx="75">
                  <c:v>A10</c:v>
                </c:pt>
                <c:pt idx="76">
                  <c:v>B8</c:v>
                </c:pt>
                <c:pt idx="77">
                  <c:v>E7</c:v>
                </c:pt>
                <c:pt idx="78">
                  <c:v>E10</c:v>
                </c:pt>
                <c:pt idx="79">
                  <c:v>B5</c:v>
                </c:pt>
                <c:pt idx="80">
                  <c:v>H4</c:v>
                </c:pt>
                <c:pt idx="81">
                  <c:v>H5</c:v>
                </c:pt>
                <c:pt idx="82">
                  <c:v>C4</c:v>
                </c:pt>
                <c:pt idx="83">
                  <c:v>D4</c:v>
                </c:pt>
                <c:pt idx="84">
                  <c:v>E3</c:v>
                </c:pt>
                <c:pt idx="85">
                  <c:v>G3</c:v>
                </c:pt>
                <c:pt idx="86">
                  <c:v>H8</c:v>
                </c:pt>
                <c:pt idx="87">
                  <c:v>D5</c:v>
                </c:pt>
                <c:pt idx="88">
                  <c:v>G10</c:v>
                </c:pt>
                <c:pt idx="89">
                  <c:v>G12</c:v>
                </c:pt>
                <c:pt idx="90">
                  <c:v>A3</c:v>
                </c:pt>
                <c:pt idx="91">
                  <c:v>B11</c:v>
                </c:pt>
                <c:pt idx="92">
                  <c:v>H12</c:v>
                </c:pt>
                <c:pt idx="93">
                  <c:v>F12</c:v>
                </c:pt>
                <c:pt idx="94">
                  <c:v>H10</c:v>
                </c:pt>
                <c:pt idx="95">
                  <c:v>E12</c:v>
                </c:pt>
              </c:strCache>
            </c:strRef>
          </c:xVal>
          <c:yVal>
            <c:numRef>
              <c:f>furfural!$E$2:$E$97</c:f>
              <c:numCache>
                <c:formatCode>General</c:formatCode>
                <c:ptCount val="96"/>
                <c:pt idx="0">
                  <c:v>55.913978494623649</c:v>
                </c:pt>
                <c:pt idx="1">
                  <c:v>57.000000000000007</c:v>
                </c:pt>
                <c:pt idx="2">
                  <c:v>61.111111111111136</c:v>
                </c:pt>
                <c:pt idx="3">
                  <c:v>63.636363636363633</c:v>
                </c:pt>
                <c:pt idx="4">
                  <c:v>64.077669902912646</c:v>
                </c:pt>
                <c:pt idx="5">
                  <c:v>64.89361702127664</c:v>
                </c:pt>
                <c:pt idx="6">
                  <c:v>65.909090909090935</c:v>
                </c:pt>
                <c:pt idx="7">
                  <c:v>66.326530612244895</c:v>
                </c:pt>
                <c:pt idx="8">
                  <c:v>66.666666666666657</c:v>
                </c:pt>
                <c:pt idx="9">
                  <c:v>66.666666666666657</c:v>
                </c:pt>
                <c:pt idx="10">
                  <c:v>66.666666666666671</c:v>
                </c:pt>
                <c:pt idx="11">
                  <c:v>67.346938775510196</c:v>
                </c:pt>
                <c:pt idx="12">
                  <c:v>67.816091954022966</c:v>
                </c:pt>
                <c:pt idx="13">
                  <c:v>67.924528301886767</c:v>
                </c:pt>
                <c:pt idx="14">
                  <c:v>68.093385214007768</c:v>
                </c:pt>
                <c:pt idx="15">
                  <c:v>68.224299065420553</c:v>
                </c:pt>
                <c:pt idx="16">
                  <c:v>69.085173501577316</c:v>
                </c:pt>
                <c:pt idx="17">
                  <c:v>70.129870129870127</c:v>
                </c:pt>
                <c:pt idx="18">
                  <c:v>70.238095238095227</c:v>
                </c:pt>
                <c:pt idx="19">
                  <c:v>70.707070707070713</c:v>
                </c:pt>
                <c:pt idx="20">
                  <c:v>71.264367816091962</c:v>
                </c:pt>
                <c:pt idx="21">
                  <c:v>71.604938271604922</c:v>
                </c:pt>
                <c:pt idx="22">
                  <c:v>72.043010752688161</c:v>
                </c:pt>
                <c:pt idx="23">
                  <c:v>72.135416666666671</c:v>
                </c:pt>
                <c:pt idx="24">
                  <c:v>72.448979591836732</c:v>
                </c:pt>
                <c:pt idx="25">
                  <c:v>72.61904761904762</c:v>
                </c:pt>
                <c:pt idx="26">
                  <c:v>72.727272727272705</c:v>
                </c:pt>
                <c:pt idx="27">
                  <c:v>72.727272727272734</c:v>
                </c:pt>
                <c:pt idx="28">
                  <c:v>73</c:v>
                </c:pt>
                <c:pt idx="29">
                  <c:v>73.809523809523824</c:v>
                </c:pt>
                <c:pt idx="30">
                  <c:v>74.157303370786522</c:v>
                </c:pt>
                <c:pt idx="31">
                  <c:v>74.450549450549431</c:v>
                </c:pt>
                <c:pt idx="32">
                  <c:v>74.50980392156859</c:v>
                </c:pt>
                <c:pt idx="33">
                  <c:v>74.698795180722925</c:v>
                </c:pt>
                <c:pt idx="34">
                  <c:v>75.555555555555586</c:v>
                </c:pt>
                <c:pt idx="35">
                  <c:v>75.684931506849324</c:v>
                </c:pt>
                <c:pt idx="36">
                  <c:v>75.789473684210492</c:v>
                </c:pt>
                <c:pt idx="37">
                  <c:v>75.862068965517196</c:v>
                </c:pt>
                <c:pt idx="38">
                  <c:v>76</c:v>
                </c:pt>
                <c:pt idx="39">
                  <c:v>76.119402985074643</c:v>
                </c:pt>
                <c:pt idx="40">
                  <c:v>76.589595375722467</c:v>
                </c:pt>
                <c:pt idx="41">
                  <c:v>76.623376623376629</c:v>
                </c:pt>
                <c:pt idx="42">
                  <c:v>76.767676767676747</c:v>
                </c:pt>
                <c:pt idx="43">
                  <c:v>76.84210526315789</c:v>
                </c:pt>
                <c:pt idx="44">
                  <c:v>77.108433734939766</c:v>
                </c:pt>
                <c:pt idx="45">
                  <c:v>77.659574468085125</c:v>
                </c:pt>
                <c:pt idx="46">
                  <c:v>77.777777777777743</c:v>
                </c:pt>
                <c:pt idx="47">
                  <c:v>77.89473684210526</c:v>
                </c:pt>
                <c:pt idx="48">
                  <c:v>78.082191780821887</c:v>
                </c:pt>
                <c:pt idx="49">
                  <c:v>78.095238095238102</c:v>
                </c:pt>
                <c:pt idx="50">
                  <c:v>78.494623655913969</c:v>
                </c:pt>
                <c:pt idx="51">
                  <c:v>78.571428571428555</c:v>
                </c:pt>
                <c:pt idx="52">
                  <c:v>78.947368421052616</c:v>
                </c:pt>
                <c:pt idx="53">
                  <c:v>79.268292682926827</c:v>
                </c:pt>
                <c:pt idx="54">
                  <c:v>79.816513761467917</c:v>
                </c:pt>
                <c:pt idx="55">
                  <c:v>80.219780219780219</c:v>
                </c:pt>
                <c:pt idx="56">
                  <c:v>81.028938906752416</c:v>
                </c:pt>
                <c:pt idx="57">
                  <c:v>81.609195402298838</c:v>
                </c:pt>
                <c:pt idx="58">
                  <c:v>81.690140845070488</c:v>
                </c:pt>
                <c:pt idx="59">
                  <c:v>81.730769230769212</c:v>
                </c:pt>
                <c:pt idx="60">
                  <c:v>82.178217821782169</c:v>
                </c:pt>
                <c:pt idx="61">
                  <c:v>82.35294117647058</c:v>
                </c:pt>
                <c:pt idx="62">
                  <c:v>82.978723404255305</c:v>
                </c:pt>
                <c:pt idx="63">
                  <c:v>82.999999999999986</c:v>
                </c:pt>
                <c:pt idx="64">
                  <c:v>83</c:v>
                </c:pt>
                <c:pt idx="65">
                  <c:v>83.018867924528308</c:v>
                </c:pt>
                <c:pt idx="66">
                  <c:v>83.14285714285711</c:v>
                </c:pt>
                <c:pt idx="67">
                  <c:v>83.146067415730357</c:v>
                </c:pt>
                <c:pt idx="68">
                  <c:v>83.529411764705884</c:v>
                </c:pt>
                <c:pt idx="69">
                  <c:v>83.72093023255816</c:v>
                </c:pt>
                <c:pt idx="70">
                  <c:v>83.928571428571431</c:v>
                </c:pt>
                <c:pt idx="71">
                  <c:v>84.100418410041868</c:v>
                </c:pt>
                <c:pt idx="72">
                  <c:v>84.210526315789451</c:v>
                </c:pt>
                <c:pt idx="73">
                  <c:v>84.294871794871753</c:v>
                </c:pt>
                <c:pt idx="74">
                  <c:v>84.536082474226774</c:v>
                </c:pt>
                <c:pt idx="75">
                  <c:v>84.591194968553381</c:v>
                </c:pt>
                <c:pt idx="76">
                  <c:v>84.615384615384613</c:v>
                </c:pt>
                <c:pt idx="77">
                  <c:v>84.782608695652158</c:v>
                </c:pt>
                <c:pt idx="78">
                  <c:v>85.245901639344254</c:v>
                </c:pt>
                <c:pt idx="79">
                  <c:v>85.365853658536579</c:v>
                </c:pt>
                <c:pt idx="80">
                  <c:v>85.585585585585576</c:v>
                </c:pt>
                <c:pt idx="81">
                  <c:v>86.1111111111111</c:v>
                </c:pt>
                <c:pt idx="82">
                  <c:v>86.585365853658573</c:v>
                </c:pt>
                <c:pt idx="83">
                  <c:v>86.842105263157904</c:v>
                </c:pt>
                <c:pt idx="84">
                  <c:v>86.885245901639379</c:v>
                </c:pt>
                <c:pt idx="85">
                  <c:v>89.108910891089138</c:v>
                </c:pt>
                <c:pt idx="86">
                  <c:v>89.285714285714334</c:v>
                </c:pt>
                <c:pt idx="87">
                  <c:v>89.583333333333343</c:v>
                </c:pt>
                <c:pt idx="88">
                  <c:v>90.625000000000071</c:v>
                </c:pt>
                <c:pt idx="89">
                  <c:v>91.17647058823529</c:v>
                </c:pt>
                <c:pt idx="90">
                  <c:v>91.640866873064937</c:v>
                </c:pt>
                <c:pt idx="91">
                  <c:v>92.405063291139243</c:v>
                </c:pt>
                <c:pt idx="92">
                  <c:v>93.333333333333371</c:v>
                </c:pt>
                <c:pt idx="93">
                  <c:v>96.551724137931004</c:v>
                </c:pt>
                <c:pt idx="94">
                  <c:v>96.923076923076906</c:v>
                </c:pt>
                <c:pt idx="95">
                  <c:v>98.1818181818181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085632"/>
        <c:axId val="34086208"/>
      </c:scatterChart>
      <c:valAx>
        <c:axId val="3408563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4086208"/>
        <c:crosses val="autoZero"/>
        <c:crossBetween val="midCat"/>
      </c:valAx>
      <c:valAx>
        <c:axId val="34086208"/>
        <c:scaling>
          <c:orientation val="minMax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408563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3401238036851602"/>
          <c:y val="0.57806214287752211"/>
          <c:w val="0.26598761963148393"/>
          <c:h val="7.4456875556028188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51790046596409"/>
          <c:y val="5.1400554097404488E-2"/>
          <c:w val="0.69132165962799896"/>
          <c:h val="0.81873067949839606"/>
        </c:manualLayout>
      </c:layout>
      <c:scatterChart>
        <c:scatterStyle val="lineMarker"/>
        <c:varyColors val="0"/>
        <c:ser>
          <c:idx val="3"/>
          <c:order val="0"/>
          <c:tx>
            <c:strRef>
              <c:f>HMF!$F$1</c:f>
              <c:strCache>
                <c:ptCount val="1"/>
                <c:pt idx="0">
                  <c:v>HMF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HMF!$B$2:$B$97</c:f>
              <c:strCache>
                <c:ptCount val="96"/>
                <c:pt idx="0">
                  <c:v>F11</c:v>
                </c:pt>
                <c:pt idx="1">
                  <c:v>E1</c:v>
                </c:pt>
                <c:pt idx="2">
                  <c:v>H11</c:v>
                </c:pt>
                <c:pt idx="3">
                  <c:v>H9</c:v>
                </c:pt>
                <c:pt idx="4">
                  <c:v>A1</c:v>
                </c:pt>
                <c:pt idx="5">
                  <c:v>F1</c:v>
                </c:pt>
                <c:pt idx="6">
                  <c:v>H2</c:v>
                </c:pt>
                <c:pt idx="7">
                  <c:v>F9</c:v>
                </c:pt>
                <c:pt idx="8">
                  <c:v>F2</c:v>
                </c:pt>
                <c:pt idx="9">
                  <c:v>D1</c:v>
                </c:pt>
                <c:pt idx="10">
                  <c:v>C1</c:v>
                </c:pt>
                <c:pt idx="11">
                  <c:v>C12</c:v>
                </c:pt>
                <c:pt idx="12">
                  <c:v>E6</c:v>
                </c:pt>
                <c:pt idx="13">
                  <c:v>C11</c:v>
                </c:pt>
                <c:pt idx="14">
                  <c:v>D9</c:v>
                </c:pt>
                <c:pt idx="15">
                  <c:v>B1</c:v>
                </c:pt>
                <c:pt idx="16">
                  <c:v>H5</c:v>
                </c:pt>
                <c:pt idx="17">
                  <c:v>H1</c:v>
                </c:pt>
                <c:pt idx="18">
                  <c:v>F8</c:v>
                </c:pt>
                <c:pt idx="19">
                  <c:v>A8</c:v>
                </c:pt>
                <c:pt idx="20">
                  <c:v>A12</c:v>
                </c:pt>
                <c:pt idx="21">
                  <c:v>A2</c:v>
                </c:pt>
                <c:pt idx="22">
                  <c:v>F10</c:v>
                </c:pt>
                <c:pt idx="23">
                  <c:v>H6</c:v>
                </c:pt>
                <c:pt idx="24">
                  <c:v>A7</c:v>
                </c:pt>
                <c:pt idx="25">
                  <c:v>A9</c:v>
                </c:pt>
                <c:pt idx="26">
                  <c:v>F4</c:v>
                </c:pt>
                <c:pt idx="27">
                  <c:v>D6</c:v>
                </c:pt>
                <c:pt idx="28">
                  <c:v>G6</c:v>
                </c:pt>
                <c:pt idx="29">
                  <c:v>H3</c:v>
                </c:pt>
                <c:pt idx="30">
                  <c:v>E9</c:v>
                </c:pt>
                <c:pt idx="31">
                  <c:v>H12</c:v>
                </c:pt>
                <c:pt idx="32">
                  <c:v>E4</c:v>
                </c:pt>
                <c:pt idx="33">
                  <c:v>H4</c:v>
                </c:pt>
                <c:pt idx="34">
                  <c:v>D11</c:v>
                </c:pt>
                <c:pt idx="35">
                  <c:v>A10</c:v>
                </c:pt>
                <c:pt idx="36">
                  <c:v>E8</c:v>
                </c:pt>
                <c:pt idx="37">
                  <c:v>F5</c:v>
                </c:pt>
                <c:pt idx="38">
                  <c:v>E5</c:v>
                </c:pt>
                <c:pt idx="39">
                  <c:v>B9</c:v>
                </c:pt>
                <c:pt idx="40">
                  <c:v>D10</c:v>
                </c:pt>
                <c:pt idx="41">
                  <c:v>D8</c:v>
                </c:pt>
                <c:pt idx="42">
                  <c:v>A5</c:v>
                </c:pt>
                <c:pt idx="43">
                  <c:v>D3</c:v>
                </c:pt>
                <c:pt idx="44">
                  <c:v>H7</c:v>
                </c:pt>
                <c:pt idx="45">
                  <c:v>F7</c:v>
                </c:pt>
                <c:pt idx="46">
                  <c:v>C8</c:v>
                </c:pt>
                <c:pt idx="47">
                  <c:v>A11</c:v>
                </c:pt>
                <c:pt idx="48">
                  <c:v>D2</c:v>
                </c:pt>
                <c:pt idx="49">
                  <c:v>F6</c:v>
                </c:pt>
                <c:pt idx="50">
                  <c:v>F3</c:v>
                </c:pt>
                <c:pt idx="51">
                  <c:v>C3</c:v>
                </c:pt>
                <c:pt idx="52">
                  <c:v>C9</c:v>
                </c:pt>
                <c:pt idx="53">
                  <c:v>H8</c:v>
                </c:pt>
                <c:pt idx="54">
                  <c:v>A4</c:v>
                </c:pt>
                <c:pt idx="55">
                  <c:v>D12</c:v>
                </c:pt>
                <c:pt idx="56">
                  <c:v>D5</c:v>
                </c:pt>
                <c:pt idx="57">
                  <c:v>E11</c:v>
                </c:pt>
                <c:pt idx="58">
                  <c:v>C7</c:v>
                </c:pt>
                <c:pt idx="59">
                  <c:v>B7</c:v>
                </c:pt>
                <c:pt idx="60">
                  <c:v>E2</c:v>
                </c:pt>
                <c:pt idx="61">
                  <c:v>B4</c:v>
                </c:pt>
                <c:pt idx="62">
                  <c:v>D7</c:v>
                </c:pt>
                <c:pt idx="63">
                  <c:v>A3</c:v>
                </c:pt>
                <c:pt idx="64">
                  <c:v>C5</c:v>
                </c:pt>
                <c:pt idx="65">
                  <c:v>C4</c:v>
                </c:pt>
                <c:pt idx="66">
                  <c:v>B3</c:v>
                </c:pt>
                <c:pt idx="67">
                  <c:v>A6</c:v>
                </c:pt>
                <c:pt idx="68">
                  <c:v>C10</c:v>
                </c:pt>
                <c:pt idx="69">
                  <c:v>B6</c:v>
                </c:pt>
                <c:pt idx="70">
                  <c:v>B8</c:v>
                </c:pt>
                <c:pt idx="71">
                  <c:v>E7</c:v>
                </c:pt>
                <c:pt idx="72">
                  <c:v>G7</c:v>
                </c:pt>
                <c:pt idx="73">
                  <c:v>C6</c:v>
                </c:pt>
                <c:pt idx="74">
                  <c:v>B2</c:v>
                </c:pt>
                <c:pt idx="75">
                  <c:v>B11</c:v>
                </c:pt>
                <c:pt idx="76">
                  <c:v>G3</c:v>
                </c:pt>
                <c:pt idx="77">
                  <c:v>B10</c:v>
                </c:pt>
                <c:pt idx="78">
                  <c:v>B12</c:v>
                </c:pt>
                <c:pt idx="79">
                  <c:v>D4</c:v>
                </c:pt>
                <c:pt idx="80">
                  <c:v>G1</c:v>
                </c:pt>
                <c:pt idx="81">
                  <c:v>G2</c:v>
                </c:pt>
                <c:pt idx="82">
                  <c:v>C2</c:v>
                </c:pt>
                <c:pt idx="83">
                  <c:v>E3</c:v>
                </c:pt>
                <c:pt idx="84">
                  <c:v>F12</c:v>
                </c:pt>
                <c:pt idx="85">
                  <c:v>G11</c:v>
                </c:pt>
                <c:pt idx="86">
                  <c:v>G9</c:v>
                </c:pt>
                <c:pt idx="87">
                  <c:v>G8</c:v>
                </c:pt>
                <c:pt idx="88">
                  <c:v>B5</c:v>
                </c:pt>
                <c:pt idx="89">
                  <c:v>G4</c:v>
                </c:pt>
                <c:pt idx="90">
                  <c:v>G5</c:v>
                </c:pt>
                <c:pt idx="91">
                  <c:v>H10</c:v>
                </c:pt>
                <c:pt idx="92">
                  <c:v>E12</c:v>
                </c:pt>
                <c:pt idx="93">
                  <c:v>E10</c:v>
                </c:pt>
                <c:pt idx="94">
                  <c:v>G12</c:v>
                </c:pt>
                <c:pt idx="95">
                  <c:v>G10</c:v>
                </c:pt>
              </c:strCache>
            </c:strRef>
          </c:xVal>
          <c:yVal>
            <c:numRef>
              <c:f>HMF!$F$2:$F$97</c:f>
              <c:numCache>
                <c:formatCode>General</c:formatCode>
                <c:ptCount val="96"/>
                <c:pt idx="0">
                  <c:v>64.150943396226424</c:v>
                </c:pt>
                <c:pt idx="1">
                  <c:v>67.592592592592609</c:v>
                </c:pt>
                <c:pt idx="2">
                  <c:v>68.965517241379317</c:v>
                </c:pt>
                <c:pt idx="3">
                  <c:v>72.043010752688176</c:v>
                </c:pt>
                <c:pt idx="4">
                  <c:v>72.527472527472511</c:v>
                </c:pt>
                <c:pt idx="5">
                  <c:v>73.73737373737373</c:v>
                </c:pt>
                <c:pt idx="6">
                  <c:v>74.117647058823565</c:v>
                </c:pt>
                <c:pt idx="7">
                  <c:v>74.712643678160916</c:v>
                </c:pt>
                <c:pt idx="8">
                  <c:v>75.324675324675312</c:v>
                </c:pt>
                <c:pt idx="9">
                  <c:v>77.41935483870968</c:v>
                </c:pt>
                <c:pt idx="10">
                  <c:v>77.570093457943912</c:v>
                </c:pt>
                <c:pt idx="11">
                  <c:v>78.313253012048193</c:v>
                </c:pt>
                <c:pt idx="12">
                  <c:v>78.787878787878796</c:v>
                </c:pt>
                <c:pt idx="13">
                  <c:v>78.78787878787881</c:v>
                </c:pt>
                <c:pt idx="14">
                  <c:v>79.000000000000014</c:v>
                </c:pt>
                <c:pt idx="15">
                  <c:v>79.591836734693914</c:v>
                </c:pt>
                <c:pt idx="16">
                  <c:v>79.629629629629605</c:v>
                </c:pt>
                <c:pt idx="17">
                  <c:v>80</c:v>
                </c:pt>
                <c:pt idx="18">
                  <c:v>81.05263157894737</c:v>
                </c:pt>
                <c:pt idx="19">
                  <c:v>81.164383561643859</c:v>
                </c:pt>
                <c:pt idx="20">
                  <c:v>81.428571428571416</c:v>
                </c:pt>
                <c:pt idx="21">
                  <c:v>81.589958158995827</c:v>
                </c:pt>
                <c:pt idx="22">
                  <c:v>81.609195402298866</c:v>
                </c:pt>
                <c:pt idx="23">
                  <c:v>81.818181818181827</c:v>
                </c:pt>
                <c:pt idx="24">
                  <c:v>82.031249999999986</c:v>
                </c:pt>
                <c:pt idx="25">
                  <c:v>82.879377431906633</c:v>
                </c:pt>
                <c:pt idx="26">
                  <c:v>83.486238532110107</c:v>
                </c:pt>
                <c:pt idx="27">
                  <c:v>83.495145631067984</c:v>
                </c:pt>
                <c:pt idx="28">
                  <c:v>83.673469387755119</c:v>
                </c:pt>
                <c:pt idx="29">
                  <c:v>83.908045977011483</c:v>
                </c:pt>
                <c:pt idx="30">
                  <c:v>83.908045977011525</c:v>
                </c:pt>
                <c:pt idx="31">
                  <c:v>84</c:v>
                </c:pt>
                <c:pt idx="32">
                  <c:v>84.615384615384627</c:v>
                </c:pt>
                <c:pt idx="33">
                  <c:v>84.684684684684683</c:v>
                </c:pt>
                <c:pt idx="34">
                  <c:v>84.761904761904773</c:v>
                </c:pt>
                <c:pt idx="35">
                  <c:v>84.905660377358473</c:v>
                </c:pt>
                <c:pt idx="36">
                  <c:v>85</c:v>
                </c:pt>
                <c:pt idx="37">
                  <c:v>85.106382978723403</c:v>
                </c:pt>
                <c:pt idx="38">
                  <c:v>86.021505376344052</c:v>
                </c:pt>
                <c:pt idx="39">
                  <c:v>86.17021276595743</c:v>
                </c:pt>
                <c:pt idx="40">
                  <c:v>86.419753086419732</c:v>
                </c:pt>
                <c:pt idx="41">
                  <c:v>86.734693877551038</c:v>
                </c:pt>
                <c:pt idx="42">
                  <c:v>87.066246056782362</c:v>
                </c:pt>
                <c:pt idx="43">
                  <c:v>87.368421052631561</c:v>
                </c:pt>
                <c:pt idx="44">
                  <c:v>87.5</c:v>
                </c:pt>
                <c:pt idx="45">
                  <c:v>87.735849056603769</c:v>
                </c:pt>
                <c:pt idx="46">
                  <c:v>88.095238095238116</c:v>
                </c:pt>
                <c:pt idx="47">
                  <c:v>88.745980707395518</c:v>
                </c:pt>
                <c:pt idx="48">
                  <c:v>88.888888888888843</c:v>
                </c:pt>
                <c:pt idx="49">
                  <c:v>88.888888888888872</c:v>
                </c:pt>
                <c:pt idx="50">
                  <c:v>88.999999999999986</c:v>
                </c:pt>
                <c:pt idx="51">
                  <c:v>89.024390243902459</c:v>
                </c:pt>
                <c:pt idx="52">
                  <c:v>89.285714285714292</c:v>
                </c:pt>
                <c:pt idx="53">
                  <c:v>89.285714285714334</c:v>
                </c:pt>
                <c:pt idx="54">
                  <c:v>89.306358381502875</c:v>
                </c:pt>
                <c:pt idx="55">
                  <c:v>90.476190476190482</c:v>
                </c:pt>
                <c:pt idx="56">
                  <c:v>90.625</c:v>
                </c:pt>
                <c:pt idx="57">
                  <c:v>90.909090909090935</c:v>
                </c:pt>
                <c:pt idx="58">
                  <c:v>92</c:v>
                </c:pt>
                <c:pt idx="59">
                  <c:v>92.222222222222243</c:v>
                </c:pt>
                <c:pt idx="60">
                  <c:v>92.537313432835802</c:v>
                </c:pt>
                <c:pt idx="61">
                  <c:v>93.518518518518491</c:v>
                </c:pt>
                <c:pt idx="62">
                  <c:v>93.617021276595764</c:v>
                </c:pt>
                <c:pt idx="63">
                  <c:v>93.808049535603701</c:v>
                </c:pt>
                <c:pt idx="64">
                  <c:v>93.814432989690673</c:v>
                </c:pt>
                <c:pt idx="65">
                  <c:v>93.902439024390247</c:v>
                </c:pt>
                <c:pt idx="66">
                  <c:v>94.117647058823565</c:v>
                </c:pt>
                <c:pt idx="67">
                  <c:v>95.192307692307722</c:v>
                </c:pt>
                <c:pt idx="68">
                  <c:v>95.890410958904113</c:v>
                </c:pt>
                <c:pt idx="69">
                  <c:v>96.078431372548991</c:v>
                </c:pt>
                <c:pt idx="70">
                  <c:v>96.153846153846118</c:v>
                </c:pt>
                <c:pt idx="71">
                  <c:v>96.739130434782624</c:v>
                </c:pt>
                <c:pt idx="72">
                  <c:v>96.999999999999972</c:v>
                </c:pt>
                <c:pt idx="73">
                  <c:v>97.674418604651194</c:v>
                </c:pt>
                <c:pt idx="74">
                  <c:v>98.701298701298697</c:v>
                </c:pt>
                <c:pt idx="75">
                  <c:v>98.734177215189831</c:v>
                </c:pt>
                <c:pt idx="76">
                  <c:v>100.00000000000003</c:v>
                </c:pt>
                <c:pt idx="77">
                  <c:v>100.00000000000004</c:v>
                </c:pt>
                <c:pt idx="78">
                  <c:v>102.24719101123596</c:v>
                </c:pt>
                <c:pt idx="79">
                  <c:v>102.63157894736842</c:v>
                </c:pt>
                <c:pt idx="80">
                  <c:v>103.15789473684214</c:v>
                </c:pt>
                <c:pt idx="81">
                  <c:v>103.37078651685397</c:v>
                </c:pt>
                <c:pt idx="82">
                  <c:v>104.22535211267605</c:v>
                </c:pt>
                <c:pt idx="83">
                  <c:v>104.91803278688525</c:v>
                </c:pt>
                <c:pt idx="84">
                  <c:v>105.17241379310344</c:v>
                </c:pt>
                <c:pt idx="85">
                  <c:v>106.02409638554218</c:v>
                </c:pt>
                <c:pt idx="86">
                  <c:v>106.31578947368423</c:v>
                </c:pt>
                <c:pt idx="87">
                  <c:v>108.9108910891089</c:v>
                </c:pt>
                <c:pt idx="88">
                  <c:v>109.75609756097559</c:v>
                </c:pt>
                <c:pt idx="89">
                  <c:v>111.60714285714286</c:v>
                </c:pt>
                <c:pt idx="90">
                  <c:v>112.28070175438596</c:v>
                </c:pt>
                <c:pt idx="91">
                  <c:v>115.38461538461536</c:v>
                </c:pt>
                <c:pt idx="92">
                  <c:v>116.36363636363627</c:v>
                </c:pt>
                <c:pt idx="93">
                  <c:v>116.3934426229508</c:v>
                </c:pt>
                <c:pt idx="94">
                  <c:v>120.5882352941176</c:v>
                </c:pt>
                <c:pt idx="95">
                  <c:v>132.8125000000000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07328"/>
        <c:axId val="157107904"/>
      </c:scatterChart>
      <c:valAx>
        <c:axId val="15710732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7107904"/>
        <c:crosses val="autoZero"/>
        <c:crossBetween val="midCat"/>
      </c:valAx>
      <c:valAx>
        <c:axId val="157107904"/>
        <c:scaling>
          <c:orientation val="minMax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710732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70543376057404716"/>
          <c:y val="0.56462270341207355"/>
          <c:w val="0.23345498568732911"/>
          <c:h val="0.1586740362181979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935130047449746"/>
          <c:y val="5.1400554097404488E-2"/>
          <c:w val="0.6670799649872251"/>
          <c:h val="0.81873067949839606"/>
        </c:manualLayout>
      </c:layout>
      <c:scatterChart>
        <c:scatterStyle val="lineMarker"/>
        <c:varyColors val="0"/>
        <c:ser>
          <c:idx val="4"/>
          <c:order val="0"/>
          <c:tx>
            <c:strRef>
              <c:f>Vanillin!$G$1</c:f>
              <c:strCache>
                <c:ptCount val="1"/>
                <c:pt idx="0">
                  <c:v>Vanillin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Vanillin!$B$2:$B$97</c:f>
              <c:strCache>
                <c:ptCount val="96"/>
                <c:pt idx="0">
                  <c:v>H11</c:v>
                </c:pt>
                <c:pt idx="1">
                  <c:v>H2</c:v>
                </c:pt>
                <c:pt idx="2">
                  <c:v>F11</c:v>
                </c:pt>
                <c:pt idx="3">
                  <c:v>H3</c:v>
                </c:pt>
                <c:pt idx="4">
                  <c:v>E1</c:v>
                </c:pt>
                <c:pt idx="5">
                  <c:v>C1</c:v>
                </c:pt>
                <c:pt idx="6">
                  <c:v>C11</c:v>
                </c:pt>
                <c:pt idx="7">
                  <c:v>D5</c:v>
                </c:pt>
                <c:pt idx="8">
                  <c:v>A9</c:v>
                </c:pt>
                <c:pt idx="9">
                  <c:v>H5</c:v>
                </c:pt>
                <c:pt idx="10">
                  <c:v>B9</c:v>
                </c:pt>
                <c:pt idx="11">
                  <c:v>H1</c:v>
                </c:pt>
                <c:pt idx="12">
                  <c:v>D1</c:v>
                </c:pt>
                <c:pt idx="13">
                  <c:v>E11</c:v>
                </c:pt>
                <c:pt idx="14">
                  <c:v>D11</c:v>
                </c:pt>
                <c:pt idx="15">
                  <c:v>E5</c:v>
                </c:pt>
                <c:pt idx="16">
                  <c:v>H8</c:v>
                </c:pt>
                <c:pt idx="17">
                  <c:v>D3</c:v>
                </c:pt>
                <c:pt idx="18">
                  <c:v>H9</c:v>
                </c:pt>
                <c:pt idx="19">
                  <c:v>G7</c:v>
                </c:pt>
                <c:pt idx="20">
                  <c:v>G3</c:v>
                </c:pt>
                <c:pt idx="21">
                  <c:v>A7</c:v>
                </c:pt>
                <c:pt idx="22">
                  <c:v>H6</c:v>
                </c:pt>
                <c:pt idx="23">
                  <c:v>B7</c:v>
                </c:pt>
                <c:pt idx="24">
                  <c:v>C3</c:v>
                </c:pt>
                <c:pt idx="25">
                  <c:v>A5</c:v>
                </c:pt>
                <c:pt idx="26">
                  <c:v>H12</c:v>
                </c:pt>
                <c:pt idx="27">
                  <c:v>B8</c:v>
                </c:pt>
                <c:pt idx="28">
                  <c:v>G11</c:v>
                </c:pt>
                <c:pt idx="29">
                  <c:v>C2</c:v>
                </c:pt>
                <c:pt idx="30">
                  <c:v>F3</c:v>
                </c:pt>
                <c:pt idx="31">
                  <c:v>E9</c:v>
                </c:pt>
                <c:pt idx="32">
                  <c:v>G6</c:v>
                </c:pt>
                <c:pt idx="33">
                  <c:v>B5</c:v>
                </c:pt>
                <c:pt idx="34">
                  <c:v>H7</c:v>
                </c:pt>
                <c:pt idx="35">
                  <c:v>B12</c:v>
                </c:pt>
                <c:pt idx="36">
                  <c:v>G8</c:v>
                </c:pt>
                <c:pt idx="37">
                  <c:v>H4</c:v>
                </c:pt>
                <c:pt idx="38">
                  <c:v>F1</c:v>
                </c:pt>
                <c:pt idx="39">
                  <c:v>E2</c:v>
                </c:pt>
                <c:pt idx="40">
                  <c:v>C5</c:v>
                </c:pt>
                <c:pt idx="41">
                  <c:v>F4</c:v>
                </c:pt>
                <c:pt idx="42">
                  <c:v>F7</c:v>
                </c:pt>
                <c:pt idx="43">
                  <c:v>E7</c:v>
                </c:pt>
                <c:pt idx="44">
                  <c:v>A8</c:v>
                </c:pt>
                <c:pt idx="45">
                  <c:v>A1</c:v>
                </c:pt>
                <c:pt idx="46">
                  <c:v>F10</c:v>
                </c:pt>
                <c:pt idx="47">
                  <c:v>F5</c:v>
                </c:pt>
                <c:pt idx="48">
                  <c:v>D2</c:v>
                </c:pt>
                <c:pt idx="49">
                  <c:v>D12</c:v>
                </c:pt>
                <c:pt idx="50">
                  <c:v>D6</c:v>
                </c:pt>
                <c:pt idx="51">
                  <c:v>C9</c:v>
                </c:pt>
                <c:pt idx="52">
                  <c:v>F2</c:v>
                </c:pt>
                <c:pt idx="53">
                  <c:v>E4</c:v>
                </c:pt>
                <c:pt idx="54">
                  <c:v>F6</c:v>
                </c:pt>
                <c:pt idx="55">
                  <c:v>G4</c:v>
                </c:pt>
                <c:pt idx="56">
                  <c:v>D7</c:v>
                </c:pt>
                <c:pt idx="57">
                  <c:v>D8</c:v>
                </c:pt>
                <c:pt idx="58">
                  <c:v>E6</c:v>
                </c:pt>
                <c:pt idx="59">
                  <c:v>G1</c:v>
                </c:pt>
                <c:pt idx="60">
                  <c:v>B3</c:v>
                </c:pt>
                <c:pt idx="61">
                  <c:v>A12</c:v>
                </c:pt>
                <c:pt idx="62">
                  <c:v>C8</c:v>
                </c:pt>
                <c:pt idx="63">
                  <c:v>G2</c:v>
                </c:pt>
                <c:pt idx="64">
                  <c:v>A11</c:v>
                </c:pt>
                <c:pt idx="65">
                  <c:v>A10</c:v>
                </c:pt>
                <c:pt idx="66">
                  <c:v>F9</c:v>
                </c:pt>
                <c:pt idx="67">
                  <c:v>E3</c:v>
                </c:pt>
                <c:pt idx="68">
                  <c:v>B6</c:v>
                </c:pt>
                <c:pt idx="69">
                  <c:v>A6</c:v>
                </c:pt>
                <c:pt idx="70">
                  <c:v>A2</c:v>
                </c:pt>
                <c:pt idx="71">
                  <c:v>B4</c:v>
                </c:pt>
                <c:pt idx="72">
                  <c:v>A4</c:v>
                </c:pt>
                <c:pt idx="73">
                  <c:v>C6</c:v>
                </c:pt>
                <c:pt idx="74">
                  <c:v>B2</c:v>
                </c:pt>
                <c:pt idx="75">
                  <c:v>B1</c:v>
                </c:pt>
                <c:pt idx="76">
                  <c:v>E8</c:v>
                </c:pt>
                <c:pt idx="77">
                  <c:v>F8</c:v>
                </c:pt>
                <c:pt idx="78">
                  <c:v>G12</c:v>
                </c:pt>
                <c:pt idx="79">
                  <c:v>G5</c:v>
                </c:pt>
                <c:pt idx="80">
                  <c:v>D9</c:v>
                </c:pt>
                <c:pt idx="81">
                  <c:v>G9</c:v>
                </c:pt>
                <c:pt idx="82">
                  <c:v>H10</c:v>
                </c:pt>
                <c:pt idx="83">
                  <c:v>C7</c:v>
                </c:pt>
                <c:pt idx="84">
                  <c:v>E12</c:v>
                </c:pt>
                <c:pt idx="85">
                  <c:v>A3</c:v>
                </c:pt>
                <c:pt idx="86">
                  <c:v>C10</c:v>
                </c:pt>
                <c:pt idx="87">
                  <c:v>C12</c:v>
                </c:pt>
                <c:pt idx="88">
                  <c:v>D4</c:v>
                </c:pt>
                <c:pt idx="89">
                  <c:v>F12</c:v>
                </c:pt>
                <c:pt idx="90">
                  <c:v>C4</c:v>
                </c:pt>
                <c:pt idx="91">
                  <c:v>B10</c:v>
                </c:pt>
                <c:pt idx="92">
                  <c:v>G10</c:v>
                </c:pt>
                <c:pt idx="93">
                  <c:v>B11</c:v>
                </c:pt>
                <c:pt idx="94">
                  <c:v>E10</c:v>
                </c:pt>
                <c:pt idx="95">
                  <c:v>D10</c:v>
                </c:pt>
              </c:strCache>
            </c:strRef>
          </c:xVal>
          <c:yVal>
            <c:numRef>
              <c:f>Vanillin!$G$2:$G$97</c:f>
              <c:numCache>
                <c:formatCode>General</c:formatCode>
                <c:ptCount val="96"/>
                <c:pt idx="0">
                  <c:v>22.988505747126403</c:v>
                </c:pt>
                <c:pt idx="1">
                  <c:v>24.705882352941181</c:v>
                </c:pt>
                <c:pt idx="2">
                  <c:v>25.471698113207548</c:v>
                </c:pt>
                <c:pt idx="3">
                  <c:v>29.885057471264325</c:v>
                </c:pt>
                <c:pt idx="4">
                  <c:v>31.481481481481495</c:v>
                </c:pt>
                <c:pt idx="5">
                  <c:v>31.775700934579444</c:v>
                </c:pt>
                <c:pt idx="6">
                  <c:v>32.32323232323234</c:v>
                </c:pt>
                <c:pt idx="7">
                  <c:v>38.541666666666686</c:v>
                </c:pt>
                <c:pt idx="8">
                  <c:v>39.688715953307373</c:v>
                </c:pt>
                <c:pt idx="9">
                  <c:v>40.740740740740748</c:v>
                </c:pt>
                <c:pt idx="10">
                  <c:v>41.489361702127667</c:v>
                </c:pt>
                <c:pt idx="11">
                  <c:v>41.904761904761919</c:v>
                </c:pt>
                <c:pt idx="12">
                  <c:v>41.93548387096773</c:v>
                </c:pt>
                <c:pt idx="13">
                  <c:v>42.045454545454561</c:v>
                </c:pt>
                <c:pt idx="14">
                  <c:v>44.761904761904773</c:v>
                </c:pt>
                <c:pt idx="15">
                  <c:v>45.161290322580612</c:v>
                </c:pt>
                <c:pt idx="16">
                  <c:v>45.238095238095269</c:v>
                </c:pt>
                <c:pt idx="17">
                  <c:v>45.263157894736842</c:v>
                </c:pt>
                <c:pt idx="18">
                  <c:v>46.23655913978498</c:v>
                </c:pt>
                <c:pt idx="19">
                  <c:v>46.999999999999993</c:v>
                </c:pt>
                <c:pt idx="20">
                  <c:v>48.514851485148505</c:v>
                </c:pt>
                <c:pt idx="21">
                  <c:v>50.000000000000021</c:v>
                </c:pt>
                <c:pt idx="22">
                  <c:v>50.505050505050484</c:v>
                </c:pt>
                <c:pt idx="23">
                  <c:v>51.111111111111107</c:v>
                </c:pt>
                <c:pt idx="24">
                  <c:v>51.219512195121929</c:v>
                </c:pt>
                <c:pt idx="25">
                  <c:v>53.943217665615173</c:v>
                </c:pt>
                <c:pt idx="26">
                  <c:v>56.000000000000007</c:v>
                </c:pt>
                <c:pt idx="27">
                  <c:v>56.41025641025643</c:v>
                </c:pt>
                <c:pt idx="28">
                  <c:v>56.626506024096422</c:v>
                </c:pt>
                <c:pt idx="29">
                  <c:v>57.746478873239482</c:v>
                </c:pt>
                <c:pt idx="30">
                  <c:v>58.000000000000007</c:v>
                </c:pt>
                <c:pt idx="31">
                  <c:v>58.620689655172434</c:v>
                </c:pt>
                <c:pt idx="32">
                  <c:v>59.183673469387756</c:v>
                </c:pt>
                <c:pt idx="33">
                  <c:v>59.756097560975618</c:v>
                </c:pt>
                <c:pt idx="34">
                  <c:v>59.821428571428584</c:v>
                </c:pt>
                <c:pt idx="35">
                  <c:v>60.674157303370791</c:v>
                </c:pt>
                <c:pt idx="36">
                  <c:v>61.386138613861405</c:v>
                </c:pt>
                <c:pt idx="37">
                  <c:v>62.162162162162161</c:v>
                </c:pt>
                <c:pt idx="38">
                  <c:v>62.626262626262651</c:v>
                </c:pt>
                <c:pt idx="39">
                  <c:v>65.671641791044806</c:v>
                </c:pt>
                <c:pt idx="40">
                  <c:v>65.979381443298962</c:v>
                </c:pt>
                <c:pt idx="41">
                  <c:v>66.9724770642202</c:v>
                </c:pt>
                <c:pt idx="42">
                  <c:v>68.86792452830187</c:v>
                </c:pt>
                <c:pt idx="43">
                  <c:v>69.565217391304358</c:v>
                </c:pt>
                <c:pt idx="44">
                  <c:v>69.863013698630141</c:v>
                </c:pt>
                <c:pt idx="45">
                  <c:v>70.054945054945051</c:v>
                </c:pt>
                <c:pt idx="46">
                  <c:v>71.264367816091962</c:v>
                </c:pt>
                <c:pt idx="47">
                  <c:v>71.276595744680876</c:v>
                </c:pt>
                <c:pt idx="48">
                  <c:v>71.428571428571431</c:v>
                </c:pt>
                <c:pt idx="49">
                  <c:v>71.428571428571459</c:v>
                </c:pt>
                <c:pt idx="50">
                  <c:v>71.844660194174764</c:v>
                </c:pt>
                <c:pt idx="51">
                  <c:v>72.619047619047578</c:v>
                </c:pt>
                <c:pt idx="52">
                  <c:v>72.727272727272691</c:v>
                </c:pt>
                <c:pt idx="53">
                  <c:v>73.076923076923066</c:v>
                </c:pt>
                <c:pt idx="54">
                  <c:v>73.73737373737373</c:v>
                </c:pt>
                <c:pt idx="55">
                  <c:v>74.107142857142847</c:v>
                </c:pt>
                <c:pt idx="56">
                  <c:v>74.468085106383</c:v>
                </c:pt>
                <c:pt idx="57">
                  <c:v>75.510204081632651</c:v>
                </c:pt>
                <c:pt idx="58">
                  <c:v>75.757575757575751</c:v>
                </c:pt>
                <c:pt idx="59">
                  <c:v>75.789473684210535</c:v>
                </c:pt>
                <c:pt idx="60">
                  <c:v>76.470588235294144</c:v>
                </c:pt>
                <c:pt idx="61">
                  <c:v>79.714285714285694</c:v>
                </c:pt>
                <c:pt idx="62">
                  <c:v>79.761904761904773</c:v>
                </c:pt>
                <c:pt idx="63">
                  <c:v>79.775280898876417</c:v>
                </c:pt>
                <c:pt idx="64">
                  <c:v>81.028938906752416</c:v>
                </c:pt>
                <c:pt idx="65">
                  <c:v>81.132075471698059</c:v>
                </c:pt>
                <c:pt idx="66">
                  <c:v>81.609195402298823</c:v>
                </c:pt>
                <c:pt idx="67">
                  <c:v>81.967213114754145</c:v>
                </c:pt>
                <c:pt idx="68">
                  <c:v>82.35294117647058</c:v>
                </c:pt>
                <c:pt idx="69">
                  <c:v>82.692307692307693</c:v>
                </c:pt>
                <c:pt idx="70">
                  <c:v>82.845188284518869</c:v>
                </c:pt>
                <c:pt idx="71">
                  <c:v>83.333333333333314</c:v>
                </c:pt>
                <c:pt idx="72">
                  <c:v>84.104046242774515</c:v>
                </c:pt>
                <c:pt idx="73">
                  <c:v>84.88372093023257</c:v>
                </c:pt>
                <c:pt idx="74">
                  <c:v>85.714285714285694</c:v>
                </c:pt>
                <c:pt idx="75">
                  <c:v>85.714285714285722</c:v>
                </c:pt>
                <c:pt idx="76">
                  <c:v>86.000000000000014</c:v>
                </c:pt>
                <c:pt idx="77">
                  <c:v>86.315789473684205</c:v>
                </c:pt>
                <c:pt idx="78">
                  <c:v>86.764705882352942</c:v>
                </c:pt>
                <c:pt idx="79">
                  <c:v>87.719298245614027</c:v>
                </c:pt>
                <c:pt idx="80">
                  <c:v>88</c:v>
                </c:pt>
                <c:pt idx="81">
                  <c:v>89.473684210526329</c:v>
                </c:pt>
                <c:pt idx="82">
                  <c:v>90.769230769230774</c:v>
                </c:pt>
                <c:pt idx="83">
                  <c:v>91</c:v>
                </c:pt>
                <c:pt idx="84">
                  <c:v>94.545454545454461</c:v>
                </c:pt>
                <c:pt idx="85">
                  <c:v>96.594427244581979</c:v>
                </c:pt>
                <c:pt idx="86">
                  <c:v>99.999999999999943</c:v>
                </c:pt>
                <c:pt idx="87">
                  <c:v>106.02409638554218</c:v>
                </c:pt>
                <c:pt idx="88">
                  <c:v>106.57894736842107</c:v>
                </c:pt>
                <c:pt idx="89">
                  <c:v>108.62068965517244</c:v>
                </c:pt>
                <c:pt idx="90">
                  <c:v>109.75609756097562</c:v>
                </c:pt>
                <c:pt idx="91">
                  <c:v>112.08791208791212</c:v>
                </c:pt>
                <c:pt idx="92">
                  <c:v>112.50000000000003</c:v>
                </c:pt>
                <c:pt idx="93">
                  <c:v>117.72151898734174</c:v>
                </c:pt>
                <c:pt idx="94">
                  <c:v>119.67213114754098</c:v>
                </c:pt>
                <c:pt idx="95">
                  <c:v>127.1604938271604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09632"/>
        <c:axId val="157110208"/>
      </c:scatterChart>
      <c:valAx>
        <c:axId val="15710963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7110208"/>
        <c:crosses val="autoZero"/>
        <c:crossBetween val="midCat"/>
      </c:valAx>
      <c:valAx>
        <c:axId val="157110208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710963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5029662833619739"/>
          <c:y val="0.55536344415281425"/>
          <c:w val="0.30248116880627135"/>
          <c:h val="0.1454463392956338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36570428696409"/>
          <c:y val="5.1400554097404488E-2"/>
          <c:w val="0.73005118110236222"/>
          <c:h val="0.78093736939281877"/>
        </c:manualLayout>
      </c:layout>
      <c:scatterChart>
        <c:scatterStyle val="lineMarker"/>
        <c:varyColors val="0"/>
        <c:ser>
          <c:idx val="5"/>
          <c:order val="0"/>
          <c:tx>
            <c:strRef>
              <c:f>Sorbitol!$H$1</c:f>
              <c:strCache>
                <c:ptCount val="1"/>
                <c:pt idx="0">
                  <c:v>Sorbit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orbitol!$B$2:$B$97</c:f>
              <c:strCache>
                <c:ptCount val="96"/>
                <c:pt idx="0">
                  <c:v>F10</c:v>
                </c:pt>
                <c:pt idx="1">
                  <c:v>G6</c:v>
                </c:pt>
                <c:pt idx="2">
                  <c:v>D2</c:v>
                </c:pt>
                <c:pt idx="3">
                  <c:v>F11</c:v>
                </c:pt>
                <c:pt idx="4">
                  <c:v>F8</c:v>
                </c:pt>
                <c:pt idx="5">
                  <c:v>D7</c:v>
                </c:pt>
                <c:pt idx="6">
                  <c:v>G2</c:v>
                </c:pt>
                <c:pt idx="7">
                  <c:v>E1</c:v>
                </c:pt>
                <c:pt idx="8">
                  <c:v>E4</c:v>
                </c:pt>
                <c:pt idx="9">
                  <c:v>H5</c:v>
                </c:pt>
                <c:pt idx="10">
                  <c:v>B9</c:v>
                </c:pt>
                <c:pt idx="11">
                  <c:v>E11</c:v>
                </c:pt>
                <c:pt idx="12">
                  <c:v>C4</c:v>
                </c:pt>
                <c:pt idx="13">
                  <c:v>E9</c:v>
                </c:pt>
                <c:pt idx="14">
                  <c:v>G11</c:v>
                </c:pt>
                <c:pt idx="15">
                  <c:v>E7</c:v>
                </c:pt>
                <c:pt idx="16">
                  <c:v>C7</c:v>
                </c:pt>
                <c:pt idx="17">
                  <c:v>A4</c:v>
                </c:pt>
                <c:pt idx="18">
                  <c:v>E5</c:v>
                </c:pt>
                <c:pt idx="19">
                  <c:v>H3</c:v>
                </c:pt>
                <c:pt idx="20">
                  <c:v>G3</c:v>
                </c:pt>
                <c:pt idx="21">
                  <c:v>H7</c:v>
                </c:pt>
                <c:pt idx="22">
                  <c:v>G9</c:v>
                </c:pt>
                <c:pt idx="23">
                  <c:v>F4</c:v>
                </c:pt>
                <c:pt idx="24">
                  <c:v>F9</c:v>
                </c:pt>
                <c:pt idx="25">
                  <c:v>B2</c:v>
                </c:pt>
                <c:pt idx="26">
                  <c:v>F12</c:v>
                </c:pt>
                <c:pt idx="27">
                  <c:v>C3</c:v>
                </c:pt>
                <c:pt idx="28">
                  <c:v>D6</c:v>
                </c:pt>
                <c:pt idx="29">
                  <c:v>B10</c:v>
                </c:pt>
                <c:pt idx="30">
                  <c:v>D5</c:v>
                </c:pt>
                <c:pt idx="31">
                  <c:v>C2</c:v>
                </c:pt>
                <c:pt idx="32">
                  <c:v>D11</c:v>
                </c:pt>
                <c:pt idx="33">
                  <c:v>F7</c:v>
                </c:pt>
                <c:pt idx="34">
                  <c:v>B1</c:v>
                </c:pt>
                <c:pt idx="35">
                  <c:v>H9</c:v>
                </c:pt>
                <c:pt idx="36">
                  <c:v>A8</c:v>
                </c:pt>
                <c:pt idx="37">
                  <c:v>B11</c:v>
                </c:pt>
                <c:pt idx="38">
                  <c:v>B4</c:v>
                </c:pt>
                <c:pt idx="39">
                  <c:v>H11</c:v>
                </c:pt>
                <c:pt idx="40">
                  <c:v>G1</c:v>
                </c:pt>
                <c:pt idx="41">
                  <c:v>C5</c:v>
                </c:pt>
                <c:pt idx="42">
                  <c:v>H12</c:v>
                </c:pt>
                <c:pt idx="43">
                  <c:v>B6</c:v>
                </c:pt>
                <c:pt idx="44">
                  <c:v>D9</c:v>
                </c:pt>
                <c:pt idx="45">
                  <c:v>B5</c:v>
                </c:pt>
                <c:pt idx="46">
                  <c:v>F3</c:v>
                </c:pt>
                <c:pt idx="47">
                  <c:v>D1</c:v>
                </c:pt>
                <c:pt idx="48">
                  <c:v>B3</c:v>
                </c:pt>
                <c:pt idx="49">
                  <c:v>B12</c:v>
                </c:pt>
                <c:pt idx="50">
                  <c:v>E3</c:v>
                </c:pt>
                <c:pt idx="51">
                  <c:v>H2</c:v>
                </c:pt>
                <c:pt idx="52">
                  <c:v>G4</c:v>
                </c:pt>
                <c:pt idx="53">
                  <c:v>D4</c:v>
                </c:pt>
                <c:pt idx="54">
                  <c:v>C8</c:v>
                </c:pt>
                <c:pt idx="55">
                  <c:v>F2</c:v>
                </c:pt>
                <c:pt idx="56">
                  <c:v>H6</c:v>
                </c:pt>
                <c:pt idx="57">
                  <c:v>G5</c:v>
                </c:pt>
                <c:pt idx="58">
                  <c:v>C10</c:v>
                </c:pt>
                <c:pt idx="59">
                  <c:v>D10</c:v>
                </c:pt>
                <c:pt idx="60">
                  <c:v>A6</c:v>
                </c:pt>
                <c:pt idx="61">
                  <c:v>A1</c:v>
                </c:pt>
                <c:pt idx="62">
                  <c:v>D12</c:v>
                </c:pt>
                <c:pt idx="63">
                  <c:v>C1</c:v>
                </c:pt>
                <c:pt idx="64">
                  <c:v>F5</c:v>
                </c:pt>
                <c:pt idx="65">
                  <c:v>E2</c:v>
                </c:pt>
                <c:pt idx="66">
                  <c:v>B7</c:v>
                </c:pt>
                <c:pt idx="67">
                  <c:v>H4</c:v>
                </c:pt>
                <c:pt idx="68">
                  <c:v>A2</c:v>
                </c:pt>
                <c:pt idx="69">
                  <c:v>F6</c:v>
                </c:pt>
                <c:pt idx="70">
                  <c:v>E8</c:v>
                </c:pt>
                <c:pt idx="71">
                  <c:v>C12</c:v>
                </c:pt>
                <c:pt idx="72">
                  <c:v>G10</c:v>
                </c:pt>
                <c:pt idx="73">
                  <c:v>D3</c:v>
                </c:pt>
                <c:pt idx="74">
                  <c:v>H1</c:v>
                </c:pt>
                <c:pt idx="75">
                  <c:v>G7</c:v>
                </c:pt>
                <c:pt idx="76">
                  <c:v>C11</c:v>
                </c:pt>
                <c:pt idx="77">
                  <c:v>H8</c:v>
                </c:pt>
                <c:pt idx="78">
                  <c:v>E6</c:v>
                </c:pt>
                <c:pt idx="79">
                  <c:v>E10</c:v>
                </c:pt>
                <c:pt idx="80">
                  <c:v>C6</c:v>
                </c:pt>
                <c:pt idx="81">
                  <c:v>A12</c:v>
                </c:pt>
                <c:pt idx="82">
                  <c:v>F1</c:v>
                </c:pt>
                <c:pt idx="83">
                  <c:v>G8</c:v>
                </c:pt>
                <c:pt idx="84">
                  <c:v>H10</c:v>
                </c:pt>
                <c:pt idx="85">
                  <c:v>D8</c:v>
                </c:pt>
                <c:pt idx="86">
                  <c:v>C9</c:v>
                </c:pt>
                <c:pt idx="87">
                  <c:v>G12</c:v>
                </c:pt>
                <c:pt idx="88">
                  <c:v>B8</c:v>
                </c:pt>
                <c:pt idx="89">
                  <c:v>A3</c:v>
                </c:pt>
                <c:pt idx="90">
                  <c:v>E12</c:v>
                </c:pt>
                <c:pt idx="91">
                  <c:v>A10</c:v>
                </c:pt>
                <c:pt idx="92">
                  <c:v>A5</c:v>
                </c:pt>
                <c:pt idx="93">
                  <c:v>A7</c:v>
                </c:pt>
                <c:pt idx="94">
                  <c:v>A11</c:v>
                </c:pt>
                <c:pt idx="95">
                  <c:v>A9</c:v>
                </c:pt>
              </c:strCache>
            </c:strRef>
          </c:xVal>
          <c:yVal>
            <c:numRef>
              <c:f>Sorbitol!$H$2:$H$97</c:f>
              <c:numCache>
                <c:formatCode>General</c:formatCode>
                <c:ptCount val="96"/>
                <c:pt idx="0">
                  <c:v>67.826086956521749</c:v>
                </c:pt>
                <c:pt idx="1">
                  <c:v>69.298245614035082</c:v>
                </c:pt>
                <c:pt idx="2">
                  <c:v>70.731707317073202</c:v>
                </c:pt>
                <c:pt idx="3">
                  <c:v>72.727272727272734</c:v>
                </c:pt>
                <c:pt idx="4">
                  <c:v>73.246753246753244</c:v>
                </c:pt>
                <c:pt idx="5">
                  <c:v>76.642335766423358</c:v>
                </c:pt>
                <c:pt idx="6">
                  <c:v>79.411764705882391</c:v>
                </c:pt>
                <c:pt idx="7">
                  <c:v>79.646017699115006</c:v>
                </c:pt>
                <c:pt idx="8">
                  <c:v>80.799999999999983</c:v>
                </c:pt>
                <c:pt idx="9">
                  <c:v>80.869565217391298</c:v>
                </c:pt>
                <c:pt idx="10">
                  <c:v>81.410256410256437</c:v>
                </c:pt>
                <c:pt idx="11">
                  <c:v>81.730769230769226</c:v>
                </c:pt>
                <c:pt idx="12">
                  <c:v>83.07692307692308</c:v>
                </c:pt>
                <c:pt idx="13">
                  <c:v>83.478260869565219</c:v>
                </c:pt>
                <c:pt idx="14">
                  <c:v>83.486238532110093</c:v>
                </c:pt>
                <c:pt idx="15">
                  <c:v>83.739837398374007</c:v>
                </c:pt>
                <c:pt idx="16">
                  <c:v>84.027777777777786</c:v>
                </c:pt>
                <c:pt idx="17">
                  <c:v>84.033613445378137</c:v>
                </c:pt>
                <c:pt idx="18">
                  <c:v>84.105960264900659</c:v>
                </c:pt>
                <c:pt idx="19">
                  <c:v>84.403669724770651</c:v>
                </c:pt>
                <c:pt idx="20">
                  <c:v>85.106382978723389</c:v>
                </c:pt>
                <c:pt idx="21">
                  <c:v>85.15625</c:v>
                </c:pt>
                <c:pt idx="22">
                  <c:v>85.29411764705884</c:v>
                </c:pt>
                <c:pt idx="23">
                  <c:v>86.718750000000028</c:v>
                </c:pt>
                <c:pt idx="24">
                  <c:v>86.92307692307692</c:v>
                </c:pt>
                <c:pt idx="25">
                  <c:v>86.99186991869918</c:v>
                </c:pt>
                <c:pt idx="26">
                  <c:v>87.356321839080465</c:v>
                </c:pt>
                <c:pt idx="27">
                  <c:v>87.401574803149614</c:v>
                </c:pt>
                <c:pt idx="28">
                  <c:v>87.500000000000014</c:v>
                </c:pt>
                <c:pt idx="29">
                  <c:v>87.603305785123979</c:v>
                </c:pt>
                <c:pt idx="30">
                  <c:v>87.610619469026545</c:v>
                </c:pt>
                <c:pt idx="31">
                  <c:v>87.648456057007152</c:v>
                </c:pt>
                <c:pt idx="32">
                  <c:v>87.826086956521749</c:v>
                </c:pt>
                <c:pt idx="33">
                  <c:v>88</c:v>
                </c:pt>
                <c:pt idx="34">
                  <c:v>88.421052631578917</c:v>
                </c:pt>
                <c:pt idx="35">
                  <c:v>88.695652173913018</c:v>
                </c:pt>
                <c:pt idx="36">
                  <c:v>88.888888888888872</c:v>
                </c:pt>
                <c:pt idx="37">
                  <c:v>88.8888888888889</c:v>
                </c:pt>
                <c:pt idx="38">
                  <c:v>89.189189189189193</c:v>
                </c:pt>
                <c:pt idx="39">
                  <c:v>89.830508474576263</c:v>
                </c:pt>
                <c:pt idx="40">
                  <c:v>90.217391304347828</c:v>
                </c:pt>
                <c:pt idx="41">
                  <c:v>90.598290598290603</c:v>
                </c:pt>
                <c:pt idx="42">
                  <c:v>90.909090909090907</c:v>
                </c:pt>
                <c:pt idx="43">
                  <c:v>91.176470588235276</c:v>
                </c:pt>
                <c:pt idx="44">
                  <c:v>91.228070175438589</c:v>
                </c:pt>
                <c:pt idx="45">
                  <c:v>91.228070175438617</c:v>
                </c:pt>
                <c:pt idx="46">
                  <c:v>91.366906474820127</c:v>
                </c:pt>
                <c:pt idx="47">
                  <c:v>91.891891891891873</c:v>
                </c:pt>
                <c:pt idx="48">
                  <c:v>92.96875</c:v>
                </c:pt>
                <c:pt idx="49">
                  <c:v>93.162393162393158</c:v>
                </c:pt>
                <c:pt idx="50">
                  <c:v>93.333333333333329</c:v>
                </c:pt>
                <c:pt idx="51">
                  <c:v>93.388429752066102</c:v>
                </c:pt>
                <c:pt idx="52">
                  <c:v>93.495934959349569</c:v>
                </c:pt>
                <c:pt idx="53">
                  <c:v>93.518518518518505</c:v>
                </c:pt>
                <c:pt idx="54">
                  <c:v>93.89312977099236</c:v>
                </c:pt>
                <c:pt idx="55">
                  <c:v>93.999999999999957</c:v>
                </c:pt>
                <c:pt idx="56">
                  <c:v>93.999999999999986</c:v>
                </c:pt>
                <c:pt idx="57">
                  <c:v>94.166666666666671</c:v>
                </c:pt>
                <c:pt idx="58">
                  <c:v>94.285714285714306</c:v>
                </c:pt>
                <c:pt idx="59">
                  <c:v>94.444444444444443</c:v>
                </c:pt>
                <c:pt idx="60">
                  <c:v>94.56521739130433</c:v>
                </c:pt>
                <c:pt idx="61">
                  <c:v>94.687500000000014</c:v>
                </c:pt>
                <c:pt idx="62">
                  <c:v>94.782608695652158</c:v>
                </c:pt>
                <c:pt idx="63">
                  <c:v>95.081967213114737</c:v>
                </c:pt>
                <c:pt idx="64">
                  <c:v>95.098039215686285</c:v>
                </c:pt>
                <c:pt idx="65">
                  <c:v>95.161290322580655</c:v>
                </c:pt>
                <c:pt idx="66">
                  <c:v>95.200000000000017</c:v>
                </c:pt>
                <c:pt idx="67">
                  <c:v>95.698924731182814</c:v>
                </c:pt>
                <c:pt idx="68">
                  <c:v>95.726495726495727</c:v>
                </c:pt>
                <c:pt idx="69">
                  <c:v>96.078431372549034</c:v>
                </c:pt>
                <c:pt idx="70">
                  <c:v>96.363636363636374</c:v>
                </c:pt>
                <c:pt idx="71">
                  <c:v>96.36871508379889</c:v>
                </c:pt>
                <c:pt idx="72">
                  <c:v>97.590361445783145</c:v>
                </c:pt>
                <c:pt idx="73">
                  <c:v>98.076923076923066</c:v>
                </c:pt>
                <c:pt idx="74">
                  <c:v>99.074074074074105</c:v>
                </c:pt>
                <c:pt idx="75">
                  <c:v>100.00000000000003</c:v>
                </c:pt>
                <c:pt idx="76">
                  <c:v>100.83333333333333</c:v>
                </c:pt>
                <c:pt idx="77">
                  <c:v>100.86206896551724</c:v>
                </c:pt>
                <c:pt idx="78">
                  <c:v>100.93457943925237</c:v>
                </c:pt>
                <c:pt idx="79">
                  <c:v>100.98039215686273</c:v>
                </c:pt>
                <c:pt idx="80">
                  <c:v>101.63934426229508</c:v>
                </c:pt>
                <c:pt idx="81">
                  <c:v>101.92307692307692</c:v>
                </c:pt>
                <c:pt idx="82">
                  <c:v>102.04081632653066</c:v>
                </c:pt>
                <c:pt idx="83">
                  <c:v>103.19148936170211</c:v>
                </c:pt>
                <c:pt idx="84">
                  <c:v>103.66972477064218</c:v>
                </c:pt>
                <c:pt idx="85">
                  <c:v>103.70370370370372</c:v>
                </c:pt>
                <c:pt idx="86">
                  <c:v>104.65116279069768</c:v>
                </c:pt>
                <c:pt idx="87">
                  <c:v>105.31914893617021</c:v>
                </c:pt>
                <c:pt idx="88">
                  <c:v>105.55555555555559</c:v>
                </c:pt>
                <c:pt idx="89">
                  <c:v>106.83760683760681</c:v>
                </c:pt>
                <c:pt idx="90">
                  <c:v>107.14285714285711</c:v>
                </c:pt>
                <c:pt idx="91">
                  <c:v>107.54716981132076</c:v>
                </c:pt>
                <c:pt idx="92">
                  <c:v>109.02527075812267</c:v>
                </c:pt>
                <c:pt idx="93">
                  <c:v>112.26415094339619</c:v>
                </c:pt>
                <c:pt idx="94">
                  <c:v>115.45454545454544</c:v>
                </c:pt>
                <c:pt idx="95">
                  <c:v>126.250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11936"/>
        <c:axId val="157112512"/>
      </c:scatterChart>
      <c:valAx>
        <c:axId val="15711193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>
            <c:manualLayout>
              <c:xMode val="edge"/>
              <c:yMode val="edge"/>
              <c:x val="0.32225240594925636"/>
              <c:y val="0.88294620703519699"/>
            </c:manualLayout>
          </c:layout>
          <c:overlay val="0"/>
        </c:title>
        <c:majorTickMark val="out"/>
        <c:minorTickMark val="none"/>
        <c:tickLblPos val="nextTo"/>
        <c:crossAx val="157112512"/>
        <c:crosses val="autoZero"/>
        <c:crossBetween val="midCat"/>
      </c:valAx>
      <c:valAx>
        <c:axId val="157112512"/>
        <c:scaling>
          <c:orientation val="minMax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71119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6772353455818023"/>
          <c:y val="0.54601770438205277"/>
          <c:w val="0.27116535433070865"/>
          <c:h val="7.5935015157046037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43409427673165"/>
          <c:y val="5.1400554097404488E-2"/>
          <c:w val="0.74922781569784791"/>
          <c:h val="0.81873067949839606"/>
        </c:manualLayout>
      </c:layout>
      <c:scatterChart>
        <c:scatterStyle val="lineMarker"/>
        <c:varyColors val="0"/>
        <c:ser>
          <c:idx val="6"/>
          <c:order val="0"/>
          <c:tx>
            <c:strRef>
              <c:f>Ethanol!$I$1</c:f>
              <c:strCache>
                <c:ptCount val="1"/>
                <c:pt idx="0">
                  <c:v>Ethan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Ethanol!$B$2:$B$97</c:f>
              <c:strCache>
                <c:ptCount val="96"/>
                <c:pt idx="0">
                  <c:v>B11</c:v>
                </c:pt>
                <c:pt idx="1">
                  <c:v>D8</c:v>
                </c:pt>
                <c:pt idx="2">
                  <c:v>C12</c:v>
                </c:pt>
                <c:pt idx="3">
                  <c:v>F7</c:v>
                </c:pt>
                <c:pt idx="4">
                  <c:v>A4</c:v>
                </c:pt>
                <c:pt idx="5">
                  <c:v>A3</c:v>
                </c:pt>
                <c:pt idx="6">
                  <c:v>B7</c:v>
                </c:pt>
                <c:pt idx="7">
                  <c:v>E8</c:v>
                </c:pt>
                <c:pt idx="8">
                  <c:v>C3</c:v>
                </c:pt>
                <c:pt idx="9">
                  <c:v>E6</c:v>
                </c:pt>
                <c:pt idx="10">
                  <c:v>B1</c:v>
                </c:pt>
                <c:pt idx="11">
                  <c:v>A6</c:v>
                </c:pt>
                <c:pt idx="12">
                  <c:v>E3</c:v>
                </c:pt>
                <c:pt idx="13">
                  <c:v>E12</c:v>
                </c:pt>
                <c:pt idx="14">
                  <c:v>E1</c:v>
                </c:pt>
                <c:pt idx="15">
                  <c:v>C9</c:v>
                </c:pt>
                <c:pt idx="16">
                  <c:v>A12</c:v>
                </c:pt>
                <c:pt idx="17">
                  <c:v>E10</c:v>
                </c:pt>
                <c:pt idx="18">
                  <c:v>D6</c:v>
                </c:pt>
                <c:pt idx="19">
                  <c:v>C8</c:v>
                </c:pt>
                <c:pt idx="20">
                  <c:v>D2</c:v>
                </c:pt>
                <c:pt idx="21">
                  <c:v>B8</c:v>
                </c:pt>
                <c:pt idx="22">
                  <c:v>B9</c:v>
                </c:pt>
                <c:pt idx="23">
                  <c:v>E2</c:v>
                </c:pt>
                <c:pt idx="24">
                  <c:v>D12</c:v>
                </c:pt>
                <c:pt idx="25">
                  <c:v>D3</c:v>
                </c:pt>
                <c:pt idx="26">
                  <c:v>C5</c:v>
                </c:pt>
                <c:pt idx="27">
                  <c:v>C10</c:v>
                </c:pt>
                <c:pt idx="28">
                  <c:v>A10</c:v>
                </c:pt>
                <c:pt idx="29">
                  <c:v>E5</c:v>
                </c:pt>
                <c:pt idx="30">
                  <c:v>B10</c:v>
                </c:pt>
                <c:pt idx="31">
                  <c:v>D1</c:v>
                </c:pt>
                <c:pt idx="32">
                  <c:v>C1</c:v>
                </c:pt>
                <c:pt idx="33">
                  <c:v>F6</c:v>
                </c:pt>
                <c:pt idx="34">
                  <c:v>F1</c:v>
                </c:pt>
                <c:pt idx="35">
                  <c:v>A11</c:v>
                </c:pt>
                <c:pt idx="36">
                  <c:v>C7</c:v>
                </c:pt>
                <c:pt idx="37">
                  <c:v>D11</c:v>
                </c:pt>
                <c:pt idx="38">
                  <c:v>B6</c:v>
                </c:pt>
                <c:pt idx="39">
                  <c:v>D10</c:v>
                </c:pt>
                <c:pt idx="40">
                  <c:v>E4</c:v>
                </c:pt>
                <c:pt idx="41">
                  <c:v>H7</c:v>
                </c:pt>
                <c:pt idx="42">
                  <c:v>A1</c:v>
                </c:pt>
                <c:pt idx="43">
                  <c:v>C4</c:v>
                </c:pt>
                <c:pt idx="44">
                  <c:v>B12</c:v>
                </c:pt>
                <c:pt idx="45">
                  <c:v>D4</c:v>
                </c:pt>
                <c:pt idx="46">
                  <c:v>E11</c:v>
                </c:pt>
                <c:pt idx="47">
                  <c:v>B4</c:v>
                </c:pt>
                <c:pt idx="48">
                  <c:v>D9</c:v>
                </c:pt>
                <c:pt idx="49">
                  <c:v>A7</c:v>
                </c:pt>
                <c:pt idx="50">
                  <c:v>D7</c:v>
                </c:pt>
                <c:pt idx="51">
                  <c:v>B5</c:v>
                </c:pt>
                <c:pt idx="52">
                  <c:v>F8</c:v>
                </c:pt>
                <c:pt idx="53">
                  <c:v>A9</c:v>
                </c:pt>
                <c:pt idx="54">
                  <c:v>B3</c:v>
                </c:pt>
                <c:pt idx="55">
                  <c:v>H8</c:v>
                </c:pt>
                <c:pt idx="56">
                  <c:v>G12</c:v>
                </c:pt>
                <c:pt idx="57">
                  <c:v>E7</c:v>
                </c:pt>
                <c:pt idx="58">
                  <c:v>H10</c:v>
                </c:pt>
                <c:pt idx="59">
                  <c:v>A2</c:v>
                </c:pt>
                <c:pt idx="60">
                  <c:v>C11</c:v>
                </c:pt>
                <c:pt idx="61">
                  <c:v>E9</c:v>
                </c:pt>
                <c:pt idx="62">
                  <c:v>C6</c:v>
                </c:pt>
                <c:pt idx="63">
                  <c:v>G7</c:v>
                </c:pt>
                <c:pt idx="64">
                  <c:v>A5</c:v>
                </c:pt>
                <c:pt idx="65">
                  <c:v>F4</c:v>
                </c:pt>
                <c:pt idx="66">
                  <c:v>D5</c:v>
                </c:pt>
                <c:pt idx="67">
                  <c:v>H1</c:v>
                </c:pt>
                <c:pt idx="68">
                  <c:v>H11</c:v>
                </c:pt>
                <c:pt idx="69">
                  <c:v>F5</c:v>
                </c:pt>
                <c:pt idx="70">
                  <c:v>F3</c:v>
                </c:pt>
                <c:pt idx="71">
                  <c:v>G8</c:v>
                </c:pt>
                <c:pt idx="72">
                  <c:v>F12</c:v>
                </c:pt>
                <c:pt idx="73">
                  <c:v>F11</c:v>
                </c:pt>
                <c:pt idx="74">
                  <c:v>G6</c:v>
                </c:pt>
                <c:pt idx="75">
                  <c:v>B2</c:v>
                </c:pt>
                <c:pt idx="76">
                  <c:v>G4</c:v>
                </c:pt>
                <c:pt idx="77">
                  <c:v>H4</c:v>
                </c:pt>
                <c:pt idx="78">
                  <c:v>G1</c:v>
                </c:pt>
                <c:pt idx="79">
                  <c:v>H3</c:v>
                </c:pt>
                <c:pt idx="80">
                  <c:v>H12</c:v>
                </c:pt>
                <c:pt idx="81">
                  <c:v>H6</c:v>
                </c:pt>
                <c:pt idx="82">
                  <c:v>H5</c:v>
                </c:pt>
                <c:pt idx="83">
                  <c:v>G9</c:v>
                </c:pt>
                <c:pt idx="84">
                  <c:v>C2</c:v>
                </c:pt>
                <c:pt idx="85">
                  <c:v>G2</c:v>
                </c:pt>
                <c:pt idx="86">
                  <c:v>G11</c:v>
                </c:pt>
                <c:pt idx="87">
                  <c:v>G3</c:v>
                </c:pt>
                <c:pt idx="88">
                  <c:v>F2</c:v>
                </c:pt>
                <c:pt idx="89">
                  <c:v>F10</c:v>
                </c:pt>
                <c:pt idx="90">
                  <c:v>G5</c:v>
                </c:pt>
                <c:pt idx="91">
                  <c:v>H9</c:v>
                </c:pt>
                <c:pt idx="92">
                  <c:v>A8</c:v>
                </c:pt>
                <c:pt idx="93">
                  <c:v>G10</c:v>
                </c:pt>
                <c:pt idx="94">
                  <c:v>H2</c:v>
                </c:pt>
                <c:pt idx="95">
                  <c:v>F9</c:v>
                </c:pt>
              </c:strCache>
            </c:strRef>
          </c:xVal>
          <c:yVal>
            <c:numRef>
              <c:f>Ethanol!$I$2:$I$97</c:f>
              <c:numCache>
                <c:formatCode>General</c:formatCode>
                <c:ptCount val="9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8196721311475641</c:v>
                </c:pt>
                <c:pt idx="9">
                  <c:v>0.86206896551724765</c:v>
                </c:pt>
                <c:pt idx="10">
                  <c:v>2.1276595744681002</c:v>
                </c:pt>
                <c:pt idx="11">
                  <c:v>2.1739130434782759</c:v>
                </c:pt>
                <c:pt idx="12">
                  <c:v>3.0769230769230829</c:v>
                </c:pt>
                <c:pt idx="13">
                  <c:v>4.2372881355932135</c:v>
                </c:pt>
                <c:pt idx="14">
                  <c:v>4.761904761904745</c:v>
                </c:pt>
                <c:pt idx="15">
                  <c:v>4.9079754601227075</c:v>
                </c:pt>
                <c:pt idx="16">
                  <c:v>5.1470588235294166</c:v>
                </c:pt>
                <c:pt idx="17">
                  <c:v>5.3191489361702287</c:v>
                </c:pt>
                <c:pt idx="18">
                  <c:v>5.426356589147292</c:v>
                </c:pt>
                <c:pt idx="19">
                  <c:v>5.4687499999999885</c:v>
                </c:pt>
                <c:pt idx="20">
                  <c:v>5.9322033898304971</c:v>
                </c:pt>
                <c:pt idx="21">
                  <c:v>6.4814814814814676</c:v>
                </c:pt>
                <c:pt idx="22">
                  <c:v>6.5217391304347823</c:v>
                </c:pt>
                <c:pt idx="23">
                  <c:v>7.1428571428571423</c:v>
                </c:pt>
                <c:pt idx="24">
                  <c:v>7.6086956521738971</c:v>
                </c:pt>
                <c:pt idx="25">
                  <c:v>7.9207920792079332</c:v>
                </c:pt>
                <c:pt idx="26">
                  <c:v>8.3333333333333393</c:v>
                </c:pt>
                <c:pt idx="27">
                  <c:v>8.4615384615384404</c:v>
                </c:pt>
                <c:pt idx="28">
                  <c:v>8.8235294117647047</c:v>
                </c:pt>
                <c:pt idx="29">
                  <c:v>8.8235294117647065</c:v>
                </c:pt>
                <c:pt idx="30">
                  <c:v>9.0909090909090917</c:v>
                </c:pt>
                <c:pt idx="31">
                  <c:v>9.0909090909090917</c:v>
                </c:pt>
                <c:pt idx="32">
                  <c:v>9.5588235294117538</c:v>
                </c:pt>
                <c:pt idx="33">
                  <c:v>9.5744680851063837</c:v>
                </c:pt>
                <c:pt idx="34">
                  <c:v>9.9009900990099311</c:v>
                </c:pt>
                <c:pt idx="35">
                  <c:v>10.317460317460341</c:v>
                </c:pt>
                <c:pt idx="36">
                  <c:v>10.937500000000014</c:v>
                </c:pt>
                <c:pt idx="37">
                  <c:v>11.000000000000016</c:v>
                </c:pt>
                <c:pt idx="38">
                  <c:v>11.510791366906481</c:v>
                </c:pt>
                <c:pt idx="39">
                  <c:v>11.851851851851842</c:v>
                </c:pt>
                <c:pt idx="40">
                  <c:v>12.800000000000022</c:v>
                </c:pt>
                <c:pt idx="41">
                  <c:v>13.20754716981132</c:v>
                </c:pt>
                <c:pt idx="42">
                  <c:v>13.544668587896266</c:v>
                </c:pt>
                <c:pt idx="43">
                  <c:v>14.035087719298229</c:v>
                </c:pt>
                <c:pt idx="44">
                  <c:v>14.529914529914507</c:v>
                </c:pt>
                <c:pt idx="45">
                  <c:v>14.529914529914507</c:v>
                </c:pt>
                <c:pt idx="46">
                  <c:v>15.702479338842959</c:v>
                </c:pt>
                <c:pt idx="47">
                  <c:v>16.030534351145036</c:v>
                </c:pt>
                <c:pt idx="48">
                  <c:v>16.393442622950833</c:v>
                </c:pt>
                <c:pt idx="49">
                  <c:v>16.428571428571409</c:v>
                </c:pt>
                <c:pt idx="50">
                  <c:v>16.666666666666679</c:v>
                </c:pt>
                <c:pt idx="51">
                  <c:v>17.09401709401709</c:v>
                </c:pt>
                <c:pt idx="52">
                  <c:v>17.37089201877933</c:v>
                </c:pt>
                <c:pt idx="53">
                  <c:v>17.431192660550465</c:v>
                </c:pt>
                <c:pt idx="54">
                  <c:v>17.557251908396925</c:v>
                </c:pt>
                <c:pt idx="55">
                  <c:v>18.292682926829269</c:v>
                </c:pt>
                <c:pt idx="56">
                  <c:v>18.97810218978103</c:v>
                </c:pt>
                <c:pt idx="57">
                  <c:v>19.444444444444446</c:v>
                </c:pt>
                <c:pt idx="58">
                  <c:v>19.480519480519479</c:v>
                </c:pt>
                <c:pt idx="59">
                  <c:v>19.626168224299047</c:v>
                </c:pt>
                <c:pt idx="60">
                  <c:v>20.175438596491251</c:v>
                </c:pt>
                <c:pt idx="61">
                  <c:v>20.21276595744682</c:v>
                </c:pt>
                <c:pt idx="62">
                  <c:v>21.259842519685041</c:v>
                </c:pt>
                <c:pt idx="63">
                  <c:v>21.29032258064516</c:v>
                </c:pt>
                <c:pt idx="64">
                  <c:v>21.385542168674686</c:v>
                </c:pt>
                <c:pt idx="65">
                  <c:v>21.51898734177216</c:v>
                </c:pt>
                <c:pt idx="66">
                  <c:v>22.463768115942031</c:v>
                </c:pt>
                <c:pt idx="67">
                  <c:v>22.580645161290313</c:v>
                </c:pt>
                <c:pt idx="68">
                  <c:v>23.333333333333332</c:v>
                </c:pt>
                <c:pt idx="69">
                  <c:v>24.271844660194162</c:v>
                </c:pt>
                <c:pt idx="70">
                  <c:v>24.836601307189536</c:v>
                </c:pt>
                <c:pt idx="71">
                  <c:v>25.714285714285719</c:v>
                </c:pt>
                <c:pt idx="72">
                  <c:v>25.974025974025977</c:v>
                </c:pt>
                <c:pt idx="73">
                  <c:v>27.108433734939769</c:v>
                </c:pt>
                <c:pt idx="74">
                  <c:v>27.272727272727259</c:v>
                </c:pt>
                <c:pt idx="75">
                  <c:v>28.346456692913367</c:v>
                </c:pt>
                <c:pt idx="76">
                  <c:v>29.333333333333329</c:v>
                </c:pt>
                <c:pt idx="77">
                  <c:v>29.761904761904763</c:v>
                </c:pt>
                <c:pt idx="78">
                  <c:v>30</c:v>
                </c:pt>
                <c:pt idx="79">
                  <c:v>30.769230769230777</c:v>
                </c:pt>
                <c:pt idx="80">
                  <c:v>32.317073170731689</c:v>
                </c:pt>
                <c:pt idx="81">
                  <c:v>33.06451612903227</c:v>
                </c:pt>
                <c:pt idx="82">
                  <c:v>33.082706766917283</c:v>
                </c:pt>
                <c:pt idx="83">
                  <c:v>33.557046979865781</c:v>
                </c:pt>
                <c:pt idx="84">
                  <c:v>34.871794871794826</c:v>
                </c:pt>
                <c:pt idx="85">
                  <c:v>35.877862595419849</c:v>
                </c:pt>
                <c:pt idx="86">
                  <c:v>36.290322580645167</c:v>
                </c:pt>
                <c:pt idx="87">
                  <c:v>37.007874015748023</c:v>
                </c:pt>
                <c:pt idx="88">
                  <c:v>37.226277372262778</c:v>
                </c:pt>
                <c:pt idx="89">
                  <c:v>38.596491228070178</c:v>
                </c:pt>
                <c:pt idx="90">
                  <c:v>38.636363636363633</c:v>
                </c:pt>
                <c:pt idx="91">
                  <c:v>40.764331210191088</c:v>
                </c:pt>
                <c:pt idx="92">
                  <c:v>41.911764705882348</c:v>
                </c:pt>
                <c:pt idx="93">
                  <c:v>41.964285714285715</c:v>
                </c:pt>
                <c:pt idx="94">
                  <c:v>42.682926829268318</c:v>
                </c:pt>
                <c:pt idx="95">
                  <c:v>46.42032332563511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44800"/>
        <c:axId val="87245376"/>
      </c:scatterChart>
      <c:valAx>
        <c:axId val="8724480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87245376"/>
        <c:crosses val="autoZero"/>
        <c:crossBetween val="midCat"/>
      </c:valAx>
      <c:valAx>
        <c:axId val="8724537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244800"/>
        <c:crosses val="autoZero"/>
        <c:crossBetween val="midCat"/>
        <c:majorUnit val="10"/>
      </c:valAx>
    </c:plotArea>
    <c:legend>
      <c:legendPos val="r"/>
      <c:layout>
        <c:manualLayout>
          <c:xMode val="edge"/>
          <c:yMode val="edge"/>
          <c:x val="0.69764628632088821"/>
          <c:y val="0.60774218976728123"/>
          <c:w val="0.25922939041477028"/>
          <c:h val="7.5054120618386885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770075726352987"/>
          <c:y val="5.1400554097404488E-2"/>
          <c:w val="0.66489610473388261"/>
          <c:h val="0.81873067949839606"/>
        </c:manualLayout>
      </c:layout>
      <c:scatterChart>
        <c:scatterStyle val="lineMarker"/>
        <c:varyColors val="0"/>
        <c:ser>
          <c:idx val="7"/>
          <c:order val="0"/>
          <c:tx>
            <c:strRef>
              <c:f>'Temperature 35'!$J$1</c:f>
              <c:strCache>
                <c:ptCount val="1"/>
                <c:pt idx="0">
                  <c:v>T (35'C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Temperature 35'!$B$2:$B$97</c:f>
              <c:strCache>
                <c:ptCount val="96"/>
                <c:pt idx="0">
                  <c:v>A7</c:v>
                </c:pt>
                <c:pt idx="1">
                  <c:v>A6</c:v>
                </c:pt>
                <c:pt idx="2">
                  <c:v>B4</c:v>
                </c:pt>
                <c:pt idx="3">
                  <c:v>A5</c:v>
                </c:pt>
                <c:pt idx="4">
                  <c:v>F11</c:v>
                </c:pt>
                <c:pt idx="5">
                  <c:v>H8</c:v>
                </c:pt>
                <c:pt idx="6">
                  <c:v>F12</c:v>
                </c:pt>
                <c:pt idx="7">
                  <c:v>H1</c:v>
                </c:pt>
                <c:pt idx="8">
                  <c:v>A10</c:v>
                </c:pt>
                <c:pt idx="9">
                  <c:v>A1</c:v>
                </c:pt>
                <c:pt idx="10">
                  <c:v>C9</c:v>
                </c:pt>
                <c:pt idx="11">
                  <c:v>A12</c:v>
                </c:pt>
                <c:pt idx="12">
                  <c:v>F3</c:v>
                </c:pt>
                <c:pt idx="13">
                  <c:v>H7</c:v>
                </c:pt>
                <c:pt idx="14">
                  <c:v>H11</c:v>
                </c:pt>
                <c:pt idx="15">
                  <c:v>H4</c:v>
                </c:pt>
                <c:pt idx="16">
                  <c:v>G4</c:v>
                </c:pt>
                <c:pt idx="17">
                  <c:v>B2</c:v>
                </c:pt>
                <c:pt idx="18">
                  <c:v>F9</c:v>
                </c:pt>
                <c:pt idx="19">
                  <c:v>H2</c:v>
                </c:pt>
                <c:pt idx="20">
                  <c:v>A8</c:v>
                </c:pt>
                <c:pt idx="21">
                  <c:v>G12</c:v>
                </c:pt>
                <c:pt idx="22">
                  <c:v>G2</c:v>
                </c:pt>
                <c:pt idx="23">
                  <c:v>C1</c:v>
                </c:pt>
                <c:pt idx="24">
                  <c:v>F2</c:v>
                </c:pt>
                <c:pt idx="25">
                  <c:v>H3</c:v>
                </c:pt>
                <c:pt idx="26">
                  <c:v>G7</c:v>
                </c:pt>
                <c:pt idx="27">
                  <c:v>F6</c:v>
                </c:pt>
                <c:pt idx="28">
                  <c:v>C6</c:v>
                </c:pt>
                <c:pt idx="29">
                  <c:v>F8</c:v>
                </c:pt>
                <c:pt idx="30">
                  <c:v>F4</c:v>
                </c:pt>
                <c:pt idx="31">
                  <c:v>B3</c:v>
                </c:pt>
                <c:pt idx="32">
                  <c:v>G3</c:v>
                </c:pt>
                <c:pt idx="33">
                  <c:v>G5</c:v>
                </c:pt>
                <c:pt idx="34">
                  <c:v>G1</c:v>
                </c:pt>
                <c:pt idx="35">
                  <c:v>H10</c:v>
                </c:pt>
                <c:pt idx="36">
                  <c:v>C5</c:v>
                </c:pt>
                <c:pt idx="37">
                  <c:v>G6</c:v>
                </c:pt>
                <c:pt idx="38">
                  <c:v>B9</c:v>
                </c:pt>
                <c:pt idx="39">
                  <c:v>D2</c:v>
                </c:pt>
                <c:pt idx="40">
                  <c:v>C7</c:v>
                </c:pt>
                <c:pt idx="41">
                  <c:v>H5</c:v>
                </c:pt>
                <c:pt idx="42">
                  <c:v>G9</c:v>
                </c:pt>
                <c:pt idx="43">
                  <c:v>D9</c:v>
                </c:pt>
                <c:pt idx="44">
                  <c:v>E5</c:v>
                </c:pt>
                <c:pt idx="45">
                  <c:v>D6</c:v>
                </c:pt>
                <c:pt idx="46">
                  <c:v>D10</c:v>
                </c:pt>
                <c:pt idx="47">
                  <c:v>G8</c:v>
                </c:pt>
                <c:pt idx="48">
                  <c:v>H9</c:v>
                </c:pt>
                <c:pt idx="49">
                  <c:v>G11</c:v>
                </c:pt>
                <c:pt idx="50">
                  <c:v>D5</c:v>
                </c:pt>
                <c:pt idx="51">
                  <c:v>C10</c:v>
                </c:pt>
                <c:pt idx="52">
                  <c:v>H12</c:v>
                </c:pt>
                <c:pt idx="53">
                  <c:v>C8</c:v>
                </c:pt>
                <c:pt idx="54">
                  <c:v>E2</c:v>
                </c:pt>
                <c:pt idx="55">
                  <c:v>A3</c:v>
                </c:pt>
                <c:pt idx="56">
                  <c:v>A11</c:v>
                </c:pt>
                <c:pt idx="57">
                  <c:v>E6</c:v>
                </c:pt>
                <c:pt idx="58">
                  <c:v>B12</c:v>
                </c:pt>
                <c:pt idx="59">
                  <c:v>E3</c:v>
                </c:pt>
                <c:pt idx="60">
                  <c:v>C3</c:v>
                </c:pt>
                <c:pt idx="61">
                  <c:v>E11</c:v>
                </c:pt>
                <c:pt idx="62">
                  <c:v>D7</c:v>
                </c:pt>
                <c:pt idx="63">
                  <c:v>B5</c:v>
                </c:pt>
                <c:pt idx="64">
                  <c:v>F5</c:v>
                </c:pt>
                <c:pt idx="65">
                  <c:v>C12</c:v>
                </c:pt>
                <c:pt idx="66">
                  <c:v>C2</c:v>
                </c:pt>
                <c:pt idx="67">
                  <c:v>B8</c:v>
                </c:pt>
                <c:pt idx="68">
                  <c:v>D8</c:v>
                </c:pt>
                <c:pt idx="69">
                  <c:v>B6</c:v>
                </c:pt>
                <c:pt idx="70">
                  <c:v>E4</c:v>
                </c:pt>
                <c:pt idx="71">
                  <c:v>G10</c:v>
                </c:pt>
                <c:pt idx="72">
                  <c:v>E8</c:v>
                </c:pt>
                <c:pt idx="73">
                  <c:v>A2</c:v>
                </c:pt>
                <c:pt idx="74">
                  <c:v>B7</c:v>
                </c:pt>
                <c:pt idx="75">
                  <c:v>H6</c:v>
                </c:pt>
                <c:pt idx="76">
                  <c:v>C4</c:v>
                </c:pt>
                <c:pt idx="77">
                  <c:v>A4</c:v>
                </c:pt>
                <c:pt idx="78">
                  <c:v>A9</c:v>
                </c:pt>
                <c:pt idx="79">
                  <c:v>D4</c:v>
                </c:pt>
                <c:pt idx="80">
                  <c:v>E12</c:v>
                </c:pt>
                <c:pt idx="81">
                  <c:v>B10</c:v>
                </c:pt>
                <c:pt idx="82">
                  <c:v>B11</c:v>
                </c:pt>
                <c:pt idx="83">
                  <c:v>D3</c:v>
                </c:pt>
                <c:pt idx="84">
                  <c:v>E7</c:v>
                </c:pt>
                <c:pt idx="85">
                  <c:v>E10</c:v>
                </c:pt>
                <c:pt idx="86">
                  <c:v>E9</c:v>
                </c:pt>
                <c:pt idx="87">
                  <c:v>C11</c:v>
                </c:pt>
                <c:pt idx="88">
                  <c:v>F1</c:v>
                </c:pt>
                <c:pt idx="89">
                  <c:v>F10</c:v>
                </c:pt>
                <c:pt idx="90">
                  <c:v>F7</c:v>
                </c:pt>
                <c:pt idx="91">
                  <c:v>D1</c:v>
                </c:pt>
                <c:pt idx="92">
                  <c:v>D12</c:v>
                </c:pt>
                <c:pt idx="93">
                  <c:v>D11</c:v>
                </c:pt>
                <c:pt idx="94">
                  <c:v>E1</c:v>
                </c:pt>
                <c:pt idx="95">
                  <c:v>B1</c:v>
                </c:pt>
              </c:strCache>
            </c:strRef>
          </c:xVal>
          <c:yVal>
            <c:numRef>
              <c:f>'Temperature 35'!$J$2:$J$97</c:f>
              <c:numCache>
                <c:formatCode>General</c:formatCode>
                <c:ptCount val="96"/>
                <c:pt idx="0">
                  <c:v>15.714285714285737</c:v>
                </c:pt>
                <c:pt idx="1">
                  <c:v>26.086956521739125</c:v>
                </c:pt>
                <c:pt idx="2">
                  <c:v>48.091603053435108</c:v>
                </c:pt>
                <c:pt idx="3">
                  <c:v>60.843373493975925</c:v>
                </c:pt>
                <c:pt idx="4">
                  <c:v>69.277108433734952</c:v>
                </c:pt>
                <c:pt idx="5">
                  <c:v>71.951219512195124</c:v>
                </c:pt>
                <c:pt idx="6">
                  <c:v>72.72727272727272</c:v>
                </c:pt>
                <c:pt idx="7">
                  <c:v>75.80645161290326</c:v>
                </c:pt>
                <c:pt idx="8">
                  <c:v>76.470588235294116</c:v>
                </c:pt>
                <c:pt idx="9">
                  <c:v>77.809798270893353</c:v>
                </c:pt>
                <c:pt idx="10">
                  <c:v>77.914110429447874</c:v>
                </c:pt>
                <c:pt idx="11">
                  <c:v>77.941176470588232</c:v>
                </c:pt>
                <c:pt idx="12">
                  <c:v>79.738562091503269</c:v>
                </c:pt>
                <c:pt idx="13">
                  <c:v>80.503144654088061</c:v>
                </c:pt>
                <c:pt idx="14">
                  <c:v>82.777777777777757</c:v>
                </c:pt>
                <c:pt idx="15">
                  <c:v>83.333333333333286</c:v>
                </c:pt>
                <c:pt idx="16">
                  <c:v>83.333333333333343</c:v>
                </c:pt>
                <c:pt idx="17">
                  <c:v>83.464566929133838</c:v>
                </c:pt>
                <c:pt idx="18">
                  <c:v>85.450346420323342</c:v>
                </c:pt>
                <c:pt idx="19">
                  <c:v>85.975609756097569</c:v>
                </c:pt>
                <c:pt idx="20">
                  <c:v>86.764705882352928</c:v>
                </c:pt>
                <c:pt idx="21">
                  <c:v>86.861313868613124</c:v>
                </c:pt>
                <c:pt idx="22">
                  <c:v>88.549618320610691</c:v>
                </c:pt>
                <c:pt idx="23">
                  <c:v>88.970588235294088</c:v>
                </c:pt>
                <c:pt idx="24">
                  <c:v>89.78102189781022</c:v>
                </c:pt>
                <c:pt idx="25">
                  <c:v>90.209790209790228</c:v>
                </c:pt>
                <c:pt idx="26">
                  <c:v>90.322580645161281</c:v>
                </c:pt>
                <c:pt idx="27">
                  <c:v>90.425531914893625</c:v>
                </c:pt>
                <c:pt idx="28">
                  <c:v>90.551181102362193</c:v>
                </c:pt>
                <c:pt idx="29">
                  <c:v>91.314553990610349</c:v>
                </c:pt>
                <c:pt idx="30">
                  <c:v>91.772151898734194</c:v>
                </c:pt>
                <c:pt idx="31">
                  <c:v>93.129770992366417</c:v>
                </c:pt>
                <c:pt idx="32">
                  <c:v>93.700787401574786</c:v>
                </c:pt>
                <c:pt idx="33">
                  <c:v>93.939393939393938</c:v>
                </c:pt>
                <c:pt idx="34">
                  <c:v>94.615384615384613</c:v>
                </c:pt>
                <c:pt idx="35">
                  <c:v>94.805194805194816</c:v>
                </c:pt>
                <c:pt idx="36">
                  <c:v>95.512820512820511</c:v>
                </c:pt>
                <c:pt idx="37">
                  <c:v>96.969696969696983</c:v>
                </c:pt>
                <c:pt idx="38">
                  <c:v>97.101449275362327</c:v>
                </c:pt>
                <c:pt idx="39">
                  <c:v>97.457627118644069</c:v>
                </c:pt>
                <c:pt idx="40">
                  <c:v>97.656250000000028</c:v>
                </c:pt>
                <c:pt idx="41">
                  <c:v>97.744360902255636</c:v>
                </c:pt>
                <c:pt idx="42">
                  <c:v>97.986577181208062</c:v>
                </c:pt>
                <c:pt idx="43">
                  <c:v>98.360655737704931</c:v>
                </c:pt>
                <c:pt idx="44">
                  <c:v>99.26470588235297</c:v>
                </c:pt>
                <c:pt idx="45">
                  <c:v>100.00000000000003</c:v>
                </c:pt>
                <c:pt idx="46">
                  <c:v>100.00000000000003</c:v>
                </c:pt>
                <c:pt idx="47">
                  <c:v>100.71428571428574</c:v>
                </c:pt>
                <c:pt idx="48">
                  <c:v>101.27388535031847</c:v>
                </c:pt>
                <c:pt idx="49">
                  <c:v>101.61290322580645</c:v>
                </c:pt>
                <c:pt idx="50">
                  <c:v>102.17391304347825</c:v>
                </c:pt>
                <c:pt idx="51">
                  <c:v>102.30769230769235</c:v>
                </c:pt>
                <c:pt idx="52">
                  <c:v>103.04878048780488</c:v>
                </c:pt>
                <c:pt idx="53">
                  <c:v>104.6875</c:v>
                </c:pt>
                <c:pt idx="54">
                  <c:v>104.76190476190477</c:v>
                </c:pt>
                <c:pt idx="55">
                  <c:v>105.08474576271188</c:v>
                </c:pt>
                <c:pt idx="56">
                  <c:v>105.55555555555559</c:v>
                </c:pt>
                <c:pt idx="57">
                  <c:v>106.03448275862068</c:v>
                </c:pt>
                <c:pt idx="58">
                  <c:v>106.83760683760686</c:v>
                </c:pt>
                <c:pt idx="59">
                  <c:v>107.69230769230769</c:v>
                </c:pt>
                <c:pt idx="60">
                  <c:v>108.19672131147544</c:v>
                </c:pt>
                <c:pt idx="61">
                  <c:v>109.09090909090904</c:v>
                </c:pt>
                <c:pt idx="62">
                  <c:v>109.42028985507248</c:v>
                </c:pt>
                <c:pt idx="63">
                  <c:v>110.25641025641029</c:v>
                </c:pt>
                <c:pt idx="64">
                  <c:v>110.67961165048546</c:v>
                </c:pt>
                <c:pt idx="65">
                  <c:v>110.96938775510201</c:v>
                </c:pt>
                <c:pt idx="66">
                  <c:v>111.79487179487172</c:v>
                </c:pt>
                <c:pt idx="67">
                  <c:v>112.037037037037</c:v>
                </c:pt>
                <c:pt idx="68">
                  <c:v>112.12121212121211</c:v>
                </c:pt>
                <c:pt idx="69">
                  <c:v>112.23021582733814</c:v>
                </c:pt>
                <c:pt idx="70">
                  <c:v>112.80000000000001</c:v>
                </c:pt>
                <c:pt idx="71">
                  <c:v>113.3928571428571</c:v>
                </c:pt>
                <c:pt idx="72">
                  <c:v>115.46391752577321</c:v>
                </c:pt>
                <c:pt idx="73">
                  <c:v>116.82242990654208</c:v>
                </c:pt>
                <c:pt idx="74">
                  <c:v>116.98113207547173</c:v>
                </c:pt>
                <c:pt idx="75">
                  <c:v>117.74193548387098</c:v>
                </c:pt>
                <c:pt idx="76">
                  <c:v>119.29824561403504</c:v>
                </c:pt>
                <c:pt idx="77">
                  <c:v>120.00000000000001</c:v>
                </c:pt>
                <c:pt idx="78">
                  <c:v>120.1834862385321</c:v>
                </c:pt>
                <c:pt idx="79">
                  <c:v>120.51282051282048</c:v>
                </c:pt>
                <c:pt idx="80">
                  <c:v>121.18644067796612</c:v>
                </c:pt>
                <c:pt idx="81">
                  <c:v>121.969696969697</c:v>
                </c:pt>
                <c:pt idx="82">
                  <c:v>122.64150943396221</c:v>
                </c:pt>
                <c:pt idx="83">
                  <c:v>122.7722772277228</c:v>
                </c:pt>
                <c:pt idx="84">
                  <c:v>124.99999999999996</c:v>
                </c:pt>
                <c:pt idx="85">
                  <c:v>125.53191489361708</c:v>
                </c:pt>
                <c:pt idx="86">
                  <c:v>127.65957446808514</c:v>
                </c:pt>
                <c:pt idx="87">
                  <c:v>128.07017543859655</c:v>
                </c:pt>
                <c:pt idx="88">
                  <c:v>129.70297029702974</c:v>
                </c:pt>
                <c:pt idx="89">
                  <c:v>130.70175438596493</c:v>
                </c:pt>
                <c:pt idx="90">
                  <c:v>134.0659340659341</c:v>
                </c:pt>
                <c:pt idx="91">
                  <c:v>136.36363636363635</c:v>
                </c:pt>
                <c:pt idx="92">
                  <c:v>141.30434782608691</c:v>
                </c:pt>
                <c:pt idx="93">
                  <c:v>143.00000000000003</c:v>
                </c:pt>
                <c:pt idx="94">
                  <c:v>144.04761904761904</c:v>
                </c:pt>
                <c:pt idx="95">
                  <c:v>144.680851063829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47104"/>
        <c:axId val="87247680"/>
      </c:scatterChart>
      <c:valAx>
        <c:axId val="8724710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87247680"/>
        <c:crosses val="autoZero"/>
        <c:crossBetween val="midCat"/>
      </c:valAx>
      <c:valAx>
        <c:axId val="8724768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247104"/>
        <c:crosses val="autoZero"/>
        <c:crossBetween val="midCat"/>
        <c:majorUnit val="40"/>
      </c:valAx>
    </c:plotArea>
    <c:legend>
      <c:legendPos val="r"/>
      <c:layout>
        <c:manualLayout>
          <c:xMode val="edge"/>
          <c:yMode val="edge"/>
          <c:x val="0.60360969993233071"/>
          <c:y val="0.60183765844306758"/>
          <c:w val="0.3296561324835961"/>
          <c:h val="7.2612376097119499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71000393244131"/>
          <c:y val="5.1400554097404488E-2"/>
          <c:w val="0.73291825148457923"/>
          <c:h val="0.82798993875765525"/>
        </c:manualLayout>
      </c:layout>
      <c:scatterChart>
        <c:scatterStyle val="lineMarker"/>
        <c:varyColors val="0"/>
        <c:ser>
          <c:idx val="0"/>
          <c:order val="0"/>
          <c:tx>
            <c:strRef>
              <c:f>'Acetic acid'!$C$1</c:f>
              <c:strCache>
                <c:ptCount val="1"/>
                <c:pt idx="0">
                  <c:v>Acet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Acetic acid'!$B$2:$B$97</c:f>
              <c:strCache>
                <c:ptCount val="96"/>
                <c:pt idx="0">
                  <c:v>E5</c:v>
                </c:pt>
                <c:pt idx="1">
                  <c:v>D8</c:v>
                </c:pt>
                <c:pt idx="2">
                  <c:v>H4</c:v>
                </c:pt>
                <c:pt idx="3">
                  <c:v>D1</c:v>
                </c:pt>
                <c:pt idx="4">
                  <c:v>F8</c:v>
                </c:pt>
                <c:pt idx="5">
                  <c:v>D12</c:v>
                </c:pt>
                <c:pt idx="6">
                  <c:v>H2</c:v>
                </c:pt>
                <c:pt idx="7">
                  <c:v>G4</c:v>
                </c:pt>
                <c:pt idx="8">
                  <c:v>D4</c:v>
                </c:pt>
                <c:pt idx="9">
                  <c:v>C11</c:v>
                </c:pt>
                <c:pt idx="10">
                  <c:v>C4</c:v>
                </c:pt>
                <c:pt idx="11">
                  <c:v>E11</c:v>
                </c:pt>
                <c:pt idx="12">
                  <c:v>E7</c:v>
                </c:pt>
                <c:pt idx="13">
                  <c:v>A1</c:v>
                </c:pt>
                <c:pt idx="14">
                  <c:v>C8</c:v>
                </c:pt>
                <c:pt idx="15">
                  <c:v>H3</c:v>
                </c:pt>
                <c:pt idx="16">
                  <c:v>G10</c:v>
                </c:pt>
                <c:pt idx="17">
                  <c:v>G11</c:v>
                </c:pt>
                <c:pt idx="18">
                  <c:v>F9</c:v>
                </c:pt>
                <c:pt idx="19">
                  <c:v>F4</c:v>
                </c:pt>
                <c:pt idx="20">
                  <c:v>D2</c:v>
                </c:pt>
                <c:pt idx="21">
                  <c:v>B10</c:v>
                </c:pt>
                <c:pt idx="22">
                  <c:v>C10</c:v>
                </c:pt>
                <c:pt idx="23">
                  <c:v>A12</c:v>
                </c:pt>
                <c:pt idx="24">
                  <c:v>G2</c:v>
                </c:pt>
                <c:pt idx="25">
                  <c:v>F11</c:v>
                </c:pt>
                <c:pt idx="26">
                  <c:v>B12</c:v>
                </c:pt>
                <c:pt idx="27">
                  <c:v>H10</c:v>
                </c:pt>
                <c:pt idx="28">
                  <c:v>H8</c:v>
                </c:pt>
                <c:pt idx="29">
                  <c:v>C12</c:v>
                </c:pt>
                <c:pt idx="30">
                  <c:v>E12</c:v>
                </c:pt>
                <c:pt idx="31">
                  <c:v>D10</c:v>
                </c:pt>
                <c:pt idx="32">
                  <c:v>C7</c:v>
                </c:pt>
                <c:pt idx="33">
                  <c:v>D11</c:v>
                </c:pt>
                <c:pt idx="34">
                  <c:v>C1</c:v>
                </c:pt>
                <c:pt idx="35">
                  <c:v>B1</c:v>
                </c:pt>
                <c:pt idx="36">
                  <c:v>E4</c:v>
                </c:pt>
                <c:pt idx="37">
                  <c:v>B11</c:v>
                </c:pt>
                <c:pt idx="38">
                  <c:v>D7</c:v>
                </c:pt>
                <c:pt idx="39">
                  <c:v>F7</c:v>
                </c:pt>
                <c:pt idx="40">
                  <c:v>B8</c:v>
                </c:pt>
                <c:pt idx="41">
                  <c:v>F2</c:v>
                </c:pt>
                <c:pt idx="42">
                  <c:v>E1</c:v>
                </c:pt>
                <c:pt idx="43">
                  <c:v>H6</c:v>
                </c:pt>
                <c:pt idx="44">
                  <c:v>E8</c:v>
                </c:pt>
                <c:pt idx="45">
                  <c:v>D5</c:v>
                </c:pt>
                <c:pt idx="46">
                  <c:v>D6</c:v>
                </c:pt>
                <c:pt idx="47">
                  <c:v>B7</c:v>
                </c:pt>
                <c:pt idx="48">
                  <c:v>G6</c:v>
                </c:pt>
                <c:pt idx="49">
                  <c:v>E10</c:v>
                </c:pt>
                <c:pt idx="50">
                  <c:v>E3</c:v>
                </c:pt>
                <c:pt idx="51">
                  <c:v>C6</c:v>
                </c:pt>
                <c:pt idx="52">
                  <c:v>H5</c:v>
                </c:pt>
                <c:pt idx="53">
                  <c:v>H1</c:v>
                </c:pt>
                <c:pt idx="54">
                  <c:v>E6</c:v>
                </c:pt>
                <c:pt idx="55">
                  <c:v>A6</c:v>
                </c:pt>
                <c:pt idx="56">
                  <c:v>B2</c:v>
                </c:pt>
                <c:pt idx="57">
                  <c:v>H11</c:v>
                </c:pt>
                <c:pt idx="58">
                  <c:v>F3</c:v>
                </c:pt>
                <c:pt idx="59">
                  <c:v>G5</c:v>
                </c:pt>
                <c:pt idx="60">
                  <c:v>B4</c:v>
                </c:pt>
                <c:pt idx="61">
                  <c:v>D3</c:v>
                </c:pt>
                <c:pt idx="62">
                  <c:v>A10</c:v>
                </c:pt>
                <c:pt idx="63">
                  <c:v>H9</c:v>
                </c:pt>
                <c:pt idx="64">
                  <c:v>F5</c:v>
                </c:pt>
                <c:pt idx="65">
                  <c:v>H12</c:v>
                </c:pt>
                <c:pt idx="66">
                  <c:v>G12</c:v>
                </c:pt>
                <c:pt idx="67">
                  <c:v>F12</c:v>
                </c:pt>
                <c:pt idx="68">
                  <c:v>H7</c:v>
                </c:pt>
                <c:pt idx="69">
                  <c:v>A4</c:v>
                </c:pt>
                <c:pt idx="70">
                  <c:v>G8</c:v>
                </c:pt>
                <c:pt idx="71">
                  <c:v>C3</c:v>
                </c:pt>
                <c:pt idx="72">
                  <c:v>C2</c:v>
                </c:pt>
                <c:pt idx="73">
                  <c:v>D9</c:v>
                </c:pt>
                <c:pt idx="74">
                  <c:v>E9</c:v>
                </c:pt>
                <c:pt idx="75">
                  <c:v>A8</c:v>
                </c:pt>
                <c:pt idx="76">
                  <c:v>F1</c:v>
                </c:pt>
                <c:pt idx="77">
                  <c:v>B6</c:v>
                </c:pt>
                <c:pt idx="78">
                  <c:v>E2</c:v>
                </c:pt>
                <c:pt idx="79">
                  <c:v>G1</c:v>
                </c:pt>
                <c:pt idx="80">
                  <c:v>G3</c:v>
                </c:pt>
                <c:pt idx="81">
                  <c:v>G7</c:v>
                </c:pt>
                <c:pt idx="82">
                  <c:v>A7</c:v>
                </c:pt>
                <c:pt idx="83">
                  <c:v>A3</c:v>
                </c:pt>
                <c:pt idx="84">
                  <c:v>A5</c:v>
                </c:pt>
                <c:pt idx="85">
                  <c:v>C9</c:v>
                </c:pt>
                <c:pt idx="86">
                  <c:v>F10</c:v>
                </c:pt>
                <c:pt idx="87">
                  <c:v>G9</c:v>
                </c:pt>
                <c:pt idx="88">
                  <c:v>A9</c:v>
                </c:pt>
                <c:pt idx="89">
                  <c:v>B9</c:v>
                </c:pt>
                <c:pt idx="90">
                  <c:v>A2</c:v>
                </c:pt>
                <c:pt idx="91">
                  <c:v>B5</c:v>
                </c:pt>
                <c:pt idx="92">
                  <c:v>B3</c:v>
                </c:pt>
                <c:pt idx="93">
                  <c:v>A11</c:v>
                </c:pt>
                <c:pt idx="94">
                  <c:v>F6</c:v>
                </c:pt>
                <c:pt idx="95">
                  <c:v>C5</c:v>
                </c:pt>
              </c:strCache>
            </c:strRef>
          </c:xVal>
          <c:yVal>
            <c:numRef>
              <c:f>'Acetic acid'!$C$2:$C$97</c:f>
              <c:numCache>
                <c:formatCode>General</c:formatCode>
                <c:ptCount val="96"/>
                <c:pt idx="0">
                  <c:v>0</c:v>
                </c:pt>
                <c:pt idx="1">
                  <c:v>62.686567164179095</c:v>
                </c:pt>
                <c:pt idx="2">
                  <c:v>67.567567567567536</c:v>
                </c:pt>
                <c:pt idx="3">
                  <c:v>68.695652173913047</c:v>
                </c:pt>
                <c:pt idx="4">
                  <c:v>70</c:v>
                </c:pt>
                <c:pt idx="5">
                  <c:v>71.568627450980387</c:v>
                </c:pt>
                <c:pt idx="6">
                  <c:v>72.8</c:v>
                </c:pt>
                <c:pt idx="7">
                  <c:v>73.195876288659775</c:v>
                </c:pt>
                <c:pt idx="8">
                  <c:v>73.553719008264466</c:v>
                </c:pt>
                <c:pt idx="9">
                  <c:v>76.15384615384616</c:v>
                </c:pt>
                <c:pt idx="10">
                  <c:v>76.999999999999986</c:v>
                </c:pt>
                <c:pt idx="11">
                  <c:v>77.391304347826093</c:v>
                </c:pt>
                <c:pt idx="12">
                  <c:v>78.703703703703709</c:v>
                </c:pt>
                <c:pt idx="13">
                  <c:v>80.906148867313888</c:v>
                </c:pt>
                <c:pt idx="14">
                  <c:v>81.000000000000014</c:v>
                </c:pt>
                <c:pt idx="15">
                  <c:v>81.512605042016816</c:v>
                </c:pt>
                <c:pt idx="16">
                  <c:v>81.617647058823536</c:v>
                </c:pt>
                <c:pt idx="17">
                  <c:v>81.818181818181813</c:v>
                </c:pt>
                <c:pt idx="18">
                  <c:v>81.967213114754088</c:v>
                </c:pt>
                <c:pt idx="19">
                  <c:v>82.075471698113176</c:v>
                </c:pt>
                <c:pt idx="20">
                  <c:v>82.857142857142861</c:v>
                </c:pt>
                <c:pt idx="21">
                  <c:v>83.200000000000017</c:v>
                </c:pt>
                <c:pt idx="22">
                  <c:v>83.582089552238799</c:v>
                </c:pt>
                <c:pt idx="23">
                  <c:v>83.622828784119079</c:v>
                </c:pt>
                <c:pt idx="24">
                  <c:v>83.928571428571402</c:v>
                </c:pt>
                <c:pt idx="25">
                  <c:v>84.166666666666686</c:v>
                </c:pt>
                <c:pt idx="26">
                  <c:v>84.496124031007724</c:v>
                </c:pt>
                <c:pt idx="27">
                  <c:v>84.782608695652186</c:v>
                </c:pt>
                <c:pt idx="28">
                  <c:v>85.185185185185176</c:v>
                </c:pt>
                <c:pt idx="29">
                  <c:v>85.826771653543304</c:v>
                </c:pt>
                <c:pt idx="30">
                  <c:v>86.086956521739111</c:v>
                </c:pt>
                <c:pt idx="31">
                  <c:v>86.178861788617908</c:v>
                </c:pt>
                <c:pt idx="32">
                  <c:v>86.206896551724157</c:v>
                </c:pt>
                <c:pt idx="33">
                  <c:v>86.399999999999991</c:v>
                </c:pt>
                <c:pt idx="34">
                  <c:v>86.734693877551024</c:v>
                </c:pt>
                <c:pt idx="35">
                  <c:v>86.956521739130451</c:v>
                </c:pt>
                <c:pt idx="36">
                  <c:v>87.254901960784323</c:v>
                </c:pt>
                <c:pt idx="37">
                  <c:v>87.4015748031496</c:v>
                </c:pt>
                <c:pt idx="38">
                  <c:v>87.5</c:v>
                </c:pt>
                <c:pt idx="39">
                  <c:v>87.826086956521735</c:v>
                </c:pt>
                <c:pt idx="40">
                  <c:v>87.850467289719631</c:v>
                </c:pt>
                <c:pt idx="41">
                  <c:v>88.03418803418802</c:v>
                </c:pt>
                <c:pt idx="42">
                  <c:v>88.659793814432973</c:v>
                </c:pt>
                <c:pt idx="43">
                  <c:v>88.815789473684205</c:v>
                </c:pt>
                <c:pt idx="44">
                  <c:v>88.888888888888886</c:v>
                </c:pt>
                <c:pt idx="45">
                  <c:v>89.215686274509792</c:v>
                </c:pt>
                <c:pt idx="46">
                  <c:v>89.380530973451329</c:v>
                </c:pt>
                <c:pt idx="47">
                  <c:v>89.56521739130433</c:v>
                </c:pt>
                <c:pt idx="48">
                  <c:v>89.743589743589752</c:v>
                </c:pt>
                <c:pt idx="49">
                  <c:v>89.814814814814838</c:v>
                </c:pt>
                <c:pt idx="50">
                  <c:v>90.322580645161281</c:v>
                </c:pt>
                <c:pt idx="51">
                  <c:v>90.434782608695656</c:v>
                </c:pt>
                <c:pt idx="52">
                  <c:v>90.434782608695656</c:v>
                </c:pt>
                <c:pt idx="53">
                  <c:v>90.551181102362179</c:v>
                </c:pt>
                <c:pt idx="54">
                  <c:v>90.697674418604663</c:v>
                </c:pt>
                <c:pt idx="55">
                  <c:v>90.956072351421184</c:v>
                </c:pt>
                <c:pt idx="56">
                  <c:v>91.1111111111111</c:v>
                </c:pt>
                <c:pt idx="57">
                  <c:v>91.304347826086968</c:v>
                </c:pt>
                <c:pt idx="58">
                  <c:v>91.666666666666671</c:v>
                </c:pt>
                <c:pt idx="59">
                  <c:v>91.666666666666671</c:v>
                </c:pt>
                <c:pt idx="60">
                  <c:v>92.708333333333329</c:v>
                </c:pt>
                <c:pt idx="61">
                  <c:v>92.913385826771659</c:v>
                </c:pt>
                <c:pt idx="62">
                  <c:v>92.913385826771687</c:v>
                </c:pt>
                <c:pt idx="63">
                  <c:v>92.920353982300909</c:v>
                </c:pt>
                <c:pt idx="64">
                  <c:v>93.203883495145647</c:v>
                </c:pt>
                <c:pt idx="65">
                  <c:v>94.039735099337747</c:v>
                </c:pt>
                <c:pt idx="66">
                  <c:v>94.444444444444429</c:v>
                </c:pt>
                <c:pt idx="67">
                  <c:v>94.573643410852696</c:v>
                </c:pt>
                <c:pt idx="68">
                  <c:v>94.736842105263179</c:v>
                </c:pt>
                <c:pt idx="69">
                  <c:v>94.871794871794961</c:v>
                </c:pt>
                <c:pt idx="70">
                  <c:v>95.238095238095227</c:v>
                </c:pt>
                <c:pt idx="71">
                  <c:v>95.238095238095269</c:v>
                </c:pt>
                <c:pt idx="72">
                  <c:v>95.999999999999972</c:v>
                </c:pt>
                <c:pt idx="73">
                  <c:v>96.078431372548991</c:v>
                </c:pt>
                <c:pt idx="74">
                  <c:v>96.296296296296262</c:v>
                </c:pt>
                <c:pt idx="75">
                  <c:v>96.374622356495436</c:v>
                </c:pt>
                <c:pt idx="76">
                  <c:v>96.396396396396383</c:v>
                </c:pt>
                <c:pt idx="77">
                  <c:v>96.428571428571402</c:v>
                </c:pt>
                <c:pt idx="78">
                  <c:v>97.029702970297052</c:v>
                </c:pt>
                <c:pt idx="79">
                  <c:v>97.345132743362825</c:v>
                </c:pt>
                <c:pt idx="80">
                  <c:v>97.391304347826093</c:v>
                </c:pt>
                <c:pt idx="81">
                  <c:v>98.230088495575203</c:v>
                </c:pt>
                <c:pt idx="82">
                  <c:v>98.659517426273496</c:v>
                </c:pt>
                <c:pt idx="83">
                  <c:v>98.687664041994722</c:v>
                </c:pt>
                <c:pt idx="84">
                  <c:v>100</c:v>
                </c:pt>
                <c:pt idx="85">
                  <c:v>100</c:v>
                </c:pt>
                <c:pt idx="86">
                  <c:v>100.81967213114753</c:v>
                </c:pt>
                <c:pt idx="87">
                  <c:v>100.84033613445378</c:v>
                </c:pt>
                <c:pt idx="88">
                  <c:v>100.94339622641509</c:v>
                </c:pt>
                <c:pt idx="89">
                  <c:v>100.94339622641509</c:v>
                </c:pt>
                <c:pt idx="90">
                  <c:v>102.02898550724639</c:v>
                </c:pt>
                <c:pt idx="91">
                  <c:v>106.48148148148151</c:v>
                </c:pt>
                <c:pt idx="92">
                  <c:v>107.40740740740739</c:v>
                </c:pt>
                <c:pt idx="93">
                  <c:v>107.75000000000001</c:v>
                </c:pt>
                <c:pt idx="94">
                  <c:v>116.66666666666667</c:v>
                </c:pt>
                <c:pt idx="95">
                  <c:v>117.857142857142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50560"/>
        <c:axId val="87251136"/>
      </c:scatterChart>
      <c:valAx>
        <c:axId val="8725056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87251136"/>
        <c:crosses val="autoZero"/>
        <c:crossBetween val="midCat"/>
      </c:valAx>
      <c:valAx>
        <c:axId val="8725113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25056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869077516570008"/>
          <c:y val="0.5599930737824439"/>
          <c:w val="0.29642550975789383"/>
          <c:h val="0.1335239973959354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41976381709221"/>
          <c:y val="5.1400554097404488E-2"/>
          <c:w val="0.72200678682760744"/>
          <c:h val="0.8117694390518032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mic acid'!$D$1</c:f>
              <c:strCache>
                <c:ptCount val="1"/>
                <c:pt idx="0">
                  <c:v>Form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formic acid'!$B$2:$B$97</c:f>
              <c:strCache>
                <c:ptCount val="96"/>
                <c:pt idx="0">
                  <c:v>E5</c:v>
                </c:pt>
                <c:pt idx="1">
                  <c:v>D12</c:v>
                </c:pt>
                <c:pt idx="2">
                  <c:v>H3</c:v>
                </c:pt>
                <c:pt idx="3">
                  <c:v>D4</c:v>
                </c:pt>
                <c:pt idx="4">
                  <c:v>D8</c:v>
                </c:pt>
                <c:pt idx="5">
                  <c:v>G4</c:v>
                </c:pt>
                <c:pt idx="6">
                  <c:v>H2</c:v>
                </c:pt>
                <c:pt idx="7">
                  <c:v>C4</c:v>
                </c:pt>
                <c:pt idx="8">
                  <c:v>F4</c:v>
                </c:pt>
                <c:pt idx="9">
                  <c:v>C11</c:v>
                </c:pt>
                <c:pt idx="10">
                  <c:v>H10</c:v>
                </c:pt>
                <c:pt idx="11">
                  <c:v>E7</c:v>
                </c:pt>
                <c:pt idx="12">
                  <c:v>G2</c:v>
                </c:pt>
                <c:pt idx="13">
                  <c:v>A1</c:v>
                </c:pt>
                <c:pt idx="14">
                  <c:v>D1</c:v>
                </c:pt>
                <c:pt idx="15">
                  <c:v>H4</c:v>
                </c:pt>
                <c:pt idx="16">
                  <c:v>A8</c:v>
                </c:pt>
                <c:pt idx="17">
                  <c:v>E4</c:v>
                </c:pt>
                <c:pt idx="18">
                  <c:v>E12</c:v>
                </c:pt>
                <c:pt idx="19">
                  <c:v>A9</c:v>
                </c:pt>
                <c:pt idx="20">
                  <c:v>H5</c:v>
                </c:pt>
                <c:pt idx="21">
                  <c:v>B2</c:v>
                </c:pt>
                <c:pt idx="22">
                  <c:v>G10</c:v>
                </c:pt>
                <c:pt idx="23">
                  <c:v>G11</c:v>
                </c:pt>
                <c:pt idx="24">
                  <c:v>H7</c:v>
                </c:pt>
                <c:pt idx="25">
                  <c:v>F7</c:v>
                </c:pt>
                <c:pt idx="26">
                  <c:v>D11</c:v>
                </c:pt>
                <c:pt idx="27">
                  <c:v>H8</c:v>
                </c:pt>
                <c:pt idx="28">
                  <c:v>C10</c:v>
                </c:pt>
                <c:pt idx="29">
                  <c:v>F9</c:v>
                </c:pt>
                <c:pt idx="30">
                  <c:v>E3</c:v>
                </c:pt>
                <c:pt idx="31">
                  <c:v>B10</c:v>
                </c:pt>
                <c:pt idx="32">
                  <c:v>B11</c:v>
                </c:pt>
                <c:pt idx="33">
                  <c:v>D7</c:v>
                </c:pt>
                <c:pt idx="34">
                  <c:v>D5</c:v>
                </c:pt>
                <c:pt idx="35">
                  <c:v>G8</c:v>
                </c:pt>
                <c:pt idx="36">
                  <c:v>A5</c:v>
                </c:pt>
                <c:pt idx="37">
                  <c:v>A4</c:v>
                </c:pt>
                <c:pt idx="38">
                  <c:v>A2</c:v>
                </c:pt>
                <c:pt idx="39">
                  <c:v>C1</c:v>
                </c:pt>
                <c:pt idx="40">
                  <c:v>D10</c:v>
                </c:pt>
                <c:pt idx="41">
                  <c:v>C3</c:v>
                </c:pt>
                <c:pt idx="42">
                  <c:v>B4</c:v>
                </c:pt>
                <c:pt idx="43">
                  <c:v>B12</c:v>
                </c:pt>
                <c:pt idx="44">
                  <c:v>F2</c:v>
                </c:pt>
                <c:pt idx="45">
                  <c:v>H11</c:v>
                </c:pt>
                <c:pt idx="46">
                  <c:v>C8</c:v>
                </c:pt>
                <c:pt idx="47">
                  <c:v>H6</c:v>
                </c:pt>
                <c:pt idx="48">
                  <c:v>E6</c:v>
                </c:pt>
                <c:pt idx="49">
                  <c:v>G1</c:v>
                </c:pt>
                <c:pt idx="50">
                  <c:v>A7</c:v>
                </c:pt>
                <c:pt idx="51">
                  <c:v>B7</c:v>
                </c:pt>
                <c:pt idx="52">
                  <c:v>E8</c:v>
                </c:pt>
                <c:pt idx="53">
                  <c:v>E10</c:v>
                </c:pt>
                <c:pt idx="54">
                  <c:v>F8</c:v>
                </c:pt>
                <c:pt idx="55">
                  <c:v>F11</c:v>
                </c:pt>
                <c:pt idx="56">
                  <c:v>H12</c:v>
                </c:pt>
                <c:pt idx="57">
                  <c:v>C7</c:v>
                </c:pt>
                <c:pt idx="58">
                  <c:v>A6</c:v>
                </c:pt>
                <c:pt idx="59">
                  <c:v>E1</c:v>
                </c:pt>
                <c:pt idx="60">
                  <c:v>H9</c:v>
                </c:pt>
                <c:pt idx="61">
                  <c:v>C12</c:v>
                </c:pt>
                <c:pt idx="62">
                  <c:v>H1</c:v>
                </c:pt>
                <c:pt idx="63">
                  <c:v>B1</c:v>
                </c:pt>
                <c:pt idx="64">
                  <c:v>F12</c:v>
                </c:pt>
                <c:pt idx="65">
                  <c:v>F1</c:v>
                </c:pt>
                <c:pt idx="66">
                  <c:v>A12</c:v>
                </c:pt>
                <c:pt idx="67">
                  <c:v>C9</c:v>
                </c:pt>
                <c:pt idx="68">
                  <c:v>E11</c:v>
                </c:pt>
                <c:pt idx="69">
                  <c:v>C6</c:v>
                </c:pt>
                <c:pt idx="70">
                  <c:v>G5</c:v>
                </c:pt>
                <c:pt idx="71">
                  <c:v>F10</c:v>
                </c:pt>
                <c:pt idx="72">
                  <c:v>D9</c:v>
                </c:pt>
                <c:pt idx="73">
                  <c:v>B8</c:v>
                </c:pt>
                <c:pt idx="74">
                  <c:v>E9</c:v>
                </c:pt>
                <c:pt idx="75">
                  <c:v>G3</c:v>
                </c:pt>
                <c:pt idx="76">
                  <c:v>A10</c:v>
                </c:pt>
                <c:pt idx="77">
                  <c:v>G7</c:v>
                </c:pt>
                <c:pt idx="78">
                  <c:v>G6</c:v>
                </c:pt>
                <c:pt idx="79">
                  <c:v>A11</c:v>
                </c:pt>
                <c:pt idx="80">
                  <c:v>B6</c:v>
                </c:pt>
                <c:pt idx="81">
                  <c:v>F5</c:v>
                </c:pt>
                <c:pt idx="82">
                  <c:v>B5</c:v>
                </c:pt>
                <c:pt idx="83">
                  <c:v>D6</c:v>
                </c:pt>
                <c:pt idx="84">
                  <c:v>F3</c:v>
                </c:pt>
                <c:pt idx="85">
                  <c:v>B9</c:v>
                </c:pt>
                <c:pt idx="86">
                  <c:v>D2</c:v>
                </c:pt>
                <c:pt idx="87">
                  <c:v>A3</c:v>
                </c:pt>
                <c:pt idx="88">
                  <c:v>D3</c:v>
                </c:pt>
                <c:pt idx="89">
                  <c:v>G12</c:v>
                </c:pt>
                <c:pt idx="90">
                  <c:v>G9</c:v>
                </c:pt>
                <c:pt idx="91">
                  <c:v>B3</c:v>
                </c:pt>
                <c:pt idx="92">
                  <c:v>F6</c:v>
                </c:pt>
                <c:pt idx="93">
                  <c:v>C2</c:v>
                </c:pt>
                <c:pt idx="94">
                  <c:v>E2</c:v>
                </c:pt>
                <c:pt idx="95">
                  <c:v>C5</c:v>
                </c:pt>
              </c:strCache>
            </c:strRef>
          </c:xVal>
          <c:yVal>
            <c:numRef>
              <c:f>'formic acid'!$D$2:$D$97</c:f>
              <c:numCache>
                <c:formatCode>General</c:formatCode>
                <c:ptCount val="96"/>
                <c:pt idx="0">
                  <c:v>14.999999999999996</c:v>
                </c:pt>
                <c:pt idx="1">
                  <c:v>55.882352941176485</c:v>
                </c:pt>
                <c:pt idx="2">
                  <c:v>61.344537815126067</c:v>
                </c:pt>
                <c:pt idx="3">
                  <c:v>61.983471074380162</c:v>
                </c:pt>
                <c:pt idx="4">
                  <c:v>62.686567164179117</c:v>
                </c:pt>
                <c:pt idx="5">
                  <c:v>63.917525773195862</c:v>
                </c:pt>
                <c:pt idx="6">
                  <c:v>65.599999999999994</c:v>
                </c:pt>
                <c:pt idx="7">
                  <c:v>65.999999999999986</c:v>
                </c:pt>
                <c:pt idx="8">
                  <c:v>66.037735849056588</c:v>
                </c:pt>
                <c:pt idx="9">
                  <c:v>70.769230769230759</c:v>
                </c:pt>
                <c:pt idx="10">
                  <c:v>71.014492753623188</c:v>
                </c:pt>
                <c:pt idx="11">
                  <c:v>71.296296296296305</c:v>
                </c:pt>
                <c:pt idx="12">
                  <c:v>71.428571428571416</c:v>
                </c:pt>
                <c:pt idx="13">
                  <c:v>72.815533980582515</c:v>
                </c:pt>
                <c:pt idx="14">
                  <c:v>73.043478260869563</c:v>
                </c:pt>
                <c:pt idx="15">
                  <c:v>73.873873873873848</c:v>
                </c:pt>
                <c:pt idx="16">
                  <c:v>74.320241691842881</c:v>
                </c:pt>
                <c:pt idx="17">
                  <c:v>74.509803921568647</c:v>
                </c:pt>
                <c:pt idx="18">
                  <c:v>75.652173913043498</c:v>
                </c:pt>
                <c:pt idx="19">
                  <c:v>76.415094339622641</c:v>
                </c:pt>
                <c:pt idx="20">
                  <c:v>76.521739130434781</c:v>
                </c:pt>
                <c:pt idx="21">
                  <c:v>76.666666666666629</c:v>
                </c:pt>
                <c:pt idx="22">
                  <c:v>77.941176470588232</c:v>
                </c:pt>
                <c:pt idx="23">
                  <c:v>78.571428571428555</c:v>
                </c:pt>
                <c:pt idx="24">
                  <c:v>78.947368421052659</c:v>
                </c:pt>
                <c:pt idx="25">
                  <c:v>79.130434782608688</c:v>
                </c:pt>
                <c:pt idx="26">
                  <c:v>79.199999999999989</c:v>
                </c:pt>
                <c:pt idx="27">
                  <c:v>79.259259259259267</c:v>
                </c:pt>
                <c:pt idx="28">
                  <c:v>79.850746268656707</c:v>
                </c:pt>
                <c:pt idx="29">
                  <c:v>81.147540983606575</c:v>
                </c:pt>
                <c:pt idx="30">
                  <c:v>81.451612903225794</c:v>
                </c:pt>
                <c:pt idx="31">
                  <c:v>81.600000000000023</c:v>
                </c:pt>
                <c:pt idx="32">
                  <c:v>81.889763779527556</c:v>
                </c:pt>
                <c:pt idx="33">
                  <c:v>82.031250000000014</c:v>
                </c:pt>
                <c:pt idx="34">
                  <c:v>82.352941176470551</c:v>
                </c:pt>
                <c:pt idx="35">
                  <c:v>82.539682539682573</c:v>
                </c:pt>
                <c:pt idx="36">
                  <c:v>82.59740259740262</c:v>
                </c:pt>
                <c:pt idx="37">
                  <c:v>83.076923076923094</c:v>
                </c:pt>
                <c:pt idx="38">
                  <c:v>83.478260869565219</c:v>
                </c:pt>
                <c:pt idx="39">
                  <c:v>83.673469387755091</c:v>
                </c:pt>
                <c:pt idx="40">
                  <c:v>83.739837398373979</c:v>
                </c:pt>
                <c:pt idx="41">
                  <c:v>83.809523809523839</c:v>
                </c:pt>
                <c:pt idx="42">
                  <c:v>84.374999999999972</c:v>
                </c:pt>
                <c:pt idx="43">
                  <c:v>84.496124031007724</c:v>
                </c:pt>
                <c:pt idx="44">
                  <c:v>85.470085470085479</c:v>
                </c:pt>
                <c:pt idx="45">
                  <c:v>85.507246376811594</c:v>
                </c:pt>
                <c:pt idx="46">
                  <c:v>86.000000000000028</c:v>
                </c:pt>
                <c:pt idx="47">
                  <c:v>86.18421052631578</c:v>
                </c:pt>
                <c:pt idx="48">
                  <c:v>86.821705426356587</c:v>
                </c:pt>
                <c:pt idx="49">
                  <c:v>87.610619469026545</c:v>
                </c:pt>
                <c:pt idx="50">
                  <c:v>87.667560321715825</c:v>
                </c:pt>
                <c:pt idx="51">
                  <c:v>87.826086956521735</c:v>
                </c:pt>
                <c:pt idx="52">
                  <c:v>87.962962962962976</c:v>
                </c:pt>
                <c:pt idx="53">
                  <c:v>87.962962962962976</c:v>
                </c:pt>
                <c:pt idx="54">
                  <c:v>88.181818181818173</c:v>
                </c:pt>
                <c:pt idx="55">
                  <c:v>88.333333333333357</c:v>
                </c:pt>
                <c:pt idx="56">
                  <c:v>88.741721854304657</c:v>
                </c:pt>
                <c:pt idx="57">
                  <c:v>88.793103448275858</c:v>
                </c:pt>
                <c:pt idx="58">
                  <c:v>90.697674418604663</c:v>
                </c:pt>
                <c:pt idx="59">
                  <c:v>90.721649484536087</c:v>
                </c:pt>
                <c:pt idx="60">
                  <c:v>91.150442477876112</c:v>
                </c:pt>
                <c:pt idx="61">
                  <c:v>91.338582677165363</c:v>
                </c:pt>
                <c:pt idx="62">
                  <c:v>92.12598425196849</c:v>
                </c:pt>
                <c:pt idx="63">
                  <c:v>92.173913043478279</c:v>
                </c:pt>
                <c:pt idx="64">
                  <c:v>92.248062015503876</c:v>
                </c:pt>
                <c:pt idx="65">
                  <c:v>93.693693693693703</c:v>
                </c:pt>
                <c:pt idx="66">
                  <c:v>94.540942928039698</c:v>
                </c:pt>
                <c:pt idx="67">
                  <c:v>94.642857142857139</c:v>
                </c:pt>
                <c:pt idx="68">
                  <c:v>94.782608695652172</c:v>
                </c:pt>
                <c:pt idx="69">
                  <c:v>94.782608695652186</c:v>
                </c:pt>
                <c:pt idx="70">
                  <c:v>94.7916666666667</c:v>
                </c:pt>
                <c:pt idx="71">
                  <c:v>95.901639344262307</c:v>
                </c:pt>
                <c:pt idx="72">
                  <c:v>96.078431372548991</c:v>
                </c:pt>
                <c:pt idx="73">
                  <c:v>96.261682242990645</c:v>
                </c:pt>
                <c:pt idx="74">
                  <c:v>96.296296296296291</c:v>
                </c:pt>
                <c:pt idx="75">
                  <c:v>96.521739130434781</c:v>
                </c:pt>
                <c:pt idx="76">
                  <c:v>96.850393700787407</c:v>
                </c:pt>
                <c:pt idx="77">
                  <c:v>97.345132743362853</c:v>
                </c:pt>
                <c:pt idx="78">
                  <c:v>97.435897435897459</c:v>
                </c:pt>
                <c:pt idx="79">
                  <c:v>97.500000000000014</c:v>
                </c:pt>
                <c:pt idx="80">
                  <c:v>99.107142857142875</c:v>
                </c:pt>
                <c:pt idx="81">
                  <c:v>100</c:v>
                </c:pt>
                <c:pt idx="82">
                  <c:v>100</c:v>
                </c:pt>
                <c:pt idx="83">
                  <c:v>100.88495575221236</c:v>
                </c:pt>
                <c:pt idx="84">
                  <c:v>101.66666666666669</c:v>
                </c:pt>
                <c:pt idx="85">
                  <c:v>101.88679245283021</c:v>
                </c:pt>
                <c:pt idx="86">
                  <c:v>103.8095238095238</c:v>
                </c:pt>
                <c:pt idx="87">
                  <c:v>103.93700787401573</c:v>
                </c:pt>
                <c:pt idx="88">
                  <c:v>104.72440944881889</c:v>
                </c:pt>
                <c:pt idx="89">
                  <c:v>109.02777777777777</c:v>
                </c:pt>
                <c:pt idx="90">
                  <c:v>109.24369747899156</c:v>
                </c:pt>
                <c:pt idx="91">
                  <c:v>109.6296296296296</c:v>
                </c:pt>
                <c:pt idx="92">
                  <c:v>110.78431372549022</c:v>
                </c:pt>
                <c:pt idx="93">
                  <c:v>113.6</c:v>
                </c:pt>
                <c:pt idx="94">
                  <c:v>119.80198019801979</c:v>
                </c:pt>
                <c:pt idx="95">
                  <c:v>121.4285714285714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78720"/>
        <c:axId val="87279296"/>
      </c:scatterChart>
      <c:valAx>
        <c:axId val="8727872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87279296"/>
        <c:crosses val="autoZero"/>
        <c:crossBetween val="midCat"/>
      </c:valAx>
      <c:valAx>
        <c:axId val="8727929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27872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8653613650770842"/>
          <c:y val="0.5599930737824439"/>
          <c:w val="0.39679741466634427"/>
          <c:h val="0.1161582328599162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03405725047343"/>
          <c:y val="5.1400554097404488E-2"/>
          <c:w val="0.70107981476341241"/>
          <c:h val="0.8121340338243262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mic acid (2)'!$E$1</c:f>
              <c:strCache>
                <c:ptCount val="1"/>
                <c:pt idx="0">
                  <c:v>Furfura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formic acid (2)'!$B$2:$B$97</c:f>
              <c:strCache>
                <c:ptCount val="96"/>
                <c:pt idx="0">
                  <c:v>C4</c:v>
                </c:pt>
                <c:pt idx="1">
                  <c:v>F9</c:v>
                </c:pt>
                <c:pt idx="2">
                  <c:v>D11</c:v>
                </c:pt>
                <c:pt idx="3">
                  <c:v>H11</c:v>
                </c:pt>
                <c:pt idx="4">
                  <c:v>C2</c:v>
                </c:pt>
                <c:pt idx="5">
                  <c:v>E2</c:v>
                </c:pt>
                <c:pt idx="6">
                  <c:v>H2</c:v>
                </c:pt>
                <c:pt idx="7">
                  <c:v>G6</c:v>
                </c:pt>
                <c:pt idx="8">
                  <c:v>D12</c:v>
                </c:pt>
                <c:pt idx="9">
                  <c:v>D1</c:v>
                </c:pt>
                <c:pt idx="10">
                  <c:v>D4</c:v>
                </c:pt>
                <c:pt idx="11">
                  <c:v>C11</c:v>
                </c:pt>
                <c:pt idx="12">
                  <c:v>E1</c:v>
                </c:pt>
                <c:pt idx="13">
                  <c:v>G2</c:v>
                </c:pt>
                <c:pt idx="14">
                  <c:v>B2</c:v>
                </c:pt>
                <c:pt idx="15">
                  <c:v>A11</c:v>
                </c:pt>
                <c:pt idx="16">
                  <c:v>F4</c:v>
                </c:pt>
                <c:pt idx="17">
                  <c:v>A12</c:v>
                </c:pt>
                <c:pt idx="18">
                  <c:v>C6</c:v>
                </c:pt>
                <c:pt idx="19">
                  <c:v>D7</c:v>
                </c:pt>
                <c:pt idx="20">
                  <c:v>F2</c:v>
                </c:pt>
                <c:pt idx="21">
                  <c:v>H3</c:v>
                </c:pt>
                <c:pt idx="22">
                  <c:v>D3</c:v>
                </c:pt>
                <c:pt idx="23">
                  <c:v>D9</c:v>
                </c:pt>
                <c:pt idx="24">
                  <c:v>F10</c:v>
                </c:pt>
                <c:pt idx="25">
                  <c:v>F3</c:v>
                </c:pt>
                <c:pt idx="26">
                  <c:v>D2</c:v>
                </c:pt>
                <c:pt idx="27">
                  <c:v>H9</c:v>
                </c:pt>
                <c:pt idx="28">
                  <c:v>C9</c:v>
                </c:pt>
                <c:pt idx="29">
                  <c:v>B6</c:v>
                </c:pt>
                <c:pt idx="30">
                  <c:v>G11</c:v>
                </c:pt>
                <c:pt idx="31">
                  <c:v>H1</c:v>
                </c:pt>
                <c:pt idx="32">
                  <c:v>E9</c:v>
                </c:pt>
                <c:pt idx="33">
                  <c:v>F11</c:v>
                </c:pt>
                <c:pt idx="34">
                  <c:v>G3</c:v>
                </c:pt>
                <c:pt idx="35">
                  <c:v>H6</c:v>
                </c:pt>
                <c:pt idx="36">
                  <c:v>E7</c:v>
                </c:pt>
                <c:pt idx="37">
                  <c:v>C12</c:v>
                </c:pt>
                <c:pt idx="38">
                  <c:v>C8</c:v>
                </c:pt>
                <c:pt idx="39">
                  <c:v>H4</c:v>
                </c:pt>
                <c:pt idx="40">
                  <c:v>E12</c:v>
                </c:pt>
                <c:pt idx="41">
                  <c:v>E4</c:v>
                </c:pt>
                <c:pt idx="42">
                  <c:v>H8</c:v>
                </c:pt>
                <c:pt idx="43">
                  <c:v>B12</c:v>
                </c:pt>
                <c:pt idx="44">
                  <c:v>E6</c:v>
                </c:pt>
                <c:pt idx="45">
                  <c:v>D10</c:v>
                </c:pt>
                <c:pt idx="46">
                  <c:v>G4</c:v>
                </c:pt>
                <c:pt idx="47">
                  <c:v>B5</c:v>
                </c:pt>
                <c:pt idx="48">
                  <c:v>C7</c:v>
                </c:pt>
                <c:pt idx="49">
                  <c:v>E10</c:v>
                </c:pt>
                <c:pt idx="50">
                  <c:v>C10</c:v>
                </c:pt>
                <c:pt idx="51">
                  <c:v>G9</c:v>
                </c:pt>
                <c:pt idx="52">
                  <c:v>F1</c:v>
                </c:pt>
                <c:pt idx="53">
                  <c:v>B11</c:v>
                </c:pt>
                <c:pt idx="54">
                  <c:v>H10</c:v>
                </c:pt>
                <c:pt idx="55">
                  <c:v>B8</c:v>
                </c:pt>
                <c:pt idx="56">
                  <c:v>E8</c:v>
                </c:pt>
                <c:pt idx="57">
                  <c:v>D6</c:v>
                </c:pt>
                <c:pt idx="58">
                  <c:v>B4</c:v>
                </c:pt>
                <c:pt idx="59">
                  <c:v>C3</c:v>
                </c:pt>
                <c:pt idx="60">
                  <c:v>E11</c:v>
                </c:pt>
                <c:pt idx="61">
                  <c:v>A4</c:v>
                </c:pt>
                <c:pt idx="62">
                  <c:v>A10</c:v>
                </c:pt>
                <c:pt idx="63">
                  <c:v>E3</c:v>
                </c:pt>
                <c:pt idx="64">
                  <c:v>D8</c:v>
                </c:pt>
                <c:pt idx="65">
                  <c:v>A7</c:v>
                </c:pt>
                <c:pt idx="66">
                  <c:v>B9</c:v>
                </c:pt>
                <c:pt idx="67">
                  <c:v>F7</c:v>
                </c:pt>
                <c:pt idx="68">
                  <c:v>B1</c:v>
                </c:pt>
                <c:pt idx="69">
                  <c:v>F8</c:v>
                </c:pt>
                <c:pt idx="70">
                  <c:v>B3</c:v>
                </c:pt>
                <c:pt idx="71">
                  <c:v>H12</c:v>
                </c:pt>
                <c:pt idx="72">
                  <c:v>G1</c:v>
                </c:pt>
                <c:pt idx="73">
                  <c:v>F12</c:v>
                </c:pt>
                <c:pt idx="74">
                  <c:v>G12</c:v>
                </c:pt>
                <c:pt idx="75">
                  <c:v>G10</c:v>
                </c:pt>
                <c:pt idx="76">
                  <c:v>C1</c:v>
                </c:pt>
                <c:pt idx="77">
                  <c:v>A6</c:v>
                </c:pt>
                <c:pt idx="78">
                  <c:v>F6</c:v>
                </c:pt>
                <c:pt idx="79">
                  <c:v>C5</c:v>
                </c:pt>
                <c:pt idx="80">
                  <c:v>H7</c:v>
                </c:pt>
                <c:pt idx="81">
                  <c:v>B10</c:v>
                </c:pt>
                <c:pt idx="82">
                  <c:v>H5</c:v>
                </c:pt>
                <c:pt idx="83">
                  <c:v>A8</c:v>
                </c:pt>
                <c:pt idx="84">
                  <c:v>F5</c:v>
                </c:pt>
                <c:pt idx="85">
                  <c:v>G7</c:v>
                </c:pt>
                <c:pt idx="86">
                  <c:v>A5</c:v>
                </c:pt>
                <c:pt idx="87">
                  <c:v>A1</c:v>
                </c:pt>
                <c:pt idx="88">
                  <c:v>A9</c:v>
                </c:pt>
                <c:pt idx="89">
                  <c:v>A2</c:v>
                </c:pt>
                <c:pt idx="90">
                  <c:v>E5</c:v>
                </c:pt>
                <c:pt idx="91">
                  <c:v>G5</c:v>
                </c:pt>
                <c:pt idx="92">
                  <c:v>A3</c:v>
                </c:pt>
                <c:pt idx="93">
                  <c:v>B7</c:v>
                </c:pt>
                <c:pt idx="94">
                  <c:v>D5</c:v>
                </c:pt>
                <c:pt idx="95">
                  <c:v>G8</c:v>
                </c:pt>
              </c:strCache>
            </c:strRef>
          </c:xVal>
          <c:yVal>
            <c:numRef>
              <c:f>'formic acid (2)'!$E$2:$E$97</c:f>
              <c:numCache>
                <c:formatCode>General</c:formatCode>
                <c:ptCount val="96"/>
                <c:pt idx="0">
                  <c:v>41.414141414141412</c:v>
                </c:pt>
                <c:pt idx="1">
                  <c:v>57.692307692307686</c:v>
                </c:pt>
                <c:pt idx="2">
                  <c:v>58.06451612903227</c:v>
                </c:pt>
                <c:pt idx="3">
                  <c:v>63.636363636363626</c:v>
                </c:pt>
                <c:pt idx="4">
                  <c:v>65.555555555555571</c:v>
                </c:pt>
                <c:pt idx="5">
                  <c:v>65.671641791044792</c:v>
                </c:pt>
                <c:pt idx="6">
                  <c:v>66.666666666666657</c:v>
                </c:pt>
                <c:pt idx="7">
                  <c:v>66.666666666666671</c:v>
                </c:pt>
                <c:pt idx="8">
                  <c:v>67.961165048543691</c:v>
                </c:pt>
                <c:pt idx="9">
                  <c:v>68.181818181818187</c:v>
                </c:pt>
                <c:pt idx="10">
                  <c:v>69.230769230769226</c:v>
                </c:pt>
                <c:pt idx="11">
                  <c:v>69.318181818181827</c:v>
                </c:pt>
                <c:pt idx="12">
                  <c:v>69.369369369369366</c:v>
                </c:pt>
                <c:pt idx="13">
                  <c:v>72.857142857142819</c:v>
                </c:pt>
                <c:pt idx="14">
                  <c:v>72.881355932203405</c:v>
                </c:pt>
                <c:pt idx="15">
                  <c:v>74.390243902439067</c:v>
                </c:pt>
                <c:pt idx="16">
                  <c:v>74.528301886792462</c:v>
                </c:pt>
                <c:pt idx="17">
                  <c:v>74.916387959866199</c:v>
                </c:pt>
                <c:pt idx="18">
                  <c:v>75.221238938053105</c:v>
                </c:pt>
                <c:pt idx="19">
                  <c:v>76.033057851239661</c:v>
                </c:pt>
                <c:pt idx="20">
                  <c:v>76.31578947368422</c:v>
                </c:pt>
                <c:pt idx="21">
                  <c:v>76.923076923076934</c:v>
                </c:pt>
                <c:pt idx="22">
                  <c:v>77.165354330708652</c:v>
                </c:pt>
                <c:pt idx="23">
                  <c:v>77.173913043478265</c:v>
                </c:pt>
                <c:pt idx="24">
                  <c:v>77.358490566037744</c:v>
                </c:pt>
                <c:pt idx="25">
                  <c:v>77.777777777777757</c:v>
                </c:pt>
                <c:pt idx="26">
                  <c:v>78.000000000000014</c:v>
                </c:pt>
                <c:pt idx="27">
                  <c:v>78.217821782178206</c:v>
                </c:pt>
                <c:pt idx="28">
                  <c:v>78.350515463917532</c:v>
                </c:pt>
                <c:pt idx="29">
                  <c:v>78.640776699029146</c:v>
                </c:pt>
                <c:pt idx="30">
                  <c:v>78.84615384615384</c:v>
                </c:pt>
                <c:pt idx="31">
                  <c:v>79.464285714285694</c:v>
                </c:pt>
                <c:pt idx="32">
                  <c:v>79.591836734693914</c:v>
                </c:pt>
                <c:pt idx="33">
                  <c:v>79.629629629629662</c:v>
                </c:pt>
                <c:pt idx="34">
                  <c:v>79.674796747967477</c:v>
                </c:pt>
                <c:pt idx="35">
                  <c:v>80.172413793103459</c:v>
                </c:pt>
                <c:pt idx="36">
                  <c:v>80.198019801980195</c:v>
                </c:pt>
                <c:pt idx="37">
                  <c:v>80.246913580246925</c:v>
                </c:pt>
                <c:pt idx="38">
                  <c:v>80.898876404494388</c:v>
                </c:pt>
                <c:pt idx="39">
                  <c:v>80.952380952380963</c:v>
                </c:pt>
                <c:pt idx="40">
                  <c:v>81.081081081081123</c:v>
                </c:pt>
                <c:pt idx="41">
                  <c:v>81.481481481481453</c:v>
                </c:pt>
                <c:pt idx="42">
                  <c:v>81.730769230769212</c:v>
                </c:pt>
                <c:pt idx="43">
                  <c:v>81.818181818181841</c:v>
                </c:pt>
                <c:pt idx="44">
                  <c:v>81.999999999999986</c:v>
                </c:pt>
                <c:pt idx="45">
                  <c:v>82.278481012658233</c:v>
                </c:pt>
                <c:pt idx="46">
                  <c:v>82.291666666666671</c:v>
                </c:pt>
                <c:pt idx="47">
                  <c:v>82.352941176470566</c:v>
                </c:pt>
                <c:pt idx="48">
                  <c:v>82.407407407407447</c:v>
                </c:pt>
                <c:pt idx="49">
                  <c:v>82.417582417582395</c:v>
                </c:pt>
                <c:pt idx="50">
                  <c:v>82.558139534883722</c:v>
                </c:pt>
                <c:pt idx="51">
                  <c:v>82.727272727272734</c:v>
                </c:pt>
                <c:pt idx="52">
                  <c:v>82.882882882882853</c:v>
                </c:pt>
                <c:pt idx="53">
                  <c:v>82.926829268292693</c:v>
                </c:pt>
                <c:pt idx="54">
                  <c:v>82.954545454545453</c:v>
                </c:pt>
                <c:pt idx="55">
                  <c:v>82.999999999999986</c:v>
                </c:pt>
                <c:pt idx="56">
                  <c:v>83.157894736842096</c:v>
                </c:pt>
                <c:pt idx="57">
                  <c:v>83.486238532110093</c:v>
                </c:pt>
                <c:pt idx="58">
                  <c:v>83.653846153846175</c:v>
                </c:pt>
                <c:pt idx="59">
                  <c:v>83.809523809523782</c:v>
                </c:pt>
                <c:pt idx="60">
                  <c:v>83.950617283950635</c:v>
                </c:pt>
                <c:pt idx="61">
                  <c:v>85.000000000000014</c:v>
                </c:pt>
                <c:pt idx="62">
                  <c:v>85.020242914979789</c:v>
                </c:pt>
                <c:pt idx="63">
                  <c:v>85.046728971962608</c:v>
                </c:pt>
                <c:pt idx="64">
                  <c:v>85.106382978723417</c:v>
                </c:pt>
                <c:pt idx="65">
                  <c:v>85.626911314984753</c:v>
                </c:pt>
                <c:pt idx="66">
                  <c:v>86.021505376344052</c:v>
                </c:pt>
                <c:pt idx="67">
                  <c:v>86.111111111111143</c:v>
                </c:pt>
                <c:pt idx="68">
                  <c:v>86.324786324786317</c:v>
                </c:pt>
                <c:pt idx="69">
                  <c:v>87.128712871287135</c:v>
                </c:pt>
                <c:pt idx="70">
                  <c:v>87.407407407407405</c:v>
                </c:pt>
                <c:pt idx="71">
                  <c:v>87.735849056603769</c:v>
                </c:pt>
                <c:pt idx="72">
                  <c:v>88.34951456310678</c:v>
                </c:pt>
                <c:pt idx="73">
                  <c:v>88.372093023255843</c:v>
                </c:pt>
                <c:pt idx="74">
                  <c:v>88.59649122807015</c:v>
                </c:pt>
                <c:pt idx="75">
                  <c:v>88.636363636363654</c:v>
                </c:pt>
                <c:pt idx="76">
                  <c:v>89.814814814814838</c:v>
                </c:pt>
                <c:pt idx="77">
                  <c:v>90.3133903133903</c:v>
                </c:pt>
                <c:pt idx="78">
                  <c:v>90.624999999999957</c:v>
                </c:pt>
                <c:pt idx="79">
                  <c:v>90.6666666666667</c:v>
                </c:pt>
                <c:pt idx="80">
                  <c:v>90.697674418604635</c:v>
                </c:pt>
                <c:pt idx="81">
                  <c:v>91.208791208791212</c:v>
                </c:pt>
                <c:pt idx="82">
                  <c:v>92.105263157894726</c:v>
                </c:pt>
                <c:pt idx="83">
                  <c:v>92.559523809523796</c:v>
                </c:pt>
                <c:pt idx="84">
                  <c:v>93</c:v>
                </c:pt>
                <c:pt idx="85">
                  <c:v>94.495412844036721</c:v>
                </c:pt>
                <c:pt idx="86">
                  <c:v>94.623655913978524</c:v>
                </c:pt>
                <c:pt idx="87">
                  <c:v>95.115681233933131</c:v>
                </c:pt>
                <c:pt idx="88">
                  <c:v>96.124031007752023</c:v>
                </c:pt>
                <c:pt idx="89">
                  <c:v>97.093023255814018</c:v>
                </c:pt>
                <c:pt idx="90">
                  <c:v>97.590361445783174</c:v>
                </c:pt>
                <c:pt idx="91">
                  <c:v>98.999999999999986</c:v>
                </c:pt>
                <c:pt idx="92">
                  <c:v>99.470899470899482</c:v>
                </c:pt>
                <c:pt idx="93">
                  <c:v>100</c:v>
                </c:pt>
                <c:pt idx="94">
                  <c:v>101.03092783505157</c:v>
                </c:pt>
                <c:pt idx="95">
                  <c:v>101.0638297872340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81600"/>
        <c:axId val="87282176"/>
      </c:scatterChart>
      <c:valAx>
        <c:axId val="8728160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>
            <c:manualLayout>
              <c:xMode val="edge"/>
              <c:yMode val="edge"/>
              <c:x val="0.34664003949277783"/>
              <c:y val="0.91197959453756872"/>
            </c:manualLayout>
          </c:layout>
          <c:overlay val="0"/>
        </c:title>
        <c:majorTickMark val="out"/>
        <c:minorTickMark val="none"/>
        <c:tickLblPos val="nextTo"/>
        <c:crossAx val="87282176"/>
        <c:crosses val="autoZero"/>
        <c:crossBetween val="midCat"/>
      </c:valAx>
      <c:valAx>
        <c:axId val="87282176"/>
        <c:scaling>
          <c:orientation val="minMax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28160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3588739287935372"/>
          <c:y val="0.5599930737824439"/>
          <c:w val="0.44744588189410739"/>
          <c:h val="0.1709247754575123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978706069695961"/>
          <c:y val="5.1400554097404488E-2"/>
          <c:w val="0.68356023713414549"/>
          <c:h val="0.78676335958666033"/>
        </c:manualLayout>
      </c:layout>
      <c:scatterChart>
        <c:scatterStyle val="lineMarker"/>
        <c:varyColors val="0"/>
        <c:ser>
          <c:idx val="1"/>
          <c:order val="0"/>
          <c:tx>
            <c:strRef>
              <c:f>'formic acid'!$D$1</c:f>
              <c:strCache>
                <c:ptCount val="1"/>
                <c:pt idx="0">
                  <c:v>Form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formic acid'!$B$2:$B$97</c:f>
              <c:strCache>
                <c:ptCount val="96"/>
                <c:pt idx="0">
                  <c:v>F12</c:v>
                </c:pt>
                <c:pt idx="1">
                  <c:v>D3</c:v>
                </c:pt>
                <c:pt idx="2">
                  <c:v>D12</c:v>
                </c:pt>
                <c:pt idx="3">
                  <c:v>F1</c:v>
                </c:pt>
                <c:pt idx="4">
                  <c:v>H3</c:v>
                </c:pt>
                <c:pt idx="5">
                  <c:v>H2</c:v>
                </c:pt>
                <c:pt idx="6">
                  <c:v>C4</c:v>
                </c:pt>
                <c:pt idx="7">
                  <c:v>D2</c:v>
                </c:pt>
                <c:pt idx="8">
                  <c:v>E12</c:v>
                </c:pt>
                <c:pt idx="9">
                  <c:v>C3</c:v>
                </c:pt>
                <c:pt idx="10">
                  <c:v>D4</c:v>
                </c:pt>
                <c:pt idx="11">
                  <c:v>D7</c:v>
                </c:pt>
                <c:pt idx="12">
                  <c:v>F2</c:v>
                </c:pt>
                <c:pt idx="13">
                  <c:v>A2</c:v>
                </c:pt>
                <c:pt idx="14">
                  <c:v>G2</c:v>
                </c:pt>
                <c:pt idx="15">
                  <c:v>E4</c:v>
                </c:pt>
                <c:pt idx="16">
                  <c:v>B12</c:v>
                </c:pt>
                <c:pt idx="17">
                  <c:v>H1</c:v>
                </c:pt>
                <c:pt idx="18">
                  <c:v>D11</c:v>
                </c:pt>
                <c:pt idx="19">
                  <c:v>H8</c:v>
                </c:pt>
                <c:pt idx="20">
                  <c:v>A12</c:v>
                </c:pt>
                <c:pt idx="21">
                  <c:v>D1</c:v>
                </c:pt>
                <c:pt idx="22">
                  <c:v>C1</c:v>
                </c:pt>
                <c:pt idx="23">
                  <c:v>H10</c:v>
                </c:pt>
                <c:pt idx="24">
                  <c:v>D6</c:v>
                </c:pt>
                <c:pt idx="25">
                  <c:v>H4</c:v>
                </c:pt>
                <c:pt idx="26">
                  <c:v>E3</c:v>
                </c:pt>
                <c:pt idx="27">
                  <c:v>E8</c:v>
                </c:pt>
                <c:pt idx="28">
                  <c:v>F3</c:v>
                </c:pt>
                <c:pt idx="29">
                  <c:v>F8</c:v>
                </c:pt>
                <c:pt idx="30">
                  <c:v>E10</c:v>
                </c:pt>
                <c:pt idx="31">
                  <c:v>H12</c:v>
                </c:pt>
                <c:pt idx="32">
                  <c:v>A6</c:v>
                </c:pt>
                <c:pt idx="33">
                  <c:v>H9</c:v>
                </c:pt>
                <c:pt idx="34">
                  <c:v>C2</c:v>
                </c:pt>
                <c:pt idx="35">
                  <c:v>D9</c:v>
                </c:pt>
                <c:pt idx="36">
                  <c:v>A10</c:v>
                </c:pt>
                <c:pt idx="37">
                  <c:v>A8</c:v>
                </c:pt>
                <c:pt idx="38">
                  <c:v>D10</c:v>
                </c:pt>
                <c:pt idx="39">
                  <c:v>D8</c:v>
                </c:pt>
                <c:pt idx="40">
                  <c:v>A5</c:v>
                </c:pt>
                <c:pt idx="41">
                  <c:v>H11</c:v>
                </c:pt>
                <c:pt idx="42">
                  <c:v>H7</c:v>
                </c:pt>
                <c:pt idx="43">
                  <c:v>E6</c:v>
                </c:pt>
                <c:pt idx="44">
                  <c:v>B2</c:v>
                </c:pt>
                <c:pt idx="45">
                  <c:v>B10</c:v>
                </c:pt>
                <c:pt idx="46">
                  <c:v>A9</c:v>
                </c:pt>
                <c:pt idx="47">
                  <c:v>E2</c:v>
                </c:pt>
                <c:pt idx="48">
                  <c:v>A1</c:v>
                </c:pt>
                <c:pt idx="49">
                  <c:v>H5</c:v>
                </c:pt>
                <c:pt idx="50">
                  <c:v>A11</c:v>
                </c:pt>
                <c:pt idx="51">
                  <c:v>A4</c:v>
                </c:pt>
                <c:pt idx="52">
                  <c:v>G10</c:v>
                </c:pt>
                <c:pt idx="53">
                  <c:v>C8</c:v>
                </c:pt>
                <c:pt idx="54">
                  <c:v>E7</c:v>
                </c:pt>
                <c:pt idx="55">
                  <c:v>E9</c:v>
                </c:pt>
                <c:pt idx="56">
                  <c:v>B1</c:v>
                </c:pt>
                <c:pt idx="57">
                  <c:v>F10</c:v>
                </c:pt>
                <c:pt idx="58">
                  <c:v>F7</c:v>
                </c:pt>
                <c:pt idx="59">
                  <c:v>B4</c:v>
                </c:pt>
                <c:pt idx="60">
                  <c:v>E1</c:v>
                </c:pt>
                <c:pt idx="61">
                  <c:v>F9</c:v>
                </c:pt>
                <c:pt idx="62">
                  <c:v>H6</c:v>
                </c:pt>
                <c:pt idx="63">
                  <c:v>C6</c:v>
                </c:pt>
                <c:pt idx="64">
                  <c:v>B5</c:v>
                </c:pt>
                <c:pt idx="65">
                  <c:v>B7</c:v>
                </c:pt>
                <c:pt idx="66">
                  <c:v>C7</c:v>
                </c:pt>
                <c:pt idx="67">
                  <c:v>G9</c:v>
                </c:pt>
                <c:pt idx="68">
                  <c:v>C10</c:v>
                </c:pt>
                <c:pt idx="69">
                  <c:v>A7</c:v>
                </c:pt>
                <c:pt idx="70">
                  <c:v>E11</c:v>
                </c:pt>
                <c:pt idx="71">
                  <c:v>G7</c:v>
                </c:pt>
                <c:pt idx="72">
                  <c:v>B8</c:v>
                </c:pt>
                <c:pt idx="73">
                  <c:v>B6</c:v>
                </c:pt>
                <c:pt idx="74">
                  <c:v>C5</c:v>
                </c:pt>
                <c:pt idx="75">
                  <c:v>F11</c:v>
                </c:pt>
                <c:pt idx="76">
                  <c:v>G1</c:v>
                </c:pt>
                <c:pt idx="77">
                  <c:v>G4</c:v>
                </c:pt>
                <c:pt idx="78">
                  <c:v>B9</c:v>
                </c:pt>
                <c:pt idx="79">
                  <c:v>C11</c:v>
                </c:pt>
                <c:pt idx="80">
                  <c:v>G6</c:v>
                </c:pt>
                <c:pt idx="81">
                  <c:v>G8</c:v>
                </c:pt>
                <c:pt idx="82">
                  <c:v>A3</c:v>
                </c:pt>
                <c:pt idx="83">
                  <c:v>D5</c:v>
                </c:pt>
                <c:pt idx="84">
                  <c:v>C9</c:v>
                </c:pt>
                <c:pt idx="85">
                  <c:v>G5</c:v>
                </c:pt>
                <c:pt idx="86">
                  <c:v>F5</c:v>
                </c:pt>
                <c:pt idx="87">
                  <c:v>F4</c:v>
                </c:pt>
                <c:pt idx="88">
                  <c:v>F6</c:v>
                </c:pt>
                <c:pt idx="89">
                  <c:v>B11</c:v>
                </c:pt>
                <c:pt idx="90">
                  <c:v>E5</c:v>
                </c:pt>
                <c:pt idx="91">
                  <c:v>G11</c:v>
                </c:pt>
                <c:pt idx="92">
                  <c:v>B3</c:v>
                </c:pt>
                <c:pt idx="93">
                  <c:v>C12</c:v>
                </c:pt>
                <c:pt idx="94">
                  <c:v>G12</c:v>
                </c:pt>
                <c:pt idx="95">
                  <c:v>G3</c:v>
                </c:pt>
              </c:strCache>
            </c:strRef>
          </c:xVal>
          <c:yVal>
            <c:numRef>
              <c:f>'formic acid'!$D$2:$D$97</c:f>
              <c:numCache>
                <c:formatCode>General</c:formatCode>
                <c:ptCount val="96"/>
                <c:pt idx="0">
                  <c:v>43.902439024390283</c:v>
                </c:pt>
                <c:pt idx="1">
                  <c:v>65.624999999999972</c:v>
                </c:pt>
                <c:pt idx="2">
                  <c:v>74.242424242424249</c:v>
                </c:pt>
                <c:pt idx="3">
                  <c:v>77.669902912621353</c:v>
                </c:pt>
                <c:pt idx="4">
                  <c:v>80.303030303030283</c:v>
                </c:pt>
                <c:pt idx="5">
                  <c:v>81.521739130434767</c:v>
                </c:pt>
                <c:pt idx="6">
                  <c:v>83.076923076923023</c:v>
                </c:pt>
                <c:pt idx="7">
                  <c:v>83.561643835616437</c:v>
                </c:pt>
                <c:pt idx="8">
                  <c:v>83.636363636363669</c:v>
                </c:pt>
                <c:pt idx="9">
                  <c:v>83.823529411764653</c:v>
                </c:pt>
                <c:pt idx="10">
                  <c:v>83.908045977011497</c:v>
                </c:pt>
                <c:pt idx="11">
                  <c:v>84.615384615384599</c:v>
                </c:pt>
                <c:pt idx="12">
                  <c:v>85.227272727272734</c:v>
                </c:pt>
                <c:pt idx="13">
                  <c:v>85.714285714285694</c:v>
                </c:pt>
                <c:pt idx="14">
                  <c:v>85.882352941176478</c:v>
                </c:pt>
                <c:pt idx="15">
                  <c:v>87.142857142857139</c:v>
                </c:pt>
                <c:pt idx="16">
                  <c:v>87.671232876712324</c:v>
                </c:pt>
                <c:pt idx="17">
                  <c:v>87.85714285714289</c:v>
                </c:pt>
                <c:pt idx="18">
                  <c:v>88.8888888888889</c:v>
                </c:pt>
                <c:pt idx="19">
                  <c:v>90.196078431372541</c:v>
                </c:pt>
                <c:pt idx="20">
                  <c:v>90.476190476190482</c:v>
                </c:pt>
                <c:pt idx="21">
                  <c:v>90.983606557377072</c:v>
                </c:pt>
                <c:pt idx="22">
                  <c:v>91.129032258064498</c:v>
                </c:pt>
                <c:pt idx="23">
                  <c:v>91.275167785234885</c:v>
                </c:pt>
                <c:pt idx="24">
                  <c:v>91.47286821705427</c:v>
                </c:pt>
                <c:pt idx="25">
                  <c:v>91.549295774647888</c:v>
                </c:pt>
                <c:pt idx="26">
                  <c:v>92.537313432835873</c:v>
                </c:pt>
                <c:pt idx="27">
                  <c:v>93.750000000000028</c:v>
                </c:pt>
                <c:pt idx="28">
                  <c:v>93.939393939393995</c:v>
                </c:pt>
                <c:pt idx="29">
                  <c:v>93.965517241379331</c:v>
                </c:pt>
                <c:pt idx="30">
                  <c:v>94.017094017093996</c:v>
                </c:pt>
                <c:pt idx="31">
                  <c:v>94.642857142857181</c:v>
                </c:pt>
                <c:pt idx="32">
                  <c:v>94.660194174757279</c:v>
                </c:pt>
                <c:pt idx="33">
                  <c:v>94.871794871794862</c:v>
                </c:pt>
                <c:pt idx="34">
                  <c:v>94.89795918367345</c:v>
                </c:pt>
                <c:pt idx="35">
                  <c:v>95.283018867924511</c:v>
                </c:pt>
                <c:pt idx="36">
                  <c:v>95.454545454545467</c:v>
                </c:pt>
                <c:pt idx="37">
                  <c:v>95.942720763723145</c:v>
                </c:pt>
                <c:pt idx="38">
                  <c:v>96.226415094339615</c:v>
                </c:pt>
                <c:pt idx="39">
                  <c:v>96.825396825396822</c:v>
                </c:pt>
                <c:pt idx="40">
                  <c:v>97.109826589595372</c:v>
                </c:pt>
                <c:pt idx="41">
                  <c:v>97.54098360655739</c:v>
                </c:pt>
                <c:pt idx="42">
                  <c:v>97.692307692307708</c:v>
                </c:pt>
                <c:pt idx="43">
                  <c:v>97.857142857142847</c:v>
                </c:pt>
                <c:pt idx="44">
                  <c:v>97.872340425531902</c:v>
                </c:pt>
                <c:pt idx="45">
                  <c:v>98.290598290598268</c:v>
                </c:pt>
                <c:pt idx="46">
                  <c:v>98.507462686567152</c:v>
                </c:pt>
                <c:pt idx="47">
                  <c:v>98.507462686567209</c:v>
                </c:pt>
                <c:pt idx="48">
                  <c:v>98.54651162790698</c:v>
                </c:pt>
                <c:pt idx="49">
                  <c:v>98.611111111111128</c:v>
                </c:pt>
                <c:pt idx="50">
                  <c:v>98.771498771498784</c:v>
                </c:pt>
                <c:pt idx="51">
                  <c:v>99.595141700404838</c:v>
                </c:pt>
                <c:pt idx="52">
                  <c:v>99.999999999999972</c:v>
                </c:pt>
                <c:pt idx="53">
                  <c:v>100</c:v>
                </c:pt>
                <c:pt idx="54">
                  <c:v>100.8</c:v>
                </c:pt>
                <c:pt idx="55">
                  <c:v>100.89285714285714</c:v>
                </c:pt>
                <c:pt idx="56">
                  <c:v>100.90090090090089</c:v>
                </c:pt>
                <c:pt idx="57">
                  <c:v>100.95238095238098</c:v>
                </c:pt>
                <c:pt idx="58">
                  <c:v>101.28205128205123</c:v>
                </c:pt>
                <c:pt idx="59">
                  <c:v>101.40845070422537</c:v>
                </c:pt>
                <c:pt idx="60">
                  <c:v>103.33333333333331</c:v>
                </c:pt>
                <c:pt idx="61">
                  <c:v>104.76190476190474</c:v>
                </c:pt>
                <c:pt idx="62">
                  <c:v>104.81927710843375</c:v>
                </c:pt>
                <c:pt idx="63">
                  <c:v>104.92957746478871</c:v>
                </c:pt>
                <c:pt idx="64">
                  <c:v>105.06329113924049</c:v>
                </c:pt>
                <c:pt idx="65">
                  <c:v>105.21739130434781</c:v>
                </c:pt>
                <c:pt idx="66">
                  <c:v>105.40540540540542</c:v>
                </c:pt>
                <c:pt idx="67">
                  <c:v>105.64516129032258</c:v>
                </c:pt>
                <c:pt idx="68">
                  <c:v>105.66037735849054</c:v>
                </c:pt>
                <c:pt idx="69">
                  <c:v>105.97402597402599</c:v>
                </c:pt>
                <c:pt idx="70">
                  <c:v>106.45161290322582</c:v>
                </c:pt>
                <c:pt idx="71">
                  <c:v>107.03125</c:v>
                </c:pt>
                <c:pt idx="72">
                  <c:v>107.07964601769913</c:v>
                </c:pt>
                <c:pt idx="73">
                  <c:v>107.19424460431655</c:v>
                </c:pt>
                <c:pt idx="74">
                  <c:v>107.24637681159417</c:v>
                </c:pt>
                <c:pt idx="75">
                  <c:v>107.54716981132077</c:v>
                </c:pt>
                <c:pt idx="76">
                  <c:v>108.8235294117647</c:v>
                </c:pt>
                <c:pt idx="77">
                  <c:v>108.8235294117647</c:v>
                </c:pt>
                <c:pt idx="78">
                  <c:v>110.47619047619044</c:v>
                </c:pt>
                <c:pt idx="79">
                  <c:v>110.67961165048547</c:v>
                </c:pt>
                <c:pt idx="80">
                  <c:v>110.68702290076338</c:v>
                </c:pt>
                <c:pt idx="81">
                  <c:v>110.71428571428572</c:v>
                </c:pt>
                <c:pt idx="82">
                  <c:v>110.74766355140189</c:v>
                </c:pt>
                <c:pt idx="83">
                  <c:v>112.00000000000003</c:v>
                </c:pt>
                <c:pt idx="84">
                  <c:v>112.14953271028037</c:v>
                </c:pt>
                <c:pt idx="85">
                  <c:v>112.49999999999997</c:v>
                </c:pt>
                <c:pt idx="86">
                  <c:v>113.23529411764703</c:v>
                </c:pt>
                <c:pt idx="87">
                  <c:v>114.0625</c:v>
                </c:pt>
                <c:pt idx="88">
                  <c:v>117.7777777777778</c:v>
                </c:pt>
                <c:pt idx="89">
                  <c:v>118.44660194174759</c:v>
                </c:pt>
                <c:pt idx="90">
                  <c:v>118.84057971014495</c:v>
                </c:pt>
                <c:pt idx="91">
                  <c:v>123.58490566037736</c:v>
                </c:pt>
                <c:pt idx="92">
                  <c:v>128.57142857142853</c:v>
                </c:pt>
                <c:pt idx="93">
                  <c:v>135.13513513513502</c:v>
                </c:pt>
                <c:pt idx="94">
                  <c:v>141.6666666666666</c:v>
                </c:pt>
                <c:pt idx="95">
                  <c:v>146.296296296296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089792"/>
        <c:axId val="157090368"/>
      </c:scatterChart>
      <c:valAx>
        <c:axId val="15708979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>
            <c:manualLayout>
              <c:xMode val="edge"/>
              <c:yMode val="edge"/>
              <c:x val="0.38734623622066683"/>
              <c:y val="0.88835672578194957"/>
            </c:manualLayout>
          </c:layout>
          <c:overlay val="0"/>
        </c:title>
        <c:majorTickMark val="out"/>
        <c:minorTickMark val="none"/>
        <c:tickLblPos val="nextTo"/>
        <c:crossAx val="157090368"/>
        <c:crosses val="autoZero"/>
        <c:crossBetween val="midCat"/>
      </c:valAx>
      <c:valAx>
        <c:axId val="157090368"/>
        <c:scaling>
          <c:orientation val="minMax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70897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0239350509876011"/>
          <c:y val="0.5273364078239301"/>
          <c:w val="0.36705096740092852"/>
          <c:h val="0.298464709635152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72698613070908"/>
          <c:y val="5.1400554097404488E-2"/>
          <c:w val="0.7319012692863115"/>
          <c:h val="0.80229601859955935"/>
        </c:manualLayout>
      </c:layout>
      <c:scatterChart>
        <c:scatterStyle val="lineMarker"/>
        <c:varyColors val="0"/>
        <c:ser>
          <c:idx val="0"/>
          <c:order val="0"/>
          <c:tx>
            <c:strRef>
              <c:f>HMF!$F$1</c:f>
              <c:strCache>
                <c:ptCount val="1"/>
                <c:pt idx="0">
                  <c:v>HMF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HMF!$B$2:$B$97</c:f>
              <c:strCache>
                <c:ptCount val="96"/>
                <c:pt idx="0">
                  <c:v>C4</c:v>
                </c:pt>
                <c:pt idx="1">
                  <c:v>H11</c:v>
                </c:pt>
                <c:pt idx="2">
                  <c:v>F9</c:v>
                </c:pt>
                <c:pt idx="3">
                  <c:v>H2</c:v>
                </c:pt>
                <c:pt idx="4">
                  <c:v>D11</c:v>
                </c:pt>
                <c:pt idx="5">
                  <c:v>H4</c:v>
                </c:pt>
                <c:pt idx="6">
                  <c:v>C11</c:v>
                </c:pt>
                <c:pt idx="7">
                  <c:v>E2</c:v>
                </c:pt>
                <c:pt idx="8">
                  <c:v>E7</c:v>
                </c:pt>
                <c:pt idx="9">
                  <c:v>F11</c:v>
                </c:pt>
                <c:pt idx="10">
                  <c:v>G6</c:v>
                </c:pt>
                <c:pt idx="11">
                  <c:v>D4</c:v>
                </c:pt>
                <c:pt idx="12">
                  <c:v>H3</c:v>
                </c:pt>
                <c:pt idx="13">
                  <c:v>D1</c:v>
                </c:pt>
                <c:pt idx="14">
                  <c:v>A12</c:v>
                </c:pt>
                <c:pt idx="15">
                  <c:v>C6</c:v>
                </c:pt>
                <c:pt idx="16">
                  <c:v>F7</c:v>
                </c:pt>
                <c:pt idx="17">
                  <c:v>A4</c:v>
                </c:pt>
                <c:pt idx="18">
                  <c:v>H12</c:v>
                </c:pt>
                <c:pt idx="19">
                  <c:v>H6</c:v>
                </c:pt>
                <c:pt idx="20">
                  <c:v>H1</c:v>
                </c:pt>
                <c:pt idx="21">
                  <c:v>D8</c:v>
                </c:pt>
                <c:pt idx="22">
                  <c:v>H9</c:v>
                </c:pt>
                <c:pt idx="23">
                  <c:v>E12</c:v>
                </c:pt>
                <c:pt idx="24">
                  <c:v>D12</c:v>
                </c:pt>
                <c:pt idx="25">
                  <c:v>H8</c:v>
                </c:pt>
                <c:pt idx="26">
                  <c:v>F12</c:v>
                </c:pt>
                <c:pt idx="27">
                  <c:v>D7</c:v>
                </c:pt>
                <c:pt idx="28">
                  <c:v>E4</c:v>
                </c:pt>
                <c:pt idx="29">
                  <c:v>C7</c:v>
                </c:pt>
                <c:pt idx="30">
                  <c:v>B3</c:v>
                </c:pt>
                <c:pt idx="31">
                  <c:v>F4</c:v>
                </c:pt>
                <c:pt idx="32">
                  <c:v>C2</c:v>
                </c:pt>
                <c:pt idx="33">
                  <c:v>A6</c:v>
                </c:pt>
                <c:pt idx="34">
                  <c:v>E1</c:v>
                </c:pt>
                <c:pt idx="35">
                  <c:v>D10</c:v>
                </c:pt>
                <c:pt idx="36">
                  <c:v>E6</c:v>
                </c:pt>
                <c:pt idx="37">
                  <c:v>D3</c:v>
                </c:pt>
                <c:pt idx="38">
                  <c:v>E11</c:v>
                </c:pt>
                <c:pt idx="39">
                  <c:v>C3</c:v>
                </c:pt>
                <c:pt idx="40">
                  <c:v>F10</c:v>
                </c:pt>
                <c:pt idx="41">
                  <c:v>D9</c:v>
                </c:pt>
                <c:pt idx="42">
                  <c:v>E3</c:v>
                </c:pt>
                <c:pt idx="43">
                  <c:v>C1</c:v>
                </c:pt>
                <c:pt idx="44">
                  <c:v>D6</c:v>
                </c:pt>
                <c:pt idx="45">
                  <c:v>F1</c:v>
                </c:pt>
                <c:pt idx="46">
                  <c:v>C9</c:v>
                </c:pt>
                <c:pt idx="47">
                  <c:v>E9</c:v>
                </c:pt>
                <c:pt idx="48">
                  <c:v>H5</c:v>
                </c:pt>
                <c:pt idx="49">
                  <c:v>F2</c:v>
                </c:pt>
                <c:pt idx="50">
                  <c:v>B6</c:v>
                </c:pt>
                <c:pt idx="51">
                  <c:v>C12</c:v>
                </c:pt>
                <c:pt idx="52">
                  <c:v>B11</c:v>
                </c:pt>
                <c:pt idx="53">
                  <c:v>C10</c:v>
                </c:pt>
                <c:pt idx="54">
                  <c:v>H10</c:v>
                </c:pt>
                <c:pt idx="55">
                  <c:v>A10</c:v>
                </c:pt>
                <c:pt idx="56">
                  <c:v>F3</c:v>
                </c:pt>
                <c:pt idx="57">
                  <c:v>F8</c:v>
                </c:pt>
                <c:pt idx="58">
                  <c:v>A1</c:v>
                </c:pt>
                <c:pt idx="59">
                  <c:v>B7</c:v>
                </c:pt>
                <c:pt idx="60">
                  <c:v>E10</c:v>
                </c:pt>
                <c:pt idx="61">
                  <c:v>B5</c:v>
                </c:pt>
                <c:pt idx="62">
                  <c:v>B4</c:v>
                </c:pt>
                <c:pt idx="63">
                  <c:v>A3</c:v>
                </c:pt>
                <c:pt idx="64">
                  <c:v>A9</c:v>
                </c:pt>
                <c:pt idx="65">
                  <c:v>B12</c:v>
                </c:pt>
                <c:pt idx="66">
                  <c:v>C8</c:v>
                </c:pt>
                <c:pt idx="67">
                  <c:v>B1</c:v>
                </c:pt>
                <c:pt idx="68">
                  <c:v>A11</c:v>
                </c:pt>
                <c:pt idx="69">
                  <c:v>E8</c:v>
                </c:pt>
                <c:pt idx="70">
                  <c:v>A5</c:v>
                </c:pt>
                <c:pt idx="71">
                  <c:v>A8</c:v>
                </c:pt>
                <c:pt idx="72">
                  <c:v>D5</c:v>
                </c:pt>
                <c:pt idx="73">
                  <c:v>F6</c:v>
                </c:pt>
                <c:pt idx="74">
                  <c:v>H7</c:v>
                </c:pt>
                <c:pt idx="75">
                  <c:v>A2</c:v>
                </c:pt>
                <c:pt idx="76">
                  <c:v>A7</c:v>
                </c:pt>
                <c:pt idx="77">
                  <c:v>B2</c:v>
                </c:pt>
                <c:pt idx="78">
                  <c:v>B8</c:v>
                </c:pt>
                <c:pt idx="79">
                  <c:v>F5</c:v>
                </c:pt>
                <c:pt idx="80">
                  <c:v>B10</c:v>
                </c:pt>
                <c:pt idx="81">
                  <c:v>C5</c:v>
                </c:pt>
                <c:pt idx="82">
                  <c:v>B9</c:v>
                </c:pt>
                <c:pt idx="83">
                  <c:v>G12</c:v>
                </c:pt>
                <c:pt idx="84">
                  <c:v>G10</c:v>
                </c:pt>
                <c:pt idx="85">
                  <c:v>G9</c:v>
                </c:pt>
                <c:pt idx="86">
                  <c:v>E5</c:v>
                </c:pt>
                <c:pt idx="87">
                  <c:v>G4</c:v>
                </c:pt>
                <c:pt idx="88">
                  <c:v>G3</c:v>
                </c:pt>
                <c:pt idx="89">
                  <c:v>D2</c:v>
                </c:pt>
                <c:pt idx="90">
                  <c:v>G11</c:v>
                </c:pt>
                <c:pt idx="91">
                  <c:v>G2</c:v>
                </c:pt>
                <c:pt idx="92">
                  <c:v>G7</c:v>
                </c:pt>
                <c:pt idx="93">
                  <c:v>G1</c:v>
                </c:pt>
                <c:pt idx="94">
                  <c:v>G5</c:v>
                </c:pt>
                <c:pt idx="95">
                  <c:v>G8</c:v>
                </c:pt>
              </c:strCache>
            </c:strRef>
          </c:xVal>
          <c:yVal>
            <c:numRef>
              <c:f>HMF!$F$2:$F$97</c:f>
              <c:numCache>
                <c:formatCode>General</c:formatCode>
                <c:ptCount val="96"/>
                <c:pt idx="0">
                  <c:v>52.52525252525254</c:v>
                </c:pt>
                <c:pt idx="1">
                  <c:v>53.719008264462801</c:v>
                </c:pt>
                <c:pt idx="2">
                  <c:v>53.846153846153854</c:v>
                </c:pt>
                <c:pt idx="3">
                  <c:v>61.728395061728392</c:v>
                </c:pt>
                <c:pt idx="4">
                  <c:v>63.440860215053739</c:v>
                </c:pt>
                <c:pt idx="5">
                  <c:v>64.761904761904759</c:v>
                </c:pt>
                <c:pt idx="6">
                  <c:v>64.772727272727295</c:v>
                </c:pt>
                <c:pt idx="7">
                  <c:v>67.164179104477611</c:v>
                </c:pt>
                <c:pt idx="8">
                  <c:v>68.316831683168317</c:v>
                </c:pt>
                <c:pt idx="9">
                  <c:v>68.518518518518547</c:v>
                </c:pt>
                <c:pt idx="10">
                  <c:v>69.767441860465127</c:v>
                </c:pt>
                <c:pt idx="11">
                  <c:v>70.085470085470106</c:v>
                </c:pt>
                <c:pt idx="12">
                  <c:v>71.153846153846132</c:v>
                </c:pt>
                <c:pt idx="13">
                  <c:v>73.63636363636364</c:v>
                </c:pt>
                <c:pt idx="14">
                  <c:v>74.247491638795978</c:v>
                </c:pt>
                <c:pt idx="15">
                  <c:v>74.336283185840728</c:v>
                </c:pt>
                <c:pt idx="16">
                  <c:v>76.851851851851862</c:v>
                </c:pt>
                <c:pt idx="17">
                  <c:v>77.25</c:v>
                </c:pt>
                <c:pt idx="18">
                  <c:v>78.301886792452819</c:v>
                </c:pt>
                <c:pt idx="19">
                  <c:v>78.448275862068968</c:v>
                </c:pt>
                <c:pt idx="20">
                  <c:v>78.571428571428555</c:v>
                </c:pt>
                <c:pt idx="21">
                  <c:v>78.723404255319139</c:v>
                </c:pt>
                <c:pt idx="22">
                  <c:v>79.207920792079207</c:v>
                </c:pt>
                <c:pt idx="23">
                  <c:v>79.27927927927928</c:v>
                </c:pt>
                <c:pt idx="24">
                  <c:v>79.611650485436897</c:v>
                </c:pt>
                <c:pt idx="25">
                  <c:v>79.807692307692292</c:v>
                </c:pt>
                <c:pt idx="26">
                  <c:v>79.84496124031007</c:v>
                </c:pt>
                <c:pt idx="27">
                  <c:v>80.165289256198335</c:v>
                </c:pt>
                <c:pt idx="28">
                  <c:v>80.555555555555543</c:v>
                </c:pt>
                <c:pt idx="29">
                  <c:v>80.555555555555586</c:v>
                </c:pt>
                <c:pt idx="30">
                  <c:v>80.740740740740748</c:v>
                </c:pt>
                <c:pt idx="31">
                  <c:v>82.075471698113205</c:v>
                </c:pt>
                <c:pt idx="32">
                  <c:v>83.333333333333343</c:v>
                </c:pt>
                <c:pt idx="33">
                  <c:v>84.615384615384613</c:v>
                </c:pt>
                <c:pt idx="34">
                  <c:v>84.684684684684711</c:v>
                </c:pt>
                <c:pt idx="35">
                  <c:v>84.810126582278471</c:v>
                </c:pt>
                <c:pt idx="36">
                  <c:v>85</c:v>
                </c:pt>
                <c:pt idx="37">
                  <c:v>85.039370078740177</c:v>
                </c:pt>
                <c:pt idx="38">
                  <c:v>85.185185185185233</c:v>
                </c:pt>
                <c:pt idx="39">
                  <c:v>85.71428571428568</c:v>
                </c:pt>
                <c:pt idx="40">
                  <c:v>85.849056603773562</c:v>
                </c:pt>
                <c:pt idx="41">
                  <c:v>85.869565217391298</c:v>
                </c:pt>
                <c:pt idx="42">
                  <c:v>85.981308411214968</c:v>
                </c:pt>
                <c:pt idx="43">
                  <c:v>86.111111111111128</c:v>
                </c:pt>
                <c:pt idx="44">
                  <c:v>86.238532110091754</c:v>
                </c:pt>
                <c:pt idx="45">
                  <c:v>86.486486486486442</c:v>
                </c:pt>
                <c:pt idx="46">
                  <c:v>86.597938144329873</c:v>
                </c:pt>
                <c:pt idx="47">
                  <c:v>86.734693877551024</c:v>
                </c:pt>
                <c:pt idx="48">
                  <c:v>86.842105263157876</c:v>
                </c:pt>
                <c:pt idx="49">
                  <c:v>86.842105263157904</c:v>
                </c:pt>
                <c:pt idx="50">
                  <c:v>87.378640776699044</c:v>
                </c:pt>
                <c:pt idx="51">
                  <c:v>87.65432098765433</c:v>
                </c:pt>
                <c:pt idx="52">
                  <c:v>87.804878048780452</c:v>
                </c:pt>
                <c:pt idx="53">
                  <c:v>88.3720930232558</c:v>
                </c:pt>
                <c:pt idx="54">
                  <c:v>88.636363636363598</c:v>
                </c:pt>
                <c:pt idx="55">
                  <c:v>88.663967611336076</c:v>
                </c:pt>
                <c:pt idx="56">
                  <c:v>88.888888888888872</c:v>
                </c:pt>
                <c:pt idx="57">
                  <c:v>89.108910891089138</c:v>
                </c:pt>
                <c:pt idx="58">
                  <c:v>89.460154241645242</c:v>
                </c:pt>
                <c:pt idx="59">
                  <c:v>89.908256880733944</c:v>
                </c:pt>
                <c:pt idx="60">
                  <c:v>90.109890109890117</c:v>
                </c:pt>
                <c:pt idx="61">
                  <c:v>90.196078431372541</c:v>
                </c:pt>
                <c:pt idx="62">
                  <c:v>90.384615384615373</c:v>
                </c:pt>
                <c:pt idx="63">
                  <c:v>90.476190476190482</c:v>
                </c:pt>
                <c:pt idx="64">
                  <c:v>90.697674418604663</c:v>
                </c:pt>
                <c:pt idx="65">
                  <c:v>90.909090909090935</c:v>
                </c:pt>
                <c:pt idx="66">
                  <c:v>91.011235955056208</c:v>
                </c:pt>
                <c:pt idx="67">
                  <c:v>91.452991452991455</c:v>
                </c:pt>
                <c:pt idx="68">
                  <c:v>91.463414634146361</c:v>
                </c:pt>
                <c:pt idx="69">
                  <c:v>91.578947368421083</c:v>
                </c:pt>
                <c:pt idx="70">
                  <c:v>93.548387096774206</c:v>
                </c:pt>
                <c:pt idx="71">
                  <c:v>93.749999999999986</c:v>
                </c:pt>
                <c:pt idx="72">
                  <c:v>93.814432989690744</c:v>
                </c:pt>
                <c:pt idx="73">
                  <c:v>94.791666666666657</c:v>
                </c:pt>
                <c:pt idx="74">
                  <c:v>95.348837209302317</c:v>
                </c:pt>
                <c:pt idx="75">
                  <c:v>95.930232558139565</c:v>
                </c:pt>
                <c:pt idx="76">
                  <c:v>96.330275229357881</c:v>
                </c:pt>
                <c:pt idx="77">
                  <c:v>96.610169491525397</c:v>
                </c:pt>
                <c:pt idx="78">
                  <c:v>97</c:v>
                </c:pt>
                <c:pt idx="79">
                  <c:v>97</c:v>
                </c:pt>
                <c:pt idx="80">
                  <c:v>98.901098901098919</c:v>
                </c:pt>
                <c:pt idx="81">
                  <c:v>101.33333333333334</c:v>
                </c:pt>
                <c:pt idx="82">
                  <c:v>104.30107526881716</c:v>
                </c:pt>
                <c:pt idx="83">
                  <c:v>105.26315789473682</c:v>
                </c:pt>
                <c:pt idx="84">
                  <c:v>106.81818181818181</c:v>
                </c:pt>
                <c:pt idx="85">
                  <c:v>107.27272727272728</c:v>
                </c:pt>
                <c:pt idx="86">
                  <c:v>108.43373493975908</c:v>
                </c:pt>
                <c:pt idx="87">
                  <c:v>112.5</c:v>
                </c:pt>
                <c:pt idx="88">
                  <c:v>113.00813008130079</c:v>
                </c:pt>
                <c:pt idx="89">
                  <c:v>114.00000000000006</c:v>
                </c:pt>
                <c:pt idx="90">
                  <c:v>116.34615384615388</c:v>
                </c:pt>
                <c:pt idx="91">
                  <c:v>121.4285714285714</c:v>
                </c:pt>
                <c:pt idx="92">
                  <c:v>124.77064220183487</c:v>
                </c:pt>
                <c:pt idx="93">
                  <c:v>125.24271844660193</c:v>
                </c:pt>
                <c:pt idx="94">
                  <c:v>135</c:v>
                </c:pt>
                <c:pt idx="95">
                  <c:v>139.3617021276595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84480"/>
        <c:axId val="87285056"/>
      </c:scatterChart>
      <c:valAx>
        <c:axId val="8728448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>
            <c:manualLayout>
              <c:xMode val="edge"/>
              <c:yMode val="edge"/>
              <c:x val="0.34399773967238462"/>
              <c:y val="0.90553895095666881"/>
            </c:manualLayout>
          </c:layout>
          <c:overlay val="0"/>
        </c:title>
        <c:majorTickMark val="out"/>
        <c:minorTickMark val="none"/>
        <c:tickLblPos val="nextTo"/>
        <c:crossAx val="87285056"/>
        <c:crosses val="autoZero"/>
        <c:crossBetween val="midCat"/>
      </c:valAx>
      <c:valAx>
        <c:axId val="87285056"/>
        <c:scaling>
          <c:orientation val="minMax"/>
          <c:max val="14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28448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9936651344465339"/>
          <c:y val="0.58150144563883133"/>
          <c:w val="0.16855468066491688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95294938256454"/>
          <c:y val="2.7597360976985463E-2"/>
          <c:w val="0.71594279109724701"/>
          <c:h val="0.86416822632243129"/>
        </c:manualLayout>
      </c:layout>
      <c:scatterChart>
        <c:scatterStyle val="lineMarker"/>
        <c:varyColors val="0"/>
        <c:ser>
          <c:idx val="0"/>
          <c:order val="0"/>
          <c:tx>
            <c:strRef>
              <c:f>Vanillin!$G$1</c:f>
              <c:strCache>
                <c:ptCount val="1"/>
                <c:pt idx="0">
                  <c:v>Vanillin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Vanillin!$B$2:$B$97</c:f>
              <c:strCache>
                <c:ptCount val="96"/>
                <c:pt idx="0">
                  <c:v>D11</c:v>
                </c:pt>
                <c:pt idx="1">
                  <c:v>H4</c:v>
                </c:pt>
                <c:pt idx="2">
                  <c:v>H11</c:v>
                </c:pt>
                <c:pt idx="3">
                  <c:v>E7</c:v>
                </c:pt>
                <c:pt idx="4">
                  <c:v>F9</c:v>
                </c:pt>
                <c:pt idx="5">
                  <c:v>A12</c:v>
                </c:pt>
                <c:pt idx="6">
                  <c:v>B11</c:v>
                </c:pt>
                <c:pt idx="7">
                  <c:v>C11</c:v>
                </c:pt>
                <c:pt idx="8">
                  <c:v>A11</c:v>
                </c:pt>
                <c:pt idx="9">
                  <c:v>B7</c:v>
                </c:pt>
                <c:pt idx="10">
                  <c:v>G6</c:v>
                </c:pt>
                <c:pt idx="11">
                  <c:v>G10</c:v>
                </c:pt>
                <c:pt idx="12">
                  <c:v>C2</c:v>
                </c:pt>
                <c:pt idx="13">
                  <c:v>B3</c:v>
                </c:pt>
                <c:pt idx="14">
                  <c:v>H5</c:v>
                </c:pt>
                <c:pt idx="15">
                  <c:v>G12</c:v>
                </c:pt>
                <c:pt idx="16">
                  <c:v>C8</c:v>
                </c:pt>
                <c:pt idx="17">
                  <c:v>D10</c:v>
                </c:pt>
                <c:pt idx="18">
                  <c:v>C12</c:v>
                </c:pt>
                <c:pt idx="19">
                  <c:v>A10</c:v>
                </c:pt>
                <c:pt idx="20">
                  <c:v>F4</c:v>
                </c:pt>
                <c:pt idx="21">
                  <c:v>C6</c:v>
                </c:pt>
                <c:pt idx="22">
                  <c:v>A2</c:v>
                </c:pt>
                <c:pt idx="23">
                  <c:v>D8</c:v>
                </c:pt>
                <c:pt idx="24">
                  <c:v>G4</c:v>
                </c:pt>
                <c:pt idx="25">
                  <c:v>C7</c:v>
                </c:pt>
                <c:pt idx="26">
                  <c:v>H3</c:v>
                </c:pt>
                <c:pt idx="27">
                  <c:v>H2</c:v>
                </c:pt>
                <c:pt idx="28">
                  <c:v>C4</c:v>
                </c:pt>
                <c:pt idx="29">
                  <c:v>B8</c:v>
                </c:pt>
                <c:pt idx="30">
                  <c:v>F10</c:v>
                </c:pt>
                <c:pt idx="31">
                  <c:v>D7</c:v>
                </c:pt>
                <c:pt idx="32">
                  <c:v>E4</c:v>
                </c:pt>
                <c:pt idx="33">
                  <c:v>D1</c:v>
                </c:pt>
                <c:pt idx="34">
                  <c:v>F7</c:v>
                </c:pt>
                <c:pt idx="35">
                  <c:v>D6</c:v>
                </c:pt>
                <c:pt idx="36">
                  <c:v>F2</c:v>
                </c:pt>
                <c:pt idx="37">
                  <c:v>D5</c:v>
                </c:pt>
                <c:pt idx="38">
                  <c:v>H1</c:v>
                </c:pt>
                <c:pt idx="39">
                  <c:v>H12</c:v>
                </c:pt>
                <c:pt idx="40">
                  <c:v>A7</c:v>
                </c:pt>
                <c:pt idx="41">
                  <c:v>G9</c:v>
                </c:pt>
                <c:pt idx="42">
                  <c:v>F5</c:v>
                </c:pt>
                <c:pt idx="43">
                  <c:v>H8</c:v>
                </c:pt>
                <c:pt idx="44">
                  <c:v>B6</c:v>
                </c:pt>
                <c:pt idx="45">
                  <c:v>A4</c:v>
                </c:pt>
                <c:pt idx="46">
                  <c:v>C9</c:v>
                </c:pt>
                <c:pt idx="47">
                  <c:v>G2</c:v>
                </c:pt>
                <c:pt idx="48">
                  <c:v>A5</c:v>
                </c:pt>
                <c:pt idx="49">
                  <c:v>D4</c:v>
                </c:pt>
                <c:pt idx="50">
                  <c:v>B12</c:v>
                </c:pt>
                <c:pt idx="51">
                  <c:v>H7</c:v>
                </c:pt>
                <c:pt idx="52">
                  <c:v>E8</c:v>
                </c:pt>
                <c:pt idx="53">
                  <c:v>E10</c:v>
                </c:pt>
                <c:pt idx="54">
                  <c:v>B10</c:v>
                </c:pt>
                <c:pt idx="55">
                  <c:v>F8</c:v>
                </c:pt>
                <c:pt idx="56">
                  <c:v>A6</c:v>
                </c:pt>
                <c:pt idx="57">
                  <c:v>H9</c:v>
                </c:pt>
                <c:pt idx="58">
                  <c:v>D3</c:v>
                </c:pt>
                <c:pt idx="59">
                  <c:v>G5</c:v>
                </c:pt>
                <c:pt idx="60">
                  <c:v>D12</c:v>
                </c:pt>
                <c:pt idx="61">
                  <c:v>G3</c:v>
                </c:pt>
                <c:pt idx="62">
                  <c:v>E12</c:v>
                </c:pt>
                <c:pt idx="63">
                  <c:v>E2</c:v>
                </c:pt>
                <c:pt idx="64">
                  <c:v>F11</c:v>
                </c:pt>
                <c:pt idx="65">
                  <c:v>A9</c:v>
                </c:pt>
                <c:pt idx="66">
                  <c:v>G7</c:v>
                </c:pt>
                <c:pt idx="67">
                  <c:v>E6</c:v>
                </c:pt>
                <c:pt idx="68">
                  <c:v>H6</c:v>
                </c:pt>
                <c:pt idx="69">
                  <c:v>B5</c:v>
                </c:pt>
                <c:pt idx="70">
                  <c:v>A8</c:v>
                </c:pt>
                <c:pt idx="71">
                  <c:v>F12</c:v>
                </c:pt>
                <c:pt idx="72">
                  <c:v>C1</c:v>
                </c:pt>
                <c:pt idx="73">
                  <c:v>D9</c:v>
                </c:pt>
                <c:pt idx="74">
                  <c:v>E11</c:v>
                </c:pt>
                <c:pt idx="75">
                  <c:v>F1</c:v>
                </c:pt>
                <c:pt idx="76">
                  <c:v>H10</c:v>
                </c:pt>
                <c:pt idx="77">
                  <c:v>B1</c:v>
                </c:pt>
                <c:pt idx="78">
                  <c:v>C3</c:v>
                </c:pt>
                <c:pt idx="79">
                  <c:v>F6</c:v>
                </c:pt>
                <c:pt idx="80">
                  <c:v>E9</c:v>
                </c:pt>
                <c:pt idx="81">
                  <c:v>D2</c:v>
                </c:pt>
                <c:pt idx="82">
                  <c:v>B4</c:v>
                </c:pt>
                <c:pt idx="83">
                  <c:v>A1</c:v>
                </c:pt>
                <c:pt idx="84">
                  <c:v>C10</c:v>
                </c:pt>
                <c:pt idx="85">
                  <c:v>E3</c:v>
                </c:pt>
                <c:pt idx="86">
                  <c:v>E1</c:v>
                </c:pt>
                <c:pt idx="87">
                  <c:v>G8</c:v>
                </c:pt>
                <c:pt idx="88">
                  <c:v>G11</c:v>
                </c:pt>
                <c:pt idx="89">
                  <c:v>C5</c:v>
                </c:pt>
                <c:pt idx="90">
                  <c:v>G1</c:v>
                </c:pt>
                <c:pt idx="91">
                  <c:v>A3</c:v>
                </c:pt>
                <c:pt idx="92">
                  <c:v>B9</c:v>
                </c:pt>
                <c:pt idx="93">
                  <c:v>B2</c:v>
                </c:pt>
                <c:pt idx="94">
                  <c:v>E5</c:v>
                </c:pt>
                <c:pt idx="95">
                  <c:v>F3</c:v>
                </c:pt>
              </c:strCache>
            </c:strRef>
          </c:xVal>
          <c:yVal>
            <c:numRef>
              <c:f>Vanillin!$G$2:$G$97</c:f>
              <c:numCache>
                <c:formatCode>General</c:formatCode>
                <c:ptCount val="96"/>
                <c:pt idx="0">
                  <c:v>22.580645161290295</c:v>
                </c:pt>
                <c:pt idx="1">
                  <c:v>25.714285714285694</c:v>
                </c:pt>
                <c:pt idx="2">
                  <c:v>28.099173553719016</c:v>
                </c:pt>
                <c:pt idx="3">
                  <c:v>28.712871287128699</c:v>
                </c:pt>
                <c:pt idx="4">
                  <c:v>29.807692307692314</c:v>
                </c:pt>
                <c:pt idx="5">
                  <c:v>35.117056856187304</c:v>
                </c:pt>
                <c:pt idx="6">
                  <c:v>36.585365853658537</c:v>
                </c:pt>
                <c:pt idx="7">
                  <c:v>39.772727272727259</c:v>
                </c:pt>
                <c:pt idx="8">
                  <c:v>40.243902439024396</c:v>
                </c:pt>
                <c:pt idx="9">
                  <c:v>43.11926605504587</c:v>
                </c:pt>
                <c:pt idx="10">
                  <c:v>46.511627906976763</c:v>
                </c:pt>
                <c:pt idx="11">
                  <c:v>47.727272727272698</c:v>
                </c:pt>
                <c:pt idx="12">
                  <c:v>47.7777777777778</c:v>
                </c:pt>
                <c:pt idx="13">
                  <c:v>48.888888888888872</c:v>
                </c:pt>
                <c:pt idx="14">
                  <c:v>49.122807017543849</c:v>
                </c:pt>
                <c:pt idx="15">
                  <c:v>49.122807017543849</c:v>
                </c:pt>
                <c:pt idx="16">
                  <c:v>49.438202247191008</c:v>
                </c:pt>
                <c:pt idx="17">
                  <c:v>50.632911392405063</c:v>
                </c:pt>
                <c:pt idx="18">
                  <c:v>53.086419753086446</c:v>
                </c:pt>
                <c:pt idx="19">
                  <c:v>54.655870445344156</c:v>
                </c:pt>
                <c:pt idx="20">
                  <c:v>54.716981132075468</c:v>
                </c:pt>
                <c:pt idx="21">
                  <c:v>54.86725663716814</c:v>
                </c:pt>
                <c:pt idx="22">
                  <c:v>55.81395348837215</c:v>
                </c:pt>
                <c:pt idx="23">
                  <c:v>58.51063829787234</c:v>
                </c:pt>
                <c:pt idx="24">
                  <c:v>60.416666666666671</c:v>
                </c:pt>
                <c:pt idx="25">
                  <c:v>62.96296296296299</c:v>
                </c:pt>
                <c:pt idx="26">
                  <c:v>63.46153846153846</c:v>
                </c:pt>
                <c:pt idx="27">
                  <c:v>64.197530864197489</c:v>
                </c:pt>
                <c:pt idx="28">
                  <c:v>65.656565656565675</c:v>
                </c:pt>
                <c:pt idx="29">
                  <c:v>65.999999999999986</c:v>
                </c:pt>
                <c:pt idx="30">
                  <c:v>66.981132075471706</c:v>
                </c:pt>
                <c:pt idx="31">
                  <c:v>67.7685950413223</c:v>
                </c:pt>
                <c:pt idx="32">
                  <c:v>68.518518518518519</c:v>
                </c:pt>
                <c:pt idx="33">
                  <c:v>69.090909090909108</c:v>
                </c:pt>
                <c:pt idx="34">
                  <c:v>69.444444444444457</c:v>
                </c:pt>
                <c:pt idx="35">
                  <c:v>69.724770642201833</c:v>
                </c:pt>
                <c:pt idx="36">
                  <c:v>69.736842105263136</c:v>
                </c:pt>
                <c:pt idx="37">
                  <c:v>70.103092783505161</c:v>
                </c:pt>
                <c:pt idx="38">
                  <c:v>70.535714285714263</c:v>
                </c:pt>
                <c:pt idx="39">
                  <c:v>70.754716981132077</c:v>
                </c:pt>
                <c:pt idx="40">
                  <c:v>72.477064220183536</c:v>
                </c:pt>
                <c:pt idx="41">
                  <c:v>72.727272727272734</c:v>
                </c:pt>
                <c:pt idx="42">
                  <c:v>73</c:v>
                </c:pt>
                <c:pt idx="43">
                  <c:v>74.038461538461519</c:v>
                </c:pt>
                <c:pt idx="44">
                  <c:v>74.757281553398045</c:v>
                </c:pt>
                <c:pt idx="45">
                  <c:v>75.000000000000028</c:v>
                </c:pt>
                <c:pt idx="46">
                  <c:v>75.257731958762889</c:v>
                </c:pt>
                <c:pt idx="47">
                  <c:v>75.714285714285694</c:v>
                </c:pt>
                <c:pt idx="48">
                  <c:v>77.419354838709708</c:v>
                </c:pt>
                <c:pt idx="49">
                  <c:v>78.632478632478637</c:v>
                </c:pt>
                <c:pt idx="50">
                  <c:v>78.78787878787881</c:v>
                </c:pt>
                <c:pt idx="51">
                  <c:v>79.069767441860478</c:v>
                </c:pt>
                <c:pt idx="52">
                  <c:v>80</c:v>
                </c:pt>
                <c:pt idx="53">
                  <c:v>80.219780219780219</c:v>
                </c:pt>
                <c:pt idx="54">
                  <c:v>80.219780219780247</c:v>
                </c:pt>
                <c:pt idx="55">
                  <c:v>81.188118811881182</c:v>
                </c:pt>
                <c:pt idx="56">
                  <c:v>81.196581196581178</c:v>
                </c:pt>
                <c:pt idx="57">
                  <c:v>83.1683168316832</c:v>
                </c:pt>
                <c:pt idx="58">
                  <c:v>83.464566929133852</c:v>
                </c:pt>
                <c:pt idx="59">
                  <c:v>84.000000000000014</c:v>
                </c:pt>
                <c:pt idx="60">
                  <c:v>84.466019417475749</c:v>
                </c:pt>
                <c:pt idx="61">
                  <c:v>84.552845528455265</c:v>
                </c:pt>
                <c:pt idx="62">
                  <c:v>84.684684684684711</c:v>
                </c:pt>
                <c:pt idx="63">
                  <c:v>85.074626865671604</c:v>
                </c:pt>
                <c:pt idx="64">
                  <c:v>85.18518518518519</c:v>
                </c:pt>
                <c:pt idx="65">
                  <c:v>86.046511627907023</c:v>
                </c:pt>
                <c:pt idx="66">
                  <c:v>86.238532110091739</c:v>
                </c:pt>
                <c:pt idx="67">
                  <c:v>87.000000000000014</c:v>
                </c:pt>
                <c:pt idx="68">
                  <c:v>87.068965517241381</c:v>
                </c:pt>
                <c:pt idx="69">
                  <c:v>87.254901960784309</c:v>
                </c:pt>
                <c:pt idx="70">
                  <c:v>87.499999999999986</c:v>
                </c:pt>
                <c:pt idx="71">
                  <c:v>87.596899224806208</c:v>
                </c:pt>
                <c:pt idx="72">
                  <c:v>87.962962962963005</c:v>
                </c:pt>
                <c:pt idx="73">
                  <c:v>88.043478260869549</c:v>
                </c:pt>
                <c:pt idx="74">
                  <c:v>91.358024691358068</c:v>
                </c:pt>
                <c:pt idx="75">
                  <c:v>92.792792792792781</c:v>
                </c:pt>
                <c:pt idx="76">
                  <c:v>93.181818181818187</c:v>
                </c:pt>
                <c:pt idx="77">
                  <c:v>94.87179487179489</c:v>
                </c:pt>
                <c:pt idx="78">
                  <c:v>95.238095238095212</c:v>
                </c:pt>
                <c:pt idx="79">
                  <c:v>95.833333333333329</c:v>
                </c:pt>
                <c:pt idx="80">
                  <c:v>95.918367346938794</c:v>
                </c:pt>
                <c:pt idx="81">
                  <c:v>96.000000000000014</c:v>
                </c:pt>
                <c:pt idx="82">
                  <c:v>96.15384615384616</c:v>
                </c:pt>
                <c:pt idx="83">
                  <c:v>97.943444730077104</c:v>
                </c:pt>
                <c:pt idx="84">
                  <c:v>100</c:v>
                </c:pt>
                <c:pt idx="85">
                  <c:v>100.93457943925235</c:v>
                </c:pt>
                <c:pt idx="86">
                  <c:v>102.70270270270272</c:v>
                </c:pt>
                <c:pt idx="87">
                  <c:v>104.25531914893618</c:v>
                </c:pt>
                <c:pt idx="88">
                  <c:v>105.76923076923077</c:v>
                </c:pt>
                <c:pt idx="89">
                  <c:v>108.00000000000006</c:v>
                </c:pt>
                <c:pt idx="90">
                  <c:v>109.70873786407766</c:v>
                </c:pt>
                <c:pt idx="91">
                  <c:v>112.69841269841272</c:v>
                </c:pt>
                <c:pt idx="92">
                  <c:v>112.90322580645156</c:v>
                </c:pt>
                <c:pt idx="93">
                  <c:v>113.55932203389834</c:v>
                </c:pt>
                <c:pt idx="94">
                  <c:v>114.45783132530121</c:v>
                </c:pt>
                <c:pt idx="95">
                  <c:v>124.0740740740740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079296"/>
        <c:axId val="34078720"/>
      </c:scatterChart>
      <c:valAx>
        <c:axId val="3407929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4078720"/>
        <c:crosses val="autoZero"/>
        <c:crossBetween val="midCat"/>
      </c:valAx>
      <c:valAx>
        <c:axId val="34078720"/>
        <c:scaling>
          <c:orientation val="minMax"/>
          <c:max val="140"/>
          <c:min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4079296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8653790287877636"/>
          <c:y val="0.5599930737824439"/>
          <c:w val="0.29679545634609322"/>
          <c:h val="0.1560738265548842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36570428696409"/>
          <c:y val="2.7597360976985463E-2"/>
          <c:w val="0.73005118110236222"/>
          <c:h val="0.87321280541478297"/>
        </c:manualLayout>
      </c:layout>
      <c:scatterChart>
        <c:scatterStyle val="lineMarker"/>
        <c:varyColors val="0"/>
        <c:ser>
          <c:idx val="0"/>
          <c:order val="0"/>
          <c:tx>
            <c:strRef>
              <c:f>Sorbitol!$H$1</c:f>
              <c:strCache>
                <c:ptCount val="1"/>
                <c:pt idx="0">
                  <c:v>Sorbit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orbitol!$B$2:$B$97</c:f>
              <c:strCache>
                <c:ptCount val="96"/>
                <c:pt idx="0">
                  <c:v>F5</c:v>
                </c:pt>
                <c:pt idx="1">
                  <c:v>H5</c:v>
                </c:pt>
                <c:pt idx="2">
                  <c:v>F7</c:v>
                </c:pt>
                <c:pt idx="3">
                  <c:v>H6</c:v>
                </c:pt>
                <c:pt idx="4">
                  <c:v>H11</c:v>
                </c:pt>
                <c:pt idx="5">
                  <c:v>F6</c:v>
                </c:pt>
                <c:pt idx="6">
                  <c:v>D4</c:v>
                </c:pt>
                <c:pt idx="7">
                  <c:v>H9</c:v>
                </c:pt>
                <c:pt idx="8">
                  <c:v>E5</c:v>
                </c:pt>
                <c:pt idx="9">
                  <c:v>G10</c:v>
                </c:pt>
                <c:pt idx="10">
                  <c:v>F2</c:v>
                </c:pt>
                <c:pt idx="11">
                  <c:v>D3</c:v>
                </c:pt>
                <c:pt idx="12">
                  <c:v>A2</c:v>
                </c:pt>
                <c:pt idx="13">
                  <c:v>A3</c:v>
                </c:pt>
                <c:pt idx="14">
                  <c:v>G12</c:v>
                </c:pt>
                <c:pt idx="15">
                  <c:v>D8</c:v>
                </c:pt>
                <c:pt idx="16">
                  <c:v>D2</c:v>
                </c:pt>
                <c:pt idx="17">
                  <c:v>D5</c:v>
                </c:pt>
                <c:pt idx="18">
                  <c:v>C12</c:v>
                </c:pt>
                <c:pt idx="19">
                  <c:v>F3</c:v>
                </c:pt>
                <c:pt idx="20">
                  <c:v>B2</c:v>
                </c:pt>
                <c:pt idx="21">
                  <c:v>H4</c:v>
                </c:pt>
                <c:pt idx="22">
                  <c:v>G6</c:v>
                </c:pt>
                <c:pt idx="23">
                  <c:v>D7</c:v>
                </c:pt>
                <c:pt idx="24">
                  <c:v>G9</c:v>
                </c:pt>
                <c:pt idx="25">
                  <c:v>E7</c:v>
                </c:pt>
                <c:pt idx="26">
                  <c:v>F1</c:v>
                </c:pt>
                <c:pt idx="27">
                  <c:v>E6</c:v>
                </c:pt>
                <c:pt idx="28">
                  <c:v>B5</c:v>
                </c:pt>
                <c:pt idx="29">
                  <c:v>F4</c:v>
                </c:pt>
                <c:pt idx="30">
                  <c:v>G3</c:v>
                </c:pt>
                <c:pt idx="31">
                  <c:v>D6</c:v>
                </c:pt>
                <c:pt idx="32">
                  <c:v>E2</c:v>
                </c:pt>
                <c:pt idx="33">
                  <c:v>D10</c:v>
                </c:pt>
                <c:pt idx="34">
                  <c:v>F8</c:v>
                </c:pt>
                <c:pt idx="35">
                  <c:v>G2</c:v>
                </c:pt>
                <c:pt idx="36">
                  <c:v>E10</c:v>
                </c:pt>
                <c:pt idx="37">
                  <c:v>B6</c:v>
                </c:pt>
                <c:pt idx="38">
                  <c:v>H3</c:v>
                </c:pt>
                <c:pt idx="39">
                  <c:v>H2</c:v>
                </c:pt>
                <c:pt idx="40">
                  <c:v>H12</c:v>
                </c:pt>
                <c:pt idx="41">
                  <c:v>G8</c:v>
                </c:pt>
                <c:pt idx="42">
                  <c:v>G5</c:v>
                </c:pt>
                <c:pt idx="43">
                  <c:v>E8</c:v>
                </c:pt>
                <c:pt idx="44">
                  <c:v>G11</c:v>
                </c:pt>
                <c:pt idx="45">
                  <c:v>E11</c:v>
                </c:pt>
                <c:pt idx="46">
                  <c:v>D12</c:v>
                </c:pt>
                <c:pt idx="47">
                  <c:v>H10</c:v>
                </c:pt>
                <c:pt idx="48">
                  <c:v>B10</c:v>
                </c:pt>
                <c:pt idx="49">
                  <c:v>A9</c:v>
                </c:pt>
                <c:pt idx="50">
                  <c:v>H1</c:v>
                </c:pt>
                <c:pt idx="51">
                  <c:v>H7</c:v>
                </c:pt>
                <c:pt idx="52">
                  <c:v>C3</c:v>
                </c:pt>
                <c:pt idx="53">
                  <c:v>F11</c:v>
                </c:pt>
                <c:pt idx="54">
                  <c:v>A8</c:v>
                </c:pt>
                <c:pt idx="55">
                  <c:v>C10</c:v>
                </c:pt>
                <c:pt idx="56">
                  <c:v>F12</c:v>
                </c:pt>
                <c:pt idx="57">
                  <c:v>D1</c:v>
                </c:pt>
                <c:pt idx="58">
                  <c:v>F9</c:v>
                </c:pt>
                <c:pt idx="59">
                  <c:v>F10</c:v>
                </c:pt>
                <c:pt idx="60">
                  <c:v>E12</c:v>
                </c:pt>
                <c:pt idx="61">
                  <c:v>B12</c:v>
                </c:pt>
                <c:pt idx="62">
                  <c:v>E1</c:v>
                </c:pt>
                <c:pt idx="63">
                  <c:v>B7</c:v>
                </c:pt>
                <c:pt idx="64">
                  <c:v>E3</c:v>
                </c:pt>
                <c:pt idx="65">
                  <c:v>C6</c:v>
                </c:pt>
                <c:pt idx="66">
                  <c:v>B1</c:v>
                </c:pt>
                <c:pt idx="67">
                  <c:v>C8</c:v>
                </c:pt>
                <c:pt idx="68">
                  <c:v>E9</c:v>
                </c:pt>
                <c:pt idx="69">
                  <c:v>A4</c:v>
                </c:pt>
                <c:pt idx="70">
                  <c:v>H8</c:v>
                </c:pt>
                <c:pt idx="71">
                  <c:v>B9</c:v>
                </c:pt>
                <c:pt idx="72">
                  <c:v>D11</c:v>
                </c:pt>
                <c:pt idx="73">
                  <c:v>A12</c:v>
                </c:pt>
                <c:pt idx="74">
                  <c:v>C11</c:v>
                </c:pt>
                <c:pt idx="75">
                  <c:v>G1</c:v>
                </c:pt>
                <c:pt idx="76">
                  <c:v>C4</c:v>
                </c:pt>
                <c:pt idx="77">
                  <c:v>G7</c:v>
                </c:pt>
                <c:pt idx="78">
                  <c:v>B3</c:v>
                </c:pt>
                <c:pt idx="79">
                  <c:v>C9</c:v>
                </c:pt>
                <c:pt idx="80">
                  <c:v>C7</c:v>
                </c:pt>
                <c:pt idx="81">
                  <c:v>C2</c:v>
                </c:pt>
                <c:pt idx="82">
                  <c:v>A5</c:v>
                </c:pt>
                <c:pt idx="83">
                  <c:v>B4</c:v>
                </c:pt>
                <c:pt idx="84">
                  <c:v>C5</c:v>
                </c:pt>
                <c:pt idx="85">
                  <c:v>A11</c:v>
                </c:pt>
                <c:pt idx="86">
                  <c:v>D9</c:v>
                </c:pt>
                <c:pt idx="87">
                  <c:v>A7</c:v>
                </c:pt>
                <c:pt idx="88">
                  <c:v>G4</c:v>
                </c:pt>
                <c:pt idx="89">
                  <c:v>C1</c:v>
                </c:pt>
                <c:pt idx="90">
                  <c:v>B11</c:v>
                </c:pt>
                <c:pt idx="91">
                  <c:v>E4</c:v>
                </c:pt>
                <c:pt idx="92">
                  <c:v>A10</c:v>
                </c:pt>
                <c:pt idx="93">
                  <c:v>B8</c:v>
                </c:pt>
                <c:pt idx="94">
                  <c:v>A1</c:v>
                </c:pt>
                <c:pt idx="95">
                  <c:v>A6</c:v>
                </c:pt>
              </c:strCache>
            </c:strRef>
          </c:xVal>
          <c:yVal>
            <c:numRef>
              <c:f>Sorbitol!$H$2:$H$97</c:f>
              <c:numCache>
                <c:formatCode>General</c:formatCode>
                <c:ptCount val="96"/>
                <c:pt idx="0">
                  <c:v>66.666666666666643</c:v>
                </c:pt>
                <c:pt idx="1">
                  <c:v>73.793103448275858</c:v>
                </c:pt>
                <c:pt idx="2">
                  <c:v>78.195488721804523</c:v>
                </c:pt>
                <c:pt idx="3">
                  <c:v>78.571428571428584</c:v>
                </c:pt>
                <c:pt idx="4">
                  <c:v>79.041916167664667</c:v>
                </c:pt>
                <c:pt idx="5">
                  <c:v>80.800000000000011</c:v>
                </c:pt>
                <c:pt idx="6">
                  <c:v>83.760683760683747</c:v>
                </c:pt>
                <c:pt idx="7">
                  <c:v>85.384615384615387</c:v>
                </c:pt>
                <c:pt idx="8">
                  <c:v>86.554621848739515</c:v>
                </c:pt>
                <c:pt idx="9">
                  <c:v>87.943262411347519</c:v>
                </c:pt>
                <c:pt idx="10">
                  <c:v>88.43537414965985</c:v>
                </c:pt>
                <c:pt idx="11">
                  <c:v>89.189189189189207</c:v>
                </c:pt>
                <c:pt idx="12">
                  <c:v>89.932885906040255</c:v>
                </c:pt>
                <c:pt idx="13">
                  <c:v>90.066225165562926</c:v>
                </c:pt>
                <c:pt idx="14">
                  <c:v>90.151515151515156</c:v>
                </c:pt>
                <c:pt idx="15">
                  <c:v>90.756302521008394</c:v>
                </c:pt>
                <c:pt idx="16">
                  <c:v>91.428571428571416</c:v>
                </c:pt>
                <c:pt idx="17">
                  <c:v>91.452991452991455</c:v>
                </c:pt>
                <c:pt idx="18">
                  <c:v>91.641791044776141</c:v>
                </c:pt>
                <c:pt idx="19">
                  <c:v>91.83673469387756</c:v>
                </c:pt>
                <c:pt idx="20">
                  <c:v>91.860465116279059</c:v>
                </c:pt>
                <c:pt idx="21">
                  <c:v>92.073170731707293</c:v>
                </c:pt>
                <c:pt idx="22">
                  <c:v>92.36641221374046</c:v>
                </c:pt>
                <c:pt idx="23">
                  <c:v>92.372881355932194</c:v>
                </c:pt>
                <c:pt idx="24">
                  <c:v>92.907801418439746</c:v>
                </c:pt>
                <c:pt idx="25">
                  <c:v>93.518518518518505</c:v>
                </c:pt>
                <c:pt idx="26">
                  <c:v>94.285714285714263</c:v>
                </c:pt>
                <c:pt idx="27">
                  <c:v>94.444444444444414</c:v>
                </c:pt>
                <c:pt idx="28">
                  <c:v>94.705882352941188</c:v>
                </c:pt>
                <c:pt idx="29">
                  <c:v>95.035460992907801</c:v>
                </c:pt>
                <c:pt idx="30">
                  <c:v>95.121951219512184</c:v>
                </c:pt>
                <c:pt idx="31">
                  <c:v>96.52173913043481</c:v>
                </c:pt>
                <c:pt idx="32">
                  <c:v>97.297297297297277</c:v>
                </c:pt>
                <c:pt idx="33">
                  <c:v>98.148148148148138</c:v>
                </c:pt>
                <c:pt idx="34">
                  <c:v>98.152424942263309</c:v>
                </c:pt>
                <c:pt idx="35">
                  <c:v>98.449612403100815</c:v>
                </c:pt>
                <c:pt idx="36">
                  <c:v>99.08256880733947</c:v>
                </c:pt>
                <c:pt idx="37">
                  <c:v>99.264705882352956</c:v>
                </c:pt>
                <c:pt idx="38">
                  <c:v>99.324324324324323</c:v>
                </c:pt>
                <c:pt idx="39">
                  <c:v>99.363057324840781</c:v>
                </c:pt>
                <c:pt idx="40">
                  <c:v>99.999999999999986</c:v>
                </c:pt>
                <c:pt idx="41">
                  <c:v>100</c:v>
                </c:pt>
                <c:pt idx="42">
                  <c:v>100.81300813008131</c:v>
                </c:pt>
                <c:pt idx="43">
                  <c:v>100.86956521739133</c:v>
                </c:pt>
                <c:pt idx="44">
                  <c:v>101.53846153846153</c:v>
                </c:pt>
                <c:pt idx="45">
                  <c:v>102.77777777777777</c:v>
                </c:pt>
                <c:pt idx="46">
                  <c:v>102.8301886792453</c:v>
                </c:pt>
                <c:pt idx="47">
                  <c:v>102.87769784172663</c:v>
                </c:pt>
                <c:pt idx="48">
                  <c:v>102.98507462686565</c:v>
                </c:pt>
                <c:pt idx="49">
                  <c:v>103.07692307692309</c:v>
                </c:pt>
                <c:pt idx="50">
                  <c:v>104.03225806451614</c:v>
                </c:pt>
                <c:pt idx="51">
                  <c:v>104.09836065573769</c:v>
                </c:pt>
                <c:pt idx="52">
                  <c:v>104.67289719626169</c:v>
                </c:pt>
                <c:pt idx="53">
                  <c:v>104.72440944881892</c:v>
                </c:pt>
                <c:pt idx="54">
                  <c:v>106.66666666666669</c:v>
                </c:pt>
                <c:pt idx="55">
                  <c:v>107.87878787878786</c:v>
                </c:pt>
                <c:pt idx="56">
                  <c:v>108.08823529411767</c:v>
                </c:pt>
                <c:pt idx="57">
                  <c:v>108.16326530612245</c:v>
                </c:pt>
                <c:pt idx="58">
                  <c:v>108.59598853868202</c:v>
                </c:pt>
                <c:pt idx="59">
                  <c:v>108.69565217391306</c:v>
                </c:pt>
                <c:pt idx="60">
                  <c:v>108.8495575221239</c:v>
                </c:pt>
                <c:pt idx="61">
                  <c:v>109.55414012738851</c:v>
                </c:pt>
                <c:pt idx="62">
                  <c:v>110.09174311926604</c:v>
                </c:pt>
                <c:pt idx="63">
                  <c:v>110.86956521739133</c:v>
                </c:pt>
                <c:pt idx="64">
                  <c:v>111.11111111111116</c:v>
                </c:pt>
                <c:pt idx="65">
                  <c:v>112.82051282051285</c:v>
                </c:pt>
                <c:pt idx="66">
                  <c:v>113.23529411764706</c:v>
                </c:pt>
                <c:pt idx="67">
                  <c:v>113.24503311258276</c:v>
                </c:pt>
                <c:pt idx="68">
                  <c:v>115.3846153846154</c:v>
                </c:pt>
                <c:pt idx="69">
                  <c:v>116.53543307086616</c:v>
                </c:pt>
                <c:pt idx="70">
                  <c:v>117.2413793103448</c:v>
                </c:pt>
                <c:pt idx="71">
                  <c:v>117.24137931034481</c:v>
                </c:pt>
                <c:pt idx="72">
                  <c:v>117.39130434782609</c:v>
                </c:pt>
                <c:pt idx="73">
                  <c:v>117.88617886178861</c:v>
                </c:pt>
                <c:pt idx="74">
                  <c:v>117.90123456790127</c:v>
                </c:pt>
                <c:pt idx="75">
                  <c:v>119.6581196581197</c:v>
                </c:pt>
                <c:pt idx="76">
                  <c:v>120.18348623853214</c:v>
                </c:pt>
                <c:pt idx="77">
                  <c:v>122.34042553191486</c:v>
                </c:pt>
                <c:pt idx="78">
                  <c:v>123.00884955752214</c:v>
                </c:pt>
                <c:pt idx="79">
                  <c:v>125.92592592592592</c:v>
                </c:pt>
                <c:pt idx="80">
                  <c:v>125.98425196850395</c:v>
                </c:pt>
                <c:pt idx="81">
                  <c:v>127.6223776223777</c:v>
                </c:pt>
                <c:pt idx="82">
                  <c:v>127.70083102493078</c:v>
                </c:pt>
                <c:pt idx="83">
                  <c:v>127.73109243697482</c:v>
                </c:pt>
                <c:pt idx="84">
                  <c:v>127.77777777777774</c:v>
                </c:pt>
                <c:pt idx="85">
                  <c:v>132.47863247863248</c:v>
                </c:pt>
                <c:pt idx="86">
                  <c:v>137.80487804878052</c:v>
                </c:pt>
                <c:pt idx="87">
                  <c:v>140</c:v>
                </c:pt>
                <c:pt idx="88">
                  <c:v>141.37931034482759</c:v>
                </c:pt>
                <c:pt idx="89">
                  <c:v>148.14814814814815</c:v>
                </c:pt>
                <c:pt idx="90">
                  <c:v>152.88461538461536</c:v>
                </c:pt>
                <c:pt idx="91">
                  <c:v>162.22222222222226</c:v>
                </c:pt>
                <c:pt idx="92">
                  <c:v>172.72727272727272</c:v>
                </c:pt>
                <c:pt idx="93">
                  <c:v>184.37500000000006</c:v>
                </c:pt>
                <c:pt idx="94">
                  <c:v>197.81420765027315</c:v>
                </c:pt>
                <c:pt idx="95">
                  <c:v>279.1666666666666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877888"/>
        <c:axId val="90878464"/>
      </c:scatterChart>
      <c:valAx>
        <c:axId val="9087788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90878464"/>
        <c:crosses val="autoZero"/>
        <c:crossBetween val="midCat"/>
      </c:valAx>
      <c:valAx>
        <c:axId val="90878464"/>
        <c:scaling>
          <c:orientation val="minMax"/>
          <c:max val="300"/>
          <c:min val="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0877888"/>
        <c:crosses val="autoZero"/>
        <c:crossBetween val="midCat"/>
        <c:majorUnit val="50"/>
      </c:valAx>
    </c:plotArea>
    <c:legend>
      <c:legendPos val="r"/>
      <c:layout>
        <c:manualLayout>
          <c:xMode val="edge"/>
          <c:yMode val="edge"/>
          <c:x val="0.25366754155730531"/>
          <c:y val="0.13262985024455978"/>
          <c:w val="0.31855468066491688"/>
          <c:h val="0.1651184056472357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20586094342109"/>
          <c:y val="5.1400554097404488E-2"/>
          <c:w val="0.71519828026451127"/>
          <c:h val="0.79478546534580985"/>
        </c:manualLayout>
      </c:layout>
      <c:scatterChart>
        <c:scatterStyle val="lineMarker"/>
        <c:varyColors val="0"/>
        <c:ser>
          <c:idx val="0"/>
          <c:order val="0"/>
          <c:tx>
            <c:strRef>
              <c:f>Ethanol!$I$1</c:f>
              <c:strCache>
                <c:ptCount val="1"/>
                <c:pt idx="0">
                  <c:v>Ethan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Ethanol!$B$2:$B$97</c:f>
              <c:strCache>
                <c:ptCount val="96"/>
                <c:pt idx="0">
                  <c:v>E7</c:v>
                </c:pt>
                <c:pt idx="1">
                  <c:v>A3</c:v>
                </c:pt>
                <c:pt idx="2">
                  <c:v>A9</c:v>
                </c:pt>
                <c:pt idx="3">
                  <c:v>H2</c:v>
                </c:pt>
                <c:pt idx="4">
                  <c:v>E9</c:v>
                </c:pt>
                <c:pt idx="5">
                  <c:v>H5</c:v>
                </c:pt>
                <c:pt idx="6">
                  <c:v>F12</c:v>
                </c:pt>
                <c:pt idx="7">
                  <c:v>D7</c:v>
                </c:pt>
                <c:pt idx="8">
                  <c:v>G12</c:v>
                </c:pt>
                <c:pt idx="9">
                  <c:v>G11</c:v>
                </c:pt>
                <c:pt idx="10">
                  <c:v>H9</c:v>
                </c:pt>
                <c:pt idx="11">
                  <c:v>C5</c:v>
                </c:pt>
                <c:pt idx="12">
                  <c:v>H8</c:v>
                </c:pt>
                <c:pt idx="13">
                  <c:v>F11</c:v>
                </c:pt>
                <c:pt idx="14">
                  <c:v>A5</c:v>
                </c:pt>
                <c:pt idx="15">
                  <c:v>B10</c:v>
                </c:pt>
                <c:pt idx="16">
                  <c:v>C6</c:v>
                </c:pt>
                <c:pt idx="17">
                  <c:v>F8</c:v>
                </c:pt>
                <c:pt idx="18">
                  <c:v>G8</c:v>
                </c:pt>
                <c:pt idx="19">
                  <c:v>B8</c:v>
                </c:pt>
                <c:pt idx="20">
                  <c:v>F4</c:v>
                </c:pt>
                <c:pt idx="21">
                  <c:v>A11</c:v>
                </c:pt>
                <c:pt idx="22">
                  <c:v>G1</c:v>
                </c:pt>
                <c:pt idx="23">
                  <c:v>H3</c:v>
                </c:pt>
                <c:pt idx="24">
                  <c:v>F10</c:v>
                </c:pt>
                <c:pt idx="25">
                  <c:v>F2</c:v>
                </c:pt>
                <c:pt idx="26">
                  <c:v>C8</c:v>
                </c:pt>
                <c:pt idx="27">
                  <c:v>G6</c:v>
                </c:pt>
                <c:pt idx="28">
                  <c:v>H6</c:v>
                </c:pt>
                <c:pt idx="29">
                  <c:v>F3</c:v>
                </c:pt>
                <c:pt idx="30">
                  <c:v>G2</c:v>
                </c:pt>
                <c:pt idx="31">
                  <c:v>H4</c:v>
                </c:pt>
                <c:pt idx="32">
                  <c:v>B11</c:v>
                </c:pt>
                <c:pt idx="33">
                  <c:v>B2</c:v>
                </c:pt>
                <c:pt idx="34">
                  <c:v>B7</c:v>
                </c:pt>
                <c:pt idx="35">
                  <c:v>G10</c:v>
                </c:pt>
                <c:pt idx="36">
                  <c:v>C9</c:v>
                </c:pt>
                <c:pt idx="37">
                  <c:v>D1</c:v>
                </c:pt>
                <c:pt idx="38">
                  <c:v>G4</c:v>
                </c:pt>
                <c:pt idx="39">
                  <c:v>G5</c:v>
                </c:pt>
                <c:pt idx="40">
                  <c:v>H7</c:v>
                </c:pt>
                <c:pt idx="41">
                  <c:v>B4</c:v>
                </c:pt>
                <c:pt idx="42">
                  <c:v>H12</c:v>
                </c:pt>
                <c:pt idx="43">
                  <c:v>A1</c:v>
                </c:pt>
                <c:pt idx="44">
                  <c:v>C11</c:v>
                </c:pt>
                <c:pt idx="45">
                  <c:v>C1</c:v>
                </c:pt>
                <c:pt idx="46">
                  <c:v>A6</c:v>
                </c:pt>
                <c:pt idx="47">
                  <c:v>A7</c:v>
                </c:pt>
                <c:pt idx="48">
                  <c:v>E11</c:v>
                </c:pt>
                <c:pt idx="49">
                  <c:v>B5</c:v>
                </c:pt>
                <c:pt idx="50">
                  <c:v>D11</c:v>
                </c:pt>
                <c:pt idx="51">
                  <c:v>F9</c:v>
                </c:pt>
                <c:pt idx="52">
                  <c:v>A4</c:v>
                </c:pt>
                <c:pt idx="53">
                  <c:v>H1</c:v>
                </c:pt>
                <c:pt idx="54">
                  <c:v>A2</c:v>
                </c:pt>
                <c:pt idx="55">
                  <c:v>H10</c:v>
                </c:pt>
                <c:pt idx="56">
                  <c:v>C10</c:v>
                </c:pt>
                <c:pt idx="57">
                  <c:v>B9</c:v>
                </c:pt>
                <c:pt idx="58">
                  <c:v>D3</c:v>
                </c:pt>
                <c:pt idx="59">
                  <c:v>G7</c:v>
                </c:pt>
                <c:pt idx="60">
                  <c:v>G3</c:v>
                </c:pt>
                <c:pt idx="61">
                  <c:v>A10</c:v>
                </c:pt>
                <c:pt idx="62">
                  <c:v>B12</c:v>
                </c:pt>
                <c:pt idx="63">
                  <c:v>E8</c:v>
                </c:pt>
                <c:pt idx="64">
                  <c:v>B6</c:v>
                </c:pt>
                <c:pt idx="65">
                  <c:v>D4</c:v>
                </c:pt>
                <c:pt idx="66">
                  <c:v>A12</c:v>
                </c:pt>
                <c:pt idx="67">
                  <c:v>G9</c:v>
                </c:pt>
                <c:pt idx="68">
                  <c:v>E2</c:v>
                </c:pt>
                <c:pt idx="69">
                  <c:v>E3</c:v>
                </c:pt>
                <c:pt idx="70">
                  <c:v>C7</c:v>
                </c:pt>
                <c:pt idx="71">
                  <c:v>E5</c:v>
                </c:pt>
                <c:pt idx="72">
                  <c:v>B3</c:v>
                </c:pt>
                <c:pt idx="73">
                  <c:v>A8</c:v>
                </c:pt>
                <c:pt idx="74">
                  <c:v>H11</c:v>
                </c:pt>
                <c:pt idx="75">
                  <c:v>D10</c:v>
                </c:pt>
                <c:pt idx="76">
                  <c:v>E10</c:v>
                </c:pt>
                <c:pt idx="77">
                  <c:v>F5</c:v>
                </c:pt>
                <c:pt idx="78">
                  <c:v>E6</c:v>
                </c:pt>
                <c:pt idx="79">
                  <c:v>B1</c:v>
                </c:pt>
                <c:pt idx="80">
                  <c:v>C3</c:v>
                </c:pt>
                <c:pt idx="81">
                  <c:v>D8</c:v>
                </c:pt>
                <c:pt idx="82">
                  <c:v>C12</c:v>
                </c:pt>
                <c:pt idx="83">
                  <c:v>E4</c:v>
                </c:pt>
                <c:pt idx="84">
                  <c:v>E12</c:v>
                </c:pt>
                <c:pt idx="85">
                  <c:v>F6</c:v>
                </c:pt>
                <c:pt idx="86">
                  <c:v>E1</c:v>
                </c:pt>
                <c:pt idx="87">
                  <c:v>D6</c:v>
                </c:pt>
                <c:pt idx="88">
                  <c:v>D9</c:v>
                </c:pt>
                <c:pt idx="89">
                  <c:v>C2</c:v>
                </c:pt>
                <c:pt idx="90">
                  <c:v>D12</c:v>
                </c:pt>
                <c:pt idx="91">
                  <c:v>D2</c:v>
                </c:pt>
                <c:pt idx="92">
                  <c:v>C4</c:v>
                </c:pt>
                <c:pt idx="93">
                  <c:v>F7</c:v>
                </c:pt>
                <c:pt idx="94">
                  <c:v>F1</c:v>
                </c:pt>
                <c:pt idx="95">
                  <c:v>D5</c:v>
                </c:pt>
              </c:strCache>
            </c:strRef>
          </c:xVal>
          <c:yVal>
            <c:numRef>
              <c:f>Ethanol!$I$2:$I$97</c:f>
              <c:numCache>
                <c:formatCode>General</c:formatCode>
                <c:ptCount val="96"/>
                <c:pt idx="0">
                  <c:v>0</c:v>
                </c:pt>
                <c:pt idx="1">
                  <c:v>0</c:v>
                </c:pt>
                <c:pt idx="2">
                  <c:v>0.7518796992481257</c:v>
                </c:pt>
                <c:pt idx="3">
                  <c:v>3.4782608695652235</c:v>
                </c:pt>
                <c:pt idx="4">
                  <c:v>4.2253521126760569</c:v>
                </c:pt>
                <c:pt idx="5">
                  <c:v>4.2857142857142856</c:v>
                </c:pt>
                <c:pt idx="6">
                  <c:v>4.4444444444444526</c:v>
                </c:pt>
                <c:pt idx="7">
                  <c:v>4.4444444444444757</c:v>
                </c:pt>
                <c:pt idx="8">
                  <c:v>4.9261083743842411</c:v>
                </c:pt>
                <c:pt idx="9">
                  <c:v>5.0561797752808992</c:v>
                </c:pt>
                <c:pt idx="10">
                  <c:v>5.3333333333333339</c:v>
                </c:pt>
                <c:pt idx="11">
                  <c:v>5.5214723926380369</c:v>
                </c:pt>
                <c:pt idx="12">
                  <c:v>5.5813953488372192</c:v>
                </c:pt>
                <c:pt idx="13">
                  <c:v>5.8479532163742602</c:v>
                </c:pt>
                <c:pt idx="14">
                  <c:v>6.2801932367149371</c:v>
                </c:pt>
                <c:pt idx="15">
                  <c:v>6.4516129032258025</c:v>
                </c:pt>
                <c:pt idx="16">
                  <c:v>6.535947712418305</c:v>
                </c:pt>
                <c:pt idx="17">
                  <c:v>6.633499170812601</c:v>
                </c:pt>
                <c:pt idx="18">
                  <c:v>6.7901234567901332</c:v>
                </c:pt>
                <c:pt idx="19">
                  <c:v>6.8493150684931559</c:v>
                </c:pt>
                <c:pt idx="20">
                  <c:v>7.1428571428571477</c:v>
                </c:pt>
                <c:pt idx="21">
                  <c:v>7.3529411764705941</c:v>
                </c:pt>
                <c:pt idx="22">
                  <c:v>7.3684210526315752</c:v>
                </c:pt>
                <c:pt idx="23">
                  <c:v>7.4468085106383075</c:v>
                </c:pt>
                <c:pt idx="24">
                  <c:v>7.6190476190476222</c:v>
                </c:pt>
                <c:pt idx="25">
                  <c:v>7.8125000000000018</c:v>
                </c:pt>
                <c:pt idx="26">
                  <c:v>7.831325301204811</c:v>
                </c:pt>
                <c:pt idx="27">
                  <c:v>7.9268292682926873</c:v>
                </c:pt>
                <c:pt idx="28">
                  <c:v>7.9754601226993902</c:v>
                </c:pt>
                <c:pt idx="29">
                  <c:v>8.108108108108107</c:v>
                </c:pt>
                <c:pt idx="30">
                  <c:v>8.2352941176470669</c:v>
                </c:pt>
                <c:pt idx="31">
                  <c:v>8.5585585585585715</c:v>
                </c:pt>
                <c:pt idx="32">
                  <c:v>8.5714285714285712</c:v>
                </c:pt>
                <c:pt idx="33">
                  <c:v>8.6206896551724128</c:v>
                </c:pt>
                <c:pt idx="34">
                  <c:v>8.6330935251798557</c:v>
                </c:pt>
                <c:pt idx="35">
                  <c:v>8.720930232558139</c:v>
                </c:pt>
                <c:pt idx="36">
                  <c:v>8.7248322147651223</c:v>
                </c:pt>
                <c:pt idx="37">
                  <c:v>8.8235294117647101</c:v>
                </c:pt>
                <c:pt idx="38">
                  <c:v>8.9887640449438226</c:v>
                </c:pt>
                <c:pt idx="39">
                  <c:v>9.0909090909090953</c:v>
                </c:pt>
                <c:pt idx="40">
                  <c:v>9.7142857142857206</c:v>
                </c:pt>
                <c:pt idx="41">
                  <c:v>9.8484848484848388</c:v>
                </c:pt>
                <c:pt idx="42">
                  <c:v>9.8591549295774428</c:v>
                </c:pt>
                <c:pt idx="43">
                  <c:v>9.975062344139662</c:v>
                </c:pt>
                <c:pt idx="44">
                  <c:v>10.144927536231863</c:v>
                </c:pt>
                <c:pt idx="45">
                  <c:v>10.389610389610393</c:v>
                </c:pt>
                <c:pt idx="46">
                  <c:v>10.400000000000006</c:v>
                </c:pt>
                <c:pt idx="47">
                  <c:v>10.606060606060584</c:v>
                </c:pt>
                <c:pt idx="48">
                  <c:v>11.111111111111132</c:v>
                </c:pt>
                <c:pt idx="49">
                  <c:v>11.184210526315786</c:v>
                </c:pt>
                <c:pt idx="50">
                  <c:v>11.475409836065616</c:v>
                </c:pt>
                <c:pt idx="51">
                  <c:v>11.752136752136732</c:v>
                </c:pt>
                <c:pt idx="52">
                  <c:v>11.827956989247303</c:v>
                </c:pt>
                <c:pt idx="53">
                  <c:v>12.142857142857153</c:v>
                </c:pt>
                <c:pt idx="54">
                  <c:v>12.337662337662328</c:v>
                </c:pt>
                <c:pt idx="55">
                  <c:v>12.380952380952378</c:v>
                </c:pt>
                <c:pt idx="56">
                  <c:v>12.5</c:v>
                </c:pt>
                <c:pt idx="57">
                  <c:v>12.666666666666657</c:v>
                </c:pt>
                <c:pt idx="58">
                  <c:v>12.6760563380282</c:v>
                </c:pt>
                <c:pt idx="59">
                  <c:v>12.82051282051283</c:v>
                </c:pt>
                <c:pt idx="60">
                  <c:v>12.871287128712869</c:v>
                </c:pt>
                <c:pt idx="61">
                  <c:v>13.986013986013981</c:v>
                </c:pt>
                <c:pt idx="62">
                  <c:v>14.655172413793114</c:v>
                </c:pt>
                <c:pt idx="63">
                  <c:v>15.476190476190455</c:v>
                </c:pt>
                <c:pt idx="64">
                  <c:v>15.873015873015865</c:v>
                </c:pt>
                <c:pt idx="65">
                  <c:v>16</c:v>
                </c:pt>
                <c:pt idx="66">
                  <c:v>16.12903225806452</c:v>
                </c:pt>
                <c:pt idx="67">
                  <c:v>16.176470588235301</c:v>
                </c:pt>
                <c:pt idx="68">
                  <c:v>16.438356164383563</c:v>
                </c:pt>
                <c:pt idx="69">
                  <c:v>16.666666666666689</c:v>
                </c:pt>
                <c:pt idx="70">
                  <c:v>16.891891891891884</c:v>
                </c:pt>
                <c:pt idx="71">
                  <c:v>16.923076923076945</c:v>
                </c:pt>
                <c:pt idx="72">
                  <c:v>17.293233082706777</c:v>
                </c:pt>
                <c:pt idx="73">
                  <c:v>18.055555555555568</c:v>
                </c:pt>
                <c:pt idx="74">
                  <c:v>18.478260869565208</c:v>
                </c:pt>
                <c:pt idx="75">
                  <c:v>19.718309859154893</c:v>
                </c:pt>
                <c:pt idx="76">
                  <c:v>20.000000000000011</c:v>
                </c:pt>
                <c:pt idx="77">
                  <c:v>21.518987341772146</c:v>
                </c:pt>
                <c:pt idx="78">
                  <c:v>22.222222222222168</c:v>
                </c:pt>
                <c:pt idx="79">
                  <c:v>22.807017543859661</c:v>
                </c:pt>
                <c:pt idx="80">
                  <c:v>23.07692307692307</c:v>
                </c:pt>
                <c:pt idx="81">
                  <c:v>23.529411764705856</c:v>
                </c:pt>
                <c:pt idx="82">
                  <c:v>23.651452282157649</c:v>
                </c:pt>
                <c:pt idx="83">
                  <c:v>24.999999999999986</c:v>
                </c:pt>
                <c:pt idx="84">
                  <c:v>26.851851851851865</c:v>
                </c:pt>
                <c:pt idx="85">
                  <c:v>28.070175438596468</c:v>
                </c:pt>
                <c:pt idx="86">
                  <c:v>28.735632183908024</c:v>
                </c:pt>
                <c:pt idx="87">
                  <c:v>31.578947368421055</c:v>
                </c:pt>
                <c:pt idx="88">
                  <c:v>32.075471698113226</c:v>
                </c:pt>
                <c:pt idx="89">
                  <c:v>33.453237410071928</c:v>
                </c:pt>
                <c:pt idx="90">
                  <c:v>35.937500000000007</c:v>
                </c:pt>
                <c:pt idx="91">
                  <c:v>36.666666666666643</c:v>
                </c:pt>
                <c:pt idx="92">
                  <c:v>38.372093023255808</c:v>
                </c:pt>
                <c:pt idx="93">
                  <c:v>41.666666666666643</c:v>
                </c:pt>
                <c:pt idx="94">
                  <c:v>68.085106382978637</c:v>
                </c:pt>
                <c:pt idx="95">
                  <c:v>68.7499999999999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880192"/>
        <c:axId val="90880768"/>
      </c:scatterChart>
      <c:valAx>
        <c:axId val="9088019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>
            <c:manualLayout>
              <c:xMode val="edge"/>
              <c:yMode val="edge"/>
              <c:x val="0.33595032248628376"/>
              <c:y val="0.89620704666138551"/>
            </c:manualLayout>
          </c:layout>
          <c:overlay val="0"/>
        </c:title>
        <c:majorTickMark val="out"/>
        <c:minorTickMark val="none"/>
        <c:tickLblPos val="nextTo"/>
        <c:crossAx val="90880768"/>
        <c:crosses val="autoZero"/>
        <c:crossBetween val="midCat"/>
      </c:valAx>
      <c:valAx>
        <c:axId val="90880768"/>
        <c:scaling>
          <c:orientation val="minMax"/>
          <c:max val="7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0880192"/>
        <c:crosses val="autoZero"/>
        <c:crossBetween val="midCat"/>
        <c:majorUnit val="10"/>
      </c:valAx>
    </c:plotArea>
    <c:legend>
      <c:legendPos val="r"/>
      <c:layout>
        <c:manualLayout>
          <c:xMode val="edge"/>
          <c:yMode val="edge"/>
          <c:x val="0.2334886734089158"/>
          <c:y val="0.52024686322647784"/>
          <c:w val="0.3403464862396624"/>
          <c:h val="9.2018450686181461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578369332147901"/>
          <c:y val="6.7077732103840312E-2"/>
          <c:w val="0.70891384690479931"/>
          <c:h val="0.75420447110814848"/>
        </c:manualLayout>
      </c:layout>
      <c:scatterChart>
        <c:scatterStyle val="lineMarker"/>
        <c:varyColors val="0"/>
        <c:ser>
          <c:idx val="0"/>
          <c:order val="0"/>
          <c:tx>
            <c:strRef>
              <c:f>Temperature!$J$1</c:f>
              <c:strCache>
                <c:ptCount val="1"/>
                <c:pt idx="0">
                  <c:v>T (35'C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Temperature!$B$2:$B$97</c:f>
              <c:strCache>
                <c:ptCount val="96"/>
                <c:pt idx="0">
                  <c:v>C9</c:v>
                </c:pt>
                <c:pt idx="1">
                  <c:v>C10</c:v>
                </c:pt>
                <c:pt idx="2">
                  <c:v>H4</c:v>
                </c:pt>
                <c:pt idx="3">
                  <c:v>F4</c:v>
                </c:pt>
                <c:pt idx="4">
                  <c:v>H8</c:v>
                </c:pt>
                <c:pt idx="5">
                  <c:v>H2</c:v>
                </c:pt>
                <c:pt idx="6">
                  <c:v>A4</c:v>
                </c:pt>
                <c:pt idx="7">
                  <c:v>B9</c:v>
                </c:pt>
                <c:pt idx="8">
                  <c:v>A2</c:v>
                </c:pt>
                <c:pt idx="9">
                  <c:v>B11</c:v>
                </c:pt>
                <c:pt idx="10">
                  <c:v>F10</c:v>
                </c:pt>
                <c:pt idx="11">
                  <c:v>F8</c:v>
                </c:pt>
                <c:pt idx="12">
                  <c:v>F11</c:v>
                </c:pt>
                <c:pt idx="13">
                  <c:v>H11</c:v>
                </c:pt>
                <c:pt idx="14">
                  <c:v>F2</c:v>
                </c:pt>
                <c:pt idx="15">
                  <c:v>G1</c:v>
                </c:pt>
                <c:pt idx="16">
                  <c:v>H9</c:v>
                </c:pt>
                <c:pt idx="17">
                  <c:v>E12</c:v>
                </c:pt>
                <c:pt idx="18">
                  <c:v>F12</c:v>
                </c:pt>
                <c:pt idx="19">
                  <c:v>G3</c:v>
                </c:pt>
                <c:pt idx="20">
                  <c:v>B8</c:v>
                </c:pt>
                <c:pt idx="21">
                  <c:v>G4</c:v>
                </c:pt>
                <c:pt idx="22">
                  <c:v>G5</c:v>
                </c:pt>
                <c:pt idx="23">
                  <c:v>H7</c:v>
                </c:pt>
                <c:pt idx="24">
                  <c:v>B2</c:v>
                </c:pt>
                <c:pt idx="25">
                  <c:v>H5</c:v>
                </c:pt>
                <c:pt idx="26">
                  <c:v>H3</c:v>
                </c:pt>
                <c:pt idx="27">
                  <c:v>B4</c:v>
                </c:pt>
                <c:pt idx="28">
                  <c:v>B5</c:v>
                </c:pt>
                <c:pt idx="29">
                  <c:v>G12</c:v>
                </c:pt>
                <c:pt idx="30">
                  <c:v>G11</c:v>
                </c:pt>
                <c:pt idx="31">
                  <c:v>F9</c:v>
                </c:pt>
                <c:pt idx="32">
                  <c:v>G2</c:v>
                </c:pt>
                <c:pt idx="33">
                  <c:v>H10</c:v>
                </c:pt>
                <c:pt idx="34">
                  <c:v>B3</c:v>
                </c:pt>
                <c:pt idx="35">
                  <c:v>A5</c:v>
                </c:pt>
                <c:pt idx="36">
                  <c:v>G7</c:v>
                </c:pt>
                <c:pt idx="37">
                  <c:v>H6</c:v>
                </c:pt>
                <c:pt idx="38">
                  <c:v>A10</c:v>
                </c:pt>
                <c:pt idx="39">
                  <c:v>C1</c:v>
                </c:pt>
                <c:pt idx="40">
                  <c:v>G10</c:v>
                </c:pt>
                <c:pt idx="41">
                  <c:v>A12</c:v>
                </c:pt>
                <c:pt idx="42">
                  <c:v>A3</c:v>
                </c:pt>
                <c:pt idx="43">
                  <c:v>B6</c:v>
                </c:pt>
                <c:pt idx="44">
                  <c:v>B7</c:v>
                </c:pt>
                <c:pt idx="45">
                  <c:v>A9</c:v>
                </c:pt>
                <c:pt idx="46">
                  <c:v>G6</c:v>
                </c:pt>
                <c:pt idx="47">
                  <c:v>G8</c:v>
                </c:pt>
                <c:pt idx="48">
                  <c:v>D4</c:v>
                </c:pt>
                <c:pt idx="49">
                  <c:v>C11</c:v>
                </c:pt>
                <c:pt idx="50">
                  <c:v>H1</c:v>
                </c:pt>
                <c:pt idx="51">
                  <c:v>A1</c:v>
                </c:pt>
                <c:pt idx="52">
                  <c:v>C8</c:v>
                </c:pt>
                <c:pt idx="53">
                  <c:v>F3</c:v>
                </c:pt>
                <c:pt idx="54">
                  <c:v>D10</c:v>
                </c:pt>
                <c:pt idx="55">
                  <c:v>G9</c:v>
                </c:pt>
                <c:pt idx="56">
                  <c:v>B10</c:v>
                </c:pt>
                <c:pt idx="57">
                  <c:v>E10</c:v>
                </c:pt>
                <c:pt idx="58">
                  <c:v>C5</c:v>
                </c:pt>
                <c:pt idx="59">
                  <c:v>C12</c:v>
                </c:pt>
                <c:pt idx="60">
                  <c:v>C2</c:v>
                </c:pt>
                <c:pt idx="61">
                  <c:v>A6</c:v>
                </c:pt>
                <c:pt idx="62">
                  <c:v>A11</c:v>
                </c:pt>
                <c:pt idx="63">
                  <c:v>A8</c:v>
                </c:pt>
                <c:pt idx="64">
                  <c:v>H12</c:v>
                </c:pt>
                <c:pt idx="65">
                  <c:v>C6</c:v>
                </c:pt>
                <c:pt idx="66">
                  <c:v>B1</c:v>
                </c:pt>
                <c:pt idx="67">
                  <c:v>D1</c:v>
                </c:pt>
                <c:pt idx="68">
                  <c:v>A7</c:v>
                </c:pt>
                <c:pt idx="69">
                  <c:v>E4</c:v>
                </c:pt>
                <c:pt idx="70">
                  <c:v>B12</c:v>
                </c:pt>
                <c:pt idx="71">
                  <c:v>C7</c:v>
                </c:pt>
                <c:pt idx="72">
                  <c:v>E11</c:v>
                </c:pt>
                <c:pt idx="73">
                  <c:v>C4</c:v>
                </c:pt>
                <c:pt idx="74">
                  <c:v>E5</c:v>
                </c:pt>
                <c:pt idx="75">
                  <c:v>C3</c:v>
                </c:pt>
                <c:pt idx="76">
                  <c:v>E1</c:v>
                </c:pt>
                <c:pt idx="77">
                  <c:v>E9</c:v>
                </c:pt>
                <c:pt idx="78">
                  <c:v>E8</c:v>
                </c:pt>
                <c:pt idx="79">
                  <c:v>D2</c:v>
                </c:pt>
                <c:pt idx="80">
                  <c:v>D6</c:v>
                </c:pt>
                <c:pt idx="81">
                  <c:v>F5</c:v>
                </c:pt>
                <c:pt idx="82">
                  <c:v>D8</c:v>
                </c:pt>
                <c:pt idx="83">
                  <c:v>E3</c:v>
                </c:pt>
                <c:pt idx="84">
                  <c:v>D3</c:v>
                </c:pt>
                <c:pt idx="85">
                  <c:v>D12</c:v>
                </c:pt>
                <c:pt idx="86">
                  <c:v>D7</c:v>
                </c:pt>
                <c:pt idx="87">
                  <c:v>D9</c:v>
                </c:pt>
                <c:pt idx="88">
                  <c:v>D11</c:v>
                </c:pt>
                <c:pt idx="89">
                  <c:v>E2</c:v>
                </c:pt>
                <c:pt idx="90">
                  <c:v>E7</c:v>
                </c:pt>
                <c:pt idx="91">
                  <c:v>E6</c:v>
                </c:pt>
                <c:pt idx="92">
                  <c:v>F7</c:v>
                </c:pt>
                <c:pt idx="93">
                  <c:v>F6</c:v>
                </c:pt>
                <c:pt idx="94">
                  <c:v>F1</c:v>
                </c:pt>
                <c:pt idx="95">
                  <c:v>D5</c:v>
                </c:pt>
              </c:strCache>
            </c:strRef>
          </c:xVal>
          <c:yVal>
            <c:numRef>
              <c:f>Temperature!$J$2:$J$97</c:f>
              <c:numCache>
                <c:formatCode>General</c:formatCode>
                <c:ptCount val="96"/>
                <c:pt idx="0">
                  <c:v>57.046979865771789</c:v>
                </c:pt>
                <c:pt idx="1">
                  <c:v>57.638888888888893</c:v>
                </c:pt>
                <c:pt idx="2">
                  <c:v>68.468468468468473</c:v>
                </c:pt>
                <c:pt idx="3">
                  <c:v>71.008403361344534</c:v>
                </c:pt>
                <c:pt idx="4">
                  <c:v>71.162790697674424</c:v>
                </c:pt>
                <c:pt idx="5">
                  <c:v>76.08695652173914</c:v>
                </c:pt>
                <c:pt idx="6">
                  <c:v>76.881720430107521</c:v>
                </c:pt>
                <c:pt idx="7">
                  <c:v>81.333333333333343</c:v>
                </c:pt>
                <c:pt idx="8">
                  <c:v>83.766233766233768</c:v>
                </c:pt>
                <c:pt idx="9">
                  <c:v>84.571428571428569</c:v>
                </c:pt>
                <c:pt idx="10">
                  <c:v>89.523809523809518</c:v>
                </c:pt>
                <c:pt idx="11">
                  <c:v>89.88391376451078</c:v>
                </c:pt>
                <c:pt idx="12">
                  <c:v>90.643274853801188</c:v>
                </c:pt>
                <c:pt idx="13">
                  <c:v>90.760869565217376</c:v>
                </c:pt>
                <c:pt idx="14">
                  <c:v>91.666666666666686</c:v>
                </c:pt>
                <c:pt idx="15">
                  <c:v>92.10526315789474</c:v>
                </c:pt>
                <c:pt idx="16">
                  <c:v>92.444444444444457</c:v>
                </c:pt>
                <c:pt idx="17">
                  <c:v>92.592592592592581</c:v>
                </c:pt>
                <c:pt idx="18">
                  <c:v>93.8888888888889</c:v>
                </c:pt>
                <c:pt idx="19">
                  <c:v>95.544554455445564</c:v>
                </c:pt>
                <c:pt idx="20">
                  <c:v>96.575342465753451</c:v>
                </c:pt>
                <c:pt idx="21">
                  <c:v>97.191011235955045</c:v>
                </c:pt>
                <c:pt idx="22">
                  <c:v>97.72727272727272</c:v>
                </c:pt>
                <c:pt idx="23">
                  <c:v>99.428571428571402</c:v>
                </c:pt>
                <c:pt idx="24">
                  <c:v>99.999999999999986</c:v>
                </c:pt>
                <c:pt idx="25">
                  <c:v>100.4761904761905</c:v>
                </c:pt>
                <c:pt idx="26">
                  <c:v>100.53191489361701</c:v>
                </c:pt>
                <c:pt idx="27">
                  <c:v>100.75757575757575</c:v>
                </c:pt>
                <c:pt idx="28">
                  <c:v>102.63157894736842</c:v>
                </c:pt>
                <c:pt idx="29">
                  <c:v>102.95566502463053</c:v>
                </c:pt>
                <c:pt idx="30">
                  <c:v>104.49438202247192</c:v>
                </c:pt>
                <c:pt idx="31">
                  <c:v>105.55555555555559</c:v>
                </c:pt>
                <c:pt idx="32">
                  <c:v>108.8235294117647</c:v>
                </c:pt>
                <c:pt idx="33">
                  <c:v>109.04761904761907</c:v>
                </c:pt>
                <c:pt idx="34">
                  <c:v>109.77443609022555</c:v>
                </c:pt>
                <c:pt idx="35">
                  <c:v>110.38647342995166</c:v>
                </c:pt>
                <c:pt idx="36">
                  <c:v>110.8974358974359</c:v>
                </c:pt>
                <c:pt idx="37">
                  <c:v>111.04294478527608</c:v>
                </c:pt>
                <c:pt idx="38">
                  <c:v>111.18881118881121</c:v>
                </c:pt>
                <c:pt idx="39">
                  <c:v>111.68831168831169</c:v>
                </c:pt>
                <c:pt idx="40">
                  <c:v>114.53488372093021</c:v>
                </c:pt>
                <c:pt idx="41">
                  <c:v>114.83870967741936</c:v>
                </c:pt>
                <c:pt idx="42">
                  <c:v>115.47619047619051</c:v>
                </c:pt>
                <c:pt idx="43">
                  <c:v>115.87301587301585</c:v>
                </c:pt>
                <c:pt idx="44">
                  <c:v>117.98561151079139</c:v>
                </c:pt>
                <c:pt idx="45">
                  <c:v>118.04511278195488</c:v>
                </c:pt>
                <c:pt idx="46">
                  <c:v>121.95121951219514</c:v>
                </c:pt>
                <c:pt idx="47">
                  <c:v>123.45679012345681</c:v>
                </c:pt>
                <c:pt idx="48">
                  <c:v>125.33333333333331</c:v>
                </c:pt>
                <c:pt idx="49">
                  <c:v>125.36231884057972</c:v>
                </c:pt>
                <c:pt idx="50">
                  <c:v>126.4285714285714</c:v>
                </c:pt>
                <c:pt idx="51">
                  <c:v>131.67082294264341</c:v>
                </c:pt>
                <c:pt idx="52">
                  <c:v>134.3373493975904</c:v>
                </c:pt>
                <c:pt idx="53">
                  <c:v>136.48648648648648</c:v>
                </c:pt>
                <c:pt idx="54">
                  <c:v>136.61971830985922</c:v>
                </c:pt>
                <c:pt idx="55">
                  <c:v>136.76470588235296</c:v>
                </c:pt>
                <c:pt idx="56">
                  <c:v>137.09677419354841</c:v>
                </c:pt>
                <c:pt idx="57">
                  <c:v>138.46153846153842</c:v>
                </c:pt>
                <c:pt idx="58">
                  <c:v>139.87730061349691</c:v>
                </c:pt>
                <c:pt idx="59">
                  <c:v>140.66390041493773</c:v>
                </c:pt>
                <c:pt idx="60">
                  <c:v>142.44604316546764</c:v>
                </c:pt>
                <c:pt idx="61">
                  <c:v>144.00000000000003</c:v>
                </c:pt>
                <c:pt idx="62">
                  <c:v>146.32352941176475</c:v>
                </c:pt>
                <c:pt idx="63">
                  <c:v>146.5277777777778</c:v>
                </c:pt>
                <c:pt idx="64">
                  <c:v>147.18309859154928</c:v>
                </c:pt>
                <c:pt idx="65">
                  <c:v>147.71241830065361</c:v>
                </c:pt>
                <c:pt idx="66">
                  <c:v>152.63157894736844</c:v>
                </c:pt>
                <c:pt idx="67">
                  <c:v>152.94117647058832</c:v>
                </c:pt>
                <c:pt idx="68">
                  <c:v>155.30303030303031</c:v>
                </c:pt>
                <c:pt idx="69">
                  <c:v>156.57894736842104</c:v>
                </c:pt>
                <c:pt idx="70">
                  <c:v>158.62068965517238</c:v>
                </c:pt>
                <c:pt idx="71">
                  <c:v>158.78378378378375</c:v>
                </c:pt>
                <c:pt idx="72">
                  <c:v>170.83333333333331</c:v>
                </c:pt>
                <c:pt idx="73">
                  <c:v>172.09302325581393</c:v>
                </c:pt>
                <c:pt idx="74">
                  <c:v>172.30769230769235</c:v>
                </c:pt>
                <c:pt idx="75">
                  <c:v>173.62637362637358</c:v>
                </c:pt>
                <c:pt idx="76">
                  <c:v>174.71264367816087</c:v>
                </c:pt>
                <c:pt idx="77">
                  <c:v>176.05633802816905</c:v>
                </c:pt>
                <c:pt idx="78">
                  <c:v>176.19047619047612</c:v>
                </c:pt>
                <c:pt idx="79">
                  <c:v>178.33333333333329</c:v>
                </c:pt>
                <c:pt idx="80">
                  <c:v>184.21052631578948</c:v>
                </c:pt>
                <c:pt idx="81">
                  <c:v>188.60759493670886</c:v>
                </c:pt>
                <c:pt idx="82">
                  <c:v>197.05882352941174</c:v>
                </c:pt>
                <c:pt idx="83">
                  <c:v>210.71428571428578</c:v>
                </c:pt>
                <c:pt idx="84">
                  <c:v>211.26760563380284</c:v>
                </c:pt>
                <c:pt idx="85">
                  <c:v>235.93749999999986</c:v>
                </c:pt>
                <c:pt idx="86">
                  <c:v>237.77777777777774</c:v>
                </c:pt>
                <c:pt idx="87">
                  <c:v>245.28301886792448</c:v>
                </c:pt>
                <c:pt idx="88">
                  <c:v>250.81967213114746</c:v>
                </c:pt>
                <c:pt idx="89">
                  <c:v>252.05479452054803</c:v>
                </c:pt>
                <c:pt idx="90">
                  <c:v>254.68750000000009</c:v>
                </c:pt>
                <c:pt idx="91">
                  <c:v>265.079365079365</c:v>
                </c:pt>
                <c:pt idx="92">
                  <c:v>276.11111111111109</c:v>
                </c:pt>
                <c:pt idx="93">
                  <c:v>290.64327485380113</c:v>
                </c:pt>
                <c:pt idx="94">
                  <c:v>317.02127659574455</c:v>
                </c:pt>
                <c:pt idx="95">
                  <c:v>368.7500000000000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881344"/>
        <c:axId val="183525376"/>
      </c:scatterChart>
      <c:valAx>
        <c:axId val="9088134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>
            <c:manualLayout>
              <c:xMode val="edge"/>
              <c:yMode val="edge"/>
              <c:x val="0.34793499050249815"/>
              <c:y val="0.86851646113394809"/>
            </c:manualLayout>
          </c:layout>
          <c:overlay val="0"/>
        </c:title>
        <c:majorTickMark val="out"/>
        <c:minorTickMark val="none"/>
        <c:tickLblPos val="nextTo"/>
        <c:crossAx val="183525376"/>
        <c:crosses val="autoZero"/>
        <c:crossBetween val="midCat"/>
      </c:valAx>
      <c:valAx>
        <c:axId val="183525376"/>
        <c:scaling>
          <c:orientation val="minMax"/>
          <c:max val="4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0881344"/>
        <c:crosses val="autoZero"/>
        <c:crossBetween val="midCat"/>
        <c:majorUnit val="100"/>
      </c:valAx>
    </c:plotArea>
    <c:legend>
      <c:legendPos val="r"/>
      <c:layout>
        <c:manualLayout>
          <c:xMode val="edge"/>
          <c:yMode val="edge"/>
          <c:x val="0.64256586738928601"/>
          <c:y val="0.65721529600466622"/>
          <c:w val="0.33521219288950421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538299104253946"/>
          <c:y val="8.0423678404532961E-2"/>
          <c:w val="0.7210572698477572"/>
          <c:h val="0.80359657834374443"/>
        </c:manualLayout>
      </c:layout>
      <c:scatterChart>
        <c:scatterStyle val="lineMarker"/>
        <c:varyColors val="0"/>
        <c:ser>
          <c:idx val="0"/>
          <c:order val="0"/>
          <c:tx>
            <c:strRef>
              <c:f>'AcetiC acid'!$C$1</c:f>
              <c:strCache>
                <c:ptCount val="1"/>
                <c:pt idx="0">
                  <c:v>Acetic acid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AcetiC acid'!$B$2:$B$97</c:f>
              <c:strCache>
                <c:ptCount val="96"/>
                <c:pt idx="0">
                  <c:v>H8</c:v>
                </c:pt>
                <c:pt idx="1">
                  <c:v>A10</c:v>
                </c:pt>
                <c:pt idx="2">
                  <c:v>G4</c:v>
                </c:pt>
                <c:pt idx="3">
                  <c:v>F2</c:v>
                </c:pt>
                <c:pt idx="4">
                  <c:v>G11</c:v>
                </c:pt>
                <c:pt idx="5">
                  <c:v>F12</c:v>
                </c:pt>
                <c:pt idx="6">
                  <c:v>D5</c:v>
                </c:pt>
                <c:pt idx="7">
                  <c:v>G3</c:v>
                </c:pt>
                <c:pt idx="8">
                  <c:v>A3</c:v>
                </c:pt>
                <c:pt idx="9">
                  <c:v>C8</c:v>
                </c:pt>
                <c:pt idx="10">
                  <c:v>F6</c:v>
                </c:pt>
                <c:pt idx="11">
                  <c:v>H4</c:v>
                </c:pt>
                <c:pt idx="12">
                  <c:v>H3</c:v>
                </c:pt>
                <c:pt idx="13">
                  <c:v>H5</c:v>
                </c:pt>
                <c:pt idx="14">
                  <c:v>H9</c:v>
                </c:pt>
                <c:pt idx="15">
                  <c:v>D3</c:v>
                </c:pt>
                <c:pt idx="16">
                  <c:v>A1</c:v>
                </c:pt>
                <c:pt idx="17">
                  <c:v>D9</c:v>
                </c:pt>
                <c:pt idx="18">
                  <c:v>G5</c:v>
                </c:pt>
                <c:pt idx="19">
                  <c:v>F7</c:v>
                </c:pt>
                <c:pt idx="20">
                  <c:v>H7</c:v>
                </c:pt>
                <c:pt idx="21">
                  <c:v>G8</c:v>
                </c:pt>
                <c:pt idx="22">
                  <c:v>E6</c:v>
                </c:pt>
                <c:pt idx="23">
                  <c:v>E3</c:v>
                </c:pt>
                <c:pt idx="24">
                  <c:v>C12</c:v>
                </c:pt>
                <c:pt idx="25">
                  <c:v>B8</c:v>
                </c:pt>
                <c:pt idx="26">
                  <c:v>E4</c:v>
                </c:pt>
                <c:pt idx="27">
                  <c:v>F4</c:v>
                </c:pt>
                <c:pt idx="28">
                  <c:v>H2</c:v>
                </c:pt>
                <c:pt idx="29">
                  <c:v>A8</c:v>
                </c:pt>
                <c:pt idx="30">
                  <c:v>E12</c:v>
                </c:pt>
                <c:pt idx="31">
                  <c:v>H6</c:v>
                </c:pt>
                <c:pt idx="32">
                  <c:v>H11</c:v>
                </c:pt>
                <c:pt idx="33">
                  <c:v>F11</c:v>
                </c:pt>
                <c:pt idx="34">
                  <c:v>G9</c:v>
                </c:pt>
                <c:pt idx="35">
                  <c:v>F5</c:v>
                </c:pt>
                <c:pt idx="36">
                  <c:v>A11</c:v>
                </c:pt>
                <c:pt idx="37">
                  <c:v>E9</c:v>
                </c:pt>
                <c:pt idx="38">
                  <c:v>F8</c:v>
                </c:pt>
                <c:pt idx="39">
                  <c:v>A7</c:v>
                </c:pt>
                <c:pt idx="40">
                  <c:v>A12</c:v>
                </c:pt>
                <c:pt idx="41">
                  <c:v>D2</c:v>
                </c:pt>
                <c:pt idx="42">
                  <c:v>C10</c:v>
                </c:pt>
                <c:pt idx="43">
                  <c:v>C3</c:v>
                </c:pt>
                <c:pt idx="44">
                  <c:v>D11</c:v>
                </c:pt>
                <c:pt idx="45">
                  <c:v>D6</c:v>
                </c:pt>
                <c:pt idx="46">
                  <c:v>D10</c:v>
                </c:pt>
                <c:pt idx="47">
                  <c:v>B12</c:v>
                </c:pt>
                <c:pt idx="48">
                  <c:v>D8</c:v>
                </c:pt>
                <c:pt idx="49">
                  <c:v>H12</c:v>
                </c:pt>
                <c:pt idx="50">
                  <c:v>E5</c:v>
                </c:pt>
                <c:pt idx="51">
                  <c:v>G10</c:v>
                </c:pt>
                <c:pt idx="52">
                  <c:v>C11</c:v>
                </c:pt>
                <c:pt idx="53">
                  <c:v>B2</c:v>
                </c:pt>
                <c:pt idx="54">
                  <c:v>G12</c:v>
                </c:pt>
                <c:pt idx="55">
                  <c:v>E8</c:v>
                </c:pt>
                <c:pt idx="56">
                  <c:v>D1</c:v>
                </c:pt>
                <c:pt idx="57">
                  <c:v>E1</c:v>
                </c:pt>
                <c:pt idx="58">
                  <c:v>G7</c:v>
                </c:pt>
                <c:pt idx="59">
                  <c:v>A6</c:v>
                </c:pt>
                <c:pt idx="60">
                  <c:v>G2</c:v>
                </c:pt>
                <c:pt idx="61">
                  <c:v>A2</c:v>
                </c:pt>
                <c:pt idx="62">
                  <c:v>B6</c:v>
                </c:pt>
                <c:pt idx="63">
                  <c:v>G6</c:v>
                </c:pt>
                <c:pt idx="64">
                  <c:v>H10</c:v>
                </c:pt>
                <c:pt idx="65">
                  <c:v>A9</c:v>
                </c:pt>
                <c:pt idx="66">
                  <c:v>F1</c:v>
                </c:pt>
                <c:pt idx="67">
                  <c:v>F9</c:v>
                </c:pt>
                <c:pt idx="68">
                  <c:v>F3</c:v>
                </c:pt>
                <c:pt idx="69">
                  <c:v>C4</c:v>
                </c:pt>
                <c:pt idx="70">
                  <c:v>E10</c:v>
                </c:pt>
                <c:pt idx="71">
                  <c:v>H1</c:v>
                </c:pt>
                <c:pt idx="72">
                  <c:v>B10</c:v>
                </c:pt>
                <c:pt idx="73">
                  <c:v>C9</c:v>
                </c:pt>
                <c:pt idx="74">
                  <c:v>E7</c:v>
                </c:pt>
                <c:pt idx="75">
                  <c:v>B4</c:v>
                </c:pt>
                <c:pt idx="76">
                  <c:v>E11</c:v>
                </c:pt>
                <c:pt idx="77">
                  <c:v>D7</c:v>
                </c:pt>
                <c:pt idx="78">
                  <c:v>C1</c:v>
                </c:pt>
                <c:pt idx="79">
                  <c:v>B11</c:v>
                </c:pt>
                <c:pt idx="80">
                  <c:v>B5</c:v>
                </c:pt>
                <c:pt idx="81">
                  <c:v>A4</c:v>
                </c:pt>
                <c:pt idx="82">
                  <c:v>F10</c:v>
                </c:pt>
                <c:pt idx="83">
                  <c:v>D4</c:v>
                </c:pt>
                <c:pt idx="84">
                  <c:v>C5</c:v>
                </c:pt>
                <c:pt idx="85">
                  <c:v>D12</c:v>
                </c:pt>
                <c:pt idx="86">
                  <c:v>B3</c:v>
                </c:pt>
                <c:pt idx="87">
                  <c:v>G1</c:v>
                </c:pt>
                <c:pt idx="88">
                  <c:v>B9</c:v>
                </c:pt>
                <c:pt idx="89">
                  <c:v>B7</c:v>
                </c:pt>
                <c:pt idx="90">
                  <c:v>E2</c:v>
                </c:pt>
                <c:pt idx="91">
                  <c:v>C2</c:v>
                </c:pt>
                <c:pt idx="92">
                  <c:v>B1</c:v>
                </c:pt>
                <c:pt idx="93">
                  <c:v>A5</c:v>
                </c:pt>
                <c:pt idx="94">
                  <c:v>C7</c:v>
                </c:pt>
                <c:pt idx="95">
                  <c:v>C6</c:v>
                </c:pt>
              </c:strCache>
            </c:strRef>
          </c:xVal>
          <c:yVal>
            <c:numRef>
              <c:f>'AcetiC acid'!$C$2:$C$97</c:f>
              <c:numCache>
                <c:formatCode>General</c:formatCode>
                <c:ptCount val="96"/>
                <c:pt idx="0">
                  <c:v>63.64</c:v>
                </c:pt>
                <c:pt idx="1">
                  <c:v>71.23</c:v>
                </c:pt>
                <c:pt idx="2">
                  <c:v>78.790000000000006</c:v>
                </c:pt>
                <c:pt idx="3">
                  <c:v>81.05</c:v>
                </c:pt>
                <c:pt idx="4">
                  <c:v>81.52</c:v>
                </c:pt>
                <c:pt idx="5">
                  <c:v>81.73</c:v>
                </c:pt>
                <c:pt idx="6">
                  <c:v>81.900000000000006</c:v>
                </c:pt>
                <c:pt idx="7">
                  <c:v>83.17</c:v>
                </c:pt>
                <c:pt idx="8">
                  <c:v>84.38</c:v>
                </c:pt>
                <c:pt idx="9">
                  <c:v>84.69</c:v>
                </c:pt>
                <c:pt idx="10">
                  <c:v>85.19</c:v>
                </c:pt>
                <c:pt idx="11">
                  <c:v>85.42</c:v>
                </c:pt>
                <c:pt idx="12">
                  <c:v>85.83</c:v>
                </c:pt>
                <c:pt idx="13">
                  <c:v>86.96</c:v>
                </c:pt>
                <c:pt idx="14">
                  <c:v>87.1</c:v>
                </c:pt>
                <c:pt idx="15">
                  <c:v>87.63</c:v>
                </c:pt>
                <c:pt idx="16">
                  <c:v>88.06</c:v>
                </c:pt>
                <c:pt idx="17">
                  <c:v>88.1</c:v>
                </c:pt>
                <c:pt idx="18">
                  <c:v>88.42</c:v>
                </c:pt>
                <c:pt idx="19">
                  <c:v>88.51</c:v>
                </c:pt>
                <c:pt idx="20">
                  <c:v>88.64</c:v>
                </c:pt>
                <c:pt idx="21">
                  <c:v>88.66</c:v>
                </c:pt>
                <c:pt idx="22">
                  <c:v>88.76</c:v>
                </c:pt>
                <c:pt idx="23">
                  <c:v>89.13</c:v>
                </c:pt>
                <c:pt idx="24">
                  <c:v>89.32</c:v>
                </c:pt>
                <c:pt idx="25">
                  <c:v>89.47</c:v>
                </c:pt>
                <c:pt idx="26">
                  <c:v>89.47</c:v>
                </c:pt>
                <c:pt idx="27">
                  <c:v>89.62</c:v>
                </c:pt>
                <c:pt idx="28">
                  <c:v>89.8</c:v>
                </c:pt>
                <c:pt idx="29">
                  <c:v>89.84</c:v>
                </c:pt>
                <c:pt idx="30">
                  <c:v>90</c:v>
                </c:pt>
                <c:pt idx="31">
                  <c:v>91.51</c:v>
                </c:pt>
                <c:pt idx="32">
                  <c:v>91.95</c:v>
                </c:pt>
                <c:pt idx="33">
                  <c:v>92.22</c:v>
                </c:pt>
                <c:pt idx="34">
                  <c:v>93.06</c:v>
                </c:pt>
                <c:pt idx="35">
                  <c:v>93.41</c:v>
                </c:pt>
                <c:pt idx="36">
                  <c:v>93.51</c:v>
                </c:pt>
                <c:pt idx="37">
                  <c:v>93.75</c:v>
                </c:pt>
                <c:pt idx="38">
                  <c:v>93.88</c:v>
                </c:pt>
                <c:pt idx="39">
                  <c:v>94.08</c:v>
                </c:pt>
                <c:pt idx="40">
                  <c:v>94.1</c:v>
                </c:pt>
                <c:pt idx="41">
                  <c:v>94.23</c:v>
                </c:pt>
                <c:pt idx="42">
                  <c:v>94.51</c:v>
                </c:pt>
                <c:pt idx="43">
                  <c:v>94.57</c:v>
                </c:pt>
                <c:pt idx="44">
                  <c:v>94.62</c:v>
                </c:pt>
                <c:pt idx="45">
                  <c:v>94.74</c:v>
                </c:pt>
                <c:pt idx="46">
                  <c:v>95.45</c:v>
                </c:pt>
                <c:pt idx="47">
                  <c:v>95.79</c:v>
                </c:pt>
                <c:pt idx="48">
                  <c:v>95.83</c:v>
                </c:pt>
                <c:pt idx="49">
                  <c:v>96.45</c:v>
                </c:pt>
                <c:pt idx="50">
                  <c:v>96.51</c:v>
                </c:pt>
                <c:pt idx="51">
                  <c:v>96.61</c:v>
                </c:pt>
                <c:pt idx="52">
                  <c:v>96.88</c:v>
                </c:pt>
                <c:pt idx="53">
                  <c:v>96.91</c:v>
                </c:pt>
                <c:pt idx="54">
                  <c:v>97.32</c:v>
                </c:pt>
                <c:pt idx="55">
                  <c:v>97.56</c:v>
                </c:pt>
                <c:pt idx="56">
                  <c:v>98.81</c:v>
                </c:pt>
                <c:pt idx="57">
                  <c:v>98.81</c:v>
                </c:pt>
                <c:pt idx="58">
                  <c:v>98.86</c:v>
                </c:pt>
                <c:pt idx="59">
                  <c:v>98.9</c:v>
                </c:pt>
                <c:pt idx="60">
                  <c:v>98.9</c:v>
                </c:pt>
                <c:pt idx="61">
                  <c:v>99.69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.59</c:v>
                </c:pt>
                <c:pt idx="66">
                  <c:v>101.05</c:v>
                </c:pt>
                <c:pt idx="67">
                  <c:v>101.14</c:v>
                </c:pt>
                <c:pt idx="68">
                  <c:v>101.98</c:v>
                </c:pt>
                <c:pt idx="69">
                  <c:v>102.17</c:v>
                </c:pt>
                <c:pt idx="70">
                  <c:v>102.2</c:v>
                </c:pt>
                <c:pt idx="71">
                  <c:v>102.2</c:v>
                </c:pt>
                <c:pt idx="72">
                  <c:v>102.25</c:v>
                </c:pt>
                <c:pt idx="73">
                  <c:v>103.61</c:v>
                </c:pt>
                <c:pt idx="74">
                  <c:v>103.9</c:v>
                </c:pt>
                <c:pt idx="75">
                  <c:v>104.44</c:v>
                </c:pt>
                <c:pt idx="76">
                  <c:v>104.44</c:v>
                </c:pt>
                <c:pt idx="77">
                  <c:v>104.76</c:v>
                </c:pt>
                <c:pt idx="78">
                  <c:v>105.05</c:v>
                </c:pt>
                <c:pt idx="79">
                  <c:v>105.49</c:v>
                </c:pt>
                <c:pt idx="80">
                  <c:v>105.75</c:v>
                </c:pt>
                <c:pt idx="81">
                  <c:v>105.92</c:v>
                </c:pt>
                <c:pt idx="82">
                  <c:v>106.02</c:v>
                </c:pt>
                <c:pt idx="83">
                  <c:v>106.17</c:v>
                </c:pt>
                <c:pt idx="84">
                  <c:v>106.59</c:v>
                </c:pt>
                <c:pt idx="85">
                  <c:v>106.9</c:v>
                </c:pt>
                <c:pt idx="86">
                  <c:v>107.45</c:v>
                </c:pt>
                <c:pt idx="87">
                  <c:v>107.87</c:v>
                </c:pt>
                <c:pt idx="88">
                  <c:v>108.08</c:v>
                </c:pt>
                <c:pt idx="89">
                  <c:v>108.33</c:v>
                </c:pt>
                <c:pt idx="90">
                  <c:v>108.7</c:v>
                </c:pt>
                <c:pt idx="91">
                  <c:v>110.71</c:v>
                </c:pt>
                <c:pt idx="92">
                  <c:v>113.83</c:v>
                </c:pt>
                <c:pt idx="93">
                  <c:v>115.09</c:v>
                </c:pt>
                <c:pt idx="94">
                  <c:v>115.66</c:v>
                </c:pt>
                <c:pt idx="95">
                  <c:v>119.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28832"/>
        <c:axId val="183529408"/>
      </c:scatterChart>
      <c:valAx>
        <c:axId val="18352883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83529408"/>
        <c:crosses val="autoZero"/>
        <c:crossBetween val="midCat"/>
      </c:valAx>
      <c:valAx>
        <c:axId val="183529408"/>
        <c:scaling>
          <c:orientation val="minMax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52883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3406730016007629"/>
          <c:y val="0.69055113843003668"/>
          <c:w val="0.32808487449337559"/>
          <c:h val="7.4974584388644364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35665212825814"/>
          <c:y val="5.1400554097404488E-2"/>
          <c:w val="0.72924020986915428"/>
          <c:h val="0.83261956838728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mic acid'!$D$1</c:f>
              <c:strCache>
                <c:ptCount val="1"/>
                <c:pt idx="0">
                  <c:v>Formic acid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Formic acid'!$B$2:$B$97</c:f>
              <c:strCache>
                <c:ptCount val="96"/>
                <c:pt idx="0">
                  <c:v>H8</c:v>
                </c:pt>
                <c:pt idx="1">
                  <c:v>C12</c:v>
                </c:pt>
                <c:pt idx="2">
                  <c:v>F8</c:v>
                </c:pt>
                <c:pt idx="3">
                  <c:v>H9</c:v>
                </c:pt>
                <c:pt idx="4">
                  <c:v>H12</c:v>
                </c:pt>
                <c:pt idx="5">
                  <c:v>H7</c:v>
                </c:pt>
                <c:pt idx="6">
                  <c:v>H4</c:v>
                </c:pt>
                <c:pt idx="7">
                  <c:v>H5</c:v>
                </c:pt>
                <c:pt idx="8">
                  <c:v>F4</c:v>
                </c:pt>
                <c:pt idx="9">
                  <c:v>E1</c:v>
                </c:pt>
                <c:pt idx="10">
                  <c:v>G10</c:v>
                </c:pt>
                <c:pt idx="11">
                  <c:v>D5</c:v>
                </c:pt>
                <c:pt idx="12">
                  <c:v>A12</c:v>
                </c:pt>
                <c:pt idx="13">
                  <c:v>A8</c:v>
                </c:pt>
                <c:pt idx="14">
                  <c:v>H2</c:v>
                </c:pt>
                <c:pt idx="15">
                  <c:v>E4</c:v>
                </c:pt>
                <c:pt idx="16">
                  <c:v>G8</c:v>
                </c:pt>
                <c:pt idx="17">
                  <c:v>H1</c:v>
                </c:pt>
                <c:pt idx="18">
                  <c:v>G4</c:v>
                </c:pt>
                <c:pt idx="19">
                  <c:v>D2</c:v>
                </c:pt>
                <c:pt idx="20">
                  <c:v>G12</c:v>
                </c:pt>
                <c:pt idx="21">
                  <c:v>B8</c:v>
                </c:pt>
                <c:pt idx="22">
                  <c:v>H3</c:v>
                </c:pt>
                <c:pt idx="23">
                  <c:v>A4</c:v>
                </c:pt>
                <c:pt idx="24">
                  <c:v>A2</c:v>
                </c:pt>
                <c:pt idx="25">
                  <c:v>H10</c:v>
                </c:pt>
                <c:pt idx="26">
                  <c:v>F7</c:v>
                </c:pt>
                <c:pt idx="27">
                  <c:v>H11</c:v>
                </c:pt>
                <c:pt idx="28">
                  <c:v>A11</c:v>
                </c:pt>
                <c:pt idx="29">
                  <c:v>E6</c:v>
                </c:pt>
                <c:pt idx="30">
                  <c:v>A1</c:v>
                </c:pt>
                <c:pt idx="31">
                  <c:v>A10</c:v>
                </c:pt>
                <c:pt idx="32">
                  <c:v>A3</c:v>
                </c:pt>
                <c:pt idx="33">
                  <c:v>A5</c:v>
                </c:pt>
                <c:pt idx="34">
                  <c:v>E5</c:v>
                </c:pt>
                <c:pt idx="35">
                  <c:v>A7</c:v>
                </c:pt>
                <c:pt idx="36">
                  <c:v>D3</c:v>
                </c:pt>
                <c:pt idx="37">
                  <c:v>C8</c:v>
                </c:pt>
                <c:pt idx="38">
                  <c:v>G1</c:v>
                </c:pt>
                <c:pt idx="39">
                  <c:v>E9</c:v>
                </c:pt>
                <c:pt idx="40">
                  <c:v>B12</c:v>
                </c:pt>
                <c:pt idx="41">
                  <c:v>G7</c:v>
                </c:pt>
                <c:pt idx="42">
                  <c:v>A6</c:v>
                </c:pt>
                <c:pt idx="43">
                  <c:v>D11</c:v>
                </c:pt>
                <c:pt idx="44">
                  <c:v>G5</c:v>
                </c:pt>
                <c:pt idx="45">
                  <c:v>F2</c:v>
                </c:pt>
                <c:pt idx="46">
                  <c:v>F6</c:v>
                </c:pt>
                <c:pt idx="47">
                  <c:v>E8</c:v>
                </c:pt>
                <c:pt idx="48">
                  <c:v>D9</c:v>
                </c:pt>
                <c:pt idx="49">
                  <c:v>F11</c:v>
                </c:pt>
                <c:pt idx="50">
                  <c:v>B11</c:v>
                </c:pt>
                <c:pt idx="51">
                  <c:v>C11</c:v>
                </c:pt>
                <c:pt idx="52">
                  <c:v>A9</c:v>
                </c:pt>
                <c:pt idx="53">
                  <c:v>E11</c:v>
                </c:pt>
                <c:pt idx="54">
                  <c:v>F5</c:v>
                </c:pt>
                <c:pt idx="55">
                  <c:v>D8</c:v>
                </c:pt>
                <c:pt idx="56">
                  <c:v>H6</c:v>
                </c:pt>
                <c:pt idx="57">
                  <c:v>G11</c:v>
                </c:pt>
                <c:pt idx="58">
                  <c:v>F12</c:v>
                </c:pt>
                <c:pt idx="59">
                  <c:v>D6</c:v>
                </c:pt>
                <c:pt idx="60">
                  <c:v>B5</c:v>
                </c:pt>
                <c:pt idx="61">
                  <c:v>B3</c:v>
                </c:pt>
                <c:pt idx="62">
                  <c:v>B2</c:v>
                </c:pt>
                <c:pt idx="63">
                  <c:v>F10</c:v>
                </c:pt>
                <c:pt idx="64">
                  <c:v>G9</c:v>
                </c:pt>
                <c:pt idx="65">
                  <c:v>E7</c:v>
                </c:pt>
                <c:pt idx="66">
                  <c:v>F1</c:v>
                </c:pt>
                <c:pt idx="67">
                  <c:v>E2</c:v>
                </c:pt>
                <c:pt idx="68">
                  <c:v>E3</c:v>
                </c:pt>
                <c:pt idx="69">
                  <c:v>C3</c:v>
                </c:pt>
                <c:pt idx="70">
                  <c:v>C4</c:v>
                </c:pt>
                <c:pt idx="71">
                  <c:v>E10</c:v>
                </c:pt>
                <c:pt idx="72">
                  <c:v>D12</c:v>
                </c:pt>
                <c:pt idx="73">
                  <c:v>C2</c:v>
                </c:pt>
                <c:pt idx="74">
                  <c:v>D4</c:v>
                </c:pt>
                <c:pt idx="75">
                  <c:v>F3</c:v>
                </c:pt>
                <c:pt idx="76">
                  <c:v>G6</c:v>
                </c:pt>
                <c:pt idx="77">
                  <c:v>E12</c:v>
                </c:pt>
                <c:pt idx="78">
                  <c:v>D10</c:v>
                </c:pt>
                <c:pt idx="79">
                  <c:v>D1</c:v>
                </c:pt>
                <c:pt idx="80">
                  <c:v>C10</c:v>
                </c:pt>
                <c:pt idx="81">
                  <c:v>B10</c:v>
                </c:pt>
                <c:pt idx="82">
                  <c:v>G2</c:v>
                </c:pt>
                <c:pt idx="83">
                  <c:v>C9</c:v>
                </c:pt>
                <c:pt idx="84">
                  <c:v>G3</c:v>
                </c:pt>
                <c:pt idx="85">
                  <c:v>F9</c:v>
                </c:pt>
                <c:pt idx="86">
                  <c:v>B9</c:v>
                </c:pt>
                <c:pt idx="87">
                  <c:v>D7</c:v>
                </c:pt>
                <c:pt idx="88">
                  <c:v>B6</c:v>
                </c:pt>
                <c:pt idx="89">
                  <c:v>C1</c:v>
                </c:pt>
                <c:pt idx="90">
                  <c:v>B1</c:v>
                </c:pt>
                <c:pt idx="91">
                  <c:v>B7</c:v>
                </c:pt>
                <c:pt idx="92">
                  <c:v>B4</c:v>
                </c:pt>
                <c:pt idx="93">
                  <c:v>C5</c:v>
                </c:pt>
                <c:pt idx="94">
                  <c:v>C7</c:v>
                </c:pt>
                <c:pt idx="95">
                  <c:v>C6</c:v>
                </c:pt>
              </c:strCache>
            </c:strRef>
          </c:xVal>
          <c:yVal>
            <c:numRef>
              <c:f>'Formic acid'!$D$2:$D$97</c:f>
              <c:numCache>
                <c:formatCode>General</c:formatCode>
                <c:ptCount val="96"/>
                <c:pt idx="0">
                  <c:v>69.421487603305764</c:v>
                </c:pt>
                <c:pt idx="1">
                  <c:v>73.786407766990294</c:v>
                </c:pt>
                <c:pt idx="2">
                  <c:v>74.489795918367335</c:v>
                </c:pt>
                <c:pt idx="3">
                  <c:v>75.268817204301072</c:v>
                </c:pt>
                <c:pt idx="4">
                  <c:v>75.886524822695037</c:v>
                </c:pt>
                <c:pt idx="5">
                  <c:v>76.13636363636364</c:v>
                </c:pt>
                <c:pt idx="6">
                  <c:v>78.125000000000028</c:v>
                </c:pt>
                <c:pt idx="7">
                  <c:v>78.260869565217376</c:v>
                </c:pt>
                <c:pt idx="8">
                  <c:v>78.301886792452834</c:v>
                </c:pt>
                <c:pt idx="9">
                  <c:v>78.571428571428598</c:v>
                </c:pt>
                <c:pt idx="10">
                  <c:v>78.813559322033925</c:v>
                </c:pt>
                <c:pt idx="11">
                  <c:v>80.952380952380949</c:v>
                </c:pt>
                <c:pt idx="12">
                  <c:v>81.25</c:v>
                </c:pt>
                <c:pt idx="13">
                  <c:v>81.639344262295069</c:v>
                </c:pt>
                <c:pt idx="14">
                  <c:v>82.653061224489804</c:v>
                </c:pt>
                <c:pt idx="15">
                  <c:v>83.157894736842081</c:v>
                </c:pt>
                <c:pt idx="16">
                  <c:v>83.505154639175217</c:v>
                </c:pt>
                <c:pt idx="17">
                  <c:v>83.516483516483476</c:v>
                </c:pt>
                <c:pt idx="18">
                  <c:v>83.838383838383862</c:v>
                </c:pt>
                <c:pt idx="19">
                  <c:v>85.576923076923094</c:v>
                </c:pt>
                <c:pt idx="20">
                  <c:v>85.714285714285708</c:v>
                </c:pt>
                <c:pt idx="21">
                  <c:v>86.315789473684177</c:v>
                </c:pt>
                <c:pt idx="22">
                  <c:v>86.614173228346459</c:v>
                </c:pt>
                <c:pt idx="23">
                  <c:v>86.842105263157904</c:v>
                </c:pt>
                <c:pt idx="24">
                  <c:v>86.915887850467314</c:v>
                </c:pt>
                <c:pt idx="25">
                  <c:v>87.254901960784323</c:v>
                </c:pt>
                <c:pt idx="26">
                  <c:v>87.356321839080437</c:v>
                </c:pt>
                <c:pt idx="27">
                  <c:v>87.356321839080465</c:v>
                </c:pt>
                <c:pt idx="28">
                  <c:v>87.610619469026574</c:v>
                </c:pt>
                <c:pt idx="29">
                  <c:v>87.640449438202225</c:v>
                </c:pt>
                <c:pt idx="30">
                  <c:v>87.761194029850742</c:v>
                </c:pt>
                <c:pt idx="31">
                  <c:v>88.421052631578931</c:v>
                </c:pt>
                <c:pt idx="32">
                  <c:v>89.189189189189207</c:v>
                </c:pt>
                <c:pt idx="33">
                  <c:v>89.433962264150978</c:v>
                </c:pt>
                <c:pt idx="34">
                  <c:v>89.53488372093021</c:v>
                </c:pt>
                <c:pt idx="35">
                  <c:v>89.80263157894737</c:v>
                </c:pt>
                <c:pt idx="36">
                  <c:v>90.721649484536101</c:v>
                </c:pt>
                <c:pt idx="37">
                  <c:v>90.816326530612244</c:v>
                </c:pt>
                <c:pt idx="38">
                  <c:v>91.011235955056208</c:v>
                </c:pt>
                <c:pt idx="39">
                  <c:v>91.250000000000014</c:v>
                </c:pt>
                <c:pt idx="40">
                  <c:v>91.578947368421041</c:v>
                </c:pt>
                <c:pt idx="41">
                  <c:v>92.045454545454589</c:v>
                </c:pt>
                <c:pt idx="42">
                  <c:v>92.307692307692321</c:v>
                </c:pt>
                <c:pt idx="43">
                  <c:v>92.473118279569917</c:v>
                </c:pt>
                <c:pt idx="44">
                  <c:v>92.631578947368411</c:v>
                </c:pt>
                <c:pt idx="45">
                  <c:v>93.684210526315809</c:v>
                </c:pt>
                <c:pt idx="46">
                  <c:v>93.827160493827122</c:v>
                </c:pt>
                <c:pt idx="47">
                  <c:v>93.902439024390247</c:v>
                </c:pt>
                <c:pt idx="48">
                  <c:v>94.047619047619037</c:v>
                </c:pt>
                <c:pt idx="49">
                  <c:v>94.444444444444429</c:v>
                </c:pt>
                <c:pt idx="50">
                  <c:v>94.505494505494497</c:v>
                </c:pt>
                <c:pt idx="51">
                  <c:v>94.7916666666667</c:v>
                </c:pt>
                <c:pt idx="52">
                  <c:v>94.970414201183445</c:v>
                </c:pt>
                <c:pt idx="53">
                  <c:v>95.555555555555571</c:v>
                </c:pt>
                <c:pt idx="54">
                  <c:v>95.60439560439562</c:v>
                </c:pt>
                <c:pt idx="55">
                  <c:v>95.8333333333333</c:v>
                </c:pt>
                <c:pt idx="56">
                  <c:v>96.2264150943396</c:v>
                </c:pt>
                <c:pt idx="57">
                  <c:v>96.739130434782609</c:v>
                </c:pt>
                <c:pt idx="58">
                  <c:v>97.115384615384613</c:v>
                </c:pt>
                <c:pt idx="59">
                  <c:v>98.684210526315809</c:v>
                </c:pt>
                <c:pt idx="60">
                  <c:v>98.850574712643649</c:v>
                </c:pt>
                <c:pt idx="61">
                  <c:v>98.936170212765944</c:v>
                </c:pt>
                <c:pt idx="62">
                  <c:v>98.969072164948443</c:v>
                </c:pt>
                <c:pt idx="63">
                  <c:v>99.999999999999972</c:v>
                </c:pt>
                <c:pt idx="64">
                  <c:v>100</c:v>
                </c:pt>
                <c:pt idx="65">
                  <c:v>100.00000000000003</c:v>
                </c:pt>
                <c:pt idx="66">
                  <c:v>101.05263157894737</c:v>
                </c:pt>
                <c:pt idx="67">
                  <c:v>101.08695652173911</c:v>
                </c:pt>
                <c:pt idx="68">
                  <c:v>102.17391304347825</c:v>
                </c:pt>
                <c:pt idx="69">
                  <c:v>102.17391304347825</c:v>
                </c:pt>
                <c:pt idx="70">
                  <c:v>102.17391304347827</c:v>
                </c:pt>
                <c:pt idx="71">
                  <c:v>102.19780219780222</c:v>
                </c:pt>
                <c:pt idx="72">
                  <c:v>102.29885057471266</c:v>
                </c:pt>
                <c:pt idx="73">
                  <c:v>102.38095238095238</c:v>
                </c:pt>
                <c:pt idx="74">
                  <c:v>102.4691358024692</c:v>
                </c:pt>
                <c:pt idx="75">
                  <c:v>102.97029702970298</c:v>
                </c:pt>
                <c:pt idx="76">
                  <c:v>102.98507462686564</c:v>
                </c:pt>
                <c:pt idx="77">
                  <c:v>103.33333333333334</c:v>
                </c:pt>
                <c:pt idx="78">
                  <c:v>104.54545454545456</c:v>
                </c:pt>
                <c:pt idx="79">
                  <c:v>104.76190476190477</c:v>
                </c:pt>
                <c:pt idx="80">
                  <c:v>105.49450549450552</c:v>
                </c:pt>
                <c:pt idx="81">
                  <c:v>105.6179775280899</c:v>
                </c:pt>
                <c:pt idx="82">
                  <c:v>106.59340659340661</c:v>
                </c:pt>
                <c:pt idx="83">
                  <c:v>107.22891566265058</c:v>
                </c:pt>
                <c:pt idx="84">
                  <c:v>107.92079207920789</c:v>
                </c:pt>
                <c:pt idx="85">
                  <c:v>107.95454545454544</c:v>
                </c:pt>
                <c:pt idx="86">
                  <c:v>108.08080808080808</c:v>
                </c:pt>
                <c:pt idx="87">
                  <c:v>108.33333333333334</c:v>
                </c:pt>
                <c:pt idx="88">
                  <c:v>108.97435897435899</c:v>
                </c:pt>
                <c:pt idx="89">
                  <c:v>109.09090909090908</c:v>
                </c:pt>
                <c:pt idx="90">
                  <c:v>109.57446808510637</c:v>
                </c:pt>
                <c:pt idx="91">
                  <c:v>109.72222222222223</c:v>
                </c:pt>
                <c:pt idx="92">
                  <c:v>109.99999999999997</c:v>
                </c:pt>
                <c:pt idx="93">
                  <c:v>110.98901098901102</c:v>
                </c:pt>
                <c:pt idx="94">
                  <c:v>116.86746987951808</c:v>
                </c:pt>
                <c:pt idx="95">
                  <c:v>124.193548387096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248256"/>
        <c:axId val="183529984"/>
      </c:scatterChart>
      <c:valAx>
        <c:axId val="8724825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83529984"/>
        <c:crosses val="autoZero"/>
        <c:crossBetween val="midCat"/>
      </c:valAx>
      <c:valAx>
        <c:axId val="183529984"/>
        <c:scaling>
          <c:orientation val="minMax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724825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1154441621181879"/>
          <c:y val="0.64492527694330937"/>
          <c:w val="0.48845558378818127"/>
          <c:h val="0.14180713189482297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375566227308335"/>
          <c:y val="6.5924134939960202E-2"/>
          <c:w val="0.74268459861721337"/>
          <c:h val="0.81809602308675577"/>
        </c:manualLayout>
      </c:layout>
      <c:scatterChart>
        <c:scatterStyle val="lineMarker"/>
        <c:varyColors val="0"/>
        <c:ser>
          <c:idx val="0"/>
          <c:order val="0"/>
          <c:tx>
            <c:strRef>
              <c:f>Furfural!$E$1</c:f>
              <c:strCache>
                <c:ptCount val="1"/>
                <c:pt idx="0">
                  <c:v>Furfural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Furfural!$B$2:$B$97</c:f>
              <c:strCache>
                <c:ptCount val="96"/>
                <c:pt idx="0">
                  <c:v>A5</c:v>
                </c:pt>
                <c:pt idx="1">
                  <c:v>A6</c:v>
                </c:pt>
                <c:pt idx="2">
                  <c:v>A2</c:v>
                </c:pt>
                <c:pt idx="3">
                  <c:v>A11</c:v>
                </c:pt>
                <c:pt idx="4">
                  <c:v>A12</c:v>
                </c:pt>
                <c:pt idx="5">
                  <c:v>A10</c:v>
                </c:pt>
                <c:pt idx="6">
                  <c:v>A1</c:v>
                </c:pt>
                <c:pt idx="7">
                  <c:v>A8</c:v>
                </c:pt>
                <c:pt idx="8">
                  <c:v>A9</c:v>
                </c:pt>
                <c:pt idx="9">
                  <c:v>A3</c:v>
                </c:pt>
                <c:pt idx="10">
                  <c:v>A4</c:v>
                </c:pt>
                <c:pt idx="11">
                  <c:v>B11</c:v>
                </c:pt>
                <c:pt idx="12">
                  <c:v>F11</c:v>
                </c:pt>
                <c:pt idx="13">
                  <c:v>B3</c:v>
                </c:pt>
                <c:pt idx="14">
                  <c:v>A7</c:v>
                </c:pt>
                <c:pt idx="15">
                  <c:v>C4</c:v>
                </c:pt>
                <c:pt idx="16">
                  <c:v>H5</c:v>
                </c:pt>
                <c:pt idx="17">
                  <c:v>D10</c:v>
                </c:pt>
                <c:pt idx="18">
                  <c:v>D7</c:v>
                </c:pt>
                <c:pt idx="19">
                  <c:v>D9</c:v>
                </c:pt>
                <c:pt idx="20">
                  <c:v>F6</c:v>
                </c:pt>
                <c:pt idx="21">
                  <c:v>D5</c:v>
                </c:pt>
                <c:pt idx="22">
                  <c:v>B10</c:v>
                </c:pt>
                <c:pt idx="23">
                  <c:v>F3</c:v>
                </c:pt>
                <c:pt idx="24">
                  <c:v>B5</c:v>
                </c:pt>
                <c:pt idx="25">
                  <c:v>B2</c:v>
                </c:pt>
                <c:pt idx="26">
                  <c:v>D1</c:v>
                </c:pt>
                <c:pt idx="27">
                  <c:v>F7</c:v>
                </c:pt>
                <c:pt idx="28">
                  <c:v>E12</c:v>
                </c:pt>
                <c:pt idx="29">
                  <c:v>C6</c:v>
                </c:pt>
                <c:pt idx="30">
                  <c:v>D2</c:v>
                </c:pt>
                <c:pt idx="31">
                  <c:v>B7</c:v>
                </c:pt>
                <c:pt idx="32">
                  <c:v>H8</c:v>
                </c:pt>
                <c:pt idx="33">
                  <c:v>F4</c:v>
                </c:pt>
                <c:pt idx="34">
                  <c:v>B12</c:v>
                </c:pt>
                <c:pt idx="35">
                  <c:v>E11</c:v>
                </c:pt>
                <c:pt idx="36">
                  <c:v>H10</c:v>
                </c:pt>
                <c:pt idx="37">
                  <c:v>D8</c:v>
                </c:pt>
                <c:pt idx="38">
                  <c:v>C3</c:v>
                </c:pt>
                <c:pt idx="39">
                  <c:v>D6</c:v>
                </c:pt>
                <c:pt idx="40">
                  <c:v>E9</c:v>
                </c:pt>
                <c:pt idx="41">
                  <c:v>H11</c:v>
                </c:pt>
                <c:pt idx="42">
                  <c:v>E5</c:v>
                </c:pt>
                <c:pt idx="43">
                  <c:v>F10</c:v>
                </c:pt>
                <c:pt idx="44">
                  <c:v>C12</c:v>
                </c:pt>
                <c:pt idx="45">
                  <c:v>D3</c:v>
                </c:pt>
                <c:pt idx="46">
                  <c:v>E1</c:v>
                </c:pt>
                <c:pt idx="47">
                  <c:v>E6</c:v>
                </c:pt>
                <c:pt idx="48">
                  <c:v>D11</c:v>
                </c:pt>
                <c:pt idx="49">
                  <c:v>E10</c:v>
                </c:pt>
                <c:pt idx="50">
                  <c:v>G4</c:v>
                </c:pt>
                <c:pt idx="51">
                  <c:v>F12</c:v>
                </c:pt>
                <c:pt idx="52">
                  <c:v>E8</c:v>
                </c:pt>
                <c:pt idx="53">
                  <c:v>G7</c:v>
                </c:pt>
                <c:pt idx="54">
                  <c:v>D12</c:v>
                </c:pt>
                <c:pt idx="55">
                  <c:v>E7</c:v>
                </c:pt>
                <c:pt idx="56">
                  <c:v>F5</c:v>
                </c:pt>
                <c:pt idx="57">
                  <c:v>F9</c:v>
                </c:pt>
                <c:pt idx="58">
                  <c:v>G3</c:v>
                </c:pt>
                <c:pt idx="59">
                  <c:v>C9</c:v>
                </c:pt>
                <c:pt idx="60">
                  <c:v>C8</c:v>
                </c:pt>
                <c:pt idx="61">
                  <c:v>F1</c:v>
                </c:pt>
                <c:pt idx="62">
                  <c:v>F8</c:v>
                </c:pt>
                <c:pt idx="63">
                  <c:v>E2</c:v>
                </c:pt>
                <c:pt idx="64">
                  <c:v>H1</c:v>
                </c:pt>
                <c:pt idx="65">
                  <c:v>G12</c:v>
                </c:pt>
                <c:pt idx="66">
                  <c:v>H7</c:v>
                </c:pt>
                <c:pt idx="67">
                  <c:v>C5</c:v>
                </c:pt>
                <c:pt idx="68">
                  <c:v>E4</c:v>
                </c:pt>
                <c:pt idx="69">
                  <c:v>G1</c:v>
                </c:pt>
                <c:pt idx="70">
                  <c:v>C7</c:v>
                </c:pt>
                <c:pt idx="71">
                  <c:v>B8</c:v>
                </c:pt>
                <c:pt idx="72">
                  <c:v>H3</c:v>
                </c:pt>
                <c:pt idx="73">
                  <c:v>C2</c:v>
                </c:pt>
                <c:pt idx="74">
                  <c:v>E3</c:v>
                </c:pt>
                <c:pt idx="75">
                  <c:v>H4</c:v>
                </c:pt>
                <c:pt idx="76">
                  <c:v>C1</c:v>
                </c:pt>
                <c:pt idx="77">
                  <c:v>G8</c:v>
                </c:pt>
                <c:pt idx="78">
                  <c:v>G5</c:v>
                </c:pt>
                <c:pt idx="79">
                  <c:v>H9</c:v>
                </c:pt>
                <c:pt idx="80">
                  <c:v>C10</c:v>
                </c:pt>
                <c:pt idx="81">
                  <c:v>G10</c:v>
                </c:pt>
                <c:pt idx="82">
                  <c:v>B1</c:v>
                </c:pt>
                <c:pt idx="83">
                  <c:v>G6</c:v>
                </c:pt>
                <c:pt idx="84">
                  <c:v>H12</c:v>
                </c:pt>
                <c:pt idx="85">
                  <c:v>H6</c:v>
                </c:pt>
                <c:pt idx="86">
                  <c:v>H2</c:v>
                </c:pt>
                <c:pt idx="87">
                  <c:v>G2</c:v>
                </c:pt>
                <c:pt idx="88">
                  <c:v>C11</c:v>
                </c:pt>
                <c:pt idx="89">
                  <c:v>B6</c:v>
                </c:pt>
                <c:pt idx="90">
                  <c:v>G9</c:v>
                </c:pt>
                <c:pt idx="91">
                  <c:v>D4</c:v>
                </c:pt>
                <c:pt idx="92">
                  <c:v>B9</c:v>
                </c:pt>
                <c:pt idx="93">
                  <c:v>G11</c:v>
                </c:pt>
                <c:pt idx="94">
                  <c:v>B4</c:v>
                </c:pt>
                <c:pt idx="95">
                  <c:v>F2</c:v>
                </c:pt>
              </c:strCache>
            </c:strRef>
          </c:xVal>
          <c:yVal>
            <c:numRef>
              <c:f>Furfural!$E$2:$E$97</c:f>
              <c:numCache>
                <c:formatCode>General</c:formatCode>
                <c:ptCount val="96"/>
                <c:pt idx="0">
                  <c:v>48.824593128390589</c:v>
                </c:pt>
                <c:pt idx="1">
                  <c:v>52.166666666666664</c:v>
                </c:pt>
                <c:pt idx="2">
                  <c:v>55.263157894736828</c:v>
                </c:pt>
                <c:pt idx="3">
                  <c:v>59.322033898305072</c:v>
                </c:pt>
                <c:pt idx="4">
                  <c:v>61.954887218045116</c:v>
                </c:pt>
                <c:pt idx="5">
                  <c:v>62.383900928792592</c:v>
                </c:pt>
                <c:pt idx="6">
                  <c:v>62.76083467094702</c:v>
                </c:pt>
                <c:pt idx="7">
                  <c:v>63.878326996197686</c:v>
                </c:pt>
                <c:pt idx="8">
                  <c:v>64.019448946515411</c:v>
                </c:pt>
                <c:pt idx="9">
                  <c:v>65.292096219931253</c:v>
                </c:pt>
                <c:pt idx="10">
                  <c:v>69.628099173553707</c:v>
                </c:pt>
                <c:pt idx="11">
                  <c:v>70.854271356783926</c:v>
                </c:pt>
                <c:pt idx="12">
                  <c:v>72.500000000000014</c:v>
                </c:pt>
                <c:pt idx="13">
                  <c:v>73.488372093023244</c:v>
                </c:pt>
                <c:pt idx="14">
                  <c:v>73.574144486692035</c:v>
                </c:pt>
                <c:pt idx="15">
                  <c:v>73.626373626373635</c:v>
                </c:pt>
                <c:pt idx="16">
                  <c:v>75.875486381322972</c:v>
                </c:pt>
                <c:pt idx="17">
                  <c:v>75.897435897435898</c:v>
                </c:pt>
                <c:pt idx="18">
                  <c:v>76.19047619047619</c:v>
                </c:pt>
                <c:pt idx="19">
                  <c:v>76.288659793814446</c:v>
                </c:pt>
                <c:pt idx="20">
                  <c:v>77.669902912621382</c:v>
                </c:pt>
                <c:pt idx="21">
                  <c:v>78.378378378378372</c:v>
                </c:pt>
                <c:pt idx="22">
                  <c:v>78.431372549019599</c:v>
                </c:pt>
                <c:pt idx="23">
                  <c:v>78.645833333333329</c:v>
                </c:pt>
                <c:pt idx="24">
                  <c:v>78.698224852071036</c:v>
                </c:pt>
                <c:pt idx="25">
                  <c:v>78.94736842105263</c:v>
                </c:pt>
                <c:pt idx="26">
                  <c:v>78.94736842105263</c:v>
                </c:pt>
                <c:pt idx="27">
                  <c:v>79.347826086956516</c:v>
                </c:pt>
                <c:pt idx="28">
                  <c:v>79.365079365079367</c:v>
                </c:pt>
                <c:pt idx="29">
                  <c:v>79.411764705882376</c:v>
                </c:pt>
                <c:pt idx="30">
                  <c:v>79.695431472081196</c:v>
                </c:pt>
                <c:pt idx="31">
                  <c:v>79.775280898876389</c:v>
                </c:pt>
                <c:pt idx="32">
                  <c:v>79.831932773109244</c:v>
                </c:pt>
                <c:pt idx="33">
                  <c:v>79.885057471264389</c:v>
                </c:pt>
                <c:pt idx="34">
                  <c:v>79.896907216494824</c:v>
                </c:pt>
                <c:pt idx="35">
                  <c:v>79.896907216494853</c:v>
                </c:pt>
                <c:pt idx="36">
                  <c:v>80</c:v>
                </c:pt>
                <c:pt idx="37">
                  <c:v>80.402010050251263</c:v>
                </c:pt>
                <c:pt idx="38">
                  <c:v>80.555555555555543</c:v>
                </c:pt>
                <c:pt idx="39">
                  <c:v>80.710659898477161</c:v>
                </c:pt>
                <c:pt idx="40">
                  <c:v>81.012658227848107</c:v>
                </c:pt>
                <c:pt idx="41">
                  <c:v>82.017543859649123</c:v>
                </c:pt>
                <c:pt idx="42">
                  <c:v>82.474226804123717</c:v>
                </c:pt>
                <c:pt idx="43">
                  <c:v>82.72727272727272</c:v>
                </c:pt>
                <c:pt idx="44">
                  <c:v>82.926829268292707</c:v>
                </c:pt>
                <c:pt idx="45">
                  <c:v>83.15217391304347</c:v>
                </c:pt>
                <c:pt idx="46">
                  <c:v>83.333333333333343</c:v>
                </c:pt>
                <c:pt idx="47">
                  <c:v>83.333333333333343</c:v>
                </c:pt>
                <c:pt idx="48">
                  <c:v>83.425414364640872</c:v>
                </c:pt>
                <c:pt idx="49">
                  <c:v>83.673469387755091</c:v>
                </c:pt>
                <c:pt idx="50">
                  <c:v>83.815028901734095</c:v>
                </c:pt>
                <c:pt idx="51">
                  <c:v>83.82352941176471</c:v>
                </c:pt>
                <c:pt idx="52">
                  <c:v>84.065934065934059</c:v>
                </c:pt>
                <c:pt idx="53">
                  <c:v>84.079601990049753</c:v>
                </c:pt>
                <c:pt idx="54">
                  <c:v>84.263959390862937</c:v>
                </c:pt>
                <c:pt idx="55">
                  <c:v>84.795321637426895</c:v>
                </c:pt>
                <c:pt idx="56">
                  <c:v>84.924623115577887</c:v>
                </c:pt>
                <c:pt idx="57">
                  <c:v>84.97652582159624</c:v>
                </c:pt>
                <c:pt idx="58">
                  <c:v>85.057471264367805</c:v>
                </c:pt>
                <c:pt idx="59">
                  <c:v>85.11904761904762</c:v>
                </c:pt>
                <c:pt idx="60">
                  <c:v>85.534591194968542</c:v>
                </c:pt>
                <c:pt idx="61">
                  <c:v>85.567010309278373</c:v>
                </c:pt>
                <c:pt idx="62">
                  <c:v>85.628742514970043</c:v>
                </c:pt>
                <c:pt idx="63">
                  <c:v>85.63218390804596</c:v>
                </c:pt>
                <c:pt idx="64">
                  <c:v>85.65573770491801</c:v>
                </c:pt>
                <c:pt idx="65">
                  <c:v>85.786802030456855</c:v>
                </c:pt>
                <c:pt idx="66">
                  <c:v>85.990338164251199</c:v>
                </c:pt>
                <c:pt idx="67">
                  <c:v>86.31578947368422</c:v>
                </c:pt>
                <c:pt idx="68">
                  <c:v>86.390532544378715</c:v>
                </c:pt>
                <c:pt idx="69">
                  <c:v>86.41304347826086</c:v>
                </c:pt>
                <c:pt idx="70">
                  <c:v>86.928104575163417</c:v>
                </c:pt>
                <c:pt idx="71">
                  <c:v>87.058823529411782</c:v>
                </c:pt>
                <c:pt idx="72">
                  <c:v>87.128712871287135</c:v>
                </c:pt>
                <c:pt idx="73">
                  <c:v>87.349397590361463</c:v>
                </c:pt>
                <c:pt idx="74">
                  <c:v>87.719298245614027</c:v>
                </c:pt>
                <c:pt idx="75">
                  <c:v>87.793427230046944</c:v>
                </c:pt>
                <c:pt idx="76">
                  <c:v>88.198757763975195</c:v>
                </c:pt>
                <c:pt idx="77">
                  <c:v>88.524590163934434</c:v>
                </c:pt>
                <c:pt idx="78">
                  <c:v>88.541666666666671</c:v>
                </c:pt>
                <c:pt idx="79">
                  <c:v>88.679245283018858</c:v>
                </c:pt>
                <c:pt idx="80">
                  <c:v>88.725490196078454</c:v>
                </c:pt>
                <c:pt idx="81">
                  <c:v>88.780487804878035</c:v>
                </c:pt>
                <c:pt idx="82">
                  <c:v>88.888888888888886</c:v>
                </c:pt>
                <c:pt idx="83">
                  <c:v>88.8888888888889</c:v>
                </c:pt>
                <c:pt idx="84">
                  <c:v>88.990825688073372</c:v>
                </c:pt>
                <c:pt idx="85">
                  <c:v>89.035087719298261</c:v>
                </c:pt>
                <c:pt idx="86">
                  <c:v>89.041095890410958</c:v>
                </c:pt>
                <c:pt idx="87">
                  <c:v>89.393939393939377</c:v>
                </c:pt>
                <c:pt idx="88">
                  <c:v>90.15544041450778</c:v>
                </c:pt>
                <c:pt idx="89">
                  <c:v>91.534391534391517</c:v>
                </c:pt>
                <c:pt idx="90">
                  <c:v>92.168674698795158</c:v>
                </c:pt>
                <c:pt idx="91">
                  <c:v>92.72727272727272</c:v>
                </c:pt>
                <c:pt idx="92">
                  <c:v>93.604651162790702</c:v>
                </c:pt>
                <c:pt idx="93">
                  <c:v>94.623655913978482</c:v>
                </c:pt>
                <c:pt idx="94">
                  <c:v>96.808510638297847</c:v>
                </c:pt>
                <c:pt idx="95">
                  <c:v>100.628930817610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31136"/>
        <c:axId val="90875584"/>
      </c:scatterChart>
      <c:valAx>
        <c:axId val="18353113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90875584"/>
        <c:crosses val="autoZero"/>
        <c:crossBetween val="midCat"/>
      </c:valAx>
      <c:valAx>
        <c:axId val="90875584"/>
        <c:scaling>
          <c:orientation val="minMax"/>
          <c:max val="12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531136"/>
        <c:crosses val="autoZero"/>
        <c:crossBetween val="midCat"/>
        <c:majorUnit val="20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76754073131912"/>
          <c:y val="7.785593267414731E-2"/>
          <c:w val="0.68434633128256661"/>
          <c:h val="0.80616424563937339"/>
        </c:manualLayout>
      </c:layout>
      <c:scatterChart>
        <c:scatterStyle val="lineMarker"/>
        <c:varyColors val="0"/>
        <c:ser>
          <c:idx val="0"/>
          <c:order val="0"/>
          <c:tx>
            <c:strRef>
              <c:f>HMF!$F$1</c:f>
              <c:strCache>
                <c:ptCount val="1"/>
                <c:pt idx="0">
                  <c:v>HMF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HMF!$B$2:$B$97</c:f>
              <c:strCache>
                <c:ptCount val="96"/>
                <c:pt idx="0">
                  <c:v>G5</c:v>
                </c:pt>
                <c:pt idx="1">
                  <c:v>F5</c:v>
                </c:pt>
                <c:pt idx="2">
                  <c:v>D5</c:v>
                </c:pt>
                <c:pt idx="3">
                  <c:v>B11</c:v>
                </c:pt>
                <c:pt idx="4">
                  <c:v>A10</c:v>
                </c:pt>
                <c:pt idx="5">
                  <c:v>C8</c:v>
                </c:pt>
                <c:pt idx="6">
                  <c:v>F1</c:v>
                </c:pt>
                <c:pt idx="7">
                  <c:v>H6</c:v>
                </c:pt>
                <c:pt idx="8">
                  <c:v>D9</c:v>
                </c:pt>
                <c:pt idx="9">
                  <c:v>B10</c:v>
                </c:pt>
                <c:pt idx="10">
                  <c:v>C5</c:v>
                </c:pt>
                <c:pt idx="11">
                  <c:v>D6</c:v>
                </c:pt>
                <c:pt idx="12">
                  <c:v>H8</c:v>
                </c:pt>
                <c:pt idx="13">
                  <c:v>H10</c:v>
                </c:pt>
                <c:pt idx="14">
                  <c:v>D10</c:v>
                </c:pt>
                <c:pt idx="15">
                  <c:v>H5</c:v>
                </c:pt>
                <c:pt idx="16">
                  <c:v>A12</c:v>
                </c:pt>
                <c:pt idx="17">
                  <c:v>H1</c:v>
                </c:pt>
                <c:pt idx="18">
                  <c:v>E5</c:v>
                </c:pt>
                <c:pt idx="19">
                  <c:v>C12</c:v>
                </c:pt>
                <c:pt idx="20">
                  <c:v>B3</c:v>
                </c:pt>
                <c:pt idx="21">
                  <c:v>D7</c:v>
                </c:pt>
                <c:pt idx="22">
                  <c:v>H3</c:v>
                </c:pt>
                <c:pt idx="23">
                  <c:v>D8</c:v>
                </c:pt>
                <c:pt idx="24">
                  <c:v>F6</c:v>
                </c:pt>
                <c:pt idx="25">
                  <c:v>D3</c:v>
                </c:pt>
                <c:pt idx="26">
                  <c:v>D1</c:v>
                </c:pt>
                <c:pt idx="27">
                  <c:v>B5</c:v>
                </c:pt>
                <c:pt idx="28">
                  <c:v>A5</c:v>
                </c:pt>
                <c:pt idx="29">
                  <c:v>H4</c:v>
                </c:pt>
                <c:pt idx="30">
                  <c:v>B1</c:v>
                </c:pt>
                <c:pt idx="31">
                  <c:v>F3</c:v>
                </c:pt>
                <c:pt idx="32">
                  <c:v>B6</c:v>
                </c:pt>
                <c:pt idx="33">
                  <c:v>F11</c:v>
                </c:pt>
                <c:pt idx="34">
                  <c:v>A6</c:v>
                </c:pt>
                <c:pt idx="35">
                  <c:v>A2</c:v>
                </c:pt>
                <c:pt idx="36">
                  <c:v>B7</c:v>
                </c:pt>
                <c:pt idx="37">
                  <c:v>H11</c:v>
                </c:pt>
                <c:pt idx="38">
                  <c:v>E10</c:v>
                </c:pt>
                <c:pt idx="39">
                  <c:v>E6</c:v>
                </c:pt>
                <c:pt idx="40">
                  <c:v>B12</c:v>
                </c:pt>
                <c:pt idx="41">
                  <c:v>A11</c:v>
                </c:pt>
                <c:pt idx="42">
                  <c:v>E4</c:v>
                </c:pt>
                <c:pt idx="43">
                  <c:v>D12</c:v>
                </c:pt>
                <c:pt idx="44">
                  <c:v>H7</c:v>
                </c:pt>
                <c:pt idx="45">
                  <c:v>C4</c:v>
                </c:pt>
                <c:pt idx="46">
                  <c:v>C10</c:v>
                </c:pt>
                <c:pt idx="47">
                  <c:v>F10</c:v>
                </c:pt>
                <c:pt idx="48">
                  <c:v>D11</c:v>
                </c:pt>
                <c:pt idx="49">
                  <c:v>B8</c:v>
                </c:pt>
                <c:pt idx="50">
                  <c:v>E11</c:v>
                </c:pt>
                <c:pt idx="51">
                  <c:v>G6</c:v>
                </c:pt>
                <c:pt idx="52">
                  <c:v>F4</c:v>
                </c:pt>
                <c:pt idx="53">
                  <c:v>B2</c:v>
                </c:pt>
                <c:pt idx="54">
                  <c:v>G2</c:v>
                </c:pt>
                <c:pt idx="55">
                  <c:v>F12</c:v>
                </c:pt>
                <c:pt idx="56">
                  <c:v>C3</c:v>
                </c:pt>
                <c:pt idx="57">
                  <c:v>D2</c:v>
                </c:pt>
                <c:pt idx="58">
                  <c:v>A8</c:v>
                </c:pt>
                <c:pt idx="59">
                  <c:v>E8</c:v>
                </c:pt>
                <c:pt idx="60">
                  <c:v>F8</c:v>
                </c:pt>
                <c:pt idx="61">
                  <c:v>F7</c:v>
                </c:pt>
                <c:pt idx="62">
                  <c:v>D4</c:v>
                </c:pt>
                <c:pt idx="63">
                  <c:v>E9</c:v>
                </c:pt>
                <c:pt idx="64">
                  <c:v>B9</c:v>
                </c:pt>
                <c:pt idx="65">
                  <c:v>G1</c:v>
                </c:pt>
                <c:pt idx="66">
                  <c:v>G10</c:v>
                </c:pt>
                <c:pt idx="67">
                  <c:v>A7</c:v>
                </c:pt>
                <c:pt idx="68">
                  <c:v>A9</c:v>
                </c:pt>
                <c:pt idx="69">
                  <c:v>C6</c:v>
                </c:pt>
                <c:pt idx="70">
                  <c:v>E7</c:v>
                </c:pt>
                <c:pt idx="71">
                  <c:v>H9</c:v>
                </c:pt>
                <c:pt idx="72">
                  <c:v>H2</c:v>
                </c:pt>
                <c:pt idx="73">
                  <c:v>A1</c:v>
                </c:pt>
                <c:pt idx="74">
                  <c:v>F9</c:v>
                </c:pt>
                <c:pt idx="75">
                  <c:v>A3</c:v>
                </c:pt>
                <c:pt idx="76">
                  <c:v>C7</c:v>
                </c:pt>
                <c:pt idx="77">
                  <c:v>E12</c:v>
                </c:pt>
                <c:pt idx="78">
                  <c:v>G12</c:v>
                </c:pt>
                <c:pt idx="79">
                  <c:v>C9</c:v>
                </c:pt>
                <c:pt idx="80">
                  <c:v>E1</c:v>
                </c:pt>
                <c:pt idx="81">
                  <c:v>G3</c:v>
                </c:pt>
                <c:pt idx="82">
                  <c:v>C11</c:v>
                </c:pt>
                <c:pt idx="83">
                  <c:v>B4</c:v>
                </c:pt>
                <c:pt idx="84">
                  <c:v>E3</c:v>
                </c:pt>
                <c:pt idx="85">
                  <c:v>G9</c:v>
                </c:pt>
                <c:pt idx="86">
                  <c:v>G8</c:v>
                </c:pt>
                <c:pt idx="87">
                  <c:v>C1</c:v>
                </c:pt>
                <c:pt idx="88">
                  <c:v>G4</c:v>
                </c:pt>
                <c:pt idx="89">
                  <c:v>E2</c:v>
                </c:pt>
                <c:pt idx="90">
                  <c:v>C2</c:v>
                </c:pt>
                <c:pt idx="91">
                  <c:v>G7</c:v>
                </c:pt>
                <c:pt idx="92">
                  <c:v>F2</c:v>
                </c:pt>
                <c:pt idx="93">
                  <c:v>G11</c:v>
                </c:pt>
                <c:pt idx="94">
                  <c:v>A4</c:v>
                </c:pt>
                <c:pt idx="95">
                  <c:v>H12</c:v>
                </c:pt>
              </c:strCache>
            </c:strRef>
          </c:xVal>
          <c:yVal>
            <c:numRef>
              <c:f>HMF!$F$2:$F$97</c:f>
              <c:numCache>
                <c:formatCode>General</c:formatCode>
                <c:ptCount val="96"/>
                <c:pt idx="0">
                  <c:v>61.979166666666664</c:v>
                </c:pt>
                <c:pt idx="1">
                  <c:v>64.321608040201014</c:v>
                </c:pt>
                <c:pt idx="2">
                  <c:v>68.108108108108098</c:v>
                </c:pt>
                <c:pt idx="3">
                  <c:v>70.351758793969864</c:v>
                </c:pt>
                <c:pt idx="4">
                  <c:v>71.517027863777088</c:v>
                </c:pt>
                <c:pt idx="5">
                  <c:v>72.327044025157221</c:v>
                </c:pt>
                <c:pt idx="6">
                  <c:v>73.711340206185582</c:v>
                </c:pt>
                <c:pt idx="7">
                  <c:v>74.561403508771932</c:v>
                </c:pt>
                <c:pt idx="8">
                  <c:v>74.742268041237097</c:v>
                </c:pt>
                <c:pt idx="9">
                  <c:v>75</c:v>
                </c:pt>
                <c:pt idx="10">
                  <c:v>75.789473684210535</c:v>
                </c:pt>
                <c:pt idx="11">
                  <c:v>76.142131979695435</c:v>
                </c:pt>
                <c:pt idx="12">
                  <c:v>76.470588235294102</c:v>
                </c:pt>
                <c:pt idx="13">
                  <c:v>76.59574468085107</c:v>
                </c:pt>
                <c:pt idx="14">
                  <c:v>77.435897435897431</c:v>
                </c:pt>
                <c:pt idx="15">
                  <c:v>77.821011673151759</c:v>
                </c:pt>
                <c:pt idx="16">
                  <c:v>78.045112781954899</c:v>
                </c:pt>
                <c:pt idx="17">
                  <c:v>78.278688524590152</c:v>
                </c:pt>
                <c:pt idx="18">
                  <c:v>78.350515463917532</c:v>
                </c:pt>
                <c:pt idx="19">
                  <c:v>78.536585365853668</c:v>
                </c:pt>
                <c:pt idx="20">
                  <c:v>78.604651162790688</c:v>
                </c:pt>
                <c:pt idx="21">
                  <c:v>78.83597883597885</c:v>
                </c:pt>
                <c:pt idx="22">
                  <c:v>79.207920792079207</c:v>
                </c:pt>
                <c:pt idx="23">
                  <c:v>80.402010050251278</c:v>
                </c:pt>
                <c:pt idx="24">
                  <c:v>80.582524271844676</c:v>
                </c:pt>
                <c:pt idx="25">
                  <c:v>81.521739130434767</c:v>
                </c:pt>
                <c:pt idx="26">
                  <c:v>81.578947368421069</c:v>
                </c:pt>
                <c:pt idx="27">
                  <c:v>81.65680473372781</c:v>
                </c:pt>
                <c:pt idx="28">
                  <c:v>81.916817359855344</c:v>
                </c:pt>
                <c:pt idx="29">
                  <c:v>82.159624413145536</c:v>
                </c:pt>
                <c:pt idx="30">
                  <c:v>82.539682539682531</c:v>
                </c:pt>
                <c:pt idx="31">
                  <c:v>82.8125</c:v>
                </c:pt>
                <c:pt idx="32">
                  <c:v>83.068783068783077</c:v>
                </c:pt>
                <c:pt idx="33">
                  <c:v>84</c:v>
                </c:pt>
                <c:pt idx="34">
                  <c:v>84.000000000000014</c:v>
                </c:pt>
                <c:pt idx="35">
                  <c:v>84.055727554179569</c:v>
                </c:pt>
                <c:pt idx="36">
                  <c:v>84.269662921348299</c:v>
                </c:pt>
                <c:pt idx="37">
                  <c:v>84.649122807017548</c:v>
                </c:pt>
                <c:pt idx="38">
                  <c:v>84.693877551020407</c:v>
                </c:pt>
                <c:pt idx="39">
                  <c:v>85</c:v>
                </c:pt>
                <c:pt idx="40">
                  <c:v>85.051546391752581</c:v>
                </c:pt>
                <c:pt idx="41">
                  <c:v>85.053929121725744</c:v>
                </c:pt>
                <c:pt idx="42">
                  <c:v>85.207100591715985</c:v>
                </c:pt>
                <c:pt idx="43">
                  <c:v>85.279187817258872</c:v>
                </c:pt>
                <c:pt idx="44">
                  <c:v>85.507246376811608</c:v>
                </c:pt>
                <c:pt idx="45">
                  <c:v>85.714285714285708</c:v>
                </c:pt>
                <c:pt idx="46">
                  <c:v>85.784313725490193</c:v>
                </c:pt>
                <c:pt idx="47">
                  <c:v>85.909090909090907</c:v>
                </c:pt>
                <c:pt idx="48">
                  <c:v>86.187845303867405</c:v>
                </c:pt>
                <c:pt idx="49">
                  <c:v>86.470588235294116</c:v>
                </c:pt>
                <c:pt idx="50">
                  <c:v>86.597938144329888</c:v>
                </c:pt>
                <c:pt idx="51">
                  <c:v>86.666666666666671</c:v>
                </c:pt>
                <c:pt idx="52">
                  <c:v>86.781609195402325</c:v>
                </c:pt>
                <c:pt idx="53">
                  <c:v>86.842105263157904</c:v>
                </c:pt>
                <c:pt idx="54">
                  <c:v>87.373737373737384</c:v>
                </c:pt>
                <c:pt idx="55">
                  <c:v>87.745098039215691</c:v>
                </c:pt>
                <c:pt idx="56">
                  <c:v>87.777777777777786</c:v>
                </c:pt>
                <c:pt idx="57">
                  <c:v>87.817258883248726</c:v>
                </c:pt>
                <c:pt idx="58">
                  <c:v>87.832699619771859</c:v>
                </c:pt>
                <c:pt idx="59">
                  <c:v>87.912087912087927</c:v>
                </c:pt>
                <c:pt idx="60">
                  <c:v>88.023952095808383</c:v>
                </c:pt>
                <c:pt idx="61">
                  <c:v>88.043478260869563</c:v>
                </c:pt>
                <c:pt idx="62">
                  <c:v>88.48484848484847</c:v>
                </c:pt>
                <c:pt idx="63">
                  <c:v>88.607594936708892</c:v>
                </c:pt>
                <c:pt idx="64">
                  <c:v>88.95348837209302</c:v>
                </c:pt>
                <c:pt idx="65">
                  <c:v>89.130434782608674</c:v>
                </c:pt>
                <c:pt idx="66">
                  <c:v>89.268292682926813</c:v>
                </c:pt>
                <c:pt idx="67">
                  <c:v>89.543726235741445</c:v>
                </c:pt>
                <c:pt idx="68">
                  <c:v>89.951377633711502</c:v>
                </c:pt>
                <c:pt idx="69">
                  <c:v>90.000000000000014</c:v>
                </c:pt>
                <c:pt idx="70">
                  <c:v>90.058479532163744</c:v>
                </c:pt>
                <c:pt idx="71">
                  <c:v>90.094339622641513</c:v>
                </c:pt>
                <c:pt idx="72">
                  <c:v>90.410958904109577</c:v>
                </c:pt>
                <c:pt idx="73">
                  <c:v>90.529695024077029</c:v>
                </c:pt>
                <c:pt idx="74">
                  <c:v>90.610328638497663</c:v>
                </c:pt>
                <c:pt idx="75">
                  <c:v>91.237113402061851</c:v>
                </c:pt>
                <c:pt idx="76">
                  <c:v>91.503267973856211</c:v>
                </c:pt>
                <c:pt idx="77">
                  <c:v>91.534391534391546</c:v>
                </c:pt>
                <c:pt idx="78">
                  <c:v>91.878172588832498</c:v>
                </c:pt>
                <c:pt idx="79">
                  <c:v>92.261904761904773</c:v>
                </c:pt>
                <c:pt idx="80">
                  <c:v>93.055555555555571</c:v>
                </c:pt>
                <c:pt idx="81">
                  <c:v>93.10344827586205</c:v>
                </c:pt>
                <c:pt idx="82">
                  <c:v>93.264248704663217</c:v>
                </c:pt>
                <c:pt idx="83">
                  <c:v>93.61702127659575</c:v>
                </c:pt>
                <c:pt idx="84">
                  <c:v>94.73684210526315</c:v>
                </c:pt>
                <c:pt idx="85">
                  <c:v>95.783132530120469</c:v>
                </c:pt>
                <c:pt idx="86">
                  <c:v>96.174863387978149</c:v>
                </c:pt>
                <c:pt idx="87">
                  <c:v>96.894409937888213</c:v>
                </c:pt>
                <c:pt idx="88">
                  <c:v>97.109826589595386</c:v>
                </c:pt>
                <c:pt idx="89">
                  <c:v>97.126436781609215</c:v>
                </c:pt>
                <c:pt idx="90">
                  <c:v>98.192771084337352</c:v>
                </c:pt>
                <c:pt idx="91">
                  <c:v>99.00497512437812</c:v>
                </c:pt>
                <c:pt idx="92">
                  <c:v>100.62893081761007</c:v>
                </c:pt>
                <c:pt idx="93">
                  <c:v>101.0752688172043</c:v>
                </c:pt>
                <c:pt idx="94">
                  <c:v>102.89256198347107</c:v>
                </c:pt>
                <c:pt idx="95">
                  <c:v>111.4678899082568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32864"/>
        <c:axId val="183550528"/>
      </c:scatterChart>
      <c:valAx>
        <c:axId val="18353286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83550528"/>
        <c:crosses val="autoZero"/>
        <c:crossBetween val="midCat"/>
      </c:valAx>
      <c:valAx>
        <c:axId val="183550528"/>
        <c:scaling>
          <c:orientation val="minMax"/>
          <c:max val="12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532864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75257019279081128"/>
          <c:y val="0.62327553882901898"/>
          <c:w val="0.20280718459360034"/>
          <c:h val="7.9731765914898348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03798265500735"/>
          <c:y val="5.1400554097404488E-2"/>
          <c:w val="0.73424106660908994"/>
          <c:h val="0.82380117486945892"/>
        </c:manualLayout>
      </c:layout>
      <c:scatterChart>
        <c:scatterStyle val="lineMarker"/>
        <c:varyColors val="0"/>
        <c:ser>
          <c:idx val="0"/>
          <c:order val="0"/>
          <c:tx>
            <c:strRef>
              <c:f>Vanillin!$G$1</c:f>
              <c:strCache>
                <c:ptCount val="1"/>
                <c:pt idx="0">
                  <c:v>Vanillin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Vanillin!$B$2:$B$97</c:f>
              <c:strCache>
                <c:ptCount val="96"/>
                <c:pt idx="0">
                  <c:v>F5</c:v>
                </c:pt>
                <c:pt idx="1">
                  <c:v>C12</c:v>
                </c:pt>
                <c:pt idx="2">
                  <c:v>E5</c:v>
                </c:pt>
                <c:pt idx="3">
                  <c:v>B6</c:v>
                </c:pt>
                <c:pt idx="4">
                  <c:v>D6</c:v>
                </c:pt>
                <c:pt idx="5">
                  <c:v>H6</c:v>
                </c:pt>
                <c:pt idx="6">
                  <c:v>H8</c:v>
                </c:pt>
                <c:pt idx="7">
                  <c:v>C5</c:v>
                </c:pt>
                <c:pt idx="8">
                  <c:v>A5</c:v>
                </c:pt>
                <c:pt idx="9">
                  <c:v>H1</c:v>
                </c:pt>
                <c:pt idx="10">
                  <c:v>G6</c:v>
                </c:pt>
                <c:pt idx="11">
                  <c:v>F6</c:v>
                </c:pt>
                <c:pt idx="12">
                  <c:v>A6</c:v>
                </c:pt>
                <c:pt idx="13">
                  <c:v>G5</c:v>
                </c:pt>
                <c:pt idx="14">
                  <c:v>H5</c:v>
                </c:pt>
                <c:pt idx="15">
                  <c:v>G1</c:v>
                </c:pt>
                <c:pt idx="16">
                  <c:v>F1</c:v>
                </c:pt>
                <c:pt idx="17">
                  <c:v>B3</c:v>
                </c:pt>
                <c:pt idx="18">
                  <c:v>C6</c:v>
                </c:pt>
                <c:pt idx="19">
                  <c:v>G8</c:v>
                </c:pt>
                <c:pt idx="20">
                  <c:v>D8</c:v>
                </c:pt>
                <c:pt idx="21">
                  <c:v>D1</c:v>
                </c:pt>
                <c:pt idx="22">
                  <c:v>E8</c:v>
                </c:pt>
                <c:pt idx="23">
                  <c:v>F8</c:v>
                </c:pt>
                <c:pt idx="24">
                  <c:v>H7</c:v>
                </c:pt>
                <c:pt idx="25">
                  <c:v>C8</c:v>
                </c:pt>
                <c:pt idx="26">
                  <c:v>B7</c:v>
                </c:pt>
                <c:pt idx="27">
                  <c:v>G7</c:v>
                </c:pt>
                <c:pt idx="28">
                  <c:v>A9</c:v>
                </c:pt>
                <c:pt idx="29">
                  <c:v>B9</c:v>
                </c:pt>
                <c:pt idx="30">
                  <c:v>H10</c:v>
                </c:pt>
                <c:pt idx="31">
                  <c:v>E10</c:v>
                </c:pt>
                <c:pt idx="32">
                  <c:v>F7</c:v>
                </c:pt>
                <c:pt idx="33">
                  <c:v>G4</c:v>
                </c:pt>
                <c:pt idx="34">
                  <c:v>E6</c:v>
                </c:pt>
                <c:pt idx="35">
                  <c:v>B8</c:v>
                </c:pt>
                <c:pt idx="36">
                  <c:v>B1</c:v>
                </c:pt>
                <c:pt idx="37">
                  <c:v>F10</c:v>
                </c:pt>
                <c:pt idx="38">
                  <c:v>G10</c:v>
                </c:pt>
                <c:pt idx="39">
                  <c:v>H12</c:v>
                </c:pt>
                <c:pt idx="40">
                  <c:v>B2</c:v>
                </c:pt>
                <c:pt idx="41">
                  <c:v>G2</c:v>
                </c:pt>
                <c:pt idx="42">
                  <c:v>E7</c:v>
                </c:pt>
                <c:pt idx="43">
                  <c:v>C7</c:v>
                </c:pt>
                <c:pt idx="44">
                  <c:v>E2</c:v>
                </c:pt>
                <c:pt idx="45">
                  <c:v>A2</c:v>
                </c:pt>
                <c:pt idx="46">
                  <c:v>D7</c:v>
                </c:pt>
                <c:pt idx="47">
                  <c:v>D12</c:v>
                </c:pt>
                <c:pt idx="48">
                  <c:v>F12</c:v>
                </c:pt>
                <c:pt idx="49">
                  <c:v>A3</c:v>
                </c:pt>
                <c:pt idx="50">
                  <c:v>C9</c:v>
                </c:pt>
                <c:pt idx="51">
                  <c:v>C3</c:v>
                </c:pt>
                <c:pt idx="52">
                  <c:v>H9</c:v>
                </c:pt>
                <c:pt idx="53">
                  <c:v>D9</c:v>
                </c:pt>
                <c:pt idx="54">
                  <c:v>A12</c:v>
                </c:pt>
                <c:pt idx="55">
                  <c:v>B11</c:v>
                </c:pt>
                <c:pt idx="56">
                  <c:v>C4</c:v>
                </c:pt>
                <c:pt idx="57">
                  <c:v>D5</c:v>
                </c:pt>
                <c:pt idx="58">
                  <c:v>H11</c:v>
                </c:pt>
                <c:pt idx="59">
                  <c:v>H3</c:v>
                </c:pt>
                <c:pt idx="60">
                  <c:v>D2</c:v>
                </c:pt>
                <c:pt idx="61">
                  <c:v>E12</c:v>
                </c:pt>
                <c:pt idx="62">
                  <c:v>F11</c:v>
                </c:pt>
                <c:pt idx="63">
                  <c:v>E4</c:v>
                </c:pt>
                <c:pt idx="64">
                  <c:v>D10</c:v>
                </c:pt>
                <c:pt idx="65">
                  <c:v>G12</c:v>
                </c:pt>
                <c:pt idx="66">
                  <c:v>H2</c:v>
                </c:pt>
                <c:pt idx="67">
                  <c:v>F4</c:v>
                </c:pt>
                <c:pt idx="68">
                  <c:v>G9</c:v>
                </c:pt>
                <c:pt idx="69">
                  <c:v>A11</c:v>
                </c:pt>
                <c:pt idx="70">
                  <c:v>A10</c:v>
                </c:pt>
                <c:pt idx="71">
                  <c:v>E11</c:v>
                </c:pt>
                <c:pt idx="72">
                  <c:v>B4</c:v>
                </c:pt>
                <c:pt idx="73">
                  <c:v>G3</c:v>
                </c:pt>
                <c:pt idx="74">
                  <c:v>B10</c:v>
                </c:pt>
                <c:pt idx="75">
                  <c:v>C10</c:v>
                </c:pt>
                <c:pt idx="76">
                  <c:v>F3</c:v>
                </c:pt>
                <c:pt idx="77">
                  <c:v>C1</c:v>
                </c:pt>
                <c:pt idx="78">
                  <c:v>E3</c:v>
                </c:pt>
                <c:pt idx="79">
                  <c:v>B12</c:v>
                </c:pt>
                <c:pt idx="80">
                  <c:v>E1</c:v>
                </c:pt>
                <c:pt idx="81">
                  <c:v>B5</c:v>
                </c:pt>
                <c:pt idx="82">
                  <c:v>C2</c:v>
                </c:pt>
                <c:pt idx="83">
                  <c:v>F2</c:v>
                </c:pt>
                <c:pt idx="84">
                  <c:v>E9</c:v>
                </c:pt>
                <c:pt idx="85">
                  <c:v>C11</c:v>
                </c:pt>
                <c:pt idx="86">
                  <c:v>F9</c:v>
                </c:pt>
                <c:pt idx="87">
                  <c:v>A1</c:v>
                </c:pt>
                <c:pt idx="88">
                  <c:v>D4</c:v>
                </c:pt>
                <c:pt idx="89">
                  <c:v>D11</c:v>
                </c:pt>
                <c:pt idx="90">
                  <c:v>A8</c:v>
                </c:pt>
                <c:pt idx="91">
                  <c:v>A4</c:v>
                </c:pt>
                <c:pt idx="92">
                  <c:v>G11</c:v>
                </c:pt>
                <c:pt idx="93">
                  <c:v>A7</c:v>
                </c:pt>
                <c:pt idx="94">
                  <c:v>D3</c:v>
                </c:pt>
                <c:pt idx="95">
                  <c:v>H4</c:v>
                </c:pt>
              </c:strCache>
            </c:strRef>
          </c:xVal>
          <c:yVal>
            <c:numRef>
              <c:f>Vanillin!$G$2:$G$97</c:f>
              <c:numCache>
                <c:formatCode>General</c:formatCode>
                <c:ptCount val="96"/>
                <c:pt idx="0">
                  <c:v>4.0201005025125651</c:v>
                </c:pt>
                <c:pt idx="1">
                  <c:v>4.3902439024390247</c:v>
                </c:pt>
                <c:pt idx="2">
                  <c:v>5.6701030927835028</c:v>
                </c:pt>
                <c:pt idx="3">
                  <c:v>6.3492063492063489</c:v>
                </c:pt>
                <c:pt idx="4">
                  <c:v>6.598984771573603</c:v>
                </c:pt>
                <c:pt idx="5">
                  <c:v>7.0175438596491269</c:v>
                </c:pt>
                <c:pt idx="6">
                  <c:v>7.1428571428571397</c:v>
                </c:pt>
                <c:pt idx="7">
                  <c:v>9.4736842105263168</c:v>
                </c:pt>
                <c:pt idx="8">
                  <c:v>9.7649186256781171</c:v>
                </c:pt>
                <c:pt idx="9">
                  <c:v>9.8360655737704903</c:v>
                </c:pt>
                <c:pt idx="10">
                  <c:v>10</c:v>
                </c:pt>
                <c:pt idx="11">
                  <c:v>10.194174757281555</c:v>
                </c:pt>
                <c:pt idx="12">
                  <c:v>11.000000000000005</c:v>
                </c:pt>
                <c:pt idx="13">
                  <c:v>11.979166666666675</c:v>
                </c:pt>
                <c:pt idx="14">
                  <c:v>12.062256809338527</c:v>
                </c:pt>
                <c:pt idx="15">
                  <c:v>13.043478260869568</c:v>
                </c:pt>
                <c:pt idx="16">
                  <c:v>13.402061855670109</c:v>
                </c:pt>
                <c:pt idx="17">
                  <c:v>13.488372093023257</c:v>
                </c:pt>
                <c:pt idx="18">
                  <c:v>13.529411764705882</c:v>
                </c:pt>
                <c:pt idx="19">
                  <c:v>13.661202185792357</c:v>
                </c:pt>
                <c:pt idx="20">
                  <c:v>14.070351758793965</c:v>
                </c:pt>
                <c:pt idx="21">
                  <c:v>16.315789473684209</c:v>
                </c:pt>
                <c:pt idx="22">
                  <c:v>16.483516483516482</c:v>
                </c:pt>
                <c:pt idx="23">
                  <c:v>17.36526946107784</c:v>
                </c:pt>
                <c:pt idx="24">
                  <c:v>17.391304347826075</c:v>
                </c:pt>
                <c:pt idx="25">
                  <c:v>18.238993710691819</c:v>
                </c:pt>
                <c:pt idx="26">
                  <c:v>18.539325842696627</c:v>
                </c:pt>
                <c:pt idx="27">
                  <c:v>18.905472636815919</c:v>
                </c:pt>
                <c:pt idx="28">
                  <c:v>19.935170178282011</c:v>
                </c:pt>
                <c:pt idx="29">
                  <c:v>20.348837209302324</c:v>
                </c:pt>
                <c:pt idx="30">
                  <c:v>20.851063829787233</c:v>
                </c:pt>
                <c:pt idx="31">
                  <c:v>20.918367346938773</c:v>
                </c:pt>
                <c:pt idx="32">
                  <c:v>21.195652173913043</c:v>
                </c:pt>
                <c:pt idx="33">
                  <c:v>21.387283236994225</c:v>
                </c:pt>
                <c:pt idx="34">
                  <c:v>21.666666666666668</c:v>
                </c:pt>
                <c:pt idx="35">
                  <c:v>21.764705882352931</c:v>
                </c:pt>
                <c:pt idx="36">
                  <c:v>22.222222222222214</c:v>
                </c:pt>
                <c:pt idx="37">
                  <c:v>22.272727272727263</c:v>
                </c:pt>
                <c:pt idx="38">
                  <c:v>22.439024390243905</c:v>
                </c:pt>
                <c:pt idx="39">
                  <c:v>22.935779816513758</c:v>
                </c:pt>
                <c:pt idx="40">
                  <c:v>23.157894736842103</c:v>
                </c:pt>
                <c:pt idx="41">
                  <c:v>23.232323232323235</c:v>
                </c:pt>
                <c:pt idx="42">
                  <c:v>23.39181286549708</c:v>
                </c:pt>
                <c:pt idx="43">
                  <c:v>23.52941176470588</c:v>
                </c:pt>
                <c:pt idx="44">
                  <c:v>23.563218390804604</c:v>
                </c:pt>
                <c:pt idx="45">
                  <c:v>23.684210526315788</c:v>
                </c:pt>
                <c:pt idx="46">
                  <c:v>23.809523809523807</c:v>
                </c:pt>
                <c:pt idx="47">
                  <c:v>23.857868020304569</c:v>
                </c:pt>
                <c:pt idx="48">
                  <c:v>24.019607843137258</c:v>
                </c:pt>
                <c:pt idx="49">
                  <c:v>24.226804123711339</c:v>
                </c:pt>
                <c:pt idx="50">
                  <c:v>24.404761904761902</c:v>
                </c:pt>
                <c:pt idx="51">
                  <c:v>24.444444444444446</c:v>
                </c:pt>
                <c:pt idx="52">
                  <c:v>24.528301886792445</c:v>
                </c:pt>
                <c:pt idx="53">
                  <c:v>24.742268041237107</c:v>
                </c:pt>
                <c:pt idx="54">
                  <c:v>24.812030075187973</c:v>
                </c:pt>
                <c:pt idx="55">
                  <c:v>25.125628140703515</c:v>
                </c:pt>
                <c:pt idx="56">
                  <c:v>25.274725274725263</c:v>
                </c:pt>
                <c:pt idx="57">
                  <c:v>25.4054054054054</c:v>
                </c:pt>
                <c:pt idx="58">
                  <c:v>25.438596491228065</c:v>
                </c:pt>
                <c:pt idx="59">
                  <c:v>25.742574257425748</c:v>
                </c:pt>
                <c:pt idx="60">
                  <c:v>25.888324873096447</c:v>
                </c:pt>
                <c:pt idx="61">
                  <c:v>25.925925925925924</c:v>
                </c:pt>
                <c:pt idx="62">
                  <c:v>26.5</c:v>
                </c:pt>
                <c:pt idx="63">
                  <c:v>26.627218934911244</c:v>
                </c:pt>
                <c:pt idx="64">
                  <c:v>26.666666666666668</c:v>
                </c:pt>
                <c:pt idx="65">
                  <c:v>26.903553299492387</c:v>
                </c:pt>
                <c:pt idx="66">
                  <c:v>26.94063926940639</c:v>
                </c:pt>
                <c:pt idx="67">
                  <c:v>27.011494252873558</c:v>
                </c:pt>
                <c:pt idx="68">
                  <c:v>27.710843373493965</c:v>
                </c:pt>
                <c:pt idx="69">
                  <c:v>28.197226502311239</c:v>
                </c:pt>
                <c:pt idx="70">
                  <c:v>28.328173374613002</c:v>
                </c:pt>
                <c:pt idx="71">
                  <c:v>28.350515463917525</c:v>
                </c:pt>
                <c:pt idx="72">
                  <c:v>28.723404255319146</c:v>
                </c:pt>
                <c:pt idx="73">
                  <c:v>28.735632183908038</c:v>
                </c:pt>
                <c:pt idx="74">
                  <c:v>28.921568627450977</c:v>
                </c:pt>
                <c:pt idx="75">
                  <c:v>28.921568627450984</c:v>
                </c:pt>
                <c:pt idx="76">
                  <c:v>29.166666666666664</c:v>
                </c:pt>
                <c:pt idx="77">
                  <c:v>29.813664596273298</c:v>
                </c:pt>
                <c:pt idx="78">
                  <c:v>29.82456140350877</c:v>
                </c:pt>
                <c:pt idx="79">
                  <c:v>29.896907216494835</c:v>
                </c:pt>
                <c:pt idx="80">
                  <c:v>31.249999999999993</c:v>
                </c:pt>
                <c:pt idx="81">
                  <c:v>31.952662721893493</c:v>
                </c:pt>
                <c:pt idx="82">
                  <c:v>33.132530120481931</c:v>
                </c:pt>
                <c:pt idx="83">
                  <c:v>33.333333333333329</c:v>
                </c:pt>
                <c:pt idx="84">
                  <c:v>34.810126582278485</c:v>
                </c:pt>
                <c:pt idx="85">
                  <c:v>35.23316062176167</c:v>
                </c:pt>
                <c:pt idx="86">
                  <c:v>36.15023474178404</c:v>
                </c:pt>
                <c:pt idx="87">
                  <c:v>36.597110754414111</c:v>
                </c:pt>
                <c:pt idx="88">
                  <c:v>36.969696969696976</c:v>
                </c:pt>
                <c:pt idx="89">
                  <c:v>37.569060773480658</c:v>
                </c:pt>
                <c:pt idx="90">
                  <c:v>37.642585551330782</c:v>
                </c:pt>
                <c:pt idx="91">
                  <c:v>37.809917355371894</c:v>
                </c:pt>
                <c:pt idx="92">
                  <c:v>38.709677419354819</c:v>
                </c:pt>
                <c:pt idx="93">
                  <c:v>39.35361216730039</c:v>
                </c:pt>
                <c:pt idx="94">
                  <c:v>39.673913043478251</c:v>
                </c:pt>
                <c:pt idx="95">
                  <c:v>50.2347417840375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54560"/>
        <c:axId val="183555136"/>
      </c:scatterChart>
      <c:valAx>
        <c:axId val="18355456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83555136"/>
        <c:crosses val="autoZero"/>
        <c:crossBetween val="midCat"/>
      </c:valAx>
      <c:valAx>
        <c:axId val="183555136"/>
        <c:scaling>
          <c:orientation val="minMax"/>
          <c:max val="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554560"/>
        <c:crosses val="autoZero"/>
        <c:crossBetween val="midCat"/>
        <c:majorUnit val="10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031806043365938"/>
          <c:y val="5.1400554097404488E-2"/>
          <c:w val="0.69131746901396174"/>
          <c:h val="0.80947142023913676"/>
        </c:manualLayout>
      </c:layout>
      <c:scatterChart>
        <c:scatterStyle val="lineMarker"/>
        <c:varyColors val="0"/>
        <c:ser>
          <c:idx val="2"/>
          <c:order val="0"/>
          <c:tx>
            <c:strRef>
              <c:f>furfural!$E$1</c:f>
              <c:strCache>
                <c:ptCount val="1"/>
                <c:pt idx="0">
                  <c:v>furfura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furfural!$B$2:$B$97</c:f>
              <c:strCache>
                <c:ptCount val="96"/>
                <c:pt idx="0">
                  <c:v>F12</c:v>
                </c:pt>
                <c:pt idx="1">
                  <c:v>G9</c:v>
                </c:pt>
                <c:pt idx="2">
                  <c:v>D6</c:v>
                </c:pt>
                <c:pt idx="3">
                  <c:v>H12</c:v>
                </c:pt>
                <c:pt idx="4">
                  <c:v>B12</c:v>
                </c:pt>
                <c:pt idx="5">
                  <c:v>E2</c:v>
                </c:pt>
                <c:pt idx="6">
                  <c:v>E6</c:v>
                </c:pt>
                <c:pt idx="7">
                  <c:v>A12</c:v>
                </c:pt>
                <c:pt idx="8">
                  <c:v>E8</c:v>
                </c:pt>
                <c:pt idx="9">
                  <c:v>F6</c:v>
                </c:pt>
                <c:pt idx="10">
                  <c:v>D1</c:v>
                </c:pt>
                <c:pt idx="11">
                  <c:v>G3</c:v>
                </c:pt>
                <c:pt idx="12">
                  <c:v>D2</c:v>
                </c:pt>
                <c:pt idx="13">
                  <c:v>E7</c:v>
                </c:pt>
                <c:pt idx="14">
                  <c:v>D9</c:v>
                </c:pt>
                <c:pt idx="15">
                  <c:v>H8</c:v>
                </c:pt>
                <c:pt idx="16">
                  <c:v>F2</c:v>
                </c:pt>
                <c:pt idx="17">
                  <c:v>H6</c:v>
                </c:pt>
                <c:pt idx="18">
                  <c:v>D8</c:v>
                </c:pt>
                <c:pt idx="19">
                  <c:v>G8</c:v>
                </c:pt>
                <c:pt idx="20">
                  <c:v>F11</c:v>
                </c:pt>
                <c:pt idx="21">
                  <c:v>H9</c:v>
                </c:pt>
                <c:pt idx="22">
                  <c:v>C12</c:v>
                </c:pt>
                <c:pt idx="23">
                  <c:v>D3</c:v>
                </c:pt>
                <c:pt idx="24">
                  <c:v>G6</c:v>
                </c:pt>
                <c:pt idx="25">
                  <c:v>F8</c:v>
                </c:pt>
                <c:pt idx="26">
                  <c:v>H2</c:v>
                </c:pt>
                <c:pt idx="27">
                  <c:v>H3</c:v>
                </c:pt>
                <c:pt idx="28">
                  <c:v>G12</c:v>
                </c:pt>
                <c:pt idx="29">
                  <c:v>D5</c:v>
                </c:pt>
                <c:pt idx="30">
                  <c:v>F5</c:v>
                </c:pt>
                <c:pt idx="31">
                  <c:v>E9</c:v>
                </c:pt>
                <c:pt idx="32">
                  <c:v>F1</c:v>
                </c:pt>
                <c:pt idx="33">
                  <c:v>D12</c:v>
                </c:pt>
                <c:pt idx="34">
                  <c:v>B8</c:v>
                </c:pt>
                <c:pt idx="35">
                  <c:v>H10</c:v>
                </c:pt>
                <c:pt idx="36">
                  <c:v>G1</c:v>
                </c:pt>
                <c:pt idx="37">
                  <c:v>H7</c:v>
                </c:pt>
                <c:pt idx="38">
                  <c:v>D11</c:v>
                </c:pt>
                <c:pt idx="39">
                  <c:v>F10</c:v>
                </c:pt>
                <c:pt idx="40">
                  <c:v>F9</c:v>
                </c:pt>
                <c:pt idx="41">
                  <c:v>E4</c:v>
                </c:pt>
                <c:pt idx="42">
                  <c:v>H5</c:v>
                </c:pt>
                <c:pt idx="43">
                  <c:v>C11</c:v>
                </c:pt>
                <c:pt idx="44">
                  <c:v>A5</c:v>
                </c:pt>
                <c:pt idx="45">
                  <c:v>A4</c:v>
                </c:pt>
                <c:pt idx="46">
                  <c:v>E11</c:v>
                </c:pt>
                <c:pt idx="47">
                  <c:v>G10</c:v>
                </c:pt>
                <c:pt idx="48">
                  <c:v>B11</c:v>
                </c:pt>
                <c:pt idx="49">
                  <c:v>G5</c:v>
                </c:pt>
                <c:pt idx="50">
                  <c:v>F4</c:v>
                </c:pt>
                <c:pt idx="51">
                  <c:v>D10</c:v>
                </c:pt>
                <c:pt idx="52">
                  <c:v>H4</c:v>
                </c:pt>
                <c:pt idx="53">
                  <c:v>E5</c:v>
                </c:pt>
                <c:pt idx="54">
                  <c:v>G7</c:v>
                </c:pt>
                <c:pt idx="55">
                  <c:v>C9</c:v>
                </c:pt>
                <c:pt idx="56">
                  <c:v>A6</c:v>
                </c:pt>
                <c:pt idx="57">
                  <c:v>G2</c:v>
                </c:pt>
                <c:pt idx="58">
                  <c:v>B2</c:v>
                </c:pt>
                <c:pt idx="59">
                  <c:v>C2</c:v>
                </c:pt>
                <c:pt idx="60">
                  <c:v>A2</c:v>
                </c:pt>
                <c:pt idx="61">
                  <c:v>G4</c:v>
                </c:pt>
                <c:pt idx="62">
                  <c:v>A11</c:v>
                </c:pt>
                <c:pt idx="63">
                  <c:v>H11</c:v>
                </c:pt>
                <c:pt idx="64">
                  <c:v>G11</c:v>
                </c:pt>
                <c:pt idx="65">
                  <c:v>B5</c:v>
                </c:pt>
                <c:pt idx="66">
                  <c:v>E10</c:v>
                </c:pt>
                <c:pt idx="67">
                  <c:v>E3</c:v>
                </c:pt>
                <c:pt idx="68">
                  <c:v>F7</c:v>
                </c:pt>
                <c:pt idx="69">
                  <c:v>C7</c:v>
                </c:pt>
                <c:pt idx="70">
                  <c:v>C1</c:v>
                </c:pt>
                <c:pt idx="71">
                  <c:v>C8</c:v>
                </c:pt>
                <c:pt idx="72">
                  <c:v>C3</c:v>
                </c:pt>
                <c:pt idx="73">
                  <c:v>C6</c:v>
                </c:pt>
                <c:pt idx="74">
                  <c:v>D7</c:v>
                </c:pt>
                <c:pt idx="75">
                  <c:v>B1</c:v>
                </c:pt>
                <c:pt idx="76">
                  <c:v>F3</c:v>
                </c:pt>
                <c:pt idx="77">
                  <c:v>A9</c:v>
                </c:pt>
                <c:pt idx="78">
                  <c:v>A7</c:v>
                </c:pt>
                <c:pt idx="79">
                  <c:v>B9</c:v>
                </c:pt>
                <c:pt idx="80">
                  <c:v>B3</c:v>
                </c:pt>
                <c:pt idx="81">
                  <c:v>C10</c:v>
                </c:pt>
                <c:pt idx="82">
                  <c:v>H1</c:v>
                </c:pt>
                <c:pt idx="83">
                  <c:v>B7</c:v>
                </c:pt>
                <c:pt idx="84">
                  <c:v>B4</c:v>
                </c:pt>
                <c:pt idx="85">
                  <c:v>A8</c:v>
                </c:pt>
                <c:pt idx="86">
                  <c:v>E12</c:v>
                </c:pt>
                <c:pt idx="87">
                  <c:v>C4</c:v>
                </c:pt>
                <c:pt idx="88">
                  <c:v>E1</c:v>
                </c:pt>
                <c:pt idx="89">
                  <c:v>C5</c:v>
                </c:pt>
                <c:pt idx="90">
                  <c:v>A3</c:v>
                </c:pt>
                <c:pt idx="91">
                  <c:v>B10</c:v>
                </c:pt>
                <c:pt idx="92">
                  <c:v>B6</c:v>
                </c:pt>
                <c:pt idx="93">
                  <c:v>A1</c:v>
                </c:pt>
                <c:pt idx="94">
                  <c:v>A10</c:v>
                </c:pt>
                <c:pt idx="95">
                  <c:v>D4</c:v>
                </c:pt>
              </c:strCache>
            </c:strRef>
          </c:xVal>
          <c:yVal>
            <c:numRef>
              <c:f>furfural!$E$2:$E$97</c:f>
              <c:numCache>
                <c:formatCode>General</c:formatCode>
                <c:ptCount val="96"/>
                <c:pt idx="0">
                  <c:v>66.406250000000014</c:v>
                </c:pt>
                <c:pt idx="1">
                  <c:v>69.642857142857167</c:v>
                </c:pt>
                <c:pt idx="2">
                  <c:v>72.222222222222214</c:v>
                </c:pt>
                <c:pt idx="3">
                  <c:v>72.580645161290306</c:v>
                </c:pt>
                <c:pt idx="4">
                  <c:v>72.881355932203391</c:v>
                </c:pt>
                <c:pt idx="5">
                  <c:v>73.148148148148152</c:v>
                </c:pt>
                <c:pt idx="6">
                  <c:v>73.949579831932766</c:v>
                </c:pt>
                <c:pt idx="7">
                  <c:v>74.540682414698139</c:v>
                </c:pt>
                <c:pt idx="8">
                  <c:v>75.22935779816514</c:v>
                </c:pt>
                <c:pt idx="9">
                  <c:v>75.862068965517253</c:v>
                </c:pt>
                <c:pt idx="10">
                  <c:v>76.288659793814418</c:v>
                </c:pt>
                <c:pt idx="11">
                  <c:v>76.521739130434767</c:v>
                </c:pt>
                <c:pt idx="12">
                  <c:v>77.450980392156865</c:v>
                </c:pt>
                <c:pt idx="13">
                  <c:v>77.500000000000028</c:v>
                </c:pt>
                <c:pt idx="14">
                  <c:v>78.313253012048193</c:v>
                </c:pt>
                <c:pt idx="15">
                  <c:v>78.333333333333314</c:v>
                </c:pt>
                <c:pt idx="16">
                  <c:v>78.84615384615384</c:v>
                </c:pt>
                <c:pt idx="17">
                  <c:v>79.200000000000031</c:v>
                </c:pt>
                <c:pt idx="18">
                  <c:v>79.207920792079221</c:v>
                </c:pt>
                <c:pt idx="19">
                  <c:v>79.310344827586206</c:v>
                </c:pt>
                <c:pt idx="20">
                  <c:v>79.411764705882348</c:v>
                </c:pt>
                <c:pt idx="21">
                  <c:v>79.411764705882376</c:v>
                </c:pt>
                <c:pt idx="22">
                  <c:v>79.439252336448575</c:v>
                </c:pt>
                <c:pt idx="23">
                  <c:v>79.646017699115063</c:v>
                </c:pt>
                <c:pt idx="24">
                  <c:v>80</c:v>
                </c:pt>
                <c:pt idx="25">
                  <c:v>80.555555555555543</c:v>
                </c:pt>
                <c:pt idx="26">
                  <c:v>80.582524271844676</c:v>
                </c:pt>
                <c:pt idx="27">
                  <c:v>80.582524271844676</c:v>
                </c:pt>
                <c:pt idx="28">
                  <c:v>80.672268907563037</c:v>
                </c:pt>
                <c:pt idx="29">
                  <c:v>81.308411214953253</c:v>
                </c:pt>
                <c:pt idx="30">
                  <c:v>81.308411214953253</c:v>
                </c:pt>
                <c:pt idx="31">
                  <c:v>81.395348837209312</c:v>
                </c:pt>
                <c:pt idx="32">
                  <c:v>81.44329896907216</c:v>
                </c:pt>
                <c:pt idx="33">
                  <c:v>82.075471698113219</c:v>
                </c:pt>
                <c:pt idx="34">
                  <c:v>82.524271844660177</c:v>
                </c:pt>
                <c:pt idx="35">
                  <c:v>82.706766917293237</c:v>
                </c:pt>
                <c:pt idx="36">
                  <c:v>82.75862068965516</c:v>
                </c:pt>
                <c:pt idx="37">
                  <c:v>82.758620689655189</c:v>
                </c:pt>
                <c:pt idx="38">
                  <c:v>82.978723404255334</c:v>
                </c:pt>
                <c:pt idx="39">
                  <c:v>83.333333333333314</c:v>
                </c:pt>
                <c:pt idx="40">
                  <c:v>83.695652173913032</c:v>
                </c:pt>
                <c:pt idx="41">
                  <c:v>83.739837398374007</c:v>
                </c:pt>
                <c:pt idx="42">
                  <c:v>83.760683760683747</c:v>
                </c:pt>
                <c:pt idx="43">
                  <c:v>83.809523809523839</c:v>
                </c:pt>
                <c:pt idx="44">
                  <c:v>83.862433862433889</c:v>
                </c:pt>
                <c:pt idx="45">
                  <c:v>83.863636363636374</c:v>
                </c:pt>
                <c:pt idx="46">
                  <c:v>83.928571428571445</c:v>
                </c:pt>
                <c:pt idx="47">
                  <c:v>84.000000000000014</c:v>
                </c:pt>
                <c:pt idx="48">
                  <c:v>84.112149532710305</c:v>
                </c:pt>
                <c:pt idx="49">
                  <c:v>84.482758620689651</c:v>
                </c:pt>
                <c:pt idx="50">
                  <c:v>84.615384615384585</c:v>
                </c:pt>
                <c:pt idx="51">
                  <c:v>84.821428571428584</c:v>
                </c:pt>
                <c:pt idx="52">
                  <c:v>85.40145985401459</c:v>
                </c:pt>
                <c:pt idx="53">
                  <c:v>85.454545454545467</c:v>
                </c:pt>
                <c:pt idx="54">
                  <c:v>85.483870967741936</c:v>
                </c:pt>
                <c:pt idx="55">
                  <c:v>85.714285714285765</c:v>
                </c:pt>
                <c:pt idx="56">
                  <c:v>86.312849162011204</c:v>
                </c:pt>
                <c:pt idx="57">
                  <c:v>86.324786324786302</c:v>
                </c:pt>
                <c:pt idx="58">
                  <c:v>86.36363636363636</c:v>
                </c:pt>
                <c:pt idx="59">
                  <c:v>86.538461538461561</c:v>
                </c:pt>
                <c:pt idx="60">
                  <c:v>87.037037037036995</c:v>
                </c:pt>
                <c:pt idx="61">
                  <c:v>87.121212121212139</c:v>
                </c:pt>
                <c:pt idx="62">
                  <c:v>87.767584097859284</c:v>
                </c:pt>
                <c:pt idx="63">
                  <c:v>88.118811881188122</c:v>
                </c:pt>
                <c:pt idx="64">
                  <c:v>88.181818181818173</c:v>
                </c:pt>
                <c:pt idx="65">
                  <c:v>88.8888888888889</c:v>
                </c:pt>
                <c:pt idx="66">
                  <c:v>88.983050847457619</c:v>
                </c:pt>
                <c:pt idx="67">
                  <c:v>89.247311827956963</c:v>
                </c:pt>
                <c:pt idx="68">
                  <c:v>89.344262295081975</c:v>
                </c:pt>
                <c:pt idx="69">
                  <c:v>89.473684210526315</c:v>
                </c:pt>
                <c:pt idx="70">
                  <c:v>89.583333333333329</c:v>
                </c:pt>
                <c:pt idx="71">
                  <c:v>89.89898989898991</c:v>
                </c:pt>
                <c:pt idx="72">
                  <c:v>90.099009900990097</c:v>
                </c:pt>
                <c:pt idx="73">
                  <c:v>90.625000000000043</c:v>
                </c:pt>
                <c:pt idx="74">
                  <c:v>91.150442477876098</c:v>
                </c:pt>
                <c:pt idx="75">
                  <c:v>91.304347826086968</c:v>
                </c:pt>
                <c:pt idx="76">
                  <c:v>91.588785046728972</c:v>
                </c:pt>
                <c:pt idx="77">
                  <c:v>91.616766467065887</c:v>
                </c:pt>
                <c:pt idx="78">
                  <c:v>92.054794520548</c:v>
                </c:pt>
                <c:pt idx="79">
                  <c:v>92.391304347826051</c:v>
                </c:pt>
                <c:pt idx="80">
                  <c:v>92.857142857142847</c:v>
                </c:pt>
                <c:pt idx="81">
                  <c:v>93.043478260869549</c:v>
                </c:pt>
                <c:pt idx="82">
                  <c:v>93.137254901960816</c:v>
                </c:pt>
                <c:pt idx="83">
                  <c:v>93.220338983050851</c:v>
                </c:pt>
                <c:pt idx="84">
                  <c:v>93.333333333333329</c:v>
                </c:pt>
                <c:pt idx="85">
                  <c:v>93.495934959349583</c:v>
                </c:pt>
                <c:pt idx="86">
                  <c:v>95.098039215686299</c:v>
                </c:pt>
                <c:pt idx="87">
                  <c:v>95.614035087719259</c:v>
                </c:pt>
                <c:pt idx="88">
                  <c:v>96.590909090909093</c:v>
                </c:pt>
                <c:pt idx="89">
                  <c:v>97.029702970297009</c:v>
                </c:pt>
                <c:pt idx="90">
                  <c:v>97.183098591549324</c:v>
                </c:pt>
                <c:pt idx="91">
                  <c:v>97.520661157024776</c:v>
                </c:pt>
                <c:pt idx="92">
                  <c:v>98.019801980198011</c:v>
                </c:pt>
                <c:pt idx="93">
                  <c:v>103.20512820512818</c:v>
                </c:pt>
                <c:pt idx="94">
                  <c:v>103.82653061224487</c:v>
                </c:pt>
                <c:pt idx="95">
                  <c:v>107.000000000000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092672"/>
        <c:axId val="157095552"/>
      </c:scatterChart>
      <c:valAx>
        <c:axId val="15709267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7095552"/>
        <c:crosses val="autoZero"/>
        <c:crossBetween val="midCat"/>
      </c:valAx>
      <c:valAx>
        <c:axId val="157095552"/>
        <c:scaling>
          <c:orientation val="minMax"/>
          <c:max val="120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7092672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58144447911526509"/>
          <c:y val="0.3732724555263926"/>
          <c:w val="0.36022221778758234"/>
          <c:h val="0.4710473170020413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74546034347727"/>
          <c:y val="5.1400554097404488E-2"/>
          <c:w val="0.69117365198224778"/>
          <c:h val="0.8326195683872849"/>
        </c:manualLayout>
      </c:layout>
      <c:scatterChart>
        <c:scatterStyle val="lineMarker"/>
        <c:varyColors val="0"/>
        <c:ser>
          <c:idx val="0"/>
          <c:order val="0"/>
          <c:tx>
            <c:strRef>
              <c:f>Sorbitol!$H$1</c:f>
              <c:strCache>
                <c:ptCount val="1"/>
                <c:pt idx="0">
                  <c:v>Sorbitol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orbitol!$B$2:$B$97</c:f>
              <c:strCache>
                <c:ptCount val="96"/>
                <c:pt idx="0">
                  <c:v>D10</c:v>
                </c:pt>
                <c:pt idx="1">
                  <c:v>C6</c:v>
                </c:pt>
                <c:pt idx="2">
                  <c:v>C4</c:v>
                </c:pt>
                <c:pt idx="3">
                  <c:v>B4</c:v>
                </c:pt>
                <c:pt idx="4">
                  <c:v>A11</c:v>
                </c:pt>
                <c:pt idx="5">
                  <c:v>C1</c:v>
                </c:pt>
                <c:pt idx="6">
                  <c:v>C7</c:v>
                </c:pt>
                <c:pt idx="7">
                  <c:v>G7</c:v>
                </c:pt>
                <c:pt idx="8">
                  <c:v>C2</c:v>
                </c:pt>
                <c:pt idx="9">
                  <c:v>F11</c:v>
                </c:pt>
                <c:pt idx="10">
                  <c:v>D2</c:v>
                </c:pt>
                <c:pt idx="11">
                  <c:v>F10</c:v>
                </c:pt>
                <c:pt idx="12">
                  <c:v>G11</c:v>
                </c:pt>
                <c:pt idx="13">
                  <c:v>H11</c:v>
                </c:pt>
                <c:pt idx="14">
                  <c:v>C10</c:v>
                </c:pt>
                <c:pt idx="15">
                  <c:v>G6</c:v>
                </c:pt>
                <c:pt idx="16">
                  <c:v>C5</c:v>
                </c:pt>
                <c:pt idx="17">
                  <c:v>H5</c:v>
                </c:pt>
                <c:pt idx="18">
                  <c:v>C12</c:v>
                </c:pt>
                <c:pt idx="19">
                  <c:v>D7</c:v>
                </c:pt>
                <c:pt idx="20">
                  <c:v>D5</c:v>
                </c:pt>
                <c:pt idx="21">
                  <c:v>G4</c:v>
                </c:pt>
                <c:pt idx="22">
                  <c:v>G8</c:v>
                </c:pt>
                <c:pt idx="23">
                  <c:v>A2</c:v>
                </c:pt>
                <c:pt idx="24">
                  <c:v>D9</c:v>
                </c:pt>
                <c:pt idx="25">
                  <c:v>H10</c:v>
                </c:pt>
                <c:pt idx="26">
                  <c:v>F2</c:v>
                </c:pt>
                <c:pt idx="27">
                  <c:v>H7</c:v>
                </c:pt>
                <c:pt idx="28">
                  <c:v>G5</c:v>
                </c:pt>
                <c:pt idx="29">
                  <c:v>F6</c:v>
                </c:pt>
                <c:pt idx="30">
                  <c:v>F1</c:v>
                </c:pt>
                <c:pt idx="31">
                  <c:v>F7</c:v>
                </c:pt>
                <c:pt idx="32">
                  <c:v>E4</c:v>
                </c:pt>
                <c:pt idx="33">
                  <c:v>D12</c:v>
                </c:pt>
                <c:pt idx="34">
                  <c:v>F3</c:v>
                </c:pt>
                <c:pt idx="35">
                  <c:v>D11</c:v>
                </c:pt>
                <c:pt idx="36">
                  <c:v>G2</c:v>
                </c:pt>
                <c:pt idx="37">
                  <c:v>H8</c:v>
                </c:pt>
                <c:pt idx="38">
                  <c:v>C3</c:v>
                </c:pt>
                <c:pt idx="39">
                  <c:v>B5</c:v>
                </c:pt>
                <c:pt idx="40">
                  <c:v>F8</c:v>
                </c:pt>
                <c:pt idx="41">
                  <c:v>H1</c:v>
                </c:pt>
                <c:pt idx="42">
                  <c:v>D3</c:v>
                </c:pt>
                <c:pt idx="43">
                  <c:v>G9</c:v>
                </c:pt>
                <c:pt idx="44">
                  <c:v>A12</c:v>
                </c:pt>
                <c:pt idx="45">
                  <c:v>G1</c:v>
                </c:pt>
                <c:pt idx="46">
                  <c:v>D8</c:v>
                </c:pt>
                <c:pt idx="47">
                  <c:v>B11</c:v>
                </c:pt>
                <c:pt idx="48">
                  <c:v>B8</c:v>
                </c:pt>
                <c:pt idx="49">
                  <c:v>E6</c:v>
                </c:pt>
                <c:pt idx="50">
                  <c:v>B2</c:v>
                </c:pt>
                <c:pt idx="51">
                  <c:v>E2</c:v>
                </c:pt>
                <c:pt idx="52">
                  <c:v>A4</c:v>
                </c:pt>
                <c:pt idx="53">
                  <c:v>A7</c:v>
                </c:pt>
                <c:pt idx="54">
                  <c:v>B10</c:v>
                </c:pt>
                <c:pt idx="55">
                  <c:v>B3</c:v>
                </c:pt>
                <c:pt idx="56">
                  <c:v>B9</c:v>
                </c:pt>
                <c:pt idx="57">
                  <c:v>G10</c:v>
                </c:pt>
                <c:pt idx="58">
                  <c:v>H3</c:v>
                </c:pt>
                <c:pt idx="59">
                  <c:v>B6</c:v>
                </c:pt>
                <c:pt idx="60">
                  <c:v>D4</c:v>
                </c:pt>
                <c:pt idx="61">
                  <c:v>D1</c:v>
                </c:pt>
                <c:pt idx="62">
                  <c:v>G12</c:v>
                </c:pt>
                <c:pt idx="63">
                  <c:v>A9</c:v>
                </c:pt>
                <c:pt idx="64">
                  <c:v>E10</c:v>
                </c:pt>
                <c:pt idx="65">
                  <c:v>H4</c:v>
                </c:pt>
                <c:pt idx="66">
                  <c:v>F12</c:v>
                </c:pt>
                <c:pt idx="67">
                  <c:v>H9</c:v>
                </c:pt>
                <c:pt idx="68">
                  <c:v>A1</c:v>
                </c:pt>
                <c:pt idx="69">
                  <c:v>E11</c:v>
                </c:pt>
                <c:pt idx="70">
                  <c:v>E9</c:v>
                </c:pt>
                <c:pt idx="71">
                  <c:v>F4</c:v>
                </c:pt>
                <c:pt idx="72">
                  <c:v>E12</c:v>
                </c:pt>
                <c:pt idx="73">
                  <c:v>E7</c:v>
                </c:pt>
                <c:pt idx="74">
                  <c:v>C11</c:v>
                </c:pt>
                <c:pt idx="75">
                  <c:v>A3</c:v>
                </c:pt>
                <c:pt idx="76">
                  <c:v>A8</c:v>
                </c:pt>
                <c:pt idx="77">
                  <c:v>C8</c:v>
                </c:pt>
                <c:pt idx="78">
                  <c:v>F9</c:v>
                </c:pt>
                <c:pt idx="79">
                  <c:v>G3</c:v>
                </c:pt>
                <c:pt idx="80">
                  <c:v>E3</c:v>
                </c:pt>
                <c:pt idx="81">
                  <c:v>B1</c:v>
                </c:pt>
                <c:pt idx="82">
                  <c:v>F5</c:v>
                </c:pt>
                <c:pt idx="83">
                  <c:v>E5</c:v>
                </c:pt>
                <c:pt idx="84">
                  <c:v>D6</c:v>
                </c:pt>
                <c:pt idx="85">
                  <c:v>B12</c:v>
                </c:pt>
                <c:pt idx="86">
                  <c:v>B7</c:v>
                </c:pt>
                <c:pt idx="87">
                  <c:v>A10</c:v>
                </c:pt>
                <c:pt idx="88">
                  <c:v>E1</c:v>
                </c:pt>
                <c:pt idx="89">
                  <c:v>A6</c:v>
                </c:pt>
                <c:pt idx="90">
                  <c:v>A5</c:v>
                </c:pt>
                <c:pt idx="91">
                  <c:v>E8</c:v>
                </c:pt>
                <c:pt idx="92">
                  <c:v>H6</c:v>
                </c:pt>
                <c:pt idx="93">
                  <c:v>H12</c:v>
                </c:pt>
                <c:pt idx="94">
                  <c:v>C9</c:v>
                </c:pt>
                <c:pt idx="95">
                  <c:v>H2</c:v>
                </c:pt>
              </c:strCache>
            </c:strRef>
          </c:xVal>
          <c:yVal>
            <c:numRef>
              <c:f>Sorbitol!$H$2:$H$97</c:f>
              <c:numCache>
                <c:formatCode>General</c:formatCode>
                <c:ptCount val="96"/>
                <c:pt idx="0">
                  <c:v>76.595744680851027</c:v>
                </c:pt>
                <c:pt idx="1">
                  <c:v>80</c:v>
                </c:pt>
                <c:pt idx="2">
                  <c:v>80.208333333333343</c:v>
                </c:pt>
                <c:pt idx="3">
                  <c:v>87.804878048780495</c:v>
                </c:pt>
                <c:pt idx="4">
                  <c:v>91.26984126984128</c:v>
                </c:pt>
                <c:pt idx="5">
                  <c:v>93.277310924369715</c:v>
                </c:pt>
                <c:pt idx="6">
                  <c:v>93.846153846153868</c:v>
                </c:pt>
                <c:pt idx="7">
                  <c:v>95.867768595041312</c:v>
                </c:pt>
                <c:pt idx="8">
                  <c:v>98.596491228070178</c:v>
                </c:pt>
                <c:pt idx="9">
                  <c:v>100</c:v>
                </c:pt>
                <c:pt idx="10">
                  <c:v>101.4285714285714</c:v>
                </c:pt>
                <c:pt idx="11">
                  <c:v>101.73913043478264</c:v>
                </c:pt>
                <c:pt idx="12">
                  <c:v>102.56410256410255</c:v>
                </c:pt>
                <c:pt idx="13">
                  <c:v>104.06504065040652</c:v>
                </c:pt>
                <c:pt idx="14">
                  <c:v>104.09836065573769</c:v>
                </c:pt>
                <c:pt idx="15">
                  <c:v>105.98290598290596</c:v>
                </c:pt>
                <c:pt idx="16">
                  <c:v>106.06060606060606</c:v>
                </c:pt>
                <c:pt idx="17">
                  <c:v>106.06060606060606</c:v>
                </c:pt>
                <c:pt idx="18">
                  <c:v>108.6538461538461</c:v>
                </c:pt>
                <c:pt idx="19">
                  <c:v>109.09090909090907</c:v>
                </c:pt>
                <c:pt idx="20">
                  <c:v>109.33333333333334</c:v>
                </c:pt>
                <c:pt idx="21">
                  <c:v>109.82142857142858</c:v>
                </c:pt>
                <c:pt idx="22">
                  <c:v>110.2040816326531</c:v>
                </c:pt>
                <c:pt idx="23">
                  <c:v>110.81081081081085</c:v>
                </c:pt>
                <c:pt idx="24">
                  <c:v>111.76470588235293</c:v>
                </c:pt>
                <c:pt idx="25">
                  <c:v>114.15094339622642</c:v>
                </c:pt>
                <c:pt idx="26">
                  <c:v>114.28571428571431</c:v>
                </c:pt>
                <c:pt idx="27">
                  <c:v>114.52991452991455</c:v>
                </c:pt>
                <c:pt idx="28">
                  <c:v>114.85148514851484</c:v>
                </c:pt>
                <c:pt idx="29">
                  <c:v>115.38461538461533</c:v>
                </c:pt>
                <c:pt idx="30">
                  <c:v>115.62500000000003</c:v>
                </c:pt>
                <c:pt idx="31">
                  <c:v>115.6626506024097</c:v>
                </c:pt>
                <c:pt idx="32">
                  <c:v>117.35537190082646</c:v>
                </c:pt>
                <c:pt idx="33">
                  <c:v>117.56756756756761</c:v>
                </c:pt>
                <c:pt idx="34">
                  <c:v>118.18181818181816</c:v>
                </c:pt>
                <c:pt idx="35">
                  <c:v>118.42105263157887</c:v>
                </c:pt>
                <c:pt idx="36">
                  <c:v>118.4782608695652</c:v>
                </c:pt>
                <c:pt idx="37">
                  <c:v>119.58762886597935</c:v>
                </c:pt>
                <c:pt idx="38">
                  <c:v>119.67213114754098</c:v>
                </c:pt>
                <c:pt idx="39">
                  <c:v>120.00000000000006</c:v>
                </c:pt>
                <c:pt idx="40">
                  <c:v>120.84805653710251</c:v>
                </c:pt>
                <c:pt idx="41">
                  <c:v>121.8390804597701</c:v>
                </c:pt>
                <c:pt idx="42">
                  <c:v>122.53521126760567</c:v>
                </c:pt>
                <c:pt idx="43">
                  <c:v>124.41860465116279</c:v>
                </c:pt>
                <c:pt idx="44">
                  <c:v>125</c:v>
                </c:pt>
                <c:pt idx="45">
                  <c:v>125.30120481927707</c:v>
                </c:pt>
                <c:pt idx="46">
                  <c:v>125.67567567567575</c:v>
                </c:pt>
                <c:pt idx="47">
                  <c:v>126.99999999999999</c:v>
                </c:pt>
                <c:pt idx="48">
                  <c:v>127.47252747252749</c:v>
                </c:pt>
                <c:pt idx="49">
                  <c:v>129.85074626865671</c:v>
                </c:pt>
                <c:pt idx="50">
                  <c:v>130.43478260869568</c:v>
                </c:pt>
                <c:pt idx="51">
                  <c:v>131.50684931506848</c:v>
                </c:pt>
                <c:pt idx="52">
                  <c:v>132.03883495145635</c:v>
                </c:pt>
                <c:pt idx="53">
                  <c:v>132.67326732673271</c:v>
                </c:pt>
                <c:pt idx="54">
                  <c:v>132.95454545454544</c:v>
                </c:pt>
                <c:pt idx="55">
                  <c:v>133.70786516853931</c:v>
                </c:pt>
                <c:pt idx="56">
                  <c:v>136.14457831325302</c:v>
                </c:pt>
                <c:pt idx="57">
                  <c:v>136.17021276595744</c:v>
                </c:pt>
                <c:pt idx="58">
                  <c:v>136.55913978494624</c:v>
                </c:pt>
                <c:pt idx="59">
                  <c:v>136.66666666666663</c:v>
                </c:pt>
                <c:pt idx="60">
                  <c:v>137.66233766233773</c:v>
                </c:pt>
                <c:pt idx="61">
                  <c:v>137.93103448275861</c:v>
                </c:pt>
                <c:pt idx="62">
                  <c:v>139.75903614457835</c:v>
                </c:pt>
                <c:pt idx="63">
                  <c:v>141.46341463414635</c:v>
                </c:pt>
                <c:pt idx="64">
                  <c:v>142.2535211267606</c:v>
                </c:pt>
                <c:pt idx="65">
                  <c:v>142.26804123711344</c:v>
                </c:pt>
                <c:pt idx="66">
                  <c:v>142.52873563218392</c:v>
                </c:pt>
                <c:pt idx="67">
                  <c:v>142.55319148936167</c:v>
                </c:pt>
                <c:pt idx="68">
                  <c:v>144.07407407407408</c:v>
                </c:pt>
                <c:pt idx="69">
                  <c:v>145.07042253521121</c:v>
                </c:pt>
                <c:pt idx="70">
                  <c:v>145.76271186440673</c:v>
                </c:pt>
                <c:pt idx="71">
                  <c:v>145.78313253012047</c:v>
                </c:pt>
                <c:pt idx="72">
                  <c:v>146.77419354838707</c:v>
                </c:pt>
                <c:pt idx="73">
                  <c:v>148.00000000000003</c:v>
                </c:pt>
                <c:pt idx="74">
                  <c:v>148.03921568627453</c:v>
                </c:pt>
                <c:pt idx="75">
                  <c:v>148.27586206896552</c:v>
                </c:pt>
                <c:pt idx="76">
                  <c:v>148.31460674157302</c:v>
                </c:pt>
                <c:pt idx="77">
                  <c:v>148.97959183673476</c:v>
                </c:pt>
                <c:pt idx="78">
                  <c:v>149.2592592592593</c:v>
                </c:pt>
                <c:pt idx="79">
                  <c:v>149.99999999999997</c:v>
                </c:pt>
                <c:pt idx="80">
                  <c:v>149.99999999999997</c:v>
                </c:pt>
                <c:pt idx="81">
                  <c:v>150.68493150684924</c:v>
                </c:pt>
                <c:pt idx="82">
                  <c:v>151.78571428571428</c:v>
                </c:pt>
                <c:pt idx="83">
                  <c:v>152.45901639344262</c:v>
                </c:pt>
                <c:pt idx="84">
                  <c:v>152.94117647058832</c:v>
                </c:pt>
                <c:pt idx="85">
                  <c:v>153.75000000000006</c:v>
                </c:pt>
                <c:pt idx="86">
                  <c:v>155.29411764705884</c:v>
                </c:pt>
                <c:pt idx="87">
                  <c:v>157.3170731707317</c:v>
                </c:pt>
                <c:pt idx="88">
                  <c:v>160.00000000000006</c:v>
                </c:pt>
                <c:pt idx="89">
                  <c:v>161.72839506172843</c:v>
                </c:pt>
                <c:pt idx="90">
                  <c:v>166.52173913043487</c:v>
                </c:pt>
                <c:pt idx="91">
                  <c:v>167.85714285714295</c:v>
                </c:pt>
                <c:pt idx="92">
                  <c:v>169.99999999999997</c:v>
                </c:pt>
                <c:pt idx="93">
                  <c:v>173.49397590361448</c:v>
                </c:pt>
                <c:pt idx="94">
                  <c:v>183.33333333333337</c:v>
                </c:pt>
                <c:pt idx="95">
                  <c:v>213.432835820895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867968"/>
        <c:axId val="89868544"/>
      </c:scatterChart>
      <c:valAx>
        <c:axId val="8986796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89868544"/>
        <c:crosses val="autoZero"/>
        <c:crossBetween val="midCat"/>
      </c:valAx>
      <c:valAx>
        <c:axId val="89868544"/>
        <c:scaling>
          <c:orientation val="minMax"/>
          <c:max val="220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9867968"/>
        <c:crosses val="autoZero"/>
        <c:crossBetween val="midCat"/>
        <c:majorUnit val="40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703637104225241"/>
          <c:y val="5.1400554097404488E-2"/>
          <c:w val="0.70430153888949598"/>
          <c:h val="0.83261956838728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Ethanol '!$I$1</c:f>
              <c:strCache>
                <c:ptCount val="1"/>
                <c:pt idx="0">
                  <c:v>Ethanol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Ethanol '!$B$2:$B$97</c:f>
              <c:strCache>
                <c:ptCount val="96"/>
                <c:pt idx="0">
                  <c:v>D6</c:v>
                </c:pt>
                <c:pt idx="1">
                  <c:v>E9</c:v>
                </c:pt>
                <c:pt idx="2">
                  <c:v>D10</c:v>
                </c:pt>
                <c:pt idx="3">
                  <c:v>H1</c:v>
                </c:pt>
                <c:pt idx="4">
                  <c:v>F12</c:v>
                </c:pt>
                <c:pt idx="5">
                  <c:v>C2</c:v>
                </c:pt>
                <c:pt idx="6">
                  <c:v>C3</c:v>
                </c:pt>
                <c:pt idx="7">
                  <c:v>D5</c:v>
                </c:pt>
                <c:pt idx="8">
                  <c:v>F9</c:v>
                </c:pt>
                <c:pt idx="9">
                  <c:v>H5</c:v>
                </c:pt>
                <c:pt idx="10">
                  <c:v>D3</c:v>
                </c:pt>
                <c:pt idx="11">
                  <c:v>A8</c:v>
                </c:pt>
                <c:pt idx="12">
                  <c:v>C12</c:v>
                </c:pt>
                <c:pt idx="13">
                  <c:v>H8</c:v>
                </c:pt>
                <c:pt idx="14">
                  <c:v>H10</c:v>
                </c:pt>
                <c:pt idx="15">
                  <c:v>G6</c:v>
                </c:pt>
                <c:pt idx="16">
                  <c:v>H11</c:v>
                </c:pt>
                <c:pt idx="17">
                  <c:v>F5</c:v>
                </c:pt>
                <c:pt idx="18">
                  <c:v>F10</c:v>
                </c:pt>
                <c:pt idx="19">
                  <c:v>D12</c:v>
                </c:pt>
                <c:pt idx="20">
                  <c:v>E7</c:v>
                </c:pt>
                <c:pt idx="21">
                  <c:v>C8</c:v>
                </c:pt>
                <c:pt idx="22">
                  <c:v>C1</c:v>
                </c:pt>
                <c:pt idx="23">
                  <c:v>G11</c:v>
                </c:pt>
                <c:pt idx="24">
                  <c:v>F7</c:v>
                </c:pt>
                <c:pt idx="25">
                  <c:v>G3</c:v>
                </c:pt>
                <c:pt idx="26">
                  <c:v>G10</c:v>
                </c:pt>
                <c:pt idx="27">
                  <c:v>H3</c:v>
                </c:pt>
                <c:pt idx="28">
                  <c:v>B3</c:v>
                </c:pt>
                <c:pt idx="29">
                  <c:v>G9</c:v>
                </c:pt>
                <c:pt idx="30">
                  <c:v>F11</c:v>
                </c:pt>
                <c:pt idx="31">
                  <c:v>H12</c:v>
                </c:pt>
                <c:pt idx="32">
                  <c:v>F8</c:v>
                </c:pt>
                <c:pt idx="33">
                  <c:v>D9</c:v>
                </c:pt>
                <c:pt idx="34">
                  <c:v>G8</c:v>
                </c:pt>
                <c:pt idx="35">
                  <c:v>H7</c:v>
                </c:pt>
                <c:pt idx="36">
                  <c:v>G12</c:v>
                </c:pt>
                <c:pt idx="37">
                  <c:v>C6</c:v>
                </c:pt>
                <c:pt idx="38">
                  <c:v>H9</c:v>
                </c:pt>
                <c:pt idx="39">
                  <c:v>D8</c:v>
                </c:pt>
                <c:pt idx="40">
                  <c:v>B10</c:v>
                </c:pt>
                <c:pt idx="41">
                  <c:v>E1</c:v>
                </c:pt>
                <c:pt idx="42">
                  <c:v>C4</c:v>
                </c:pt>
                <c:pt idx="43">
                  <c:v>D7</c:v>
                </c:pt>
                <c:pt idx="44">
                  <c:v>E8</c:v>
                </c:pt>
                <c:pt idx="45">
                  <c:v>E2</c:v>
                </c:pt>
                <c:pt idx="46">
                  <c:v>A2</c:v>
                </c:pt>
                <c:pt idx="47">
                  <c:v>D11</c:v>
                </c:pt>
                <c:pt idx="48">
                  <c:v>H4</c:v>
                </c:pt>
                <c:pt idx="49">
                  <c:v>C7</c:v>
                </c:pt>
                <c:pt idx="50">
                  <c:v>E6</c:v>
                </c:pt>
                <c:pt idx="51">
                  <c:v>H2</c:v>
                </c:pt>
                <c:pt idx="52">
                  <c:v>A10</c:v>
                </c:pt>
                <c:pt idx="53">
                  <c:v>E10</c:v>
                </c:pt>
                <c:pt idx="54">
                  <c:v>G2</c:v>
                </c:pt>
                <c:pt idx="55">
                  <c:v>E4</c:v>
                </c:pt>
                <c:pt idx="56">
                  <c:v>C5</c:v>
                </c:pt>
                <c:pt idx="57">
                  <c:v>G7</c:v>
                </c:pt>
                <c:pt idx="58">
                  <c:v>G5</c:v>
                </c:pt>
                <c:pt idx="59">
                  <c:v>F2</c:v>
                </c:pt>
                <c:pt idx="60">
                  <c:v>D1</c:v>
                </c:pt>
                <c:pt idx="61">
                  <c:v>G4</c:v>
                </c:pt>
                <c:pt idx="62">
                  <c:v>F1</c:v>
                </c:pt>
                <c:pt idx="63">
                  <c:v>F3</c:v>
                </c:pt>
                <c:pt idx="64">
                  <c:v>B1</c:v>
                </c:pt>
                <c:pt idx="65">
                  <c:v>E3</c:v>
                </c:pt>
                <c:pt idx="66">
                  <c:v>B4</c:v>
                </c:pt>
                <c:pt idx="67">
                  <c:v>C9</c:v>
                </c:pt>
                <c:pt idx="68">
                  <c:v>D4</c:v>
                </c:pt>
                <c:pt idx="69">
                  <c:v>H6</c:v>
                </c:pt>
                <c:pt idx="70">
                  <c:v>D2</c:v>
                </c:pt>
                <c:pt idx="71">
                  <c:v>A11</c:v>
                </c:pt>
                <c:pt idx="72">
                  <c:v>C10</c:v>
                </c:pt>
                <c:pt idx="73">
                  <c:v>E12</c:v>
                </c:pt>
                <c:pt idx="74">
                  <c:v>B11</c:v>
                </c:pt>
                <c:pt idx="75">
                  <c:v>B6</c:v>
                </c:pt>
                <c:pt idx="76">
                  <c:v>B7</c:v>
                </c:pt>
                <c:pt idx="77">
                  <c:v>B2</c:v>
                </c:pt>
                <c:pt idx="78">
                  <c:v>B12</c:v>
                </c:pt>
                <c:pt idx="79">
                  <c:v>A1</c:v>
                </c:pt>
                <c:pt idx="80">
                  <c:v>A9</c:v>
                </c:pt>
                <c:pt idx="81">
                  <c:v>G1</c:v>
                </c:pt>
                <c:pt idx="82">
                  <c:v>A7</c:v>
                </c:pt>
                <c:pt idx="83">
                  <c:v>A3</c:v>
                </c:pt>
                <c:pt idx="84">
                  <c:v>A5</c:v>
                </c:pt>
                <c:pt idx="85">
                  <c:v>B8</c:v>
                </c:pt>
                <c:pt idx="86">
                  <c:v>B5</c:v>
                </c:pt>
                <c:pt idx="87">
                  <c:v>F4</c:v>
                </c:pt>
                <c:pt idx="88">
                  <c:v>A4</c:v>
                </c:pt>
                <c:pt idx="89">
                  <c:v>F6</c:v>
                </c:pt>
                <c:pt idx="90">
                  <c:v>A6</c:v>
                </c:pt>
                <c:pt idx="91">
                  <c:v>E11</c:v>
                </c:pt>
                <c:pt idx="92">
                  <c:v>C11</c:v>
                </c:pt>
                <c:pt idx="93">
                  <c:v>E5</c:v>
                </c:pt>
                <c:pt idx="94">
                  <c:v>B9</c:v>
                </c:pt>
                <c:pt idx="95">
                  <c:v>A12</c:v>
                </c:pt>
              </c:strCache>
            </c:strRef>
          </c:xVal>
          <c:yVal>
            <c:numRef>
              <c:f>'Ethanol '!$I$2:$I$97</c:f>
              <c:numCache>
                <c:formatCode>General</c:formatCode>
                <c:ptCount val="9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.7857142857142614</c:v>
                </c:pt>
                <c:pt idx="12">
                  <c:v>1.875000000000054</c:v>
                </c:pt>
                <c:pt idx="13">
                  <c:v>2.0618556701031072</c:v>
                </c:pt>
                <c:pt idx="14">
                  <c:v>2.8301886792452828</c:v>
                </c:pt>
                <c:pt idx="15">
                  <c:v>3.3898305084745997</c:v>
                </c:pt>
                <c:pt idx="16">
                  <c:v>4.065040650406516</c:v>
                </c:pt>
                <c:pt idx="17">
                  <c:v>4.5454545454544837</c:v>
                </c:pt>
                <c:pt idx="18">
                  <c:v>5.2631578947368247</c:v>
                </c:pt>
                <c:pt idx="19">
                  <c:v>6.0000000000000036</c:v>
                </c:pt>
                <c:pt idx="20">
                  <c:v>6.0606060606061041</c:v>
                </c:pt>
                <c:pt idx="21">
                  <c:v>6.2500000000000195</c:v>
                </c:pt>
                <c:pt idx="22">
                  <c:v>6.5573770491803058</c:v>
                </c:pt>
                <c:pt idx="23">
                  <c:v>6.837606837606848</c:v>
                </c:pt>
                <c:pt idx="24">
                  <c:v>6.9444444444444642</c:v>
                </c:pt>
                <c:pt idx="25">
                  <c:v>7.6086956521738971</c:v>
                </c:pt>
                <c:pt idx="26">
                  <c:v>8.5106382978723101</c:v>
                </c:pt>
                <c:pt idx="27">
                  <c:v>8.6021505376344241</c:v>
                </c:pt>
                <c:pt idx="28">
                  <c:v>8.6206896551724412</c:v>
                </c:pt>
                <c:pt idx="29">
                  <c:v>9.3023255813953671</c:v>
                </c:pt>
                <c:pt idx="30">
                  <c:v>9.5238095238095415</c:v>
                </c:pt>
                <c:pt idx="31">
                  <c:v>9.6385542168674885</c:v>
                </c:pt>
                <c:pt idx="32">
                  <c:v>10.616438356164384</c:v>
                </c:pt>
                <c:pt idx="33">
                  <c:v>11.111111111111189</c:v>
                </c:pt>
                <c:pt idx="34">
                  <c:v>11.224489795918339</c:v>
                </c:pt>
                <c:pt idx="35">
                  <c:v>11.965811965811945</c:v>
                </c:pt>
                <c:pt idx="36">
                  <c:v>12.04819277108432</c:v>
                </c:pt>
                <c:pt idx="37">
                  <c:v>12.30769230769226</c:v>
                </c:pt>
                <c:pt idx="38">
                  <c:v>12.76595744680851</c:v>
                </c:pt>
                <c:pt idx="39">
                  <c:v>13.333333333333334</c:v>
                </c:pt>
                <c:pt idx="40">
                  <c:v>14.285714285714231</c:v>
                </c:pt>
                <c:pt idx="41">
                  <c:v>15.151515151515193</c:v>
                </c:pt>
                <c:pt idx="42">
                  <c:v>15.463917525773191</c:v>
                </c:pt>
                <c:pt idx="43">
                  <c:v>16.417910447761219</c:v>
                </c:pt>
                <c:pt idx="44">
                  <c:v>16.666666666666625</c:v>
                </c:pt>
                <c:pt idx="45">
                  <c:v>17.54385964912278</c:v>
                </c:pt>
                <c:pt idx="46">
                  <c:v>18.518518518518494</c:v>
                </c:pt>
                <c:pt idx="47">
                  <c:v>19.402985074626837</c:v>
                </c:pt>
                <c:pt idx="48">
                  <c:v>19.587628865979369</c:v>
                </c:pt>
                <c:pt idx="49">
                  <c:v>20</c:v>
                </c:pt>
                <c:pt idx="50">
                  <c:v>20.689655172413797</c:v>
                </c:pt>
                <c:pt idx="51">
                  <c:v>20.895522388059721</c:v>
                </c:pt>
                <c:pt idx="52">
                  <c:v>21.739130434782584</c:v>
                </c:pt>
                <c:pt idx="53">
                  <c:v>22.222222222222378</c:v>
                </c:pt>
                <c:pt idx="54">
                  <c:v>22.826086956521742</c:v>
                </c:pt>
                <c:pt idx="55">
                  <c:v>23.076923076923102</c:v>
                </c:pt>
                <c:pt idx="56">
                  <c:v>23.52941176470587</c:v>
                </c:pt>
                <c:pt idx="57">
                  <c:v>23.684210526315795</c:v>
                </c:pt>
                <c:pt idx="58">
                  <c:v>23.809523809523775</c:v>
                </c:pt>
                <c:pt idx="59">
                  <c:v>24.000000000000014</c:v>
                </c:pt>
                <c:pt idx="60">
                  <c:v>24.489795918367331</c:v>
                </c:pt>
                <c:pt idx="61">
                  <c:v>24.999999999999986</c:v>
                </c:pt>
                <c:pt idx="62">
                  <c:v>25.000000000000078</c:v>
                </c:pt>
                <c:pt idx="63">
                  <c:v>25.999999999999961</c:v>
                </c:pt>
                <c:pt idx="64">
                  <c:v>26.086956521739111</c:v>
                </c:pt>
                <c:pt idx="65">
                  <c:v>27.941176470588225</c:v>
                </c:pt>
                <c:pt idx="66">
                  <c:v>28.571428571428598</c:v>
                </c:pt>
                <c:pt idx="67">
                  <c:v>29.113924050632932</c:v>
                </c:pt>
                <c:pt idx="68">
                  <c:v>29.166666666666785</c:v>
                </c:pt>
                <c:pt idx="69">
                  <c:v>29.999999999999993</c:v>
                </c:pt>
                <c:pt idx="70">
                  <c:v>30.434782608695571</c:v>
                </c:pt>
                <c:pt idx="71">
                  <c:v>32.394366197183111</c:v>
                </c:pt>
                <c:pt idx="72">
                  <c:v>33.333333333333329</c:v>
                </c:pt>
                <c:pt idx="73">
                  <c:v>34.28571428571427</c:v>
                </c:pt>
                <c:pt idx="74">
                  <c:v>35.937499999999964</c:v>
                </c:pt>
                <c:pt idx="75">
                  <c:v>36.231884057971051</c:v>
                </c:pt>
                <c:pt idx="76">
                  <c:v>40.909090909090914</c:v>
                </c:pt>
                <c:pt idx="77">
                  <c:v>44.578313253012027</c:v>
                </c:pt>
                <c:pt idx="78">
                  <c:v>45.901639344262321</c:v>
                </c:pt>
                <c:pt idx="79">
                  <c:v>48.113207547169701</c:v>
                </c:pt>
                <c:pt idx="80">
                  <c:v>51.063829787234027</c:v>
                </c:pt>
                <c:pt idx="81">
                  <c:v>51.999999999999972</c:v>
                </c:pt>
                <c:pt idx="82">
                  <c:v>56.521739130434781</c:v>
                </c:pt>
                <c:pt idx="83">
                  <c:v>57.49999999999995</c:v>
                </c:pt>
                <c:pt idx="84">
                  <c:v>58.928571428571466</c:v>
                </c:pt>
                <c:pt idx="85">
                  <c:v>62.26415094339626</c:v>
                </c:pt>
                <c:pt idx="86">
                  <c:v>64.864864864864884</c:v>
                </c:pt>
                <c:pt idx="87">
                  <c:v>65.000000000000057</c:v>
                </c:pt>
                <c:pt idx="88">
                  <c:v>65.517241379310349</c:v>
                </c:pt>
                <c:pt idx="89">
                  <c:v>69.444444444444414</c:v>
                </c:pt>
                <c:pt idx="90">
                  <c:v>80.769230769230731</c:v>
                </c:pt>
                <c:pt idx="91">
                  <c:v>90.90909090909085</c:v>
                </c:pt>
                <c:pt idx="92">
                  <c:v>92.10526315789474</c:v>
                </c:pt>
                <c:pt idx="93">
                  <c:v>105.88235294117638</c:v>
                </c:pt>
                <c:pt idx="94">
                  <c:v>113.95348837209302</c:v>
                </c:pt>
                <c:pt idx="95">
                  <c:v>1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56288"/>
        <c:axId val="183555712"/>
      </c:scatterChart>
      <c:valAx>
        <c:axId val="18355628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83555712"/>
        <c:crosses val="autoZero"/>
        <c:crossBetween val="midCat"/>
      </c:valAx>
      <c:valAx>
        <c:axId val="183555712"/>
        <c:scaling>
          <c:orientation val="minMax"/>
          <c:max val="14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55628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1747508748906387"/>
          <c:y val="0.53221529600466611"/>
          <c:w val="0.64836027300634835"/>
          <c:h val="6.0618759055292258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54953160166633"/>
          <c:y val="5.1400554097404488E-2"/>
          <c:w val="0.73388687366374572"/>
          <c:h val="0.83261956838728512"/>
        </c:manualLayout>
      </c:layout>
      <c:scatterChart>
        <c:scatterStyle val="lineMarker"/>
        <c:varyColors val="0"/>
        <c:ser>
          <c:idx val="0"/>
          <c:order val="0"/>
          <c:tx>
            <c:strRef>
              <c:f>Temperature!$J$1</c:f>
              <c:strCache>
                <c:ptCount val="1"/>
                <c:pt idx="0">
                  <c:v>T (35'C)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Temperature!$B$2:$B$97</c:f>
              <c:strCache>
                <c:ptCount val="96"/>
                <c:pt idx="0">
                  <c:v>C3</c:v>
                </c:pt>
                <c:pt idx="1">
                  <c:v>C1</c:v>
                </c:pt>
                <c:pt idx="2">
                  <c:v>A1</c:v>
                </c:pt>
                <c:pt idx="3">
                  <c:v>A8</c:v>
                </c:pt>
                <c:pt idx="4">
                  <c:v>C10</c:v>
                </c:pt>
                <c:pt idx="5">
                  <c:v>A12</c:v>
                </c:pt>
                <c:pt idx="6">
                  <c:v>C8</c:v>
                </c:pt>
                <c:pt idx="7">
                  <c:v>B5</c:v>
                </c:pt>
                <c:pt idx="8">
                  <c:v>B12</c:v>
                </c:pt>
                <c:pt idx="9">
                  <c:v>B7</c:v>
                </c:pt>
                <c:pt idx="10">
                  <c:v>C12</c:v>
                </c:pt>
                <c:pt idx="11">
                  <c:v>C9</c:v>
                </c:pt>
                <c:pt idx="12">
                  <c:v>A11</c:v>
                </c:pt>
                <c:pt idx="13">
                  <c:v>H12</c:v>
                </c:pt>
                <c:pt idx="14">
                  <c:v>C5</c:v>
                </c:pt>
                <c:pt idx="15">
                  <c:v>H3</c:v>
                </c:pt>
                <c:pt idx="16">
                  <c:v>A2</c:v>
                </c:pt>
                <c:pt idx="17">
                  <c:v>A4</c:v>
                </c:pt>
                <c:pt idx="18">
                  <c:v>A6</c:v>
                </c:pt>
                <c:pt idx="19">
                  <c:v>A9</c:v>
                </c:pt>
                <c:pt idx="20">
                  <c:v>H2</c:v>
                </c:pt>
                <c:pt idx="21">
                  <c:v>B9</c:v>
                </c:pt>
                <c:pt idx="22">
                  <c:v>B1</c:v>
                </c:pt>
                <c:pt idx="23">
                  <c:v>B2</c:v>
                </c:pt>
                <c:pt idx="24">
                  <c:v>H8</c:v>
                </c:pt>
                <c:pt idx="25">
                  <c:v>B11</c:v>
                </c:pt>
                <c:pt idx="26">
                  <c:v>A3</c:v>
                </c:pt>
                <c:pt idx="27">
                  <c:v>B8</c:v>
                </c:pt>
                <c:pt idx="28">
                  <c:v>G1</c:v>
                </c:pt>
                <c:pt idx="29">
                  <c:v>F2</c:v>
                </c:pt>
                <c:pt idx="30">
                  <c:v>A5</c:v>
                </c:pt>
                <c:pt idx="31">
                  <c:v>C11</c:v>
                </c:pt>
                <c:pt idx="32">
                  <c:v>E1</c:v>
                </c:pt>
                <c:pt idx="33">
                  <c:v>C7</c:v>
                </c:pt>
                <c:pt idx="34">
                  <c:v>D10</c:v>
                </c:pt>
                <c:pt idx="35">
                  <c:v>B10</c:v>
                </c:pt>
                <c:pt idx="36">
                  <c:v>G12</c:v>
                </c:pt>
                <c:pt idx="37">
                  <c:v>D2</c:v>
                </c:pt>
                <c:pt idx="38">
                  <c:v>G8</c:v>
                </c:pt>
                <c:pt idx="39">
                  <c:v>F12</c:v>
                </c:pt>
                <c:pt idx="40">
                  <c:v>H1</c:v>
                </c:pt>
                <c:pt idx="41">
                  <c:v>H4</c:v>
                </c:pt>
                <c:pt idx="42">
                  <c:v>E4</c:v>
                </c:pt>
                <c:pt idx="43">
                  <c:v>H5</c:v>
                </c:pt>
                <c:pt idx="44">
                  <c:v>D5</c:v>
                </c:pt>
                <c:pt idx="45">
                  <c:v>E9</c:v>
                </c:pt>
                <c:pt idx="46">
                  <c:v>H10</c:v>
                </c:pt>
                <c:pt idx="47">
                  <c:v>C2</c:v>
                </c:pt>
                <c:pt idx="48">
                  <c:v>H9</c:v>
                </c:pt>
                <c:pt idx="49">
                  <c:v>E6</c:v>
                </c:pt>
                <c:pt idx="50">
                  <c:v>E3</c:v>
                </c:pt>
                <c:pt idx="51">
                  <c:v>A7</c:v>
                </c:pt>
                <c:pt idx="52">
                  <c:v>D7</c:v>
                </c:pt>
                <c:pt idx="53">
                  <c:v>A10</c:v>
                </c:pt>
                <c:pt idx="54">
                  <c:v>C4</c:v>
                </c:pt>
                <c:pt idx="55">
                  <c:v>B4</c:v>
                </c:pt>
                <c:pt idx="56">
                  <c:v>F10</c:v>
                </c:pt>
                <c:pt idx="57">
                  <c:v>F8</c:v>
                </c:pt>
                <c:pt idx="58">
                  <c:v>D3</c:v>
                </c:pt>
                <c:pt idx="59">
                  <c:v>D11</c:v>
                </c:pt>
                <c:pt idx="60">
                  <c:v>F9</c:v>
                </c:pt>
                <c:pt idx="61">
                  <c:v>H6</c:v>
                </c:pt>
                <c:pt idx="62">
                  <c:v>B6</c:v>
                </c:pt>
                <c:pt idx="63">
                  <c:v>G11</c:v>
                </c:pt>
                <c:pt idx="64">
                  <c:v>D12</c:v>
                </c:pt>
                <c:pt idx="65">
                  <c:v>E11</c:v>
                </c:pt>
                <c:pt idx="66">
                  <c:v>G4</c:v>
                </c:pt>
                <c:pt idx="67">
                  <c:v>D1</c:v>
                </c:pt>
                <c:pt idx="68">
                  <c:v>G10</c:v>
                </c:pt>
                <c:pt idx="69">
                  <c:v>F7</c:v>
                </c:pt>
                <c:pt idx="70">
                  <c:v>G3</c:v>
                </c:pt>
                <c:pt idx="71">
                  <c:v>B3</c:v>
                </c:pt>
                <c:pt idx="72">
                  <c:v>F4</c:v>
                </c:pt>
                <c:pt idx="73">
                  <c:v>F3</c:v>
                </c:pt>
                <c:pt idx="74">
                  <c:v>F11</c:v>
                </c:pt>
                <c:pt idx="75">
                  <c:v>F5</c:v>
                </c:pt>
                <c:pt idx="76">
                  <c:v>G2</c:v>
                </c:pt>
                <c:pt idx="77">
                  <c:v>G5</c:v>
                </c:pt>
                <c:pt idx="78">
                  <c:v>E2</c:v>
                </c:pt>
                <c:pt idx="79">
                  <c:v>H11</c:v>
                </c:pt>
                <c:pt idx="80">
                  <c:v>E8</c:v>
                </c:pt>
                <c:pt idx="81">
                  <c:v>G9</c:v>
                </c:pt>
                <c:pt idx="82">
                  <c:v>E5</c:v>
                </c:pt>
                <c:pt idx="83">
                  <c:v>D8</c:v>
                </c:pt>
                <c:pt idx="84">
                  <c:v>E12</c:v>
                </c:pt>
                <c:pt idx="85">
                  <c:v>C6</c:v>
                </c:pt>
                <c:pt idx="86">
                  <c:v>D6</c:v>
                </c:pt>
                <c:pt idx="87">
                  <c:v>H7</c:v>
                </c:pt>
                <c:pt idx="88">
                  <c:v>E7</c:v>
                </c:pt>
                <c:pt idx="89">
                  <c:v>F1</c:v>
                </c:pt>
                <c:pt idx="90">
                  <c:v>D4</c:v>
                </c:pt>
                <c:pt idx="91">
                  <c:v>F6</c:v>
                </c:pt>
                <c:pt idx="92">
                  <c:v>G6</c:v>
                </c:pt>
                <c:pt idx="93">
                  <c:v>E10</c:v>
                </c:pt>
                <c:pt idx="94">
                  <c:v>G7</c:v>
                </c:pt>
                <c:pt idx="95">
                  <c:v>D9</c:v>
                </c:pt>
              </c:strCache>
            </c:strRef>
          </c:xVal>
          <c:yVal>
            <c:numRef>
              <c:f>Temperature!$J$2:$J$97</c:f>
              <c:numCache>
                <c:formatCode>General</c:formatCode>
                <c:ptCount val="96"/>
                <c:pt idx="0">
                  <c:v>5.4347826086956204</c:v>
                </c:pt>
                <c:pt idx="1">
                  <c:v>29.292929292929308</c:v>
                </c:pt>
                <c:pt idx="2">
                  <c:v>41.194029850746297</c:v>
                </c:pt>
                <c:pt idx="3">
                  <c:v>43.278688524590166</c:v>
                </c:pt>
                <c:pt idx="4">
                  <c:v>45.054945054945065</c:v>
                </c:pt>
                <c:pt idx="5">
                  <c:v>45.83333333333335</c:v>
                </c:pt>
                <c:pt idx="6">
                  <c:v>45.91836734693878</c:v>
                </c:pt>
                <c:pt idx="7">
                  <c:v>45.977011494252842</c:v>
                </c:pt>
                <c:pt idx="8">
                  <c:v>46.315789473684184</c:v>
                </c:pt>
                <c:pt idx="9">
                  <c:v>48.611111111111136</c:v>
                </c:pt>
                <c:pt idx="10">
                  <c:v>49.190938511326806</c:v>
                </c:pt>
                <c:pt idx="11">
                  <c:v>49.397590361445793</c:v>
                </c:pt>
                <c:pt idx="12">
                  <c:v>49.557522123893833</c:v>
                </c:pt>
                <c:pt idx="13">
                  <c:v>50.354609929078023</c:v>
                </c:pt>
                <c:pt idx="14">
                  <c:v>51.648351648351621</c:v>
                </c:pt>
                <c:pt idx="15">
                  <c:v>51.968503937007881</c:v>
                </c:pt>
                <c:pt idx="16">
                  <c:v>53.271028037383196</c:v>
                </c:pt>
                <c:pt idx="17">
                  <c:v>53.289473684210535</c:v>
                </c:pt>
                <c:pt idx="18">
                  <c:v>56.043956043956058</c:v>
                </c:pt>
                <c:pt idx="19">
                  <c:v>57.692307692307701</c:v>
                </c:pt>
                <c:pt idx="20">
                  <c:v>59.183673469387742</c:v>
                </c:pt>
                <c:pt idx="21">
                  <c:v>59.595959595959627</c:v>
                </c:pt>
                <c:pt idx="22">
                  <c:v>60.638297872340416</c:v>
                </c:pt>
                <c:pt idx="23">
                  <c:v>60.82474226804122</c:v>
                </c:pt>
                <c:pt idx="24">
                  <c:v>61.157024793388423</c:v>
                </c:pt>
                <c:pt idx="25">
                  <c:v>61.538461538461554</c:v>
                </c:pt>
                <c:pt idx="26">
                  <c:v>62.162162162162168</c:v>
                </c:pt>
                <c:pt idx="27">
                  <c:v>63.157894736842088</c:v>
                </c:pt>
                <c:pt idx="28">
                  <c:v>65.16853932584273</c:v>
                </c:pt>
                <c:pt idx="29">
                  <c:v>65.263157894736807</c:v>
                </c:pt>
                <c:pt idx="30">
                  <c:v>65.283018867924582</c:v>
                </c:pt>
                <c:pt idx="31">
                  <c:v>66.666666666666657</c:v>
                </c:pt>
                <c:pt idx="32">
                  <c:v>66.6666666666667</c:v>
                </c:pt>
                <c:pt idx="33">
                  <c:v>69.879518072289144</c:v>
                </c:pt>
                <c:pt idx="34">
                  <c:v>70.454545454545439</c:v>
                </c:pt>
                <c:pt idx="35">
                  <c:v>70.786516853932596</c:v>
                </c:pt>
                <c:pt idx="36">
                  <c:v>71.428571428571402</c:v>
                </c:pt>
                <c:pt idx="37">
                  <c:v>72.115384615384627</c:v>
                </c:pt>
                <c:pt idx="38">
                  <c:v>73.195876288659747</c:v>
                </c:pt>
                <c:pt idx="39">
                  <c:v>74.038461538461547</c:v>
                </c:pt>
                <c:pt idx="40">
                  <c:v>74.725274725274673</c:v>
                </c:pt>
                <c:pt idx="41">
                  <c:v>75</c:v>
                </c:pt>
                <c:pt idx="42">
                  <c:v>75.78947368421052</c:v>
                </c:pt>
                <c:pt idx="43">
                  <c:v>76.086956521739125</c:v>
                </c:pt>
                <c:pt idx="44">
                  <c:v>76.190476190476204</c:v>
                </c:pt>
                <c:pt idx="45">
                  <c:v>76.249999999999986</c:v>
                </c:pt>
                <c:pt idx="46">
                  <c:v>76.470588235294116</c:v>
                </c:pt>
                <c:pt idx="47">
                  <c:v>76.984126984126988</c:v>
                </c:pt>
                <c:pt idx="48">
                  <c:v>77.419354838709694</c:v>
                </c:pt>
                <c:pt idx="49">
                  <c:v>77.528089887640462</c:v>
                </c:pt>
                <c:pt idx="50">
                  <c:v>78.260869565217391</c:v>
                </c:pt>
                <c:pt idx="51">
                  <c:v>78.947368421052659</c:v>
                </c:pt>
                <c:pt idx="52">
                  <c:v>79.761904761904802</c:v>
                </c:pt>
                <c:pt idx="53">
                  <c:v>79.999999999999972</c:v>
                </c:pt>
                <c:pt idx="54">
                  <c:v>80.43478260869567</c:v>
                </c:pt>
                <c:pt idx="55">
                  <c:v>81.111111111111072</c:v>
                </c:pt>
                <c:pt idx="56">
                  <c:v>81.927710843373504</c:v>
                </c:pt>
                <c:pt idx="57">
                  <c:v>82.31292517006807</c:v>
                </c:pt>
                <c:pt idx="58">
                  <c:v>82.474226804123745</c:v>
                </c:pt>
                <c:pt idx="59">
                  <c:v>82.79569892473117</c:v>
                </c:pt>
                <c:pt idx="60">
                  <c:v>82.954545454545524</c:v>
                </c:pt>
                <c:pt idx="61">
                  <c:v>83.018867924528266</c:v>
                </c:pt>
                <c:pt idx="62">
                  <c:v>83.333333333333343</c:v>
                </c:pt>
                <c:pt idx="63">
                  <c:v>83.695652173913047</c:v>
                </c:pt>
                <c:pt idx="64">
                  <c:v>85.057471264367777</c:v>
                </c:pt>
                <c:pt idx="65">
                  <c:v>86.666666666666686</c:v>
                </c:pt>
                <c:pt idx="66">
                  <c:v>86.868686868686908</c:v>
                </c:pt>
                <c:pt idx="67">
                  <c:v>86.904761904761884</c:v>
                </c:pt>
                <c:pt idx="68">
                  <c:v>87.288135593220375</c:v>
                </c:pt>
                <c:pt idx="69">
                  <c:v>87.356321839080422</c:v>
                </c:pt>
                <c:pt idx="70">
                  <c:v>89.108910891089096</c:v>
                </c:pt>
                <c:pt idx="71">
                  <c:v>89.361702127659569</c:v>
                </c:pt>
                <c:pt idx="72">
                  <c:v>90.566037735849051</c:v>
                </c:pt>
                <c:pt idx="73">
                  <c:v>91.089108910891099</c:v>
                </c:pt>
                <c:pt idx="74">
                  <c:v>93.333333333333385</c:v>
                </c:pt>
                <c:pt idx="75">
                  <c:v>94.505494505494497</c:v>
                </c:pt>
                <c:pt idx="76">
                  <c:v>95.60439560439562</c:v>
                </c:pt>
                <c:pt idx="77">
                  <c:v>96.842105263157848</c:v>
                </c:pt>
                <c:pt idx="78">
                  <c:v>97.826086956521749</c:v>
                </c:pt>
                <c:pt idx="79">
                  <c:v>101.14942528735638</c:v>
                </c:pt>
                <c:pt idx="80">
                  <c:v>101.21951219512195</c:v>
                </c:pt>
                <c:pt idx="81">
                  <c:v>101.38888888888886</c:v>
                </c:pt>
                <c:pt idx="82">
                  <c:v>102.32558139534886</c:v>
                </c:pt>
                <c:pt idx="83">
                  <c:v>103.12499999999997</c:v>
                </c:pt>
                <c:pt idx="84">
                  <c:v>104.44444444444446</c:v>
                </c:pt>
                <c:pt idx="85">
                  <c:v>106.45161290322578</c:v>
                </c:pt>
                <c:pt idx="86">
                  <c:v>107.89473684210529</c:v>
                </c:pt>
                <c:pt idx="87">
                  <c:v>107.95454545454548</c:v>
                </c:pt>
                <c:pt idx="88">
                  <c:v>111.68831168831173</c:v>
                </c:pt>
                <c:pt idx="89">
                  <c:v>122.10526315789477</c:v>
                </c:pt>
                <c:pt idx="90">
                  <c:v>128.39506172839512</c:v>
                </c:pt>
                <c:pt idx="91">
                  <c:v>132.09876543209876</c:v>
                </c:pt>
                <c:pt idx="92">
                  <c:v>134.32835820895517</c:v>
                </c:pt>
                <c:pt idx="93">
                  <c:v>137.3626373626374</c:v>
                </c:pt>
                <c:pt idx="94">
                  <c:v>163.63636363636365</c:v>
                </c:pt>
                <c:pt idx="95">
                  <c:v>167.857142857142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57440"/>
        <c:axId val="194455232"/>
      </c:scatterChart>
      <c:valAx>
        <c:axId val="18355744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455232"/>
        <c:crosses val="autoZero"/>
        <c:crossBetween val="midCat"/>
      </c:valAx>
      <c:valAx>
        <c:axId val="194455232"/>
        <c:scaling>
          <c:orientation val="minMax"/>
          <c:max val="18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557440"/>
        <c:crosses val="autoZero"/>
        <c:crossBetween val="midCat"/>
        <c:majorUnit val="30"/>
      </c:valAx>
    </c:plotArea>
    <c:legend>
      <c:legendPos val="r"/>
      <c:layout>
        <c:manualLayout>
          <c:xMode val="edge"/>
          <c:yMode val="edge"/>
          <c:x val="0.6676571136987357"/>
          <c:y val="0.71277085156022169"/>
          <c:w val="0.25456490603454773"/>
          <c:h val="3.7420895304753572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71000393244131"/>
          <c:y val="5.1400554097404488E-2"/>
          <c:w val="0.73291825148457923"/>
          <c:h val="0.83261956838728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Acetic acid'!$C$1</c:f>
              <c:strCache>
                <c:ptCount val="1"/>
                <c:pt idx="0">
                  <c:v>Acetic acid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Acetic acid'!$B$2:$B$97</c:f>
              <c:strCache>
                <c:ptCount val="96"/>
                <c:pt idx="0">
                  <c:v>H12</c:v>
                </c:pt>
                <c:pt idx="1">
                  <c:v>F2</c:v>
                </c:pt>
                <c:pt idx="2">
                  <c:v>G12</c:v>
                </c:pt>
                <c:pt idx="3">
                  <c:v>C9</c:v>
                </c:pt>
                <c:pt idx="4">
                  <c:v>H2</c:v>
                </c:pt>
                <c:pt idx="5">
                  <c:v>C6</c:v>
                </c:pt>
                <c:pt idx="6">
                  <c:v>E3</c:v>
                </c:pt>
                <c:pt idx="7">
                  <c:v>A2</c:v>
                </c:pt>
                <c:pt idx="8">
                  <c:v>H11</c:v>
                </c:pt>
                <c:pt idx="9">
                  <c:v>D7</c:v>
                </c:pt>
                <c:pt idx="10">
                  <c:v>A4</c:v>
                </c:pt>
                <c:pt idx="11">
                  <c:v>F9</c:v>
                </c:pt>
                <c:pt idx="12">
                  <c:v>C11</c:v>
                </c:pt>
                <c:pt idx="13">
                  <c:v>D4</c:v>
                </c:pt>
                <c:pt idx="14">
                  <c:v>E11</c:v>
                </c:pt>
                <c:pt idx="15">
                  <c:v>C1</c:v>
                </c:pt>
                <c:pt idx="16">
                  <c:v>D10</c:v>
                </c:pt>
                <c:pt idx="17">
                  <c:v>D2</c:v>
                </c:pt>
                <c:pt idx="18">
                  <c:v>B10</c:v>
                </c:pt>
                <c:pt idx="19">
                  <c:v>D6</c:v>
                </c:pt>
                <c:pt idx="20">
                  <c:v>H10</c:v>
                </c:pt>
                <c:pt idx="21">
                  <c:v>C7</c:v>
                </c:pt>
                <c:pt idx="22">
                  <c:v>A9</c:v>
                </c:pt>
                <c:pt idx="23">
                  <c:v>C10</c:v>
                </c:pt>
                <c:pt idx="24">
                  <c:v>E4</c:v>
                </c:pt>
                <c:pt idx="25">
                  <c:v>E12</c:v>
                </c:pt>
                <c:pt idx="26">
                  <c:v>H4</c:v>
                </c:pt>
                <c:pt idx="27">
                  <c:v>A7</c:v>
                </c:pt>
                <c:pt idx="28">
                  <c:v>D9</c:v>
                </c:pt>
                <c:pt idx="29">
                  <c:v>D11</c:v>
                </c:pt>
                <c:pt idx="30">
                  <c:v>E2</c:v>
                </c:pt>
                <c:pt idx="31">
                  <c:v>F3</c:v>
                </c:pt>
                <c:pt idx="32">
                  <c:v>B2</c:v>
                </c:pt>
                <c:pt idx="33">
                  <c:v>F1</c:v>
                </c:pt>
                <c:pt idx="34">
                  <c:v>B9</c:v>
                </c:pt>
                <c:pt idx="35">
                  <c:v>F6</c:v>
                </c:pt>
                <c:pt idx="36">
                  <c:v>B7</c:v>
                </c:pt>
                <c:pt idx="37">
                  <c:v>H3</c:v>
                </c:pt>
                <c:pt idx="38">
                  <c:v>G11</c:v>
                </c:pt>
                <c:pt idx="39">
                  <c:v>E10</c:v>
                </c:pt>
                <c:pt idx="40">
                  <c:v>F11</c:v>
                </c:pt>
                <c:pt idx="41">
                  <c:v>A5</c:v>
                </c:pt>
                <c:pt idx="42">
                  <c:v>B6</c:v>
                </c:pt>
                <c:pt idx="43">
                  <c:v>H7</c:v>
                </c:pt>
                <c:pt idx="44">
                  <c:v>C4</c:v>
                </c:pt>
                <c:pt idx="45">
                  <c:v>H1</c:v>
                </c:pt>
                <c:pt idx="46">
                  <c:v>G4</c:v>
                </c:pt>
                <c:pt idx="47">
                  <c:v>C3</c:v>
                </c:pt>
                <c:pt idx="48">
                  <c:v>F12</c:v>
                </c:pt>
                <c:pt idx="49">
                  <c:v>A6</c:v>
                </c:pt>
                <c:pt idx="50">
                  <c:v>A8</c:v>
                </c:pt>
                <c:pt idx="51">
                  <c:v>E8</c:v>
                </c:pt>
                <c:pt idx="52">
                  <c:v>D12</c:v>
                </c:pt>
                <c:pt idx="53">
                  <c:v>A1</c:v>
                </c:pt>
                <c:pt idx="54">
                  <c:v>D3</c:v>
                </c:pt>
                <c:pt idx="55">
                  <c:v>F4</c:v>
                </c:pt>
                <c:pt idx="56">
                  <c:v>G1</c:v>
                </c:pt>
                <c:pt idx="57">
                  <c:v>A11</c:v>
                </c:pt>
                <c:pt idx="58">
                  <c:v>F7</c:v>
                </c:pt>
                <c:pt idx="59">
                  <c:v>E9</c:v>
                </c:pt>
                <c:pt idx="60">
                  <c:v>B5</c:v>
                </c:pt>
                <c:pt idx="61">
                  <c:v>G6</c:v>
                </c:pt>
                <c:pt idx="62">
                  <c:v>E1</c:v>
                </c:pt>
                <c:pt idx="63">
                  <c:v>C8</c:v>
                </c:pt>
                <c:pt idx="64">
                  <c:v>H6</c:v>
                </c:pt>
                <c:pt idx="65">
                  <c:v>F8</c:v>
                </c:pt>
                <c:pt idx="66">
                  <c:v>A3</c:v>
                </c:pt>
                <c:pt idx="67">
                  <c:v>F10</c:v>
                </c:pt>
                <c:pt idx="68">
                  <c:v>C5</c:v>
                </c:pt>
                <c:pt idx="69">
                  <c:v>B3</c:v>
                </c:pt>
                <c:pt idx="70">
                  <c:v>G3</c:v>
                </c:pt>
                <c:pt idx="71">
                  <c:v>D8</c:v>
                </c:pt>
                <c:pt idx="72">
                  <c:v>A10</c:v>
                </c:pt>
                <c:pt idx="73">
                  <c:v>G9</c:v>
                </c:pt>
                <c:pt idx="74">
                  <c:v>D5</c:v>
                </c:pt>
                <c:pt idx="75">
                  <c:v>B11</c:v>
                </c:pt>
                <c:pt idx="76">
                  <c:v>G2</c:v>
                </c:pt>
                <c:pt idx="77">
                  <c:v>G5</c:v>
                </c:pt>
                <c:pt idx="78">
                  <c:v>C12</c:v>
                </c:pt>
                <c:pt idx="79">
                  <c:v>B8</c:v>
                </c:pt>
                <c:pt idx="80">
                  <c:v>H9</c:v>
                </c:pt>
                <c:pt idx="81">
                  <c:v>G10</c:v>
                </c:pt>
                <c:pt idx="82">
                  <c:v>D1</c:v>
                </c:pt>
                <c:pt idx="83">
                  <c:v>E5</c:v>
                </c:pt>
                <c:pt idx="84">
                  <c:v>G7</c:v>
                </c:pt>
                <c:pt idx="85">
                  <c:v>E6</c:v>
                </c:pt>
                <c:pt idx="86">
                  <c:v>G8</c:v>
                </c:pt>
                <c:pt idx="87">
                  <c:v>C2</c:v>
                </c:pt>
                <c:pt idx="88">
                  <c:v>B1</c:v>
                </c:pt>
                <c:pt idx="89">
                  <c:v>H5</c:v>
                </c:pt>
                <c:pt idx="90">
                  <c:v>H8</c:v>
                </c:pt>
                <c:pt idx="91">
                  <c:v>B4</c:v>
                </c:pt>
                <c:pt idx="92">
                  <c:v>A12</c:v>
                </c:pt>
                <c:pt idx="93">
                  <c:v>E7</c:v>
                </c:pt>
                <c:pt idx="94">
                  <c:v>B12</c:v>
                </c:pt>
                <c:pt idx="95">
                  <c:v>F5</c:v>
                </c:pt>
              </c:strCache>
            </c:strRef>
          </c:xVal>
          <c:yVal>
            <c:numRef>
              <c:f>'Acetic acid'!$C$2:$C$97</c:f>
              <c:numCache>
                <c:formatCode>General</c:formatCode>
                <c:ptCount val="96"/>
                <c:pt idx="0">
                  <c:v>56.613756613756614</c:v>
                </c:pt>
                <c:pt idx="1">
                  <c:v>71.257485029940128</c:v>
                </c:pt>
                <c:pt idx="2">
                  <c:v>72.666666666666686</c:v>
                </c:pt>
                <c:pt idx="3">
                  <c:v>72.847682119205274</c:v>
                </c:pt>
                <c:pt idx="4">
                  <c:v>73.513513513513516</c:v>
                </c:pt>
                <c:pt idx="5">
                  <c:v>75.438596491228068</c:v>
                </c:pt>
                <c:pt idx="6">
                  <c:v>77.319587628865975</c:v>
                </c:pt>
                <c:pt idx="7">
                  <c:v>78.18499127399653</c:v>
                </c:pt>
                <c:pt idx="8">
                  <c:v>78.651685393258433</c:v>
                </c:pt>
                <c:pt idx="9">
                  <c:v>79.518072289156621</c:v>
                </c:pt>
                <c:pt idx="10">
                  <c:v>79.803921568627445</c:v>
                </c:pt>
                <c:pt idx="11">
                  <c:v>81.012658227848107</c:v>
                </c:pt>
                <c:pt idx="12">
                  <c:v>82.424242424242422</c:v>
                </c:pt>
                <c:pt idx="13">
                  <c:v>82.758620689655189</c:v>
                </c:pt>
                <c:pt idx="14">
                  <c:v>83.453237410071949</c:v>
                </c:pt>
                <c:pt idx="15">
                  <c:v>84.137931034482733</c:v>
                </c:pt>
                <c:pt idx="16">
                  <c:v>84.34782608695653</c:v>
                </c:pt>
                <c:pt idx="17">
                  <c:v>84.375</c:v>
                </c:pt>
                <c:pt idx="18">
                  <c:v>84.444444444444457</c:v>
                </c:pt>
                <c:pt idx="19">
                  <c:v>84.615384615384613</c:v>
                </c:pt>
                <c:pt idx="20">
                  <c:v>84.768211920529808</c:v>
                </c:pt>
                <c:pt idx="21">
                  <c:v>85.430463576158928</c:v>
                </c:pt>
                <c:pt idx="22">
                  <c:v>85.740740740740762</c:v>
                </c:pt>
                <c:pt idx="23">
                  <c:v>85.820895522388085</c:v>
                </c:pt>
                <c:pt idx="24">
                  <c:v>86.127167630057798</c:v>
                </c:pt>
                <c:pt idx="25">
                  <c:v>86.206896551724157</c:v>
                </c:pt>
                <c:pt idx="26">
                  <c:v>86.224489795918359</c:v>
                </c:pt>
                <c:pt idx="27">
                  <c:v>86.679920477137188</c:v>
                </c:pt>
                <c:pt idx="28">
                  <c:v>86.861313868613138</c:v>
                </c:pt>
                <c:pt idx="29">
                  <c:v>86.928104575163403</c:v>
                </c:pt>
                <c:pt idx="30">
                  <c:v>87.417218543046346</c:v>
                </c:pt>
                <c:pt idx="31">
                  <c:v>87.634408602150515</c:v>
                </c:pt>
                <c:pt idx="32">
                  <c:v>87.654320987654302</c:v>
                </c:pt>
                <c:pt idx="33">
                  <c:v>87.769784172661872</c:v>
                </c:pt>
                <c:pt idx="34">
                  <c:v>87.94326241134749</c:v>
                </c:pt>
                <c:pt idx="35">
                  <c:v>88.023952095808383</c:v>
                </c:pt>
                <c:pt idx="36">
                  <c:v>88.414634146341484</c:v>
                </c:pt>
                <c:pt idx="37">
                  <c:v>89.075630252100851</c:v>
                </c:pt>
                <c:pt idx="38">
                  <c:v>89.115646258503418</c:v>
                </c:pt>
                <c:pt idx="39">
                  <c:v>89.189189189189207</c:v>
                </c:pt>
                <c:pt idx="40">
                  <c:v>89.473684210526315</c:v>
                </c:pt>
                <c:pt idx="41">
                  <c:v>89.977728285078001</c:v>
                </c:pt>
                <c:pt idx="42">
                  <c:v>90.062111801242253</c:v>
                </c:pt>
                <c:pt idx="43">
                  <c:v>90.37433155080214</c:v>
                </c:pt>
                <c:pt idx="44">
                  <c:v>90.697674418604649</c:v>
                </c:pt>
                <c:pt idx="45">
                  <c:v>90.721649484536115</c:v>
                </c:pt>
                <c:pt idx="46">
                  <c:v>90.857142857142847</c:v>
                </c:pt>
                <c:pt idx="47">
                  <c:v>90.963855421686731</c:v>
                </c:pt>
                <c:pt idx="48">
                  <c:v>91.156462585034021</c:v>
                </c:pt>
                <c:pt idx="49">
                  <c:v>91.596638655462172</c:v>
                </c:pt>
                <c:pt idx="50">
                  <c:v>91.650099403578551</c:v>
                </c:pt>
                <c:pt idx="51">
                  <c:v>93.103448275862078</c:v>
                </c:pt>
                <c:pt idx="52">
                  <c:v>93.197278911564609</c:v>
                </c:pt>
                <c:pt idx="53">
                  <c:v>93.706293706293721</c:v>
                </c:pt>
                <c:pt idx="54">
                  <c:v>94.011976047904184</c:v>
                </c:pt>
                <c:pt idx="55">
                  <c:v>94.219653179190772</c:v>
                </c:pt>
                <c:pt idx="56">
                  <c:v>94.354838709677409</c:v>
                </c:pt>
                <c:pt idx="57">
                  <c:v>94.456289978678015</c:v>
                </c:pt>
                <c:pt idx="58">
                  <c:v>94.838709677419359</c:v>
                </c:pt>
                <c:pt idx="59">
                  <c:v>94.904458598726109</c:v>
                </c:pt>
                <c:pt idx="60">
                  <c:v>95.000000000000028</c:v>
                </c:pt>
                <c:pt idx="61">
                  <c:v>95.27027027027026</c:v>
                </c:pt>
                <c:pt idx="62">
                  <c:v>96.000000000000014</c:v>
                </c:pt>
                <c:pt idx="63">
                  <c:v>96.026490066225151</c:v>
                </c:pt>
                <c:pt idx="64">
                  <c:v>96.571428571428584</c:v>
                </c:pt>
                <c:pt idx="65">
                  <c:v>96.774193548387103</c:v>
                </c:pt>
                <c:pt idx="66">
                  <c:v>96.899224806201531</c:v>
                </c:pt>
                <c:pt idx="67">
                  <c:v>97.037037037037024</c:v>
                </c:pt>
                <c:pt idx="68">
                  <c:v>97.058823529411768</c:v>
                </c:pt>
                <c:pt idx="69">
                  <c:v>97.297297297297291</c:v>
                </c:pt>
                <c:pt idx="70">
                  <c:v>97.814207650273218</c:v>
                </c:pt>
                <c:pt idx="71">
                  <c:v>98.795180722891573</c:v>
                </c:pt>
                <c:pt idx="72">
                  <c:v>99.101796407185589</c:v>
                </c:pt>
                <c:pt idx="73">
                  <c:v>99.21259842519683</c:v>
                </c:pt>
                <c:pt idx="74">
                  <c:v>99.259259259259267</c:v>
                </c:pt>
                <c:pt idx="75">
                  <c:v>99.999999999999972</c:v>
                </c:pt>
                <c:pt idx="76">
                  <c:v>100.61728395061726</c:v>
                </c:pt>
                <c:pt idx="77">
                  <c:v>102.00000000000003</c:v>
                </c:pt>
                <c:pt idx="78">
                  <c:v>102.31213872832372</c:v>
                </c:pt>
                <c:pt idx="79">
                  <c:v>102.4390243902439</c:v>
                </c:pt>
                <c:pt idx="80">
                  <c:v>102.43902439024393</c:v>
                </c:pt>
                <c:pt idx="81">
                  <c:v>102.94117647058825</c:v>
                </c:pt>
                <c:pt idx="82">
                  <c:v>102.98507462686568</c:v>
                </c:pt>
                <c:pt idx="83">
                  <c:v>103.57142857142858</c:v>
                </c:pt>
                <c:pt idx="84">
                  <c:v>103.67647058823528</c:v>
                </c:pt>
                <c:pt idx="85">
                  <c:v>104.375</c:v>
                </c:pt>
                <c:pt idx="86">
                  <c:v>105.88235294117648</c:v>
                </c:pt>
                <c:pt idx="87">
                  <c:v>107.19424460431657</c:v>
                </c:pt>
                <c:pt idx="88">
                  <c:v>109.60000000000001</c:v>
                </c:pt>
                <c:pt idx="89">
                  <c:v>110.46511627906976</c:v>
                </c:pt>
                <c:pt idx="90">
                  <c:v>112.29946524064172</c:v>
                </c:pt>
                <c:pt idx="91">
                  <c:v>112.50000000000003</c:v>
                </c:pt>
                <c:pt idx="92">
                  <c:v>112.62135922330098</c:v>
                </c:pt>
                <c:pt idx="93">
                  <c:v>115.17241379310343</c:v>
                </c:pt>
                <c:pt idx="94">
                  <c:v>116.27906976744184</c:v>
                </c:pt>
                <c:pt idx="95">
                  <c:v>12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456960"/>
        <c:axId val="90876160"/>
      </c:scatterChart>
      <c:valAx>
        <c:axId val="19445696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90876160"/>
        <c:crosses val="autoZero"/>
        <c:crossBetween val="midCat"/>
      </c:valAx>
      <c:valAx>
        <c:axId val="90876160"/>
        <c:scaling>
          <c:orientation val="minMax"/>
          <c:max val="12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45696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0179289361317223"/>
          <c:y val="0.62959570092980488"/>
          <c:w val="0.36623943820119587"/>
          <c:h val="7.3328458669663837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989837508280049"/>
          <c:y val="5.1400554097404488E-2"/>
          <c:w val="0.7123806997147607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mic acid'!$D$1</c:f>
              <c:strCache>
                <c:ptCount val="1"/>
                <c:pt idx="0">
                  <c:v>Formic acid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Formic acid'!$B$2:$B$97</c:f>
              <c:strCache>
                <c:ptCount val="96"/>
                <c:pt idx="0">
                  <c:v>H11</c:v>
                </c:pt>
                <c:pt idx="1">
                  <c:v>A7</c:v>
                </c:pt>
                <c:pt idx="2">
                  <c:v>A6</c:v>
                </c:pt>
                <c:pt idx="3">
                  <c:v>B2</c:v>
                </c:pt>
                <c:pt idx="4">
                  <c:v>H1</c:v>
                </c:pt>
                <c:pt idx="5">
                  <c:v>D11</c:v>
                </c:pt>
                <c:pt idx="6">
                  <c:v>F8</c:v>
                </c:pt>
                <c:pt idx="7">
                  <c:v>C6</c:v>
                </c:pt>
                <c:pt idx="8">
                  <c:v>A1</c:v>
                </c:pt>
                <c:pt idx="9">
                  <c:v>G8</c:v>
                </c:pt>
                <c:pt idx="10">
                  <c:v>D12</c:v>
                </c:pt>
                <c:pt idx="11">
                  <c:v>D4</c:v>
                </c:pt>
                <c:pt idx="12">
                  <c:v>E11</c:v>
                </c:pt>
                <c:pt idx="13">
                  <c:v>D7</c:v>
                </c:pt>
                <c:pt idx="14">
                  <c:v>D2</c:v>
                </c:pt>
                <c:pt idx="15">
                  <c:v>A3</c:v>
                </c:pt>
                <c:pt idx="16">
                  <c:v>H3</c:v>
                </c:pt>
                <c:pt idx="17">
                  <c:v>D3</c:v>
                </c:pt>
                <c:pt idx="18">
                  <c:v>E3</c:v>
                </c:pt>
                <c:pt idx="19">
                  <c:v>H9</c:v>
                </c:pt>
                <c:pt idx="20">
                  <c:v>H7</c:v>
                </c:pt>
                <c:pt idx="21">
                  <c:v>H4</c:v>
                </c:pt>
                <c:pt idx="22">
                  <c:v>B7</c:v>
                </c:pt>
                <c:pt idx="23">
                  <c:v>A2</c:v>
                </c:pt>
                <c:pt idx="24">
                  <c:v>C5</c:v>
                </c:pt>
                <c:pt idx="25">
                  <c:v>C7</c:v>
                </c:pt>
                <c:pt idx="26">
                  <c:v>F3</c:v>
                </c:pt>
                <c:pt idx="27">
                  <c:v>F9</c:v>
                </c:pt>
                <c:pt idx="28">
                  <c:v>B6</c:v>
                </c:pt>
                <c:pt idx="29">
                  <c:v>B5</c:v>
                </c:pt>
                <c:pt idx="30">
                  <c:v>B9</c:v>
                </c:pt>
                <c:pt idx="31">
                  <c:v>H2</c:v>
                </c:pt>
                <c:pt idx="32">
                  <c:v>A9</c:v>
                </c:pt>
                <c:pt idx="33">
                  <c:v>D5</c:v>
                </c:pt>
                <c:pt idx="34">
                  <c:v>H10</c:v>
                </c:pt>
                <c:pt idx="35">
                  <c:v>A5</c:v>
                </c:pt>
                <c:pt idx="36">
                  <c:v>C11</c:v>
                </c:pt>
                <c:pt idx="37">
                  <c:v>F11</c:v>
                </c:pt>
                <c:pt idx="38">
                  <c:v>D6</c:v>
                </c:pt>
                <c:pt idx="39">
                  <c:v>E12</c:v>
                </c:pt>
                <c:pt idx="40">
                  <c:v>H8</c:v>
                </c:pt>
                <c:pt idx="41">
                  <c:v>A11</c:v>
                </c:pt>
                <c:pt idx="42">
                  <c:v>E1</c:v>
                </c:pt>
                <c:pt idx="43">
                  <c:v>A4</c:v>
                </c:pt>
                <c:pt idx="44">
                  <c:v>H12</c:v>
                </c:pt>
                <c:pt idx="45">
                  <c:v>E8</c:v>
                </c:pt>
                <c:pt idx="46">
                  <c:v>C1</c:v>
                </c:pt>
                <c:pt idx="47">
                  <c:v>H6</c:v>
                </c:pt>
                <c:pt idx="48">
                  <c:v>C3</c:v>
                </c:pt>
                <c:pt idx="49">
                  <c:v>B10</c:v>
                </c:pt>
                <c:pt idx="50">
                  <c:v>H5</c:v>
                </c:pt>
                <c:pt idx="51">
                  <c:v>F2</c:v>
                </c:pt>
                <c:pt idx="52">
                  <c:v>G1</c:v>
                </c:pt>
                <c:pt idx="53">
                  <c:v>C10</c:v>
                </c:pt>
                <c:pt idx="54">
                  <c:v>C9</c:v>
                </c:pt>
                <c:pt idx="55">
                  <c:v>B8</c:v>
                </c:pt>
                <c:pt idx="56">
                  <c:v>E4</c:v>
                </c:pt>
                <c:pt idx="57">
                  <c:v>F10</c:v>
                </c:pt>
                <c:pt idx="58">
                  <c:v>C8</c:v>
                </c:pt>
                <c:pt idx="59">
                  <c:v>F6</c:v>
                </c:pt>
                <c:pt idx="60">
                  <c:v>F1</c:v>
                </c:pt>
                <c:pt idx="61">
                  <c:v>D1</c:v>
                </c:pt>
                <c:pt idx="62">
                  <c:v>G9</c:v>
                </c:pt>
                <c:pt idx="63">
                  <c:v>F12</c:v>
                </c:pt>
                <c:pt idx="64">
                  <c:v>D8</c:v>
                </c:pt>
                <c:pt idx="65">
                  <c:v>D10</c:v>
                </c:pt>
                <c:pt idx="66">
                  <c:v>G3</c:v>
                </c:pt>
                <c:pt idx="67">
                  <c:v>F4</c:v>
                </c:pt>
                <c:pt idx="68">
                  <c:v>E5</c:v>
                </c:pt>
                <c:pt idx="69">
                  <c:v>A12</c:v>
                </c:pt>
                <c:pt idx="70">
                  <c:v>G4</c:v>
                </c:pt>
                <c:pt idx="71">
                  <c:v>C12</c:v>
                </c:pt>
                <c:pt idx="72">
                  <c:v>C4</c:v>
                </c:pt>
                <c:pt idx="73">
                  <c:v>D9</c:v>
                </c:pt>
                <c:pt idx="74">
                  <c:v>B3</c:v>
                </c:pt>
                <c:pt idx="75">
                  <c:v>A10</c:v>
                </c:pt>
                <c:pt idx="76">
                  <c:v>G2</c:v>
                </c:pt>
                <c:pt idx="77">
                  <c:v>E2</c:v>
                </c:pt>
                <c:pt idx="78">
                  <c:v>A8</c:v>
                </c:pt>
                <c:pt idx="79">
                  <c:v>G11</c:v>
                </c:pt>
                <c:pt idx="80">
                  <c:v>B12</c:v>
                </c:pt>
                <c:pt idx="81">
                  <c:v>F7</c:v>
                </c:pt>
                <c:pt idx="82">
                  <c:v>E6</c:v>
                </c:pt>
                <c:pt idx="83">
                  <c:v>E10</c:v>
                </c:pt>
                <c:pt idx="84">
                  <c:v>G5</c:v>
                </c:pt>
                <c:pt idx="85">
                  <c:v>B11</c:v>
                </c:pt>
                <c:pt idx="86">
                  <c:v>G12</c:v>
                </c:pt>
                <c:pt idx="87">
                  <c:v>E9</c:v>
                </c:pt>
                <c:pt idx="88">
                  <c:v>G10</c:v>
                </c:pt>
                <c:pt idx="89">
                  <c:v>G6</c:v>
                </c:pt>
                <c:pt idx="90">
                  <c:v>C2</c:v>
                </c:pt>
                <c:pt idx="91">
                  <c:v>B1</c:v>
                </c:pt>
                <c:pt idx="92">
                  <c:v>E7</c:v>
                </c:pt>
                <c:pt idx="93">
                  <c:v>G7</c:v>
                </c:pt>
                <c:pt idx="94">
                  <c:v>B4</c:v>
                </c:pt>
                <c:pt idx="95">
                  <c:v>F5</c:v>
                </c:pt>
              </c:strCache>
            </c:strRef>
          </c:xVal>
          <c:yVal>
            <c:numRef>
              <c:f>'Formic acid'!$D$2:$D$97</c:f>
              <c:numCache>
                <c:formatCode>General</c:formatCode>
                <c:ptCount val="96"/>
                <c:pt idx="0">
                  <c:v>63.483146067415717</c:v>
                </c:pt>
                <c:pt idx="1">
                  <c:v>70.974155069582523</c:v>
                </c:pt>
                <c:pt idx="2">
                  <c:v>75</c:v>
                </c:pt>
                <c:pt idx="3">
                  <c:v>76.543209876543187</c:v>
                </c:pt>
                <c:pt idx="4">
                  <c:v>77.319587628865989</c:v>
                </c:pt>
                <c:pt idx="5">
                  <c:v>77.7777777777778</c:v>
                </c:pt>
                <c:pt idx="6">
                  <c:v>78.709677419354847</c:v>
                </c:pt>
                <c:pt idx="7">
                  <c:v>80.701754385964904</c:v>
                </c:pt>
                <c:pt idx="8">
                  <c:v>81.818181818181841</c:v>
                </c:pt>
                <c:pt idx="9">
                  <c:v>82.35294117647058</c:v>
                </c:pt>
                <c:pt idx="10">
                  <c:v>85.034013605442155</c:v>
                </c:pt>
                <c:pt idx="11">
                  <c:v>86.206896551724142</c:v>
                </c:pt>
                <c:pt idx="12">
                  <c:v>87.05035971223019</c:v>
                </c:pt>
                <c:pt idx="13">
                  <c:v>88.554216867469876</c:v>
                </c:pt>
                <c:pt idx="14">
                  <c:v>88.750000000000014</c:v>
                </c:pt>
                <c:pt idx="15">
                  <c:v>88.95348837209302</c:v>
                </c:pt>
                <c:pt idx="16">
                  <c:v>89.075630252100851</c:v>
                </c:pt>
                <c:pt idx="17">
                  <c:v>89.820359281437121</c:v>
                </c:pt>
                <c:pt idx="18">
                  <c:v>90.206185567010294</c:v>
                </c:pt>
                <c:pt idx="19">
                  <c:v>90.24390243902441</c:v>
                </c:pt>
                <c:pt idx="20">
                  <c:v>90.37433155080214</c:v>
                </c:pt>
                <c:pt idx="21">
                  <c:v>90.81632653061223</c:v>
                </c:pt>
                <c:pt idx="22">
                  <c:v>90.853658536585357</c:v>
                </c:pt>
                <c:pt idx="23">
                  <c:v>91.099476439790578</c:v>
                </c:pt>
                <c:pt idx="24">
                  <c:v>91.17647058823529</c:v>
                </c:pt>
                <c:pt idx="25">
                  <c:v>91.390728476821195</c:v>
                </c:pt>
                <c:pt idx="26">
                  <c:v>91.397849462365571</c:v>
                </c:pt>
                <c:pt idx="27">
                  <c:v>91.772151898734151</c:v>
                </c:pt>
                <c:pt idx="28">
                  <c:v>92.546583850931654</c:v>
                </c:pt>
                <c:pt idx="29">
                  <c:v>92.857142857142875</c:v>
                </c:pt>
                <c:pt idx="30">
                  <c:v>92.907801418439718</c:v>
                </c:pt>
                <c:pt idx="31">
                  <c:v>92.972972972972983</c:v>
                </c:pt>
                <c:pt idx="32">
                  <c:v>93.333333333333329</c:v>
                </c:pt>
                <c:pt idx="33">
                  <c:v>93.333333333333329</c:v>
                </c:pt>
                <c:pt idx="34">
                  <c:v>93.377483443708627</c:v>
                </c:pt>
                <c:pt idx="35">
                  <c:v>93.541202672605806</c:v>
                </c:pt>
                <c:pt idx="36">
                  <c:v>93.939393939393952</c:v>
                </c:pt>
                <c:pt idx="37">
                  <c:v>93.984962406015043</c:v>
                </c:pt>
                <c:pt idx="38">
                  <c:v>94.230769230769226</c:v>
                </c:pt>
                <c:pt idx="39">
                  <c:v>94.482758620689651</c:v>
                </c:pt>
                <c:pt idx="40">
                  <c:v>94.652406417112317</c:v>
                </c:pt>
                <c:pt idx="41">
                  <c:v>94.669509594882712</c:v>
                </c:pt>
                <c:pt idx="42">
                  <c:v>95.199999999999989</c:v>
                </c:pt>
                <c:pt idx="43">
                  <c:v>95.29411764705884</c:v>
                </c:pt>
                <c:pt idx="44">
                  <c:v>95.767195767195759</c:v>
                </c:pt>
                <c:pt idx="45">
                  <c:v>95.862068965517238</c:v>
                </c:pt>
                <c:pt idx="46">
                  <c:v>96.551724137931032</c:v>
                </c:pt>
                <c:pt idx="47">
                  <c:v>96.571428571428584</c:v>
                </c:pt>
                <c:pt idx="48">
                  <c:v>96.987951807228924</c:v>
                </c:pt>
                <c:pt idx="49">
                  <c:v>97.037037037037067</c:v>
                </c:pt>
                <c:pt idx="50">
                  <c:v>97.093023255813947</c:v>
                </c:pt>
                <c:pt idx="51">
                  <c:v>98.802395209580837</c:v>
                </c:pt>
                <c:pt idx="52">
                  <c:v>99.193548387096783</c:v>
                </c:pt>
                <c:pt idx="53">
                  <c:v>99.25373134328359</c:v>
                </c:pt>
                <c:pt idx="54">
                  <c:v>99.337748344370851</c:v>
                </c:pt>
                <c:pt idx="55">
                  <c:v>99.390243902439039</c:v>
                </c:pt>
                <c:pt idx="56">
                  <c:v>99.421965317919089</c:v>
                </c:pt>
                <c:pt idx="57">
                  <c:v>100</c:v>
                </c:pt>
                <c:pt idx="58">
                  <c:v>100.00000000000003</c:v>
                </c:pt>
                <c:pt idx="59">
                  <c:v>100.59880239520957</c:v>
                </c:pt>
                <c:pt idx="60">
                  <c:v>100.71942446043165</c:v>
                </c:pt>
                <c:pt idx="61">
                  <c:v>100.74626865671644</c:v>
                </c:pt>
                <c:pt idx="62">
                  <c:v>100.78740157480314</c:v>
                </c:pt>
                <c:pt idx="63">
                  <c:v>101.36054421768705</c:v>
                </c:pt>
                <c:pt idx="64">
                  <c:v>101.80722891566263</c:v>
                </c:pt>
                <c:pt idx="65">
                  <c:v>103.47826086956519</c:v>
                </c:pt>
                <c:pt idx="66">
                  <c:v>103.82513661202186</c:v>
                </c:pt>
                <c:pt idx="67">
                  <c:v>104.04624277456649</c:v>
                </c:pt>
                <c:pt idx="68">
                  <c:v>105.35714285714289</c:v>
                </c:pt>
                <c:pt idx="69">
                  <c:v>105.58252427184469</c:v>
                </c:pt>
                <c:pt idx="70">
                  <c:v>105.71428571428572</c:v>
                </c:pt>
                <c:pt idx="71">
                  <c:v>105.78034682080926</c:v>
                </c:pt>
                <c:pt idx="72">
                  <c:v>105.81395348837211</c:v>
                </c:pt>
                <c:pt idx="73">
                  <c:v>105.83941605839418</c:v>
                </c:pt>
                <c:pt idx="74">
                  <c:v>105.94594594594594</c:v>
                </c:pt>
                <c:pt idx="75">
                  <c:v>105.98802395209579</c:v>
                </c:pt>
                <c:pt idx="76">
                  <c:v>106.17283950617282</c:v>
                </c:pt>
                <c:pt idx="77">
                  <c:v>106.62251655629136</c:v>
                </c:pt>
                <c:pt idx="78">
                  <c:v>106.75944333996024</c:v>
                </c:pt>
                <c:pt idx="79">
                  <c:v>106.80272108843538</c:v>
                </c:pt>
                <c:pt idx="80">
                  <c:v>106.9767441860465</c:v>
                </c:pt>
                <c:pt idx="81">
                  <c:v>108.38709677419357</c:v>
                </c:pt>
                <c:pt idx="82">
                  <c:v>109.375</c:v>
                </c:pt>
                <c:pt idx="83">
                  <c:v>110.81081081081084</c:v>
                </c:pt>
                <c:pt idx="84">
                  <c:v>111.33333333333336</c:v>
                </c:pt>
                <c:pt idx="85">
                  <c:v>112.39669421487602</c:v>
                </c:pt>
                <c:pt idx="86">
                  <c:v>113.33333333333336</c:v>
                </c:pt>
                <c:pt idx="87">
                  <c:v>113.37579617834392</c:v>
                </c:pt>
                <c:pt idx="88">
                  <c:v>113.97058823529413</c:v>
                </c:pt>
                <c:pt idx="89">
                  <c:v>114.18918918918916</c:v>
                </c:pt>
                <c:pt idx="90">
                  <c:v>114.38848920863312</c:v>
                </c:pt>
                <c:pt idx="91">
                  <c:v>116.00000000000001</c:v>
                </c:pt>
                <c:pt idx="92">
                  <c:v>120.68965517241379</c:v>
                </c:pt>
                <c:pt idx="93">
                  <c:v>124.26470588235293</c:v>
                </c:pt>
                <c:pt idx="94">
                  <c:v>129.16666666666669</c:v>
                </c:pt>
                <c:pt idx="95">
                  <c:v>14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556864"/>
        <c:axId val="194453504"/>
      </c:scatterChart>
      <c:valAx>
        <c:axId val="18355686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453504"/>
        <c:crosses val="autoZero"/>
        <c:crossBetween val="midCat"/>
      </c:valAx>
      <c:valAx>
        <c:axId val="194453504"/>
        <c:scaling>
          <c:orientation val="minMax"/>
          <c:max val="12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556864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54381499874050887"/>
          <c:y val="0.57102303230365492"/>
          <c:w val="0.42190884882507457"/>
          <c:h val="0.11957683385728661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19665542726743"/>
          <c:y val="5.1400554097404488E-2"/>
          <c:w val="0.71024360546302923"/>
          <c:h val="0.77539003389343342"/>
        </c:manualLayout>
      </c:layout>
      <c:scatterChart>
        <c:scatterStyle val="lineMarker"/>
        <c:varyColors val="0"/>
        <c:ser>
          <c:idx val="0"/>
          <c:order val="0"/>
          <c:tx>
            <c:strRef>
              <c:f>Furfural!$E$1</c:f>
              <c:strCache>
                <c:ptCount val="1"/>
                <c:pt idx="0">
                  <c:v>Furfural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Furfural!$B$2:$B$97</c:f>
              <c:strCache>
                <c:ptCount val="96"/>
                <c:pt idx="0">
                  <c:v>H1</c:v>
                </c:pt>
                <c:pt idx="1">
                  <c:v>A11</c:v>
                </c:pt>
                <c:pt idx="2">
                  <c:v>A8</c:v>
                </c:pt>
                <c:pt idx="3">
                  <c:v>A6</c:v>
                </c:pt>
                <c:pt idx="4">
                  <c:v>A3</c:v>
                </c:pt>
                <c:pt idx="5">
                  <c:v>A7</c:v>
                </c:pt>
                <c:pt idx="6">
                  <c:v>A9</c:v>
                </c:pt>
                <c:pt idx="7">
                  <c:v>F4</c:v>
                </c:pt>
                <c:pt idx="8">
                  <c:v>A10</c:v>
                </c:pt>
                <c:pt idx="9">
                  <c:v>A12</c:v>
                </c:pt>
                <c:pt idx="10">
                  <c:v>B1</c:v>
                </c:pt>
                <c:pt idx="11">
                  <c:v>A5</c:v>
                </c:pt>
                <c:pt idx="12">
                  <c:v>H11</c:v>
                </c:pt>
                <c:pt idx="13">
                  <c:v>A4</c:v>
                </c:pt>
                <c:pt idx="14">
                  <c:v>B11</c:v>
                </c:pt>
                <c:pt idx="15">
                  <c:v>B9</c:v>
                </c:pt>
                <c:pt idx="16">
                  <c:v>D1</c:v>
                </c:pt>
                <c:pt idx="17">
                  <c:v>B7</c:v>
                </c:pt>
                <c:pt idx="18">
                  <c:v>B8</c:v>
                </c:pt>
                <c:pt idx="19">
                  <c:v>H7</c:v>
                </c:pt>
                <c:pt idx="20">
                  <c:v>A1</c:v>
                </c:pt>
                <c:pt idx="21">
                  <c:v>F1</c:v>
                </c:pt>
                <c:pt idx="22">
                  <c:v>D4</c:v>
                </c:pt>
                <c:pt idx="23">
                  <c:v>E10</c:v>
                </c:pt>
                <c:pt idx="24">
                  <c:v>H12</c:v>
                </c:pt>
                <c:pt idx="25">
                  <c:v>H9</c:v>
                </c:pt>
                <c:pt idx="26">
                  <c:v>E12</c:v>
                </c:pt>
                <c:pt idx="27">
                  <c:v>A2</c:v>
                </c:pt>
                <c:pt idx="28">
                  <c:v>D2</c:v>
                </c:pt>
                <c:pt idx="29">
                  <c:v>H4</c:v>
                </c:pt>
                <c:pt idx="30">
                  <c:v>F5</c:v>
                </c:pt>
                <c:pt idx="31">
                  <c:v>D10</c:v>
                </c:pt>
                <c:pt idx="32">
                  <c:v>B3</c:v>
                </c:pt>
                <c:pt idx="33">
                  <c:v>B6</c:v>
                </c:pt>
                <c:pt idx="34">
                  <c:v>F10</c:v>
                </c:pt>
                <c:pt idx="35">
                  <c:v>D8</c:v>
                </c:pt>
                <c:pt idx="36">
                  <c:v>C1</c:v>
                </c:pt>
                <c:pt idx="37">
                  <c:v>F6</c:v>
                </c:pt>
                <c:pt idx="38">
                  <c:v>H6</c:v>
                </c:pt>
                <c:pt idx="39">
                  <c:v>E1</c:v>
                </c:pt>
                <c:pt idx="40">
                  <c:v>F7</c:v>
                </c:pt>
                <c:pt idx="41">
                  <c:v>G7</c:v>
                </c:pt>
                <c:pt idx="42">
                  <c:v>G3</c:v>
                </c:pt>
                <c:pt idx="43">
                  <c:v>B2</c:v>
                </c:pt>
                <c:pt idx="44">
                  <c:v>D11</c:v>
                </c:pt>
                <c:pt idx="45">
                  <c:v>E3</c:v>
                </c:pt>
                <c:pt idx="46">
                  <c:v>D12</c:v>
                </c:pt>
                <c:pt idx="47">
                  <c:v>F9</c:v>
                </c:pt>
                <c:pt idx="48">
                  <c:v>G11</c:v>
                </c:pt>
                <c:pt idx="49">
                  <c:v>B12</c:v>
                </c:pt>
                <c:pt idx="50">
                  <c:v>C6</c:v>
                </c:pt>
                <c:pt idx="51">
                  <c:v>F11</c:v>
                </c:pt>
                <c:pt idx="52">
                  <c:v>E7</c:v>
                </c:pt>
                <c:pt idx="53">
                  <c:v>H3</c:v>
                </c:pt>
                <c:pt idx="54">
                  <c:v>D7</c:v>
                </c:pt>
                <c:pt idx="55">
                  <c:v>C2</c:v>
                </c:pt>
                <c:pt idx="56">
                  <c:v>H8</c:v>
                </c:pt>
                <c:pt idx="57">
                  <c:v>C10</c:v>
                </c:pt>
                <c:pt idx="58">
                  <c:v>C12</c:v>
                </c:pt>
                <c:pt idx="59">
                  <c:v>F8</c:v>
                </c:pt>
                <c:pt idx="60">
                  <c:v>H2</c:v>
                </c:pt>
                <c:pt idx="61">
                  <c:v>G1</c:v>
                </c:pt>
                <c:pt idx="62">
                  <c:v>D5</c:v>
                </c:pt>
                <c:pt idx="63">
                  <c:v>D6</c:v>
                </c:pt>
                <c:pt idx="64">
                  <c:v>H5</c:v>
                </c:pt>
                <c:pt idx="65">
                  <c:v>C8</c:v>
                </c:pt>
                <c:pt idx="66">
                  <c:v>F12</c:v>
                </c:pt>
                <c:pt idx="67">
                  <c:v>G12</c:v>
                </c:pt>
                <c:pt idx="68">
                  <c:v>F3</c:v>
                </c:pt>
                <c:pt idx="69">
                  <c:v>B5</c:v>
                </c:pt>
                <c:pt idx="70">
                  <c:v>C9</c:v>
                </c:pt>
                <c:pt idx="71">
                  <c:v>D9</c:v>
                </c:pt>
                <c:pt idx="72">
                  <c:v>D3</c:v>
                </c:pt>
                <c:pt idx="73">
                  <c:v>G10</c:v>
                </c:pt>
                <c:pt idx="74">
                  <c:v>B4</c:v>
                </c:pt>
                <c:pt idx="75">
                  <c:v>G6</c:v>
                </c:pt>
                <c:pt idx="76">
                  <c:v>H10</c:v>
                </c:pt>
                <c:pt idx="77">
                  <c:v>E9</c:v>
                </c:pt>
                <c:pt idx="78">
                  <c:v>F2</c:v>
                </c:pt>
                <c:pt idx="79">
                  <c:v>G2</c:v>
                </c:pt>
                <c:pt idx="80">
                  <c:v>E5</c:v>
                </c:pt>
                <c:pt idx="81">
                  <c:v>G8</c:v>
                </c:pt>
                <c:pt idx="82">
                  <c:v>C7</c:v>
                </c:pt>
                <c:pt idx="83">
                  <c:v>E11</c:v>
                </c:pt>
                <c:pt idx="84">
                  <c:v>C4</c:v>
                </c:pt>
                <c:pt idx="85">
                  <c:v>B10</c:v>
                </c:pt>
                <c:pt idx="86">
                  <c:v>C11</c:v>
                </c:pt>
                <c:pt idx="87">
                  <c:v>G9</c:v>
                </c:pt>
                <c:pt idx="88">
                  <c:v>G5</c:v>
                </c:pt>
                <c:pt idx="89">
                  <c:v>C5</c:v>
                </c:pt>
                <c:pt idx="90">
                  <c:v>C3</c:v>
                </c:pt>
                <c:pt idx="91">
                  <c:v>E6</c:v>
                </c:pt>
                <c:pt idx="92">
                  <c:v>E4</c:v>
                </c:pt>
                <c:pt idx="93">
                  <c:v>G4</c:v>
                </c:pt>
                <c:pt idx="94">
                  <c:v>E8</c:v>
                </c:pt>
                <c:pt idx="95">
                  <c:v>E2</c:v>
                </c:pt>
              </c:strCache>
            </c:strRef>
          </c:xVal>
          <c:yVal>
            <c:numRef>
              <c:f>Furfural!$E$2:$E$97</c:f>
              <c:numCache>
                <c:formatCode>General</c:formatCode>
                <c:ptCount val="96"/>
                <c:pt idx="0">
                  <c:v>40.354838709677402</c:v>
                </c:pt>
                <c:pt idx="1">
                  <c:v>57.276119402985096</c:v>
                </c:pt>
                <c:pt idx="2">
                  <c:v>62.035225048923692</c:v>
                </c:pt>
                <c:pt idx="3">
                  <c:v>63.187855787476252</c:v>
                </c:pt>
                <c:pt idx="4">
                  <c:v>63.976377952755904</c:v>
                </c:pt>
                <c:pt idx="5">
                  <c:v>64.299424184261028</c:v>
                </c:pt>
                <c:pt idx="6">
                  <c:v>66.666666666666671</c:v>
                </c:pt>
                <c:pt idx="7">
                  <c:v>69.512195121951208</c:v>
                </c:pt>
                <c:pt idx="8">
                  <c:v>70.071684587813621</c:v>
                </c:pt>
                <c:pt idx="9">
                  <c:v>70.175438596491247</c:v>
                </c:pt>
                <c:pt idx="10">
                  <c:v>70.895522388059717</c:v>
                </c:pt>
                <c:pt idx="11">
                  <c:v>72.661870503597129</c:v>
                </c:pt>
                <c:pt idx="12">
                  <c:v>72.811059907834093</c:v>
                </c:pt>
                <c:pt idx="13">
                  <c:v>73.118279569892479</c:v>
                </c:pt>
                <c:pt idx="14">
                  <c:v>73.714285714285694</c:v>
                </c:pt>
                <c:pt idx="15">
                  <c:v>73.71794871794873</c:v>
                </c:pt>
                <c:pt idx="16">
                  <c:v>74.149659863945573</c:v>
                </c:pt>
                <c:pt idx="17">
                  <c:v>75.000000000000014</c:v>
                </c:pt>
                <c:pt idx="18">
                  <c:v>76.666666666666671</c:v>
                </c:pt>
                <c:pt idx="19">
                  <c:v>77.027027027027017</c:v>
                </c:pt>
                <c:pt idx="20">
                  <c:v>77.662337662337649</c:v>
                </c:pt>
                <c:pt idx="21">
                  <c:v>77.86259541984731</c:v>
                </c:pt>
                <c:pt idx="22">
                  <c:v>79.285714285714278</c:v>
                </c:pt>
                <c:pt idx="23">
                  <c:v>79.629629629629619</c:v>
                </c:pt>
                <c:pt idx="24">
                  <c:v>79.899497487437188</c:v>
                </c:pt>
                <c:pt idx="25">
                  <c:v>79.904306220095705</c:v>
                </c:pt>
                <c:pt idx="26">
                  <c:v>80</c:v>
                </c:pt>
                <c:pt idx="27">
                  <c:v>80.041580041580033</c:v>
                </c:pt>
                <c:pt idx="28">
                  <c:v>80.555555555555557</c:v>
                </c:pt>
                <c:pt idx="29">
                  <c:v>80.882352941176478</c:v>
                </c:pt>
                <c:pt idx="30">
                  <c:v>81.325301204819283</c:v>
                </c:pt>
                <c:pt idx="31">
                  <c:v>81.714285714285722</c:v>
                </c:pt>
                <c:pt idx="32">
                  <c:v>81.764705882352956</c:v>
                </c:pt>
                <c:pt idx="33">
                  <c:v>82.098765432098773</c:v>
                </c:pt>
                <c:pt idx="34">
                  <c:v>82.198952879581142</c:v>
                </c:pt>
                <c:pt idx="35">
                  <c:v>82.758620689655174</c:v>
                </c:pt>
                <c:pt idx="36">
                  <c:v>82.78145695364239</c:v>
                </c:pt>
                <c:pt idx="37">
                  <c:v>82.84023668639054</c:v>
                </c:pt>
                <c:pt idx="38">
                  <c:v>83.000000000000014</c:v>
                </c:pt>
                <c:pt idx="39">
                  <c:v>83.333333333333343</c:v>
                </c:pt>
                <c:pt idx="40">
                  <c:v>84.745762711864401</c:v>
                </c:pt>
                <c:pt idx="41">
                  <c:v>84.831460674157299</c:v>
                </c:pt>
                <c:pt idx="42">
                  <c:v>85.22727272727272</c:v>
                </c:pt>
                <c:pt idx="43">
                  <c:v>85.256410256410277</c:v>
                </c:pt>
                <c:pt idx="44">
                  <c:v>85.38011695906431</c:v>
                </c:pt>
                <c:pt idx="45">
                  <c:v>85.53459119496857</c:v>
                </c:pt>
                <c:pt idx="46">
                  <c:v>85.620915032679719</c:v>
                </c:pt>
                <c:pt idx="47">
                  <c:v>85.628742514970043</c:v>
                </c:pt>
                <c:pt idx="48">
                  <c:v>85.714285714285722</c:v>
                </c:pt>
                <c:pt idx="49">
                  <c:v>85.975609756097569</c:v>
                </c:pt>
                <c:pt idx="50">
                  <c:v>86</c:v>
                </c:pt>
                <c:pt idx="51">
                  <c:v>86.503067484662594</c:v>
                </c:pt>
                <c:pt idx="52">
                  <c:v>87.179487179487182</c:v>
                </c:pt>
                <c:pt idx="53">
                  <c:v>87.391304347826093</c:v>
                </c:pt>
                <c:pt idx="54">
                  <c:v>87.425149700598809</c:v>
                </c:pt>
                <c:pt idx="55">
                  <c:v>87.581699346405244</c:v>
                </c:pt>
                <c:pt idx="56">
                  <c:v>88.177339901477851</c:v>
                </c:pt>
                <c:pt idx="57">
                  <c:v>88.271604938271579</c:v>
                </c:pt>
                <c:pt idx="58">
                  <c:v>88.811188811188828</c:v>
                </c:pt>
                <c:pt idx="59">
                  <c:v>89.349112426035532</c:v>
                </c:pt>
                <c:pt idx="60">
                  <c:v>89.523809523809518</c:v>
                </c:pt>
                <c:pt idx="61">
                  <c:v>89.743589743589723</c:v>
                </c:pt>
                <c:pt idx="62">
                  <c:v>90.131578947368425</c:v>
                </c:pt>
                <c:pt idx="63">
                  <c:v>90.344827586206904</c:v>
                </c:pt>
                <c:pt idx="64">
                  <c:v>90.5</c:v>
                </c:pt>
                <c:pt idx="65">
                  <c:v>90.714285714285708</c:v>
                </c:pt>
                <c:pt idx="66">
                  <c:v>90.78947368421052</c:v>
                </c:pt>
                <c:pt idx="67">
                  <c:v>90.963855421686745</c:v>
                </c:pt>
                <c:pt idx="68">
                  <c:v>90.967741935483886</c:v>
                </c:pt>
                <c:pt idx="69">
                  <c:v>91.071428571428569</c:v>
                </c:pt>
                <c:pt idx="70">
                  <c:v>91.082802547770711</c:v>
                </c:pt>
                <c:pt idx="71">
                  <c:v>91.304347826086939</c:v>
                </c:pt>
                <c:pt idx="72">
                  <c:v>91.411042944785265</c:v>
                </c:pt>
                <c:pt idx="73">
                  <c:v>91.84782608695653</c:v>
                </c:pt>
                <c:pt idx="74">
                  <c:v>91.85185185185189</c:v>
                </c:pt>
                <c:pt idx="75">
                  <c:v>92.261904761904773</c:v>
                </c:pt>
                <c:pt idx="76">
                  <c:v>92.462311557788937</c:v>
                </c:pt>
                <c:pt idx="77">
                  <c:v>92.76315789473685</c:v>
                </c:pt>
                <c:pt idx="78">
                  <c:v>93.103448275862064</c:v>
                </c:pt>
                <c:pt idx="79">
                  <c:v>93.491124260355036</c:v>
                </c:pt>
                <c:pt idx="80">
                  <c:v>93.661971830985934</c:v>
                </c:pt>
                <c:pt idx="81">
                  <c:v>94.078947368421041</c:v>
                </c:pt>
                <c:pt idx="82">
                  <c:v>94.30379746835446</c:v>
                </c:pt>
                <c:pt idx="83">
                  <c:v>94.444444444444429</c:v>
                </c:pt>
                <c:pt idx="84">
                  <c:v>94.696969696969717</c:v>
                </c:pt>
                <c:pt idx="85">
                  <c:v>94.87179487179489</c:v>
                </c:pt>
                <c:pt idx="86">
                  <c:v>96.078431372549034</c:v>
                </c:pt>
                <c:pt idx="87">
                  <c:v>96.428571428571431</c:v>
                </c:pt>
                <c:pt idx="88">
                  <c:v>96.491228070175438</c:v>
                </c:pt>
                <c:pt idx="89">
                  <c:v>96.527777777777757</c:v>
                </c:pt>
                <c:pt idx="90">
                  <c:v>96.575342465753437</c:v>
                </c:pt>
                <c:pt idx="91">
                  <c:v>97.385620915032675</c:v>
                </c:pt>
                <c:pt idx="92">
                  <c:v>98.571428571428584</c:v>
                </c:pt>
                <c:pt idx="93">
                  <c:v>99.390243902439039</c:v>
                </c:pt>
                <c:pt idx="94">
                  <c:v>100</c:v>
                </c:pt>
                <c:pt idx="95">
                  <c:v>10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458112"/>
        <c:axId val="194458688"/>
      </c:scatterChart>
      <c:valAx>
        <c:axId val="19445811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458688"/>
        <c:crosses val="autoZero"/>
        <c:crossBetween val="midCat"/>
      </c:valAx>
      <c:valAx>
        <c:axId val="194458688"/>
        <c:scaling>
          <c:orientation val="minMax"/>
          <c:max val="10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458112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7453722625251189"/>
          <c:y val="0.56800557704561483"/>
          <c:w val="0.26598761963148393"/>
          <c:h val="6.8476542804212726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51790046596409"/>
          <c:y val="5.1400554097404488E-2"/>
          <c:w val="0.73717194780688811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HMF!$F$1</c:f>
              <c:strCache>
                <c:ptCount val="1"/>
                <c:pt idx="0">
                  <c:v>HMF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HMF!$B$2:$B$97</c:f>
              <c:strCache>
                <c:ptCount val="96"/>
                <c:pt idx="0">
                  <c:v>B7</c:v>
                </c:pt>
                <c:pt idx="1">
                  <c:v>H12</c:v>
                </c:pt>
                <c:pt idx="2">
                  <c:v>D7</c:v>
                </c:pt>
                <c:pt idx="3">
                  <c:v>H4</c:v>
                </c:pt>
                <c:pt idx="4">
                  <c:v>H11</c:v>
                </c:pt>
                <c:pt idx="5">
                  <c:v>C9</c:v>
                </c:pt>
                <c:pt idx="6">
                  <c:v>B9</c:v>
                </c:pt>
                <c:pt idx="7">
                  <c:v>C2</c:v>
                </c:pt>
                <c:pt idx="8">
                  <c:v>F8</c:v>
                </c:pt>
                <c:pt idx="9">
                  <c:v>C1</c:v>
                </c:pt>
                <c:pt idx="10">
                  <c:v>D8</c:v>
                </c:pt>
                <c:pt idx="11">
                  <c:v>H3</c:v>
                </c:pt>
                <c:pt idx="12">
                  <c:v>A8</c:v>
                </c:pt>
                <c:pt idx="13">
                  <c:v>F5</c:v>
                </c:pt>
                <c:pt idx="14">
                  <c:v>F9</c:v>
                </c:pt>
                <c:pt idx="15">
                  <c:v>H6</c:v>
                </c:pt>
                <c:pt idx="16">
                  <c:v>H9</c:v>
                </c:pt>
                <c:pt idx="17">
                  <c:v>H2</c:v>
                </c:pt>
                <c:pt idx="18">
                  <c:v>B3</c:v>
                </c:pt>
                <c:pt idx="19">
                  <c:v>A10</c:v>
                </c:pt>
                <c:pt idx="20">
                  <c:v>B11</c:v>
                </c:pt>
                <c:pt idx="21">
                  <c:v>D11</c:v>
                </c:pt>
                <c:pt idx="22">
                  <c:v>F6</c:v>
                </c:pt>
                <c:pt idx="23">
                  <c:v>H8</c:v>
                </c:pt>
                <c:pt idx="24">
                  <c:v>D1</c:v>
                </c:pt>
                <c:pt idx="25">
                  <c:v>A1</c:v>
                </c:pt>
                <c:pt idx="26">
                  <c:v>B6</c:v>
                </c:pt>
                <c:pt idx="27">
                  <c:v>F2</c:v>
                </c:pt>
                <c:pt idx="28">
                  <c:v>F11</c:v>
                </c:pt>
                <c:pt idx="29">
                  <c:v>H7</c:v>
                </c:pt>
                <c:pt idx="30">
                  <c:v>A5</c:v>
                </c:pt>
                <c:pt idx="31">
                  <c:v>A6</c:v>
                </c:pt>
                <c:pt idx="32">
                  <c:v>A11</c:v>
                </c:pt>
                <c:pt idx="33">
                  <c:v>A12</c:v>
                </c:pt>
                <c:pt idx="34">
                  <c:v>E12</c:v>
                </c:pt>
                <c:pt idx="35">
                  <c:v>B12</c:v>
                </c:pt>
                <c:pt idx="36">
                  <c:v>B2</c:v>
                </c:pt>
                <c:pt idx="37">
                  <c:v>A7</c:v>
                </c:pt>
                <c:pt idx="38">
                  <c:v>E3</c:v>
                </c:pt>
                <c:pt idx="39">
                  <c:v>E10</c:v>
                </c:pt>
                <c:pt idx="40">
                  <c:v>F7</c:v>
                </c:pt>
                <c:pt idx="41">
                  <c:v>A2</c:v>
                </c:pt>
                <c:pt idx="42">
                  <c:v>D10</c:v>
                </c:pt>
                <c:pt idx="43">
                  <c:v>G3</c:v>
                </c:pt>
                <c:pt idx="44">
                  <c:v>H5</c:v>
                </c:pt>
                <c:pt idx="45">
                  <c:v>C12</c:v>
                </c:pt>
                <c:pt idx="46">
                  <c:v>G7</c:v>
                </c:pt>
                <c:pt idx="47">
                  <c:v>H10</c:v>
                </c:pt>
                <c:pt idx="48">
                  <c:v>E7</c:v>
                </c:pt>
                <c:pt idx="49">
                  <c:v>B8</c:v>
                </c:pt>
                <c:pt idx="50">
                  <c:v>H1</c:v>
                </c:pt>
                <c:pt idx="51">
                  <c:v>D9</c:v>
                </c:pt>
                <c:pt idx="52">
                  <c:v>B1</c:v>
                </c:pt>
                <c:pt idx="53">
                  <c:v>E11</c:v>
                </c:pt>
                <c:pt idx="54">
                  <c:v>G5</c:v>
                </c:pt>
                <c:pt idx="55">
                  <c:v>F3</c:v>
                </c:pt>
                <c:pt idx="56">
                  <c:v>E1</c:v>
                </c:pt>
                <c:pt idx="57">
                  <c:v>A3</c:v>
                </c:pt>
                <c:pt idx="58">
                  <c:v>C8</c:v>
                </c:pt>
                <c:pt idx="59">
                  <c:v>D5</c:v>
                </c:pt>
                <c:pt idx="60">
                  <c:v>F10</c:v>
                </c:pt>
                <c:pt idx="61">
                  <c:v>C7</c:v>
                </c:pt>
                <c:pt idx="62">
                  <c:v>F4</c:v>
                </c:pt>
                <c:pt idx="63">
                  <c:v>A9</c:v>
                </c:pt>
                <c:pt idx="64">
                  <c:v>G2</c:v>
                </c:pt>
                <c:pt idx="65">
                  <c:v>D2</c:v>
                </c:pt>
                <c:pt idx="66">
                  <c:v>F12</c:v>
                </c:pt>
                <c:pt idx="67">
                  <c:v>G12</c:v>
                </c:pt>
                <c:pt idx="68">
                  <c:v>D3</c:v>
                </c:pt>
                <c:pt idx="69">
                  <c:v>G6</c:v>
                </c:pt>
                <c:pt idx="70">
                  <c:v>D12</c:v>
                </c:pt>
                <c:pt idx="71">
                  <c:v>E6</c:v>
                </c:pt>
                <c:pt idx="72">
                  <c:v>C10</c:v>
                </c:pt>
                <c:pt idx="73">
                  <c:v>E2</c:v>
                </c:pt>
                <c:pt idx="74">
                  <c:v>G8</c:v>
                </c:pt>
                <c:pt idx="75">
                  <c:v>E9</c:v>
                </c:pt>
                <c:pt idx="76">
                  <c:v>B10</c:v>
                </c:pt>
                <c:pt idx="77">
                  <c:v>C3</c:v>
                </c:pt>
                <c:pt idx="78">
                  <c:v>C11</c:v>
                </c:pt>
                <c:pt idx="79">
                  <c:v>A4</c:v>
                </c:pt>
                <c:pt idx="80">
                  <c:v>G4</c:v>
                </c:pt>
                <c:pt idx="81">
                  <c:v>C5</c:v>
                </c:pt>
                <c:pt idx="82">
                  <c:v>G9</c:v>
                </c:pt>
                <c:pt idx="83">
                  <c:v>E5</c:v>
                </c:pt>
                <c:pt idx="84">
                  <c:v>D6</c:v>
                </c:pt>
                <c:pt idx="85">
                  <c:v>C6</c:v>
                </c:pt>
                <c:pt idx="86">
                  <c:v>G11</c:v>
                </c:pt>
                <c:pt idx="87">
                  <c:v>G10</c:v>
                </c:pt>
                <c:pt idx="88">
                  <c:v>B5</c:v>
                </c:pt>
                <c:pt idx="89">
                  <c:v>E4</c:v>
                </c:pt>
                <c:pt idx="90">
                  <c:v>E8</c:v>
                </c:pt>
                <c:pt idx="91">
                  <c:v>D4</c:v>
                </c:pt>
                <c:pt idx="92">
                  <c:v>F1</c:v>
                </c:pt>
                <c:pt idx="93">
                  <c:v>G1</c:v>
                </c:pt>
                <c:pt idx="94">
                  <c:v>B4</c:v>
                </c:pt>
                <c:pt idx="95">
                  <c:v>C4</c:v>
                </c:pt>
              </c:strCache>
            </c:strRef>
          </c:xVal>
          <c:yVal>
            <c:numRef>
              <c:f>HMF!$F$2:$F$97</c:f>
              <c:numCache>
                <c:formatCode>General</c:formatCode>
                <c:ptCount val="96"/>
                <c:pt idx="0">
                  <c:v>55.20833333333335</c:v>
                </c:pt>
                <c:pt idx="1">
                  <c:v>58.793969849246231</c:v>
                </c:pt>
                <c:pt idx="2">
                  <c:v>59.281437125748518</c:v>
                </c:pt>
                <c:pt idx="3">
                  <c:v>67.647058823529406</c:v>
                </c:pt>
                <c:pt idx="4">
                  <c:v>70.046082949308754</c:v>
                </c:pt>
                <c:pt idx="5">
                  <c:v>70.70063694267516</c:v>
                </c:pt>
                <c:pt idx="6">
                  <c:v>73.076923076923066</c:v>
                </c:pt>
                <c:pt idx="7">
                  <c:v>76.470588235294144</c:v>
                </c:pt>
                <c:pt idx="8">
                  <c:v>76.92307692307692</c:v>
                </c:pt>
                <c:pt idx="9">
                  <c:v>77.483443708609272</c:v>
                </c:pt>
                <c:pt idx="10">
                  <c:v>77.58620689655173</c:v>
                </c:pt>
                <c:pt idx="11">
                  <c:v>77.826086956521749</c:v>
                </c:pt>
                <c:pt idx="12">
                  <c:v>78.082191780821915</c:v>
                </c:pt>
                <c:pt idx="13">
                  <c:v>78.313253012048207</c:v>
                </c:pt>
                <c:pt idx="14">
                  <c:v>78.443113772455078</c:v>
                </c:pt>
                <c:pt idx="15">
                  <c:v>79.500000000000028</c:v>
                </c:pt>
                <c:pt idx="16">
                  <c:v>79.904306220095705</c:v>
                </c:pt>
                <c:pt idx="17">
                  <c:v>80.476190476190467</c:v>
                </c:pt>
                <c:pt idx="18">
                  <c:v>80.588235294117652</c:v>
                </c:pt>
                <c:pt idx="19">
                  <c:v>80.645161290322577</c:v>
                </c:pt>
                <c:pt idx="20">
                  <c:v>81.71428571428568</c:v>
                </c:pt>
                <c:pt idx="21">
                  <c:v>81.871345029239777</c:v>
                </c:pt>
                <c:pt idx="22">
                  <c:v>82.248520710059168</c:v>
                </c:pt>
                <c:pt idx="23">
                  <c:v>82.266009852216754</c:v>
                </c:pt>
                <c:pt idx="24">
                  <c:v>82.312925170068013</c:v>
                </c:pt>
                <c:pt idx="25">
                  <c:v>82.597402597402606</c:v>
                </c:pt>
                <c:pt idx="26">
                  <c:v>82.716049382716065</c:v>
                </c:pt>
                <c:pt idx="27">
                  <c:v>82.758620689655189</c:v>
                </c:pt>
                <c:pt idx="28">
                  <c:v>82.822085889570559</c:v>
                </c:pt>
                <c:pt idx="29">
                  <c:v>82.882882882882896</c:v>
                </c:pt>
                <c:pt idx="30">
                  <c:v>83.093525179856115</c:v>
                </c:pt>
                <c:pt idx="31">
                  <c:v>83.111954459203034</c:v>
                </c:pt>
                <c:pt idx="32">
                  <c:v>83.395522388059689</c:v>
                </c:pt>
                <c:pt idx="33">
                  <c:v>83.458646616541358</c:v>
                </c:pt>
                <c:pt idx="34">
                  <c:v>83.999999999999972</c:v>
                </c:pt>
                <c:pt idx="35">
                  <c:v>84.146341463414657</c:v>
                </c:pt>
                <c:pt idx="36">
                  <c:v>85.256410256410277</c:v>
                </c:pt>
                <c:pt idx="37">
                  <c:v>85.79654510556621</c:v>
                </c:pt>
                <c:pt idx="38">
                  <c:v>86.163522012578639</c:v>
                </c:pt>
                <c:pt idx="39">
                  <c:v>86.41975308641976</c:v>
                </c:pt>
                <c:pt idx="40">
                  <c:v>86.440677966101703</c:v>
                </c:pt>
                <c:pt idx="41">
                  <c:v>86.694386694386694</c:v>
                </c:pt>
                <c:pt idx="42">
                  <c:v>86.857142857142875</c:v>
                </c:pt>
                <c:pt idx="43">
                  <c:v>87.499999999999986</c:v>
                </c:pt>
                <c:pt idx="44">
                  <c:v>88.000000000000028</c:v>
                </c:pt>
                <c:pt idx="45">
                  <c:v>88.111888111888106</c:v>
                </c:pt>
                <c:pt idx="46">
                  <c:v>88.202247191011239</c:v>
                </c:pt>
                <c:pt idx="47">
                  <c:v>88.44221105527636</c:v>
                </c:pt>
                <c:pt idx="48">
                  <c:v>88.461538461538467</c:v>
                </c:pt>
                <c:pt idx="49">
                  <c:v>88.666666666666671</c:v>
                </c:pt>
                <c:pt idx="50">
                  <c:v>89.032258064516128</c:v>
                </c:pt>
                <c:pt idx="51">
                  <c:v>89.130434782608688</c:v>
                </c:pt>
                <c:pt idx="52">
                  <c:v>89.552238805970148</c:v>
                </c:pt>
                <c:pt idx="53">
                  <c:v>89.583333333333343</c:v>
                </c:pt>
                <c:pt idx="54">
                  <c:v>90.058479532163744</c:v>
                </c:pt>
                <c:pt idx="55">
                  <c:v>90.322580645161267</c:v>
                </c:pt>
                <c:pt idx="56">
                  <c:v>90.740740740740762</c:v>
                </c:pt>
                <c:pt idx="57">
                  <c:v>90.944881889763778</c:v>
                </c:pt>
                <c:pt idx="58">
                  <c:v>91.428571428571431</c:v>
                </c:pt>
                <c:pt idx="59">
                  <c:v>91.447368421052644</c:v>
                </c:pt>
                <c:pt idx="60">
                  <c:v>91.623036649214654</c:v>
                </c:pt>
                <c:pt idx="61">
                  <c:v>91.772151898734194</c:v>
                </c:pt>
                <c:pt idx="62">
                  <c:v>92.073170731707307</c:v>
                </c:pt>
                <c:pt idx="63">
                  <c:v>92.156862745098024</c:v>
                </c:pt>
                <c:pt idx="64">
                  <c:v>92.307692307692307</c:v>
                </c:pt>
                <c:pt idx="65">
                  <c:v>92.3611111111111</c:v>
                </c:pt>
                <c:pt idx="66">
                  <c:v>92.763157894736864</c:v>
                </c:pt>
                <c:pt idx="67">
                  <c:v>92.771084337349393</c:v>
                </c:pt>
                <c:pt idx="68">
                  <c:v>93.251533742331276</c:v>
                </c:pt>
                <c:pt idx="69">
                  <c:v>93.452380952380949</c:v>
                </c:pt>
                <c:pt idx="70">
                  <c:v>93.46405228758168</c:v>
                </c:pt>
                <c:pt idx="71">
                  <c:v>93.464052287581694</c:v>
                </c:pt>
                <c:pt idx="72">
                  <c:v>93.827160493827151</c:v>
                </c:pt>
                <c:pt idx="73">
                  <c:v>94.039735099337761</c:v>
                </c:pt>
                <c:pt idx="74">
                  <c:v>94.078947368421055</c:v>
                </c:pt>
                <c:pt idx="75">
                  <c:v>94.078947368421069</c:v>
                </c:pt>
                <c:pt idx="76">
                  <c:v>94.230769230769226</c:v>
                </c:pt>
                <c:pt idx="77">
                  <c:v>94.520547945205479</c:v>
                </c:pt>
                <c:pt idx="78">
                  <c:v>94.771241830065392</c:v>
                </c:pt>
                <c:pt idx="79">
                  <c:v>94.838709677419359</c:v>
                </c:pt>
                <c:pt idx="80">
                  <c:v>95.121951219512198</c:v>
                </c:pt>
                <c:pt idx="81">
                  <c:v>95.138888888888886</c:v>
                </c:pt>
                <c:pt idx="82">
                  <c:v>95.714285714285722</c:v>
                </c:pt>
                <c:pt idx="83">
                  <c:v>95.774647887323965</c:v>
                </c:pt>
                <c:pt idx="84">
                  <c:v>95.862068965517224</c:v>
                </c:pt>
                <c:pt idx="85">
                  <c:v>96</c:v>
                </c:pt>
                <c:pt idx="86">
                  <c:v>96.273291925465827</c:v>
                </c:pt>
                <c:pt idx="87">
                  <c:v>97.282608695652172</c:v>
                </c:pt>
                <c:pt idx="88">
                  <c:v>97.61904761904762</c:v>
                </c:pt>
                <c:pt idx="89">
                  <c:v>97.857142857142875</c:v>
                </c:pt>
                <c:pt idx="90">
                  <c:v>100</c:v>
                </c:pt>
                <c:pt idx="91">
                  <c:v>104.28571428571429</c:v>
                </c:pt>
                <c:pt idx="92">
                  <c:v>104.58015267175573</c:v>
                </c:pt>
                <c:pt idx="93">
                  <c:v>108.54700854700855</c:v>
                </c:pt>
                <c:pt idx="94">
                  <c:v>110.37037037037041</c:v>
                </c:pt>
                <c:pt idx="95">
                  <c:v>115.909090909090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478080"/>
        <c:axId val="194478656"/>
      </c:scatterChart>
      <c:valAx>
        <c:axId val="19447808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478656"/>
        <c:crosses val="autoZero"/>
        <c:crossBetween val="midCat"/>
      </c:valAx>
      <c:valAx>
        <c:axId val="194478656"/>
        <c:scaling>
          <c:orientation val="minMax"/>
          <c:max val="12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47808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74344457209606818"/>
          <c:y val="0.64260088826109263"/>
          <c:w val="0.18523275740343761"/>
          <c:h val="7.5935015157046037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68909803672607"/>
          <c:y val="5.1400554097404488E-2"/>
          <c:w val="0.70475383687526783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Vanillin!$G$1</c:f>
              <c:strCache>
                <c:ptCount val="1"/>
                <c:pt idx="0">
                  <c:v>Vanillin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Vanillin!$B$2:$B$97</c:f>
              <c:strCache>
                <c:ptCount val="96"/>
                <c:pt idx="0">
                  <c:v>D7</c:v>
                </c:pt>
                <c:pt idx="1">
                  <c:v>B7</c:v>
                </c:pt>
                <c:pt idx="2">
                  <c:v>G12</c:v>
                </c:pt>
                <c:pt idx="3">
                  <c:v>A12</c:v>
                </c:pt>
                <c:pt idx="4">
                  <c:v>A11</c:v>
                </c:pt>
                <c:pt idx="5">
                  <c:v>B11</c:v>
                </c:pt>
                <c:pt idx="6">
                  <c:v>H11</c:v>
                </c:pt>
                <c:pt idx="7">
                  <c:v>F8</c:v>
                </c:pt>
                <c:pt idx="8">
                  <c:v>F9</c:v>
                </c:pt>
                <c:pt idx="9">
                  <c:v>C1</c:v>
                </c:pt>
                <c:pt idx="10">
                  <c:v>D12</c:v>
                </c:pt>
                <c:pt idx="11">
                  <c:v>F1</c:v>
                </c:pt>
                <c:pt idx="12">
                  <c:v>G9</c:v>
                </c:pt>
                <c:pt idx="13">
                  <c:v>A8</c:v>
                </c:pt>
                <c:pt idx="14">
                  <c:v>H7</c:v>
                </c:pt>
                <c:pt idx="15">
                  <c:v>A7</c:v>
                </c:pt>
                <c:pt idx="16">
                  <c:v>G7</c:v>
                </c:pt>
                <c:pt idx="17">
                  <c:v>A3</c:v>
                </c:pt>
                <c:pt idx="18">
                  <c:v>F11</c:v>
                </c:pt>
                <c:pt idx="19">
                  <c:v>B3</c:v>
                </c:pt>
                <c:pt idx="20">
                  <c:v>G11</c:v>
                </c:pt>
                <c:pt idx="21">
                  <c:v>E6</c:v>
                </c:pt>
                <c:pt idx="22">
                  <c:v>G3</c:v>
                </c:pt>
                <c:pt idx="23">
                  <c:v>H3</c:v>
                </c:pt>
                <c:pt idx="24">
                  <c:v>D8</c:v>
                </c:pt>
                <c:pt idx="25">
                  <c:v>H9</c:v>
                </c:pt>
                <c:pt idx="26">
                  <c:v>H1</c:v>
                </c:pt>
                <c:pt idx="27">
                  <c:v>C9</c:v>
                </c:pt>
                <c:pt idx="28">
                  <c:v>F4</c:v>
                </c:pt>
                <c:pt idx="29">
                  <c:v>H12</c:v>
                </c:pt>
                <c:pt idx="30">
                  <c:v>H8</c:v>
                </c:pt>
                <c:pt idx="31">
                  <c:v>D9</c:v>
                </c:pt>
                <c:pt idx="32">
                  <c:v>E7</c:v>
                </c:pt>
                <c:pt idx="33">
                  <c:v>B1</c:v>
                </c:pt>
                <c:pt idx="34">
                  <c:v>D4</c:v>
                </c:pt>
                <c:pt idx="35">
                  <c:v>H6</c:v>
                </c:pt>
                <c:pt idx="36">
                  <c:v>F2</c:v>
                </c:pt>
                <c:pt idx="37">
                  <c:v>F7</c:v>
                </c:pt>
                <c:pt idx="38">
                  <c:v>G2</c:v>
                </c:pt>
                <c:pt idx="39">
                  <c:v>C3</c:v>
                </c:pt>
                <c:pt idx="40">
                  <c:v>E3</c:v>
                </c:pt>
                <c:pt idx="41">
                  <c:v>A6</c:v>
                </c:pt>
                <c:pt idx="42">
                  <c:v>E2</c:v>
                </c:pt>
                <c:pt idx="43">
                  <c:v>F5</c:v>
                </c:pt>
                <c:pt idx="44">
                  <c:v>D6</c:v>
                </c:pt>
                <c:pt idx="45">
                  <c:v>H4</c:v>
                </c:pt>
                <c:pt idx="46">
                  <c:v>D10</c:v>
                </c:pt>
                <c:pt idx="47">
                  <c:v>G5</c:v>
                </c:pt>
                <c:pt idx="48">
                  <c:v>B6</c:v>
                </c:pt>
                <c:pt idx="49">
                  <c:v>E11</c:v>
                </c:pt>
                <c:pt idx="50">
                  <c:v>A9</c:v>
                </c:pt>
                <c:pt idx="51">
                  <c:v>C4</c:v>
                </c:pt>
                <c:pt idx="52">
                  <c:v>F3</c:v>
                </c:pt>
                <c:pt idx="53">
                  <c:v>D1</c:v>
                </c:pt>
                <c:pt idx="54">
                  <c:v>F10</c:v>
                </c:pt>
                <c:pt idx="55">
                  <c:v>B4</c:v>
                </c:pt>
                <c:pt idx="56">
                  <c:v>D11</c:v>
                </c:pt>
                <c:pt idx="57">
                  <c:v>C6</c:v>
                </c:pt>
                <c:pt idx="58">
                  <c:v>C7</c:v>
                </c:pt>
                <c:pt idx="59">
                  <c:v>F6</c:v>
                </c:pt>
                <c:pt idx="60">
                  <c:v>C5</c:v>
                </c:pt>
                <c:pt idx="61">
                  <c:v>F12</c:v>
                </c:pt>
                <c:pt idx="62">
                  <c:v>A4</c:v>
                </c:pt>
                <c:pt idx="63">
                  <c:v>E4</c:v>
                </c:pt>
                <c:pt idx="64">
                  <c:v>C8</c:v>
                </c:pt>
                <c:pt idx="65">
                  <c:v>C10</c:v>
                </c:pt>
                <c:pt idx="66">
                  <c:v>B10</c:v>
                </c:pt>
                <c:pt idx="67">
                  <c:v>G4</c:v>
                </c:pt>
                <c:pt idx="68">
                  <c:v>B9</c:v>
                </c:pt>
                <c:pt idx="69">
                  <c:v>A5</c:v>
                </c:pt>
                <c:pt idx="70">
                  <c:v>G8</c:v>
                </c:pt>
                <c:pt idx="71">
                  <c:v>B12</c:v>
                </c:pt>
                <c:pt idx="72">
                  <c:v>E12</c:v>
                </c:pt>
                <c:pt idx="73">
                  <c:v>H5</c:v>
                </c:pt>
                <c:pt idx="74">
                  <c:v>E10</c:v>
                </c:pt>
                <c:pt idx="75">
                  <c:v>H10</c:v>
                </c:pt>
                <c:pt idx="76">
                  <c:v>G6</c:v>
                </c:pt>
                <c:pt idx="77">
                  <c:v>B2</c:v>
                </c:pt>
                <c:pt idx="78">
                  <c:v>B8</c:v>
                </c:pt>
                <c:pt idx="79">
                  <c:v>A10</c:v>
                </c:pt>
                <c:pt idx="80">
                  <c:v>E9</c:v>
                </c:pt>
                <c:pt idx="81">
                  <c:v>A1</c:v>
                </c:pt>
                <c:pt idx="82">
                  <c:v>E5</c:v>
                </c:pt>
                <c:pt idx="83">
                  <c:v>H2</c:v>
                </c:pt>
                <c:pt idx="84">
                  <c:v>G10</c:v>
                </c:pt>
                <c:pt idx="85">
                  <c:v>D3</c:v>
                </c:pt>
                <c:pt idx="86">
                  <c:v>A2</c:v>
                </c:pt>
                <c:pt idx="87">
                  <c:v>C2</c:v>
                </c:pt>
                <c:pt idx="88">
                  <c:v>B5</c:v>
                </c:pt>
                <c:pt idx="89">
                  <c:v>G1</c:v>
                </c:pt>
                <c:pt idx="90">
                  <c:v>D2</c:v>
                </c:pt>
                <c:pt idx="91">
                  <c:v>E1</c:v>
                </c:pt>
                <c:pt idx="92">
                  <c:v>C12</c:v>
                </c:pt>
                <c:pt idx="93">
                  <c:v>D5</c:v>
                </c:pt>
                <c:pt idx="94">
                  <c:v>C11</c:v>
                </c:pt>
                <c:pt idx="95">
                  <c:v>E8</c:v>
                </c:pt>
              </c:strCache>
            </c:strRef>
          </c:xVal>
          <c:yVal>
            <c:numRef>
              <c:f>Vanillin!$G$2:$G$97</c:f>
              <c:numCache>
                <c:formatCode>General</c:formatCode>
                <c:ptCount val="96"/>
                <c:pt idx="0">
                  <c:v>11.976047904191621</c:v>
                </c:pt>
                <c:pt idx="1">
                  <c:v>12.5</c:v>
                </c:pt>
                <c:pt idx="2">
                  <c:v>20.481927710843379</c:v>
                </c:pt>
                <c:pt idx="3">
                  <c:v>21.052631578947373</c:v>
                </c:pt>
                <c:pt idx="4">
                  <c:v>22.388059701492544</c:v>
                </c:pt>
                <c:pt idx="5">
                  <c:v>22.857142857142858</c:v>
                </c:pt>
                <c:pt idx="6">
                  <c:v>23.502304147465424</c:v>
                </c:pt>
                <c:pt idx="7">
                  <c:v>24.852071005917161</c:v>
                </c:pt>
                <c:pt idx="8">
                  <c:v>28.143712574850294</c:v>
                </c:pt>
                <c:pt idx="9">
                  <c:v>29.80132450331126</c:v>
                </c:pt>
                <c:pt idx="10">
                  <c:v>32.679738562091501</c:v>
                </c:pt>
                <c:pt idx="11">
                  <c:v>33.587786259542</c:v>
                </c:pt>
                <c:pt idx="12">
                  <c:v>34.285714285714278</c:v>
                </c:pt>
                <c:pt idx="13">
                  <c:v>36.399217221135046</c:v>
                </c:pt>
                <c:pt idx="14">
                  <c:v>36.486486486486477</c:v>
                </c:pt>
                <c:pt idx="15">
                  <c:v>37.428023032629561</c:v>
                </c:pt>
                <c:pt idx="16">
                  <c:v>37.640449438202253</c:v>
                </c:pt>
                <c:pt idx="17">
                  <c:v>37.795275590551192</c:v>
                </c:pt>
                <c:pt idx="18">
                  <c:v>38.036809815950917</c:v>
                </c:pt>
                <c:pt idx="19">
                  <c:v>38.235294117647051</c:v>
                </c:pt>
                <c:pt idx="20">
                  <c:v>38.509316770186345</c:v>
                </c:pt>
                <c:pt idx="21">
                  <c:v>38.562091503267979</c:v>
                </c:pt>
                <c:pt idx="22">
                  <c:v>38.636363636363633</c:v>
                </c:pt>
                <c:pt idx="23">
                  <c:v>38.695652173913047</c:v>
                </c:pt>
                <c:pt idx="24">
                  <c:v>39.080459770114942</c:v>
                </c:pt>
                <c:pt idx="25">
                  <c:v>39.234449760765564</c:v>
                </c:pt>
                <c:pt idx="26">
                  <c:v>40.645161290322562</c:v>
                </c:pt>
                <c:pt idx="27">
                  <c:v>40.764331210191088</c:v>
                </c:pt>
                <c:pt idx="28">
                  <c:v>40.853658536585371</c:v>
                </c:pt>
                <c:pt idx="29">
                  <c:v>41.206030150753762</c:v>
                </c:pt>
                <c:pt idx="30">
                  <c:v>42.364532019704427</c:v>
                </c:pt>
                <c:pt idx="31">
                  <c:v>42.75362318840579</c:v>
                </c:pt>
                <c:pt idx="32">
                  <c:v>42.948717948717949</c:v>
                </c:pt>
                <c:pt idx="33">
                  <c:v>44.029850746268664</c:v>
                </c:pt>
                <c:pt idx="34">
                  <c:v>46.428571428571423</c:v>
                </c:pt>
                <c:pt idx="35">
                  <c:v>46.500000000000021</c:v>
                </c:pt>
                <c:pt idx="36">
                  <c:v>46.551724137931039</c:v>
                </c:pt>
                <c:pt idx="37">
                  <c:v>46.892655367231633</c:v>
                </c:pt>
                <c:pt idx="38">
                  <c:v>47.928994082840241</c:v>
                </c:pt>
                <c:pt idx="39">
                  <c:v>48.630136986301373</c:v>
                </c:pt>
                <c:pt idx="40">
                  <c:v>49.056603773584911</c:v>
                </c:pt>
                <c:pt idx="41">
                  <c:v>49.525616698292211</c:v>
                </c:pt>
                <c:pt idx="42">
                  <c:v>49.66887417218544</c:v>
                </c:pt>
                <c:pt idx="43">
                  <c:v>50.000000000000014</c:v>
                </c:pt>
                <c:pt idx="44">
                  <c:v>50.344827586206897</c:v>
                </c:pt>
                <c:pt idx="45">
                  <c:v>50.490196078431367</c:v>
                </c:pt>
                <c:pt idx="46">
                  <c:v>50.857142857142868</c:v>
                </c:pt>
                <c:pt idx="47">
                  <c:v>50.877192982456144</c:v>
                </c:pt>
                <c:pt idx="48">
                  <c:v>51.234567901234563</c:v>
                </c:pt>
                <c:pt idx="49">
                  <c:v>51.388888888888886</c:v>
                </c:pt>
                <c:pt idx="50">
                  <c:v>52.941176470588239</c:v>
                </c:pt>
                <c:pt idx="51">
                  <c:v>53.030303030303017</c:v>
                </c:pt>
                <c:pt idx="52">
                  <c:v>54.193548387096754</c:v>
                </c:pt>
                <c:pt idx="53">
                  <c:v>54.42176870748299</c:v>
                </c:pt>
                <c:pt idx="54">
                  <c:v>55.497382198952884</c:v>
                </c:pt>
                <c:pt idx="55">
                  <c:v>55.555555555555571</c:v>
                </c:pt>
                <c:pt idx="56">
                  <c:v>57.309941520467831</c:v>
                </c:pt>
                <c:pt idx="57">
                  <c:v>57.333333333333329</c:v>
                </c:pt>
                <c:pt idx="58">
                  <c:v>57.594936708860757</c:v>
                </c:pt>
                <c:pt idx="59">
                  <c:v>58.579881656804744</c:v>
                </c:pt>
                <c:pt idx="60">
                  <c:v>59.027777777777779</c:v>
                </c:pt>
                <c:pt idx="61">
                  <c:v>59.868421052631582</c:v>
                </c:pt>
                <c:pt idx="62">
                  <c:v>60.645161290322591</c:v>
                </c:pt>
                <c:pt idx="63">
                  <c:v>61.428571428571423</c:v>
                </c:pt>
                <c:pt idx="64">
                  <c:v>61.428571428571445</c:v>
                </c:pt>
                <c:pt idx="65">
                  <c:v>61.728395061728378</c:v>
                </c:pt>
                <c:pt idx="66">
                  <c:v>62.17948717948719</c:v>
                </c:pt>
                <c:pt idx="67">
                  <c:v>62.195121951219512</c:v>
                </c:pt>
                <c:pt idx="68">
                  <c:v>62.820512820512818</c:v>
                </c:pt>
                <c:pt idx="69">
                  <c:v>64.208633093525179</c:v>
                </c:pt>
                <c:pt idx="70">
                  <c:v>64.473684210526301</c:v>
                </c:pt>
                <c:pt idx="71">
                  <c:v>64.634146341463435</c:v>
                </c:pt>
                <c:pt idx="72">
                  <c:v>65.333333333333329</c:v>
                </c:pt>
                <c:pt idx="73">
                  <c:v>65.500000000000014</c:v>
                </c:pt>
                <c:pt idx="74">
                  <c:v>66.049382716049379</c:v>
                </c:pt>
                <c:pt idx="75">
                  <c:v>66.331658291457288</c:v>
                </c:pt>
                <c:pt idx="76">
                  <c:v>67.857142857142847</c:v>
                </c:pt>
                <c:pt idx="77">
                  <c:v>67.948717948717956</c:v>
                </c:pt>
                <c:pt idx="78">
                  <c:v>68</c:v>
                </c:pt>
                <c:pt idx="79">
                  <c:v>68.279569892473134</c:v>
                </c:pt>
                <c:pt idx="80">
                  <c:v>68.421052631578959</c:v>
                </c:pt>
                <c:pt idx="81">
                  <c:v>69.350649350649334</c:v>
                </c:pt>
                <c:pt idx="82">
                  <c:v>70.422535211267629</c:v>
                </c:pt>
                <c:pt idx="83">
                  <c:v>71.428571428571416</c:v>
                </c:pt>
                <c:pt idx="84">
                  <c:v>75.000000000000028</c:v>
                </c:pt>
                <c:pt idx="85">
                  <c:v>75.460122699386517</c:v>
                </c:pt>
                <c:pt idx="86">
                  <c:v>75.467775467775468</c:v>
                </c:pt>
                <c:pt idx="87">
                  <c:v>75.816993464052302</c:v>
                </c:pt>
                <c:pt idx="88">
                  <c:v>79.166666666666671</c:v>
                </c:pt>
                <c:pt idx="89">
                  <c:v>79.487179487179489</c:v>
                </c:pt>
                <c:pt idx="90">
                  <c:v>79.8611111111111</c:v>
                </c:pt>
                <c:pt idx="91">
                  <c:v>80.555555555555557</c:v>
                </c:pt>
                <c:pt idx="92">
                  <c:v>82.51748251748252</c:v>
                </c:pt>
                <c:pt idx="93">
                  <c:v>88.157894736842096</c:v>
                </c:pt>
                <c:pt idx="94">
                  <c:v>94.117647058823522</c:v>
                </c:pt>
                <c:pt idx="95">
                  <c:v>10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480384"/>
        <c:axId val="194480960"/>
      </c:scatterChart>
      <c:valAx>
        <c:axId val="19448038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480960"/>
        <c:crosses val="autoZero"/>
        <c:crossBetween val="midCat"/>
      </c:valAx>
      <c:valAx>
        <c:axId val="194480960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480384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71710484549335785"/>
          <c:y val="0.61740527507525611"/>
          <c:w val="0.23754305077213642"/>
          <c:h val="7.5935015157046037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03405725047343"/>
          <c:y val="6.3425717849531868E-2"/>
          <c:w val="0.70107981476341241"/>
          <c:h val="0.7974461170981002"/>
        </c:manualLayout>
      </c:layout>
      <c:scatterChart>
        <c:scatterStyle val="lineMarker"/>
        <c:varyColors val="0"/>
        <c:ser>
          <c:idx val="0"/>
          <c:order val="0"/>
          <c:tx>
            <c:strRef>
              <c:f>Sorbitol!$H$1</c:f>
              <c:strCache>
                <c:ptCount val="1"/>
                <c:pt idx="0">
                  <c:v>Sorbitol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orbitol!$B$2:$B$97</c:f>
              <c:strCache>
                <c:ptCount val="96"/>
                <c:pt idx="0">
                  <c:v>G12</c:v>
                </c:pt>
                <c:pt idx="1">
                  <c:v>H11</c:v>
                </c:pt>
                <c:pt idx="2">
                  <c:v>G9</c:v>
                </c:pt>
                <c:pt idx="3">
                  <c:v>H7</c:v>
                </c:pt>
                <c:pt idx="4">
                  <c:v>F11</c:v>
                </c:pt>
                <c:pt idx="5">
                  <c:v>G11</c:v>
                </c:pt>
                <c:pt idx="6">
                  <c:v>G3</c:v>
                </c:pt>
                <c:pt idx="7">
                  <c:v>H9</c:v>
                </c:pt>
                <c:pt idx="8">
                  <c:v>H8</c:v>
                </c:pt>
                <c:pt idx="9">
                  <c:v>G2</c:v>
                </c:pt>
                <c:pt idx="10">
                  <c:v>H4</c:v>
                </c:pt>
                <c:pt idx="11">
                  <c:v>G4</c:v>
                </c:pt>
                <c:pt idx="12">
                  <c:v>H5</c:v>
                </c:pt>
                <c:pt idx="13">
                  <c:v>G10</c:v>
                </c:pt>
                <c:pt idx="14">
                  <c:v>H12</c:v>
                </c:pt>
                <c:pt idx="15">
                  <c:v>H3</c:v>
                </c:pt>
                <c:pt idx="16">
                  <c:v>H1</c:v>
                </c:pt>
                <c:pt idx="17">
                  <c:v>H2</c:v>
                </c:pt>
                <c:pt idx="18">
                  <c:v>H6</c:v>
                </c:pt>
                <c:pt idx="19">
                  <c:v>H10</c:v>
                </c:pt>
                <c:pt idx="20">
                  <c:v>F9</c:v>
                </c:pt>
                <c:pt idx="21">
                  <c:v>E4</c:v>
                </c:pt>
                <c:pt idx="22">
                  <c:v>F10</c:v>
                </c:pt>
                <c:pt idx="23">
                  <c:v>G5</c:v>
                </c:pt>
                <c:pt idx="24">
                  <c:v>F4</c:v>
                </c:pt>
                <c:pt idx="25">
                  <c:v>G7</c:v>
                </c:pt>
                <c:pt idx="26">
                  <c:v>F3</c:v>
                </c:pt>
                <c:pt idx="27">
                  <c:v>F8</c:v>
                </c:pt>
                <c:pt idx="28">
                  <c:v>C7</c:v>
                </c:pt>
                <c:pt idx="29">
                  <c:v>G6</c:v>
                </c:pt>
                <c:pt idx="30">
                  <c:v>A2</c:v>
                </c:pt>
                <c:pt idx="31">
                  <c:v>F7</c:v>
                </c:pt>
                <c:pt idx="32">
                  <c:v>B4</c:v>
                </c:pt>
                <c:pt idx="33">
                  <c:v>C1</c:v>
                </c:pt>
                <c:pt idx="34">
                  <c:v>C6</c:v>
                </c:pt>
                <c:pt idx="35">
                  <c:v>F1</c:v>
                </c:pt>
                <c:pt idx="36">
                  <c:v>D2</c:v>
                </c:pt>
                <c:pt idx="37">
                  <c:v>A12</c:v>
                </c:pt>
                <c:pt idx="38">
                  <c:v>G1</c:v>
                </c:pt>
                <c:pt idx="39">
                  <c:v>F6</c:v>
                </c:pt>
                <c:pt idx="40">
                  <c:v>A8</c:v>
                </c:pt>
                <c:pt idx="41">
                  <c:v>F12</c:v>
                </c:pt>
                <c:pt idx="42">
                  <c:v>A7</c:v>
                </c:pt>
                <c:pt idx="43">
                  <c:v>D8</c:v>
                </c:pt>
                <c:pt idx="44">
                  <c:v>F2</c:v>
                </c:pt>
                <c:pt idx="45">
                  <c:v>B5</c:v>
                </c:pt>
                <c:pt idx="46">
                  <c:v>A11</c:v>
                </c:pt>
                <c:pt idx="47">
                  <c:v>D12</c:v>
                </c:pt>
                <c:pt idx="48">
                  <c:v>E2</c:v>
                </c:pt>
                <c:pt idx="49">
                  <c:v>D10</c:v>
                </c:pt>
                <c:pt idx="50">
                  <c:v>D11</c:v>
                </c:pt>
                <c:pt idx="51">
                  <c:v>C10</c:v>
                </c:pt>
                <c:pt idx="52">
                  <c:v>A6</c:v>
                </c:pt>
                <c:pt idx="53">
                  <c:v>A4</c:v>
                </c:pt>
                <c:pt idx="54">
                  <c:v>A1</c:v>
                </c:pt>
                <c:pt idx="55">
                  <c:v>D7</c:v>
                </c:pt>
                <c:pt idx="56">
                  <c:v>C11</c:v>
                </c:pt>
                <c:pt idx="57">
                  <c:v>B3</c:v>
                </c:pt>
                <c:pt idx="58">
                  <c:v>C5</c:v>
                </c:pt>
                <c:pt idx="59">
                  <c:v>E6</c:v>
                </c:pt>
                <c:pt idx="60">
                  <c:v>B11</c:v>
                </c:pt>
                <c:pt idx="61">
                  <c:v>B6</c:v>
                </c:pt>
                <c:pt idx="62">
                  <c:v>D6</c:v>
                </c:pt>
                <c:pt idx="63">
                  <c:v>A3</c:v>
                </c:pt>
                <c:pt idx="64">
                  <c:v>G8</c:v>
                </c:pt>
                <c:pt idx="65">
                  <c:v>C4</c:v>
                </c:pt>
                <c:pt idx="66">
                  <c:v>D3</c:v>
                </c:pt>
                <c:pt idx="67">
                  <c:v>D1</c:v>
                </c:pt>
                <c:pt idx="68">
                  <c:v>A5</c:v>
                </c:pt>
                <c:pt idx="69">
                  <c:v>F5</c:v>
                </c:pt>
                <c:pt idx="70">
                  <c:v>C12</c:v>
                </c:pt>
                <c:pt idx="71">
                  <c:v>B8</c:v>
                </c:pt>
                <c:pt idx="72">
                  <c:v>D5</c:v>
                </c:pt>
                <c:pt idx="73">
                  <c:v>E10</c:v>
                </c:pt>
                <c:pt idx="74">
                  <c:v>D9</c:v>
                </c:pt>
                <c:pt idx="75">
                  <c:v>D4</c:v>
                </c:pt>
                <c:pt idx="76">
                  <c:v>E9</c:v>
                </c:pt>
                <c:pt idx="77">
                  <c:v>E12</c:v>
                </c:pt>
                <c:pt idx="78">
                  <c:v>B2</c:v>
                </c:pt>
                <c:pt idx="79">
                  <c:v>C2</c:v>
                </c:pt>
                <c:pt idx="80">
                  <c:v>B10</c:v>
                </c:pt>
                <c:pt idx="81">
                  <c:v>E11</c:v>
                </c:pt>
                <c:pt idx="82">
                  <c:v>C8</c:v>
                </c:pt>
                <c:pt idx="83">
                  <c:v>E7</c:v>
                </c:pt>
                <c:pt idx="84">
                  <c:v>B7</c:v>
                </c:pt>
                <c:pt idx="85">
                  <c:v>E3</c:v>
                </c:pt>
                <c:pt idx="86">
                  <c:v>E5</c:v>
                </c:pt>
                <c:pt idx="87">
                  <c:v>B9</c:v>
                </c:pt>
                <c:pt idx="88">
                  <c:v>B12</c:v>
                </c:pt>
                <c:pt idx="89">
                  <c:v>A10</c:v>
                </c:pt>
                <c:pt idx="90">
                  <c:v>C9</c:v>
                </c:pt>
                <c:pt idx="91">
                  <c:v>E8</c:v>
                </c:pt>
                <c:pt idx="92">
                  <c:v>A9</c:v>
                </c:pt>
                <c:pt idx="93">
                  <c:v>B1</c:v>
                </c:pt>
                <c:pt idx="94">
                  <c:v>E1</c:v>
                </c:pt>
                <c:pt idx="95">
                  <c:v>C3</c:v>
                </c:pt>
              </c:strCache>
            </c:strRef>
          </c:xVal>
          <c:yVal>
            <c:numRef>
              <c:f>Sorbitol!$H$2:$H$97</c:f>
              <c:numCache>
                <c:formatCode>General</c:formatCode>
                <c:ptCount val="9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.72289156626506035</c:v>
                </c:pt>
                <c:pt idx="15">
                  <c:v>1.3548387096774193</c:v>
                </c:pt>
                <c:pt idx="16">
                  <c:v>1.7241379310344824</c:v>
                </c:pt>
                <c:pt idx="17">
                  <c:v>3.1343283582089549</c:v>
                </c:pt>
                <c:pt idx="18">
                  <c:v>3.7499999999999991</c:v>
                </c:pt>
                <c:pt idx="19">
                  <c:v>11.886792452830189</c:v>
                </c:pt>
                <c:pt idx="20">
                  <c:v>65.555555555555529</c:v>
                </c:pt>
                <c:pt idx="21">
                  <c:v>87.603305785123965</c:v>
                </c:pt>
                <c:pt idx="22">
                  <c:v>91.304347826086968</c:v>
                </c:pt>
                <c:pt idx="23">
                  <c:v>93.069306930693074</c:v>
                </c:pt>
                <c:pt idx="24">
                  <c:v>93.975903614457806</c:v>
                </c:pt>
                <c:pt idx="25">
                  <c:v>95.041322314049594</c:v>
                </c:pt>
                <c:pt idx="26">
                  <c:v>95.454545454545482</c:v>
                </c:pt>
                <c:pt idx="27">
                  <c:v>96.466431095406364</c:v>
                </c:pt>
                <c:pt idx="28">
                  <c:v>99.230769230769255</c:v>
                </c:pt>
                <c:pt idx="29">
                  <c:v>100.85470085470085</c:v>
                </c:pt>
                <c:pt idx="30">
                  <c:v>100.90090090090091</c:v>
                </c:pt>
                <c:pt idx="31">
                  <c:v>102.40963855421693</c:v>
                </c:pt>
                <c:pt idx="32">
                  <c:v>103.2520325203252</c:v>
                </c:pt>
                <c:pt idx="33">
                  <c:v>103.36134453781511</c:v>
                </c:pt>
                <c:pt idx="34">
                  <c:v>103.47826086956522</c:v>
                </c:pt>
                <c:pt idx="35">
                  <c:v>104.68750000000004</c:v>
                </c:pt>
                <c:pt idx="36">
                  <c:v>105.71428571428572</c:v>
                </c:pt>
                <c:pt idx="37">
                  <c:v>105.76923076923075</c:v>
                </c:pt>
                <c:pt idx="38">
                  <c:v>107.22891566265061</c:v>
                </c:pt>
                <c:pt idx="39">
                  <c:v>107.69230769230769</c:v>
                </c:pt>
                <c:pt idx="40">
                  <c:v>107.86516853932582</c:v>
                </c:pt>
                <c:pt idx="41">
                  <c:v>110.34482758620692</c:v>
                </c:pt>
                <c:pt idx="42">
                  <c:v>111.88118811881193</c:v>
                </c:pt>
                <c:pt idx="43">
                  <c:v>112.16216216216219</c:v>
                </c:pt>
                <c:pt idx="44">
                  <c:v>113.09523809523809</c:v>
                </c:pt>
                <c:pt idx="45">
                  <c:v>113.33333333333337</c:v>
                </c:pt>
                <c:pt idx="46">
                  <c:v>113.49206349206351</c:v>
                </c:pt>
                <c:pt idx="47">
                  <c:v>113.51351351351353</c:v>
                </c:pt>
                <c:pt idx="48">
                  <c:v>113.69863013698631</c:v>
                </c:pt>
                <c:pt idx="49">
                  <c:v>113.82978723404253</c:v>
                </c:pt>
                <c:pt idx="50">
                  <c:v>114.4736842105263</c:v>
                </c:pt>
                <c:pt idx="51">
                  <c:v>114.7540983606557</c:v>
                </c:pt>
                <c:pt idx="52">
                  <c:v>116.04938271604944</c:v>
                </c:pt>
                <c:pt idx="53">
                  <c:v>117.47572815533982</c:v>
                </c:pt>
                <c:pt idx="54">
                  <c:v>118.14814814814815</c:v>
                </c:pt>
                <c:pt idx="55">
                  <c:v>118.18181818181816</c:v>
                </c:pt>
                <c:pt idx="56">
                  <c:v>118.62745098039214</c:v>
                </c:pt>
                <c:pt idx="57">
                  <c:v>119.10112359550563</c:v>
                </c:pt>
                <c:pt idx="58">
                  <c:v>119.1919191919192</c:v>
                </c:pt>
                <c:pt idx="59">
                  <c:v>119.40298507462688</c:v>
                </c:pt>
                <c:pt idx="60">
                  <c:v>119.99999999999997</c:v>
                </c:pt>
                <c:pt idx="61">
                  <c:v>119.99999999999997</c:v>
                </c:pt>
                <c:pt idx="62">
                  <c:v>120.58823529411771</c:v>
                </c:pt>
                <c:pt idx="63">
                  <c:v>120.68965517241385</c:v>
                </c:pt>
                <c:pt idx="64">
                  <c:v>121.42857142857142</c:v>
                </c:pt>
                <c:pt idx="65">
                  <c:v>122.91666666666666</c:v>
                </c:pt>
                <c:pt idx="66">
                  <c:v>123.94366197183101</c:v>
                </c:pt>
                <c:pt idx="67">
                  <c:v>124.13793103448276</c:v>
                </c:pt>
                <c:pt idx="68">
                  <c:v>124.78260869565227</c:v>
                </c:pt>
                <c:pt idx="69">
                  <c:v>125</c:v>
                </c:pt>
                <c:pt idx="70">
                  <c:v>125.00000000000003</c:v>
                </c:pt>
                <c:pt idx="71">
                  <c:v>125.27472527472526</c:v>
                </c:pt>
                <c:pt idx="72">
                  <c:v>125.33333333333334</c:v>
                </c:pt>
                <c:pt idx="73">
                  <c:v>125.35211267605636</c:v>
                </c:pt>
                <c:pt idx="74">
                  <c:v>126.47058823529412</c:v>
                </c:pt>
                <c:pt idx="75">
                  <c:v>127.27272727272731</c:v>
                </c:pt>
                <c:pt idx="76">
                  <c:v>128.81355932203388</c:v>
                </c:pt>
                <c:pt idx="77">
                  <c:v>129.03225806451607</c:v>
                </c:pt>
                <c:pt idx="78">
                  <c:v>129.34782608695653</c:v>
                </c:pt>
                <c:pt idx="79">
                  <c:v>129.82456140350877</c:v>
                </c:pt>
                <c:pt idx="80">
                  <c:v>130.68181818181816</c:v>
                </c:pt>
                <c:pt idx="81">
                  <c:v>130.98591549295773</c:v>
                </c:pt>
                <c:pt idx="82">
                  <c:v>131.63265306122454</c:v>
                </c:pt>
                <c:pt idx="83">
                  <c:v>132.00000000000003</c:v>
                </c:pt>
                <c:pt idx="84">
                  <c:v>134.11764705882354</c:v>
                </c:pt>
                <c:pt idx="85">
                  <c:v>134.72222222222223</c:v>
                </c:pt>
                <c:pt idx="86">
                  <c:v>136.06557377049182</c:v>
                </c:pt>
                <c:pt idx="87">
                  <c:v>136.14457831325305</c:v>
                </c:pt>
                <c:pt idx="88">
                  <c:v>136.25000000000006</c:v>
                </c:pt>
                <c:pt idx="89">
                  <c:v>136.58536585365857</c:v>
                </c:pt>
                <c:pt idx="90">
                  <c:v>140.2777777777778</c:v>
                </c:pt>
                <c:pt idx="91">
                  <c:v>142.85714285714292</c:v>
                </c:pt>
                <c:pt idx="92">
                  <c:v>143.90243902439028</c:v>
                </c:pt>
                <c:pt idx="93">
                  <c:v>145.20547945205476</c:v>
                </c:pt>
                <c:pt idx="94">
                  <c:v>147.27272727272737</c:v>
                </c:pt>
                <c:pt idx="95">
                  <c:v>150.819672131147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485568"/>
        <c:axId val="194936832"/>
      </c:scatterChart>
      <c:valAx>
        <c:axId val="19448556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936832"/>
        <c:crosses val="autoZero"/>
        <c:crossBetween val="midCat"/>
      </c:valAx>
      <c:valAx>
        <c:axId val="194936832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485568"/>
        <c:crosses val="autoZero"/>
        <c:crossBetween val="midCat"/>
        <c:majorUnit val="50"/>
      </c:valAx>
    </c:plotArea>
    <c:legend>
      <c:legendPos val="r"/>
      <c:layout>
        <c:manualLayout>
          <c:xMode val="edge"/>
          <c:yMode val="edge"/>
          <c:x val="0.66639143526733169"/>
          <c:y val="0.58801831362171875"/>
          <c:w val="0.27225245863623426"/>
          <c:h val="7.2483423558998492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808573158306634"/>
          <c:y val="5.1400554097404488E-2"/>
          <c:w val="0.7581312847924635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Ethanol!$I$1</c:f>
              <c:strCache>
                <c:ptCount val="1"/>
                <c:pt idx="0">
                  <c:v>Ethanol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Ethanol!$B$2:$B$97</c:f>
              <c:strCache>
                <c:ptCount val="96"/>
                <c:pt idx="0">
                  <c:v>B5</c:v>
                </c:pt>
                <c:pt idx="1">
                  <c:v>A8</c:v>
                </c:pt>
                <c:pt idx="2">
                  <c:v>A9</c:v>
                </c:pt>
                <c:pt idx="3">
                  <c:v>C6</c:v>
                </c:pt>
                <c:pt idx="4">
                  <c:v>B2</c:v>
                </c:pt>
                <c:pt idx="5">
                  <c:v>H8</c:v>
                </c:pt>
                <c:pt idx="6">
                  <c:v>A3</c:v>
                </c:pt>
                <c:pt idx="7">
                  <c:v>C7</c:v>
                </c:pt>
                <c:pt idx="8">
                  <c:v>B10</c:v>
                </c:pt>
                <c:pt idx="9">
                  <c:v>G10</c:v>
                </c:pt>
                <c:pt idx="10">
                  <c:v>B12</c:v>
                </c:pt>
                <c:pt idx="11">
                  <c:v>B8</c:v>
                </c:pt>
                <c:pt idx="12">
                  <c:v>E12</c:v>
                </c:pt>
                <c:pt idx="13">
                  <c:v>H9</c:v>
                </c:pt>
                <c:pt idx="14">
                  <c:v>C8</c:v>
                </c:pt>
                <c:pt idx="15">
                  <c:v>C5</c:v>
                </c:pt>
                <c:pt idx="16">
                  <c:v>A1</c:v>
                </c:pt>
                <c:pt idx="17">
                  <c:v>D8</c:v>
                </c:pt>
                <c:pt idx="18">
                  <c:v>H11</c:v>
                </c:pt>
                <c:pt idx="19">
                  <c:v>C10</c:v>
                </c:pt>
                <c:pt idx="20">
                  <c:v>D3</c:v>
                </c:pt>
                <c:pt idx="21">
                  <c:v>A10</c:v>
                </c:pt>
                <c:pt idx="22">
                  <c:v>A5</c:v>
                </c:pt>
                <c:pt idx="23">
                  <c:v>B11</c:v>
                </c:pt>
                <c:pt idx="24">
                  <c:v>C4</c:v>
                </c:pt>
                <c:pt idx="25">
                  <c:v>B4</c:v>
                </c:pt>
                <c:pt idx="26">
                  <c:v>A12</c:v>
                </c:pt>
                <c:pt idx="27">
                  <c:v>G9</c:v>
                </c:pt>
                <c:pt idx="28">
                  <c:v>H7</c:v>
                </c:pt>
                <c:pt idx="29">
                  <c:v>F1</c:v>
                </c:pt>
                <c:pt idx="30">
                  <c:v>F7</c:v>
                </c:pt>
                <c:pt idx="31">
                  <c:v>F9</c:v>
                </c:pt>
                <c:pt idx="32">
                  <c:v>D5</c:v>
                </c:pt>
                <c:pt idx="33">
                  <c:v>G4</c:v>
                </c:pt>
                <c:pt idx="34">
                  <c:v>F11</c:v>
                </c:pt>
                <c:pt idx="35">
                  <c:v>G8</c:v>
                </c:pt>
                <c:pt idx="36">
                  <c:v>E6</c:v>
                </c:pt>
                <c:pt idx="37">
                  <c:v>A2</c:v>
                </c:pt>
                <c:pt idx="38">
                  <c:v>G3</c:v>
                </c:pt>
                <c:pt idx="39">
                  <c:v>G11</c:v>
                </c:pt>
                <c:pt idx="40">
                  <c:v>H12</c:v>
                </c:pt>
                <c:pt idx="41">
                  <c:v>A11</c:v>
                </c:pt>
                <c:pt idx="42">
                  <c:v>E7</c:v>
                </c:pt>
                <c:pt idx="43">
                  <c:v>H6</c:v>
                </c:pt>
                <c:pt idx="44">
                  <c:v>A7</c:v>
                </c:pt>
                <c:pt idx="45">
                  <c:v>H5</c:v>
                </c:pt>
                <c:pt idx="46">
                  <c:v>D11</c:v>
                </c:pt>
                <c:pt idx="47">
                  <c:v>E9</c:v>
                </c:pt>
                <c:pt idx="48">
                  <c:v>E2</c:v>
                </c:pt>
                <c:pt idx="49">
                  <c:v>E8</c:v>
                </c:pt>
                <c:pt idx="50">
                  <c:v>H4</c:v>
                </c:pt>
                <c:pt idx="51">
                  <c:v>D1</c:v>
                </c:pt>
                <c:pt idx="52">
                  <c:v>C3</c:v>
                </c:pt>
                <c:pt idx="53">
                  <c:v>C12</c:v>
                </c:pt>
                <c:pt idx="54">
                  <c:v>H1</c:v>
                </c:pt>
                <c:pt idx="55">
                  <c:v>D6</c:v>
                </c:pt>
                <c:pt idx="56">
                  <c:v>B7</c:v>
                </c:pt>
                <c:pt idx="57">
                  <c:v>C9</c:v>
                </c:pt>
                <c:pt idx="58">
                  <c:v>H10</c:v>
                </c:pt>
                <c:pt idx="59">
                  <c:v>A4</c:v>
                </c:pt>
                <c:pt idx="60">
                  <c:v>B1</c:v>
                </c:pt>
                <c:pt idx="61">
                  <c:v>B3</c:v>
                </c:pt>
                <c:pt idx="62">
                  <c:v>C1</c:v>
                </c:pt>
                <c:pt idx="63">
                  <c:v>D12</c:v>
                </c:pt>
                <c:pt idx="64">
                  <c:v>G12</c:v>
                </c:pt>
                <c:pt idx="65">
                  <c:v>E11</c:v>
                </c:pt>
                <c:pt idx="66">
                  <c:v>G7</c:v>
                </c:pt>
                <c:pt idx="67">
                  <c:v>B9</c:v>
                </c:pt>
                <c:pt idx="68">
                  <c:v>F8</c:v>
                </c:pt>
                <c:pt idx="69">
                  <c:v>A6</c:v>
                </c:pt>
                <c:pt idx="70">
                  <c:v>D10</c:v>
                </c:pt>
                <c:pt idx="71">
                  <c:v>G2</c:v>
                </c:pt>
                <c:pt idx="72">
                  <c:v>C2</c:v>
                </c:pt>
                <c:pt idx="73">
                  <c:v>G6</c:v>
                </c:pt>
                <c:pt idx="74">
                  <c:v>D9</c:v>
                </c:pt>
                <c:pt idx="75">
                  <c:v>B6</c:v>
                </c:pt>
                <c:pt idx="76">
                  <c:v>F3</c:v>
                </c:pt>
                <c:pt idx="77">
                  <c:v>F12</c:v>
                </c:pt>
                <c:pt idx="78">
                  <c:v>D7</c:v>
                </c:pt>
                <c:pt idx="79">
                  <c:v>H2</c:v>
                </c:pt>
                <c:pt idx="80">
                  <c:v>E3</c:v>
                </c:pt>
                <c:pt idx="81">
                  <c:v>H3</c:v>
                </c:pt>
                <c:pt idx="82">
                  <c:v>F6</c:v>
                </c:pt>
                <c:pt idx="83">
                  <c:v>F4</c:v>
                </c:pt>
                <c:pt idx="84">
                  <c:v>F2</c:v>
                </c:pt>
                <c:pt idx="85">
                  <c:v>C11</c:v>
                </c:pt>
                <c:pt idx="86">
                  <c:v>D4</c:v>
                </c:pt>
                <c:pt idx="87">
                  <c:v>F10</c:v>
                </c:pt>
                <c:pt idx="88">
                  <c:v>D2</c:v>
                </c:pt>
                <c:pt idx="89">
                  <c:v>G5</c:v>
                </c:pt>
                <c:pt idx="90">
                  <c:v>F5</c:v>
                </c:pt>
                <c:pt idx="91">
                  <c:v>G1</c:v>
                </c:pt>
                <c:pt idx="92">
                  <c:v>E1</c:v>
                </c:pt>
                <c:pt idx="93">
                  <c:v>E4</c:v>
                </c:pt>
                <c:pt idx="94">
                  <c:v>E5</c:v>
                </c:pt>
                <c:pt idx="95">
                  <c:v>E10</c:v>
                </c:pt>
              </c:strCache>
            </c:strRef>
          </c:xVal>
          <c:yVal>
            <c:numRef>
              <c:f>Ethanol!$I$2:$I$97</c:f>
              <c:numCache>
                <c:formatCode>General</c:formatCode>
                <c:ptCount val="9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.0638297872340274</c:v>
                </c:pt>
                <c:pt idx="10">
                  <c:v>1.6393442622951278</c:v>
                </c:pt>
                <c:pt idx="11">
                  <c:v>1.8867924528301629</c:v>
                </c:pt>
                <c:pt idx="12">
                  <c:v>2.8571428571428155</c:v>
                </c:pt>
                <c:pt idx="13">
                  <c:v>3.1914893617021276</c:v>
                </c:pt>
                <c:pt idx="14">
                  <c:v>7.5000000000000027</c:v>
                </c:pt>
                <c:pt idx="15">
                  <c:v>8.8235294117647101</c:v>
                </c:pt>
                <c:pt idx="16">
                  <c:v>10.377358490566085</c:v>
                </c:pt>
                <c:pt idx="17">
                  <c:v>15.555555555555525</c:v>
                </c:pt>
                <c:pt idx="18">
                  <c:v>16.260162601626028</c:v>
                </c:pt>
                <c:pt idx="19">
                  <c:v>16.666666666666664</c:v>
                </c:pt>
                <c:pt idx="20">
                  <c:v>19.04761904761898</c:v>
                </c:pt>
                <c:pt idx="21">
                  <c:v>19.565217391304355</c:v>
                </c:pt>
                <c:pt idx="22">
                  <c:v>20.238095238095365</c:v>
                </c:pt>
                <c:pt idx="23">
                  <c:v>20.31250000000005</c:v>
                </c:pt>
                <c:pt idx="24">
                  <c:v>20.618556701030936</c:v>
                </c:pt>
                <c:pt idx="25">
                  <c:v>20.689655172413783</c:v>
                </c:pt>
                <c:pt idx="26">
                  <c:v>20.833333333333393</c:v>
                </c:pt>
                <c:pt idx="27">
                  <c:v>20.930232558139537</c:v>
                </c:pt>
                <c:pt idx="28">
                  <c:v>22.222222222222239</c:v>
                </c:pt>
                <c:pt idx="29">
                  <c:v>22.500000000000007</c:v>
                </c:pt>
                <c:pt idx="30">
                  <c:v>23.611111111111072</c:v>
                </c:pt>
                <c:pt idx="31">
                  <c:v>24.561403508771882</c:v>
                </c:pt>
                <c:pt idx="32">
                  <c:v>24.63768115942031</c:v>
                </c:pt>
                <c:pt idx="33">
                  <c:v>24.999999999999986</c:v>
                </c:pt>
                <c:pt idx="34">
                  <c:v>25</c:v>
                </c:pt>
                <c:pt idx="35">
                  <c:v>25.510204081632644</c:v>
                </c:pt>
                <c:pt idx="36">
                  <c:v>25.862068965517249</c:v>
                </c:pt>
                <c:pt idx="37">
                  <c:v>26.086956521739111</c:v>
                </c:pt>
                <c:pt idx="38">
                  <c:v>26.08695652173915</c:v>
                </c:pt>
                <c:pt idx="39">
                  <c:v>26.49572649572648</c:v>
                </c:pt>
                <c:pt idx="40">
                  <c:v>26.506024096385527</c:v>
                </c:pt>
                <c:pt idx="41">
                  <c:v>26.760563380281727</c:v>
                </c:pt>
                <c:pt idx="42">
                  <c:v>27.27272727272727</c:v>
                </c:pt>
                <c:pt idx="43">
                  <c:v>27.500000000000004</c:v>
                </c:pt>
                <c:pt idx="44">
                  <c:v>27.536231884058012</c:v>
                </c:pt>
                <c:pt idx="45">
                  <c:v>29.292929292929259</c:v>
                </c:pt>
                <c:pt idx="46">
                  <c:v>29.850746268656724</c:v>
                </c:pt>
                <c:pt idx="47">
                  <c:v>30.612244897959169</c:v>
                </c:pt>
                <c:pt idx="48">
                  <c:v>31.578947368421051</c:v>
                </c:pt>
                <c:pt idx="49">
                  <c:v>31.818181818181817</c:v>
                </c:pt>
                <c:pt idx="50">
                  <c:v>31.958762886597974</c:v>
                </c:pt>
                <c:pt idx="51">
                  <c:v>32.653061224489747</c:v>
                </c:pt>
                <c:pt idx="52">
                  <c:v>32.786885245901672</c:v>
                </c:pt>
                <c:pt idx="53">
                  <c:v>33.124999999999993</c:v>
                </c:pt>
                <c:pt idx="54">
                  <c:v>33.333333333333293</c:v>
                </c:pt>
                <c:pt idx="55">
                  <c:v>34.28571428571427</c:v>
                </c:pt>
                <c:pt idx="56">
                  <c:v>34.848484848484865</c:v>
                </c:pt>
                <c:pt idx="57">
                  <c:v>35.443037974683534</c:v>
                </c:pt>
                <c:pt idx="58">
                  <c:v>35.84905660377359</c:v>
                </c:pt>
                <c:pt idx="59">
                  <c:v>36.206896551724149</c:v>
                </c:pt>
                <c:pt idx="60">
                  <c:v>37.142857142857174</c:v>
                </c:pt>
                <c:pt idx="61">
                  <c:v>37.500000000000014</c:v>
                </c:pt>
                <c:pt idx="62">
                  <c:v>37.704918032786914</c:v>
                </c:pt>
                <c:pt idx="63">
                  <c:v>38.000000000000078</c:v>
                </c:pt>
                <c:pt idx="64">
                  <c:v>38.554216867469897</c:v>
                </c:pt>
                <c:pt idx="65">
                  <c:v>38.636363636363555</c:v>
                </c:pt>
                <c:pt idx="66">
                  <c:v>40.789473684210513</c:v>
                </c:pt>
                <c:pt idx="67">
                  <c:v>41.86046511627908</c:v>
                </c:pt>
                <c:pt idx="68">
                  <c:v>43.493150684931535</c:v>
                </c:pt>
                <c:pt idx="69">
                  <c:v>44.230769230769234</c:v>
                </c:pt>
                <c:pt idx="70">
                  <c:v>46.153846153846153</c:v>
                </c:pt>
                <c:pt idx="71">
                  <c:v>46.739130434782595</c:v>
                </c:pt>
                <c:pt idx="72">
                  <c:v>46.887966804979278</c:v>
                </c:pt>
                <c:pt idx="73">
                  <c:v>47.457627118644027</c:v>
                </c:pt>
                <c:pt idx="74">
                  <c:v>50</c:v>
                </c:pt>
                <c:pt idx="75">
                  <c:v>52.173913043478258</c:v>
                </c:pt>
                <c:pt idx="76">
                  <c:v>54.000000000000028</c:v>
                </c:pt>
                <c:pt idx="77">
                  <c:v>54.545454545454589</c:v>
                </c:pt>
                <c:pt idx="78">
                  <c:v>55.223880597014983</c:v>
                </c:pt>
                <c:pt idx="79">
                  <c:v>56.716417910447781</c:v>
                </c:pt>
                <c:pt idx="80">
                  <c:v>57.352941176470615</c:v>
                </c:pt>
                <c:pt idx="81">
                  <c:v>63.440860215053775</c:v>
                </c:pt>
                <c:pt idx="82">
                  <c:v>63.888888888888808</c:v>
                </c:pt>
                <c:pt idx="83">
                  <c:v>67.500000000000028</c:v>
                </c:pt>
                <c:pt idx="84">
                  <c:v>79.999999999999929</c:v>
                </c:pt>
                <c:pt idx="85">
                  <c:v>86.842105263157862</c:v>
                </c:pt>
                <c:pt idx="86">
                  <c:v>91.6666666666666</c:v>
                </c:pt>
                <c:pt idx="87">
                  <c:v>92.105263157894797</c:v>
                </c:pt>
                <c:pt idx="88">
                  <c:v>117.39130434782601</c:v>
                </c:pt>
                <c:pt idx="89">
                  <c:v>119.04761904761909</c:v>
                </c:pt>
                <c:pt idx="90">
                  <c:v>122.72727272727279</c:v>
                </c:pt>
                <c:pt idx="91">
                  <c:v>124.00000000000003</c:v>
                </c:pt>
                <c:pt idx="92">
                  <c:v>142.42424242424246</c:v>
                </c:pt>
                <c:pt idx="93">
                  <c:v>180.769230769231</c:v>
                </c:pt>
                <c:pt idx="94">
                  <c:v>194.11764705882337</c:v>
                </c:pt>
                <c:pt idx="95">
                  <c:v>261.111111111111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37984"/>
        <c:axId val="194939136"/>
      </c:scatterChart>
      <c:valAx>
        <c:axId val="19493798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939136"/>
        <c:crosses val="autoZero"/>
        <c:crossBetween val="midCat"/>
      </c:valAx>
      <c:valAx>
        <c:axId val="194939136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937984"/>
        <c:crosses val="autoZero"/>
        <c:crossBetween val="midCat"/>
        <c:majorUnit val="50"/>
      </c:valAx>
    </c:plotArea>
    <c:legend>
      <c:legendPos val="r"/>
      <c:layout>
        <c:manualLayout>
          <c:xMode val="edge"/>
          <c:yMode val="edge"/>
          <c:x val="0.1908692182372749"/>
          <c:y val="0.38893514673802138"/>
          <c:w val="0.33562106136260744"/>
          <c:h val="0.15283387224030701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741324670947188"/>
          <c:y val="3.8802897561646593E-2"/>
          <c:w val="0.7012150087075486"/>
          <c:h val="0.82206937324424267"/>
        </c:manualLayout>
      </c:layout>
      <c:scatterChart>
        <c:scatterStyle val="lineMarker"/>
        <c:varyColors val="0"/>
        <c:ser>
          <c:idx val="3"/>
          <c:order val="0"/>
          <c:tx>
            <c:strRef>
              <c:f>HMF!$F$1</c:f>
              <c:strCache>
                <c:ptCount val="1"/>
                <c:pt idx="0">
                  <c:v>HMF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HMF!$B$2:$B$97</c:f>
              <c:strCache>
                <c:ptCount val="96"/>
                <c:pt idx="0">
                  <c:v>F12</c:v>
                </c:pt>
                <c:pt idx="1">
                  <c:v>F6</c:v>
                </c:pt>
                <c:pt idx="2">
                  <c:v>H6</c:v>
                </c:pt>
                <c:pt idx="3">
                  <c:v>H12</c:v>
                </c:pt>
                <c:pt idx="4">
                  <c:v>E6</c:v>
                </c:pt>
                <c:pt idx="5">
                  <c:v>F11</c:v>
                </c:pt>
                <c:pt idx="6">
                  <c:v>C3</c:v>
                </c:pt>
                <c:pt idx="7">
                  <c:v>E2</c:v>
                </c:pt>
                <c:pt idx="8">
                  <c:v>A12</c:v>
                </c:pt>
                <c:pt idx="9">
                  <c:v>H9</c:v>
                </c:pt>
                <c:pt idx="10">
                  <c:v>H5</c:v>
                </c:pt>
                <c:pt idx="11">
                  <c:v>G9</c:v>
                </c:pt>
                <c:pt idx="12">
                  <c:v>A6</c:v>
                </c:pt>
                <c:pt idx="13">
                  <c:v>E7</c:v>
                </c:pt>
                <c:pt idx="14">
                  <c:v>H1</c:v>
                </c:pt>
                <c:pt idx="15">
                  <c:v>C6</c:v>
                </c:pt>
                <c:pt idx="16">
                  <c:v>E4</c:v>
                </c:pt>
                <c:pt idx="17">
                  <c:v>F4</c:v>
                </c:pt>
                <c:pt idx="18">
                  <c:v>C9</c:v>
                </c:pt>
                <c:pt idx="19">
                  <c:v>D7</c:v>
                </c:pt>
                <c:pt idx="20">
                  <c:v>H3</c:v>
                </c:pt>
                <c:pt idx="21">
                  <c:v>H10</c:v>
                </c:pt>
                <c:pt idx="22">
                  <c:v>E11</c:v>
                </c:pt>
                <c:pt idx="23">
                  <c:v>H8</c:v>
                </c:pt>
                <c:pt idx="24">
                  <c:v>D6</c:v>
                </c:pt>
                <c:pt idx="25">
                  <c:v>H7</c:v>
                </c:pt>
                <c:pt idx="26">
                  <c:v>B2</c:v>
                </c:pt>
                <c:pt idx="27">
                  <c:v>H2</c:v>
                </c:pt>
                <c:pt idx="28">
                  <c:v>F9</c:v>
                </c:pt>
                <c:pt idx="29">
                  <c:v>A2</c:v>
                </c:pt>
                <c:pt idx="30">
                  <c:v>D8</c:v>
                </c:pt>
                <c:pt idx="31">
                  <c:v>E9</c:v>
                </c:pt>
                <c:pt idx="32">
                  <c:v>D12</c:v>
                </c:pt>
                <c:pt idx="33">
                  <c:v>F8</c:v>
                </c:pt>
                <c:pt idx="34">
                  <c:v>E8</c:v>
                </c:pt>
                <c:pt idx="35">
                  <c:v>F7</c:v>
                </c:pt>
                <c:pt idx="36">
                  <c:v>D9</c:v>
                </c:pt>
                <c:pt idx="37">
                  <c:v>D11</c:v>
                </c:pt>
                <c:pt idx="38">
                  <c:v>H4</c:v>
                </c:pt>
                <c:pt idx="39">
                  <c:v>F1</c:v>
                </c:pt>
                <c:pt idx="40">
                  <c:v>E10</c:v>
                </c:pt>
                <c:pt idx="41">
                  <c:v>C12</c:v>
                </c:pt>
                <c:pt idx="42">
                  <c:v>A3</c:v>
                </c:pt>
                <c:pt idx="43">
                  <c:v>F3</c:v>
                </c:pt>
                <c:pt idx="44">
                  <c:v>D1</c:v>
                </c:pt>
                <c:pt idx="45">
                  <c:v>A5</c:v>
                </c:pt>
                <c:pt idx="46">
                  <c:v>H11</c:v>
                </c:pt>
                <c:pt idx="47">
                  <c:v>B12</c:v>
                </c:pt>
                <c:pt idx="48">
                  <c:v>F2</c:v>
                </c:pt>
                <c:pt idx="49">
                  <c:v>C2</c:v>
                </c:pt>
                <c:pt idx="50">
                  <c:v>D3</c:v>
                </c:pt>
                <c:pt idx="51">
                  <c:v>C11</c:v>
                </c:pt>
                <c:pt idx="52">
                  <c:v>B3</c:v>
                </c:pt>
                <c:pt idx="53">
                  <c:v>C7</c:v>
                </c:pt>
                <c:pt idx="54">
                  <c:v>D2</c:v>
                </c:pt>
                <c:pt idx="55">
                  <c:v>E12</c:v>
                </c:pt>
                <c:pt idx="56">
                  <c:v>A8</c:v>
                </c:pt>
                <c:pt idx="57">
                  <c:v>A9</c:v>
                </c:pt>
                <c:pt idx="58">
                  <c:v>D5</c:v>
                </c:pt>
                <c:pt idx="59">
                  <c:v>E1</c:v>
                </c:pt>
                <c:pt idx="60">
                  <c:v>E5</c:v>
                </c:pt>
                <c:pt idx="61">
                  <c:v>F10</c:v>
                </c:pt>
                <c:pt idx="62">
                  <c:v>C1</c:v>
                </c:pt>
                <c:pt idx="63">
                  <c:v>B4</c:v>
                </c:pt>
                <c:pt idx="64">
                  <c:v>A11</c:v>
                </c:pt>
                <c:pt idx="65">
                  <c:v>C8</c:v>
                </c:pt>
                <c:pt idx="66">
                  <c:v>E3</c:v>
                </c:pt>
                <c:pt idx="67">
                  <c:v>A10</c:v>
                </c:pt>
                <c:pt idx="68">
                  <c:v>B11</c:v>
                </c:pt>
                <c:pt idx="69">
                  <c:v>F5</c:v>
                </c:pt>
                <c:pt idx="70">
                  <c:v>D10</c:v>
                </c:pt>
                <c:pt idx="71">
                  <c:v>A4</c:v>
                </c:pt>
                <c:pt idx="72">
                  <c:v>C10</c:v>
                </c:pt>
                <c:pt idx="73">
                  <c:v>B7</c:v>
                </c:pt>
                <c:pt idx="74">
                  <c:v>C4</c:v>
                </c:pt>
                <c:pt idx="75">
                  <c:v>A7</c:v>
                </c:pt>
                <c:pt idx="76">
                  <c:v>B8</c:v>
                </c:pt>
                <c:pt idx="77">
                  <c:v>B5</c:v>
                </c:pt>
                <c:pt idx="78">
                  <c:v>A1</c:v>
                </c:pt>
                <c:pt idx="79">
                  <c:v>G1</c:v>
                </c:pt>
                <c:pt idx="80">
                  <c:v>G12</c:v>
                </c:pt>
                <c:pt idx="81">
                  <c:v>B10</c:v>
                </c:pt>
                <c:pt idx="82">
                  <c:v>C5</c:v>
                </c:pt>
                <c:pt idx="83">
                  <c:v>G5</c:v>
                </c:pt>
                <c:pt idx="84">
                  <c:v>B1</c:v>
                </c:pt>
                <c:pt idx="85">
                  <c:v>B6</c:v>
                </c:pt>
                <c:pt idx="86">
                  <c:v>D4</c:v>
                </c:pt>
                <c:pt idx="87">
                  <c:v>G2</c:v>
                </c:pt>
                <c:pt idx="88">
                  <c:v>B9</c:v>
                </c:pt>
                <c:pt idx="89">
                  <c:v>G8</c:v>
                </c:pt>
                <c:pt idx="90">
                  <c:v>G3</c:v>
                </c:pt>
                <c:pt idx="91">
                  <c:v>G7</c:v>
                </c:pt>
                <c:pt idx="92">
                  <c:v>G4</c:v>
                </c:pt>
                <c:pt idx="93">
                  <c:v>G10</c:v>
                </c:pt>
                <c:pt idx="94">
                  <c:v>G6</c:v>
                </c:pt>
                <c:pt idx="95">
                  <c:v>G11</c:v>
                </c:pt>
              </c:strCache>
            </c:strRef>
          </c:xVal>
          <c:yVal>
            <c:numRef>
              <c:f>HMF!$F$2:$F$97</c:f>
              <c:numCache>
                <c:formatCode>General</c:formatCode>
                <c:ptCount val="96"/>
                <c:pt idx="0">
                  <c:v>61.718749999999986</c:v>
                </c:pt>
                <c:pt idx="1">
                  <c:v>74.137931034482762</c:v>
                </c:pt>
                <c:pt idx="2">
                  <c:v>74.400000000000006</c:v>
                </c:pt>
                <c:pt idx="3">
                  <c:v>75.806451612903231</c:v>
                </c:pt>
                <c:pt idx="4">
                  <c:v>76.47058823529413</c:v>
                </c:pt>
                <c:pt idx="5">
                  <c:v>76.470588235294159</c:v>
                </c:pt>
                <c:pt idx="6">
                  <c:v>77.227722772277204</c:v>
                </c:pt>
                <c:pt idx="7">
                  <c:v>77.777777777777771</c:v>
                </c:pt>
                <c:pt idx="8">
                  <c:v>77.952755905511808</c:v>
                </c:pt>
                <c:pt idx="9">
                  <c:v>79.411764705882376</c:v>
                </c:pt>
                <c:pt idx="10">
                  <c:v>80.341880341880341</c:v>
                </c:pt>
                <c:pt idx="11">
                  <c:v>80.357142857142847</c:v>
                </c:pt>
                <c:pt idx="12">
                  <c:v>81.284916201117341</c:v>
                </c:pt>
                <c:pt idx="13">
                  <c:v>84.166666666666686</c:v>
                </c:pt>
                <c:pt idx="14">
                  <c:v>84.313725490196092</c:v>
                </c:pt>
                <c:pt idx="15">
                  <c:v>84.375</c:v>
                </c:pt>
                <c:pt idx="16">
                  <c:v>84.552845528455293</c:v>
                </c:pt>
                <c:pt idx="17">
                  <c:v>84.615384615384599</c:v>
                </c:pt>
                <c:pt idx="18">
                  <c:v>85.714285714285708</c:v>
                </c:pt>
                <c:pt idx="19">
                  <c:v>85.840707964601776</c:v>
                </c:pt>
                <c:pt idx="20">
                  <c:v>86.407766990291265</c:v>
                </c:pt>
                <c:pt idx="21">
                  <c:v>86.466165413533844</c:v>
                </c:pt>
                <c:pt idx="22">
                  <c:v>86.607142857142861</c:v>
                </c:pt>
                <c:pt idx="23">
                  <c:v>86.666666666666643</c:v>
                </c:pt>
                <c:pt idx="24">
                  <c:v>87.037037037037052</c:v>
                </c:pt>
                <c:pt idx="25">
                  <c:v>87.068965517241381</c:v>
                </c:pt>
                <c:pt idx="26">
                  <c:v>87.272727272727252</c:v>
                </c:pt>
                <c:pt idx="27">
                  <c:v>87.378640776699058</c:v>
                </c:pt>
                <c:pt idx="28">
                  <c:v>88.043478260869563</c:v>
                </c:pt>
                <c:pt idx="29">
                  <c:v>88.095238095238088</c:v>
                </c:pt>
                <c:pt idx="30">
                  <c:v>88.118811881188137</c:v>
                </c:pt>
                <c:pt idx="31">
                  <c:v>88.372093023255829</c:v>
                </c:pt>
                <c:pt idx="32">
                  <c:v>88.679245283018844</c:v>
                </c:pt>
                <c:pt idx="33">
                  <c:v>88.8888888888889</c:v>
                </c:pt>
                <c:pt idx="34">
                  <c:v>88.9908256880734</c:v>
                </c:pt>
                <c:pt idx="35">
                  <c:v>89.344262295081975</c:v>
                </c:pt>
                <c:pt idx="36">
                  <c:v>90.361445783132567</c:v>
                </c:pt>
                <c:pt idx="37">
                  <c:v>90.425531914893625</c:v>
                </c:pt>
                <c:pt idx="38">
                  <c:v>90.510948905109501</c:v>
                </c:pt>
                <c:pt idx="39">
                  <c:v>90.721649484536087</c:v>
                </c:pt>
                <c:pt idx="40">
                  <c:v>91.52542372881355</c:v>
                </c:pt>
                <c:pt idx="41">
                  <c:v>91.588785046728972</c:v>
                </c:pt>
                <c:pt idx="42">
                  <c:v>92.112676056338046</c:v>
                </c:pt>
                <c:pt idx="43">
                  <c:v>92.52336448598129</c:v>
                </c:pt>
                <c:pt idx="44">
                  <c:v>92.783505154639144</c:v>
                </c:pt>
                <c:pt idx="45">
                  <c:v>92.857142857142861</c:v>
                </c:pt>
                <c:pt idx="46">
                  <c:v>93.069306930693088</c:v>
                </c:pt>
                <c:pt idx="47">
                  <c:v>93.220338983050851</c:v>
                </c:pt>
                <c:pt idx="48">
                  <c:v>93.269230769230759</c:v>
                </c:pt>
                <c:pt idx="49">
                  <c:v>93.269230769230788</c:v>
                </c:pt>
                <c:pt idx="50">
                  <c:v>93.805309734513287</c:v>
                </c:pt>
                <c:pt idx="51">
                  <c:v>94.285714285714306</c:v>
                </c:pt>
                <c:pt idx="52">
                  <c:v>94.642857142857139</c:v>
                </c:pt>
                <c:pt idx="53">
                  <c:v>94.736842105263179</c:v>
                </c:pt>
                <c:pt idx="54">
                  <c:v>95.098039215686285</c:v>
                </c:pt>
                <c:pt idx="55">
                  <c:v>95.098039215686299</c:v>
                </c:pt>
                <c:pt idx="56">
                  <c:v>95.121951219512198</c:v>
                </c:pt>
                <c:pt idx="57">
                  <c:v>95.209580838323376</c:v>
                </c:pt>
                <c:pt idx="58">
                  <c:v>95.327102803738342</c:v>
                </c:pt>
                <c:pt idx="59">
                  <c:v>95.454545454545425</c:v>
                </c:pt>
                <c:pt idx="60">
                  <c:v>95.454545454545482</c:v>
                </c:pt>
                <c:pt idx="61">
                  <c:v>95.614035087719287</c:v>
                </c:pt>
                <c:pt idx="62">
                  <c:v>95.833333333333343</c:v>
                </c:pt>
                <c:pt idx="63">
                  <c:v>96.296296296296319</c:v>
                </c:pt>
                <c:pt idx="64">
                  <c:v>96.33027522935781</c:v>
                </c:pt>
                <c:pt idx="65">
                  <c:v>96.969696969696997</c:v>
                </c:pt>
                <c:pt idx="66">
                  <c:v>97.849462365591378</c:v>
                </c:pt>
                <c:pt idx="67">
                  <c:v>97.959183673469369</c:v>
                </c:pt>
                <c:pt idx="68">
                  <c:v>99.065420560747668</c:v>
                </c:pt>
                <c:pt idx="69">
                  <c:v>99.065420560747668</c:v>
                </c:pt>
                <c:pt idx="70">
                  <c:v>99.10714285714289</c:v>
                </c:pt>
                <c:pt idx="71">
                  <c:v>99.545454545454547</c:v>
                </c:pt>
                <c:pt idx="72">
                  <c:v>100</c:v>
                </c:pt>
                <c:pt idx="73">
                  <c:v>100.84745762711864</c:v>
                </c:pt>
                <c:pt idx="74">
                  <c:v>100.87719298245612</c:v>
                </c:pt>
                <c:pt idx="75">
                  <c:v>102.73972602739727</c:v>
                </c:pt>
                <c:pt idx="76">
                  <c:v>102.91262135922329</c:v>
                </c:pt>
                <c:pt idx="77">
                  <c:v>103.7037037037037</c:v>
                </c:pt>
                <c:pt idx="78">
                  <c:v>103.84615384615384</c:v>
                </c:pt>
                <c:pt idx="79">
                  <c:v>106.89655172413795</c:v>
                </c:pt>
                <c:pt idx="80">
                  <c:v>107.56302521008404</c:v>
                </c:pt>
                <c:pt idx="81">
                  <c:v>108.26446280991735</c:v>
                </c:pt>
                <c:pt idx="82">
                  <c:v>109.9009900990099</c:v>
                </c:pt>
                <c:pt idx="83">
                  <c:v>110.34482758620692</c:v>
                </c:pt>
                <c:pt idx="84">
                  <c:v>110.86956521739131</c:v>
                </c:pt>
                <c:pt idx="85">
                  <c:v>111.88118811881189</c:v>
                </c:pt>
                <c:pt idx="86">
                  <c:v>113.00000000000003</c:v>
                </c:pt>
                <c:pt idx="87">
                  <c:v>113.67521367521367</c:v>
                </c:pt>
                <c:pt idx="88">
                  <c:v>114.13043478260865</c:v>
                </c:pt>
                <c:pt idx="89">
                  <c:v>114.65517241379311</c:v>
                </c:pt>
                <c:pt idx="90">
                  <c:v>115.65217391304346</c:v>
                </c:pt>
                <c:pt idx="91">
                  <c:v>116.93548387096774</c:v>
                </c:pt>
                <c:pt idx="92">
                  <c:v>118.93939393939397</c:v>
                </c:pt>
                <c:pt idx="93">
                  <c:v>120.8</c:v>
                </c:pt>
                <c:pt idx="94">
                  <c:v>126.95652173913044</c:v>
                </c:pt>
                <c:pt idx="95">
                  <c:v>129.090909090909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097280"/>
        <c:axId val="157144704"/>
      </c:scatterChart>
      <c:valAx>
        <c:axId val="15709728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7144704"/>
        <c:crosses val="autoZero"/>
        <c:crossBetween val="midCat"/>
      </c:valAx>
      <c:valAx>
        <c:axId val="157144704"/>
        <c:scaling>
          <c:orientation val="minMax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709728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72402833314118953"/>
          <c:y val="0.41030949256342958"/>
          <c:w val="0.198193948072594"/>
          <c:h val="0.4710473170020413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370521120548894"/>
          <c:y val="5.1400554097404488E-2"/>
          <c:w val="0.71358275006480754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Temperature!$J$1</c:f>
              <c:strCache>
                <c:ptCount val="1"/>
                <c:pt idx="0">
                  <c:v>T (35'C)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Temperature!$B$2:$B$97</c:f>
              <c:strCache>
                <c:ptCount val="96"/>
                <c:pt idx="0">
                  <c:v>A6</c:v>
                </c:pt>
                <c:pt idx="1">
                  <c:v>F10</c:v>
                </c:pt>
                <c:pt idx="2">
                  <c:v>H9</c:v>
                </c:pt>
                <c:pt idx="3">
                  <c:v>H4</c:v>
                </c:pt>
                <c:pt idx="4">
                  <c:v>E4</c:v>
                </c:pt>
                <c:pt idx="5">
                  <c:v>A2</c:v>
                </c:pt>
                <c:pt idx="6">
                  <c:v>G6</c:v>
                </c:pt>
                <c:pt idx="7">
                  <c:v>H7</c:v>
                </c:pt>
                <c:pt idx="8">
                  <c:v>A4</c:v>
                </c:pt>
                <c:pt idx="9">
                  <c:v>A11</c:v>
                </c:pt>
                <c:pt idx="10">
                  <c:v>G4</c:v>
                </c:pt>
                <c:pt idx="11">
                  <c:v>D3</c:v>
                </c:pt>
                <c:pt idx="12">
                  <c:v>A1</c:v>
                </c:pt>
                <c:pt idx="13">
                  <c:v>C7</c:v>
                </c:pt>
                <c:pt idx="14">
                  <c:v>B7</c:v>
                </c:pt>
                <c:pt idx="15">
                  <c:v>G12</c:v>
                </c:pt>
                <c:pt idx="16">
                  <c:v>E6</c:v>
                </c:pt>
                <c:pt idx="17">
                  <c:v>F8</c:v>
                </c:pt>
                <c:pt idx="18">
                  <c:v>E2</c:v>
                </c:pt>
                <c:pt idx="19">
                  <c:v>F9</c:v>
                </c:pt>
                <c:pt idx="20">
                  <c:v>H8</c:v>
                </c:pt>
                <c:pt idx="21">
                  <c:v>G5</c:v>
                </c:pt>
                <c:pt idx="22">
                  <c:v>C3</c:v>
                </c:pt>
                <c:pt idx="23">
                  <c:v>F2</c:v>
                </c:pt>
                <c:pt idx="24">
                  <c:v>B6</c:v>
                </c:pt>
                <c:pt idx="25">
                  <c:v>C12</c:v>
                </c:pt>
                <c:pt idx="26">
                  <c:v>D9</c:v>
                </c:pt>
                <c:pt idx="27">
                  <c:v>B12</c:v>
                </c:pt>
                <c:pt idx="28">
                  <c:v>B9</c:v>
                </c:pt>
                <c:pt idx="29">
                  <c:v>D6</c:v>
                </c:pt>
                <c:pt idx="30">
                  <c:v>G2</c:v>
                </c:pt>
                <c:pt idx="31">
                  <c:v>H6</c:v>
                </c:pt>
                <c:pt idx="32">
                  <c:v>B3</c:v>
                </c:pt>
                <c:pt idx="33">
                  <c:v>F1</c:v>
                </c:pt>
                <c:pt idx="34">
                  <c:v>D4</c:v>
                </c:pt>
                <c:pt idx="35">
                  <c:v>F7</c:v>
                </c:pt>
                <c:pt idx="36">
                  <c:v>B5</c:v>
                </c:pt>
                <c:pt idx="37">
                  <c:v>D1</c:v>
                </c:pt>
                <c:pt idx="38">
                  <c:v>H11</c:v>
                </c:pt>
                <c:pt idx="39">
                  <c:v>F12</c:v>
                </c:pt>
                <c:pt idx="40">
                  <c:v>F6</c:v>
                </c:pt>
                <c:pt idx="41">
                  <c:v>A5</c:v>
                </c:pt>
                <c:pt idx="42">
                  <c:v>E12</c:v>
                </c:pt>
                <c:pt idx="43">
                  <c:v>H3</c:v>
                </c:pt>
                <c:pt idx="44">
                  <c:v>G8</c:v>
                </c:pt>
                <c:pt idx="45">
                  <c:v>E7</c:v>
                </c:pt>
                <c:pt idx="46">
                  <c:v>D10</c:v>
                </c:pt>
                <c:pt idx="47">
                  <c:v>F4</c:v>
                </c:pt>
                <c:pt idx="48">
                  <c:v>C5</c:v>
                </c:pt>
                <c:pt idx="49">
                  <c:v>E10</c:v>
                </c:pt>
                <c:pt idx="50">
                  <c:v>B4</c:v>
                </c:pt>
                <c:pt idx="51">
                  <c:v>D12</c:v>
                </c:pt>
                <c:pt idx="52">
                  <c:v>G11</c:v>
                </c:pt>
                <c:pt idx="53">
                  <c:v>A8</c:v>
                </c:pt>
                <c:pt idx="54">
                  <c:v>E9</c:v>
                </c:pt>
                <c:pt idx="55">
                  <c:v>C2</c:v>
                </c:pt>
                <c:pt idx="56">
                  <c:v>C6</c:v>
                </c:pt>
                <c:pt idx="57">
                  <c:v>A7</c:v>
                </c:pt>
                <c:pt idx="58">
                  <c:v>D2</c:v>
                </c:pt>
                <c:pt idx="59">
                  <c:v>E5</c:v>
                </c:pt>
                <c:pt idx="60">
                  <c:v>A10</c:v>
                </c:pt>
                <c:pt idx="61">
                  <c:v>E11</c:v>
                </c:pt>
                <c:pt idx="62">
                  <c:v>G3</c:v>
                </c:pt>
                <c:pt idx="63">
                  <c:v>A12</c:v>
                </c:pt>
                <c:pt idx="64">
                  <c:v>G1</c:v>
                </c:pt>
                <c:pt idx="65">
                  <c:v>B8</c:v>
                </c:pt>
                <c:pt idx="66">
                  <c:v>C4</c:v>
                </c:pt>
                <c:pt idx="67">
                  <c:v>C11</c:v>
                </c:pt>
                <c:pt idx="68">
                  <c:v>F5</c:v>
                </c:pt>
                <c:pt idx="69">
                  <c:v>F11</c:v>
                </c:pt>
                <c:pt idx="70">
                  <c:v>E3</c:v>
                </c:pt>
                <c:pt idx="71">
                  <c:v>D11</c:v>
                </c:pt>
                <c:pt idx="72">
                  <c:v>G9</c:v>
                </c:pt>
                <c:pt idx="73">
                  <c:v>A9</c:v>
                </c:pt>
                <c:pt idx="74">
                  <c:v>G10</c:v>
                </c:pt>
                <c:pt idx="75">
                  <c:v>D7</c:v>
                </c:pt>
                <c:pt idx="76">
                  <c:v>C1</c:v>
                </c:pt>
                <c:pt idx="77">
                  <c:v>H1</c:v>
                </c:pt>
                <c:pt idx="78">
                  <c:v>G7</c:v>
                </c:pt>
                <c:pt idx="79">
                  <c:v>B10</c:v>
                </c:pt>
                <c:pt idx="80">
                  <c:v>H5</c:v>
                </c:pt>
                <c:pt idx="81">
                  <c:v>E1</c:v>
                </c:pt>
                <c:pt idx="82">
                  <c:v>B1</c:v>
                </c:pt>
                <c:pt idx="83">
                  <c:v>E8</c:v>
                </c:pt>
                <c:pt idx="84">
                  <c:v>C8</c:v>
                </c:pt>
                <c:pt idx="85">
                  <c:v>B11</c:v>
                </c:pt>
                <c:pt idx="86">
                  <c:v>C10</c:v>
                </c:pt>
                <c:pt idx="87">
                  <c:v>F3</c:v>
                </c:pt>
                <c:pt idx="88">
                  <c:v>H12</c:v>
                </c:pt>
                <c:pt idx="89">
                  <c:v>H10</c:v>
                </c:pt>
                <c:pt idx="90">
                  <c:v>D8</c:v>
                </c:pt>
                <c:pt idx="91">
                  <c:v>D5</c:v>
                </c:pt>
                <c:pt idx="92">
                  <c:v>C9</c:v>
                </c:pt>
                <c:pt idx="93">
                  <c:v>A3</c:v>
                </c:pt>
                <c:pt idx="94">
                  <c:v>B2</c:v>
                </c:pt>
                <c:pt idx="95">
                  <c:v>H2</c:v>
                </c:pt>
              </c:strCache>
            </c:strRef>
          </c:xVal>
          <c:yVal>
            <c:numRef>
              <c:f>Temperature!$J$2:$J$97</c:f>
              <c:numCache>
                <c:formatCode>General</c:formatCode>
                <c:ptCount val="96"/>
                <c:pt idx="0">
                  <c:v>0</c:v>
                </c:pt>
                <c:pt idx="1">
                  <c:v>2.0202020202020345</c:v>
                </c:pt>
                <c:pt idx="2">
                  <c:v>19.811320754716995</c:v>
                </c:pt>
                <c:pt idx="3">
                  <c:v>25.217391304347796</c:v>
                </c:pt>
                <c:pt idx="4">
                  <c:v>30.630630630630662</c:v>
                </c:pt>
                <c:pt idx="5">
                  <c:v>34.704370179948576</c:v>
                </c:pt>
                <c:pt idx="6">
                  <c:v>35.344827586206875</c:v>
                </c:pt>
                <c:pt idx="7">
                  <c:v>38.888888888888886</c:v>
                </c:pt>
                <c:pt idx="8">
                  <c:v>40.102827763496137</c:v>
                </c:pt>
                <c:pt idx="9">
                  <c:v>40.401146131805177</c:v>
                </c:pt>
                <c:pt idx="10">
                  <c:v>40.425531914893583</c:v>
                </c:pt>
                <c:pt idx="11">
                  <c:v>41.666666666666707</c:v>
                </c:pt>
                <c:pt idx="12">
                  <c:v>42.34527687296422</c:v>
                </c:pt>
                <c:pt idx="13">
                  <c:v>42.741935483870982</c:v>
                </c:pt>
                <c:pt idx="14">
                  <c:v>42.982456140350855</c:v>
                </c:pt>
                <c:pt idx="15">
                  <c:v>43.137254901960759</c:v>
                </c:pt>
                <c:pt idx="16">
                  <c:v>43.243243243243235</c:v>
                </c:pt>
                <c:pt idx="17">
                  <c:v>43.666666666666671</c:v>
                </c:pt>
                <c:pt idx="18">
                  <c:v>43.689320388349515</c:v>
                </c:pt>
                <c:pt idx="19">
                  <c:v>43.894389438943875</c:v>
                </c:pt>
                <c:pt idx="20">
                  <c:v>44.247787610619483</c:v>
                </c:pt>
                <c:pt idx="21">
                  <c:v>45.000000000000007</c:v>
                </c:pt>
                <c:pt idx="22">
                  <c:v>45.283018867924575</c:v>
                </c:pt>
                <c:pt idx="23">
                  <c:v>46.428571428571416</c:v>
                </c:pt>
                <c:pt idx="24">
                  <c:v>47.321428571428591</c:v>
                </c:pt>
                <c:pt idx="25">
                  <c:v>48.695652173913132</c:v>
                </c:pt>
                <c:pt idx="26">
                  <c:v>48.958333333333293</c:v>
                </c:pt>
                <c:pt idx="27">
                  <c:v>48.958333333333336</c:v>
                </c:pt>
                <c:pt idx="28">
                  <c:v>49.473684210526322</c:v>
                </c:pt>
                <c:pt idx="29">
                  <c:v>50.000000000000021</c:v>
                </c:pt>
                <c:pt idx="30">
                  <c:v>50.92592592592591</c:v>
                </c:pt>
                <c:pt idx="31">
                  <c:v>51.376146788990795</c:v>
                </c:pt>
                <c:pt idx="32">
                  <c:v>51.485148514851474</c:v>
                </c:pt>
                <c:pt idx="33">
                  <c:v>51.612903225806448</c:v>
                </c:pt>
                <c:pt idx="34">
                  <c:v>51.851851851851826</c:v>
                </c:pt>
                <c:pt idx="35">
                  <c:v>52.06611570247933</c:v>
                </c:pt>
                <c:pt idx="36">
                  <c:v>52.873563218390807</c:v>
                </c:pt>
                <c:pt idx="37">
                  <c:v>53.535353535353515</c:v>
                </c:pt>
                <c:pt idx="38">
                  <c:v>53.773584905660385</c:v>
                </c:pt>
                <c:pt idx="39">
                  <c:v>53.913043478260882</c:v>
                </c:pt>
                <c:pt idx="40">
                  <c:v>54.032258064516114</c:v>
                </c:pt>
                <c:pt idx="41">
                  <c:v>54.518072289156635</c:v>
                </c:pt>
                <c:pt idx="42">
                  <c:v>54.71698113207546</c:v>
                </c:pt>
                <c:pt idx="43">
                  <c:v>54.716981132075503</c:v>
                </c:pt>
                <c:pt idx="44">
                  <c:v>54.999999999999986</c:v>
                </c:pt>
                <c:pt idx="45">
                  <c:v>55.357142857142868</c:v>
                </c:pt>
                <c:pt idx="46">
                  <c:v>55.555555555555571</c:v>
                </c:pt>
                <c:pt idx="47">
                  <c:v>55.660377358490578</c:v>
                </c:pt>
                <c:pt idx="48">
                  <c:v>55.789473684210542</c:v>
                </c:pt>
                <c:pt idx="49">
                  <c:v>56.818181818181777</c:v>
                </c:pt>
                <c:pt idx="50">
                  <c:v>57.281553398058257</c:v>
                </c:pt>
                <c:pt idx="51">
                  <c:v>57.731958762886606</c:v>
                </c:pt>
                <c:pt idx="52">
                  <c:v>57.999999999999986</c:v>
                </c:pt>
                <c:pt idx="53">
                  <c:v>58.153846153846146</c:v>
                </c:pt>
                <c:pt idx="54">
                  <c:v>58.490566037735817</c:v>
                </c:pt>
                <c:pt idx="55">
                  <c:v>58.496732026143846</c:v>
                </c:pt>
                <c:pt idx="56">
                  <c:v>59.829059829059851</c:v>
                </c:pt>
                <c:pt idx="57">
                  <c:v>60.152284263959366</c:v>
                </c:pt>
                <c:pt idx="58">
                  <c:v>60.396039603960418</c:v>
                </c:pt>
                <c:pt idx="59">
                  <c:v>60.439560439560424</c:v>
                </c:pt>
                <c:pt idx="60">
                  <c:v>60.869565217391298</c:v>
                </c:pt>
                <c:pt idx="61">
                  <c:v>62.000000000000021</c:v>
                </c:pt>
                <c:pt idx="62">
                  <c:v>62.616822429906534</c:v>
                </c:pt>
                <c:pt idx="63">
                  <c:v>62.942779291553151</c:v>
                </c:pt>
                <c:pt idx="64">
                  <c:v>63.291139240506347</c:v>
                </c:pt>
                <c:pt idx="65">
                  <c:v>63.636363636363647</c:v>
                </c:pt>
                <c:pt idx="66">
                  <c:v>63.63636363636369</c:v>
                </c:pt>
                <c:pt idx="67">
                  <c:v>63.716814159292035</c:v>
                </c:pt>
                <c:pt idx="68">
                  <c:v>63.917525773195884</c:v>
                </c:pt>
                <c:pt idx="69">
                  <c:v>64.210526315789465</c:v>
                </c:pt>
                <c:pt idx="70">
                  <c:v>64.545454545454533</c:v>
                </c:pt>
                <c:pt idx="71">
                  <c:v>65.686274509803894</c:v>
                </c:pt>
                <c:pt idx="72">
                  <c:v>65.909090909090935</c:v>
                </c:pt>
                <c:pt idx="73">
                  <c:v>66.363636363636374</c:v>
                </c:pt>
                <c:pt idx="74">
                  <c:v>66.666666666666643</c:v>
                </c:pt>
                <c:pt idx="75">
                  <c:v>66.666666666666657</c:v>
                </c:pt>
                <c:pt idx="76">
                  <c:v>67.391304347826065</c:v>
                </c:pt>
                <c:pt idx="77">
                  <c:v>67.857142857142861</c:v>
                </c:pt>
                <c:pt idx="78">
                  <c:v>68</c:v>
                </c:pt>
                <c:pt idx="79">
                  <c:v>69.135802469135797</c:v>
                </c:pt>
                <c:pt idx="80">
                  <c:v>69.565217391304358</c:v>
                </c:pt>
                <c:pt idx="81">
                  <c:v>70.666666666666714</c:v>
                </c:pt>
                <c:pt idx="82">
                  <c:v>70.886075949367125</c:v>
                </c:pt>
                <c:pt idx="83">
                  <c:v>71.13402061855669</c:v>
                </c:pt>
                <c:pt idx="84">
                  <c:v>71.276595744680847</c:v>
                </c:pt>
                <c:pt idx="85">
                  <c:v>71.428571428571431</c:v>
                </c:pt>
                <c:pt idx="86">
                  <c:v>72.999999999999972</c:v>
                </c:pt>
                <c:pt idx="87">
                  <c:v>73.394495412844009</c:v>
                </c:pt>
                <c:pt idx="88">
                  <c:v>74.038461538461547</c:v>
                </c:pt>
                <c:pt idx="89">
                  <c:v>77.142857142857125</c:v>
                </c:pt>
                <c:pt idx="90">
                  <c:v>80.232558139534873</c:v>
                </c:pt>
                <c:pt idx="91">
                  <c:v>82.105263157894697</c:v>
                </c:pt>
                <c:pt idx="92">
                  <c:v>82.857142857142847</c:v>
                </c:pt>
                <c:pt idx="93">
                  <c:v>84.135977337110504</c:v>
                </c:pt>
                <c:pt idx="94">
                  <c:v>95.918367346938822</c:v>
                </c:pt>
                <c:pt idx="95">
                  <c:v>143.750000000000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38560"/>
        <c:axId val="194937408"/>
      </c:scatterChart>
      <c:valAx>
        <c:axId val="19493856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937408"/>
        <c:crosses val="autoZero"/>
        <c:crossBetween val="midCat"/>
      </c:valAx>
      <c:valAx>
        <c:axId val="194937408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938560"/>
        <c:crosses val="autoZero"/>
        <c:crossBetween val="midCat"/>
        <c:majorUnit val="50"/>
      </c:valAx>
    </c:plotArea>
    <c:legend>
      <c:legendPos val="r"/>
      <c:layout>
        <c:manualLayout>
          <c:xMode val="edge"/>
          <c:yMode val="edge"/>
          <c:x val="0.66506835940787723"/>
          <c:y val="0.63869677748614762"/>
          <c:w val="0.29326497392545609"/>
          <c:h val="0.1114949693788276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50402992620888"/>
          <c:y val="5.1400554097404488E-2"/>
          <c:w val="0.70312422549081155"/>
          <c:h val="0.83261956838728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Sheet1 (2)'!$C$1</c:f>
              <c:strCache>
                <c:ptCount val="1"/>
                <c:pt idx="0">
                  <c:v>Acet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Sheet1 (2)'!$B$2:$B$97</c:f>
              <c:strCache>
                <c:ptCount val="96"/>
                <c:pt idx="0">
                  <c:v>H2</c:v>
                </c:pt>
                <c:pt idx="1">
                  <c:v>F9</c:v>
                </c:pt>
                <c:pt idx="2">
                  <c:v>B8</c:v>
                </c:pt>
                <c:pt idx="3">
                  <c:v>D6</c:v>
                </c:pt>
                <c:pt idx="4">
                  <c:v>D4</c:v>
                </c:pt>
                <c:pt idx="5">
                  <c:v>F7</c:v>
                </c:pt>
                <c:pt idx="6">
                  <c:v>B1</c:v>
                </c:pt>
                <c:pt idx="7">
                  <c:v>D12</c:v>
                </c:pt>
                <c:pt idx="8">
                  <c:v>G4</c:v>
                </c:pt>
                <c:pt idx="9">
                  <c:v>H6</c:v>
                </c:pt>
                <c:pt idx="10">
                  <c:v>D8</c:v>
                </c:pt>
                <c:pt idx="11">
                  <c:v>E7</c:v>
                </c:pt>
                <c:pt idx="12">
                  <c:v>G12</c:v>
                </c:pt>
                <c:pt idx="13">
                  <c:v>D7</c:v>
                </c:pt>
                <c:pt idx="14">
                  <c:v>B6</c:v>
                </c:pt>
                <c:pt idx="15">
                  <c:v>D10</c:v>
                </c:pt>
                <c:pt idx="16">
                  <c:v>C5</c:v>
                </c:pt>
                <c:pt idx="17">
                  <c:v>C3</c:v>
                </c:pt>
                <c:pt idx="18">
                  <c:v>F4</c:v>
                </c:pt>
                <c:pt idx="19">
                  <c:v>E5</c:v>
                </c:pt>
                <c:pt idx="20">
                  <c:v>D1</c:v>
                </c:pt>
                <c:pt idx="21">
                  <c:v>B3</c:v>
                </c:pt>
                <c:pt idx="22">
                  <c:v>E9</c:v>
                </c:pt>
                <c:pt idx="23">
                  <c:v>C7</c:v>
                </c:pt>
                <c:pt idx="24">
                  <c:v>G2</c:v>
                </c:pt>
                <c:pt idx="25">
                  <c:v>A10</c:v>
                </c:pt>
                <c:pt idx="26">
                  <c:v>H9</c:v>
                </c:pt>
                <c:pt idx="27">
                  <c:v>H12</c:v>
                </c:pt>
                <c:pt idx="28">
                  <c:v>H7</c:v>
                </c:pt>
                <c:pt idx="29">
                  <c:v>E2</c:v>
                </c:pt>
                <c:pt idx="30">
                  <c:v>B10</c:v>
                </c:pt>
                <c:pt idx="31">
                  <c:v>F8</c:v>
                </c:pt>
                <c:pt idx="32">
                  <c:v>A2</c:v>
                </c:pt>
                <c:pt idx="33">
                  <c:v>H5</c:v>
                </c:pt>
                <c:pt idx="34">
                  <c:v>A1</c:v>
                </c:pt>
                <c:pt idx="35">
                  <c:v>H11</c:v>
                </c:pt>
                <c:pt idx="36">
                  <c:v>C11</c:v>
                </c:pt>
                <c:pt idx="37">
                  <c:v>A12</c:v>
                </c:pt>
                <c:pt idx="38">
                  <c:v>A7</c:v>
                </c:pt>
                <c:pt idx="39">
                  <c:v>E4</c:v>
                </c:pt>
                <c:pt idx="40">
                  <c:v>A9</c:v>
                </c:pt>
                <c:pt idx="41">
                  <c:v>G7</c:v>
                </c:pt>
                <c:pt idx="42">
                  <c:v>E11</c:v>
                </c:pt>
                <c:pt idx="43">
                  <c:v>G10</c:v>
                </c:pt>
                <c:pt idx="44">
                  <c:v>C12</c:v>
                </c:pt>
                <c:pt idx="45">
                  <c:v>A8</c:v>
                </c:pt>
                <c:pt idx="46">
                  <c:v>D11</c:v>
                </c:pt>
                <c:pt idx="47">
                  <c:v>E12</c:v>
                </c:pt>
                <c:pt idx="48">
                  <c:v>F2</c:v>
                </c:pt>
                <c:pt idx="49">
                  <c:v>G8</c:v>
                </c:pt>
                <c:pt idx="50">
                  <c:v>B12</c:v>
                </c:pt>
                <c:pt idx="51">
                  <c:v>C9</c:v>
                </c:pt>
                <c:pt idx="52">
                  <c:v>F6</c:v>
                </c:pt>
                <c:pt idx="53">
                  <c:v>A6</c:v>
                </c:pt>
                <c:pt idx="54">
                  <c:v>C10</c:v>
                </c:pt>
                <c:pt idx="55">
                  <c:v>A4</c:v>
                </c:pt>
                <c:pt idx="56">
                  <c:v>F3</c:v>
                </c:pt>
                <c:pt idx="57">
                  <c:v>E1</c:v>
                </c:pt>
                <c:pt idx="58">
                  <c:v>C8</c:v>
                </c:pt>
                <c:pt idx="59">
                  <c:v>A11</c:v>
                </c:pt>
                <c:pt idx="60">
                  <c:v>C6</c:v>
                </c:pt>
                <c:pt idx="61">
                  <c:v>G6</c:v>
                </c:pt>
                <c:pt idx="62">
                  <c:v>H10</c:v>
                </c:pt>
                <c:pt idx="63">
                  <c:v>F5</c:v>
                </c:pt>
                <c:pt idx="64">
                  <c:v>A5</c:v>
                </c:pt>
                <c:pt idx="65">
                  <c:v>C4</c:v>
                </c:pt>
                <c:pt idx="66">
                  <c:v>B4</c:v>
                </c:pt>
                <c:pt idx="67">
                  <c:v>C2</c:v>
                </c:pt>
                <c:pt idx="68">
                  <c:v>E10</c:v>
                </c:pt>
                <c:pt idx="69">
                  <c:v>F10</c:v>
                </c:pt>
                <c:pt idx="70">
                  <c:v>E3</c:v>
                </c:pt>
                <c:pt idx="71">
                  <c:v>G1</c:v>
                </c:pt>
                <c:pt idx="72">
                  <c:v>D9</c:v>
                </c:pt>
                <c:pt idx="73">
                  <c:v>G5</c:v>
                </c:pt>
                <c:pt idx="74">
                  <c:v>D2</c:v>
                </c:pt>
                <c:pt idx="75">
                  <c:v>A3</c:v>
                </c:pt>
                <c:pt idx="76">
                  <c:v>B2</c:v>
                </c:pt>
                <c:pt idx="77">
                  <c:v>B11</c:v>
                </c:pt>
                <c:pt idx="78">
                  <c:v>B5</c:v>
                </c:pt>
                <c:pt idx="79">
                  <c:v>G9</c:v>
                </c:pt>
                <c:pt idx="80">
                  <c:v>G3</c:v>
                </c:pt>
                <c:pt idx="81">
                  <c:v>D5</c:v>
                </c:pt>
                <c:pt idx="82">
                  <c:v>D3</c:v>
                </c:pt>
                <c:pt idx="83">
                  <c:v>F12</c:v>
                </c:pt>
                <c:pt idx="84">
                  <c:v>H4</c:v>
                </c:pt>
                <c:pt idx="85">
                  <c:v>B7</c:v>
                </c:pt>
                <c:pt idx="86">
                  <c:v>H3</c:v>
                </c:pt>
                <c:pt idx="87">
                  <c:v>G11</c:v>
                </c:pt>
                <c:pt idx="88">
                  <c:v>H1</c:v>
                </c:pt>
                <c:pt idx="89">
                  <c:v>F11</c:v>
                </c:pt>
                <c:pt idx="90">
                  <c:v>C1</c:v>
                </c:pt>
                <c:pt idx="91">
                  <c:v>E6</c:v>
                </c:pt>
                <c:pt idx="92">
                  <c:v>B9</c:v>
                </c:pt>
                <c:pt idx="93">
                  <c:v>H8</c:v>
                </c:pt>
                <c:pt idx="94">
                  <c:v>E8</c:v>
                </c:pt>
                <c:pt idx="95">
                  <c:v>F1</c:v>
                </c:pt>
              </c:strCache>
            </c:strRef>
          </c:xVal>
          <c:yVal>
            <c:numRef>
              <c:f>'Sheet1 (2)'!$C$2:$C$97</c:f>
              <c:numCache>
                <c:formatCode>General</c:formatCode>
                <c:ptCount val="96"/>
                <c:pt idx="0">
                  <c:v>71.612903225806448</c:v>
                </c:pt>
                <c:pt idx="1">
                  <c:v>78.625954198473281</c:v>
                </c:pt>
                <c:pt idx="2">
                  <c:v>80.468750000000014</c:v>
                </c:pt>
                <c:pt idx="3">
                  <c:v>81.300813008130064</c:v>
                </c:pt>
                <c:pt idx="4">
                  <c:v>81.699346405228724</c:v>
                </c:pt>
                <c:pt idx="5">
                  <c:v>81.746031746031747</c:v>
                </c:pt>
                <c:pt idx="6">
                  <c:v>81.818181818181827</c:v>
                </c:pt>
                <c:pt idx="7">
                  <c:v>82.142857142857167</c:v>
                </c:pt>
                <c:pt idx="8">
                  <c:v>82.35294117647058</c:v>
                </c:pt>
                <c:pt idx="9">
                  <c:v>82.894736842105246</c:v>
                </c:pt>
                <c:pt idx="10">
                  <c:v>82.926829268292664</c:v>
                </c:pt>
                <c:pt idx="11">
                  <c:v>83.07692307692308</c:v>
                </c:pt>
                <c:pt idx="12">
                  <c:v>83.116883116883116</c:v>
                </c:pt>
                <c:pt idx="13">
                  <c:v>83.783783783783775</c:v>
                </c:pt>
                <c:pt idx="14">
                  <c:v>83.85093167701865</c:v>
                </c:pt>
                <c:pt idx="15">
                  <c:v>84.285714285714263</c:v>
                </c:pt>
                <c:pt idx="16">
                  <c:v>84.967320261437891</c:v>
                </c:pt>
                <c:pt idx="17">
                  <c:v>85.034013605442183</c:v>
                </c:pt>
                <c:pt idx="18">
                  <c:v>85.294117647058826</c:v>
                </c:pt>
                <c:pt idx="19">
                  <c:v>85.314685314685292</c:v>
                </c:pt>
                <c:pt idx="20">
                  <c:v>85.517241379310349</c:v>
                </c:pt>
                <c:pt idx="21">
                  <c:v>85.91549295774648</c:v>
                </c:pt>
                <c:pt idx="22">
                  <c:v>85.91549295774648</c:v>
                </c:pt>
                <c:pt idx="23">
                  <c:v>85.925925925925952</c:v>
                </c:pt>
                <c:pt idx="24">
                  <c:v>85.925925925925952</c:v>
                </c:pt>
                <c:pt idx="25">
                  <c:v>85.964912280701753</c:v>
                </c:pt>
                <c:pt idx="26">
                  <c:v>86.206896551724142</c:v>
                </c:pt>
                <c:pt idx="27">
                  <c:v>86.549707602339183</c:v>
                </c:pt>
                <c:pt idx="28">
                  <c:v>86.764705882352928</c:v>
                </c:pt>
                <c:pt idx="29">
                  <c:v>87.068965517241352</c:v>
                </c:pt>
                <c:pt idx="30">
                  <c:v>87.09677419354837</c:v>
                </c:pt>
                <c:pt idx="31">
                  <c:v>87.610619469026545</c:v>
                </c:pt>
                <c:pt idx="32">
                  <c:v>87.698412698412682</c:v>
                </c:pt>
                <c:pt idx="33">
                  <c:v>88.571428571428569</c:v>
                </c:pt>
                <c:pt idx="34">
                  <c:v>89.344262295081947</c:v>
                </c:pt>
                <c:pt idx="35">
                  <c:v>89.570552147239255</c:v>
                </c:pt>
                <c:pt idx="36">
                  <c:v>89.830508474576277</c:v>
                </c:pt>
                <c:pt idx="37">
                  <c:v>89.861751152073708</c:v>
                </c:pt>
                <c:pt idx="38">
                  <c:v>89.912280701754383</c:v>
                </c:pt>
                <c:pt idx="39">
                  <c:v>89.999999999999986</c:v>
                </c:pt>
                <c:pt idx="40">
                  <c:v>90.187891440501048</c:v>
                </c:pt>
                <c:pt idx="41">
                  <c:v>90.298507462686558</c:v>
                </c:pt>
                <c:pt idx="42">
                  <c:v>90.344827586206875</c:v>
                </c:pt>
                <c:pt idx="43">
                  <c:v>90.344827586206904</c:v>
                </c:pt>
                <c:pt idx="44">
                  <c:v>91.538461538461519</c:v>
                </c:pt>
                <c:pt idx="45">
                  <c:v>91.689008042895466</c:v>
                </c:pt>
                <c:pt idx="46">
                  <c:v>91.729323308270665</c:v>
                </c:pt>
                <c:pt idx="47">
                  <c:v>92.10526315789474</c:v>
                </c:pt>
                <c:pt idx="48">
                  <c:v>92.187499999999972</c:v>
                </c:pt>
                <c:pt idx="49">
                  <c:v>92.857142857142875</c:v>
                </c:pt>
                <c:pt idx="50">
                  <c:v>93.430656934306583</c:v>
                </c:pt>
                <c:pt idx="51">
                  <c:v>93.650793650793631</c:v>
                </c:pt>
                <c:pt idx="52">
                  <c:v>94.399999999999991</c:v>
                </c:pt>
                <c:pt idx="53">
                  <c:v>94.512195121951237</c:v>
                </c:pt>
                <c:pt idx="54">
                  <c:v>94.871794871794847</c:v>
                </c:pt>
                <c:pt idx="55">
                  <c:v>95.622119815668199</c:v>
                </c:pt>
                <c:pt idx="56">
                  <c:v>96.296296296296291</c:v>
                </c:pt>
                <c:pt idx="57">
                  <c:v>96.376811594202906</c:v>
                </c:pt>
                <c:pt idx="58">
                  <c:v>96.747967479674827</c:v>
                </c:pt>
                <c:pt idx="59">
                  <c:v>96.8</c:v>
                </c:pt>
                <c:pt idx="60">
                  <c:v>96.875000000000014</c:v>
                </c:pt>
                <c:pt idx="61">
                  <c:v>97.674418604651152</c:v>
                </c:pt>
                <c:pt idx="62">
                  <c:v>97.72727272727272</c:v>
                </c:pt>
                <c:pt idx="63">
                  <c:v>97.857142857142833</c:v>
                </c:pt>
                <c:pt idx="64">
                  <c:v>97.979797979797951</c:v>
                </c:pt>
                <c:pt idx="65">
                  <c:v>98.275862068965552</c:v>
                </c:pt>
                <c:pt idx="66">
                  <c:v>98.780487804878049</c:v>
                </c:pt>
                <c:pt idx="67">
                  <c:v>99.264705882352928</c:v>
                </c:pt>
                <c:pt idx="68">
                  <c:v>99.270072992700719</c:v>
                </c:pt>
                <c:pt idx="69">
                  <c:v>99.390243902439025</c:v>
                </c:pt>
                <c:pt idx="70">
                  <c:v>102.14285714285715</c:v>
                </c:pt>
                <c:pt idx="71">
                  <c:v>102.72108843537413</c:v>
                </c:pt>
                <c:pt idx="72">
                  <c:v>102.81690140845072</c:v>
                </c:pt>
                <c:pt idx="73">
                  <c:v>103.07692307692307</c:v>
                </c:pt>
                <c:pt idx="74">
                  <c:v>103.2258064516129</c:v>
                </c:pt>
                <c:pt idx="75">
                  <c:v>103.32541567695958</c:v>
                </c:pt>
                <c:pt idx="76">
                  <c:v>103.41880341880344</c:v>
                </c:pt>
                <c:pt idx="77">
                  <c:v>103.90625000000003</c:v>
                </c:pt>
                <c:pt idx="78">
                  <c:v>104.51127819548871</c:v>
                </c:pt>
                <c:pt idx="79">
                  <c:v>105.06329113924049</c:v>
                </c:pt>
                <c:pt idx="80">
                  <c:v>106.66666666666667</c:v>
                </c:pt>
                <c:pt idx="81">
                  <c:v>106.81818181818181</c:v>
                </c:pt>
                <c:pt idx="82">
                  <c:v>107.14285714285714</c:v>
                </c:pt>
                <c:pt idx="83">
                  <c:v>107.19424460431655</c:v>
                </c:pt>
                <c:pt idx="84">
                  <c:v>107.28476821192055</c:v>
                </c:pt>
                <c:pt idx="85">
                  <c:v>108.33333333333334</c:v>
                </c:pt>
                <c:pt idx="86">
                  <c:v>109.03225806451613</c:v>
                </c:pt>
                <c:pt idx="87">
                  <c:v>109.92366412213744</c:v>
                </c:pt>
                <c:pt idx="88">
                  <c:v>110.58201058201055</c:v>
                </c:pt>
                <c:pt idx="89">
                  <c:v>113.66906474820142</c:v>
                </c:pt>
                <c:pt idx="90">
                  <c:v>114.38356164383561</c:v>
                </c:pt>
                <c:pt idx="91">
                  <c:v>114.61538461538461</c:v>
                </c:pt>
                <c:pt idx="92">
                  <c:v>115.67164179104479</c:v>
                </c:pt>
                <c:pt idx="93">
                  <c:v>115.86206896551721</c:v>
                </c:pt>
                <c:pt idx="94">
                  <c:v>118.04511278195488</c:v>
                </c:pt>
                <c:pt idx="95">
                  <c:v>122.222222222222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42592"/>
        <c:axId val="194943168"/>
      </c:scatterChart>
      <c:valAx>
        <c:axId val="19494259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 smtClean="0"/>
                  <a:t>Haploid</a:t>
                </a:r>
                <a:r>
                  <a:rPr lang="en-GB" baseline="0" dirty="0" smtClean="0"/>
                  <a:t> segregants</a:t>
                </a:r>
                <a:endParaRPr lang="en-GB" dirty="0"/>
              </a:p>
            </c:rich>
          </c:tx>
          <c:layout/>
          <c:overlay val="0"/>
        </c:title>
        <c:majorTickMark val="out"/>
        <c:minorTickMark val="none"/>
        <c:tickLblPos val="nextTo"/>
        <c:crossAx val="194943168"/>
        <c:crosses val="autoZero"/>
        <c:crossBetween val="midCat"/>
      </c:valAx>
      <c:valAx>
        <c:axId val="194943168"/>
        <c:scaling>
          <c:orientation val="minMax"/>
          <c:max val="140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dirty="0" smtClean="0"/>
                  <a:t>% redox signal intensity of control</a:t>
                </a:r>
                <a:endParaRPr lang="en-GB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9425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3517854859285183"/>
          <c:y val="0.77351892043448467"/>
          <c:w val="0.3004525705445506"/>
          <c:h val="5.9620397100666682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26933866604813"/>
          <c:y val="5.5914625255176438E-2"/>
          <c:w val="0.72403357604290408"/>
          <c:h val="0.82810549722951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Sheet1 (3)'!$D$1</c:f>
              <c:strCache>
                <c:ptCount val="1"/>
                <c:pt idx="0">
                  <c:v>Form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Sheet1 (3)'!$A$2:$A$97</c:f>
              <c:strCache>
                <c:ptCount val="96"/>
                <c:pt idx="0">
                  <c:v>DBVPG6044 x Y12</c:v>
                </c:pt>
                <c:pt idx="1">
                  <c:v>DBVPG6044 x Y12</c:v>
                </c:pt>
                <c:pt idx="2">
                  <c:v>DBVPG6044 x Y12</c:v>
                </c:pt>
                <c:pt idx="3">
                  <c:v>DBVPG6044 x Y12</c:v>
                </c:pt>
                <c:pt idx="4">
                  <c:v>DBVPG6044 x Y12</c:v>
                </c:pt>
                <c:pt idx="5">
                  <c:v>DBVPG6044 x Y12</c:v>
                </c:pt>
                <c:pt idx="6">
                  <c:v>DBVPG6044 x Y12</c:v>
                </c:pt>
                <c:pt idx="7">
                  <c:v>DBVPG6044 x Y12</c:v>
                </c:pt>
                <c:pt idx="8">
                  <c:v>DBVPG6044 x Y12</c:v>
                </c:pt>
                <c:pt idx="9">
                  <c:v>DBVPG6044 x Y12</c:v>
                </c:pt>
                <c:pt idx="10">
                  <c:v>DBVPG6044 x Y12</c:v>
                </c:pt>
                <c:pt idx="11">
                  <c:v>DBVPG6044 x Y12</c:v>
                </c:pt>
                <c:pt idx="12">
                  <c:v>DBVPG6044 x Y12</c:v>
                </c:pt>
                <c:pt idx="13">
                  <c:v>DBVPG6044 x Y12</c:v>
                </c:pt>
                <c:pt idx="14">
                  <c:v>DBVPG6044 x Y12</c:v>
                </c:pt>
                <c:pt idx="15">
                  <c:v>DBVPG6044 x Y12</c:v>
                </c:pt>
                <c:pt idx="16">
                  <c:v>DBVPG6044 x Y12</c:v>
                </c:pt>
                <c:pt idx="17">
                  <c:v>DBVPG6044 x Y12</c:v>
                </c:pt>
                <c:pt idx="18">
                  <c:v>DBVPG6044 x Y12</c:v>
                </c:pt>
                <c:pt idx="19">
                  <c:v>DBVPG6044 x Y12</c:v>
                </c:pt>
                <c:pt idx="20">
                  <c:v>DBVPG6044 x Y12</c:v>
                </c:pt>
                <c:pt idx="21">
                  <c:v>DBVPG6044 x Y12</c:v>
                </c:pt>
                <c:pt idx="22">
                  <c:v>DBVPG6044 x Y12</c:v>
                </c:pt>
                <c:pt idx="23">
                  <c:v>DBVPG6044 x Y12</c:v>
                </c:pt>
                <c:pt idx="24">
                  <c:v>DBVPG6044 x Y12</c:v>
                </c:pt>
                <c:pt idx="25">
                  <c:v>DBVPG6044 x Y12</c:v>
                </c:pt>
                <c:pt idx="26">
                  <c:v>DBVPG6044 x Y12</c:v>
                </c:pt>
                <c:pt idx="27">
                  <c:v>DBVPG6044 x Y12</c:v>
                </c:pt>
                <c:pt idx="28">
                  <c:v>DBVPG6044 x Y12</c:v>
                </c:pt>
                <c:pt idx="29">
                  <c:v>DBVPG6044 x Y12</c:v>
                </c:pt>
                <c:pt idx="30">
                  <c:v>DBVPG6044 x Y12</c:v>
                </c:pt>
                <c:pt idx="31">
                  <c:v>DBVPG6044 x Y12</c:v>
                </c:pt>
                <c:pt idx="32">
                  <c:v>DBVPG6044 x Y12</c:v>
                </c:pt>
                <c:pt idx="33">
                  <c:v>DBVPG6044 x Y12</c:v>
                </c:pt>
                <c:pt idx="34">
                  <c:v>DBVPG6044 x Y12</c:v>
                </c:pt>
                <c:pt idx="35">
                  <c:v>DBVPG6044 x Y12</c:v>
                </c:pt>
                <c:pt idx="36">
                  <c:v>DBVPG6044 x Y12</c:v>
                </c:pt>
                <c:pt idx="37">
                  <c:v>DBVPG6044 x Y12</c:v>
                </c:pt>
                <c:pt idx="38">
                  <c:v>DBVPG6044 x Y12</c:v>
                </c:pt>
                <c:pt idx="39">
                  <c:v>DBVPG6044 x Y12</c:v>
                </c:pt>
                <c:pt idx="40">
                  <c:v>DBVPG6044 x Y12</c:v>
                </c:pt>
                <c:pt idx="41">
                  <c:v>DBVPG6044 x Y12</c:v>
                </c:pt>
                <c:pt idx="42">
                  <c:v>DBVPG6044 x Y12</c:v>
                </c:pt>
                <c:pt idx="43">
                  <c:v>DBVPG6044 x Y12</c:v>
                </c:pt>
                <c:pt idx="44">
                  <c:v>DBVPG6044 x Y12</c:v>
                </c:pt>
                <c:pt idx="45">
                  <c:v>DBVPG6044 x Y12</c:v>
                </c:pt>
                <c:pt idx="46">
                  <c:v>DBVPG6044 x Y12</c:v>
                </c:pt>
                <c:pt idx="47">
                  <c:v>DBVPG6044 x Y12</c:v>
                </c:pt>
                <c:pt idx="48">
                  <c:v>DBVPG6044 x Y12</c:v>
                </c:pt>
                <c:pt idx="49">
                  <c:v>DBVPG6044 x Y12</c:v>
                </c:pt>
                <c:pt idx="50">
                  <c:v>DBVPG6044 x Y12</c:v>
                </c:pt>
                <c:pt idx="51">
                  <c:v>DBVPG6044 x Y12</c:v>
                </c:pt>
                <c:pt idx="52">
                  <c:v>DBVPG6044 x Y12</c:v>
                </c:pt>
                <c:pt idx="53">
                  <c:v>DBVPG6044 x Y12</c:v>
                </c:pt>
                <c:pt idx="54">
                  <c:v>DBVPG6044 x Y12</c:v>
                </c:pt>
                <c:pt idx="55">
                  <c:v>DBVPG6044 x Y12</c:v>
                </c:pt>
                <c:pt idx="56">
                  <c:v>DBVPG6044 x Y12</c:v>
                </c:pt>
                <c:pt idx="57">
                  <c:v>DBVPG6044 x Y12</c:v>
                </c:pt>
                <c:pt idx="58">
                  <c:v>DBVPG6044 x Y12</c:v>
                </c:pt>
                <c:pt idx="59">
                  <c:v>DBVPG6044 x Y12</c:v>
                </c:pt>
                <c:pt idx="60">
                  <c:v>DBVPG6044 x Y12</c:v>
                </c:pt>
                <c:pt idx="61">
                  <c:v>DBVPG6044 x Y12</c:v>
                </c:pt>
                <c:pt idx="62">
                  <c:v>DBVPG6044 x Y12</c:v>
                </c:pt>
                <c:pt idx="63">
                  <c:v>DBVPG6044 x Y12</c:v>
                </c:pt>
                <c:pt idx="64">
                  <c:v>DBVPG6044 x Y12</c:v>
                </c:pt>
                <c:pt idx="65">
                  <c:v>DBVPG6044 x Y12</c:v>
                </c:pt>
                <c:pt idx="66">
                  <c:v>DBVPG6044 x Y12</c:v>
                </c:pt>
                <c:pt idx="67">
                  <c:v>DBVPG6044 x Y12</c:v>
                </c:pt>
                <c:pt idx="68">
                  <c:v>DBVPG6044 x Y12</c:v>
                </c:pt>
                <c:pt idx="69">
                  <c:v>DBVPG6044 x Y12</c:v>
                </c:pt>
                <c:pt idx="70">
                  <c:v>DBVPG6044 x Y12</c:v>
                </c:pt>
                <c:pt idx="71">
                  <c:v>DBVPG6044 x Y12</c:v>
                </c:pt>
                <c:pt idx="72">
                  <c:v>DBVPG6044 x Y12</c:v>
                </c:pt>
                <c:pt idx="73">
                  <c:v>DBVPG6044 x Y12</c:v>
                </c:pt>
                <c:pt idx="74">
                  <c:v>DBVPG6044 x Y12</c:v>
                </c:pt>
                <c:pt idx="75">
                  <c:v>DBVPG6044 x Y12</c:v>
                </c:pt>
                <c:pt idx="76">
                  <c:v>DBVPG6044 x Y12</c:v>
                </c:pt>
                <c:pt idx="77">
                  <c:v>DBVPG6044 x Y12</c:v>
                </c:pt>
                <c:pt idx="78">
                  <c:v>DBVPG6044 x Y12</c:v>
                </c:pt>
                <c:pt idx="79">
                  <c:v>DBVPG6044 x Y12</c:v>
                </c:pt>
                <c:pt idx="80">
                  <c:v>DBVPG6044 x Y12</c:v>
                </c:pt>
                <c:pt idx="81">
                  <c:v>DBVPG6044 x Y12</c:v>
                </c:pt>
                <c:pt idx="82">
                  <c:v>DBVPG6044 x Y12</c:v>
                </c:pt>
                <c:pt idx="83">
                  <c:v>DBVPG6044 x Y12</c:v>
                </c:pt>
                <c:pt idx="84">
                  <c:v>DBVPG6044 x Y12</c:v>
                </c:pt>
                <c:pt idx="85">
                  <c:v>DBVPG6044 x Y12</c:v>
                </c:pt>
                <c:pt idx="86">
                  <c:v>DBVPG6044 x Y12</c:v>
                </c:pt>
                <c:pt idx="87">
                  <c:v>DBVPG6044 x Y12</c:v>
                </c:pt>
                <c:pt idx="88">
                  <c:v>DBVPG6044 x Y12</c:v>
                </c:pt>
                <c:pt idx="89">
                  <c:v>DBVPG6044 x Y12</c:v>
                </c:pt>
                <c:pt idx="90">
                  <c:v>DBVPG6044 x Y12</c:v>
                </c:pt>
                <c:pt idx="91">
                  <c:v>DBVPG6044 x Y12</c:v>
                </c:pt>
                <c:pt idx="92">
                  <c:v>DBVPG6044 x Y12</c:v>
                </c:pt>
                <c:pt idx="93">
                  <c:v>DBVPG6044 x Y12</c:v>
                </c:pt>
                <c:pt idx="94">
                  <c:v>DBVPG6044 x Y12</c:v>
                </c:pt>
                <c:pt idx="95">
                  <c:v>DBVPG6044 x Y12</c:v>
                </c:pt>
              </c:strCache>
            </c:strRef>
          </c:xVal>
          <c:yVal>
            <c:numRef>
              <c:f>'Sheet1 (3)'!$D$2:$D$97</c:f>
              <c:numCache>
                <c:formatCode>General</c:formatCode>
                <c:ptCount val="96"/>
                <c:pt idx="0">
                  <c:v>71.428571428571431</c:v>
                </c:pt>
                <c:pt idx="1">
                  <c:v>77.241379310344826</c:v>
                </c:pt>
                <c:pt idx="2">
                  <c:v>77.777777777777786</c:v>
                </c:pt>
                <c:pt idx="3">
                  <c:v>78.709677419354833</c:v>
                </c:pt>
                <c:pt idx="4">
                  <c:v>80.147058823529392</c:v>
                </c:pt>
                <c:pt idx="5">
                  <c:v>81.679389312977108</c:v>
                </c:pt>
                <c:pt idx="6">
                  <c:v>82.222222222222229</c:v>
                </c:pt>
                <c:pt idx="7">
                  <c:v>84.049079754601223</c:v>
                </c:pt>
                <c:pt idx="8">
                  <c:v>84.285714285714292</c:v>
                </c:pt>
                <c:pt idx="9">
                  <c:v>84.459459459459467</c:v>
                </c:pt>
                <c:pt idx="10">
                  <c:v>84.795321637426895</c:v>
                </c:pt>
                <c:pt idx="11">
                  <c:v>86.507936507936535</c:v>
                </c:pt>
                <c:pt idx="12">
                  <c:v>86.619718309859167</c:v>
                </c:pt>
                <c:pt idx="13">
                  <c:v>86.666666666666643</c:v>
                </c:pt>
                <c:pt idx="14">
                  <c:v>87.5</c:v>
                </c:pt>
                <c:pt idx="15">
                  <c:v>87.804878048780481</c:v>
                </c:pt>
                <c:pt idx="16">
                  <c:v>88.617886178861781</c:v>
                </c:pt>
                <c:pt idx="17">
                  <c:v>88.811188811188813</c:v>
                </c:pt>
                <c:pt idx="18">
                  <c:v>88.888888888888857</c:v>
                </c:pt>
                <c:pt idx="19">
                  <c:v>88.961038961038966</c:v>
                </c:pt>
                <c:pt idx="20">
                  <c:v>88.965517241379317</c:v>
                </c:pt>
                <c:pt idx="21">
                  <c:v>88.970588235294102</c:v>
                </c:pt>
                <c:pt idx="22">
                  <c:v>88.983050847457605</c:v>
                </c:pt>
                <c:pt idx="23">
                  <c:v>89.230769230769241</c:v>
                </c:pt>
                <c:pt idx="24">
                  <c:v>89.285714285714292</c:v>
                </c:pt>
                <c:pt idx="25">
                  <c:v>89.754098360655718</c:v>
                </c:pt>
                <c:pt idx="26">
                  <c:v>90.51724137931032</c:v>
                </c:pt>
                <c:pt idx="27">
                  <c:v>90.552995391705082</c:v>
                </c:pt>
                <c:pt idx="28">
                  <c:v>90.789473684210535</c:v>
                </c:pt>
                <c:pt idx="29">
                  <c:v>90.84507042253523</c:v>
                </c:pt>
                <c:pt idx="30">
                  <c:v>91.034482758620683</c:v>
                </c:pt>
                <c:pt idx="31">
                  <c:v>91.071428571428569</c:v>
                </c:pt>
                <c:pt idx="32">
                  <c:v>91.111111111111143</c:v>
                </c:pt>
                <c:pt idx="33">
                  <c:v>91.406249999999972</c:v>
                </c:pt>
                <c:pt idx="34">
                  <c:v>91.428571428571416</c:v>
                </c:pt>
                <c:pt idx="35">
                  <c:v>91.463414634146346</c:v>
                </c:pt>
                <c:pt idx="36">
                  <c:v>91.724137931034463</c:v>
                </c:pt>
                <c:pt idx="37">
                  <c:v>91.970802919708021</c:v>
                </c:pt>
                <c:pt idx="38">
                  <c:v>92.253521126760575</c:v>
                </c:pt>
                <c:pt idx="39">
                  <c:v>92.493297587131366</c:v>
                </c:pt>
                <c:pt idx="40">
                  <c:v>92.647058823529406</c:v>
                </c:pt>
                <c:pt idx="41">
                  <c:v>92.857142857142833</c:v>
                </c:pt>
                <c:pt idx="42">
                  <c:v>93.233082706766908</c:v>
                </c:pt>
                <c:pt idx="43">
                  <c:v>93.28358208955224</c:v>
                </c:pt>
                <c:pt idx="44">
                  <c:v>93.319415448851771</c:v>
                </c:pt>
                <c:pt idx="45">
                  <c:v>93.749999999999972</c:v>
                </c:pt>
                <c:pt idx="46">
                  <c:v>94.531250000000014</c:v>
                </c:pt>
                <c:pt idx="47">
                  <c:v>94.700460829493082</c:v>
                </c:pt>
                <c:pt idx="48">
                  <c:v>94.736842105263165</c:v>
                </c:pt>
                <c:pt idx="49">
                  <c:v>95</c:v>
                </c:pt>
                <c:pt idx="50">
                  <c:v>95.39473684210526</c:v>
                </c:pt>
                <c:pt idx="51">
                  <c:v>96.153846153846146</c:v>
                </c:pt>
                <c:pt idx="52">
                  <c:v>96.323529411764696</c:v>
                </c:pt>
                <c:pt idx="53">
                  <c:v>96.341463414634134</c:v>
                </c:pt>
                <c:pt idx="54">
                  <c:v>96.363636363636346</c:v>
                </c:pt>
                <c:pt idx="55">
                  <c:v>96.551724137931032</c:v>
                </c:pt>
                <c:pt idx="56">
                  <c:v>96.774193548387089</c:v>
                </c:pt>
                <c:pt idx="57">
                  <c:v>97.142857142857153</c:v>
                </c:pt>
                <c:pt idx="58">
                  <c:v>97.345132743362811</c:v>
                </c:pt>
                <c:pt idx="59">
                  <c:v>98.496240601503743</c:v>
                </c:pt>
                <c:pt idx="60">
                  <c:v>98.757763975155299</c:v>
                </c:pt>
                <c:pt idx="61">
                  <c:v>100</c:v>
                </c:pt>
                <c:pt idx="62">
                  <c:v>100</c:v>
                </c:pt>
                <c:pt idx="63">
                  <c:v>100.2</c:v>
                </c:pt>
                <c:pt idx="64">
                  <c:v>100.75757575757575</c:v>
                </c:pt>
                <c:pt idx="65">
                  <c:v>101.42857142857144</c:v>
                </c:pt>
                <c:pt idx="66">
                  <c:v>101.44927536231883</c:v>
                </c:pt>
                <c:pt idx="67">
                  <c:v>102.06896551724134</c:v>
                </c:pt>
                <c:pt idx="68">
                  <c:v>102.34375</c:v>
                </c:pt>
                <c:pt idx="69">
                  <c:v>102.42424242424242</c:v>
                </c:pt>
                <c:pt idx="70">
                  <c:v>102.87769784172663</c:v>
                </c:pt>
                <c:pt idx="71">
                  <c:v>103.19999999999997</c:v>
                </c:pt>
                <c:pt idx="72">
                  <c:v>103.31125827814571</c:v>
                </c:pt>
                <c:pt idx="73">
                  <c:v>103.59712230215827</c:v>
                </c:pt>
                <c:pt idx="74">
                  <c:v>103.70370370370372</c:v>
                </c:pt>
                <c:pt idx="75">
                  <c:v>104.54545454545459</c:v>
                </c:pt>
                <c:pt idx="76">
                  <c:v>104.99999999999999</c:v>
                </c:pt>
                <c:pt idx="77">
                  <c:v>105.22388059701491</c:v>
                </c:pt>
                <c:pt idx="78">
                  <c:v>105.46318289786223</c:v>
                </c:pt>
                <c:pt idx="79">
                  <c:v>105.76923076923075</c:v>
                </c:pt>
                <c:pt idx="80">
                  <c:v>105.98290598290596</c:v>
                </c:pt>
                <c:pt idx="81">
                  <c:v>106.12244897959182</c:v>
                </c:pt>
                <c:pt idx="82">
                  <c:v>106.15384615384616</c:v>
                </c:pt>
                <c:pt idx="83">
                  <c:v>106.70731707317074</c:v>
                </c:pt>
                <c:pt idx="84">
                  <c:v>106.97674418604647</c:v>
                </c:pt>
                <c:pt idx="85">
                  <c:v>108.06451612903226</c:v>
                </c:pt>
                <c:pt idx="86">
                  <c:v>108.46560846560844</c:v>
                </c:pt>
                <c:pt idx="87">
                  <c:v>110.96774193548387</c:v>
                </c:pt>
                <c:pt idx="88">
                  <c:v>111.45038167938932</c:v>
                </c:pt>
                <c:pt idx="89">
                  <c:v>111.53846153846152</c:v>
                </c:pt>
                <c:pt idx="90">
                  <c:v>113.82113821138216</c:v>
                </c:pt>
                <c:pt idx="91">
                  <c:v>113.86861313868613</c:v>
                </c:pt>
                <c:pt idx="92">
                  <c:v>115.78947368421053</c:v>
                </c:pt>
                <c:pt idx="93">
                  <c:v>119.04761904761902</c:v>
                </c:pt>
                <c:pt idx="94">
                  <c:v>128.12500000000003</c:v>
                </c:pt>
                <c:pt idx="95">
                  <c:v>128.767123287671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61408"/>
        <c:axId val="194961984"/>
      </c:scatterChart>
      <c:valAx>
        <c:axId val="19496140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 smtClean="0"/>
                  <a:t>Haploid segregants</a:t>
                </a:r>
                <a:endParaRPr lang="en-GB" dirty="0"/>
              </a:p>
            </c:rich>
          </c:tx>
          <c:layout/>
          <c:overlay val="0"/>
        </c:title>
        <c:majorTickMark val="out"/>
        <c:minorTickMark val="none"/>
        <c:tickLblPos val="nextTo"/>
        <c:crossAx val="194961984"/>
        <c:crosses val="autoZero"/>
        <c:crossBetween val="midCat"/>
        <c:majorUnit val="50"/>
      </c:valAx>
      <c:valAx>
        <c:axId val="194961984"/>
        <c:scaling>
          <c:orientation val="minMax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dirty="0" smtClean="0"/>
                  <a:t>% Redox signal intensity of control</a:t>
                </a:r>
                <a:endParaRPr lang="en-GB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96140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2367996693177887"/>
          <c:y val="0.77351892043448467"/>
          <c:w val="0.40925027938072245"/>
          <c:h val="5.9620397100666682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58792650918635"/>
          <c:y val="8.0081816013788665E-2"/>
          <c:w val="0.70782895888014008"/>
          <c:h val="0.73444800161879542"/>
        </c:manualLayout>
      </c:layout>
      <c:scatterChart>
        <c:scatterStyle val="lineMarker"/>
        <c:varyColors val="0"/>
        <c:ser>
          <c:idx val="0"/>
          <c:order val="0"/>
          <c:tx>
            <c:strRef>
              <c:f>Furfural!$E$1</c:f>
              <c:strCache>
                <c:ptCount val="1"/>
                <c:pt idx="0">
                  <c:v>Furfura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Furfural!$B$2:$B$97</c:f>
              <c:strCache>
                <c:ptCount val="96"/>
                <c:pt idx="0">
                  <c:v>D12</c:v>
                </c:pt>
                <c:pt idx="1">
                  <c:v>B6</c:v>
                </c:pt>
                <c:pt idx="2">
                  <c:v>D1</c:v>
                </c:pt>
                <c:pt idx="3">
                  <c:v>F6</c:v>
                </c:pt>
                <c:pt idx="4">
                  <c:v>E9</c:v>
                </c:pt>
                <c:pt idx="5">
                  <c:v>H3</c:v>
                </c:pt>
                <c:pt idx="6">
                  <c:v>D6</c:v>
                </c:pt>
                <c:pt idx="7">
                  <c:v>D8</c:v>
                </c:pt>
                <c:pt idx="8">
                  <c:v>E7</c:v>
                </c:pt>
                <c:pt idx="9">
                  <c:v>D4</c:v>
                </c:pt>
                <c:pt idx="10">
                  <c:v>H12</c:v>
                </c:pt>
                <c:pt idx="11">
                  <c:v>E6</c:v>
                </c:pt>
                <c:pt idx="12">
                  <c:v>G6</c:v>
                </c:pt>
                <c:pt idx="13">
                  <c:v>E1</c:v>
                </c:pt>
                <c:pt idx="14">
                  <c:v>H4</c:v>
                </c:pt>
                <c:pt idx="15">
                  <c:v>D9</c:v>
                </c:pt>
                <c:pt idx="16">
                  <c:v>D11</c:v>
                </c:pt>
                <c:pt idx="17">
                  <c:v>C1</c:v>
                </c:pt>
                <c:pt idx="18">
                  <c:v>C4</c:v>
                </c:pt>
                <c:pt idx="19">
                  <c:v>H8</c:v>
                </c:pt>
                <c:pt idx="20">
                  <c:v>H6</c:v>
                </c:pt>
                <c:pt idx="21">
                  <c:v>H2</c:v>
                </c:pt>
                <c:pt idx="22">
                  <c:v>D10</c:v>
                </c:pt>
                <c:pt idx="23">
                  <c:v>C3</c:v>
                </c:pt>
                <c:pt idx="24">
                  <c:v>E12</c:v>
                </c:pt>
                <c:pt idx="25">
                  <c:v>E10</c:v>
                </c:pt>
                <c:pt idx="26">
                  <c:v>G4</c:v>
                </c:pt>
                <c:pt idx="27">
                  <c:v>H5</c:v>
                </c:pt>
                <c:pt idx="28">
                  <c:v>E11</c:v>
                </c:pt>
                <c:pt idx="29">
                  <c:v>H10</c:v>
                </c:pt>
                <c:pt idx="30">
                  <c:v>C11</c:v>
                </c:pt>
                <c:pt idx="31">
                  <c:v>D7</c:v>
                </c:pt>
                <c:pt idx="32">
                  <c:v>C8</c:v>
                </c:pt>
                <c:pt idx="33">
                  <c:v>F8</c:v>
                </c:pt>
                <c:pt idx="34">
                  <c:v>C9</c:v>
                </c:pt>
                <c:pt idx="35">
                  <c:v>C6</c:v>
                </c:pt>
                <c:pt idx="36">
                  <c:v>B4</c:v>
                </c:pt>
                <c:pt idx="37">
                  <c:v>F4</c:v>
                </c:pt>
                <c:pt idx="38">
                  <c:v>C5</c:v>
                </c:pt>
                <c:pt idx="39">
                  <c:v>H7</c:v>
                </c:pt>
                <c:pt idx="40">
                  <c:v>E4</c:v>
                </c:pt>
                <c:pt idx="41">
                  <c:v>C10</c:v>
                </c:pt>
                <c:pt idx="42">
                  <c:v>B5</c:v>
                </c:pt>
                <c:pt idx="43">
                  <c:v>B7</c:v>
                </c:pt>
                <c:pt idx="44">
                  <c:v>F9</c:v>
                </c:pt>
                <c:pt idx="45">
                  <c:v>F12</c:v>
                </c:pt>
                <c:pt idx="46">
                  <c:v>C12</c:v>
                </c:pt>
                <c:pt idx="47">
                  <c:v>B3</c:v>
                </c:pt>
                <c:pt idx="48">
                  <c:v>H9</c:v>
                </c:pt>
                <c:pt idx="49">
                  <c:v>F7</c:v>
                </c:pt>
                <c:pt idx="50">
                  <c:v>B11</c:v>
                </c:pt>
                <c:pt idx="51">
                  <c:v>B1</c:v>
                </c:pt>
                <c:pt idx="52">
                  <c:v>B8</c:v>
                </c:pt>
                <c:pt idx="53">
                  <c:v>F10</c:v>
                </c:pt>
                <c:pt idx="54">
                  <c:v>B12</c:v>
                </c:pt>
                <c:pt idx="55">
                  <c:v>F3</c:v>
                </c:pt>
                <c:pt idx="56">
                  <c:v>G8</c:v>
                </c:pt>
                <c:pt idx="57">
                  <c:v>B9</c:v>
                </c:pt>
                <c:pt idx="58">
                  <c:v>G5</c:v>
                </c:pt>
                <c:pt idx="59">
                  <c:v>F2</c:v>
                </c:pt>
                <c:pt idx="60">
                  <c:v>F5</c:v>
                </c:pt>
                <c:pt idx="61">
                  <c:v>E5</c:v>
                </c:pt>
                <c:pt idx="62">
                  <c:v>G10</c:v>
                </c:pt>
                <c:pt idx="63">
                  <c:v>G2</c:v>
                </c:pt>
                <c:pt idx="64">
                  <c:v>G7</c:v>
                </c:pt>
                <c:pt idx="65">
                  <c:v>E3</c:v>
                </c:pt>
                <c:pt idx="66">
                  <c:v>C7</c:v>
                </c:pt>
                <c:pt idx="67">
                  <c:v>H1</c:v>
                </c:pt>
                <c:pt idx="68">
                  <c:v>D5</c:v>
                </c:pt>
                <c:pt idx="69">
                  <c:v>G1</c:v>
                </c:pt>
                <c:pt idx="70">
                  <c:v>H11</c:v>
                </c:pt>
                <c:pt idx="71">
                  <c:v>A8</c:v>
                </c:pt>
                <c:pt idx="72">
                  <c:v>B2</c:v>
                </c:pt>
                <c:pt idx="73">
                  <c:v>B10</c:v>
                </c:pt>
                <c:pt idx="74">
                  <c:v>G3</c:v>
                </c:pt>
                <c:pt idx="75">
                  <c:v>E8</c:v>
                </c:pt>
                <c:pt idx="76">
                  <c:v>G11</c:v>
                </c:pt>
                <c:pt idx="77">
                  <c:v>D3</c:v>
                </c:pt>
                <c:pt idx="78">
                  <c:v>G12</c:v>
                </c:pt>
                <c:pt idx="79">
                  <c:v>E2</c:v>
                </c:pt>
                <c:pt idx="80">
                  <c:v>D2</c:v>
                </c:pt>
                <c:pt idx="81">
                  <c:v>F1</c:v>
                </c:pt>
                <c:pt idx="82">
                  <c:v>A1</c:v>
                </c:pt>
                <c:pt idx="83">
                  <c:v>A5</c:v>
                </c:pt>
                <c:pt idx="84">
                  <c:v>C2</c:v>
                </c:pt>
                <c:pt idx="85">
                  <c:v>A7</c:v>
                </c:pt>
                <c:pt idx="86">
                  <c:v>A3</c:v>
                </c:pt>
                <c:pt idx="87">
                  <c:v>A12</c:v>
                </c:pt>
                <c:pt idx="88">
                  <c:v>A6</c:v>
                </c:pt>
                <c:pt idx="89">
                  <c:v>F11</c:v>
                </c:pt>
                <c:pt idx="90">
                  <c:v>G9</c:v>
                </c:pt>
                <c:pt idx="91">
                  <c:v>A10</c:v>
                </c:pt>
                <c:pt idx="92">
                  <c:v>A11</c:v>
                </c:pt>
                <c:pt idx="93">
                  <c:v>A2</c:v>
                </c:pt>
                <c:pt idx="94">
                  <c:v>A9</c:v>
                </c:pt>
                <c:pt idx="95">
                  <c:v>A4</c:v>
                </c:pt>
              </c:strCache>
            </c:strRef>
          </c:xVal>
          <c:yVal>
            <c:numRef>
              <c:f>Furfural!$E$2:$E$97</c:f>
              <c:numCache>
                <c:formatCode>General</c:formatCode>
                <c:ptCount val="96"/>
                <c:pt idx="0">
                  <c:v>60.655737704918032</c:v>
                </c:pt>
                <c:pt idx="1">
                  <c:v>67.619047619047635</c:v>
                </c:pt>
                <c:pt idx="2">
                  <c:v>67.64705882352942</c:v>
                </c:pt>
                <c:pt idx="3">
                  <c:v>70.408163265306086</c:v>
                </c:pt>
                <c:pt idx="4">
                  <c:v>70.873786407766971</c:v>
                </c:pt>
                <c:pt idx="5">
                  <c:v>71.428571428571416</c:v>
                </c:pt>
                <c:pt idx="6">
                  <c:v>71.874999999999986</c:v>
                </c:pt>
                <c:pt idx="7">
                  <c:v>72.727272727272734</c:v>
                </c:pt>
                <c:pt idx="8">
                  <c:v>73.275862068965509</c:v>
                </c:pt>
                <c:pt idx="9">
                  <c:v>73.584905660377331</c:v>
                </c:pt>
                <c:pt idx="10">
                  <c:v>74.774774774774784</c:v>
                </c:pt>
                <c:pt idx="11">
                  <c:v>74.999999999999972</c:v>
                </c:pt>
                <c:pt idx="12">
                  <c:v>75.247524752475243</c:v>
                </c:pt>
                <c:pt idx="13">
                  <c:v>75.925925925925952</c:v>
                </c:pt>
                <c:pt idx="14">
                  <c:v>76.000000000000028</c:v>
                </c:pt>
                <c:pt idx="15">
                  <c:v>76.288659793814418</c:v>
                </c:pt>
                <c:pt idx="16">
                  <c:v>76.521739130434781</c:v>
                </c:pt>
                <c:pt idx="17">
                  <c:v>76.530612244897966</c:v>
                </c:pt>
                <c:pt idx="18">
                  <c:v>76.595744680851055</c:v>
                </c:pt>
                <c:pt idx="19">
                  <c:v>76.6666666666667</c:v>
                </c:pt>
                <c:pt idx="20">
                  <c:v>76.785714285714278</c:v>
                </c:pt>
                <c:pt idx="21">
                  <c:v>76.785714285714306</c:v>
                </c:pt>
                <c:pt idx="22">
                  <c:v>77.192982456140356</c:v>
                </c:pt>
                <c:pt idx="23">
                  <c:v>77.27272727272728</c:v>
                </c:pt>
                <c:pt idx="24">
                  <c:v>77.31092436974788</c:v>
                </c:pt>
                <c:pt idx="25">
                  <c:v>77.570093457943926</c:v>
                </c:pt>
                <c:pt idx="26">
                  <c:v>77.678571428571445</c:v>
                </c:pt>
                <c:pt idx="27">
                  <c:v>77.685950413223139</c:v>
                </c:pt>
                <c:pt idx="28">
                  <c:v>77.981651376146786</c:v>
                </c:pt>
                <c:pt idx="29">
                  <c:v>78.217821782178234</c:v>
                </c:pt>
                <c:pt idx="30">
                  <c:v>79.310344827586192</c:v>
                </c:pt>
                <c:pt idx="31">
                  <c:v>79.646017699115063</c:v>
                </c:pt>
                <c:pt idx="32">
                  <c:v>79.807692307692321</c:v>
                </c:pt>
                <c:pt idx="33">
                  <c:v>79.824561403508767</c:v>
                </c:pt>
                <c:pt idx="34">
                  <c:v>79.999999999999957</c:v>
                </c:pt>
                <c:pt idx="35">
                  <c:v>79.999999999999986</c:v>
                </c:pt>
                <c:pt idx="36">
                  <c:v>80</c:v>
                </c:pt>
                <c:pt idx="37">
                  <c:v>80.412371134020631</c:v>
                </c:pt>
                <c:pt idx="38">
                  <c:v>80.434782608695627</c:v>
                </c:pt>
                <c:pt idx="39">
                  <c:v>80.833333333333329</c:v>
                </c:pt>
                <c:pt idx="40">
                  <c:v>81.18811881188121</c:v>
                </c:pt>
                <c:pt idx="41">
                  <c:v>81.196581196581207</c:v>
                </c:pt>
                <c:pt idx="42">
                  <c:v>81.343283582089541</c:v>
                </c:pt>
                <c:pt idx="43">
                  <c:v>81.538461538461533</c:v>
                </c:pt>
                <c:pt idx="44">
                  <c:v>81.553398058252398</c:v>
                </c:pt>
                <c:pt idx="45">
                  <c:v>81.666666666666643</c:v>
                </c:pt>
                <c:pt idx="46">
                  <c:v>81.730769230769212</c:v>
                </c:pt>
                <c:pt idx="47">
                  <c:v>81.818181818181813</c:v>
                </c:pt>
                <c:pt idx="48">
                  <c:v>82.242990654205613</c:v>
                </c:pt>
                <c:pt idx="49">
                  <c:v>82.456140350877192</c:v>
                </c:pt>
                <c:pt idx="50">
                  <c:v>82.677165354330683</c:v>
                </c:pt>
                <c:pt idx="51">
                  <c:v>82.786885245901658</c:v>
                </c:pt>
                <c:pt idx="52">
                  <c:v>83.177570093457945</c:v>
                </c:pt>
                <c:pt idx="53">
                  <c:v>83.199999999999989</c:v>
                </c:pt>
                <c:pt idx="54">
                  <c:v>83.739837398374007</c:v>
                </c:pt>
                <c:pt idx="55">
                  <c:v>83.999999999999986</c:v>
                </c:pt>
                <c:pt idx="56">
                  <c:v>85.074626865671647</c:v>
                </c:pt>
                <c:pt idx="57">
                  <c:v>85.294117647058826</c:v>
                </c:pt>
                <c:pt idx="58">
                  <c:v>85.82677165354329</c:v>
                </c:pt>
                <c:pt idx="59">
                  <c:v>85.858585858585826</c:v>
                </c:pt>
                <c:pt idx="60">
                  <c:v>85.950413223140501</c:v>
                </c:pt>
                <c:pt idx="61">
                  <c:v>86.065573770491781</c:v>
                </c:pt>
                <c:pt idx="62">
                  <c:v>86.274509803921589</c:v>
                </c:pt>
                <c:pt idx="63">
                  <c:v>86.48648648648647</c:v>
                </c:pt>
                <c:pt idx="64">
                  <c:v>86.885245901639337</c:v>
                </c:pt>
                <c:pt idx="65">
                  <c:v>87.288135593220346</c:v>
                </c:pt>
                <c:pt idx="66">
                  <c:v>87.850467289719631</c:v>
                </c:pt>
                <c:pt idx="67">
                  <c:v>88.764044943820238</c:v>
                </c:pt>
                <c:pt idx="68">
                  <c:v>88.799999999999969</c:v>
                </c:pt>
                <c:pt idx="69">
                  <c:v>89.583333333333343</c:v>
                </c:pt>
                <c:pt idx="70">
                  <c:v>89.62264150943399</c:v>
                </c:pt>
                <c:pt idx="71">
                  <c:v>89.821882951653919</c:v>
                </c:pt>
                <c:pt idx="72">
                  <c:v>90.109890109890117</c:v>
                </c:pt>
                <c:pt idx="73">
                  <c:v>90.434782608695656</c:v>
                </c:pt>
                <c:pt idx="74">
                  <c:v>90.441176470588246</c:v>
                </c:pt>
                <c:pt idx="75">
                  <c:v>91.596638655462158</c:v>
                </c:pt>
                <c:pt idx="76">
                  <c:v>91.666666666666657</c:v>
                </c:pt>
                <c:pt idx="77">
                  <c:v>92.380952380952351</c:v>
                </c:pt>
                <c:pt idx="78">
                  <c:v>92.436974789915965</c:v>
                </c:pt>
                <c:pt idx="79">
                  <c:v>93.40659340659343</c:v>
                </c:pt>
                <c:pt idx="80">
                  <c:v>93.548387096774221</c:v>
                </c:pt>
                <c:pt idx="81">
                  <c:v>94.949494949494948</c:v>
                </c:pt>
                <c:pt idx="82">
                  <c:v>95.392953929539331</c:v>
                </c:pt>
                <c:pt idx="83">
                  <c:v>97.601918465227754</c:v>
                </c:pt>
                <c:pt idx="84">
                  <c:v>97.674418604651152</c:v>
                </c:pt>
                <c:pt idx="85">
                  <c:v>98.076923076923052</c:v>
                </c:pt>
                <c:pt idx="86">
                  <c:v>99.026763990267639</c:v>
                </c:pt>
                <c:pt idx="87">
                  <c:v>100.22988505747124</c:v>
                </c:pt>
                <c:pt idx="88">
                  <c:v>102.59740259740259</c:v>
                </c:pt>
                <c:pt idx="89">
                  <c:v>102.72727272727276</c:v>
                </c:pt>
                <c:pt idx="90">
                  <c:v>106.18556701030928</c:v>
                </c:pt>
                <c:pt idx="91">
                  <c:v>106.33608815426999</c:v>
                </c:pt>
                <c:pt idx="92">
                  <c:v>108.98876404494379</c:v>
                </c:pt>
                <c:pt idx="93">
                  <c:v>116.50485436893206</c:v>
                </c:pt>
                <c:pt idx="94">
                  <c:v>118.15181518151812</c:v>
                </c:pt>
                <c:pt idx="95">
                  <c:v>118.7250996015935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63712"/>
        <c:axId val="194964288"/>
      </c:scatterChart>
      <c:valAx>
        <c:axId val="19496371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964288"/>
        <c:crosses val="autoZero"/>
        <c:crossBetween val="midCat"/>
        <c:majorUnit val="50"/>
      </c:valAx>
      <c:valAx>
        <c:axId val="194964288"/>
        <c:scaling>
          <c:orientation val="minMax"/>
          <c:max val="120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 of control</a:t>
                </a:r>
              </a:p>
            </c:rich>
          </c:tx>
          <c:layout>
            <c:manualLayout>
              <c:xMode val="edge"/>
              <c:yMode val="edge"/>
              <c:x val="1.6666666666666666E-2"/>
              <c:y val="0.230511447195834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94963712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59263998250218719"/>
          <c:y val="0.69782072383278715"/>
          <c:w val="0.30887445319335083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50402992620888"/>
          <c:y val="7.7186773933331093E-2"/>
          <c:w val="0.70312422549081155"/>
          <c:h val="0.70866189988551997"/>
        </c:manualLayout>
      </c:layout>
      <c:scatterChart>
        <c:scatterStyle val="lineMarker"/>
        <c:varyColors val="0"/>
        <c:ser>
          <c:idx val="0"/>
          <c:order val="0"/>
          <c:tx>
            <c:strRef>
              <c:f>HMF!$F$1</c:f>
              <c:strCache>
                <c:ptCount val="1"/>
                <c:pt idx="0">
                  <c:v>HMF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HMF!$B$2:$B$97</c:f>
              <c:strCache>
                <c:ptCount val="96"/>
                <c:pt idx="0">
                  <c:v>D12</c:v>
                </c:pt>
                <c:pt idx="1">
                  <c:v>H12</c:v>
                </c:pt>
                <c:pt idx="2">
                  <c:v>B6</c:v>
                </c:pt>
                <c:pt idx="3">
                  <c:v>D8</c:v>
                </c:pt>
                <c:pt idx="4">
                  <c:v>F10</c:v>
                </c:pt>
                <c:pt idx="5">
                  <c:v>E1</c:v>
                </c:pt>
                <c:pt idx="6">
                  <c:v>D4</c:v>
                </c:pt>
                <c:pt idx="7">
                  <c:v>F7</c:v>
                </c:pt>
                <c:pt idx="8">
                  <c:v>G6</c:v>
                </c:pt>
                <c:pt idx="9">
                  <c:v>E4</c:v>
                </c:pt>
                <c:pt idx="10">
                  <c:v>D5</c:v>
                </c:pt>
                <c:pt idx="11">
                  <c:v>E9</c:v>
                </c:pt>
                <c:pt idx="12">
                  <c:v>D7</c:v>
                </c:pt>
                <c:pt idx="13">
                  <c:v>D1</c:v>
                </c:pt>
                <c:pt idx="14">
                  <c:v>E12</c:v>
                </c:pt>
                <c:pt idx="15">
                  <c:v>E5</c:v>
                </c:pt>
                <c:pt idx="16">
                  <c:v>D11</c:v>
                </c:pt>
                <c:pt idx="17">
                  <c:v>E7</c:v>
                </c:pt>
                <c:pt idx="18">
                  <c:v>E3</c:v>
                </c:pt>
                <c:pt idx="19">
                  <c:v>G2</c:v>
                </c:pt>
                <c:pt idx="20">
                  <c:v>H9</c:v>
                </c:pt>
                <c:pt idx="21">
                  <c:v>G8</c:v>
                </c:pt>
                <c:pt idx="22">
                  <c:v>C10</c:v>
                </c:pt>
                <c:pt idx="23">
                  <c:v>C4</c:v>
                </c:pt>
                <c:pt idx="24">
                  <c:v>D10</c:v>
                </c:pt>
                <c:pt idx="25">
                  <c:v>F9</c:v>
                </c:pt>
                <c:pt idx="26">
                  <c:v>F3</c:v>
                </c:pt>
                <c:pt idx="27">
                  <c:v>G7</c:v>
                </c:pt>
                <c:pt idx="28">
                  <c:v>A8</c:v>
                </c:pt>
                <c:pt idx="29">
                  <c:v>B8</c:v>
                </c:pt>
                <c:pt idx="30">
                  <c:v>C3</c:v>
                </c:pt>
                <c:pt idx="31">
                  <c:v>H7</c:v>
                </c:pt>
                <c:pt idx="32">
                  <c:v>C8</c:v>
                </c:pt>
                <c:pt idx="33">
                  <c:v>B7</c:v>
                </c:pt>
                <c:pt idx="34">
                  <c:v>G3</c:v>
                </c:pt>
                <c:pt idx="35">
                  <c:v>E10</c:v>
                </c:pt>
                <c:pt idx="36">
                  <c:v>H3</c:v>
                </c:pt>
                <c:pt idx="37">
                  <c:v>B4</c:v>
                </c:pt>
                <c:pt idx="38">
                  <c:v>A7</c:v>
                </c:pt>
                <c:pt idx="39">
                  <c:v>F8</c:v>
                </c:pt>
                <c:pt idx="40">
                  <c:v>D9</c:v>
                </c:pt>
                <c:pt idx="41">
                  <c:v>G4</c:v>
                </c:pt>
                <c:pt idx="42">
                  <c:v>E11</c:v>
                </c:pt>
                <c:pt idx="43">
                  <c:v>H10</c:v>
                </c:pt>
                <c:pt idx="44">
                  <c:v>H5</c:v>
                </c:pt>
                <c:pt idx="45">
                  <c:v>F6</c:v>
                </c:pt>
                <c:pt idx="46">
                  <c:v>H1</c:v>
                </c:pt>
                <c:pt idx="47">
                  <c:v>F11</c:v>
                </c:pt>
                <c:pt idx="48">
                  <c:v>H8</c:v>
                </c:pt>
                <c:pt idx="49">
                  <c:v>D6</c:v>
                </c:pt>
                <c:pt idx="50">
                  <c:v>E8</c:v>
                </c:pt>
                <c:pt idx="51">
                  <c:v>D3</c:v>
                </c:pt>
                <c:pt idx="52">
                  <c:v>F5</c:v>
                </c:pt>
                <c:pt idx="53">
                  <c:v>E6</c:v>
                </c:pt>
                <c:pt idx="54">
                  <c:v>C5</c:v>
                </c:pt>
                <c:pt idx="55">
                  <c:v>B12</c:v>
                </c:pt>
                <c:pt idx="56">
                  <c:v>G12</c:v>
                </c:pt>
                <c:pt idx="57">
                  <c:v>B10</c:v>
                </c:pt>
                <c:pt idx="58">
                  <c:v>H4</c:v>
                </c:pt>
                <c:pt idx="59">
                  <c:v>B11</c:v>
                </c:pt>
                <c:pt idx="60">
                  <c:v>G5</c:v>
                </c:pt>
                <c:pt idx="61">
                  <c:v>H2</c:v>
                </c:pt>
                <c:pt idx="62">
                  <c:v>G1</c:v>
                </c:pt>
                <c:pt idx="63">
                  <c:v>C11</c:v>
                </c:pt>
                <c:pt idx="64">
                  <c:v>A3</c:v>
                </c:pt>
                <c:pt idx="65">
                  <c:v>B3</c:v>
                </c:pt>
                <c:pt idx="66">
                  <c:v>F1</c:v>
                </c:pt>
                <c:pt idx="67">
                  <c:v>C7</c:v>
                </c:pt>
                <c:pt idx="68">
                  <c:v>F12</c:v>
                </c:pt>
                <c:pt idx="69">
                  <c:v>A10</c:v>
                </c:pt>
                <c:pt idx="70">
                  <c:v>G10</c:v>
                </c:pt>
                <c:pt idx="71">
                  <c:v>C12</c:v>
                </c:pt>
                <c:pt idx="72">
                  <c:v>H6</c:v>
                </c:pt>
                <c:pt idx="73">
                  <c:v>A12</c:v>
                </c:pt>
                <c:pt idx="74">
                  <c:v>C9</c:v>
                </c:pt>
                <c:pt idx="75">
                  <c:v>B5</c:v>
                </c:pt>
                <c:pt idx="76">
                  <c:v>F4</c:v>
                </c:pt>
                <c:pt idx="77">
                  <c:v>C1</c:v>
                </c:pt>
                <c:pt idx="78">
                  <c:v>C6</c:v>
                </c:pt>
                <c:pt idx="79">
                  <c:v>A2</c:v>
                </c:pt>
                <c:pt idx="80">
                  <c:v>A5</c:v>
                </c:pt>
                <c:pt idx="81">
                  <c:v>F2</c:v>
                </c:pt>
                <c:pt idx="82">
                  <c:v>G11</c:v>
                </c:pt>
                <c:pt idx="83">
                  <c:v>E2</c:v>
                </c:pt>
                <c:pt idx="84">
                  <c:v>A11</c:v>
                </c:pt>
                <c:pt idx="85">
                  <c:v>A1</c:v>
                </c:pt>
                <c:pt idx="86">
                  <c:v>H11</c:v>
                </c:pt>
                <c:pt idx="87">
                  <c:v>G9</c:v>
                </c:pt>
                <c:pt idx="88">
                  <c:v>B9</c:v>
                </c:pt>
                <c:pt idx="89">
                  <c:v>D2</c:v>
                </c:pt>
                <c:pt idx="90">
                  <c:v>B2</c:v>
                </c:pt>
                <c:pt idx="91">
                  <c:v>A6</c:v>
                </c:pt>
                <c:pt idx="92">
                  <c:v>C2</c:v>
                </c:pt>
                <c:pt idx="93">
                  <c:v>A9</c:v>
                </c:pt>
                <c:pt idx="94">
                  <c:v>B1</c:v>
                </c:pt>
                <c:pt idx="95">
                  <c:v>A4</c:v>
                </c:pt>
              </c:strCache>
            </c:strRef>
          </c:xVal>
          <c:yVal>
            <c:numRef>
              <c:f>HMF!$F$2:$F$97</c:f>
              <c:numCache>
                <c:formatCode>General</c:formatCode>
                <c:ptCount val="96"/>
                <c:pt idx="0">
                  <c:v>41.803278688524586</c:v>
                </c:pt>
                <c:pt idx="1">
                  <c:v>58.558558558558559</c:v>
                </c:pt>
                <c:pt idx="2">
                  <c:v>62.857142857142854</c:v>
                </c:pt>
                <c:pt idx="3">
                  <c:v>65.289256198347118</c:v>
                </c:pt>
                <c:pt idx="4">
                  <c:v>65.600000000000009</c:v>
                </c:pt>
                <c:pt idx="5">
                  <c:v>65.740740740740762</c:v>
                </c:pt>
                <c:pt idx="6">
                  <c:v>66.981132075471677</c:v>
                </c:pt>
                <c:pt idx="7">
                  <c:v>67.543859649122822</c:v>
                </c:pt>
                <c:pt idx="8">
                  <c:v>68.316831683168303</c:v>
                </c:pt>
                <c:pt idx="9">
                  <c:v>68.316831683168346</c:v>
                </c:pt>
                <c:pt idx="10">
                  <c:v>68.799999999999983</c:v>
                </c:pt>
                <c:pt idx="11">
                  <c:v>68.93203883495147</c:v>
                </c:pt>
                <c:pt idx="12">
                  <c:v>69.026548672566364</c:v>
                </c:pt>
                <c:pt idx="13">
                  <c:v>69.607843137254903</c:v>
                </c:pt>
                <c:pt idx="14">
                  <c:v>69.747899159663845</c:v>
                </c:pt>
                <c:pt idx="15">
                  <c:v>70.491803278688508</c:v>
                </c:pt>
                <c:pt idx="16">
                  <c:v>71.304347826086953</c:v>
                </c:pt>
                <c:pt idx="17">
                  <c:v>71.551724137931032</c:v>
                </c:pt>
                <c:pt idx="18">
                  <c:v>72.033898305084762</c:v>
                </c:pt>
                <c:pt idx="19">
                  <c:v>72.072072072072075</c:v>
                </c:pt>
                <c:pt idx="20">
                  <c:v>72.897196261682254</c:v>
                </c:pt>
                <c:pt idx="21">
                  <c:v>73.134328358208961</c:v>
                </c:pt>
                <c:pt idx="22">
                  <c:v>74.358974358974379</c:v>
                </c:pt>
                <c:pt idx="23">
                  <c:v>74.468085106383</c:v>
                </c:pt>
                <c:pt idx="24">
                  <c:v>74.561403508771946</c:v>
                </c:pt>
                <c:pt idx="25">
                  <c:v>74.757281553398045</c:v>
                </c:pt>
                <c:pt idx="26">
                  <c:v>75.2</c:v>
                </c:pt>
                <c:pt idx="27">
                  <c:v>75.409836065573757</c:v>
                </c:pt>
                <c:pt idx="28">
                  <c:v>75.572519083969453</c:v>
                </c:pt>
                <c:pt idx="29">
                  <c:v>75.700934579439263</c:v>
                </c:pt>
                <c:pt idx="30">
                  <c:v>75.757575757575751</c:v>
                </c:pt>
                <c:pt idx="31">
                  <c:v>75.833333333333343</c:v>
                </c:pt>
                <c:pt idx="32">
                  <c:v>75.961538461538467</c:v>
                </c:pt>
                <c:pt idx="33">
                  <c:v>76.153846153846132</c:v>
                </c:pt>
                <c:pt idx="34">
                  <c:v>76.470588235294116</c:v>
                </c:pt>
                <c:pt idx="35">
                  <c:v>76.63551401869158</c:v>
                </c:pt>
                <c:pt idx="36">
                  <c:v>76.69172932330828</c:v>
                </c:pt>
                <c:pt idx="37">
                  <c:v>77.142857142857125</c:v>
                </c:pt>
                <c:pt idx="38">
                  <c:v>77.163461538461519</c:v>
                </c:pt>
                <c:pt idx="39">
                  <c:v>77.192982456140342</c:v>
                </c:pt>
                <c:pt idx="40">
                  <c:v>77.319587628865946</c:v>
                </c:pt>
                <c:pt idx="41">
                  <c:v>77.678571428571402</c:v>
                </c:pt>
                <c:pt idx="42">
                  <c:v>77.981651376146772</c:v>
                </c:pt>
                <c:pt idx="43">
                  <c:v>78.217821782178234</c:v>
                </c:pt>
                <c:pt idx="44">
                  <c:v>78.512396694214885</c:v>
                </c:pt>
                <c:pt idx="45">
                  <c:v>78.571428571428541</c:v>
                </c:pt>
                <c:pt idx="46">
                  <c:v>78.651685393258418</c:v>
                </c:pt>
                <c:pt idx="47">
                  <c:v>79.090909090909093</c:v>
                </c:pt>
                <c:pt idx="48">
                  <c:v>79.166666666666671</c:v>
                </c:pt>
                <c:pt idx="49">
                  <c:v>79.1666666666667</c:v>
                </c:pt>
                <c:pt idx="50">
                  <c:v>79.831932773109244</c:v>
                </c:pt>
                <c:pt idx="51">
                  <c:v>79.999999999999986</c:v>
                </c:pt>
                <c:pt idx="52">
                  <c:v>80.165289256198363</c:v>
                </c:pt>
                <c:pt idx="53">
                  <c:v>80.434782608695656</c:v>
                </c:pt>
                <c:pt idx="54">
                  <c:v>80.434782608695656</c:v>
                </c:pt>
                <c:pt idx="55">
                  <c:v>80.487804878048792</c:v>
                </c:pt>
                <c:pt idx="56">
                  <c:v>80.672268907563051</c:v>
                </c:pt>
                <c:pt idx="57">
                  <c:v>80.869565217391312</c:v>
                </c:pt>
                <c:pt idx="58">
                  <c:v>81.000000000000014</c:v>
                </c:pt>
                <c:pt idx="59">
                  <c:v>81.102362204724415</c:v>
                </c:pt>
                <c:pt idx="60">
                  <c:v>81.102362204724415</c:v>
                </c:pt>
                <c:pt idx="61">
                  <c:v>81.250000000000028</c:v>
                </c:pt>
                <c:pt idx="62">
                  <c:v>81.250000000000028</c:v>
                </c:pt>
                <c:pt idx="63">
                  <c:v>81.896551724137908</c:v>
                </c:pt>
                <c:pt idx="64">
                  <c:v>83.211678832116775</c:v>
                </c:pt>
                <c:pt idx="65">
                  <c:v>83.333333333333343</c:v>
                </c:pt>
                <c:pt idx="66">
                  <c:v>83.838383838383848</c:v>
                </c:pt>
                <c:pt idx="67">
                  <c:v>84.112149532710291</c:v>
                </c:pt>
                <c:pt idx="68">
                  <c:v>84.166666666666643</c:v>
                </c:pt>
                <c:pt idx="69">
                  <c:v>84.297520661157023</c:v>
                </c:pt>
                <c:pt idx="70">
                  <c:v>84.313725490196092</c:v>
                </c:pt>
                <c:pt idx="71">
                  <c:v>84.615384615384599</c:v>
                </c:pt>
                <c:pt idx="72">
                  <c:v>84.821428571428555</c:v>
                </c:pt>
                <c:pt idx="73">
                  <c:v>84.827586206896541</c:v>
                </c:pt>
                <c:pt idx="74">
                  <c:v>85.555555555555557</c:v>
                </c:pt>
                <c:pt idx="75">
                  <c:v>86.567164179104466</c:v>
                </c:pt>
                <c:pt idx="76">
                  <c:v>86.597938144329888</c:v>
                </c:pt>
                <c:pt idx="77">
                  <c:v>86.734693877551038</c:v>
                </c:pt>
                <c:pt idx="78">
                  <c:v>87.272727272727252</c:v>
                </c:pt>
                <c:pt idx="79">
                  <c:v>87.378640776699044</c:v>
                </c:pt>
                <c:pt idx="80">
                  <c:v>88.489208633093526</c:v>
                </c:pt>
                <c:pt idx="81">
                  <c:v>88.888888888888872</c:v>
                </c:pt>
                <c:pt idx="82">
                  <c:v>89.814814814814824</c:v>
                </c:pt>
                <c:pt idx="83">
                  <c:v>90.109890109890117</c:v>
                </c:pt>
                <c:pt idx="84">
                  <c:v>90.168539325842701</c:v>
                </c:pt>
                <c:pt idx="85">
                  <c:v>90.243902439024396</c:v>
                </c:pt>
                <c:pt idx="86">
                  <c:v>90.566037735849093</c:v>
                </c:pt>
                <c:pt idx="87">
                  <c:v>90.721649484536087</c:v>
                </c:pt>
                <c:pt idx="88">
                  <c:v>91.176470588235276</c:v>
                </c:pt>
                <c:pt idx="89">
                  <c:v>91.397849462365599</c:v>
                </c:pt>
                <c:pt idx="90">
                  <c:v>92.307692307692307</c:v>
                </c:pt>
                <c:pt idx="91">
                  <c:v>92.532467532467521</c:v>
                </c:pt>
                <c:pt idx="92">
                  <c:v>96.51162790697677</c:v>
                </c:pt>
                <c:pt idx="93">
                  <c:v>98.019801980198011</c:v>
                </c:pt>
                <c:pt idx="94">
                  <c:v>98.360655737704946</c:v>
                </c:pt>
                <c:pt idx="95">
                  <c:v>106.3745019920318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66016"/>
        <c:axId val="194966592"/>
      </c:scatterChart>
      <c:valAx>
        <c:axId val="19496601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966592"/>
        <c:crosses val="autoZero"/>
        <c:crossBetween val="midCat"/>
        <c:majorUnit val="50"/>
      </c:valAx>
      <c:valAx>
        <c:axId val="194966592"/>
        <c:scaling>
          <c:orientation val="minMax"/>
          <c:max val="12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 of contr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966016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70006873510876999"/>
          <c:y val="0.64332640711577715"/>
          <c:w val="0.26255613642597259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821262285030928"/>
          <c:y val="5.1400554097404488E-2"/>
          <c:w val="0.74048726621107386"/>
          <c:h val="0.67762378254268041"/>
        </c:manualLayout>
      </c:layout>
      <c:scatterChart>
        <c:scatterStyle val="lineMarker"/>
        <c:varyColors val="0"/>
        <c:ser>
          <c:idx val="0"/>
          <c:order val="0"/>
          <c:tx>
            <c:strRef>
              <c:f>Vanillin!$G$1</c:f>
              <c:strCache>
                <c:ptCount val="1"/>
                <c:pt idx="0">
                  <c:v>Vanillin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Vanillin!$B$2:$B$97</c:f>
              <c:strCache>
                <c:ptCount val="96"/>
                <c:pt idx="0">
                  <c:v>C2</c:v>
                </c:pt>
                <c:pt idx="1">
                  <c:v>D2</c:v>
                </c:pt>
                <c:pt idx="2">
                  <c:v>D1</c:v>
                </c:pt>
                <c:pt idx="3">
                  <c:v>H4</c:v>
                </c:pt>
                <c:pt idx="4">
                  <c:v>E6</c:v>
                </c:pt>
                <c:pt idx="5">
                  <c:v>E8</c:v>
                </c:pt>
                <c:pt idx="6">
                  <c:v>C8</c:v>
                </c:pt>
                <c:pt idx="7">
                  <c:v>E1</c:v>
                </c:pt>
                <c:pt idx="8">
                  <c:v>H8</c:v>
                </c:pt>
                <c:pt idx="9">
                  <c:v>A8</c:v>
                </c:pt>
                <c:pt idx="10">
                  <c:v>B2</c:v>
                </c:pt>
                <c:pt idx="11">
                  <c:v>G8</c:v>
                </c:pt>
                <c:pt idx="12">
                  <c:v>D5</c:v>
                </c:pt>
                <c:pt idx="13">
                  <c:v>H5</c:v>
                </c:pt>
                <c:pt idx="14">
                  <c:v>C5</c:v>
                </c:pt>
                <c:pt idx="15">
                  <c:v>H3</c:v>
                </c:pt>
                <c:pt idx="16">
                  <c:v>F8</c:v>
                </c:pt>
                <c:pt idx="17">
                  <c:v>F2</c:v>
                </c:pt>
                <c:pt idx="18">
                  <c:v>H1</c:v>
                </c:pt>
                <c:pt idx="19">
                  <c:v>A1</c:v>
                </c:pt>
                <c:pt idx="20">
                  <c:v>H10</c:v>
                </c:pt>
                <c:pt idx="21">
                  <c:v>A7</c:v>
                </c:pt>
                <c:pt idx="22">
                  <c:v>D8</c:v>
                </c:pt>
                <c:pt idx="23">
                  <c:v>B5</c:v>
                </c:pt>
                <c:pt idx="24">
                  <c:v>D10</c:v>
                </c:pt>
                <c:pt idx="25">
                  <c:v>D7</c:v>
                </c:pt>
                <c:pt idx="26">
                  <c:v>E2</c:v>
                </c:pt>
                <c:pt idx="27">
                  <c:v>H12</c:v>
                </c:pt>
                <c:pt idx="28">
                  <c:v>F5</c:v>
                </c:pt>
                <c:pt idx="29">
                  <c:v>B3</c:v>
                </c:pt>
                <c:pt idx="30">
                  <c:v>B12</c:v>
                </c:pt>
                <c:pt idx="31">
                  <c:v>D11</c:v>
                </c:pt>
                <c:pt idx="32">
                  <c:v>C3</c:v>
                </c:pt>
                <c:pt idx="33">
                  <c:v>H7</c:v>
                </c:pt>
                <c:pt idx="34">
                  <c:v>B7</c:v>
                </c:pt>
                <c:pt idx="35">
                  <c:v>G5</c:v>
                </c:pt>
                <c:pt idx="36">
                  <c:v>G4</c:v>
                </c:pt>
                <c:pt idx="37">
                  <c:v>H2</c:v>
                </c:pt>
                <c:pt idx="38">
                  <c:v>G2</c:v>
                </c:pt>
                <c:pt idx="39">
                  <c:v>G6</c:v>
                </c:pt>
                <c:pt idx="40">
                  <c:v>F3</c:v>
                </c:pt>
                <c:pt idx="41">
                  <c:v>G12</c:v>
                </c:pt>
                <c:pt idx="42">
                  <c:v>E10</c:v>
                </c:pt>
                <c:pt idx="43">
                  <c:v>G7</c:v>
                </c:pt>
                <c:pt idx="44">
                  <c:v>D3</c:v>
                </c:pt>
                <c:pt idx="45">
                  <c:v>F10</c:v>
                </c:pt>
                <c:pt idx="46">
                  <c:v>A5</c:v>
                </c:pt>
                <c:pt idx="47">
                  <c:v>D12</c:v>
                </c:pt>
                <c:pt idx="48">
                  <c:v>G3</c:v>
                </c:pt>
                <c:pt idx="49">
                  <c:v>F1</c:v>
                </c:pt>
                <c:pt idx="50">
                  <c:v>D4</c:v>
                </c:pt>
                <c:pt idx="51">
                  <c:v>F12</c:v>
                </c:pt>
                <c:pt idx="52">
                  <c:v>A12</c:v>
                </c:pt>
                <c:pt idx="53">
                  <c:v>B8</c:v>
                </c:pt>
                <c:pt idx="54">
                  <c:v>E12</c:v>
                </c:pt>
                <c:pt idx="55">
                  <c:v>D9</c:v>
                </c:pt>
                <c:pt idx="56">
                  <c:v>E5</c:v>
                </c:pt>
                <c:pt idx="57">
                  <c:v>H6</c:v>
                </c:pt>
                <c:pt idx="58">
                  <c:v>C10</c:v>
                </c:pt>
                <c:pt idx="59">
                  <c:v>E7</c:v>
                </c:pt>
                <c:pt idx="60">
                  <c:v>C1</c:v>
                </c:pt>
                <c:pt idx="61">
                  <c:v>A3</c:v>
                </c:pt>
                <c:pt idx="62">
                  <c:v>F7</c:v>
                </c:pt>
                <c:pt idx="63">
                  <c:v>G10</c:v>
                </c:pt>
                <c:pt idx="64">
                  <c:v>B10</c:v>
                </c:pt>
                <c:pt idx="65">
                  <c:v>B11</c:v>
                </c:pt>
                <c:pt idx="66">
                  <c:v>F6</c:v>
                </c:pt>
                <c:pt idx="67">
                  <c:v>H9</c:v>
                </c:pt>
                <c:pt idx="68">
                  <c:v>C12</c:v>
                </c:pt>
                <c:pt idx="69">
                  <c:v>B6</c:v>
                </c:pt>
                <c:pt idx="70">
                  <c:v>C4</c:v>
                </c:pt>
                <c:pt idx="71">
                  <c:v>C7</c:v>
                </c:pt>
                <c:pt idx="72">
                  <c:v>C11</c:v>
                </c:pt>
                <c:pt idx="73">
                  <c:v>F4</c:v>
                </c:pt>
                <c:pt idx="74">
                  <c:v>D6</c:v>
                </c:pt>
                <c:pt idx="75">
                  <c:v>E3</c:v>
                </c:pt>
                <c:pt idx="76">
                  <c:v>C6</c:v>
                </c:pt>
                <c:pt idx="77">
                  <c:v>H11</c:v>
                </c:pt>
                <c:pt idx="78">
                  <c:v>A10</c:v>
                </c:pt>
                <c:pt idx="79">
                  <c:v>F9</c:v>
                </c:pt>
                <c:pt idx="80">
                  <c:v>B1</c:v>
                </c:pt>
                <c:pt idx="81">
                  <c:v>A6</c:v>
                </c:pt>
                <c:pt idx="82">
                  <c:v>A11</c:v>
                </c:pt>
                <c:pt idx="83">
                  <c:v>C9</c:v>
                </c:pt>
                <c:pt idx="84">
                  <c:v>E4</c:v>
                </c:pt>
                <c:pt idx="85">
                  <c:v>F11</c:v>
                </c:pt>
                <c:pt idx="86">
                  <c:v>G11</c:v>
                </c:pt>
                <c:pt idx="87">
                  <c:v>G1</c:v>
                </c:pt>
                <c:pt idx="88">
                  <c:v>E9</c:v>
                </c:pt>
                <c:pt idx="89">
                  <c:v>B4</c:v>
                </c:pt>
                <c:pt idx="90">
                  <c:v>B9</c:v>
                </c:pt>
                <c:pt idx="91">
                  <c:v>E11</c:v>
                </c:pt>
                <c:pt idx="92">
                  <c:v>G9</c:v>
                </c:pt>
                <c:pt idx="93">
                  <c:v>A2</c:v>
                </c:pt>
                <c:pt idx="94">
                  <c:v>A4</c:v>
                </c:pt>
                <c:pt idx="95">
                  <c:v>A9</c:v>
                </c:pt>
              </c:strCache>
            </c:strRef>
          </c:xVal>
          <c:yVal>
            <c:numRef>
              <c:f>Vanillin!$G$2:$G$97</c:f>
              <c:numCache>
                <c:formatCode>General</c:formatCode>
                <c:ptCount val="96"/>
                <c:pt idx="0">
                  <c:v>55.813953488372128</c:v>
                </c:pt>
                <c:pt idx="1">
                  <c:v>89.247311827957006</c:v>
                </c:pt>
                <c:pt idx="2">
                  <c:v>92.156862745098039</c:v>
                </c:pt>
                <c:pt idx="3">
                  <c:v>93.000000000000043</c:v>
                </c:pt>
                <c:pt idx="4">
                  <c:v>94.56521739130433</c:v>
                </c:pt>
                <c:pt idx="5">
                  <c:v>97.478991596638636</c:v>
                </c:pt>
                <c:pt idx="6">
                  <c:v>99.038461538461533</c:v>
                </c:pt>
                <c:pt idx="7">
                  <c:v>99.07407407407409</c:v>
                </c:pt>
                <c:pt idx="8">
                  <c:v>99.166666666666686</c:v>
                </c:pt>
                <c:pt idx="9">
                  <c:v>99.999999999999986</c:v>
                </c:pt>
                <c:pt idx="10">
                  <c:v>100</c:v>
                </c:pt>
                <c:pt idx="11">
                  <c:v>100.74626865671644</c:v>
                </c:pt>
                <c:pt idx="12">
                  <c:v>100.79999999999998</c:v>
                </c:pt>
                <c:pt idx="13">
                  <c:v>101.65289256198349</c:v>
                </c:pt>
                <c:pt idx="14">
                  <c:v>102.17391304347822</c:v>
                </c:pt>
                <c:pt idx="15">
                  <c:v>102.25563909774435</c:v>
                </c:pt>
                <c:pt idx="16">
                  <c:v>102.63157894736838</c:v>
                </c:pt>
                <c:pt idx="17">
                  <c:v>103.03030303030299</c:v>
                </c:pt>
                <c:pt idx="18">
                  <c:v>104.49438202247192</c:v>
                </c:pt>
                <c:pt idx="19">
                  <c:v>105.69105691056913</c:v>
                </c:pt>
                <c:pt idx="20">
                  <c:v>105.94059405940595</c:v>
                </c:pt>
                <c:pt idx="21">
                  <c:v>106.00961538461537</c:v>
                </c:pt>
                <c:pt idx="22">
                  <c:v>106.61157024793391</c:v>
                </c:pt>
                <c:pt idx="23">
                  <c:v>106.71641791044777</c:v>
                </c:pt>
                <c:pt idx="24">
                  <c:v>107.01754385964915</c:v>
                </c:pt>
                <c:pt idx="25">
                  <c:v>107.0796460176991</c:v>
                </c:pt>
                <c:pt idx="26">
                  <c:v>107.69230769230774</c:v>
                </c:pt>
                <c:pt idx="27">
                  <c:v>108.10810810810815</c:v>
                </c:pt>
                <c:pt idx="28">
                  <c:v>108.26446280991738</c:v>
                </c:pt>
                <c:pt idx="29">
                  <c:v>108.33333333333334</c:v>
                </c:pt>
                <c:pt idx="30">
                  <c:v>108.94308943089432</c:v>
                </c:pt>
                <c:pt idx="31">
                  <c:v>109.56521739130436</c:v>
                </c:pt>
                <c:pt idx="32">
                  <c:v>109.84848484848486</c:v>
                </c:pt>
                <c:pt idx="33">
                  <c:v>109.99999999999999</c:v>
                </c:pt>
                <c:pt idx="34">
                  <c:v>110.00000000000001</c:v>
                </c:pt>
                <c:pt idx="35">
                  <c:v>110.23622047244092</c:v>
                </c:pt>
                <c:pt idx="36">
                  <c:v>110.71428571428572</c:v>
                </c:pt>
                <c:pt idx="37">
                  <c:v>110.71428571428574</c:v>
                </c:pt>
                <c:pt idx="38">
                  <c:v>110.81081081081084</c:v>
                </c:pt>
                <c:pt idx="39">
                  <c:v>110.89108910891088</c:v>
                </c:pt>
                <c:pt idx="40">
                  <c:v>111.99999999999999</c:v>
                </c:pt>
                <c:pt idx="41">
                  <c:v>112.60504201680672</c:v>
                </c:pt>
                <c:pt idx="42">
                  <c:v>113.08411214953271</c:v>
                </c:pt>
                <c:pt idx="43">
                  <c:v>113.11475409836066</c:v>
                </c:pt>
                <c:pt idx="44">
                  <c:v>113.33333333333331</c:v>
                </c:pt>
                <c:pt idx="45">
                  <c:v>113.6</c:v>
                </c:pt>
                <c:pt idx="46">
                  <c:v>113.66906474820139</c:v>
                </c:pt>
                <c:pt idx="47">
                  <c:v>113.93442622950818</c:v>
                </c:pt>
                <c:pt idx="48">
                  <c:v>113.97058823529412</c:v>
                </c:pt>
                <c:pt idx="49">
                  <c:v>114.14141414141416</c:v>
                </c:pt>
                <c:pt idx="50">
                  <c:v>114.15094339622642</c:v>
                </c:pt>
                <c:pt idx="51">
                  <c:v>114.16666666666666</c:v>
                </c:pt>
                <c:pt idx="52">
                  <c:v>114.48275862068967</c:v>
                </c:pt>
                <c:pt idx="53">
                  <c:v>114.95327102803734</c:v>
                </c:pt>
                <c:pt idx="54">
                  <c:v>115.12605042016806</c:v>
                </c:pt>
                <c:pt idx="55">
                  <c:v>115.46391752577318</c:v>
                </c:pt>
                <c:pt idx="56">
                  <c:v>115.57377049180324</c:v>
                </c:pt>
                <c:pt idx="57">
                  <c:v>116.07142857142858</c:v>
                </c:pt>
                <c:pt idx="58">
                  <c:v>116.23931623931625</c:v>
                </c:pt>
                <c:pt idx="59">
                  <c:v>116.37931034482756</c:v>
                </c:pt>
                <c:pt idx="60">
                  <c:v>117.3469387755102</c:v>
                </c:pt>
                <c:pt idx="61">
                  <c:v>117.51824817518248</c:v>
                </c:pt>
                <c:pt idx="62">
                  <c:v>117.54385964912284</c:v>
                </c:pt>
                <c:pt idx="63">
                  <c:v>117.64705882352946</c:v>
                </c:pt>
                <c:pt idx="64">
                  <c:v>118.26086956521742</c:v>
                </c:pt>
                <c:pt idx="65">
                  <c:v>118.89763779527559</c:v>
                </c:pt>
                <c:pt idx="66">
                  <c:v>119.38775510204079</c:v>
                </c:pt>
                <c:pt idx="67">
                  <c:v>119.62616822429908</c:v>
                </c:pt>
                <c:pt idx="68">
                  <c:v>120.19230769230769</c:v>
                </c:pt>
                <c:pt idx="69">
                  <c:v>120.95238095238095</c:v>
                </c:pt>
                <c:pt idx="70">
                  <c:v>121.27659574468086</c:v>
                </c:pt>
                <c:pt idx="71">
                  <c:v>121.49532710280376</c:v>
                </c:pt>
                <c:pt idx="72">
                  <c:v>121.551724137931</c:v>
                </c:pt>
                <c:pt idx="73">
                  <c:v>121.64948453608247</c:v>
                </c:pt>
                <c:pt idx="74">
                  <c:v>123.95833333333337</c:v>
                </c:pt>
                <c:pt idx="75">
                  <c:v>124.57627118644068</c:v>
                </c:pt>
                <c:pt idx="76">
                  <c:v>125.45454545454542</c:v>
                </c:pt>
                <c:pt idx="77">
                  <c:v>125.47169811320755</c:v>
                </c:pt>
                <c:pt idx="78">
                  <c:v>125.61983471074383</c:v>
                </c:pt>
                <c:pt idx="79">
                  <c:v>126.21359223300969</c:v>
                </c:pt>
                <c:pt idx="80">
                  <c:v>126.22950819672131</c:v>
                </c:pt>
                <c:pt idx="81">
                  <c:v>126.62337662337664</c:v>
                </c:pt>
                <c:pt idx="82">
                  <c:v>127.24719101123594</c:v>
                </c:pt>
                <c:pt idx="83">
                  <c:v>127.77777777777774</c:v>
                </c:pt>
                <c:pt idx="84">
                  <c:v>128.71287128712873</c:v>
                </c:pt>
                <c:pt idx="85">
                  <c:v>129.09090909090909</c:v>
                </c:pt>
                <c:pt idx="86">
                  <c:v>129.62962962962962</c:v>
                </c:pt>
                <c:pt idx="87">
                  <c:v>131.25000000000006</c:v>
                </c:pt>
                <c:pt idx="88">
                  <c:v>132.03883495145629</c:v>
                </c:pt>
                <c:pt idx="89">
                  <c:v>132.38095238095235</c:v>
                </c:pt>
                <c:pt idx="90">
                  <c:v>133.33333333333331</c:v>
                </c:pt>
                <c:pt idx="91">
                  <c:v>135.77981651376149</c:v>
                </c:pt>
                <c:pt idx="92">
                  <c:v>140.20618556701027</c:v>
                </c:pt>
                <c:pt idx="93">
                  <c:v>142.71844660194176</c:v>
                </c:pt>
                <c:pt idx="94">
                  <c:v>144.62151394422301</c:v>
                </c:pt>
                <c:pt idx="95">
                  <c:v>146.5346534653465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68320"/>
        <c:axId val="194968896"/>
      </c:scatterChart>
      <c:valAx>
        <c:axId val="19496832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968896"/>
        <c:crosses val="autoZero"/>
        <c:crossBetween val="midCat"/>
        <c:majorUnit val="50"/>
      </c:valAx>
      <c:valAx>
        <c:axId val="194968896"/>
        <c:scaling>
          <c:orientation val="minMax"/>
          <c:max val="16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 of contr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96832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6696563530075936"/>
          <c:y val="0.64332640711577715"/>
          <c:w val="0.29565949141944842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99604773124572"/>
          <c:y val="5.1400554097404488E-2"/>
          <c:w val="0.69263220768577483"/>
          <c:h val="0.67933279404140279"/>
        </c:manualLayout>
      </c:layout>
      <c:scatterChart>
        <c:scatterStyle val="lineMarker"/>
        <c:varyColors val="0"/>
        <c:ser>
          <c:idx val="0"/>
          <c:order val="0"/>
          <c:tx>
            <c:strRef>
              <c:f>Sorbitol!$H$1</c:f>
              <c:strCache>
                <c:ptCount val="1"/>
                <c:pt idx="0">
                  <c:v>Sorbit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orbitol!$B$2:$B$97</c:f>
              <c:strCache>
                <c:ptCount val="96"/>
                <c:pt idx="0">
                  <c:v>A2</c:v>
                </c:pt>
                <c:pt idx="1">
                  <c:v>B7</c:v>
                </c:pt>
                <c:pt idx="2">
                  <c:v>H4</c:v>
                </c:pt>
                <c:pt idx="3">
                  <c:v>H12</c:v>
                </c:pt>
                <c:pt idx="4">
                  <c:v>F8</c:v>
                </c:pt>
                <c:pt idx="5">
                  <c:v>B5</c:v>
                </c:pt>
                <c:pt idx="6">
                  <c:v>H3</c:v>
                </c:pt>
                <c:pt idx="7">
                  <c:v>H6</c:v>
                </c:pt>
                <c:pt idx="8">
                  <c:v>G8</c:v>
                </c:pt>
                <c:pt idx="9">
                  <c:v>H7</c:v>
                </c:pt>
                <c:pt idx="10">
                  <c:v>F12</c:v>
                </c:pt>
                <c:pt idx="11">
                  <c:v>G4</c:v>
                </c:pt>
                <c:pt idx="12">
                  <c:v>G6</c:v>
                </c:pt>
                <c:pt idx="13">
                  <c:v>H2</c:v>
                </c:pt>
                <c:pt idx="14">
                  <c:v>E1</c:v>
                </c:pt>
                <c:pt idx="15">
                  <c:v>B6</c:v>
                </c:pt>
                <c:pt idx="16">
                  <c:v>G3</c:v>
                </c:pt>
                <c:pt idx="17">
                  <c:v>H11</c:v>
                </c:pt>
                <c:pt idx="18">
                  <c:v>C4</c:v>
                </c:pt>
                <c:pt idx="19">
                  <c:v>C1</c:v>
                </c:pt>
                <c:pt idx="20">
                  <c:v>H1</c:v>
                </c:pt>
                <c:pt idx="21">
                  <c:v>G5</c:v>
                </c:pt>
                <c:pt idx="22">
                  <c:v>F4</c:v>
                </c:pt>
                <c:pt idx="23">
                  <c:v>F2</c:v>
                </c:pt>
                <c:pt idx="24">
                  <c:v>C11</c:v>
                </c:pt>
                <c:pt idx="25">
                  <c:v>E12</c:v>
                </c:pt>
                <c:pt idx="26">
                  <c:v>B8</c:v>
                </c:pt>
                <c:pt idx="27">
                  <c:v>H10</c:v>
                </c:pt>
                <c:pt idx="28">
                  <c:v>G11</c:v>
                </c:pt>
                <c:pt idx="29">
                  <c:v>G9</c:v>
                </c:pt>
                <c:pt idx="30">
                  <c:v>G12</c:v>
                </c:pt>
                <c:pt idx="31">
                  <c:v>C2</c:v>
                </c:pt>
                <c:pt idx="32">
                  <c:v>F10</c:v>
                </c:pt>
                <c:pt idx="33">
                  <c:v>G7</c:v>
                </c:pt>
                <c:pt idx="34">
                  <c:v>B11</c:v>
                </c:pt>
                <c:pt idx="35">
                  <c:v>F3</c:v>
                </c:pt>
                <c:pt idx="36">
                  <c:v>H9</c:v>
                </c:pt>
                <c:pt idx="37">
                  <c:v>C10</c:v>
                </c:pt>
                <c:pt idx="38">
                  <c:v>G1</c:v>
                </c:pt>
                <c:pt idx="39">
                  <c:v>A1</c:v>
                </c:pt>
                <c:pt idx="40">
                  <c:v>A12</c:v>
                </c:pt>
                <c:pt idx="41">
                  <c:v>E2</c:v>
                </c:pt>
                <c:pt idx="42">
                  <c:v>B2</c:v>
                </c:pt>
                <c:pt idx="43">
                  <c:v>E8</c:v>
                </c:pt>
                <c:pt idx="44">
                  <c:v>B3</c:v>
                </c:pt>
                <c:pt idx="45">
                  <c:v>A5</c:v>
                </c:pt>
                <c:pt idx="46">
                  <c:v>H5</c:v>
                </c:pt>
                <c:pt idx="47">
                  <c:v>E4</c:v>
                </c:pt>
                <c:pt idx="48">
                  <c:v>E7</c:v>
                </c:pt>
                <c:pt idx="49">
                  <c:v>F7</c:v>
                </c:pt>
                <c:pt idx="50">
                  <c:v>F9</c:v>
                </c:pt>
                <c:pt idx="51">
                  <c:v>B10</c:v>
                </c:pt>
                <c:pt idx="52">
                  <c:v>C8</c:v>
                </c:pt>
                <c:pt idx="53">
                  <c:v>C9</c:v>
                </c:pt>
                <c:pt idx="54">
                  <c:v>A4</c:v>
                </c:pt>
                <c:pt idx="55">
                  <c:v>F1</c:v>
                </c:pt>
                <c:pt idx="56">
                  <c:v>E5</c:v>
                </c:pt>
                <c:pt idx="57">
                  <c:v>G10</c:v>
                </c:pt>
                <c:pt idx="58">
                  <c:v>E11</c:v>
                </c:pt>
                <c:pt idx="59">
                  <c:v>C6</c:v>
                </c:pt>
                <c:pt idx="60">
                  <c:v>F11</c:v>
                </c:pt>
                <c:pt idx="61">
                  <c:v>E6</c:v>
                </c:pt>
                <c:pt idx="62">
                  <c:v>D8</c:v>
                </c:pt>
                <c:pt idx="63">
                  <c:v>D5</c:v>
                </c:pt>
                <c:pt idx="64">
                  <c:v>A9</c:v>
                </c:pt>
                <c:pt idx="65">
                  <c:v>A7</c:v>
                </c:pt>
                <c:pt idx="66">
                  <c:v>E10</c:v>
                </c:pt>
                <c:pt idx="67">
                  <c:v>D12</c:v>
                </c:pt>
                <c:pt idx="68">
                  <c:v>C12</c:v>
                </c:pt>
                <c:pt idx="69">
                  <c:v>B1</c:v>
                </c:pt>
                <c:pt idx="70">
                  <c:v>D4</c:v>
                </c:pt>
                <c:pt idx="71">
                  <c:v>A10</c:v>
                </c:pt>
                <c:pt idx="72">
                  <c:v>E9</c:v>
                </c:pt>
                <c:pt idx="73">
                  <c:v>D6</c:v>
                </c:pt>
                <c:pt idx="74">
                  <c:v>E3</c:v>
                </c:pt>
                <c:pt idx="75">
                  <c:v>H8</c:v>
                </c:pt>
                <c:pt idx="76">
                  <c:v>G2</c:v>
                </c:pt>
                <c:pt idx="77">
                  <c:v>A8</c:v>
                </c:pt>
                <c:pt idx="78">
                  <c:v>B9</c:v>
                </c:pt>
                <c:pt idx="79">
                  <c:v>D7</c:v>
                </c:pt>
                <c:pt idx="80">
                  <c:v>C3</c:v>
                </c:pt>
                <c:pt idx="81">
                  <c:v>D9</c:v>
                </c:pt>
                <c:pt idx="82">
                  <c:v>D3</c:v>
                </c:pt>
                <c:pt idx="83">
                  <c:v>B4</c:v>
                </c:pt>
                <c:pt idx="84">
                  <c:v>D10</c:v>
                </c:pt>
                <c:pt idx="85">
                  <c:v>D2</c:v>
                </c:pt>
                <c:pt idx="86">
                  <c:v>D11</c:v>
                </c:pt>
                <c:pt idx="87">
                  <c:v>A11</c:v>
                </c:pt>
                <c:pt idx="88">
                  <c:v>F5</c:v>
                </c:pt>
                <c:pt idx="89">
                  <c:v>F6</c:v>
                </c:pt>
                <c:pt idx="90">
                  <c:v>D1</c:v>
                </c:pt>
                <c:pt idx="91">
                  <c:v>A3</c:v>
                </c:pt>
                <c:pt idx="92">
                  <c:v>C5</c:v>
                </c:pt>
                <c:pt idx="93">
                  <c:v>A6</c:v>
                </c:pt>
                <c:pt idx="94">
                  <c:v>B12</c:v>
                </c:pt>
                <c:pt idx="95">
                  <c:v>C7</c:v>
                </c:pt>
              </c:strCache>
            </c:strRef>
          </c:xVal>
          <c:yVal>
            <c:numRef>
              <c:f>Sorbitol!$H$2:$H$97</c:f>
              <c:numCache>
                <c:formatCode>General</c:formatCode>
                <c:ptCount val="96"/>
                <c:pt idx="0">
                  <c:v>41.935483870967715</c:v>
                </c:pt>
                <c:pt idx="1">
                  <c:v>48.837209302325554</c:v>
                </c:pt>
                <c:pt idx="2">
                  <c:v>77.952755905511779</c:v>
                </c:pt>
                <c:pt idx="3">
                  <c:v>78.787878787878768</c:v>
                </c:pt>
                <c:pt idx="4">
                  <c:v>81.060606060606105</c:v>
                </c:pt>
                <c:pt idx="5">
                  <c:v>81.111111111111143</c:v>
                </c:pt>
                <c:pt idx="6">
                  <c:v>81.914893617021278</c:v>
                </c:pt>
                <c:pt idx="7">
                  <c:v>88.815789473684191</c:v>
                </c:pt>
                <c:pt idx="8">
                  <c:v>90.849673202614355</c:v>
                </c:pt>
                <c:pt idx="9">
                  <c:v>91.919191919191903</c:v>
                </c:pt>
                <c:pt idx="10">
                  <c:v>92.3611111111111</c:v>
                </c:pt>
                <c:pt idx="11">
                  <c:v>97.727272727272762</c:v>
                </c:pt>
                <c:pt idx="12">
                  <c:v>97.902097902097879</c:v>
                </c:pt>
                <c:pt idx="13">
                  <c:v>98.095238095238102</c:v>
                </c:pt>
                <c:pt idx="14">
                  <c:v>98.717948717948673</c:v>
                </c:pt>
                <c:pt idx="15">
                  <c:v>99.264705882352928</c:v>
                </c:pt>
                <c:pt idx="16">
                  <c:v>101.8018018018018</c:v>
                </c:pt>
                <c:pt idx="17">
                  <c:v>101.96078431372551</c:v>
                </c:pt>
                <c:pt idx="18">
                  <c:v>102.35294117647061</c:v>
                </c:pt>
                <c:pt idx="19">
                  <c:v>102.46913580246914</c:v>
                </c:pt>
                <c:pt idx="20">
                  <c:v>104.40251572327044</c:v>
                </c:pt>
                <c:pt idx="21">
                  <c:v>105.0420168067227</c:v>
                </c:pt>
                <c:pt idx="22">
                  <c:v>105.98290598290599</c:v>
                </c:pt>
                <c:pt idx="23">
                  <c:v>106.81818181818177</c:v>
                </c:pt>
                <c:pt idx="24">
                  <c:v>107.40740740740739</c:v>
                </c:pt>
                <c:pt idx="25">
                  <c:v>107.40740740740742</c:v>
                </c:pt>
                <c:pt idx="26">
                  <c:v>109.30232558139539</c:v>
                </c:pt>
                <c:pt idx="27">
                  <c:v>109.9009900990099</c:v>
                </c:pt>
                <c:pt idx="28">
                  <c:v>110.11235955056178</c:v>
                </c:pt>
                <c:pt idx="29">
                  <c:v>110.22727272727275</c:v>
                </c:pt>
                <c:pt idx="30">
                  <c:v>111.42857142857142</c:v>
                </c:pt>
                <c:pt idx="31">
                  <c:v>113.6094674556213</c:v>
                </c:pt>
                <c:pt idx="32">
                  <c:v>113.7254901960785</c:v>
                </c:pt>
                <c:pt idx="33">
                  <c:v>115.06849315068494</c:v>
                </c:pt>
                <c:pt idx="34">
                  <c:v>115.25423728813567</c:v>
                </c:pt>
                <c:pt idx="35">
                  <c:v>116.12903225806454</c:v>
                </c:pt>
                <c:pt idx="36">
                  <c:v>116.4556962025316</c:v>
                </c:pt>
                <c:pt idx="37">
                  <c:v>116.66666666666666</c:v>
                </c:pt>
                <c:pt idx="38">
                  <c:v>117.58241758241761</c:v>
                </c:pt>
                <c:pt idx="39">
                  <c:v>117.87234042553195</c:v>
                </c:pt>
                <c:pt idx="40">
                  <c:v>121.05263157894737</c:v>
                </c:pt>
                <c:pt idx="41">
                  <c:v>121.49532710280373</c:v>
                </c:pt>
                <c:pt idx="42">
                  <c:v>121.66666666666663</c:v>
                </c:pt>
                <c:pt idx="43">
                  <c:v>122.95081967213117</c:v>
                </c:pt>
                <c:pt idx="44">
                  <c:v>125.2873563218391</c:v>
                </c:pt>
                <c:pt idx="45">
                  <c:v>125.45454545454535</c:v>
                </c:pt>
                <c:pt idx="46">
                  <c:v>126.02739726027399</c:v>
                </c:pt>
                <c:pt idx="47">
                  <c:v>126.96629213483146</c:v>
                </c:pt>
                <c:pt idx="48">
                  <c:v>127.11864406779658</c:v>
                </c:pt>
                <c:pt idx="49">
                  <c:v>127.19298245614038</c:v>
                </c:pt>
                <c:pt idx="50">
                  <c:v>127.86259541984739</c:v>
                </c:pt>
                <c:pt idx="51">
                  <c:v>129.8245614035088</c:v>
                </c:pt>
                <c:pt idx="52">
                  <c:v>129.87012987012989</c:v>
                </c:pt>
                <c:pt idx="53">
                  <c:v>130.15873015873015</c:v>
                </c:pt>
                <c:pt idx="54">
                  <c:v>130.58823529411768</c:v>
                </c:pt>
                <c:pt idx="55">
                  <c:v>131.25</c:v>
                </c:pt>
                <c:pt idx="56">
                  <c:v>133.33333333333331</c:v>
                </c:pt>
                <c:pt idx="57">
                  <c:v>133.73493975903611</c:v>
                </c:pt>
                <c:pt idx="58">
                  <c:v>134.21052631578948</c:v>
                </c:pt>
                <c:pt idx="59">
                  <c:v>135.36585365853665</c:v>
                </c:pt>
                <c:pt idx="60">
                  <c:v>137.20930232558149</c:v>
                </c:pt>
                <c:pt idx="61">
                  <c:v>137.49999999999997</c:v>
                </c:pt>
                <c:pt idx="62">
                  <c:v>137.70491803278682</c:v>
                </c:pt>
                <c:pt idx="63">
                  <c:v>137.83783783783778</c:v>
                </c:pt>
                <c:pt idx="64">
                  <c:v>139.08045977011491</c:v>
                </c:pt>
                <c:pt idx="65">
                  <c:v>140.32258064516125</c:v>
                </c:pt>
                <c:pt idx="66">
                  <c:v>140.69767441860463</c:v>
                </c:pt>
                <c:pt idx="67">
                  <c:v>140.99999999999994</c:v>
                </c:pt>
                <c:pt idx="68">
                  <c:v>141.13924050632906</c:v>
                </c:pt>
                <c:pt idx="69">
                  <c:v>141.37931034482759</c:v>
                </c:pt>
                <c:pt idx="70">
                  <c:v>143.58974358974356</c:v>
                </c:pt>
                <c:pt idx="71">
                  <c:v>143.99999999999997</c:v>
                </c:pt>
                <c:pt idx="72">
                  <c:v>146.55172413793105</c:v>
                </c:pt>
                <c:pt idx="73">
                  <c:v>147.5409836065574</c:v>
                </c:pt>
                <c:pt idx="74">
                  <c:v>148.18181818181819</c:v>
                </c:pt>
                <c:pt idx="75">
                  <c:v>148.83720930232556</c:v>
                </c:pt>
                <c:pt idx="76">
                  <c:v>149.01960784313724</c:v>
                </c:pt>
                <c:pt idx="77">
                  <c:v>149.05660377358495</c:v>
                </c:pt>
                <c:pt idx="78">
                  <c:v>149.99999999999991</c:v>
                </c:pt>
                <c:pt idx="79">
                  <c:v>150.57471264367814</c:v>
                </c:pt>
                <c:pt idx="80">
                  <c:v>151.24999999999997</c:v>
                </c:pt>
                <c:pt idx="81">
                  <c:v>151.7647058823529</c:v>
                </c:pt>
                <c:pt idx="82">
                  <c:v>152.00000000000003</c:v>
                </c:pt>
                <c:pt idx="83">
                  <c:v>153.19148936170222</c:v>
                </c:pt>
                <c:pt idx="84">
                  <c:v>154.92957746478868</c:v>
                </c:pt>
                <c:pt idx="85">
                  <c:v>156.75675675675672</c:v>
                </c:pt>
                <c:pt idx="86">
                  <c:v>156.92307692307691</c:v>
                </c:pt>
                <c:pt idx="87">
                  <c:v>158.53658536585365</c:v>
                </c:pt>
                <c:pt idx="88">
                  <c:v>166.29213483146069</c:v>
                </c:pt>
                <c:pt idx="89">
                  <c:v>167.70833333333329</c:v>
                </c:pt>
                <c:pt idx="90">
                  <c:v>171.42857142857142</c:v>
                </c:pt>
                <c:pt idx="91">
                  <c:v>179.99999999999994</c:v>
                </c:pt>
                <c:pt idx="92">
                  <c:v>180.85106382978719</c:v>
                </c:pt>
                <c:pt idx="93">
                  <c:v>183.72093023255817</c:v>
                </c:pt>
                <c:pt idx="94">
                  <c:v>190.24390243902431</c:v>
                </c:pt>
                <c:pt idx="95">
                  <c:v>292.8571428571426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337088"/>
        <c:axId val="183530560"/>
      </c:scatterChart>
      <c:valAx>
        <c:axId val="19933708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83530560"/>
        <c:crosses val="autoZero"/>
        <c:crossBetween val="midCat"/>
        <c:majorUnit val="50"/>
      </c:valAx>
      <c:valAx>
        <c:axId val="183530560"/>
        <c:scaling>
          <c:orientation val="minMax"/>
          <c:max val="20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 of contr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9337088"/>
        <c:crosses val="autoZero"/>
        <c:crossBetween val="midCat"/>
        <c:majorUnit val="40"/>
      </c:valAx>
    </c:plotArea>
    <c:legend>
      <c:legendPos val="r"/>
      <c:layout>
        <c:manualLayout>
          <c:xMode val="edge"/>
          <c:yMode val="edge"/>
          <c:x val="0.58990254815588317"/>
          <c:y val="0.64332640711577715"/>
          <c:w val="0.37272232337885935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08501214860282"/>
          <c:y val="5.1400554097404488E-2"/>
          <c:w val="0.72969631611943364"/>
          <c:h val="0.73444808982210552"/>
        </c:manualLayout>
      </c:layout>
      <c:scatterChart>
        <c:scatterStyle val="lineMarker"/>
        <c:varyColors val="0"/>
        <c:ser>
          <c:idx val="0"/>
          <c:order val="0"/>
          <c:tx>
            <c:strRef>
              <c:f>Ethanol!$I$1</c:f>
              <c:strCache>
                <c:ptCount val="1"/>
                <c:pt idx="0">
                  <c:v>Ethan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Ethanol!$B$2:$B$97</c:f>
              <c:strCache>
                <c:ptCount val="96"/>
                <c:pt idx="0">
                  <c:v>A3</c:v>
                </c:pt>
                <c:pt idx="1">
                  <c:v>E7</c:v>
                </c:pt>
                <c:pt idx="2">
                  <c:v>C3</c:v>
                </c:pt>
                <c:pt idx="3">
                  <c:v>E6</c:v>
                </c:pt>
                <c:pt idx="4">
                  <c:v>D3</c:v>
                </c:pt>
                <c:pt idx="5">
                  <c:v>B4</c:v>
                </c:pt>
                <c:pt idx="6">
                  <c:v>B3</c:v>
                </c:pt>
                <c:pt idx="7">
                  <c:v>E10</c:v>
                </c:pt>
                <c:pt idx="8">
                  <c:v>C6</c:v>
                </c:pt>
                <c:pt idx="9">
                  <c:v>G4</c:v>
                </c:pt>
                <c:pt idx="10">
                  <c:v>D4</c:v>
                </c:pt>
                <c:pt idx="11">
                  <c:v>F7</c:v>
                </c:pt>
                <c:pt idx="12">
                  <c:v>G1</c:v>
                </c:pt>
                <c:pt idx="13">
                  <c:v>D6</c:v>
                </c:pt>
                <c:pt idx="14">
                  <c:v>E11</c:v>
                </c:pt>
                <c:pt idx="15">
                  <c:v>C10</c:v>
                </c:pt>
                <c:pt idx="16">
                  <c:v>B10</c:v>
                </c:pt>
                <c:pt idx="17">
                  <c:v>D7</c:v>
                </c:pt>
                <c:pt idx="18">
                  <c:v>D1</c:v>
                </c:pt>
                <c:pt idx="19">
                  <c:v>B6</c:v>
                </c:pt>
                <c:pt idx="20">
                  <c:v>E4</c:v>
                </c:pt>
                <c:pt idx="21">
                  <c:v>A12</c:v>
                </c:pt>
                <c:pt idx="22">
                  <c:v>D9</c:v>
                </c:pt>
                <c:pt idx="23">
                  <c:v>G11</c:v>
                </c:pt>
                <c:pt idx="24">
                  <c:v>A2</c:v>
                </c:pt>
                <c:pt idx="25">
                  <c:v>D8</c:v>
                </c:pt>
                <c:pt idx="26">
                  <c:v>G5</c:v>
                </c:pt>
                <c:pt idx="27">
                  <c:v>A4</c:v>
                </c:pt>
                <c:pt idx="28">
                  <c:v>H8</c:v>
                </c:pt>
                <c:pt idx="29">
                  <c:v>C8</c:v>
                </c:pt>
                <c:pt idx="30">
                  <c:v>C11</c:v>
                </c:pt>
                <c:pt idx="31">
                  <c:v>F10</c:v>
                </c:pt>
                <c:pt idx="32">
                  <c:v>F1</c:v>
                </c:pt>
                <c:pt idx="33">
                  <c:v>F6</c:v>
                </c:pt>
                <c:pt idx="34">
                  <c:v>H6</c:v>
                </c:pt>
                <c:pt idx="35">
                  <c:v>C4</c:v>
                </c:pt>
                <c:pt idx="36">
                  <c:v>B9</c:v>
                </c:pt>
                <c:pt idx="37">
                  <c:v>E12</c:v>
                </c:pt>
                <c:pt idx="38">
                  <c:v>H11</c:v>
                </c:pt>
                <c:pt idx="39">
                  <c:v>H5</c:v>
                </c:pt>
                <c:pt idx="40">
                  <c:v>A9</c:v>
                </c:pt>
                <c:pt idx="41">
                  <c:v>G7</c:v>
                </c:pt>
                <c:pt idx="42">
                  <c:v>G2</c:v>
                </c:pt>
                <c:pt idx="43">
                  <c:v>D5</c:v>
                </c:pt>
                <c:pt idx="44">
                  <c:v>H1</c:v>
                </c:pt>
                <c:pt idx="45">
                  <c:v>D12</c:v>
                </c:pt>
                <c:pt idx="46">
                  <c:v>B12</c:v>
                </c:pt>
                <c:pt idx="47">
                  <c:v>H10</c:v>
                </c:pt>
                <c:pt idx="48">
                  <c:v>H3</c:v>
                </c:pt>
                <c:pt idx="49">
                  <c:v>A8</c:v>
                </c:pt>
                <c:pt idx="50">
                  <c:v>E8</c:v>
                </c:pt>
                <c:pt idx="51">
                  <c:v>C7</c:v>
                </c:pt>
                <c:pt idx="52">
                  <c:v>A11</c:v>
                </c:pt>
                <c:pt idx="53">
                  <c:v>A1</c:v>
                </c:pt>
                <c:pt idx="54">
                  <c:v>F4</c:v>
                </c:pt>
                <c:pt idx="55">
                  <c:v>B1</c:v>
                </c:pt>
                <c:pt idx="56">
                  <c:v>F3</c:v>
                </c:pt>
                <c:pt idx="57">
                  <c:v>G12</c:v>
                </c:pt>
                <c:pt idx="58">
                  <c:v>B7</c:v>
                </c:pt>
                <c:pt idx="59">
                  <c:v>E2</c:v>
                </c:pt>
                <c:pt idx="60">
                  <c:v>H12</c:v>
                </c:pt>
                <c:pt idx="61">
                  <c:v>F8</c:v>
                </c:pt>
                <c:pt idx="62">
                  <c:v>D11</c:v>
                </c:pt>
                <c:pt idx="63">
                  <c:v>A7</c:v>
                </c:pt>
                <c:pt idx="64">
                  <c:v>C1</c:v>
                </c:pt>
                <c:pt idx="65">
                  <c:v>H7</c:v>
                </c:pt>
                <c:pt idx="66">
                  <c:v>E1</c:v>
                </c:pt>
                <c:pt idx="67">
                  <c:v>E5</c:v>
                </c:pt>
                <c:pt idx="68">
                  <c:v>H9</c:v>
                </c:pt>
                <c:pt idx="69">
                  <c:v>C9</c:v>
                </c:pt>
                <c:pt idx="70">
                  <c:v>H2</c:v>
                </c:pt>
                <c:pt idx="71">
                  <c:v>D2</c:v>
                </c:pt>
                <c:pt idx="72">
                  <c:v>A5</c:v>
                </c:pt>
                <c:pt idx="73">
                  <c:v>H4</c:v>
                </c:pt>
                <c:pt idx="74">
                  <c:v>B11</c:v>
                </c:pt>
                <c:pt idx="75">
                  <c:v>F2</c:v>
                </c:pt>
                <c:pt idx="76">
                  <c:v>C5</c:v>
                </c:pt>
                <c:pt idx="77">
                  <c:v>F5</c:v>
                </c:pt>
                <c:pt idx="78">
                  <c:v>G6</c:v>
                </c:pt>
                <c:pt idx="79">
                  <c:v>C2</c:v>
                </c:pt>
                <c:pt idx="80">
                  <c:v>E3</c:v>
                </c:pt>
                <c:pt idx="81">
                  <c:v>F9</c:v>
                </c:pt>
                <c:pt idx="82">
                  <c:v>C12</c:v>
                </c:pt>
                <c:pt idx="83">
                  <c:v>B5</c:v>
                </c:pt>
                <c:pt idx="84">
                  <c:v>G3</c:v>
                </c:pt>
                <c:pt idx="85">
                  <c:v>D10</c:v>
                </c:pt>
                <c:pt idx="86">
                  <c:v>E9</c:v>
                </c:pt>
                <c:pt idx="87">
                  <c:v>G8</c:v>
                </c:pt>
                <c:pt idx="88">
                  <c:v>A10</c:v>
                </c:pt>
                <c:pt idx="89">
                  <c:v>B8</c:v>
                </c:pt>
                <c:pt idx="90">
                  <c:v>F11</c:v>
                </c:pt>
                <c:pt idx="91">
                  <c:v>A6</c:v>
                </c:pt>
                <c:pt idx="92">
                  <c:v>G10</c:v>
                </c:pt>
                <c:pt idx="93">
                  <c:v>B2</c:v>
                </c:pt>
                <c:pt idx="94">
                  <c:v>F12</c:v>
                </c:pt>
                <c:pt idx="95">
                  <c:v>G9</c:v>
                </c:pt>
              </c:strCache>
            </c:strRef>
          </c:xVal>
          <c:yVal>
            <c:numRef>
              <c:f>Ethanol!$I$2:$I$97</c:f>
              <c:numCache>
                <c:formatCode>General</c:formatCode>
                <c:ptCount val="96"/>
                <c:pt idx="0">
                  <c:v>0</c:v>
                </c:pt>
                <c:pt idx="1">
                  <c:v>8.5889570552147205</c:v>
                </c:pt>
                <c:pt idx="2">
                  <c:v>8.9108910891089135</c:v>
                </c:pt>
                <c:pt idx="3">
                  <c:v>11.111111111111112</c:v>
                </c:pt>
                <c:pt idx="4">
                  <c:v>11.194029850746269</c:v>
                </c:pt>
                <c:pt idx="5">
                  <c:v>12.195121951219512</c:v>
                </c:pt>
                <c:pt idx="6">
                  <c:v>12.295081967213136</c:v>
                </c:pt>
                <c:pt idx="7">
                  <c:v>12.499999999999988</c:v>
                </c:pt>
                <c:pt idx="8">
                  <c:v>12.568306010928957</c:v>
                </c:pt>
                <c:pt idx="9">
                  <c:v>13.227513227513221</c:v>
                </c:pt>
                <c:pt idx="10">
                  <c:v>13.461538461538433</c:v>
                </c:pt>
                <c:pt idx="11">
                  <c:v>13.636363636363635</c:v>
                </c:pt>
                <c:pt idx="12">
                  <c:v>13.636363636363638</c:v>
                </c:pt>
                <c:pt idx="13">
                  <c:v>14.393939393939384</c:v>
                </c:pt>
                <c:pt idx="14">
                  <c:v>14.583333333333334</c:v>
                </c:pt>
                <c:pt idx="15">
                  <c:v>14.942528735632193</c:v>
                </c:pt>
                <c:pt idx="16">
                  <c:v>15.037593984962399</c:v>
                </c:pt>
                <c:pt idx="17">
                  <c:v>15.151515151515147</c:v>
                </c:pt>
                <c:pt idx="18">
                  <c:v>15.217391304347828</c:v>
                </c:pt>
                <c:pt idx="19">
                  <c:v>15.52795031055901</c:v>
                </c:pt>
                <c:pt idx="20">
                  <c:v>15.702479338842959</c:v>
                </c:pt>
                <c:pt idx="21">
                  <c:v>16.279069767441847</c:v>
                </c:pt>
                <c:pt idx="22">
                  <c:v>16.774193548387093</c:v>
                </c:pt>
                <c:pt idx="23">
                  <c:v>17.197452229299362</c:v>
                </c:pt>
                <c:pt idx="24">
                  <c:v>17.532467532467532</c:v>
                </c:pt>
                <c:pt idx="25">
                  <c:v>17.948717948717949</c:v>
                </c:pt>
                <c:pt idx="26">
                  <c:v>18.404907975460123</c:v>
                </c:pt>
                <c:pt idx="27">
                  <c:v>18.791946308724839</c:v>
                </c:pt>
                <c:pt idx="28">
                  <c:v>18.823529411764699</c:v>
                </c:pt>
                <c:pt idx="29">
                  <c:v>18.840579710144915</c:v>
                </c:pt>
                <c:pt idx="30">
                  <c:v>19.298245614035075</c:v>
                </c:pt>
                <c:pt idx="31">
                  <c:v>19.31818181818182</c:v>
                </c:pt>
                <c:pt idx="32">
                  <c:v>19.727891156462597</c:v>
                </c:pt>
                <c:pt idx="33">
                  <c:v>19.999999999999996</c:v>
                </c:pt>
                <c:pt idx="34">
                  <c:v>20.000000000000011</c:v>
                </c:pt>
                <c:pt idx="35">
                  <c:v>20.000000000000011</c:v>
                </c:pt>
                <c:pt idx="36">
                  <c:v>20.666666666666668</c:v>
                </c:pt>
                <c:pt idx="37">
                  <c:v>21.088435374149668</c:v>
                </c:pt>
                <c:pt idx="38">
                  <c:v>21.229050279329606</c:v>
                </c:pt>
                <c:pt idx="39">
                  <c:v>21.51898734177216</c:v>
                </c:pt>
                <c:pt idx="40">
                  <c:v>21.621621621621621</c:v>
                </c:pt>
                <c:pt idx="41">
                  <c:v>21.794871794871796</c:v>
                </c:pt>
                <c:pt idx="42">
                  <c:v>22.619047619047613</c:v>
                </c:pt>
                <c:pt idx="43">
                  <c:v>22.695035460992923</c:v>
                </c:pt>
                <c:pt idx="44">
                  <c:v>22.699386503067476</c:v>
                </c:pt>
                <c:pt idx="45">
                  <c:v>23.076923076923077</c:v>
                </c:pt>
                <c:pt idx="46">
                  <c:v>23.076923076923094</c:v>
                </c:pt>
                <c:pt idx="47">
                  <c:v>23.809523809523807</c:v>
                </c:pt>
                <c:pt idx="48">
                  <c:v>24.031007751937974</c:v>
                </c:pt>
                <c:pt idx="49">
                  <c:v>24.242424242424221</c:v>
                </c:pt>
                <c:pt idx="50">
                  <c:v>24.409448818897648</c:v>
                </c:pt>
                <c:pt idx="51">
                  <c:v>25.510204081632637</c:v>
                </c:pt>
                <c:pt idx="52">
                  <c:v>25.531914893617021</c:v>
                </c:pt>
                <c:pt idx="53">
                  <c:v>27.302631578947391</c:v>
                </c:pt>
                <c:pt idx="54">
                  <c:v>27.485380116959057</c:v>
                </c:pt>
                <c:pt idx="55">
                  <c:v>27.83505154639176</c:v>
                </c:pt>
                <c:pt idx="56">
                  <c:v>27.857142857142868</c:v>
                </c:pt>
                <c:pt idx="57">
                  <c:v>28.750000000000004</c:v>
                </c:pt>
                <c:pt idx="58">
                  <c:v>29.032258064516132</c:v>
                </c:pt>
                <c:pt idx="59">
                  <c:v>29.078014184397162</c:v>
                </c:pt>
                <c:pt idx="60">
                  <c:v>29.255319148936181</c:v>
                </c:pt>
                <c:pt idx="61">
                  <c:v>29.873417721518987</c:v>
                </c:pt>
                <c:pt idx="62">
                  <c:v>30.000000000000004</c:v>
                </c:pt>
                <c:pt idx="63">
                  <c:v>30.666666666666632</c:v>
                </c:pt>
                <c:pt idx="64">
                  <c:v>30.769230769230759</c:v>
                </c:pt>
                <c:pt idx="65">
                  <c:v>30.927835051546381</c:v>
                </c:pt>
                <c:pt idx="66">
                  <c:v>31.623931623931611</c:v>
                </c:pt>
                <c:pt idx="67">
                  <c:v>31.782945736434097</c:v>
                </c:pt>
                <c:pt idx="68">
                  <c:v>32.000000000000007</c:v>
                </c:pt>
                <c:pt idx="69">
                  <c:v>32.575757575757549</c:v>
                </c:pt>
                <c:pt idx="70">
                  <c:v>33.834586466165405</c:v>
                </c:pt>
                <c:pt idx="71">
                  <c:v>34.188034188034202</c:v>
                </c:pt>
                <c:pt idx="72">
                  <c:v>34.420289855072419</c:v>
                </c:pt>
                <c:pt idx="73">
                  <c:v>35.000000000000021</c:v>
                </c:pt>
                <c:pt idx="74">
                  <c:v>35.714285714285715</c:v>
                </c:pt>
                <c:pt idx="75">
                  <c:v>35.810810810810821</c:v>
                </c:pt>
                <c:pt idx="76">
                  <c:v>37.301587301587297</c:v>
                </c:pt>
                <c:pt idx="77">
                  <c:v>37.398373983739852</c:v>
                </c:pt>
                <c:pt idx="78">
                  <c:v>37.499999999999993</c:v>
                </c:pt>
                <c:pt idx="79">
                  <c:v>37.727272727272712</c:v>
                </c:pt>
                <c:pt idx="80">
                  <c:v>38.053097345132748</c:v>
                </c:pt>
                <c:pt idx="81">
                  <c:v>40.804597701149405</c:v>
                </c:pt>
                <c:pt idx="82">
                  <c:v>41.454545454545425</c:v>
                </c:pt>
                <c:pt idx="83">
                  <c:v>44.186046511627872</c:v>
                </c:pt>
                <c:pt idx="84">
                  <c:v>44.202898550724626</c:v>
                </c:pt>
                <c:pt idx="85">
                  <c:v>46.913580246913547</c:v>
                </c:pt>
                <c:pt idx="86">
                  <c:v>54.887218045112775</c:v>
                </c:pt>
                <c:pt idx="87">
                  <c:v>55.963302752293572</c:v>
                </c:pt>
                <c:pt idx="88">
                  <c:v>59.493670886075975</c:v>
                </c:pt>
                <c:pt idx="89">
                  <c:v>61.194029850746233</c:v>
                </c:pt>
                <c:pt idx="90">
                  <c:v>72.619047619047606</c:v>
                </c:pt>
                <c:pt idx="91">
                  <c:v>78.846153846153896</c:v>
                </c:pt>
                <c:pt idx="92">
                  <c:v>90.909090909090892</c:v>
                </c:pt>
                <c:pt idx="93">
                  <c:v>110.76923076923076</c:v>
                </c:pt>
                <c:pt idx="94">
                  <c:v>129.78723404255317</c:v>
                </c:pt>
                <c:pt idx="95">
                  <c:v>143.661971830985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482112"/>
        <c:axId val="194482688"/>
      </c:scatterChart>
      <c:valAx>
        <c:axId val="19448211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4482688"/>
        <c:crosses val="autoZero"/>
        <c:crossBetween val="midCat"/>
        <c:majorUnit val="50"/>
      </c:valAx>
      <c:valAx>
        <c:axId val="194482688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 of contr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4482112"/>
        <c:crosses val="autoZero"/>
        <c:crossBetween val="midCat"/>
        <c:majorUnit val="50"/>
      </c:valAx>
    </c:plotArea>
    <c:legend>
      <c:legendPos val="r"/>
      <c:layout>
        <c:manualLayout>
          <c:xMode val="edge"/>
          <c:yMode val="edge"/>
          <c:x val="0.82597309711286104"/>
          <c:y val="0.64332640711577715"/>
          <c:w val="0.13665201224846893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80884481354616"/>
          <c:y val="5.1400554097404488E-2"/>
          <c:w val="0.72998600483319542"/>
          <c:h val="0.73444808982210552"/>
        </c:manualLayout>
      </c:layout>
      <c:scatterChart>
        <c:scatterStyle val="lineMarker"/>
        <c:varyColors val="0"/>
        <c:ser>
          <c:idx val="0"/>
          <c:order val="0"/>
          <c:tx>
            <c:strRef>
              <c:f>'T35'!$J$1</c:f>
              <c:strCache>
                <c:ptCount val="1"/>
                <c:pt idx="0">
                  <c:v>T (35'C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T35'!$B$2:$B$97</c:f>
              <c:strCache>
                <c:ptCount val="96"/>
                <c:pt idx="0">
                  <c:v>A7</c:v>
                </c:pt>
                <c:pt idx="1">
                  <c:v>A6</c:v>
                </c:pt>
                <c:pt idx="2">
                  <c:v>B4</c:v>
                </c:pt>
                <c:pt idx="3">
                  <c:v>H1</c:v>
                </c:pt>
                <c:pt idx="4">
                  <c:v>C6</c:v>
                </c:pt>
                <c:pt idx="5">
                  <c:v>G4</c:v>
                </c:pt>
                <c:pt idx="6">
                  <c:v>G2</c:v>
                </c:pt>
                <c:pt idx="7">
                  <c:v>H8</c:v>
                </c:pt>
                <c:pt idx="8">
                  <c:v>G1</c:v>
                </c:pt>
                <c:pt idx="9">
                  <c:v>A5</c:v>
                </c:pt>
                <c:pt idx="10">
                  <c:v>G12</c:v>
                </c:pt>
                <c:pt idx="11">
                  <c:v>G5</c:v>
                </c:pt>
                <c:pt idx="12">
                  <c:v>C10</c:v>
                </c:pt>
                <c:pt idx="13">
                  <c:v>D9</c:v>
                </c:pt>
                <c:pt idx="14">
                  <c:v>B12</c:v>
                </c:pt>
                <c:pt idx="15">
                  <c:v>G11</c:v>
                </c:pt>
                <c:pt idx="16">
                  <c:v>F6</c:v>
                </c:pt>
                <c:pt idx="17">
                  <c:v>A2</c:v>
                </c:pt>
                <c:pt idx="18">
                  <c:v>A12</c:v>
                </c:pt>
                <c:pt idx="19">
                  <c:v>H5</c:v>
                </c:pt>
                <c:pt idx="20">
                  <c:v>E7</c:v>
                </c:pt>
                <c:pt idx="21">
                  <c:v>F2</c:v>
                </c:pt>
                <c:pt idx="22">
                  <c:v>H11</c:v>
                </c:pt>
                <c:pt idx="23">
                  <c:v>F10</c:v>
                </c:pt>
                <c:pt idx="24">
                  <c:v>F4</c:v>
                </c:pt>
                <c:pt idx="25">
                  <c:v>G3</c:v>
                </c:pt>
                <c:pt idx="26">
                  <c:v>F3</c:v>
                </c:pt>
                <c:pt idx="27">
                  <c:v>E8</c:v>
                </c:pt>
                <c:pt idx="28">
                  <c:v>A1</c:v>
                </c:pt>
                <c:pt idx="29">
                  <c:v>G6</c:v>
                </c:pt>
                <c:pt idx="30">
                  <c:v>F1</c:v>
                </c:pt>
                <c:pt idx="31">
                  <c:v>B9</c:v>
                </c:pt>
                <c:pt idx="32">
                  <c:v>G7</c:v>
                </c:pt>
                <c:pt idx="33">
                  <c:v>H12</c:v>
                </c:pt>
                <c:pt idx="34">
                  <c:v>E9</c:v>
                </c:pt>
                <c:pt idx="35">
                  <c:v>H9</c:v>
                </c:pt>
                <c:pt idx="36">
                  <c:v>E11</c:v>
                </c:pt>
                <c:pt idx="37">
                  <c:v>E10</c:v>
                </c:pt>
                <c:pt idx="38">
                  <c:v>F7</c:v>
                </c:pt>
                <c:pt idx="39">
                  <c:v>D3</c:v>
                </c:pt>
                <c:pt idx="40">
                  <c:v>A4</c:v>
                </c:pt>
                <c:pt idx="41">
                  <c:v>F5</c:v>
                </c:pt>
                <c:pt idx="42">
                  <c:v>E2</c:v>
                </c:pt>
                <c:pt idx="43">
                  <c:v>A11</c:v>
                </c:pt>
                <c:pt idx="44">
                  <c:v>D8</c:v>
                </c:pt>
                <c:pt idx="45">
                  <c:v>C9</c:v>
                </c:pt>
                <c:pt idx="46">
                  <c:v>B6</c:v>
                </c:pt>
                <c:pt idx="47">
                  <c:v>C8</c:v>
                </c:pt>
                <c:pt idx="48">
                  <c:v>E12</c:v>
                </c:pt>
                <c:pt idx="49">
                  <c:v>D6</c:v>
                </c:pt>
                <c:pt idx="50">
                  <c:v>D1</c:v>
                </c:pt>
                <c:pt idx="51">
                  <c:v>D2</c:v>
                </c:pt>
                <c:pt idx="52">
                  <c:v>F8</c:v>
                </c:pt>
                <c:pt idx="53">
                  <c:v>D5</c:v>
                </c:pt>
                <c:pt idx="54">
                  <c:v>H3</c:v>
                </c:pt>
                <c:pt idx="55">
                  <c:v>B3</c:v>
                </c:pt>
                <c:pt idx="56">
                  <c:v>H6</c:v>
                </c:pt>
                <c:pt idx="57">
                  <c:v>E1</c:v>
                </c:pt>
                <c:pt idx="58">
                  <c:v>E5</c:v>
                </c:pt>
                <c:pt idx="59">
                  <c:v>H2</c:v>
                </c:pt>
                <c:pt idx="60">
                  <c:v>F9</c:v>
                </c:pt>
                <c:pt idx="61">
                  <c:v>D12</c:v>
                </c:pt>
                <c:pt idx="62">
                  <c:v>E6</c:v>
                </c:pt>
                <c:pt idx="63">
                  <c:v>D7</c:v>
                </c:pt>
                <c:pt idx="64">
                  <c:v>H10</c:v>
                </c:pt>
                <c:pt idx="65">
                  <c:v>E4</c:v>
                </c:pt>
                <c:pt idx="66">
                  <c:v>A9</c:v>
                </c:pt>
                <c:pt idx="67">
                  <c:v>C5</c:v>
                </c:pt>
                <c:pt idx="68">
                  <c:v>F12</c:v>
                </c:pt>
                <c:pt idx="69">
                  <c:v>B10</c:v>
                </c:pt>
                <c:pt idx="70">
                  <c:v>E3</c:v>
                </c:pt>
                <c:pt idx="71">
                  <c:v>C7</c:v>
                </c:pt>
                <c:pt idx="72">
                  <c:v>C11</c:v>
                </c:pt>
                <c:pt idx="73">
                  <c:v>G8</c:v>
                </c:pt>
                <c:pt idx="74">
                  <c:v>C3</c:v>
                </c:pt>
                <c:pt idx="75">
                  <c:v>A10</c:v>
                </c:pt>
                <c:pt idx="76">
                  <c:v>H7</c:v>
                </c:pt>
                <c:pt idx="77">
                  <c:v>C1</c:v>
                </c:pt>
                <c:pt idx="78">
                  <c:v>A3</c:v>
                </c:pt>
                <c:pt idx="79">
                  <c:v>B7</c:v>
                </c:pt>
                <c:pt idx="80">
                  <c:v>D4</c:v>
                </c:pt>
                <c:pt idx="81">
                  <c:v>F11</c:v>
                </c:pt>
                <c:pt idx="82">
                  <c:v>H4</c:v>
                </c:pt>
                <c:pt idx="83">
                  <c:v>B1</c:v>
                </c:pt>
                <c:pt idx="84">
                  <c:v>D11</c:v>
                </c:pt>
                <c:pt idx="85">
                  <c:v>G10</c:v>
                </c:pt>
                <c:pt idx="86">
                  <c:v>B5</c:v>
                </c:pt>
                <c:pt idx="87">
                  <c:v>B11</c:v>
                </c:pt>
                <c:pt idx="88">
                  <c:v>C12</c:v>
                </c:pt>
                <c:pt idx="89">
                  <c:v>B2</c:v>
                </c:pt>
                <c:pt idx="90">
                  <c:v>D10</c:v>
                </c:pt>
                <c:pt idx="91">
                  <c:v>A8</c:v>
                </c:pt>
                <c:pt idx="92">
                  <c:v>B8</c:v>
                </c:pt>
                <c:pt idx="93">
                  <c:v>C4</c:v>
                </c:pt>
                <c:pt idx="94">
                  <c:v>C2</c:v>
                </c:pt>
                <c:pt idx="95">
                  <c:v>G9</c:v>
                </c:pt>
              </c:strCache>
            </c:strRef>
          </c:xVal>
          <c:yVal>
            <c:numRef>
              <c:f>'T35'!$J$2:$J$97</c:f>
              <c:numCache>
                <c:formatCode>General</c:formatCode>
                <c:ptCount val="96"/>
                <c:pt idx="0">
                  <c:v>29.333333333333371</c:v>
                </c:pt>
                <c:pt idx="1">
                  <c:v>46.153846153846168</c:v>
                </c:pt>
                <c:pt idx="2">
                  <c:v>51.219512195121951</c:v>
                </c:pt>
                <c:pt idx="3">
                  <c:v>57.668711656441729</c:v>
                </c:pt>
                <c:pt idx="4">
                  <c:v>62.841530054644792</c:v>
                </c:pt>
                <c:pt idx="5">
                  <c:v>66.137566137566154</c:v>
                </c:pt>
                <c:pt idx="6">
                  <c:v>69.047619047619051</c:v>
                </c:pt>
                <c:pt idx="7">
                  <c:v>69.411764705882334</c:v>
                </c:pt>
                <c:pt idx="8">
                  <c:v>69.88636363636364</c:v>
                </c:pt>
                <c:pt idx="9">
                  <c:v>73.188405797101481</c:v>
                </c:pt>
                <c:pt idx="10">
                  <c:v>74.374999999999986</c:v>
                </c:pt>
                <c:pt idx="11">
                  <c:v>76.073619631901863</c:v>
                </c:pt>
                <c:pt idx="12">
                  <c:v>76.436781609195421</c:v>
                </c:pt>
                <c:pt idx="13">
                  <c:v>77.41935483870968</c:v>
                </c:pt>
                <c:pt idx="14">
                  <c:v>80.128205128205138</c:v>
                </c:pt>
                <c:pt idx="15">
                  <c:v>80.25477707006371</c:v>
                </c:pt>
                <c:pt idx="16">
                  <c:v>80.952380952380921</c:v>
                </c:pt>
                <c:pt idx="17">
                  <c:v>81.168831168831176</c:v>
                </c:pt>
                <c:pt idx="18">
                  <c:v>82.170542635658904</c:v>
                </c:pt>
                <c:pt idx="19">
                  <c:v>82.278481012658233</c:v>
                </c:pt>
                <c:pt idx="20">
                  <c:v>82.822085889570531</c:v>
                </c:pt>
                <c:pt idx="21">
                  <c:v>83.108108108108112</c:v>
                </c:pt>
                <c:pt idx="22">
                  <c:v>83.24022346368713</c:v>
                </c:pt>
                <c:pt idx="23">
                  <c:v>84.659090909090892</c:v>
                </c:pt>
                <c:pt idx="24">
                  <c:v>84.795321637426895</c:v>
                </c:pt>
                <c:pt idx="25">
                  <c:v>86.231884057971001</c:v>
                </c:pt>
                <c:pt idx="26">
                  <c:v>87.142857142857139</c:v>
                </c:pt>
                <c:pt idx="27">
                  <c:v>88.188976377952756</c:v>
                </c:pt>
                <c:pt idx="28">
                  <c:v>88.81578947368422</c:v>
                </c:pt>
                <c:pt idx="29">
                  <c:v>88.888888888888872</c:v>
                </c:pt>
                <c:pt idx="30">
                  <c:v>89.115646258503403</c:v>
                </c:pt>
                <c:pt idx="31">
                  <c:v>89.333333333333329</c:v>
                </c:pt>
                <c:pt idx="32">
                  <c:v>89.743589743589723</c:v>
                </c:pt>
                <c:pt idx="33">
                  <c:v>89.893617021276611</c:v>
                </c:pt>
                <c:pt idx="34">
                  <c:v>90.225563909774436</c:v>
                </c:pt>
                <c:pt idx="35">
                  <c:v>90.857142857142861</c:v>
                </c:pt>
                <c:pt idx="36">
                  <c:v>91.666666666666643</c:v>
                </c:pt>
                <c:pt idx="37">
                  <c:v>92.187500000000014</c:v>
                </c:pt>
                <c:pt idx="38">
                  <c:v>92.424242424242422</c:v>
                </c:pt>
                <c:pt idx="39">
                  <c:v>92.537313432835845</c:v>
                </c:pt>
                <c:pt idx="40">
                  <c:v>92.617449664429557</c:v>
                </c:pt>
                <c:pt idx="41">
                  <c:v>92.682926829268311</c:v>
                </c:pt>
                <c:pt idx="42">
                  <c:v>93.61702127659575</c:v>
                </c:pt>
                <c:pt idx="43">
                  <c:v>94.326241134751783</c:v>
                </c:pt>
                <c:pt idx="44">
                  <c:v>94.871794871794862</c:v>
                </c:pt>
                <c:pt idx="45">
                  <c:v>96.212121212121204</c:v>
                </c:pt>
                <c:pt idx="46">
                  <c:v>96.894409937888199</c:v>
                </c:pt>
                <c:pt idx="47">
                  <c:v>97.101449275362356</c:v>
                </c:pt>
                <c:pt idx="48">
                  <c:v>97.278911564625872</c:v>
                </c:pt>
                <c:pt idx="49">
                  <c:v>97.727272727272734</c:v>
                </c:pt>
                <c:pt idx="50">
                  <c:v>97.826086956521735</c:v>
                </c:pt>
                <c:pt idx="51">
                  <c:v>98.290598290598297</c:v>
                </c:pt>
                <c:pt idx="52">
                  <c:v>98.481012658227812</c:v>
                </c:pt>
                <c:pt idx="53">
                  <c:v>100.00000000000003</c:v>
                </c:pt>
                <c:pt idx="54">
                  <c:v>100.00000000000003</c:v>
                </c:pt>
                <c:pt idx="55">
                  <c:v>100.00000000000004</c:v>
                </c:pt>
                <c:pt idx="56">
                  <c:v>100.68965517241378</c:v>
                </c:pt>
                <c:pt idx="57">
                  <c:v>103.41880341880341</c:v>
                </c:pt>
                <c:pt idx="58">
                  <c:v>104.65116279069768</c:v>
                </c:pt>
                <c:pt idx="59">
                  <c:v>106.01503759398494</c:v>
                </c:pt>
                <c:pt idx="60">
                  <c:v>106.3218390804598</c:v>
                </c:pt>
                <c:pt idx="61">
                  <c:v>111.1111111111111</c:v>
                </c:pt>
                <c:pt idx="62">
                  <c:v>113.8888888888889</c:v>
                </c:pt>
                <c:pt idx="63">
                  <c:v>114.39393939393942</c:v>
                </c:pt>
                <c:pt idx="64">
                  <c:v>115.87301587301589</c:v>
                </c:pt>
                <c:pt idx="65">
                  <c:v>116.52892561983472</c:v>
                </c:pt>
                <c:pt idx="66">
                  <c:v>118.01801801801801</c:v>
                </c:pt>
                <c:pt idx="67">
                  <c:v>118.25396825396825</c:v>
                </c:pt>
                <c:pt idx="68">
                  <c:v>119.14893617021272</c:v>
                </c:pt>
                <c:pt idx="69">
                  <c:v>121.05263157894737</c:v>
                </c:pt>
                <c:pt idx="70">
                  <c:v>123.89380530973446</c:v>
                </c:pt>
                <c:pt idx="71">
                  <c:v>127.55102040816327</c:v>
                </c:pt>
                <c:pt idx="72">
                  <c:v>128.07017543859652</c:v>
                </c:pt>
                <c:pt idx="73">
                  <c:v>129.35779816513767</c:v>
                </c:pt>
                <c:pt idx="74">
                  <c:v>130.69306930693077</c:v>
                </c:pt>
                <c:pt idx="75">
                  <c:v>131.64556962025318</c:v>
                </c:pt>
                <c:pt idx="76">
                  <c:v>131.95876288659792</c:v>
                </c:pt>
                <c:pt idx="77">
                  <c:v>132.96703296703299</c:v>
                </c:pt>
                <c:pt idx="78">
                  <c:v>133.33333333333334</c:v>
                </c:pt>
                <c:pt idx="79">
                  <c:v>133.33333333333337</c:v>
                </c:pt>
                <c:pt idx="80">
                  <c:v>135.57692307692301</c:v>
                </c:pt>
                <c:pt idx="81">
                  <c:v>136.90476190476193</c:v>
                </c:pt>
                <c:pt idx="82">
                  <c:v>140</c:v>
                </c:pt>
                <c:pt idx="83">
                  <c:v>140.20618556701035</c:v>
                </c:pt>
                <c:pt idx="84">
                  <c:v>143.00000000000003</c:v>
                </c:pt>
                <c:pt idx="85">
                  <c:v>144.31818181818176</c:v>
                </c:pt>
                <c:pt idx="86">
                  <c:v>150</c:v>
                </c:pt>
                <c:pt idx="87">
                  <c:v>154.76190476190476</c:v>
                </c:pt>
                <c:pt idx="88">
                  <c:v>158.18181818181819</c:v>
                </c:pt>
                <c:pt idx="89">
                  <c:v>163.07692307692312</c:v>
                </c:pt>
                <c:pt idx="90">
                  <c:v>166.66666666666669</c:v>
                </c:pt>
                <c:pt idx="91">
                  <c:v>178.78787878787875</c:v>
                </c:pt>
                <c:pt idx="92">
                  <c:v>180.59701492537314</c:v>
                </c:pt>
                <c:pt idx="93">
                  <c:v>194.28571428571419</c:v>
                </c:pt>
                <c:pt idx="94">
                  <c:v>198.18181818181796</c:v>
                </c:pt>
                <c:pt idx="95">
                  <c:v>205.6338028169014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338816"/>
        <c:axId val="199339392"/>
      </c:scatterChart>
      <c:valAx>
        <c:axId val="19933881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99339392"/>
        <c:crosses val="autoZero"/>
        <c:crossBetween val="midCat"/>
        <c:majorUnit val="50"/>
      </c:valAx>
      <c:valAx>
        <c:axId val="199339392"/>
        <c:scaling>
          <c:orientation val="minMax"/>
          <c:max val="2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 of contr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9338816"/>
        <c:crosses val="autoZero"/>
        <c:crossBetween val="midCat"/>
        <c:majorUnit val="50"/>
      </c:valAx>
    </c:plotArea>
    <c:legend>
      <c:legendPos val="r"/>
      <c:layout>
        <c:manualLayout>
          <c:xMode val="edge"/>
          <c:yMode val="edge"/>
          <c:x val="0.70036290176349003"/>
          <c:y val="0.64332640711577715"/>
          <c:w val="0.26226225524942387"/>
          <c:h val="8.3717191601049873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307795606273064"/>
          <c:y val="2.6251148246400808E-2"/>
          <c:w val="0.71153961936855781"/>
          <c:h val="0.8481865836045317"/>
        </c:manualLayout>
      </c:layout>
      <c:scatterChart>
        <c:scatterStyle val="lineMarker"/>
        <c:varyColors val="0"/>
        <c:ser>
          <c:idx val="4"/>
          <c:order val="0"/>
          <c:tx>
            <c:strRef>
              <c:f>Vanillin!$G$1</c:f>
              <c:strCache>
                <c:ptCount val="1"/>
                <c:pt idx="0">
                  <c:v>Vanillin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Vanillin!$B$2:$B$97</c:f>
              <c:strCache>
                <c:ptCount val="96"/>
                <c:pt idx="0">
                  <c:v>G9</c:v>
                </c:pt>
                <c:pt idx="1">
                  <c:v>C3</c:v>
                </c:pt>
                <c:pt idx="2">
                  <c:v>F12</c:v>
                </c:pt>
                <c:pt idx="3">
                  <c:v>B12</c:v>
                </c:pt>
                <c:pt idx="4">
                  <c:v>F6</c:v>
                </c:pt>
                <c:pt idx="5">
                  <c:v>C9</c:v>
                </c:pt>
                <c:pt idx="6">
                  <c:v>H2</c:v>
                </c:pt>
                <c:pt idx="7">
                  <c:v>C2</c:v>
                </c:pt>
                <c:pt idx="8">
                  <c:v>H5</c:v>
                </c:pt>
                <c:pt idx="9">
                  <c:v>E2</c:v>
                </c:pt>
                <c:pt idx="10">
                  <c:v>D9</c:v>
                </c:pt>
                <c:pt idx="11">
                  <c:v>A5</c:v>
                </c:pt>
                <c:pt idx="12">
                  <c:v>F11</c:v>
                </c:pt>
                <c:pt idx="13">
                  <c:v>A12</c:v>
                </c:pt>
                <c:pt idx="14">
                  <c:v>H6</c:v>
                </c:pt>
                <c:pt idx="15">
                  <c:v>F8</c:v>
                </c:pt>
                <c:pt idx="16">
                  <c:v>B4</c:v>
                </c:pt>
                <c:pt idx="17">
                  <c:v>B5</c:v>
                </c:pt>
                <c:pt idx="18">
                  <c:v>H12</c:v>
                </c:pt>
                <c:pt idx="19">
                  <c:v>A2</c:v>
                </c:pt>
                <c:pt idx="20">
                  <c:v>F4</c:v>
                </c:pt>
                <c:pt idx="21">
                  <c:v>A6</c:v>
                </c:pt>
                <c:pt idx="22">
                  <c:v>G12</c:v>
                </c:pt>
                <c:pt idx="23">
                  <c:v>B3</c:v>
                </c:pt>
                <c:pt idx="24">
                  <c:v>A4</c:v>
                </c:pt>
                <c:pt idx="25">
                  <c:v>G1</c:v>
                </c:pt>
                <c:pt idx="26">
                  <c:v>F2</c:v>
                </c:pt>
                <c:pt idx="27">
                  <c:v>G8</c:v>
                </c:pt>
                <c:pt idx="28">
                  <c:v>B8</c:v>
                </c:pt>
                <c:pt idx="29">
                  <c:v>D11</c:v>
                </c:pt>
                <c:pt idx="30">
                  <c:v>F10</c:v>
                </c:pt>
                <c:pt idx="31">
                  <c:v>B2</c:v>
                </c:pt>
                <c:pt idx="32">
                  <c:v>H9</c:v>
                </c:pt>
                <c:pt idx="33">
                  <c:v>A11</c:v>
                </c:pt>
                <c:pt idx="34">
                  <c:v>H8</c:v>
                </c:pt>
                <c:pt idx="35">
                  <c:v>D6</c:v>
                </c:pt>
                <c:pt idx="36">
                  <c:v>E9</c:v>
                </c:pt>
                <c:pt idx="37">
                  <c:v>G4</c:v>
                </c:pt>
                <c:pt idx="38">
                  <c:v>H1</c:v>
                </c:pt>
                <c:pt idx="39">
                  <c:v>G5</c:v>
                </c:pt>
                <c:pt idx="40">
                  <c:v>H10</c:v>
                </c:pt>
                <c:pt idx="41">
                  <c:v>D8</c:v>
                </c:pt>
                <c:pt idx="42">
                  <c:v>E5</c:v>
                </c:pt>
                <c:pt idx="43">
                  <c:v>C11</c:v>
                </c:pt>
                <c:pt idx="44">
                  <c:v>A7</c:v>
                </c:pt>
                <c:pt idx="45">
                  <c:v>D3</c:v>
                </c:pt>
                <c:pt idx="46">
                  <c:v>E3</c:v>
                </c:pt>
                <c:pt idx="47">
                  <c:v>C1</c:v>
                </c:pt>
                <c:pt idx="48">
                  <c:v>C6</c:v>
                </c:pt>
                <c:pt idx="49">
                  <c:v>H7</c:v>
                </c:pt>
                <c:pt idx="50">
                  <c:v>G7</c:v>
                </c:pt>
                <c:pt idx="51">
                  <c:v>E1</c:v>
                </c:pt>
                <c:pt idx="52">
                  <c:v>G10</c:v>
                </c:pt>
                <c:pt idx="53">
                  <c:v>C7</c:v>
                </c:pt>
                <c:pt idx="54">
                  <c:v>H11</c:v>
                </c:pt>
                <c:pt idx="55">
                  <c:v>G2</c:v>
                </c:pt>
                <c:pt idx="56">
                  <c:v>E8</c:v>
                </c:pt>
                <c:pt idx="57">
                  <c:v>E11</c:v>
                </c:pt>
                <c:pt idx="58">
                  <c:v>A9</c:v>
                </c:pt>
                <c:pt idx="59">
                  <c:v>B11</c:v>
                </c:pt>
                <c:pt idx="60">
                  <c:v>F3</c:v>
                </c:pt>
                <c:pt idx="61">
                  <c:v>B7</c:v>
                </c:pt>
                <c:pt idx="62">
                  <c:v>B6</c:v>
                </c:pt>
                <c:pt idx="63">
                  <c:v>D12</c:v>
                </c:pt>
                <c:pt idx="64">
                  <c:v>G11</c:v>
                </c:pt>
                <c:pt idx="65">
                  <c:v>F5</c:v>
                </c:pt>
                <c:pt idx="66">
                  <c:v>G3</c:v>
                </c:pt>
                <c:pt idx="67">
                  <c:v>G6</c:v>
                </c:pt>
                <c:pt idx="68">
                  <c:v>D5</c:v>
                </c:pt>
                <c:pt idx="69">
                  <c:v>D1</c:v>
                </c:pt>
                <c:pt idx="70">
                  <c:v>A8</c:v>
                </c:pt>
                <c:pt idx="71">
                  <c:v>E4</c:v>
                </c:pt>
                <c:pt idx="72">
                  <c:v>C12</c:v>
                </c:pt>
                <c:pt idx="73">
                  <c:v>B9</c:v>
                </c:pt>
                <c:pt idx="74">
                  <c:v>E7</c:v>
                </c:pt>
                <c:pt idx="75">
                  <c:v>E6</c:v>
                </c:pt>
                <c:pt idx="76">
                  <c:v>A3</c:v>
                </c:pt>
                <c:pt idx="77">
                  <c:v>H3</c:v>
                </c:pt>
                <c:pt idx="78">
                  <c:v>F1</c:v>
                </c:pt>
                <c:pt idx="79">
                  <c:v>C8</c:v>
                </c:pt>
                <c:pt idx="80">
                  <c:v>H4</c:v>
                </c:pt>
                <c:pt idx="81">
                  <c:v>B1</c:v>
                </c:pt>
                <c:pt idx="82">
                  <c:v>D10</c:v>
                </c:pt>
                <c:pt idx="83">
                  <c:v>E10</c:v>
                </c:pt>
                <c:pt idx="84">
                  <c:v>D2</c:v>
                </c:pt>
                <c:pt idx="85">
                  <c:v>C10</c:v>
                </c:pt>
                <c:pt idx="86">
                  <c:v>F9</c:v>
                </c:pt>
                <c:pt idx="87">
                  <c:v>B10</c:v>
                </c:pt>
                <c:pt idx="88">
                  <c:v>A1</c:v>
                </c:pt>
                <c:pt idx="89">
                  <c:v>E12</c:v>
                </c:pt>
                <c:pt idx="90">
                  <c:v>C5</c:v>
                </c:pt>
                <c:pt idx="91">
                  <c:v>A10</c:v>
                </c:pt>
                <c:pt idx="92">
                  <c:v>F7</c:v>
                </c:pt>
                <c:pt idx="93">
                  <c:v>D7</c:v>
                </c:pt>
                <c:pt idx="94">
                  <c:v>C4</c:v>
                </c:pt>
                <c:pt idx="95">
                  <c:v>D4</c:v>
                </c:pt>
              </c:strCache>
            </c:strRef>
          </c:xVal>
          <c:yVal>
            <c:numRef>
              <c:f>Vanillin!$G$2:$G$97</c:f>
              <c:numCache>
                <c:formatCode>General</c:formatCode>
                <c:ptCount val="96"/>
                <c:pt idx="0">
                  <c:v>32.14285714285716</c:v>
                </c:pt>
                <c:pt idx="1">
                  <c:v>36.633663366336641</c:v>
                </c:pt>
                <c:pt idx="2">
                  <c:v>37.500000000000014</c:v>
                </c:pt>
                <c:pt idx="3">
                  <c:v>49.152542372881342</c:v>
                </c:pt>
                <c:pt idx="4">
                  <c:v>56.896551724137957</c:v>
                </c:pt>
                <c:pt idx="5">
                  <c:v>57.142857142857181</c:v>
                </c:pt>
                <c:pt idx="6">
                  <c:v>57.28155339805825</c:v>
                </c:pt>
                <c:pt idx="7">
                  <c:v>58.653846153846146</c:v>
                </c:pt>
                <c:pt idx="8">
                  <c:v>62.393162393162406</c:v>
                </c:pt>
                <c:pt idx="9">
                  <c:v>63.888888888888914</c:v>
                </c:pt>
                <c:pt idx="10">
                  <c:v>65.060240963855435</c:v>
                </c:pt>
                <c:pt idx="11">
                  <c:v>65.873015873015888</c:v>
                </c:pt>
                <c:pt idx="12">
                  <c:v>66.666666666666671</c:v>
                </c:pt>
                <c:pt idx="13">
                  <c:v>67.71653543307086</c:v>
                </c:pt>
                <c:pt idx="14">
                  <c:v>68.800000000000011</c:v>
                </c:pt>
                <c:pt idx="15">
                  <c:v>69.444444444444457</c:v>
                </c:pt>
                <c:pt idx="16">
                  <c:v>69.629629629629648</c:v>
                </c:pt>
                <c:pt idx="17">
                  <c:v>70.370370370370367</c:v>
                </c:pt>
                <c:pt idx="18">
                  <c:v>70.967741935483872</c:v>
                </c:pt>
                <c:pt idx="19">
                  <c:v>73.015873015872984</c:v>
                </c:pt>
                <c:pt idx="20">
                  <c:v>75.213675213675202</c:v>
                </c:pt>
                <c:pt idx="21">
                  <c:v>75.418994413407844</c:v>
                </c:pt>
                <c:pt idx="22">
                  <c:v>75.630252100840309</c:v>
                </c:pt>
                <c:pt idx="23">
                  <c:v>75.892857142857125</c:v>
                </c:pt>
                <c:pt idx="24">
                  <c:v>77.727272727272734</c:v>
                </c:pt>
                <c:pt idx="25">
                  <c:v>78.448275862068968</c:v>
                </c:pt>
                <c:pt idx="26">
                  <c:v>78.84615384615384</c:v>
                </c:pt>
                <c:pt idx="27">
                  <c:v>79.310344827586206</c:v>
                </c:pt>
                <c:pt idx="28">
                  <c:v>79.611650485436897</c:v>
                </c:pt>
                <c:pt idx="29">
                  <c:v>79.787234042553209</c:v>
                </c:pt>
                <c:pt idx="30">
                  <c:v>79.824561403508767</c:v>
                </c:pt>
                <c:pt idx="31">
                  <c:v>80</c:v>
                </c:pt>
                <c:pt idx="32">
                  <c:v>81.372549019607874</c:v>
                </c:pt>
                <c:pt idx="33">
                  <c:v>81.651376146788976</c:v>
                </c:pt>
                <c:pt idx="34">
                  <c:v>82.499999999999986</c:v>
                </c:pt>
                <c:pt idx="35">
                  <c:v>83.333333333333329</c:v>
                </c:pt>
                <c:pt idx="36">
                  <c:v>83.72093023255816</c:v>
                </c:pt>
                <c:pt idx="37">
                  <c:v>84.090909090909079</c:v>
                </c:pt>
                <c:pt idx="38">
                  <c:v>84.313725490196106</c:v>
                </c:pt>
                <c:pt idx="39">
                  <c:v>84.482758620689651</c:v>
                </c:pt>
                <c:pt idx="40">
                  <c:v>86.466165413533844</c:v>
                </c:pt>
                <c:pt idx="41">
                  <c:v>87.128712871287121</c:v>
                </c:pt>
                <c:pt idx="42">
                  <c:v>87.272727272727252</c:v>
                </c:pt>
                <c:pt idx="43">
                  <c:v>87.619047619047649</c:v>
                </c:pt>
                <c:pt idx="44">
                  <c:v>88.767123287671254</c:v>
                </c:pt>
                <c:pt idx="45">
                  <c:v>89.380530973451329</c:v>
                </c:pt>
                <c:pt idx="46">
                  <c:v>90.322580645161281</c:v>
                </c:pt>
                <c:pt idx="47">
                  <c:v>90.624999999999972</c:v>
                </c:pt>
                <c:pt idx="48">
                  <c:v>90.625000000000043</c:v>
                </c:pt>
                <c:pt idx="49">
                  <c:v>91.379310344827587</c:v>
                </c:pt>
                <c:pt idx="50">
                  <c:v>92.741935483870947</c:v>
                </c:pt>
                <c:pt idx="51">
                  <c:v>93.181818181818187</c:v>
                </c:pt>
                <c:pt idx="52">
                  <c:v>94.4</c:v>
                </c:pt>
                <c:pt idx="53">
                  <c:v>94.736842105263193</c:v>
                </c:pt>
                <c:pt idx="54">
                  <c:v>95.049504950495063</c:v>
                </c:pt>
                <c:pt idx="55">
                  <c:v>95.726495726495699</c:v>
                </c:pt>
                <c:pt idx="56">
                  <c:v>96.330275229357781</c:v>
                </c:pt>
                <c:pt idx="57">
                  <c:v>96.428571428571445</c:v>
                </c:pt>
                <c:pt idx="58">
                  <c:v>97.005988023952128</c:v>
                </c:pt>
                <c:pt idx="59">
                  <c:v>97.196261682242991</c:v>
                </c:pt>
                <c:pt idx="60">
                  <c:v>97.196261682243019</c:v>
                </c:pt>
                <c:pt idx="61">
                  <c:v>97.457627118644055</c:v>
                </c:pt>
                <c:pt idx="62">
                  <c:v>98.019801980198025</c:v>
                </c:pt>
                <c:pt idx="63">
                  <c:v>100</c:v>
                </c:pt>
                <c:pt idx="64">
                  <c:v>100</c:v>
                </c:pt>
                <c:pt idx="65">
                  <c:v>100.00000000000003</c:v>
                </c:pt>
                <c:pt idx="66">
                  <c:v>100.8695652173913</c:v>
                </c:pt>
                <c:pt idx="67">
                  <c:v>100.8695652173913</c:v>
                </c:pt>
                <c:pt idx="68">
                  <c:v>100.93457943925237</c:v>
                </c:pt>
                <c:pt idx="69">
                  <c:v>101.03092783505154</c:v>
                </c:pt>
                <c:pt idx="70">
                  <c:v>102.4390243902439</c:v>
                </c:pt>
                <c:pt idx="71">
                  <c:v>102.4390243902439</c:v>
                </c:pt>
                <c:pt idx="72">
                  <c:v>102.803738317757</c:v>
                </c:pt>
                <c:pt idx="73">
                  <c:v>103.26086956521736</c:v>
                </c:pt>
                <c:pt idx="74">
                  <c:v>103.33333333333334</c:v>
                </c:pt>
                <c:pt idx="75">
                  <c:v>105.0420168067227</c:v>
                </c:pt>
                <c:pt idx="76">
                  <c:v>106.47887323943665</c:v>
                </c:pt>
                <c:pt idx="77">
                  <c:v>106.79611650485437</c:v>
                </c:pt>
                <c:pt idx="78">
                  <c:v>107.2164948453608</c:v>
                </c:pt>
                <c:pt idx="79">
                  <c:v>111.11111111111114</c:v>
                </c:pt>
                <c:pt idx="80">
                  <c:v>111.6788321167883</c:v>
                </c:pt>
                <c:pt idx="81">
                  <c:v>111.95652173913039</c:v>
                </c:pt>
                <c:pt idx="82">
                  <c:v>112.50000000000003</c:v>
                </c:pt>
                <c:pt idx="83">
                  <c:v>112.71186440677965</c:v>
                </c:pt>
                <c:pt idx="84">
                  <c:v>112.74509803921569</c:v>
                </c:pt>
                <c:pt idx="85">
                  <c:v>114.78260869565217</c:v>
                </c:pt>
                <c:pt idx="86">
                  <c:v>115.21739130434784</c:v>
                </c:pt>
                <c:pt idx="87">
                  <c:v>115.70247933884296</c:v>
                </c:pt>
                <c:pt idx="88">
                  <c:v>116.34615384615381</c:v>
                </c:pt>
                <c:pt idx="89">
                  <c:v>116.6666666666667</c:v>
                </c:pt>
                <c:pt idx="90">
                  <c:v>116.8316831683168</c:v>
                </c:pt>
                <c:pt idx="91">
                  <c:v>120.91836734693875</c:v>
                </c:pt>
                <c:pt idx="92">
                  <c:v>121.31147540983609</c:v>
                </c:pt>
                <c:pt idx="93">
                  <c:v>127.43362831858407</c:v>
                </c:pt>
                <c:pt idx="94">
                  <c:v>130.70175438596488</c:v>
                </c:pt>
                <c:pt idx="95">
                  <c:v>131.000000000000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46432"/>
        <c:axId val="172746432"/>
      </c:scatterChart>
      <c:valAx>
        <c:axId val="15714643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2746432"/>
        <c:crosses val="autoZero"/>
        <c:crossBetween val="midCat"/>
      </c:valAx>
      <c:valAx>
        <c:axId val="172746432"/>
        <c:scaling>
          <c:orientation val="minMax"/>
          <c:min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714643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2120441288460226"/>
          <c:y val="0.41530548096281983"/>
          <c:w val="0.31212905335092961"/>
          <c:h val="0.4151252841825163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92319638521621"/>
          <c:y val="4.7566574728411817E-2"/>
          <c:w val="0.67319067562866963"/>
          <c:h val="0.74917098583249209"/>
        </c:manualLayout>
      </c:layout>
      <c:scatterChart>
        <c:scatterStyle val="lineMarker"/>
        <c:varyColors val="0"/>
        <c:ser>
          <c:idx val="5"/>
          <c:order val="0"/>
          <c:tx>
            <c:strRef>
              <c:f>Sorbitol!$H$1</c:f>
              <c:strCache>
                <c:ptCount val="1"/>
                <c:pt idx="0">
                  <c:v>Sorbit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Sorbitol!$B$2:$B$97</c:f>
              <c:strCache>
                <c:ptCount val="96"/>
                <c:pt idx="0">
                  <c:v>H9</c:v>
                </c:pt>
                <c:pt idx="1">
                  <c:v>F6</c:v>
                </c:pt>
                <c:pt idx="2">
                  <c:v>D3</c:v>
                </c:pt>
                <c:pt idx="3">
                  <c:v>D11</c:v>
                </c:pt>
                <c:pt idx="4">
                  <c:v>H7</c:v>
                </c:pt>
                <c:pt idx="5">
                  <c:v>G1</c:v>
                </c:pt>
                <c:pt idx="6">
                  <c:v>H11</c:v>
                </c:pt>
                <c:pt idx="7">
                  <c:v>G7</c:v>
                </c:pt>
                <c:pt idx="8">
                  <c:v>H2</c:v>
                </c:pt>
                <c:pt idx="9">
                  <c:v>E6</c:v>
                </c:pt>
                <c:pt idx="10">
                  <c:v>H10</c:v>
                </c:pt>
                <c:pt idx="11">
                  <c:v>H4</c:v>
                </c:pt>
                <c:pt idx="12">
                  <c:v>G3</c:v>
                </c:pt>
                <c:pt idx="13">
                  <c:v>G6</c:v>
                </c:pt>
                <c:pt idx="14">
                  <c:v>E10</c:v>
                </c:pt>
                <c:pt idx="15">
                  <c:v>F11</c:v>
                </c:pt>
                <c:pt idx="16">
                  <c:v>G10</c:v>
                </c:pt>
                <c:pt idx="17">
                  <c:v>G2</c:v>
                </c:pt>
                <c:pt idx="18">
                  <c:v>G11</c:v>
                </c:pt>
                <c:pt idx="19">
                  <c:v>F9</c:v>
                </c:pt>
                <c:pt idx="20">
                  <c:v>F10</c:v>
                </c:pt>
                <c:pt idx="21">
                  <c:v>H3</c:v>
                </c:pt>
                <c:pt idx="22">
                  <c:v>E4</c:v>
                </c:pt>
                <c:pt idx="23">
                  <c:v>H12</c:v>
                </c:pt>
                <c:pt idx="24">
                  <c:v>B11</c:v>
                </c:pt>
                <c:pt idx="25">
                  <c:v>G5</c:v>
                </c:pt>
                <c:pt idx="26">
                  <c:v>D10</c:v>
                </c:pt>
                <c:pt idx="27">
                  <c:v>E3</c:v>
                </c:pt>
                <c:pt idx="28">
                  <c:v>G12</c:v>
                </c:pt>
                <c:pt idx="29">
                  <c:v>H6</c:v>
                </c:pt>
                <c:pt idx="30">
                  <c:v>H5</c:v>
                </c:pt>
                <c:pt idx="31">
                  <c:v>H1</c:v>
                </c:pt>
                <c:pt idx="32">
                  <c:v>A4</c:v>
                </c:pt>
                <c:pt idx="33">
                  <c:v>D9</c:v>
                </c:pt>
                <c:pt idx="34">
                  <c:v>F2</c:v>
                </c:pt>
                <c:pt idx="35">
                  <c:v>E2</c:v>
                </c:pt>
                <c:pt idx="36">
                  <c:v>H8</c:v>
                </c:pt>
                <c:pt idx="37">
                  <c:v>B9</c:v>
                </c:pt>
                <c:pt idx="38">
                  <c:v>D4</c:v>
                </c:pt>
                <c:pt idx="39">
                  <c:v>E7</c:v>
                </c:pt>
                <c:pt idx="40">
                  <c:v>F12</c:v>
                </c:pt>
                <c:pt idx="41">
                  <c:v>E8</c:v>
                </c:pt>
                <c:pt idx="42">
                  <c:v>D5</c:v>
                </c:pt>
                <c:pt idx="43">
                  <c:v>D6</c:v>
                </c:pt>
                <c:pt idx="44">
                  <c:v>C2</c:v>
                </c:pt>
                <c:pt idx="45">
                  <c:v>E1</c:v>
                </c:pt>
                <c:pt idx="46">
                  <c:v>G8</c:v>
                </c:pt>
                <c:pt idx="47">
                  <c:v>G4</c:v>
                </c:pt>
                <c:pt idx="48">
                  <c:v>F8</c:v>
                </c:pt>
                <c:pt idx="49">
                  <c:v>B4</c:v>
                </c:pt>
                <c:pt idx="50">
                  <c:v>G9</c:v>
                </c:pt>
                <c:pt idx="51">
                  <c:v>C4</c:v>
                </c:pt>
                <c:pt idx="52">
                  <c:v>E11</c:v>
                </c:pt>
                <c:pt idx="53">
                  <c:v>F4</c:v>
                </c:pt>
                <c:pt idx="54">
                  <c:v>D7</c:v>
                </c:pt>
                <c:pt idx="55">
                  <c:v>D1</c:v>
                </c:pt>
                <c:pt idx="56">
                  <c:v>F7</c:v>
                </c:pt>
                <c:pt idx="57">
                  <c:v>C1</c:v>
                </c:pt>
                <c:pt idx="58">
                  <c:v>C11</c:v>
                </c:pt>
                <c:pt idx="59">
                  <c:v>A11</c:v>
                </c:pt>
                <c:pt idx="60">
                  <c:v>B7</c:v>
                </c:pt>
                <c:pt idx="61">
                  <c:v>D2</c:v>
                </c:pt>
                <c:pt idx="62">
                  <c:v>C9</c:v>
                </c:pt>
                <c:pt idx="63">
                  <c:v>B3</c:v>
                </c:pt>
                <c:pt idx="64">
                  <c:v>C10</c:v>
                </c:pt>
                <c:pt idx="65">
                  <c:v>F5</c:v>
                </c:pt>
                <c:pt idx="66">
                  <c:v>C5</c:v>
                </c:pt>
                <c:pt idx="67">
                  <c:v>C6</c:v>
                </c:pt>
                <c:pt idx="68">
                  <c:v>D12</c:v>
                </c:pt>
                <c:pt idx="69">
                  <c:v>C7</c:v>
                </c:pt>
                <c:pt idx="70">
                  <c:v>B8</c:v>
                </c:pt>
                <c:pt idx="71">
                  <c:v>B10</c:v>
                </c:pt>
                <c:pt idx="72">
                  <c:v>E9</c:v>
                </c:pt>
                <c:pt idx="73">
                  <c:v>B2</c:v>
                </c:pt>
                <c:pt idx="74">
                  <c:v>A1</c:v>
                </c:pt>
                <c:pt idx="75">
                  <c:v>D8</c:v>
                </c:pt>
                <c:pt idx="76">
                  <c:v>C3</c:v>
                </c:pt>
                <c:pt idx="77">
                  <c:v>A3</c:v>
                </c:pt>
                <c:pt idx="78">
                  <c:v>A8</c:v>
                </c:pt>
                <c:pt idx="79">
                  <c:v>B6</c:v>
                </c:pt>
                <c:pt idx="80">
                  <c:v>F1</c:v>
                </c:pt>
                <c:pt idx="81">
                  <c:v>E5</c:v>
                </c:pt>
                <c:pt idx="82">
                  <c:v>B12</c:v>
                </c:pt>
                <c:pt idx="83">
                  <c:v>B5</c:v>
                </c:pt>
                <c:pt idx="84">
                  <c:v>E12</c:v>
                </c:pt>
                <c:pt idx="85">
                  <c:v>A2</c:v>
                </c:pt>
                <c:pt idx="86">
                  <c:v>C12</c:v>
                </c:pt>
                <c:pt idx="87">
                  <c:v>A10</c:v>
                </c:pt>
                <c:pt idx="88">
                  <c:v>A5</c:v>
                </c:pt>
                <c:pt idx="89">
                  <c:v>C8</c:v>
                </c:pt>
                <c:pt idx="90">
                  <c:v>A12</c:v>
                </c:pt>
                <c:pt idx="91">
                  <c:v>A7</c:v>
                </c:pt>
                <c:pt idx="92">
                  <c:v>F3</c:v>
                </c:pt>
                <c:pt idx="93">
                  <c:v>A9</c:v>
                </c:pt>
                <c:pt idx="94">
                  <c:v>A6</c:v>
                </c:pt>
                <c:pt idx="95">
                  <c:v>B1</c:v>
                </c:pt>
              </c:strCache>
            </c:strRef>
          </c:xVal>
          <c:yVal>
            <c:numRef>
              <c:f>Sorbitol!$H$2:$H$97</c:f>
              <c:numCache>
                <c:formatCode>General</c:formatCode>
                <c:ptCount val="96"/>
                <c:pt idx="0">
                  <c:v>58.787878787878775</c:v>
                </c:pt>
                <c:pt idx="1">
                  <c:v>60.714285714285708</c:v>
                </c:pt>
                <c:pt idx="2">
                  <c:v>61.616161616161634</c:v>
                </c:pt>
                <c:pt idx="3">
                  <c:v>70.000000000000014</c:v>
                </c:pt>
                <c:pt idx="4">
                  <c:v>70.072992700729912</c:v>
                </c:pt>
                <c:pt idx="5">
                  <c:v>72.142857142857139</c:v>
                </c:pt>
                <c:pt idx="6">
                  <c:v>72.560975609756085</c:v>
                </c:pt>
                <c:pt idx="7">
                  <c:v>73.611111111111114</c:v>
                </c:pt>
                <c:pt idx="8">
                  <c:v>74.025974025974023</c:v>
                </c:pt>
                <c:pt idx="9">
                  <c:v>75.490196078431381</c:v>
                </c:pt>
                <c:pt idx="10">
                  <c:v>75.974025974025977</c:v>
                </c:pt>
                <c:pt idx="11">
                  <c:v>76.3888888888889</c:v>
                </c:pt>
                <c:pt idx="12">
                  <c:v>79.508196721311506</c:v>
                </c:pt>
                <c:pt idx="13">
                  <c:v>80.468749999999986</c:v>
                </c:pt>
                <c:pt idx="14">
                  <c:v>82.692307692307693</c:v>
                </c:pt>
                <c:pt idx="15">
                  <c:v>83.088235294117652</c:v>
                </c:pt>
                <c:pt idx="16">
                  <c:v>84.166666666666643</c:v>
                </c:pt>
                <c:pt idx="17">
                  <c:v>84.297520661157037</c:v>
                </c:pt>
                <c:pt idx="18">
                  <c:v>84.827586206896555</c:v>
                </c:pt>
                <c:pt idx="19">
                  <c:v>84.86486486486487</c:v>
                </c:pt>
                <c:pt idx="20">
                  <c:v>85.18518518518519</c:v>
                </c:pt>
                <c:pt idx="21">
                  <c:v>86.567164179104481</c:v>
                </c:pt>
                <c:pt idx="22">
                  <c:v>88</c:v>
                </c:pt>
                <c:pt idx="23">
                  <c:v>88.819875776397524</c:v>
                </c:pt>
                <c:pt idx="24">
                  <c:v>88.983050847457619</c:v>
                </c:pt>
                <c:pt idx="25">
                  <c:v>90.243902439024367</c:v>
                </c:pt>
                <c:pt idx="26">
                  <c:v>90.816326530612272</c:v>
                </c:pt>
                <c:pt idx="27">
                  <c:v>90.909090909090907</c:v>
                </c:pt>
                <c:pt idx="28">
                  <c:v>91.452991452991455</c:v>
                </c:pt>
                <c:pt idx="29">
                  <c:v>92.028985507246389</c:v>
                </c:pt>
                <c:pt idx="30">
                  <c:v>92.248062015503876</c:v>
                </c:pt>
                <c:pt idx="31">
                  <c:v>92.647058823529406</c:v>
                </c:pt>
                <c:pt idx="32">
                  <c:v>92.857142857142861</c:v>
                </c:pt>
                <c:pt idx="33">
                  <c:v>92.929292929292899</c:v>
                </c:pt>
                <c:pt idx="34">
                  <c:v>93.893129770992388</c:v>
                </c:pt>
                <c:pt idx="35">
                  <c:v>94.495412844036679</c:v>
                </c:pt>
                <c:pt idx="36">
                  <c:v>95.3125</c:v>
                </c:pt>
                <c:pt idx="37">
                  <c:v>95.833333333333343</c:v>
                </c:pt>
                <c:pt idx="38">
                  <c:v>95.918367346938766</c:v>
                </c:pt>
                <c:pt idx="39">
                  <c:v>96.190476190476232</c:v>
                </c:pt>
                <c:pt idx="40">
                  <c:v>96.296296296296305</c:v>
                </c:pt>
                <c:pt idx="41">
                  <c:v>96.666666666666686</c:v>
                </c:pt>
                <c:pt idx="42">
                  <c:v>96.907216494845386</c:v>
                </c:pt>
                <c:pt idx="43">
                  <c:v>99.000000000000028</c:v>
                </c:pt>
                <c:pt idx="44">
                  <c:v>99.374999999999943</c:v>
                </c:pt>
                <c:pt idx="45">
                  <c:v>100</c:v>
                </c:pt>
                <c:pt idx="46">
                  <c:v>100.86956521739133</c:v>
                </c:pt>
                <c:pt idx="47">
                  <c:v>101.6</c:v>
                </c:pt>
                <c:pt idx="48">
                  <c:v>101.86915887850468</c:v>
                </c:pt>
                <c:pt idx="49">
                  <c:v>102.75229357798166</c:v>
                </c:pt>
                <c:pt idx="50">
                  <c:v>103.44827586206897</c:v>
                </c:pt>
                <c:pt idx="51">
                  <c:v>103.96039603960394</c:v>
                </c:pt>
                <c:pt idx="52">
                  <c:v>103.99999999999999</c:v>
                </c:pt>
                <c:pt idx="53">
                  <c:v>104.03225806451614</c:v>
                </c:pt>
                <c:pt idx="54">
                  <c:v>104.67289719626164</c:v>
                </c:pt>
                <c:pt idx="55">
                  <c:v>105.55555555555559</c:v>
                </c:pt>
                <c:pt idx="56">
                  <c:v>106.09756097560978</c:v>
                </c:pt>
                <c:pt idx="57">
                  <c:v>109.30232558139532</c:v>
                </c:pt>
                <c:pt idx="58">
                  <c:v>109.375</c:v>
                </c:pt>
                <c:pt idx="59">
                  <c:v>110.89108910891088</c:v>
                </c:pt>
                <c:pt idx="60">
                  <c:v>110.90909090909093</c:v>
                </c:pt>
                <c:pt idx="61">
                  <c:v>113.51351351351353</c:v>
                </c:pt>
                <c:pt idx="62">
                  <c:v>114.28571428571428</c:v>
                </c:pt>
                <c:pt idx="63">
                  <c:v>115.625</c:v>
                </c:pt>
                <c:pt idx="64">
                  <c:v>116.32653061224485</c:v>
                </c:pt>
                <c:pt idx="65">
                  <c:v>116.6666666666666</c:v>
                </c:pt>
                <c:pt idx="66">
                  <c:v>117.89473684210527</c:v>
                </c:pt>
                <c:pt idx="67">
                  <c:v>117.97752808988761</c:v>
                </c:pt>
                <c:pt idx="68">
                  <c:v>118.75000000000003</c:v>
                </c:pt>
                <c:pt idx="69">
                  <c:v>119.7802197802198</c:v>
                </c:pt>
                <c:pt idx="70">
                  <c:v>119.99999999999997</c:v>
                </c:pt>
                <c:pt idx="71">
                  <c:v>120.99999999999997</c:v>
                </c:pt>
                <c:pt idx="72">
                  <c:v>121.79487179487182</c:v>
                </c:pt>
                <c:pt idx="73">
                  <c:v>121.83908045977012</c:v>
                </c:pt>
                <c:pt idx="74">
                  <c:v>123.52941176470591</c:v>
                </c:pt>
                <c:pt idx="75">
                  <c:v>124.65753424657531</c:v>
                </c:pt>
                <c:pt idx="76">
                  <c:v>124.70588235294117</c:v>
                </c:pt>
                <c:pt idx="77">
                  <c:v>124.73118279569897</c:v>
                </c:pt>
                <c:pt idx="78">
                  <c:v>125.58139534883716</c:v>
                </c:pt>
                <c:pt idx="79">
                  <c:v>125.88235294117646</c:v>
                </c:pt>
                <c:pt idx="80">
                  <c:v>127.16049382716052</c:v>
                </c:pt>
                <c:pt idx="81">
                  <c:v>128.98550724637676</c:v>
                </c:pt>
                <c:pt idx="82">
                  <c:v>129.99999999999997</c:v>
                </c:pt>
                <c:pt idx="83">
                  <c:v>130.26315789473685</c:v>
                </c:pt>
                <c:pt idx="84">
                  <c:v>130.48780487804879</c:v>
                </c:pt>
                <c:pt idx="85">
                  <c:v>132.63157894736841</c:v>
                </c:pt>
                <c:pt idx="86">
                  <c:v>137.02127659574472</c:v>
                </c:pt>
                <c:pt idx="87">
                  <c:v>139.13043478260872</c:v>
                </c:pt>
                <c:pt idx="88">
                  <c:v>142.15686274509807</c:v>
                </c:pt>
                <c:pt idx="89">
                  <c:v>146.31578947368419</c:v>
                </c:pt>
                <c:pt idx="90">
                  <c:v>147.29729729729729</c:v>
                </c:pt>
                <c:pt idx="91">
                  <c:v>148.71794871794876</c:v>
                </c:pt>
                <c:pt idx="92">
                  <c:v>149.36708860759498</c:v>
                </c:pt>
                <c:pt idx="93">
                  <c:v>151.38888888888891</c:v>
                </c:pt>
                <c:pt idx="94">
                  <c:v>153.19148936170214</c:v>
                </c:pt>
                <c:pt idx="95">
                  <c:v>156.164383561643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20192"/>
        <c:axId val="168920768"/>
      </c:scatterChart>
      <c:valAx>
        <c:axId val="168920192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68920768"/>
        <c:crosses val="autoZero"/>
        <c:crossBetween val="midCat"/>
      </c:valAx>
      <c:valAx>
        <c:axId val="168920768"/>
        <c:scaling>
          <c:orientation val="minMax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89201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3048252163494489"/>
          <c:y val="0.35475393700787405"/>
          <c:w val="0.28618385223236087"/>
          <c:h val="0.4710473170020413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284227401883268"/>
          <c:y val="5.1400554097404488E-2"/>
          <c:w val="0.71979341137134178"/>
          <c:h val="0.80947142023913676"/>
        </c:manualLayout>
      </c:layout>
      <c:scatterChart>
        <c:scatterStyle val="lineMarker"/>
        <c:varyColors val="0"/>
        <c:ser>
          <c:idx val="6"/>
          <c:order val="0"/>
          <c:tx>
            <c:strRef>
              <c:f>Ethanol!$I$1</c:f>
              <c:strCache>
                <c:ptCount val="1"/>
                <c:pt idx="0">
                  <c:v>Ethanol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Ethanol!$B$2:$B$97</c:f>
              <c:strCache>
                <c:ptCount val="96"/>
                <c:pt idx="0">
                  <c:v>A3</c:v>
                </c:pt>
                <c:pt idx="1">
                  <c:v>E6</c:v>
                </c:pt>
                <c:pt idx="2">
                  <c:v>G6</c:v>
                </c:pt>
                <c:pt idx="3">
                  <c:v>E11</c:v>
                </c:pt>
                <c:pt idx="4">
                  <c:v>E10</c:v>
                </c:pt>
                <c:pt idx="5">
                  <c:v>E9</c:v>
                </c:pt>
                <c:pt idx="6">
                  <c:v>G7</c:v>
                </c:pt>
                <c:pt idx="7">
                  <c:v>F2</c:v>
                </c:pt>
                <c:pt idx="8">
                  <c:v>E5</c:v>
                </c:pt>
                <c:pt idx="9">
                  <c:v>G4</c:v>
                </c:pt>
                <c:pt idx="10">
                  <c:v>G5</c:v>
                </c:pt>
                <c:pt idx="11">
                  <c:v>A4</c:v>
                </c:pt>
                <c:pt idx="12">
                  <c:v>H3</c:v>
                </c:pt>
                <c:pt idx="13">
                  <c:v>C6</c:v>
                </c:pt>
                <c:pt idx="14">
                  <c:v>H12</c:v>
                </c:pt>
                <c:pt idx="15">
                  <c:v>G9</c:v>
                </c:pt>
                <c:pt idx="16">
                  <c:v>F9</c:v>
                </c:pt>
                <c:pt idx="17">
                  <c:v>B3</c:v>
                </c:pt>
                <c:pt idx="18">
                  <c:v>C1</c:v>
                </c:pt>
                <c:pt idx="19">
                  <c:v>E3</c:v>
                </c:pt>
                <c:pt idx="20">
                  <c:v>E4</c:v>
                </c:pt>
                <c:pt idx="21">
                  <c:v>D11</c:v>
                </c:pt>
                <c:pt idx="22">
                  <c:v>D6</c:v>
                </c:pt>
                <c:pt idx="23">
                  <c:v>H6</c:v>
                </c:pt>
                <c:pt idx="24">
                  <c:v>E2</c:v>
                </c:pt>
                <c:pt idx="25">
                  <c:v>G1</c:v>
                </c:pt>
                <c:pt idx="26">
                  <c:v>G10</c:v>
                </c:pt>
                <c:pt idx="27">
                  <c:v>C2</c:v>
                </c:pt>
                <c:pt idx="28">
                  <c:v>F12</c:v>
                </c:pt>
                <c:pt idx="29">
                  <c:v>E7</c:v>
                </c:pt>
                <c:pt idx="30">
                  <c:v>H10</c:v>
                </c:pt>
                <c:pt idx="31">
                  <c:v>H1</c:v>
                </c:pt>
                <c:pt idx="32">
                  <c:v>C12</c:v>
                </c:pt>
                <c:pt idx="33">
                  <c:v>D4</c:v>
                </c:pt>
                <c:pt idx="34">
                  <c:v>G12</c:v>
                </c:pt>
                <c:pt idx="35">
                  <c:v>F7</c:v>
                </c:pt>
                <c:pt idx="36">
                  <c:v>H8</c:v>
                </c:pt>
                <c:pt idx="37">
                  <c:v>C4</c:v>
                </c:pt>
                <c:pt idx="38">
                  <c:v>G3</c:v>
                </c:pt>
                <c:pt idx="39">
                  <c:v>G2</c:v>
                </c:pt>
                <c:pt idx="40">
                  <c:v>D8</c:v>
                </c:pt>
                <c:pt idx="41">
                  <c:v>H2</c:v>
                </c:pt>
                <c:pt idx="42">
                  <c:v>B2</c:v>
                </c:pt>
                <c:pt idx="43">
                  <c:v>E1</c:v>
                </c:pt>
                <c:pt idx="44">
                  <c:v>F11</c:v>
                </c:pt>
                <c:pt idx="45">
                  <c:v>B5</c:v>
                </c:pt>
                <c:pt idx="46">
                  <c:v>G8</c:v>
                </c:pt>
                <c:pt idx="47">
                  <c:v>H5</c:v>
                </c:pt>
                <c:pt idx="48">
                  <c:v>D10</c:v>
                </c:pt>
                <c:pt idx="49">
                  <c:v>H9</c:v>
                </c:pt>
                <c:pt idx="50">
                  <c:v>H11</c:v>
                </c:pt>
                <c:pt idx="51">
                  <c:v>B8</c:v>
                </c:pt>
                <c:pt idx="52">
                  <c:v>G11</c:v>
                </c:pt>
                <c:pt idx="53">
                  <c:v>A11</c:v>
                </c:pt>
                <c:pt idx="54">
                  <c:v>H4</c:v>
                </c:pt>
                <c:pt idx="55">
                  <c:v>F8</c:v>
                </c:pt>
                <c:pt idx="56">
                  <c:v>C11</c:v>
                </c:pt>
                <c:pt idx="57">
                  <c:v>A7</c:v>
                </c:pt>
                <c:pt idx="58">
                  <c:v>B10</c:v>
                </c:pt>
                <c:pt idx="59">
                  <c:v>F6</c:v>
                </c:pt>
                <c:pt idx="60">
                  <c:v>D5</c:v>
                </c:pt>
                <c:pt idx="61">
                  <c:v>B1</c:v>
                </c:pt>
                <c:pt idx="62">
                  <c:v>C3</c:v>
                </c:pt>
                <c:pt idx="63">
                  <c:v>D7</c:v>
                </c:pt>
                <c:pt idx="64">
                  <c:v>A9</c:v>
                </c:pt>
                <c:pt idx="65">
                  <c:v>D1</c:v>
                </c:pt>
                <c:pt idx="66">
                  <c:v>B6</c:v>
                </c:pt>
                <c:pt idx="67">
                  <c:v>C7</c:v>
                </c:pt>
                <c:pt idx="68">
                  <c:v>H7</c:v>
                </c:pt>
                <c:pt idx="69">
                  <c:v>D9</c:v>
                </c:pt>
                <c:pt idx="70">
                  <c:v>A5</c:v>
                </c:pt>
                <c:pt idx="71">
                  <c:v>F10</c:v>
                </c:pt>
                <c:pt idx="72">
                  <c:v>D2</c:v>
                </c:pt>
                <c:pt idx="73">
                  <c:v>A12</c:v>
                </c:pt>
                <c:pt idx="74">
                  <c:v>B4</c:v>
                </c:pt>
                <c:pt idx="75">
                  <c:v>C9</c:v>
                </c:pt>
                <c:pt idx="76">
                  <c:v>D3</c:v>
                </c:pt>
                <c:pt idx="77">
                  <c:v>A10</c:v>
                </c:pt>
                <c:pt idx="78">
                  <c:v>E8</c:v>
                </c:pt>
                <c:pt idx="79">
                  <c:v>C8</c:v>
                </c:pt>
                <c:pt idx="80">
                  <c:v>B11</c:v>
                </c:pt>
                <c:pt idx="81">
                  <c:v>F4</c:v>
                </c:pt>
                <c:pt idx="82">
                  <c:v>C5</c:v>
                </c:pt>
                <c:pt idx="83">
                  <c:v>D12</c:v>
                </c:pt>
                <c:pt idx="84">
                  <c:v>E12</c:v>
                </c:pt>
                <c:pt idx="85">
                  <c:v>B7</c:v>
                </c:pt>
                <c:pt idx="86">
                  <c:v>F5</c:v>
                </c:pt>
                <c:pt idx="87">
                  <c:v>A2</c:v>
                </c:pt>
                <c:pt idx="88">
                  <c:v>A1</c:v>
                </c:pt>
                <c:pt idx="89">
                  <c:v>C10</c:v>
                </c:pt>
                <c:pt idx="90">
                  <c:v>A6</c:v>
                </c:pt>
                <c:pt idx="91">
                  <c:v>B12</c:v>
                </c:pt>
                <c:pt idx="92">
                  <c:v>F3</c:v>
                </c:pt>
                <c:pt idx="93">
                  <c:v>A8</c:v>
                </c:pt>
                <c:pt idx="94">
                  <c:v>B9</c:v>
                </c:pt>
                <c:pt idx="95">
                  <c:v>F1</c:v>
                </c:pt>
              </c:strCache>
            </c:strRef>
          </c:xVal>
          <c:yVal>
            <c:numRef>
              <c:f>Ethanol!$I$2:$I$97</c:f>
              <c:numCache>
                <c:formatCode>General</c:formatCode>
                <c:ptCount val="9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.703703703703809</c:v>
                </c:pt>
                <c:pt idx="4">
                  <c:v>7.5000000000000009</c:v>
                </c:pt>
                <c:pt idx="5">
                  <c:v>7.6923076923076925</c:v>
                </c:pt>
                <c:pt idx="6">
                  <c:v>10.447761194029862</c:v>
                </c:pt>
                <c:pt idx="7">
                  <c:v>11.111111111111084</c:v>
                </c:pt>
                <c:pt idx="8">
                  <c:v>12.903225806451632</c:v>
                </c:pt>
                <c:pt idx="9">
                  <c:v>14.864864864864854</c:v>
                </c:pt>
                <c:pt idx="10">
                  <c:v>17.499999999999996</c:v>
                </c:pt>
                <c:pt idx="11">
                  <c:v>18.000000000000011</c:v>
                </c:pt>
                <c:pt idx="12">
                  <c:v>18.446601941747602</c:v>
                </c:pt>
                <c:pt idx="13">
                  <c:v>18.518518518518494</c:v>
                </c:pt>
                <c:pt idx="14">
                  <c:v>18.548387096774171</c:v>
                </c:pt>
                <c:pt idx="15">
                  <c:v>18.852459016393457</c:v>
                </c:pt>
                <c:pt idx="16">
                  <c:v>19.087136929460545</c:v>
                </c:pt>
                <c:pt idx="17">
                  <c:v>19.117647058823508</c:v>
                </c:pt>
                <c:pt idx="18">
                  <c:v>19.14893617021276</c:v>
                </c:pt>
                <c:pt idx="19">
                  <c:v>19.29824561403511</c:v>
                </c:pt>
                <c:pt idx="20">
                  <c:v>20</c:v>
                </c:pt>
                <c:pt idx="21">
                  <c:v>20.000000000000085</c:v>
                </c:pt>
                <c:pt idx="22">
                  <c:v>20.588235294117663</c:v>
                </c:pt>
                <c:pt idx="23">
                  <c:v>20.652173913043459</c:v>
                </c:pt>
                <c:pt idx="24">
                  <c:v>20.689655172413783</c:v>
                </c:pt>
                <c:pt idx="25">
                  <c:v>20.754716981132066</c:v>
                </c:pt>
                <c:pt idx="26">
                  <c:v>20.833333333333321</c:v>
                </c:pt>
                <c:pt idx="27">
                  <c:v>20.879120879120762</c:v>
                </c:pt>
                <c:pt idx="28">
                  <c:v>21.621621621621614</c:v>
                </c:pt>
                <c:pt idx="29">
                  <c:v>22.077922077922093</c:v>
                </c:pt>
                <c:pt idx="30">
                  <c:v>22.580645161290306</c:v>
                </c:pt>
                <c:pt idx="31">
                  <c:v>22.619047619047652</c:v>
                </c:pt>
                <c:pt idx="32">
                  <c:v>23.170731707317056</c:v>
                </c:pt>
                <c:pt idx="33">
                  <c:v>23.456790123456774</c:v>
                </c:pt>
                <c:pt idx="34">
                  <c:v>23.863636363636367</c:v>
                </c:pt>
                <c:pt idx="35">
                  <c:v>23.913043478260899</c:v>
                </c:pt>
                <c:pt idx="36">
                  <c:v>24.752475247524735</c:v>
                </c:pt>
                <c:pt idx="37">
                  <c:v>24.999999999999968</c:v>
                </c:pt>
                <c:pt idx="38">
                  <c:v>25.510204081632644</c:v>
                </c:pt>
                <c:pt idx="39">
                  <c:v>26.881720430107514</c:v>
                </c:pt>
                <c:pt idx="40">
                  <c:v>27.500000000000046</c:v>
                </c:pt>
                <c:pt idx="41">
                  <c:v>27.659574468085125</c:v>
                </c:pt>
                <c:pt idx="42">
                  <c:v>27.868852459016402</c:v>
                </c:pt>
                <c:pt idx="43">
                  <c:v>28.301886792452823</c:v>
                </c:pt>
                <c:pt idx="44">
                  <c:v>28.409090909090896</c:v>
                </c:pt>
                <c:pt idx="45">
                  <c:v>28.846153846153854</c:v>
                </c:pt>
                <c:pt idx="46">
                  <c:v>29.213483146067382</c:v>
                </c:pt>
                <c:pt idx="47">
                  <c:v>29.687500000000032</c:v>
                </c:pt>
                <c:pt idx="48">
                  <c:v>29.68750000000005</c:v>
                </c:pt>
                <c:pt idx="49">
                  <c:v>30.400000000000016</c:v>
                </c:pt>
                <c:pt idx="50">
                  <c:v>30.833333333333357</c:v>
                </c:pt>
                <c:pt idx="51">
                  <c:v>30.909090909090864</c:v>
                </c:pt>
                <c:pt idx="52">
                  <c:v>31.147540983606564</c:v>
                </c:pt>
                <c:pt idx="53">
                  <c:v>31.372549019607899</c:v>
                </c:pt>
                <c:pt idx="54">
                  <c:v>31.372549019607899</c:v>
                </c:pt>
                <c:pt idx="55">
                  <c:v>32.01970443349753</c:v>
                </c:pt>
                <c:pt idx="56">
                  <c:v>32.352941176470495</c:v>
                </c:pt>
                <c:pt idx="57">
                  <c:v>33.333333333333329</c:v>
                </c:pt>
                <c:pt idx="58">
                  <c:v>33.333333333333329</c:v>
                </c:pt>
                <c:pt idx="59">
                  <c:v>33.333333333333329</c:v>
                </c:pt>
                <c:pt idx="60">
                  <c:v>33.333333333333357</c:v>
                </c:pt>
                <c:pt idx="61">
                  <c:v>33.898305084745779</c:v>
                </c:pt>
                <c:pt idx="62">
                  <c:v>34.375000000000078</c:v>
                </c:pt>
                <c:pt idx="63">
                  <c:v>39.655172413793068</c:v>
                </c:pt>
                <c:pt idx="64">
                  <c:v>41.463414634146254</c:v>
                </c:pt>
                <c:pt idx="65">
                  <c:v>41.463414634146361</c:v>
                </c:pt>
                <c:pt idx="66">
                  <c:v>44.067796610169509</c:v>
                </c:pt>
                <c:pt idx="67">
                  <c:v>44.89795918367345</c:v>
                </c:pt>
                <c:pt idx="68">
                  <c:v>45</c:v>
                </c:pt>
                <c:pt idx="69">
                  <c:v>45.161290322580612</c:v>
                </c:pt>
                <c:pt idx="70">
                  <c:v>48.780487804878121</c:v>
                </c:pt>
                <c:pt idx="71">
                  <c:v>49.295774647887328</c:v>
                </c:pt>
                <c:pt idx="72">
                  <c:v>50</c:v>
                </c:pt>
                <c:pt idx="73">
                  <c:v>50.000000000000057</c:v>
                </c:pt>
                <c:pt idx="74">
                  <c:v>50.909090909090892</c:v>
                </c:pt>
                <c:pt idx="75">
                  <c:v>52.380952380952294</c:v>
                </c:pt>
                <c:pt idx="76">
                  <c:v>54.1666666666667</c:v>
                </c:pt>
                <c:pt idx="77">
                  <c:v>54.901960784313694</c:v>
                </c:pt>
                <c:pt idx="78">
                  <c:v>55.319148936170279</c:v>
                </c:pt>
                <c:pt idx="79">
                  <c:v>56.716417910447788</c:v>
                </c:pt>
                <c:pt idx="80">
                  <c:v>57.777777777777715</c:v>
                </c:pt>
                <c:pt idx="81">
                  <c:v>58.42696629213485</c:v>
                </c:pt>
                <c:pt idx="82">
                  <c:v>58.82352941176471</c:v>
                </c:pt>
                <c:pt idx="83">
                  <c:v>59.999999999999979</c:v>
                </c:pt>
                <c:pt idx="84">
                  <c:v>60</c:v>
                </c:pt>
                <c:pt idx="85">
                  <c:v>64.28571428571432</c:v>
                </c:pt>
                <c:pt idx="86">
                  <c:v>72.222222222222143</c:v>
                </c:pt>
                <c:pt idx="87">
                  <c:v>74.999999999999972</c:v>
                </c:pt>
                <c:pt idx="88">
                  <c:v>76.744186046511658</c:v>
                </c:pt>
                <c:pt idx="89">
                  <c:v>79.166666666666458</c:v>
                </c:pt>
                <c:pt idx="90">
                  <c:v>79.200000000000017</c:v>
                </c:pt>
                <c:pt idx="91">
                  <c:v>79.661016949152611</c:v>
                </c:pt>
                <c:pt idx="92">
                  <c:v>79.661016949152611</c:v>
                </c:pt>
                <c:pt idx="93">
                  <c:v>81.818181818181785</c:v>
                </c:pt>
                <c:pt idx="94">
                  <c:v>86.1111111111112</c:v>
                </c:pt>
                <c:pt idx="95">
                  <c:v>87.8787878787877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22496"/>
        <c:axId val="168923072"/>
      </c:scatterChart>
      <c:valAx>
        <c:axId val="168922496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68923072"/>
        <c:crosses val="autoZero"/>
        <c:crossBetween val="midCat"/>
      </c:valAx>
      <c:valAx>
        <c:axId val="1689230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8922496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6031828091811628"/>
          <c:y val="0.45843018800449575"/>
          <c:w val="0.28412642344508798"/>
          <c:h val="0.38588976448349854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946367911982844"/>
          <c:y val="5.1400554097404488E-2"/>
          <c:w val="0.71782428215046812"/>
          <c:h val="0.80947142023913676"/>
        </c:manualLayout>
      </c:layout>
      <c:scatterChart>
        <c:scatterStyle val="lineMarker"/>
        <c:varyColors val="0"/>
        <c:ser>
          <c:idx val="7"/>
          <c:order val="0"/>
          <c:tx>
            <c:strRef>
              <c:f>Temperature!$J$1</c:f>
              <c:strCache>
                <c:ptCount val="1"/>
                <c:pt idx="0">
                  <c:v>T (35'C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Temperature!$B$2:$B$97</c:f>
              <c:strCache>
                <c:ptCount val="96"/>
                <c:pt idx="0">
                  <c:v>A3</c:v>
                </c:pt>
                <c:pt idx="1">
                  <c:v>D11</c:v>
                </c:pt>
                <c:pt idx="2">
                  <c:v>C3</c:v>
                </c:pt>
                <c:pt idx="3">
                  <c:v>A6</c:v>
                </c:pt>
                <c:pt idx="4">
                  <c:v>F10</c:v>
                </c:pt>
                <c:pt idx="5">
                  <c:v>H12</c:v>
                </c:pt>
                <c:pt idx="6">
                  <c:v>F12</c:v>
                </c:pt>
                <c:pt idx="7">
                  <c:v>G1</c:v>
                </c:pt>
                <c:pt idx="8">
                  <c:v>H11</c:v>
                </c:pt>
                <c:pt idx="9">
                  <c:v>H8</c:v>
                </c:pt>
                <c:pt idx="10">
                  <c:v>G4</c:v>
                </c:pt>
                <c:pt idx="11">
                  <c:v>F8</c:v>
                </c:pt>
                <c:pt idx="12">
                  <c:v>G8</c:v>
                </c:pt>
                <c:pt idx="13">
                  <c:v>H1</c:v>
                </c:pt>
                <c:pt idx="14">
                  <c:v>C1</c:v>
                </c:pt>
                <c:pt idx="15">
                  <c:v>F2</c:v>
                </c:pt>
                <c:pt idx="16">
                  <c:v>H9</c:v>
                </c:pt>
                <c:pt idx="17">
                  <c:v>G10</c:v>
                </c:pt>
                <c:pt idx="18">
                  <c:v>H2</c:v>
                </c:pt>
                <c:pt idx="19">
                  <c:v>A1</c:v>
                </c:pt>
                <c:pt idx="20">
                  <c:v>C8</c:v>
                </c:pt>
                <c:pt idx="21">
                  <c:v>H3</c:v>
                </c:pt>
                <c:pt idx="22">
                  <c:v>C4</c:v>
                </c:pt>
                <c:pt idx="23">
                  <c:v>H7</c:v>
                </c:pt>
                <c:pt idx="24">
                  <c:v>H10</c:v>
                </c:pt>
                <c:pt idx="25">
                  <c:v>B12</c:v>
                </c:pt>
                <c:pt idx="26">
                  <c:v>G5</c:v>
                </c:pt>
                <c:pt idx="27">
                  <c:v>B5</c:v>
                </c:pt>
                <c:pt idx="28">
                  <c:v>G7</c:v>
                </c:pt>
                <c:pt idx="29">
                  <c:v>G12</c:v>
                </c:pt>
                <c:pt idx="30">
                  <c:v>F7</c:v>
                </c:pt>
                <c:pt idx="31">
                  <c:v>G9</c:v>
                </c:pt>
                <c:pt idx="32">
                  <c:v>F9</c:v>
                </c:pt>
                <c:pt idx="33">
                  <c:v>G11</c:v>
                </c:pt>
                <c:pt idx="34">
                  <c:v>G3</c:v>
                </c:pt>
                <c:pt idx="35">
                  <c:v>C5</c:v>
                </c:pt>
                <c:pt idx="36">
                  <c:v>C12</c:v>
                </c:pt>
                <c:pt idx="37">
                  <c:v>G2</c:v>
                </c:pt>
                <c:pt idx="38">
                  <c:v>C11</c:v>
                </c:pt>
                <c:pt idx="39">
                  <c:v>F11</c:v>
                </c:pt>
                <c:pt idx="40">
                  <c:v>H5</c:v>
                </c:pt>
                <c:pt idx="41">
                  <c:v>B1</c:v>
                </c:pt>
                <c:pt idx="42">
                  <c:v>B2</c:v>
                </c:pt>
                <c:pt idx="43">
                  <c:v>D10</c:v>
                </c:pt>
                <c:pt idx="44">
                  <c:v>C9</c:v>
                </c:pt>
                <c:pt idx="45">
                  <c:v>B10</c:v>
                </c:pt>
                <c:pt idx="46">
                  <c:v>A8</c:v>
                </c:pt>
                <c:pt idx="47">
                  <c:v>E1</c:v>
                </c:pt>
                <c:pt idx="48">
                  <c:v>C2</c:v>
                </c:pt>
                <c:pt idx="49">
                  <c:v>G6</c:v>
                </c:pt>
                <c:pt idx="50">
                  <c:v>F4</c:v>
                </c:pt>
                <c:pt idx="51">
                  <c:v>A4</c:v>
                </c:pt>
                <c:pt idx="52">
                  <c:v>B8</c:v>
                </c:pt>
                <c:pt idx="53">
                  <c:v>H4</c:v>
                </c:pt>
                <c:pt idx="54">
                  <c:v>A11</c:v>
                </c:pt>
                <c:pt idx="55">
                  <c:v>A12</c:v>
                </c:pt>
                <c:pt idx="56">
                  <c:v>B6</c:v>
                </c:pt>
                <c:pt idx="57">
                  <c:v>E7</c:v>
                </c:pt>
                <c:pt idx="58">
                  <c:v>D7</c:v>
                </c:pt>
                <c:pt idx="59">
                  <c:v>C7</c:v>
                </c:pt>
                <c:pt idx="60">
                  <c:v>D6</c:v>
                </c:pt>
                <c:pt idx="61">
                  <c:v>C6</c:v>
                </c:pt>
                <c:pt idx="62">
                  <c:v>B3</c:v>
                </c:pt>
                <c:pt idx="63">
                  <c:v>B11</c:v>
                </c:pt>
                <c:pt idx="64">
                  <c:v>B7</c:v>
                </c:pt>
                <c:pt idx="65">
                  <c:v>E6</c:v>
                </c:pt>
                <c:pt idx="66">
                  <c:v>E3</c:v>
                </c:pt>
                <c:pt idx="67">
                  <c:v>D4</c:v>
                </c:pt>
                <c:pt idx="68">
                  <c:v>B4</c:v>
                </c:pt>
                <c:pt idx="69">
                  <c:v>D2</c:v>
                </c:pt>
                <c:pt idx="70">
                  <c:v>A5</c:v>
                </c:pt>
                <c:pt idx="71">
                  <c:v>E5</c:v>
                </c:pt>
                <c:pt idx="72">
                  <c:v>A10</c:v>
                </c:pt>
                <c:pt idx="73">
                  <c:v>E2</c:v>
                </c:pt>
                <c:pt idx="74">
                  <c:v>F3</c:v>
                </c:pt>
                <c:pt idx="75">
                  <c:v>E10</c:v>
                </c:pt>
                <c:pt idx="76">
                  <c:v>E9</c:v>
                </c:pt>
                <c:pt idx="77">
                  <c:v>D5</c:v>
                </c:pt>
                <c:pt idx="78">
                  <c:v>H6</c:v>
                </c:pt>
                <c:pt idx="79">
                  <c:v>A9</c:v>
                </c:pt>
                <c:pt idx="80">
                  <c:v>B9</c:v>
                </c:pt>
                <c:pt idx="81">
                  <c:v>D3</c:v>
                </c:pt>
                <c:pt idx="82">
                  <c:v>F6</c:v>
                </c:pt>
                <c:pt idx="83">
                  <c:v>C10</c:v>
                </c:pt>
                <c:pt idx="84">
                  <c:v>E8</c:v>
                </c:pt>
                <c:pt idx="85">
                  <c:v>A7</c:v>
                </c:pt>
                <c:pt idx="86">
                  <c:v>D1</c:v>
                </c:pt>
                <c:pt idx="87">
                  <c:v>A2</c:v>
                </c:pt>
                <c:pt idx="88">
                  <c:v>D12</c:v>
                </c:pt>
                <c:pt idx="89">
                  <c:v>D9</c:v>
                </c:pt>
                <c:pt idx="90">
                  <c:v>E4</c:v>
                </c:pt>
                <c:pt idx="91">
                  <c:v>D8</c:v>
                </c:pt>
                <c:pt idx="92">
                  <c:v>E11</c:v>
                </c:pt>
                <c:pt idx="93">
                  <c:v>E12</c:v>
                </c:pt>
                <c:pt idx="94">
                  <c:v>F1</c:v>
                </c:pt>
                <c:pt idx="95">
                  <c:v>F5</c:v>
                </c:pt>
              </c:strCache>
            </c:strRef>
          </c:xVal>
          <c:yVal>
            <c:numRef>
              <c:f>Temperature!$J$2:$J$97</c:f>
              <c:numCache>
                <c:formatCode>General</c:formatCode>
                <c:ptCount val="96"/>
                <c:pt idx="0">
                  <c:v>0</c:v>
                </c:pt>
                <c:pt idx="1">
                  <c:v>0</c:v>
                </c:pt>
                <c:pt idx="2">
                  <c:v>15.624999999999925</c:v>
                </c:pt>
                <c:pt idx="3">
                  <c:v>40.800000000000011</c:v>
                </c:pt>
                <c:pt idx="4">
                  <c:v>47.887323943661983</c:v>
                </c:pt>
                <c:pt idx="5">
                  <c:v>50</c:v>
                </c:pt>
                <c:pt idx="6">
                  <c:v>52.027027027027039</c:v>
                </c:pt>
                <c:pt idx="7">
                  <c:v>54.716981132075503</c:v>
                </c:pt>
                <c:pt idx="8">
                  <c:v>57.258064516129046</c:v>
                </c:pt>
                <c:pt idx="9">
                  <c:v>57.600000000000016</c:v>
                </c:pt>
                <c:pt idx="10">
                  <c:v>58.108108108108112</c:v>
                </c:pt>
                <c:pt idx="11">
                  <c:v>59.605911330049274</c:v>
                </c:pt>
                <c:pt idx="12">
                  <c:v>59.836065573770483</c:v>
                </c:pt>
                <c:pt idx="13">
                  <c:v>61.702127659574458</c:v>
                </c:pt>
                <c:pt idx="14">
                  <c:v>61.702127659574479</c:v>
                </c:pt>
                <c:pt idx="15">
                  <c:v>62.626262626262609</c:v>
                </c:pt>
                <c:pt idx="16">
                  <c:v>62.903225806451601</c:v>
                </c:pt>
                <c:pt idx="17">
                  <c:v>63.114754098360656</c:v>
                </c:pt>
                <c:pt idx="18">
                  <c:v>64.077669902912632</c:v>
                </c:pt>
                <c:pt idx="19">
                  <c:v>64.186046511627993</c:v>
                </c:pt>
                <c:pt idx="20">
                  <c:v>67.164179104477626</c:v>
                </c:pt>
                <c:pt idx="21">
                  <c:v>70.588235294117652</c:v>
                </c:pt>
                <c:pt idx="22">
                  <c:v>71.15384615384616</c:v>
                </c:pt>
                <c:pt idx="23">
                  <c:v>73.267326732673268</c:v>
                </c:pt>
                <c:pt idx="24">
                  <c:v>73.333333333333357</c:v>
                </c:pt>
                <c:pt idx="25">
                  <c:v>74.576271186440664</c:v>
                </c:pt>
                <c:pt idx="26">
                  <c:v>76.666666666666629</c:v>
                </c:pt>
                <c:pt idx="27">
                  <c:v>76.92307692307692</c:v>
                </c:pt>
                <c:pt idx="28">
                  <c:v>79.77528089887636</c:v>
                </c:pt>
                <c:pt idx="29">
                  <c:v>80.952380952380921</c:v>
                </c:pt>
                <c:pt idx="30">
                  <c:v>82.608695652173878</c:v>
                </c:pt>
                <c:pt idx="31">
                  <c:v>85.833333333333357</c:v>
                </c:pt>
                <c:pt idx="32">
                  <c:v>90.871369294605913</c:v>
                </c:pt>
                <c:pt idx="33">
                  <c:v>90.909090909090892</c:v>
                </c:pt>
                <c:pt idx="34">
                  <c:v>91.83673469387756</c:v>
                </c:pt>
                <c:pt idx="35">
                  <c:v>92.156862745097982</c:v>
                </c:pt>
                <c:pt idx="36">
                  <c:v>92.682926829268311</c:v>
                </c:pt>
                <c:pt idx="37">
                  <c:v>93.548387096774192</c:v>
                </c:pt>
                <c:pt idx="38">
                  <c:v>94.117647058823479</c:v>
                </c:pt>
                <c:pt idx="39">
                  <c:v>95.45454545454551</c:v>
                </c:pt>
                <c:pt idx="40">
                  <c:v>95.652173913043441</c:v>
                </c:pt>
                <c:pt idx="41">
                  <c:v>96.610169491525397</c:v>
                </c:pt>
                <c:pt idx="42">
                  <c:v>96.721311475409749</c:v>
                </c:pt>
                <c:pt idx="43">
                  <c:v>96.874999999999972</c:v>
                </c:pt>
                <c:pt idx="44">
                  <c:v>97.619047619047549</c:v>
                </c:pt>
                <c:pt idx="45">
                  <c:v>100</c:v>
                </c:pt>
                <c:pt idx="46">
                  <c:v>100</c:v>
                </c:pt>
                <c:pt idx="47">
                  <c:v>105.66037735849056</c:v>
                </c:pt>
                <c:pt idx="48">
                  <c:v>106.59340659340657</c:v>
                </c:pt>
                <c:pt idx="49">
                  <c:v>107.46268656716418</c:v>
                </c:pt>
                <c:pt idx="50">
                  <c:v>107.86516853932582</c:v>
                </c:pt>
                <c:pt idx="51">
                  <c:v>108.00000000000006</c:v>
                </c:pt>
                <c:pt idx="52">
                  <c:v>109.09090909090912</c:v>
                </c:pt>
                <c:pt idx="53">
                  <c:v>109.37499999999993</c:v>
                </c:pt>
                <c:pt idx="54">
                  <c:v>109.80392156862749</c:v>
                </c:pt>
                <c:pt idx="55">
                  <c:v>110.00000000000007</c:v>
                </c:pt>
                <c:pt idx="56">
                  <c:v>110.16949152542372</c:v>
                </c:pt>
                <c:pt idx="57">
                  <c:v>111.68831168831169</c:v>
                </c:pt>
                <c:pt idx="58">
                  <c:v>115.51724137931043</c:v>
                </c:pt>
                <c:pt idx="59">
                  <c:v>118.36734693877551</c:v>
                </c:pt>
                <c:pt idx="60">
                  <c:v>120.58823529411767</c:v>
                </c:pt>
                <c:pt idx="61">
                  <c:v>122.22222222222223</c:v>
                </c:pt>
                <c:pt idx="62">
                  <c:v>123.52941176470587</c:v>
                </c:pt>
                <c:pt idx="63">
                  <c:v>124.44444444444447</c:v>
                </c:pt>
                <c:pt idx="64">
                  <c:v>125.00000000000011</c:v>
                </c:pt>
                <c:pt idx="65">
                  <c:v>125.45454545454548</c:v>
                </c:pt>
                <c:pt idx="66">
                  <c:v>126.31578947368421</c:v>
                </c:pt>
                <c:pt idx="67">
                  <c:v>128.39506172839506</c:v>
                </c:pt>
                <c:pt idx="68">
                  <c:v>132.72727272727275</c:v>
                </c:pt>
                <c:pt idx="69">
                  <c:v>138.88888888888889</c:v>
                </c:pt>
                <c:pt idx="70">
                  <c:v>140.65040650406519</c:v>
                </c:pt>
                <c:pt idx="71">
                  <c:v>141.93548387096774</c:v>
                </c:pt>
                <c:pt idx="72">
                  <c:v>149.01960784313724</c:v>
                </c:pt>
                <c:pt idx="73">
                  <c:v>155.17241379310337</c:v>
                </c:pt>
                <c:pt idx="74">
                  <c:v>155.93220338983059</c:v>
                </c:pt>
                <c:pt idx="75">
                  <c:v>156.25000000000003</c:v>
                </c:pt>
                <c:pt idx="76">
                  <c:v>156.41025641025635</c:v>
                </c:pt>
                <c:pt idx="77">
                  <c:v>156.86274509803923</c:v>
                </c:pt>
                <c:pt idx="78">
                  <c:v>158.33333333333334</c:v>
                </c:pt>
                <c:pt idx="79">
                  <c:v>158.53658536585365</c:v>
                </c:pt>
                <c:pt idx="80">
                  <c:v>163.88888888888891</c:v>
                </c:pt>
                <c:pt idx="81">
                  <c:v>166.66666666666669</c:v>
                </c:pt>
                <c:pt idx="82">
                  <c:v>169.84126984126985</c:v>
                </c:pt>
                <c:pt idx="83">
                  <c:v>170.83333333333309</c:v>
                </c:pt>
                <c:pt idx="84">
                  <c:v>176.5957446808512</c:v>
                </c:pt>
                <c:pt idx="85">
                  <c:v>177.7777777777778</c:v>
                </c:pt>
                <c:pt idx="86">
                  <c:v>178.04878048780481</c:v>
                </c:pt>
                <c:pt idx="87">
                  <c:v>178.12499999999991</c:v>
                </c:pt>
                <c:pt idx="88">
                  <c:v>211.42857142857125</c:v>
                </c:pt>
                <c:pt idx="89">
                  <c:v>227.41935483870955</c:v>
                </c:pt>
                <c:pt idx="90">
                  <c:v>240</c:v>
                </c:pt>
                <c:pt idx="91">
                  <c:v>247.50000000000009</c:v>
                </c:pt>
                <c:pt idx="92">
                  <c:v>288.88888888888886</c:v>
                </c:pt>
                <c:pt idx="93">
                  <c:v>313.33333333333326</c:v>
                </c:pt>
                <c:pt idx="94">
                  <c:v>351.51515151515156</c:v>
                </c:pt>
                <c:pt idx="95">
                  <c:v>477.777777777777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24800"/>
        <c:axId val="168925376"/>
      </c:scatterChart>
      <c:valAx>
        <c:axId val="16892480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68925376"/>
        <c:crosses val="autoZero"/>
        <c:crossBetween val="midCat"/>
      </c:valAx>
      <c:valAx>
        <c:axId val="168925376"/>
        <c:scaling>
          <c:orientation val="minMax"/>
          <c:max val="5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8924800"/>
        <c:crosses val="autoZero"/>
        <c:crossBetween val="midCat"/>
        <c:majorUnit val="100"/>
      </c:valAx>
    </c:plotArea>
    <c:legend>
      <c:legendPos val="r"/>
      <c:layout>
        <c:manualLayout>
          <c:xMode val="edge"/>
          <c:yMode val="edge"/>
          <c:x val="0.27054190948480461"/>
          <c:y val="6.9679166240931872E-2"/>
          <c:w val="0.29057377463110162"/>
          <c:h val="0.4710473170020413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75014474983821"/>
          <c:y val="5.5546740892657646E-2"/>
          <c:w val="0.72569011614045842"/>
          <c:h val="0.81873067949839606"/>
        </c:manualLayout>
      </c:layout>
      <c:scatterChart>
        <c:scatterStyle val="lineMarker"/>
        <c:varyColors val="0"/>
        <c:ser>
          <c:idx val="0"/>
          <c:order val="0"/>
          <c:tx>
            <c:strRef>
              <c:f>'acetic acid'!$C$1</c:f>
              <c:strCache>
                <c:ptCount val="1"/>
                <c:pt idx="0">
                  <c:v>Acetic aci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acetic acid'!$B$2:$B$97</c:f>
              <c:strCache>
                <c:ptCount val="96"/>
                <c:pt idx="0">
                  <c:v>H5</c:v>
                </c:pt>
                <c:pt idx="1">
                  <c:v>C3</c:v>
                </c:pt>
                <c:pt idx="2">
                  <c:v>E7</c:v>
                </c:pt>
                <c:pt idx="3">
                  <c:v>D10</c:v>
                </c:pt>
                <c:pt idx="4">
                  <c:v>F7</c:v>
                </c:pt>
                <c:pt idx="5">
                  <c:v>D3</c:v>
                </c:pt>
                <c:pt idx="6">
                  <c:v>E9</c:v>
                </c:pt>
                <c:pt idx="7">
                  <c:v>C10</c:v>
                </c:pt>
                <c:pt idx="8">
                  <c:v>B8</c:v>
                </c:pt>
                <c:pt idx="9">
                  <c:v>F2</c:v>
                </c:pt>
                <c:pt idx="10">
                  <c:v>D7</c:v>
                </c:pt>
                <c:pt idx="11">
                  <c:v>D12</c:v>
                </c:pt>
                <c:pt idx="12">
                  <c:v>E5</c:v>
                </c:pt>
                <c:pt idx="13">
                  <c:v>D11</c:v>
                </c:pt>
                <c:pt idx="14">
                  <c:v>F4</c:v>
                </c:pt>
                <c:pt idx="15">
                  <c:v>H6</c:v>
                </c:pt>
                <c:pt idx="16">
                  <c:v>H12</c:v>
                </c:pt>
                <c:pt idx="17">
                  <c:v>E2</c:v>
                </c:pt>
                <c:pt idx="18">
                  <c:v>D4</c:v>
                </c:pt>
                <c:pt idx="19">
                  <c:v>E4</c:v>
                </c:pt>
                <c:pt idx="20">
                  <c:v>C2</c:v>
                </c:pt>
                <c:pt idx="21">
                  <c:v>D2</c:v>
                </c:pt>
                <c:pt idx="22">
                  <c:v>B12</c:v>
                </c:pt>
                <c:pt idx="23">
                  <c:v>A4</c:v>
                </c:pt>
                <c:pt idx="24">
                  <c:v>E10</c:v>
                </c:pt>
                <c:pt idx="25">
                  <c:v>C12</c:v>
                </c:pt>
                <c:pt idx="26">
                  <c:v>F5</c:v>
                </c:pt>
                <c:pt idx="27">
                  <c:v>C4</c:v>
                </c:pt>
                <c:pt idx="28">
                  <c:v>B10</c:v>
                </c:pt>
                <c:pt idx="29">
                  <c:v>F1</c:v>
                </c:pt>
                <c:pt idx="30">
                  <c:v>F3</c:v>
                </c:pt>
                <c:pt idx="31">
                  <c:v>B9</c:v>
                </c:pt>
                <c:pt idx="32">
                  <c:v>E8</c:v>
                </c:pt>
                <c:pt idx="33">
                  <c:v>H7</c:v>
                </c:pt>
                <c:pt idx="34">
                  <c:v>D1</c:v>
                </c:pt>
                <c:pt idx="35">
                  <c:v>H9</c:v>
                </c:pt>
                <c:pt idx="36">
                  <c:v>C7</c:v>
                </c:pt>
                <c:pt idx="37">
                  <c:v>D6</c:v>
                </c:pt>
                <c:pt idx="38">
                  <c:v>H10</c:v>
                </c:pt>
                <c:pt idx="39">
                  <c:v>A9</c:v>
                </c:pt>
                <c:pt idx="40">
                  <c:v>E11</c:v>
                </c:pt>
                <c:pt idx="41">
                  <c:v>H3</c:v>
                </c:pt>
                <c:pt idx="42">
                  <c:v>H1</c:v>
                </c:pt>
                <c:pt idx="43">
                  <c:v>B2</c:v>
                </c:pt>
                <c:pt idx="44">
                  <c:v>D5</c:v>
                </c:pt>
                <c:pt idx="45">
                  <c:v>F9</c:v>
                </c:pt>
                <c:pt idx="46">
                  <c:v>D9</c:v>
                </c:pt>
                <c:pt idx="47">
                  <c:v>A10</c:v>
                </c:pt>
                <c:pt idx="48">
                  <c:v>F11</c:v>
                </c:pt>
                <c:pt idx="49">
                  <c:v>F10</c:v>
                </c:pt>
                <c:pt idx="50">
                  <c:v>A7</c:v>
                </c:pt>
                <c:pt idx="51">
                  <c:v>B4</c:v>
                </c:pt>
                <c:pt idx="52">
                  <c:v>A11</c:v>
                </c:pt>
                <c:pt idx="53">
                  <c:v>C11</c:v>
                </c:pt>
                <c:pt idx="54">
                  <c:v>A2</c:v>
                </c:pt>
                <c:pt idx="55">
                  <c:v>G5</c:v>
                </c:pt>
                <c:pt idx="56">
                  <c:v>G10</c:v>
                </c:pt>
                <c:pt idx="57">
                  <c:v>B1</c:v>
                </c:pt>
                <c:pt idx="58">
                  <c:v>G6</c:v>
                </c:pt>
                <c:pt idx="59">
                  <c:v>G9</c:v>
                </c:pt>
                <c:pt idx="60">
                  <c:v>E1</c:v>
                </c:pt>
                <c:pt idx="61">
                  <c:v>A6</c:v>
                </c:pt>
                <c:pt idx="62">
                  <c:v>C1</c:v>
                </c:pt>
                <c:pt idx="63">
                  <c:v>E3</c:v>
                </c:pt>
                <c:pt idx="64">
                  <c:v>B3</c:v>
                </c:pt>
                <c:pt idx="65">
                  <c:v>H2</c:v>
                </c:pt>
                <c:pt idx="66">
                  <c:v>G2</c:v>
                </c:pt>
                <c:pt idx="67">
                  <c:v>C8</c:v>
                </c:pt>
                <c:pt idx="68">
                  <c:v>G7</c:v>
                </c:pt>
                <c:pt idx="69">
                  <c:v>E12</c:v>
                </c:pt>
                <c:pt idx="70">
                  <c:v>B5</c:v>
                </c:pt>
                <c:pt idx="71">
                  <c:v>A8</c:v>
                </c:pt>
                <c:pt idx="72">
                  <c:v>C6</c:v>
                </c:pt>
                <c:pt idx="73">
                  <c:v>A3</c:v>
                </c:pt>
                <c:pt idx="74">
                  <c:v>B6</c:v>
                </c:pt>
                <c:pt idx="75">
                  <c:v>G3</c:v>
                </c:pt>
                <c:pt idx="76">
                  <c:v>C5</c:v>
                </c:pt>
                <c:pt idx="77">
                  <c:v>B7</c:v>
                </c:pt>
                <c:pt idx="78">
                  <c:v>H4</c:v>
                </c:pt>
                <c:pt idx="79">
                  <c:v>G4</c:v>
                </c:pt>
                <c:pt idx="80">
                  <c:v>G12</c:v>
                </c:pt>
                <c:pt idx="81">
                  <c:v>B11</c:v>
                </c:pt>
                <c:pt idx="82">
                  <c:v>E6</c:v>
                </c:pt>
                <c:pt idx="83">
                  <c:v>G8</c:v>
                </c:pt>
                <c:pt idx="84">
                  <c:v>F8</c:v>
                </c:pt>
                <c:pt idx="85">
                  <c:v>C9</c:v>
                </c:pt>
                <c:pt idx="86">
                  <c:v>G1</c:v>
                </c:pt>
                <c:pt idx="87">
                  <c:v>A5</c:v>
                </c:pt>
                <c:pt idx="88">
                  <c:v>H8</c:v>
                </c:pt>
                <c:pt idx="89">
                  <c:v>D8</c:v>
                </c:pt>
                <c:pt idx="90">
                  <c:v>A1</c:v>
                </c:pt>
                <c:pt idx="91">
                  <c:v>A12</c:v>
                </c:pt>
                <c:pt idx="92">
                  <c:v>F6</c:v>
                </c:pt>
                <c:pt idx="93">
                  <c:v>G11</c:v>
                </c:pt>
                <c:pt idx="94">
                  <c:v>H11</c:v>
                </c:pt>
                <c:pt idx="95">
                  <c:v>F12</c:v>
                </c:pt>
              </c:strCache>
            </c:strRef>
          </c:xVal>
          <c:yVal>
            <c:numRef>
              <c:f>'acetic acid'!$C$2:$C$97</c:f>
              <c:numCache>
                <c:formatCode>General</c:formatCode>
                <c:ptCount val="96"/>
                <c:pt idx="0">
                  <c:v>70.535714285714292</c:v>
                </c:pt>
                <c:pt idx="1">
                  <c:v>75.000000000000014</c:v>
                </c:pt>
                <c:pt idx="2">
                  <c:v>79.047619047619051</c:v>
                </c:pt>
                <c:pt idx="3">
                  <c:v>79.090909090909079</c:v>
                </c:pt>
                <c:pt idx="4">
                  <c:v>79.245283018867937</c:v>
                </c:pt>
                <c:pt idx="5">
                  <c:v>80</c:v>
                </c:pt>
                <c:pt idx="6">
                  <c:v>80.612244897959201</c:v>
                </c:pt>
                <c:pt idx="7">
                  <c:v>80.991735537190067</c:v>
                </c:pt>
                <c:pt idx="8">
                  <c:v>81.308411214953253</c:v>
                </c:pt>
                <c:pt idx="9">
                  <c:v>82.075471698113176</c:v>
                </c:pt>
                <c:pt idx="10">
                  <c:v>82.352941176470608</c:v>
                </c:pt>
                <c:pt idx="11">
                  <c:v>82.72727272727272</c:v>
                </c:pt>
                <c:pt idx="12">
                  <c:v>82.758620689655174</c:v>
                </c:pt>
                <c:pt idx="13">
                  <c:v>83.146067415730343</c:v>
                </c:pt>
                <c:pt idx="14">
                  <c:v>83.653846153846132</c:v>
                </c:pt>
                <c:pt idx="15">
                  <c:v>83.846153846153854</c:v>
                </c:pt>
                <c:pt idx="16">
                  <c:v>84.027777777777786</c:v>
                </c:pt>
                <c:pt idx="17">
                  <c:v>84.545454545454518</c:v>
                </c:pt>
                <c:pt idx="18">
                  <c:v>85.148514851485146</c:v>
                </c:pt>
                <c:pt idx="19">
                  <c:v>86.274509803921575</c:v>
                </c:pt>
                <c:pt idx="20">
                  <c:v>87.155963302752284</c:v>
                </c:pt>
                <c:pt idx="21">
                  <c:v>87.155963302752284</c:v>
                </c:pt>
                <c:pt idx="22">
                  <c:v>87.5</c:v>
                </c:pt>
                <c:pt idx="23">
                  <c:v>87.594936708860786</c:v>
                </c:pt>
                <c:pt idx="24">
                  <c:v>87.619047619047606</c:v>
                </c:pt>
                <c:pt idx="25">
                  <c:v>87.786259541984762</c:v>
                </c:pt>
                <c:pt idx="26">
                  <c:v>87.804878048780495</c:v>
                </c:pt>
                <c:pt idx="27">
                  <c:v>87.826086956521749</c:v>
                </c:pt>
                <c:pt idx="28">
                  <c:v>88</c:v>
                </c:pt>
                <c:pt idx="29">
                  <c:v>88.181818181818159</c:v>
                </c:pt>
                <c:pt idx="30">
                  <c:v>88.549618320610691</c:v>
                </c:pt>
                <c:pt idx="31">
                  <c:v>88.749999999999972</c:v>
                </c:pt>
                <c:pt idx="32">
                  <c:v>88.775510204081669</c:v>
                </c:pt>
                <c:pt idx="33">
                  <c:v>88.8888888888889</c:v>
                </c:pt>
                <c:pt idx="34">
                  <c:v>88.983050847457648</c:v>
                </c:pt>
                <c:pt idx="35">
                  <c:v>89.130434782608688</c:v>
                </c:pt>
                <c:pt idx="36">
                  <c:v>89.189189189189179</c:v>
                </c:pt>
                <c:pt idx="37">
                  <c:v>89.215686274509835</c:v>
                </c:pt>
                <c:pt idx="38">
                  <c:v>89.344262295082018</c:v>
                </c:pt>
                <c:pt idx="39">
                  <c:v>89.354838709677438</c:v>
                </c:pt>
                <c:pt idx="40">
                  <c:v>89.583333333333329</c:v>
                </c:pt>
                <c:pt idx="41">
                  <c:v>89.6</c:v>
                </c:pt>
                <c:pt idx="42">
                  <c:v>89.600000000000009</c:v>
                </c:pt>
                <c:pt idx="43">
                  <c:v>89.622641509433947</c:v>
                </c:pt>
                <c:pt idx="44">
                  <c:v>89.622641509433961</c:v>
                </c:pt>
                <c:pt idx="45">
                  <c:v>89.622641509433961</c:v>
                </c:pt>
                <c:pt idx="46">
                  <c:v>90.090090090090115</c:v>
                </c:pt>
                <c:pt idx="47">
                  <c:v>91.081081081081081</c:v>
                </c:pt>
                <c:pt idx="48">
                  <c:v>91.578947368421012</c:v>
                </c:pt>
                <c:pt idx="49">
                  <c:v>91.588785046728972</c:v>
                </c:pt>
                <c:pt idx="50">
                  <c:v>92.151898734177237</c:v>
                </c:pt>
                <c:pt idx="51">
                  <c:v>92.241379310344826</c:v>
                </c:pt>
                <c:pt idx="52">
                  <c:v>92.250000000000028</c:v>
                </c:pt>
                <c:pt idx="53">
                  <c:v>92.391304347826079</c:v>
                </c:pt>
                <c:pt idx="54">
                  <c:v>92.732558139534859</c:v>
                </c:pt>
                <c:pt idx="55">
                  <c:v>92.741935483870989</c:v>
                </c:pt>
                <c:pt idx="56">
                  <c:v>92.857142857142847</c:v>
                </c:pt>
                <c:pt idx="57">
                  <c:v>92.929292929292941</c:v>
                </c:pt>
                <c:pt idx="58">
                  <c:v>93.000000000000014</c:v>
                </c:pt>
                <c:pt idx="59">
                  <c:v>93.069306930693088</c:v>
                </c:pt>
                <c:pt idx="60">
                  <c:v>93.137254901960802</c:v>
                </c:pt>
                <c:pt idx="61">
                  <c:v>93.215339233038335</c:v>
                </c:pt>
                <c:pt idx="62">
                  <c:v>93.269230769230788</c:v>
                </c:pt>
                <c:pt idx="63">
                  <c:v>93.45794392523365</c:v>
                </c:pt>
                <c:pt idx="64">
                  <c:v>93.577981651376163</c:v>
                </c:pt>
                <c:pt idx="65">
                  <c:v>93.636363636363654</c:v>
                </c:pt>
                <c:pt idx="66">
                  <c:v>93.693693693693689</c:v>
                </c:pt>
                <c:pt idx="67">
                  <c:v>93.877551020408191</c:v>
                </c:pt>
                <c:pt idx="68">
                  <c:v>93.939393939393952</c:v>
                </c:pt>
                <c:pt idx="69">
                  <c:v>94.392523364485953</c:v>
                </c:pt>
                <c:pt idx="70">
                  <c:v>94.791666666666629</c:v>
                </c:pt>
                <c:pt idx="71">
                  <c:v>94.920634920634896</c:v>
                </c:pt>
                <c:pt idx="72">
                  <c:v>95.238095238095241</c:v>
                </c:pt>
                <c:pt idx="73">
                  <c:v>95.379537953795364</c:v>
                </c:pt>
                <c:pt idx="74">
                  <c:v>95.652173913043484</c:v>
                </c:pt>
                <c:pt idx="75">
                  <c:v>95.689655172413808</c:v>
                </c:pt>
                <c:pt idx="76">
                  <c:v>95.78947368421052</c:v>
                </c:pt>
                <c:pt idx="77">
                  <c:v>96.590909090909093</c:v>
                </c:pt>
                <c:pt idx="78">
                  <c:v>96.774193548387103</c:v>
                </c:pt>
                <c:pt idx="79">
                  <c:v>96.938775510204081</c:v>
                </c:pt>
                <c:pt idx="80">
                  <c:v>96.999999999999957</c:v>
                </c:pt>
                <c:pt idx="81">
                  <c:v>97.029702970297052</c:v>
                </c:pt>
                <c:pt idx="82">
                  <c:v>97.142857142857125</c:v>
                </c:pt>
                <c:pt idx="83">
                  <c:v>97.916666666666671</c:v>
                </c:pt>
                <c:pt idx="84">
                  <c:v>98.019801980197983</c:v>
                </c:pt>
                <c:pt idx="85">
                  <c:v>98.91304347826086</c:v>
                </c:pt>
                <c:pt idx="86">
                  <c:v>99.099099099099092</c:v>
                </c:pt>
                <c:pt idx="87">
                  <c:v>99.710982658959566</c:v>
                </c:pt>
                <c:pt idx="88">
                  <c:v>100.80000000000003</c:v>
                </c:pt>
                <c:pt idx="89">
                  <c:v>101.09890109890112</c:v>
                </c:pt>
                <c:pt idx="90">
                  <c:v>101.18694362017804</c:v>
                </c:pt>
                <c:pt idx="91">
                  <c:v>102.41691842900306</c:v>
                </c:pt>
                <c:pt idx="92">
                  <c:v>105.45454545454544</c:v>
                </c:pt>
                <c:pt idx="93">
                  <c:v>107.5</c:v>
                </c:pt>
                <c:pt idx="94">
                  <c:v>108.5106382978723</c:v>
                </c:pt>
                <c:pt idx="95">
                  <c:v>113.4615384615384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081024"/>
        <c:axId val="34081600"/>
      </c:scatterChart>
      <c:valAx>
        <c:axId val="3408102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Haploid segregant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4081600"/>
        <c:crosses val="autoZero"/>
        <c:crossBetween val="midCat"/>
      </c:valAx>
      <c:valAx>
        <c:axId val="34081600"/>
        <c:scaling>
          <c:orientation val="minMax"/>
          <c:min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408102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3671877660842615"/>
          <c:y val="0.62006648214639004"/>
          <c:w val="0.37639555873437558"/>
          <c:h val="9.9851521900519657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1715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6145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7494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3330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7979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842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0854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706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9635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5101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0575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FDA2BC-F9A0-46C6-905E-D06EAE86889D}" type="datetimeFigureOut">
              <a:rPr lang="en-GB" smtClean="0"/>
              <a:t>09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03C1D-785C-4B8B-9DDF-332120B69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3332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5.xml"/><Relationship Id="rId3" Type="http://schemas.openxmlformats.org/officeDocument/2006/relationships/chart" Target="../charts/chart10.xml"/><Relationship Id="rId7" Type="http://schemas.openxmlformats.org/officeDocument/2006/relationships/chart" Target="../charts/chart14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3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Relationship Id="rId9" Type="http://schemas.openxmlformats.org/officeDocument/2006/relationships/chart" Target="../charts/chart16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3.xml"/><Relationship Id="rId3" Type="http://schemas.openxmlformats.org/officeDocument/2006/relationships/chart" Target="../charts/chart18.xml"/><Relationship Id="rId7" Type="http://schemas.openxmlformats.org/officeDocument/2006/relationships/chart" Target="../charts/chart22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1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Relationship Id="rId9" Type="http://schemas.openxmlformats.org/officeDocument/2006/relationships/chart" Target="../charts/chart24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1.xml"/><Relationship Id="rId3" Type="http://schemas.openxmlformats.org/officeDocument/2006/relationships/chart" Target="../charts/chart26.xml"/><Relationship Id="rId7" Type="http://schemas.openxmlformats.org/officeDocument/2006/relationships/chart" Target="../charts/chart30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9.xml"/><Relationship Id="rId5" Type="http://schemas.openxmlformats.org/officeDocument/2006/relationships/chart" Target="../charts/chart28.xml"/><Relationship Id="rId4" Type="http://schemas.openxmlformats.org/officeDocument/2006/relationships/chart" Target="../charts/chart27.xml"/><Relationship Id="rId9" Type="http://schemas.openxmlformats.org/officeDocument/2006/relationships/chart" Target="../charts/chart3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9.xml"/><Relationship Id="rId3" Type="http://schemas.openxmlformats.org/officeDocument/2006/relationships/chart" Target="../charts/chart34.xml"/><Relationship Id="rId7" Type="http://schemas.openxmlformats.org/officeDocument/2006/relationships/chart" Target="../charts/chart38.xml"/><Relationship Id="rId2" Type="http://schemas.openxmlformats.org/officeDocument/2006/relationships/chart" Target="../charts/chart3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7.xml"/><Relationship Id="rId5" Type="http://schemas.openxmlformats.org/officeDocument/2006/relationships/chart" Target="../charts/chart36.xml"/><Relationship Id="rId4" Type="http://schemas.openxmlformats.org/officeDocument/2006/relationships/chart" Target="../charts/chart35.xml"/><Relationship Id="rId9" Type="http://schemas.openxmlformats.org/officeDocument/2006/relationships/chart" Target="../charts/chart40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7.xml"/><Relationship Id="rId3" Type="http://schemas.openxmlformats.org/officeDocument/2006/relationships/chart" Target="../charts/chart42.xml"/><Relationship Id="rId7" Type="http://schemas.openxmlformats.org/officeDocument/2006/relationships/chart" Target="../charts/chart46.xml"/><Relationship Id="rId2" Type="http://schemas.openxmlformats.org/officeDocument/2006/relationships/chart" Target="../charts/chart4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5.xml"/><Relationship Id="rId5" Type="http://schemas.openxmlformats.org/officeDocument/2006/relationships/chart" Target="../charts/chart44.xml"/><Relationship Id="rId4" Type="http://schemas.openxmlformats.org/officeDocument/2006/relationships/chart" Target="../charts/chart43.xml"/><Relationship Id="rId9" Type="http://schemas.openxmlformats.org/officeDocument/2006/relationships/chart" Target="../charts/chart4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0904437"/>
              </p:ext>
            </p:extLst>
          </p:nvPr>
        </p:nvGraphicFramePr>
        <p:xfrm>
          <a:off x="-2637" y="-21908"/>
          <a:ext cx="2495533" cy="2937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5811254"/>
              </p:ext>
            </p:extLst>
          </p:nvPr>
        </p:nvGraphicFramePr>
        <p:xfrm>
          <a:off x="2204864" y="-1"/>
          <a:ext cx="2376264" cy="29878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6360665"/>
              </p:ext>
            </p:extLst>
          </p:nvPr>
        </p:nvGraphicFramePr>
        <p:xfrm>
          <a:off x="4437112" y="0"/>
          <a:ext cx="2420888" cy="2915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7177839"/>
              </p:ext>
            </p:extLst>
          </p:nvPr>
        </p:nvGraphicFramePr>
        <p:xfrm>
          <a:off x="0" y="2987824"/>
          <a:ext cx="2420888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5600004"/>
              </p:ext>
            </p:extLst>
          </p:nvPr>
        </p:nvGraphicFramePr>
        <p:xfrm>
          <a:off x="2289042" y="3059832"/>
          <a:ext cx="2292086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5227965"/>
              </p:ext>
            </p:extLst>
          </p:nvPr>
        </p:nvGraphicFramePr>
        <p:xfrm>
          <a:off x="4365104" y="2987824"/>
          <a:ext cx="2492896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1950598"/>
              </p:ext>
            </p:extLst>
          </p:nvPr>
        </p:nvGraphicFramePr>
        <p:xfrm>
          <a:off x="0" y="6012160"/>
          <a:ext cx="2564904" cy="313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4918756"/>
              </p:ext>
            </p:extLst>
          </p:nvPr>
        </p:nvGraphicFramePr>
        <p:xfrm>
          <a:off x="2348880" y="6012160"/>
          <a:ext cx="2376264" cy="313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664090" y="8799756"/>
            <a:ext cx="2206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BVPG6765 x YPS128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0" y="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420888" y="95331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581128" y="95331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-9321" y="3099790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414986" y="3144012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581128" y="3099789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0" y="6156176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G</a:t>
            </a:r>
            <a:endParaRPr lang="en-GB" sz="2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420888" y="6156176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H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28757809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3975189"/>
              </p:ext>
            </p:extLst>
          </p:nvPr>
        </p:nvGraphicFramePr>
        <p:xfrm>
          <a:off x="0" y="-3246"/>
          <a:ext cx="2348880" cy="30630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7586832"/>
              </p:ext>
            </p:extLst>
          </p:nvPr>
        </p:nvGraphicFramePr>
        <p:xfrm>
          <a:off x="2204864" y="0"/>
          <a:ext cx="2304256" cy="3028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5991688"/>
              </p:ext>
            </p:extLst>
          </p:nvPr>
        </p:nvGraphicFramePr>
        <p:xfrm>
          <a:off x="4509120" y="-24544"/>
          <a:ext cx="2348880" cy="3084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689422"/>
              </p:ext>
            </p:extLst>
          </p:nvPr>
        </p:nvGraphicFramePr>
        <p:xfrm>
          <a:off x="0" y="3131840"/>
          <a:ext cx="2492896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616552"/>
              </p:ext>
            </p:extLst>
          </p:nvPr>
        </p:nvGraphicFramePr>
        <p:xfrm>
          <a:off x="2286000" y="3131840"/>
          <a:ext cx="2367136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076708"/>
              </p:ext>
            </p:extLst>
          </p:nvPr>
        </p:nvGraphicFramePr>
        <p:xfrm>
          <a:off x="4572000" y="3131840"/>
          <a:ext cx="2286000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0485000"/>
              </p:ext>
            </p:extLst>
          </p:nvPr>
        </p:nvGraphicFramePr>
        <p:xfrm>
          <a:off x="-7099" y="6084168"/>
          <a:ext cx="2355979" cy="3059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3825252"/>
              </p:ext>
            </p:extLst>
          </p:nvPr>
        </p:nvGraphicFramePr>
        <p:xfrm>
          <a:off x="2276872" y="6156176"/>
          <a:ext cx="2376264" cy="2987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36017" y="12778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331121" y="12778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628125" y="71804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0" y="3178495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424307" y="3222717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609110" y="3197155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0" y="6249481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G</a:t>
            </a:r>
            <a:endParaRPr lang="en-GB" sz="2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420888" y="6249481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H</a:t>
            </a:r>
            <a:endParaRPr lang="en-GB" sz="2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857075" y="8748464"/>
            <a:ext cx="18649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BVPG6765 x Y1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07728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1707565"/>
              </p:ext>
            </p:extLst>
          </p:nvPr>
        </p:nvGraphicFramePr>
        <p:xfrm>
          <a:off x="0" y="0"/>
          <a:ext cx="2420888" cy="3059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3332732"/>
              </p:ext>
            </p:extLst>
          </p:nvPr>
        </p:nvGraphicFramePr>
        <p:xfrm>
          <a:off x="2492896" y="0"/>
          <a:ext cx="2232248" cy="313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0512440"/>
              </p:ext>
            </p:extLst>
          </p:nvPr>
        </p:nvGraphicFramePr>
        <p:xfrm>
          <a:off x="4581128" y="0"/>
          <a:ext cx="2276872" cy="32038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6019805"/>
              </p:ext>
            </p:extLst>
          </p:nvPr>
        </p:nvGraphicFramePr>
        <p:xfrm>
          <a:off x="0" y="3203848"/>
          <a:ext cx="2420888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8995148"/>
              </p:ext>
            </p:extLst>
          </p:nvPr>
        </p:nvGraphicFramePr>
        <p:xfrm>
          <a:off x="2348880" y="3275856"/>
          <a:ext cx="2304256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5287248"/>
              </p:ext>
            </p:extLst>
          </p:nvPr>
        </p:nvGraphicFramePr>
        <p:xfrm>
          <a:off x="4572000" y="3275856"/>
          <a:ext cx="2286000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3990346"/>
              </p:ext>
            </p:extLst>
          </p:nvPr>
        </p:nvGraphicFramePr>
        <p:xfrm>
          <a:off x="-26369" y="6084168"/>
          <a:ext cx="2591273" cy="3059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7089893"/>
              </p:ext>
            </p:extLst>
          </p:nvPr>
        </p:nvGraphicFramePr>
        <p:xfrm>
          <a:off x="2286608" y="6012160"/>
          <a:ext cx="2438536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36017" y="10142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516428" y="10142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758285" y="101419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57381" y="3261261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442529" y="3288043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627332" y="3262481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-43140" y="6228791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G</a:t>
            </a:r>
            <a:endParaRPr lang="en-GB" sz="2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377748" y="6228791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H</a:t>
            </a:r>
            <a:endParaRPr lang="en-GB" sz="2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210352" y="8773552"/>
            <a:ext cx="2647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BVPG6765 x DBVPG604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33603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9882086"/>
              </p:ext>
            </p:extLst>
          </p:nvPr>
        </p:nvGraphicFramePr>
        <p:xfrm>
          <a:off x="0" y="-3246"/>
          <a:ext cx="2348880" cy="3495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9484786"/>
              </p:ext>
            </p:extLst>
          </p:nvPr>
        </p:nvGraphicFramePr>
        <p:xfrm>
          <a:off x="2276872" y="18660"/>
          <a:ext cx="2376264" cy="34732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2711000"/>
              </p:ext>
            </p:extLst>
          </p:nvPr>
        </p:nvGraphicFramePr>
        <p:xfrm>
          <a:off x="4509120" y="-5884"/>
          <a:ext cx="2348880" cy="34977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3306314"/>
              </p:ext>
            </p:extLst>
          </p:nvPr>
        </p:nvGraphicFramePr>
        <p:xfrm>
          <a:off x="0" y="3491880"/>
          <a:ext cx="2276872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6755883"/>
              </p:ext>
            </p:extLst>
          </p:nvPr>
        </p:nvGraphicFramePr>
        <p:xfrm>
          <a:off x="2286000" y="3563888"/>
          <a:ext cx="2367136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9241483"/>
              </p:ext>
            </p:extLst>
          </p:nvPr>
        </p:nvGraphicFramePr>
        <p:xfrm>
          <a:off x="4437112" y="3563888"/>
          <a:ext cx="2420888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4303437"/>
              </p:ext>
            </p:extLst>
          </p:nvPr>
        </p:nvGraphicFramePr>
        <p:xfrm>
          <a:off x="-23529" y="6394916"/>
          <a:ext cx="2516425" cy="2749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6719549"/>
              </p:ext>
            </p:extLst>
          </p:nvPr>
        </p:nvGraphicFramePr>
        <p:xfrm>
          <a:off x="2310746" y="6400800"/>
          <a:ext cx="241439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6532" y="223534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357619" y="20487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599476" y="204872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7381" y="3714827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367885" y="3722948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627332" y="3716047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-43140" y="6459623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G</a:t>
            </a:r>
            <a:endParaRPr lang="en-GB" sz="2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377748" y="645962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H</a:t>
            </a:r>
            <a:endParaRPr lang="en-GB" sz="2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599476" y="8810128"/>
            <a:ext cx="2206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YPS128 x DBVPG604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89420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2539187"/>
              </p:ext>
            </p:extLst>
          </p:nvPr>
        </p:nvGraphicFramePr>
        <p:xfrm>
          <a:off x="0" y="0"/>
          <a:ext cx="2420888" cy="313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2014763"/>
              </p:ext>
            </p:extLst>
          </p:nvPr>
        </p:nvGraphicFramePr>
        <p:xfrm>
          <a:off x="2286000" y="0"/>
          <a:ext cx="2367136" cy="32038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46498"/>
              </p:ext>
            </p:extLst>
          </p:nvPr>
        </p:nvGraphicFramePr>
        <p:xfrm>
          <a:off x="4509120" y="-5884"/>
          <a:ext cx="2348880" cy="33537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5363101"/>
              </p:ext>
            </p:extLst>
          </p:nvPr>
        </p:nvGraphicFramePr>
        <p:xfrm>
          <a:off x="0" y="3203848"/>
          <a:ext cx="2492896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2487667"/>
              </p:ext>
            </p:extLst>
          </p:nvPr>
        </p:nvGraphicFramePr>
        <p:xfrm>
          <a:off x="2276872" y="3203848"/>
          <a:ext cx="2520280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0150019"/>
              </p:ext>
            </p:extLst>
          </p:nvPr>
        </p:nvGraphicFramePr>
        <p:xfrm>
          <a:off x="4581128" y="3131840"/>
          <a:ext cx="2276872" cy="3168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6281269"/>
              </p:ext>
            </p:extLst>
          </p:nvPr>
        </p:nvGraphicFramePr>
        <p:xfrm>
          <a:off x="0" y="6394916"/>
          <a:ext cx="2420888" cy="2749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7635282"/>
              </p:ext>
            </p:extLst>
          </p:nvPr>
        </p:nvGraphicFramePr>
        <p:xfrm>
          <a:off x="2348880" y="6400800"/>
          <a:ext cx="237626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6532" y="223534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357619" y="20487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599476" y="204872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87985" y="3318508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398489" y="3326629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657936" y="3319728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-43140" y="6459623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G</a:t>
            </a:r>
            <a:endParaRPr lang="en-GB" sz="2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377748" y="645962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H</a:t>
            </a:r>
            <a:endParaRPr lang="en-GB" sz="24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5301208" y="8388424"/>
            <a:ext cx="1423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YPS128 x Y1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10350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5780202"/>
              </p:ext>
            </p:extLst>
          </p:nvPr>
        </p:nvGraphicFramePr>
        <p:xfrm>
          <a:off x="0" y="0"/>
          <a:ext cx="2420888" cy="3059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3426131"/>
              </p:ext>
            </p:extLst>
          </p:nvPr>
        </p:nvGraphicFramePr>
        <p:xfrm>
          <a:off x="2204864" y="0"/>
          <a:ext cx="2448272" cy="313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3508242"/>
              </p:ext>
            </p:extLst>
          </p:nvPr>
        </p:nvGraphicFramePr>
        <p:xfrm>
          <a:off x="4365104" y="-180528"/>
          <a:ext cx="2492896" cy="36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0517719"/>
              </p:ext>
            </p:extLst>
          </p:nvPr>
        </p:nvGraphicFramePr>
        <p:xfrm>
          <a:off x="0" y="3059832"/>
          <a:ext cx="2420888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4964804"/>
              </p:ext>
            </p:extLst>
          </p:nvPr>
        </p:nvGraphicFramePr>
        <p:xfrm>
          <a:off x="2305440" y="3131840"/>
          <a:ext cx="2419704" cy="3456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4035487"/>
              </p:ext>
            </p:extLst>
          </p:nvPr>
        </p:nvGraphicFramePr>
        <p:xfrm>
          <a:off x="4437112" y="3131840"/>
          <a:ext cx="2420888" cy="3456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2011041"/>
              </p:ext>
            </p:extLst>
          </p:nvPr>
        </p:nvGraphicFramePr>
        <p:xfrm>
          <a:off x="0" y="6012160"/>
          <a:ext cx="2564904" cy="313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7641856"/>
              </p:ext>
            </p:extLst>
          </p:nvPr>
        </p:nvGraphicFramePr>
        <p:xfrm>
          <a:off x="2298592" y="5940152"/>
          <a:ext cx="2426552" cy="32038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4948115" y="8751988"/>
            <a:ext cx="1885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Y12 X DBVPG6044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0" y="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235581" y="8539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563174" y="8382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87985" y="3310386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386044" y="3238701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645491" y="3231800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-102932" y="6038493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G</a:t>
            </a:r>
            <a:endParaRPr lang="en-GB" sz="2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317956" y="603849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H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3509626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6</TotalTime>
  <Words>370</Words>
  <Application>Microsoft Office PowerPoint</Application>
  <PresentationFormat>On-screen Show (4:3)</PresentationFormat>
  <Paragraphs>150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Nott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etham Darren</dc:creator>
  <cp:lastModifiedBy>Greetham Darren</cp:lastModifiedBy>
  <cp:revision>79</cp:revision>
  <dcterms:created xsi:type="dcterms:W3CDTF">2013-10-21T10:24:58Z</dcterms:created>
  <dcterms:modified xsi:type="dcterms:W3CDTF">2014-06-09T09:09:27Z</dcterms:modified>
</cp:coreProperties>
</file>